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8" r:id="rId1"/>
  </p:sldMasterIdLst>
  <p:notesMasterIdLst>
    <p:notesMasterId r:id="rId29"/>
  </p:notesMasterIdLst>
  <p:sldIdLst>
    <p:sldId id="308" r:id="rId2"/>
    <p:sldId id="313" r:id="rId3"/>
    <p:sldId id="314" r:id="rId4"/>
    <p:sldId id="307" r:id="rId5"/>
    <p:sldId id="306" r:id="rId6"/>
    <p:sldId id="305" r:id="rId7"/>
    <p:sldId id="300" r:id="rId8"/>
    <p:sldId id="309" r:id="rId9"/>
    <p:sldId id="298" r:id="rId10"/>
    <p:sldId id="297" r:id="rId11"/>
    <p:sldId id="296" r:id="rId12"/>
    <p:sldId id="295" r:id="rId13"/>
    <p:sldId id="310" r:id="rId14"/>
    <p:sldId id="311" r:id="rId15"/>
    <p:sldId id="271" r:id="rId16"/>
    <p:sldId id="270" r:id="rId17"/>
    <p:sldId id="269" r:id="rId18"/>
    <p:sldId id="398" r:id="rId19"/>
    <p:sldId id="399" r:id="rId20"/>
    <p:sldId id="400" r:id="rId21"/>
    <p:sldId id="265" r:id="rId22"/>
    <p:sldId id="264" r:id="rId23"/>
    <p:sldId id="263" r:id="rId24"/>
    <p:sldId id="262" r:id="rId25"/>
    <p:sldId id="261" r:id="rId26"/>
    <p:sldId id="258" r:id="rId27"/>
    <p:sldId id="257" r:id="rId2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FA382C8D-EC5A-E89E-74CA-F9DA23F7D81B}" name="Duncan, Ellen" initials="DE" userId="S::ellen.duncan@nyulangone.org::13f0eb4f-3c2d-4204-bfb7-9f2d693e5b64" providerId="AD"/>
  <p188:author id="{E7912F8E-321D-B5CC-D28B-5CBA7DC74208}" name="Sagalowsky, Selin" initials="SS" userId="S::selin.sagalowsky@nyulangone.org::9be54335-ee71-4fe8-b292-c8d8bb8574b1" providerId="AD"/>
  <p188:author id="{C2FF47B5-9890-39C4-885D-688B40B7AB71}" name="Agnant, Joanne" initials="AJ" userId="S::joanne.agnant@nyulangone.org::8b8911d6-3ba3-44bf-b325-5d59eae7ea49" providerId="AD"/>
  <p188:author id="{9A3522F1-09BB-F3B8-8FC5-D05C6448243E}" name="Zabar, Sondra" initials="ZS" userId="S::sondra.zabar@nyulangone.org::52b238e4-f4cc-4aba-9f74-fc09f18bb6f3" providerId="AD"/>
</p188:authorLst>
</file>

<file path=ppt/commentAuthors.xml><?xml version="1.0" encoding="utf-8"?>
<p:cmAuthorLst xmlns:a="http://schemas.openxmlformats.org/drawingml/2006/main" xmlns:r="http://schemas.openxmlformats.org/officeDocument/2006/relationships" xmlns:p="http://schemas.openxmlformats.org/presentationml/2006/main">
  <p:cmAuthor id="1" name="Sagalowsky, Selin" initials="SS" lastIdx="99" clrIdx="0"/>
  <p:cmAuthor id="2" name="Duncan, Ellen" initials="DE" lastIdx="23" clrIdx="1"/>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9E2FE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94EAE6E9-EDE1-1E0C-32DD-35B22DFC02EB}" v="17" dt="2024-03-29T13:22:14.004"/>
    <p1510:client id="{C361BF02-C4B7-AD82-B5CE-756932F06AD4}" v="44" dt="2024-03-29T12:13:10.646"/>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10"/>
    <p:restoredTop sz="80964"/>
  </p:normalViewPr>
  <p:slideViewPr>
    <p:cSldViewPr snapToGrid="0">
      <p:cViewPr varScale="1">
        <p:scale>
          <a:sx n="82" d="100"/>
          <a:sy n="82" d="100"/>
        </p:scale>
        <p:origin x="1600" y="184"/>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21" Type="http://schemas.openxmlformats.org/officeDocument/2006/relationships/slide" Target="slides/slide20.xml"/><Relationship Id="rId34" Type="http://schemas.openxmlformats.org/officeDocument/2006/relationships/tableStyles" Target="tableStyle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notesMaster" Target="notesMasters/notesMaster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viewProps" Target="viewProps.xml"/><Relationship Id="rId37" Type="http://schemas.microsoft.com/office/2018/10/relationships/authors" Target="author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microsoft.com/office/2015/10/relationships/revisionInfo" Target="revisionInfo.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commentAuthors" Target="commentAuthors.xml"/><Relationship Id="rId35" Type="http://schemas.microsoft.com/office/2016/11/relationships/changesInfo" Target="changesInfos/changesInfo1.xml"/><Relationship Id="rId8" Type="http://schemas.openxmlformats.org/officeDocument/2006/relationships/slide" Target="slides/slide7.xml"/><Relationship Id="rId3" Type="http://schemas.openxmlformats.org/officeDocument/2006/relationships/slide" Target="slides/slide2.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Duncan, Ellen" userId="13f0eb4f-3c2d-4204-bfb7-9f2d693e5b64" providerId="ADAL" clId="{2812095B-06DE-AF4D-B537-2ED6BB31BD58}"/>
    <pc:docChg chg="custSel addSld delSld modSld">
      <pc:chgData name="Duncan, Ellen" userId="13f0eb4f-3c2d-4204-bfb7-9f2d693e5b64" providerId="ADAL" clId="{2812095B-06DE-AF4D-B537-2ED6BB31BD58}" dt="2024-03-23T22:43:40.306" v="211"/>
      <pc:docMkLst>
        <pc:docMk/>
      </pc:docMkLst>
      <pc:sldChg chg="del">
        <pc:chgData name="Duncan, Ellen" userId="13f0eb4f-3c2d-4204-bfb7-9f2d693e5b64" providerId="ADAL" clId="{2812095B-06DE-AF4D-B537-2ED6BB31BD58}" dt="2024-03-23T16:47:35.938" v="178" actId="2696"/>
        <pc:sldMkLst>
          <pc:docMk/>
          <pc:sldMk cId="245396161" sldId="260"/>
        </pc:sldMkLst>
      </pc:sldChg>
      <pc:sldChg chg="modSp add mod modNotesTx">
        <pc:chgData name="Duncan, Ellen" userId="13f0eb4f-3c2d-4204-bfb7-9f2d693e5b64" providerId="ADAL" clId="{2812095B-06DE-AF4D-B537-2ED6BB31BD58}" dt="2024-03-23T17:02:38.035" v="186" actId="948"/>
        <pc:sldMkLst>
          <pc:docMk/>
          <pc:sldMk cId="3168291106" sldId="300"/>
        </pc:sldMkLst>
        <pc:spChg chg="mod">
          <ac:chgData name="Duncan, Ellen" userId="13f0eb4f-3c2d-4204-bfb7-9f2d693e5b64" providerId="ADAL" clId="{2812095B-06DE-AF4D-B537-2ED6BB31BD58}" dt="2024-03-23T17:02:38.035" v="186" actId="948"/>
          <ac:spMkLst>
            <pc:docMk/>
            <pc:sldMk cId="3168291106" sldId="300"/>
            <ac:spMk id="14" creationId="{00000000-0000-0000-0000-000000000000}"/>
          </ac:spMkLst>
        </pc:spChg>
      </pc:sldChg>
      <pc:sldChg chg="addSp delSp modSp mod">
        <pc:chgData name="Duncan, Ellen" userId="13f0eb4f-3c2d-4204-bfb7-9f2d693e5b64" providerId="ADAL" clId="{2812095B-06DE-AF4D-B537-2ED6BB31BD58}" dt="2024-03-23T22:40:02.205" v="201" actId="948"/>
        <pc:sldMkLst>
          <pc:docMk/>
          <pc:sldMk cId="3157483606" sldId="308"/>
        </pc:sldMkLst>
        <pc:spChg chg="add del mod">
          <ac:chgData name="Duncan, Ellen" userId="13f0eb4f-3c2d-4204-bfb7-9f2d693e5b64" providerId="ADAL" clId="{2812095B-06DE-AF4D-B537-2ED6BB31BD58}" dt="2024-03-23T22:39:09.068" v="190" actId="478"/>
          <ac:spMkLst>
            <pc:docMk/>
            <pc:sldMk cId="3157483606" sldId="308"/>
            <ac:spMk id="4" creationId="{4BE65AF8-504D-3AE4-F390-957B08B0449C}"/>
          </ac:spMkLst>
        </pc:spChg>
        <pc:spChg chg="del">
          <ac:chgData name="Duncan, Ellen" userId="13f0eb4f-3c2d-4204-bfb7-9f2d693e5b64" providerId="ADAL" clId="{2812095B-06DE-AF4D-B537-2ED6BB31BD58}" dt="2024-03-23T16:47:32.850" v="177" actId="478"/>
          <ac:spMkLst>
            <pc:docMk/>
            <pc:sldMk cId="3157483606" sldId="308"/>
            <ac:spMk id="7" creationId="{71C7DDC3-85A4-4B25-AFC1-9A71D91B72A2}"/>
          </ac:spMkLst>
        </pc:spChg>
        <pc:spChg chg="mod">
          <ac:chgData name="Duncan, Ellen" userId="13f0eb4f-3c2d-4204-bfb7-9f2d693e5b64" providerId="ADAL" clId="{2812095B-06DE-AF4D-B537-2ED6BB31BD58}" dt="2024-03-23T22:40:02.205" v="201" actId="948"/>
          <ac:spMkLst>
            <pc:docMk/>
            <pc:sldMk cId="3157483606" sldId="308"/>
            <ac:spMk id="10" creationId="{00000000-0000-0000-0000-000000000000}"/>
          </ac:spMkLst>
        </pc:spChg>
        <pc:spChg chg="mod">
          <ac:chgData name="Duncan, Ellen" userId="13f0eb4f-3c2d-4204-bfb7-9f2d693e5b64" providerId="ADAL" clId="{2812095B-06DE-AF4D-B537-2ED6BB31BD58}" dt="2024-03-23T22:39:17.772" v="197" actId="1076"/>
          <ac:spMkLst>
            <pc:docMk/>
            <pc:sldMk cId="3157483606" sldId="308"/>
            <ac:spMk id="21" creationId="{00000000-0000-0000-0000-000000000000}"/>
          </ac:spMkLst>
        </pc:spChg>
        <pc:picChg chg="add mod">
          <ac:chgData name="Duncan, Ellen" userId="13f0eb4f-3c2d-4204-bfb7-9f2d693e5b64" providerId="ADAL" clId="{2812095B-06DE-AF4D-B537-2ED6BB31BD58}" dt="2024-03-23T22:38:45.399" v="187"/>
          <ac:picMkLst>
            <pc:docMk/>
            <pc:sldMk cId="3157483606" sldId="308"/>
            <ac:picMk id="3" creationId="{4D6855E3-649D-5A5C-EE4F-7AB6403F27CC}"/>
          </ac:picMkLst>
        </pc:picChg>
      </pc:sldChg>
      <pc:sldChg chg="modSp mod">
        <pc:chgData name="Duncan, Ellen" userId="13f0eb4f-3c2d-4204-bfb7-9f2d693e5b64" providerId="ADAL" clId="{2812095B-06DE-AF4D-B537-2ED6BB31BD58}" dt="2024-03-23T22:40:22.060" v="203" actId="122"/>
        <pc:sldMkLst>
          <pc:docMk/>
          <pc:sldMk cId="2340474459" sldId="313"/>
        </pc:sldMkLst>
        <pc:spChg chg="mod">
          <ac:chgData name="Duncan, Ellen" userId="13f0eb4f-3c2d-4204-bfb7-9f2d693e5b64" providerId="ADAL" clId="{2812095B-06DE-AF4D-B537-2ED6BB31BD58}" dt="2024-03-23T22:40:22.060" v="203" actId="122"/>
          <ac:spMkLst>
            <pc:docMk/>
            <pc:sldMk cId="2340474459" sldId="313"/>
            <ac:spMk id="3" creationId="{A339D4AF-8E0D-40A6-88D1-785C765D71A9}"/>
          </ac:spMkLst>
        </pc:spChg>
      </pc:sldChg>
      <pc:sldChg chg="addSp modSp mod">
        <pc:chgData name="Duncan, Ellen" userId="13f0eb4f-3c2d-4204-bfb7-9f2d693e5b64" providerId="ADAL" clId="{2812095B-06DE-AF4D-B537-2ED6BB31BD58}" dt="2024-03-23T22:43:36.857" v="209" actId="1076"/>
        <pc:sldMkLst>
          <pc:docMk/>
          <pc:sldMk cId="1127798271" sldId="398"/>
        </pc:sldMkLst>
        <pc:spChg chg="add mod">
          <ac:chgData name="Duncan, Ellen" userId="13f0eb4f-3c2d-4204-bfb7-9f2d693e5b64" providerId="ADAL" clId="{2812095B-06DE-AF4D-B537-2ED6BB31BD58}" dt="2024-03-23T22:43:36.857" v="209" actId="1076"/>
          <ac:spMkLst>
            <pc:docMk/>
            <pc:sldMk cId="1127798271" sldId="398"/>
            <ac:spMk id="4" creationId="{737148E5-929D-B0B4-EBA4-3611617AC3ED}"/>
          </ac:spMkLst>
        </pc:spChg>
        <pc:picChg chg="mod">
          <ac:chgData name="Duncan, Ellen" userId="13f0eb4f-3c2d-4204-bfb7-9f2d693e5b64" providerId="ADAL" clId="{2812095B-06DE-AF4D-B537-2ED6BB31BD58}" dt="2024-03-23T22:43:30.320" v="207" actId="1076"/>
          <ac:picMkLst>
            <pc:docMk/>
            <pc:sldMk cId="1127798271" sldId="398"/>
            <ac:picMk id="2" creationId="{3B065A5D-262E-0FDD-FAB7-0F73F21509CD}"/>
          </ac:picMkLst>
        </pc:picChg>
      </pc:sldChg>
      <pc:sldChg chg="addSp modSp">
        <pc:chgData name="Duncan, Ellen" userId="13f0eb4f-3c2d-4204-bfb7-9f2d693e5b64" providerId="ADAL" clId="{2812095B-06DE-AF4D-B537-2ED6BB31BD58}" dt="2024-03-23T22:43:38.885" v="210"/>
        <pc:sldMkLst>
          <pc:docMk/>
          <pc:sldMk cId="2431484239" sldId="399"/>
        </pc:sldMkLst>
        <pc:spChg chg="add mod">
          <ac:chgData name="Duncan, Ellen" userId="13f0eb4f-3c2d-4204-bfb7-9f2d693e5b64" providerId="ADAL" clId="{2812095B-06DE-AF4D-B537-2ED6BB31BD58}" dt="2024-03-23T22:43:38.885" v="210"/>
          <ac:spMkLst>
            <pc:docMk/>
            <pc:sldMk cId="2431484239" sldId="399"/>
            <ac:spMk id="2" creationId="{4FDF9F26-9811-4347-98E7-534FB82FB0D1}"/>
          </ac:spMkLst>
        </pc:spChg>
      </pc:sldChg>
      <pc:sldChg chg="addSp modSp">
        <pc:chgData name="Duncan, Ellen" userId="13f0eb4f-3c2d-4204-bfb7-9f2d693e5b64" providerId="ADAL" clId="{2812095B-06DE-AF4D-B537-2ED6BB31BD58}" dt="2024-03-23T22:43:40.306" v="211"/>
        <pc:sldMkLst>
          <pc:docMk/>
          <pc:sldMk cId="28464993" sldId="400"/>
        </pc:sldMkLst>
        <pc:spChg chg="add mod">
          <ac:chgData name="Duncan, Ellen" userId="13f0eb4f-3c2d-4204-bfb7-9f2d693e5b64" providerId="ADAL" clId="{2812095B-06DE-AF4D-B537-2ED6BB31BD58}" dt="2024-03-23T22:43:40.306" v="211"/>
          <ac:spMkLst>
            <pc:docMk/>
            <pc:sldMk cId="28464993" sldId="400"/>
            <ac:spMk id="2" creationId="{D6482D98-C247-5363-394C-D07C8D760374}"/>
          </ac:spMkLst>
        </pc:spChg>
      </pc:sldChg>
      <pc:sldChg chg="del">
        <pc:chgData name="Duncan, Ellen" userId="13f0eb4f-3c2d-4204-bfb7-9f2d693e5b64" providerId="ADAL" clId="{2812095B-06DE-AF4D-B537-2ED6BB31BD58}" dt="2024-03-23T16:44:49.900" v="1" actId="2696"/>
        <pc:sldMkLst>
          <pc:docMk/>
          <pc:sldMk cId="3732719481" sldId="401"/>
        </pc:sldMkLst>
      </pc:sldChg>
    </pc:docChg>
  </pc:docChgLst>
  <pc:docChgLst>
    <pc:chgData name="Duncan, Ellen" userId="S::ellen.duncan@nyulangone.org::13f0eb4f-3c2d-4204-bfb7-9f2d693e5b64" providerId="AD" clId="Web-{A1FD1AC5-B299-23FE-E6EF-08E5E5B89669}"/>
    <pc:docChg chg="modSld">
      <pc:chgData name="Duncan, Ellen" userId="S::ellen.duncan@nyulangone.org::13f0eb4f-3c2d-4204-bfb7-9f2d693e5b64" providerId="AD" clId="Web-{A1FD1AC5-B299-23FE-E6EF-08E5E5B89669}" dt="2023-09-06T20:44:09.196" v="5" actId="20577"/>
      <pc:docMkLst>
        <pc:docMk/>
      </pc:docMkLst>
      <pc:sldChg chg="modSp">
        <pc:chgData name="Duncan, Ellen" userId="S::ellen.duncan@nyulangone.org::13f0eb4f-3c2d-4204-bfb7-9f2d693e5b64" providerId="AD" clId="Web-{A1FD1AC5-B299-23FE-E6EF-08E5E5B89669}" dt="2023-09-06T20:44:09.196" v="5" actId="20577"/>
        <pc:sldMkLst>
          <pc:docMk/>
          <pc:sldMk cId="2340474459" sldId="313"/>
        </pc:sldMkLst>
        <pc:spChg chg="mod">
          <ac:chgData name="Duncan, Ellen" userId="S::ellen.duncan@nyulangone.org::13f0eb4f-3c2d-4204-bfb7-9f2d693e5b64" providerId="AD" clId="Web-{A1FD1AC5-B299-23FE-E6EF-08E5E5B89669}" dt="2023-09-06T20:44:09.196" v="5" actId="20577"/>
          <ac:spMkLst>
            <pc:docMk/>
            <pc:sldMk cId="2340474459" sldId="313"/>
            <ac:spMk id="2" creationId="{AE62F8B3-52F4-4267-8390-7BEAA3A7A6AB}"/>
          </ac:spMkLst>
        </pc:spChg>
      </pc:sldChg>
    </pc:docChg>
  </pc:docChgLst>
  <pc:docChgLst>
    <pc:chgData name="Duncan, Ellen" userId="S::ellen.duncan@nyulangone.org::13f0eb4f-3c2d-4204-bfb7-9f2d693e5b64" providerId="AD" clId="Web-{56E02D2D-B48F-AB8F-CABD-2CEBDD2242C8}"/>
    <pc:docChg chg="addSld">
      <pc:chgData name="Duncan, Ellen" userId="S::ellen.duncan@nyulangone.org::13f0eb4f-3c2d-4204-bfb7-9f2d693e5b64" providerId="AD" clId="Web-{56E02D2D-B48F-AB8F-CABD-2CEBDD2242C8}" dt="2024-03-23T16:44:22.434" v="0"/>
      <pc:docMkLst>
        <pc:docMk/>
      </pc:docMkLst>
      <pc:sldChg chg="new">
        <pc:chgData name="Duncan, Ellen" userId="S::ellen.duncan@nyulangone.org::13f0eb4f-3c2d-4204-bfb7-9f2d693e5b64" providerId="AD" clId="Web-{56E02D2D-B48F-AB8F-CABD-2CEBDD2242C8}" dt="2024-03-23T16:44:22.434" v="0"/>
        <pc:sldMkLst>
          <pc:docMk/>
          <pc:sldMk cId="3732719481" sldId="401"/>
        </pc:sldMkLst>
      </pc:sldChg>
    </pc:docChg>
  </pc:docChgLst>
  <pc:docChgLst>
    <pc:chgData name="Duncan, Ellen" userId="S::ellen.duncan@nyulangone.org::13f0eb4f-3c2d-4204-bfb7-9f2d693e5b64" providerId="AD" clId="Web-{E44EEBEE-CD99-B15C-F08D-E1B3544010BB}"/>
    <pc:docChg chg="modSld">
      <pc:chgData name="Duncan, Ellen" userId="S::ellen.duncan@nyulangone.org::13f0eb4f-3c2d-4204-bfb7-9f2d693e5b64" providerId="AD" clId="Web-{E44EEBEE-CD99-B15C-F08D-E1B3544010BB}" dt="2023-09-13T18:46:42.391" v="37" actId="1076"/>
      <pc:docMkLst>
        <pc:docMk/>
      </pc:docMkLst>
      <pc:sldChg chg="modSp">
        <pc:chgData name="Duncan, Ellen" userId="S::ellen.duncan@nyulangone.org::13f0eb4f-3c2d-4204-bfb7-9f2d693e5b64" providerId="AD" clId="Web-{E44EEBEE-CD99-B15C-F08D-E1B3544010BB}" dt="2023-09-13T18:46:42.391" v="37" actId="1076"/>
        <pc:sldMkLst>
          <pc:docMk/>
          <pc:sldMk cId="2960214513" sldId="295"/>
        </pc:sldMkLst>
        <pc:spChg chg="mod">
          <ac:chgData name="Duncan, Ellen" userId="S::ellen.duncan@nyulangone.org::13f0eb4f-3c2d-4204-bfb7-9f2d693e5b64" providerId="AD" clId="Web-{E44EEBEE-CD99-B15C-F08D-E1B3544010BB}" dt="2023-09-13T18:46:42.391" v="37" actId="1076"/>
          <ac:spMkLst>
            <pc:docMk/>
            <pc:sldMk cId="2960214513" sldId="295"/>
            <ac:spMk id="9" creationId="{00000000-0000-0000-0000-000000000000}"/>
          </ac:spMkLst>
        </pc:spChg>
      </pc:sldChg>
    </pc:docChg>
  </pc:docChgLst>
  <pc:docChgLst>
    <pc:chgData name="Duncan, Ellen" userId="S::ellen.duncan@nyulangone.org::13f0eb4f-3c2d-4204-bfb7-9f2d693e5b64" providerId="AD" clId="Web-{E6310CDB-08F1-35A9-9E75-C5E853A95924}"/>
    <pc:docChg chg="modSld">
      <pc:chgData name="Duncan, Ellen" userId="S::ellen.duncan@nyulangone.org::13f0eb4f-3c2d-4204-bfb7-9f2d693e5b64" providerId="AD" clId="Web-{E6310CDB-08F1-35A9-9E75-C5E853A95924}" dt="2024-03-14T16:43:33.278" v="14" actId="20577"/>
      <pc:docMkLst>
        <pc:docMk/>
      </pc:docMkLst>
      <pc:sldChg chg="modSp">
        <pc:chgData name="Duncan, Ellen" userId="S::ellen.duncan@nyulangone.org::13f0eb4f-3c2d-4204-bfb7-9f2d693e5b64" providerId="AD" clId="Web-{E6310CDB-08F1-35A9-9E75-C5E853A95924}" dt="2024-03-14T16:43:33.278" v="14" actId="20577"/>
        <pc:sldMkLst>
          <pc:docMk/>
          <pc:sldMk cId="3017569055" sldId="258"/>
        </pc:sldMkLst>
        <pc:spChg chg="mod">
          <ac:chgData name="Duncan, Ellen" userId="S::ellen.duncan@nyulangone.org::13f0eb4f-3c2d-4204-bfb7-9f2d693e5b64" providerId="AD" clId="Web-{E6310CDB-08F1-35A9-9E75-C5E853A95924}" dt="2024-03-14T16:43:33.278" v="14" actId="20577"/>
          <ac:spMkLst>
            <pc:docMk/>
            <pc:sldMk cId="3017569055" sldId="258"/>
            <ac:spMk id="3" creationId="{244448D8-6854-4C85-A320-33725E75611D}"/>
          </ac:spMkLst>
        </pc:spChg>
      </pc:sldChg>
    </pc:docChg>
  </pc:docChgLst>
  <pc:docChgLst>
    <pc:chgData name="Duncan, Ellen" userId="S::ellen.duncan@nyulangone.org::13f0eb4f-3c2d-4204-bfb7-9f2d693e5b64" providerId="AD" clId="Web-{36FE464D-2353-A1B5-5FCC-342A7361C023}"/>
    <pc:docChg chg="delSld modSld">
      <pc:chgData name="Duncan, Ellen" userId="S::ellen.duncan@nyulangone.org::13f0eb4f-3c2d-4204-bfb7-9f2d693e5b64" providerId="AD" clId="Web-{36FE464D-2353-A1B5-5FCC-342A7361C023}" dt="2023-05-26T11:20:07.666" v="50" actId="20577"/>
      <pc:docMkLst>
        <pc:docMk/>
      </pc:docMkLst>
      <pc:sldChg chg="modSp">
        <pc:chgData name="Duncan, Ellen" userId="S::ellen.duncan@nyulangone.org::13f0eb4f-3c2d-4204-bfb7-9f2d693e5b64" providerId="AD" clId="Web-{36FE464D-2353-A1B5-5FCC-342A7361C023}" dt="2023-05-26T11:20:07.666" v="50" actId="20577"/>
        <pc:sldMkLst>
          <pc:docMk/>
          <pc:sldMk cId="4278517905" sldId="265"/>
        </pc:sldMkLst>
        <pc:spChg chg="mod">
          <ac:chgData name="Duncan, Ellen" userId="S::ellen.duncan@nyulangone.org::13f0eb4f-3c2d-4204-bfb7-9f2d693e5b64" providerId="AD" clId="Web-{36FE464D-2353-A1B5-5FCC-342A7361C023}" dt="2023-05-26T11:20:07.666" v="50" actId="20577"/>
          <ac:spMkLst>
            <pc:docMk/>
            <pc:sldMk cId="4278517905" sldId="265"/>
            <ac:spMk id="14" creationId="{00000000-0000-0000-0000-000000000000}"/>
          </ac:spMkLst>
        </pc:spChg>
      </pc:sldChg>
      <pc:sldChg chg="modSp">
        <pc:chgData name="Duncan, Ellen" userId="S::ellen.duncan@nyulangone.org::13f0eb4f-3c2d-4204-bfb7-9f2d693e5b64" providerId="AD" clId="Web-{36FE464D-2353-A1B5-5FCC-342A7361C023}" dt="2023-05-26T11:19:32.274" v="15" actId="20577"/>
        <pc:sldMkLst>
          <pc:docMk/>
          <pc:sldMk cId="614994627" sldId="271"/>
        </pc:sldMkLst>
        <pc:spChg chg="mod">
          <ac:chgData name="Duncan, Ellen" userId="S::ellen.duncan@nyulangone.org::13f0eb4f-3c2d-4204-bfb7-9f2d693e5b64" providerId="AD" clId="Web-{36FE464D-2353-A1B5-5FCC-342A7361C023}" dt="2023-05-26T11:19:32.274" v="15" actId="20577"/>
          <ac:spMkLst>
            <pc:docMk/>
            <pc:sldMk cId="614994627" sldId="271"/>
            <ac:spMk id="14" creationId="{00000000-0000-0000-0000-000000000000}"/>
          </ac:spMkLst>
        </pc:spChg>
      </pc:sldChg>
      <pc:sldChg chg="modSp">
        <pc:chgData name="Duncan, Ellen" userId="S::ellen.duncan@nyulangone.org::13f0eb4f-3c2d-4204-bfb7-9f2d693e5b64" providerId="AD" clId="Web-{36FE464D-2353-A1B5-5FCC-342A7361C023}" dt="2023-05-26T11:19:54.368" v="47" actId="20577"/>
        <pc:sldMkLst>
          <pc:docMk/>
          <pc:sldMk cId="3217855894" sldId="296"/>
        </pc:sldMkLst>
        <pc:spChg chg="mod">
          <ac:chgData name="Duncan, Ellen" userId="S::ellen.duncan@nyulangone.org::13f0eb4f-3c2d-4204-bfb7-9f2d693e5b64" providerId="AD" clId="Web-{36FE464D-2353-A1B5-5FCC-342A7361C023}" dt="2023-05-26T11:19:43.587" v="33" actId="20577"/>
          <ac:spMkLst>
            <pc:docMk/>
            <pc:sldMk cId="3217855894" sldId="296"/>
            <ac:spMk id="2" creationId="{C551AF25-74B9-44A9-973E-75F4DE5FE04E}"/>
          </ac:spMkLst>
        </pc:spChg>
        <pc:spChg chg="mod">
          <ac:chgData name="Duncan, Ellen" userId="S::ellen.duncan@nyulangone.org::13f0eb4f-3c2d-4204-bfb7-9f2d693e5b64" providerId="AD" clId="Web-{36FE464D-2353-A1B5-5FCC-342A7361C023}" dt="2023-05-26T11:19:54.368" v="47" actId="20577"/>
          <ac:spMkLst>
            <pc:docMk/>
            <pc:sldMk cId="3217855894" sldId="296"/>
            <ac:spMk id="3" creationId="{3E11CACD-6C7E-40ED-AD2C-A9A6844B6D92}"/>
          </ac:spMkLst>
        </pc:spChg>
      </pc:sldChg>
      <pc:sldChg chg="modSp">
        <pc:chgData name="Duncan, Ellen" userId="S::ellen.duncan@nyulangone.org::13f0eb4f-3c2d-4204-bfb7-9f2d693e5b64" providerId="AD" clId="Web-{36FE464D-2353-A1B5-5FCC-342A7361C023}" dt="2023-05-26T11:19:39.368" v="19" actId="20577"/>
        <pc:sldMkLst>
          <pc:docMk/>
          <pc:sldMk cId="2743119629" sldId="298"/>
        </pc:sldMkLst>
        <pc:spChg chg="mod">
          <ac:chgData name="Duncan, Ellen" userId="S::ellen.duncan@nyulangone.org::13f0eb4f-3c2d-4204-bfb7-9f2d693e5b64" providerId="AD" clId="Web-{36FE464D-2353-A1B5-5FCC-342A7361C023}" dt="2023-05-26T11:19:39.368" v="19" actId="20577"/>
          <ac:spMkLst>
            <pc:docMk/>
            <pc:sldMk cId="2743119629" sldId="298"/>
            <ac:spMk id="14" creationId="{00000000-0000-0000-0000-000000000000}"/>
          </ac:spMkLst>
        </pc:spChg>
      </pc:sldChg>
      <pc:sldChg chg="del">
        <pc:chgData name="Duncan, Ellen" userId="S::ellen.duncan@nyulangone.org::13f0eb4f-3c2d-4204-bfb7-9f2d693e5b64" providerId="AD" clId="Web-{36FE464D-2353-A1B5-5FCC-342A7361C023}" dt="2023-05-26T11:09:08.369" v="0"/>
        <pc:sldMkLst>
          <pc:docMk/>
          <pc:sldMk cId="1954972011" sldId="302"/>
        </pc:sldMkLst>
      </pc:sldChg>
      <pc:sldChg chg="modSp">
        <pc:chgData name="Duncan, Ellen" userId="S::ellen.duncan@nyulangone.org::13f0eb4f-3c2d-4204-bfb7-9f2d693e5b64" providerId="AD" clId="Web-{36FE464D-2353-A1B5-5FCC-342A7361C023}" dt="2023-05-26T11:19:35.134" v="17" actId="20577"/>
        <pc:sldMkLst>
          <pc:docMk/>
          <pc:sldMk cId="2790284329" sldId="307"/>
        </pc:sldMkLst>
        <pc:spChg chg="mod">
          <ac:chgData name="Duncan, Ellen" userId="S::ellen.duncan@nyulangone.org::13f0eb4f-3c2d-4204-bfb7-9f2d693e5b64" providerId="AD" clId="Web-{36FE464D-2353-A1B5-5FCC-342A7361C023}" dt="2023-05-26T11:19:35.134" v="17" actId="20577"/>
          <ac:spMkLst>
            <pc:docMk/>
            <pc:sldMk cId="2790284329" sldId="307"/>
            <ac:spMk id="14" creationId="{00000000-0000-0000-0000-000000000000}"/>
          </ac:spMkLst>
        </pc:spChg>
      </pc:sldChg>
    </pc:docChg>
  </pc:docChgLst>
  <pc:docChgLst>
    <pc:chgData name="Duncan, Ellen" userId="S::ellen.duncan@nyulangone.org::13f0eb4f-3c2d-4204-bfb7-9f2d693e5b64" providerId="AD" clId="Web-{3EDEFDA3-D396-949E-B4CD-868CE8F3A3C5}"/>
    <pc:docChg chg="modSld">
      <pc:chgData name="Duncan, Ellen" userId="S::ellen.duncan@nyulangone.org::13f0eb4f-3c2d-4204-bfb7-9f2d693e5b64" providerId="AD" clId="Web-{3EDEFDA3-D396-949E-B4CD-868CE8F3A3C5}" dt="2024-03-11T12:44:52.144" v="10"/>
      <pc:docMkLst>
        <pc:docMk/>
      </pc:docMkLst>
      <pc:sldChg chg="modSp modNotes">
        <pc:chgData name="Duncan, Ellen" userId="S::ellen.duncan@nyulangone.org::13f0eb4f-3c2d-4204-bfb7-9f2d693e5b64" providerId="AD" clId="Web-{3EDEFDA3-D396-949E-B4CD-868CE8F3A3C5}" dt="2024-03-11T12:44:52.144" v="10"/>
        <pc:sldMkLst>
          <pc:docMk/>
          <pc:sldMk cId="2501830990" sldId="305"/>
        </pc:sldMkLst>
        <pc:spChg chg="mod">
          <ac:chgData name="Duncan, Ellen" userId="S::ellen.duncan@nyulangone.org::13f0eb4f-3c2d-4204-bfb7-9f2d693e5b64" providerId="AD" clId="Web-{3EDEFDA3-D396-949E-B4CD-868CE8F3A3C5}" dt="2024-03-11T12:44:46.910" v="9" actId="20577"/>
          <ac:spMkLst>
            <pc:docMk/>
            <pc:sldMk cId="2501830990" sldId="305"/>
            <ac:spMk id="14" creationId="{00000000-0000-0000-0000-000000000000}"/>
          </ac:spMkLst>
        </pc:spChg>
      </pc:sldChg>
      <pc:sldChg chg="modSp">
        <pc:chgData name="Duncan, Ellen" userId="S::ellen.duncan@nyulangone.org::13f0eb4f-3c2d-4204-bfb7-9f2d693e5b64" providerId="AD" clId="Web-{3EDEFDA3-D396-949E-B4CD-868CE8F3A3C5}" dt="2024-03-11T12:44:33.425" v="5" actId="20577"/>
        <pc:sldMkLst>
          <pc:docMk/>
          <pc:sldMk cId="3157483606" sldId="308"/>
        </pc:sldMkLst>
        <pc:spChg chg="mod">
          <ac:chgData name="Duncan, Ellen" userId="S::ellen.duncan@nyulangone.org::13f0eb4f-3c2d-4204-bfb7-9f2d693e5b64" providerId="AD" clId="Web-{3EDEFDA3-D396-949E-B4CD-868CE8F3A3C5}" dt="2024-03-11T12:44:33.425" v="5" actId="20577"/>
          <ac:spMkLst>
            <pc:docMk/>
            <pc:sldMk cId="3157483606" sldId="308"/>
            <ac:spMk id="10" creationId="{00000000-0000-0000-0000-000000000000}"/>
          </ac:spMkLst>
        </pc:spChg>
      </pc:sldChg>
    </pc:docChg>
  </pc:docChgLst>
  <pc:docChgLst>
    <pc:chgData name="Duncan, Ellen" userId="S::ellen.duncan@nyulangone.org::13f0eb4f-3c2d-4204-bfb7-9f2d693e5b64" providerId="AD" clId="Web-{7276CE38-3168-1662-576E-EBBAEDE6F25D}"/>
    <pc:docChg chg="modSld">
      <pc:chgData name="Duncan, Ellen" userId="S::ellen.duncan@nyulangone.org::13f0eb4f-3c2d-4204-bfb7-9f2d693e5b64" providerId="AD" clId="Web-{7276CE38-3168-1662-576E-EBBAEDE6F25D}" dt="2023-11-07T08:08:06.046" v="11"/>
      <pc:docMkLst>
        <pc:docMk/>
      </pc:docMkLst>
      <pc:sldChg chg="addSp delSp modSp">
        <pc:chgData name="Duncan, Ellen" userId="S::ellen.duncan@nyulangone.org::13f0eb4f-3c2d-4204-bfb7-9f2d693e5b64" providerId="AD" clId="Web-{7276CE38-3168-1662-576E-EBBAEDE6F25D}" dt="2023-11-07T08:08:06.046" v="11"/>
        <pc:sldMkLst>
          <pc:docMk/>
          <pc:sldMk cId="1264078744" sldId="257"/>
        </pc:sldMkLst>
        <pc:spChg chg="add del mod">
          <ac:chgData name="Duncan, Ellen" userId="S::ellen.duncan@nyulangone.org::13f0eb4f-3c2d-4204-bfb7-9f2d693e5b64" providerId="AD" clId="Web-{7276CE38-3168-1662-576E-EBBAEDE6F25D}" dt="2023-11-07T08:08:06.046" v="11"/>
          <ac:spMkLst>
            <pc:docMk/>
            <pc:sldMk cId="1264078744" sldId="257"/>
            <ac:spMk id="3" creationId="{E6343EF2-8A3C-2080-0A3C-9E9AE59971C5}"/>
          </ac:spMkLst>
        </pc:spChg>
        <pc:picChg chg="del">
          <ac:chgData name="Duncan, Ellen" userId="S::ellen.duncan@nyulangone.org::13f0eb4f-3c2d-4204-bfb7-9f2d693e5b64" providerId="AD" clId="Web-{7276CE38-3168-1662-576E-EBBAEDE6F25D}" dt="2023-11-07T08:08:05.359" v="10"/>
          <ac:picMkLst>
            <pc:docMk/>
            <pc:sldMk cId="1264078744" sldId="257"/>
            <ac:picMk id="13" creationId="{00000000-0000-0000-0000-000000000000}"/>
          </ac:picMkLst>
        </pc:picChg>
      </pc:sldChg>
      <pc:sldChg chg="addSp delSp modSp">
        <pc:chgData name="Duncan, Ellen" userId="S::ellen.duncan@nyulangone.org::13f0eb4f-3c2d-4204-bfb7-9f2d693e5b64" providerId="AD" clId="Web-{7276CE38-3168-1662-576E-EBBAEDE6F25D}" dt="2023-11-07T08:08:02.531" v="9" actId="1076"/>
        <pc:sldMkLst>
          <pc:docMk/>
          <pc:sldMk cId="3187644739" sldId="261"/>
        </pc:sldMkLst>
        <pc:spChg chg="add del mod">
          <ac:chgData name="Duncan, Ellen" userId="S::ellen.duncan@nyulangone.org::13f0eb4f-3c2d-4204-bfb7-9f2d693e5b64" providerId="AD" clId="Web-{7276CE38-3168-1662-576E-EBBAEDE6F25D}" dt="2023-11-07T08:07:58.437" v="8"/>
          <ac:spMkLst>
            <pc:docMk/>
            <pc:sldMk cId="3187644739" sldId="261"/>
            <ac:spMk id="5" creationId="{3A134981-ADCB-F81E-4EF3-7F6CB0A9C28F}"/>
          </ac:spMkLst>
        </pc:spChg>
        <pc:spChg chg="mod">
          <ac:chgData name="Duncan, Ellen" userId="S::ellen.duncan@nyulangone.org::13f0eb4f-3c2d-4204-bfb7-9f2d693e5b64" providerId="AD" clId="Web-{7276CE38-3168-1662-576E-EBBAEDE6F25D}" dt="2023-11-07T08:08:02.531" v="9" actId="1076"/>
          <ac:spMkLst>
            <pc:docMk/>
            <pc:sldMk cId="3187644739" sldId="261"/>
            <ac:spMk id="53" creationId="{00000000-0000-0000-0000-000000000000}"/>
          </ac:spMkLst>
        </pc:spChg>
        <pc:picChg chg="del">
          <ac:chgData name="Duncan, Ellen" userId="S::ellen.duncan@nyulangone.org::13f0eb4f-3c2d-4204-bfb7-9f2d693e5b64" providerId="AD" clId="Web-{7276CE38-3168-1662-576E-EBBAEDE6F25D}" dt="2023-11-07T08:07:56.968" v="7"/>
          <ac:picMkLst>
            <pc:docMk/>
            <pc:sldMk cId="3187644739" sldId="261"/>
            <ac:picMk id="60" creationId="{00000000-0000-0000-0000-000000000000}"/>
          </ac:picMkLst>
        </pc:picChg>
      </pc:sldChg>
      <pc:sldChg chg="addSp delSp modSp">
        <pc:chgData name="Duncan, Ellen" userId="S::ellen.duncan@nyulangone.org::13f0eb4f-3c2d-4204-bfb7-9f2d693e5b64" providerId="AD" clId="Web-{7276CE38-3168-1662-576E-EBBAEDE6F25D}" dt="2023-11-07T08:07:45.061" v="6" actId="1076"/>
        <pc:sldMkLst>
          <pc:docMk/>
          <pc:sldMk cId="3157483606" sldId="308"/>
        </pc:sldMkLst>
        <pc:spChg chg="add del mod">
          <ac:chgData name="Duncan, Ellen" userId="S::ellen.duncan@nyulangone.org::13f0eb4f-3c2d-4204-bfb7-9f2d693e5b64" providerId="AD" clId="Web-{7276CE38-3168-1662-576E-EBBAEDE6F25D}" dt="2023-11-07T08:07:34.514" v="3"/>
          <ac:spMkLst>
            <pc:docMk/>
            <pc:sldMk cId="3157483606" sldId="308"/>
            <ac:spMk id="3" creationId="{DDD65F37-CFB6-EA1D-B7DC-A5CD6B46FF59}"/>
          </ac:spMkLst>
        </pc:spChg>
        <pc:spChg chg="mod">
          <ac:chgData name="Duncan, Ellen" userId="S::ellen.duncan@nyulangone.org::13f0eb4f-3c2d-4204-bfb7-9f2d693e5b64" providerId="AD" clId="Web-{7276CE38-3168-1662-576E-EBBAEDE6F25D}" dt="2023-11-07T08:07:41.952" v="5" actId="1076"/>
          <ac:spMkLst>
            <pc:docMk/>
            <pc:sldMk cId="3157483606" sldId="308"/>
            <ac:spMk id="10" creationId="{00000000-0000-0000-0000-000000000000}"/>
          </ac:spMkLst>
        </pc:spChg>
        <pc:spChg chg="mod">
          <ac:chgData name="Duncan, Ellen" userId="S::ellen.duncan@nyulangone.org::13f0eb4f-3c2d-4204-bfb7-9f2d693e5b64" providerId="AD" clId="Web-{7276CE38-3168-1662-576E-EBBAEDE6F25D}" dt="2023-11-07T08:07:45.061" v="6" actId="1076"/>
          <ac:spMkLst>
            <pc:docMk/>
            <pc:sldMk cId="3157483606" sldId="308"/>
            <ac:spMk id="21" creationId="{00000000-0000-0000-0000-000000000000}"/>
          </ac:spMkLst>
        </pc:spChg>
        <pc:picChg chg="del">
          <ac:chgData name="Duncan, Ellen" userId="S::ellen.duncan@nyulangone.org::13f0eb4f-3c2d-4204-bfb7-9f2d693e5b64" providerId="AD" clId="Web-{7276CE38-3168-1662-576E-EBBAEDE6F25D}" dt="2023-11-07T08:07:26.655" v="0"/>
          <ac:picMkLst>
            <pc:docMk/>
            <pc:sldMk cId="3157483606" sldId="308"/>
            <ac:picMk id="5" creationId="{00000000-0000-0000-0000-000000000000}"/>
          </ac:picMkLst>
        </pc:picChg>
      </pc:sldChg>
    </pc:docChg>
  </pc:docChgLst>
  <pc:docChgLst>
    <pc:chgData name="Sagalowsky, Selin" userId="S::selin.sagalowsky@nyulangone.org::9be54335-ee71-4fe8-b292-c8d8bb8574b1" providerId="AD" clId="Web-{C361BF02-C4B7-AD82-B5CE-756932F06AD4}"/>
    <pc:docChg chg="addSld modSld">
      <pc:chgData name="Sagalowsky, Selin" userId="S::selin.sagalowsky@nyulangone.org::9be54335-ee71-4fe8-b292-c8d8bb8574b1" providerId="AD" clId="Web-{C361BF02-C4B7-AD82-B5CE-756932F06AD4}" dt="2024-03-29T12:13:10.646" v="43"/>
      <pc:docMkLst>
        <pc:docMk/>
      </pc:docMkLst>
      <pc:sldChg chg="modSp addCm">
        <pc:chgData name="Sagalowsky, Selin" userId="S::selin.sagalowsky@nyulangone.org::9be54335-ee71-4fe8-b292-c8d8bb8574b1" providerId="AD" clId="Web-{C361BF02-C4B7-AD82-B5CE-756932F06AD4}" dt="2024-03-29T12:10:16.766" v="12"/>
        <pc:sldMkLst>
          <pc:docMk/>
          <pc:sldMk cId="3168291106" sldId="300"/>
        </pc:sldMkLst>
        <pc:spChg chg="mod">
          <ac:chgData name="Sagalowsky, Selin" userId="S::selin.sagalowsky@nyulangone.org::9be54335-ee71-4fe8-b292-c8d8bb8574b1" providerId="AD" clId="Web-{C361BF02-C4B7-AD82-B5CE-756932F06AD4}" dt="2024-03-29T12:09:54.015" v="11" actId="20577"/>
          <ac:spMkLst>
            <pc:docMk/>
            <pc:sldMk cId="3168291106" sldId="300"/>
            <ac:spMk id="14" creationId="{00000000-0000-0000-0000-000000000000}"/>
          </ac:spMkLst>
        </pc:spChg>
        <pc:extLst>
          <p:ext xmlns:p="http://schemas.openxmlformats.org/presentationml/2006/main" uri="{D6D511B9-2390-475A-947B-AFAB55BFBCF1}">
            <pc226:cmChg xmlns:pc226="http://schemas.microsoft.com/office/powerpoint/2022/06/main/command" chg="add">
              <pc226:chgData name="Sagalowsky, Selin" userId="S::selin.sagalowsky@nyulangone.org::9be54335-ee71-4fe8-b292-c8d8bb8574b1" providerId="AD" clId="Web-{C361BF02-C4B7-AD82-B5CE-756932F06AD4}" dt="2024-03-29T12:10:16.766" v="12"/>
              <pc2:cmMkLst xmlns:pc2="http://schemas.microsoft.com/office/powerpoint/2019/9/main/command">
                <pc:docMk/>
                <pc:sldMk cId="3168291106" sldId="300"/>
                <pc2:cmMk id="{DE3488F5-D81D-4C2D-A78A-42CB6DA5BA87}"/>
              </pc2:cmMkLst>
            </pc226:cmChg>
          </p:ext>
        </pc:extLst>
      </pc:sldChg>
      <pc:sldChg chg="modSp new addCm">
        <pc:chgData name="Sagalowsky, Selin" userId="S::selin.sagalowsky@nyulangone.org::9be54335-ee71-4fe8-b292-c8d8bb8574b1" providerId="AD" clId="Web-{C361BF02-C4B7-AD82-B5CE-756932F06AD4}" dt="2024-03-29T12:13:10.646" v="43"/>
        <pc:sldMkLst>
          <pc:docMk/>
          <pc:sldMk cId="2300300582" sldId="401"/>
        </pc:sldMkLst>
        <pc:spChg chg="mod">
          <ac:chgData name="Sagalowsky, Selin" userId="S::selin.sagalowsky@nyulangone.org::9be54335-ee71-4fe8-b292-c8d8bb8574b1" providerId="AD" clId="Web-{C361BF02-C4B7-AD82-B5CE-756932F06AD4}" dt="2024-03-29T12:12:54.801" v="41" actId="20577"/>
          <ac:spMkLst>
            <pc:docMk/>
            <pc:sldMk cId="2300300582" sldId="401"/>
            <ac:spMk id="2" creationId="{531AEC09-2E3D-BFA3-5BFE-9C66D0A5B17D}"/>
          </ac:spMkLst>
        </pc:spChg>
        <pc:spChg chg="mod">
          <ac:chgData name="Sagalowsky, Selin" userId="S::selin.sagalowsky@nyulangone.org::9be54335-ee71-4fe8-b292-c8d8bb8574b1" providerId="AD" clId="Web-{C361BF02-C4B7-AD82-B5CE-756932F06AD4}" dt="2024-03-29T12:13:02.192" v="42" actId="20577"/>
          <ac:spMkLst>
            <pc:docMk/>
            <pc:sldMk cId="2300300582" sldId="401"/>
            <ac:spMk id="3" creationId="{245EF324-6253-431D-523B-508135C9033E}"/>
          </ac:spMkLst>
        </pc:spChg>
        <pc:extLst>
          <p:ext xmlns:p="http://schemas.openxmlformats.org/presentationml/2006/main" uri="{D6D511B9-2390-475A-947B-AFAB55BFBCF1}">
            <pc226:cmChg xmlns:pc226="http://schemas.microsoft.com/office/powerpoint/2022/06/main/command" chg="add">
              <pc226:chgData name="Sagalowsky, Selin" userId="S::selin.sagalowsky@nyulangone.org::9be54335-ee71-4fe8-b292-c8d8bb8574b1" providerId="AD" clId="Web-{C361BF02-C4B7-AD82-B5CE-756932F06AD4}" dt="2024-03-29T12:13:10.646" v="43"/>
              <pc2:cmMkLst xmlns:pc2="http://schemas.microsoft.com/office/powerpoint/2019/9/main/command">
                <pc:docMk/>
                <pc:sldMk cId="2300300582" sldId="401"/>
                <pc2:cmMk id="{2C6474B9-E64D-4B41-9749-3E08D05D2F81}"/>
              </pc2:cmMkLst>
            </pc226:cmChg>
          </p:ext>
        </pc:extLst>
      </pc:sldChg>
    </pc:docChg>
  </pc:docChgLst>
  <pc:docChgLst>
    <pc:chgData name="Duncan, Ellen" userId="S::ellen.duncan@nyulangone.org::13f0eb4f-3c2d-4204-bfb7-9f2d693e5b64" providerId="AD" clId="Web-{6881CA31-D65E-FA27-46AE-9473CBED0CEB}"/>
    <pc:docChg chg="modSld">
      <pc:chgData name="Duncan, Ellen" userId="S::ellen.duncan@nyulangone.org::13f0eb4f-3c2d-4204-bfb7-9f2d693e5b64" providerId="AD" clId="Web-{6881CA31-D65E-FA27-46AE-9473CBED0CEB}" dt="2024-03-15T16:22:47.633" v="63" actId="1076"/>
      <pc:docMkLst>
        <pc:docMk/>
      </pc:docMkLst>
      <pc:sldChg chg="modSp modNotes">
        <pc:chgData name="Duncan, Ellen" userId="S::ellen.duncan@nyulangone.org::13f0eb4f-3c2d-4204-bfb7-9f2d693e5b64" providerId="AD" clId="Web-{6881CA31-D65E-FA27-46AE-9473CBED0CEB}" dt="2024-03-15T16:22:08.101" v="57"/>
        <pc:sldMkLst>
          <pc:docMk/>
          <pc:sldMk cId="2501830990" sldId="305"/>
        </pc:sldMkLst>
        <pc:spChg chg="mod">
          <ac:chgData name="Duncan, Ellen" userId="S::ellen.duncan@nyulangone.org::13f0eb4f-3c2d-4204-bfb7-9f2d693e5b64" providerId="AD" clId="Web-{6881CA31-D65E-FA27-46AE-9473CBED0CEB}" dt="2024-03-15T16:22:02.789" v="48" actId="20577"/>
          <ac:spMkLst>
            <pc:docMk/>
            <pc:sldMk cId="2501830990" sldId="305"/>
            <ac:spMk id="14" creationId="{00000000-0000-0000-0000-000000000000}"/>
          </ac:spMkLst>
        </pc:spChg>
      </pc:sldChg>
      <pc:sldChg chg="modSp">
        <pc:chgData name="Duncan, Ellen" userId="S::ellen.duncan@nyulangone.org::13f0eb4f-3c2d-4204-bfb7-9f2d693e5b64" providerId="AD" clId="Web-{6881CA31-D65E-FA27-46AE-9473CBED0CEB}" dt="2024-03-15T16:21:46.788" v="37" actId="20577"/>
        <pc:sldMkLst>
          <pc:docMk/>
          <pc:sldMk cId="3157483606" sldId="308"/>
        </pc:sldMkLst>
        <pc:spChg chg="mod">
          <ac:chgData name="Duncan, Ellen" userId="S::ellen.duncan@nyulangone.org::13f0eb4f-3c2d-4204-bfb7-9f2d693e5b64" providerId="AD" clId="Web-{6881CA31-D65E-FA27-46AE-9473CBED0CEB}" dt="2024-03-15T16:21:46.788" v="37" actId="20577"/>
          <ac:spMkLst>
            <pc:docMk/>
            <pc:sldMk cId="3157483606" sldId="308"/>
            <ac:spMk id="10" creationId="{00000000-0000-0000-0000-000000000000}"/>
          </ac:spMkLst>
        </pc:spChg>
      </pc:sldChg>
      <pc:sldChg chg="modSp">
        <pc:chgData name="Duncan, Ellen" userId="S::ellen.duncan@nyulangone.org::13f0eb4f-3c2d-4204-bfb7-9f2d693e5b64" providerId="AD" clId="Web-{6881CA31-D65E-FA27-46AE-9473CBED0CEB}" dt="2024-03-15T16:22:47.633" v="63" actId="1076"/>
        <pc:sldMkLst>
          <pc:docMk/>
          <pc:sldMk cId="715599888" sldId="314"/>
        </pc:sldMkLst>
        <pc:spChg chg="mod">
          <ac:chgData name="Duncan, Ellen" userId="S::ellen.duncan@nyulangone.org::13f0eb4f-3c2d-4204-bfb7-9f2d693e5b64" providerId="AD" clId="Web-{6881CA31-D65E-FA27-46AE-9473CBED0CEB}" dt="2024-03-15T16:22:47.633" v="63" actId="1076"/>
          <ac:spMkLst>
            <pc:docMk/>
            <pc:sldMk cId="715599888" sldId="314"/>
            <ac:spMk id="3" creationId="{82E4A652-B00D-7DFA-55D1-7BA188DB9466}"/>
          </ac:spMkLst>
        </pc:spChg>
      </pc:sldChg>
    </pc:docChg>
  </pc:docChgLst>
  <pc:docChgLst>
    <pc:chgData name="Sagalowsky, Selin" userId="S::selin.sagalowsky@nyulangone.org::9be54335-ee71-4fe8-b292-c8d8bb8574b1" providerId="AD" clId="Web-{94EAE6E9-EDE1-1E0C-32DD-35B22DFC02EB}"/>
    <pc:docChg chg="delSld modSld">
      <pc:chgData name="Sagalowsky, Selin" userId="S::selin.sagalowsky@nyulangone.org::9be54335-ee71-4fe8-b292-c8d8bb8574b1" providerId="AD" clId="Web-{94EAE6E9-EDE1-1E0C-32DD-35B22DFC02EB}" dt="2024-03-29T13:22:14.004" v="16" actId="20577"/>
      <pc:docMkLst>
        <pc:docMk/>
      </pc:docMkLst>
      <pc:sldChg chg="modSp">
        <pc:chgData name="Sagalowsky, Selin" userId="S::selin.sagalowsky@nyulangone.org::9be54335-ee71-4fe8-b292-c8d8bb8574b1" providerId="AD" clId="Web-{94EAE6E9-EDE1-1E0C-32DD-35B22DFC02EB}" dt="2024-03-29T13:22:14.004" v="16" actId="20577"/>
        <pc:sldMkLst>
          <pc:docMk/>
          <pc:sldMk cId="3168291106" sldId="300"/>
        </pc:sldMkLst>
        <pc:spChg chg="mod">
          <ac:chgData name="Sagalowsky, Selin" userId="S::selin.sagalowsky@nyulangone.org::9be54335-ee71-4fe8-b292-c8d8bb8574b1" providerId="AD" clId="Web-{94EAE6E9-EDE1-1E0C-32DD-35B22DFC02EB}" dt="2024-03-29T13:22:14.004" v="16" actId="20577"/>
          <ac:spMkLst>
            <pc:docMk/>
            <pc:sldMk cId="3168291106" sldId="300"/>
            <ac:spMk id="14" creationId="{00000000-0000-0000-0000-000000000000}"/>
          </ac:spMkLst>
        </pc:spChg>
      </pc:sldChg>
      <pc:sldChg chg="del">
        <pc:chgData name="Sagalowsky, Selin" userId="S::selin.sagalowsky@nyulangone.org::9be54335-ee71-4fe8-b292-c8d8bb8574b1" providerId="AD" clId="Web-{94EAE6E9-EDE1-1E0C-32DD-35B22DFC02EB}" dt="2024-03-29T13:21:52.378" v="0"/>
        <pc:sldMkLst>
          <pc:docMk/>
          <pc:sldMk cId="2300300582" sldId="401"/>
        </pc:sldMkLst>
      </pc:sldChg>
    </pc:docChg>
  </pc:docChgLst>
  <pc:docChgLst>
    <pc:chgData name="Duncan, Ellen" userId="13f0eb4f-3c2d-4204-bfb7-9f2d693e5b64" providerId="ADAL" clId="{0E9B0462-A80E-6C41-B853-2D4428506C92}"/>
    <pc:docChg chg="undo custSel addSld modSld">
      <pc:chgData name="Duncan, Ellen" userId="13f0eb4f-3c2d-4204-bfb7-9f2d693e5b64" providerId="ADAL" clId="{0E9B0462-A80E-6C41-B853-2D4428506C92}" dt="2023-10-28T00:11:35.911" v="3174"/>
      <pc:docMkLst>
        <pc:docMk/>
      </pc:docMkLst>
      <pc:sldChg chg="modSp mod">
        <pc:chgData name="Duncan, Ellen" userId="13f0eb4f-3c2d-4204-bfb7-9f2d693e5b64" providerId="ADAL" clId="{0E9B0462-A80E-6C41-B853-2D4428506C92}" dt="2023-10-28T00:11:35.911" v="3174"/>
        <pc:sldMkLst>
          <pc:docMk/>
          <pc:sldMk cId="245396161" sldId="260"/>
        </pc:sldMkLst>
        <pc:spChg chg="mod">
          <ac:chgData name="Duncan, Ellen" userId="13f0eb4f-3c2d-4204-bfb7-9f2d693e5b64" providerId="ADAL" clId="{0E9B0462-A80E-6C41-B853-2D4428506C92}" dt="2023-10-28T00:11:35.911" v="3174"/>
          <ac:spMkLst>
            <pc:docMk/>
            <pc:sldMk cId="245396161" sldId="260"/>
            <ac:spMk id="3" creationId="{93FE1B14-B1B8-4CB1-9044-D1DAFF38FE72}"/>
          </ac:spMkLst>
        </pc:spChg>
      </pc:sldChg>
      <pc:sldChg chg="modSp mod delCm modNotesTx">
        <pc:chgData name="Duncan, Ellen" userId="13f0eb4f-3c2d-4204-bfb7-9f2d693e5b64" providerId="ADAL" clId="{0E9B0462-A80E-6C41-B853-2D4428506C92}" dt="2023-10-28T00:11:20.414" v="3173" actId="20577"/>
        <pc:sldMkLst>
          <pc:docMk/>
          <pc:sldMk cId="2570269277" sldId="263"/>
        </pc:sldMkLst>
        <pc:spChg chg="mod">
          <ac:chgData name="Duncan, Ellen" userId="13f0eb4f-3c2d-4204-bfb7-9f2d693e5b64" providerId="ADAL" clId="{0E9B0462-A80E-6C41-B853-2D4428506C92}" dt="2023-10-28T00:11:13.256" v="3130" actId="20577"/>
          <ac:spMkLst>
            <pc:docMk/>
            <pc:sldMk cId="2570269277" sldId="263"/>
            <ac:spMk id="3" creationId="{F6E22F5D-1CB0-4E49-8321-D052EE985432}"/>
          </ac:spMkLst>
        </pc:spChg>
        <pc:extLst>
          <p:ext xmlns:p="http://schemas.openxmlformats.org/presentationml/2006/main" uri="{D6D511B9-2390-475A-947B-AFAB55BFBCF1}">
            <pc226:cmChg xmlns:pc226="http://schemas.microsoft.com/office/powerpoint/2022/06/main/command" chg="del">
              <pc226:chgData name="Duncan, Ellen" userId="13f0eb4f-3c2d-4204-bfb7-9f2d693e5b64" providerId="ADAL" clId="{0E9B0462-A80E-6C41-B853-2D4428506C92}" dt="2023-10-28T00:10:37.126" v="2921"/>
              <pc2:cmMkLst xmlns:pc2="http://schemas.microsoft.com/office/powerpoint/2019/9/main/command">
                <pc:docMk/>
                <pc:sldMk cId="2570269277" sldId="263"/>
                <pc2:cmMk id="{FC827D30-7785-441B-B576-6E191F5A88A8}"/>
              </pc2:cmMkLst>
            </pc226:cmChg>
          </p:ext>
        </pc:extLst>
      </pc:sldChg>
      <pc:sldChg chg="modSp mod modNotesTx">
        <pc:chgData name="Duncan, Ellen" userId="13f0eb4f-3c2d-4204-bfb7-9f2d693e5b64" providerId="ADAL" clId="{0E9B0462-A80E-6C41-B853-2D4428506C92}" dt="2023-10-28T00:09:04.861" v="2398" actId="20577"/>
        <pc:sldMkLst>
          <pc:docMk/>
          <pc:sldMk cId="267503431" sldId="269"/>
        </pc:sldMkLst>
        <pc:spChg chg="mod">
          <ac:chgData name="Duncan, Ellen" userId="13f0eb4f-3c2d-4204-bfb7-9f2d693e5b64" providerId="ADAL" clId="{0E9B0462-A80E-6C41-B853-2D4428506C92}" dt="2023-10-28T00:07:55.649" v="2172" actId="20577"/>
          <ac:spMkLst>
            <pc:docMk/>
            <pc:sldMk cId="267503431" sldId="269"/>
            <ac:spMk id="3" creationId="{3025F434-976C-4365-B5AA-B25172EC466B}"/>
          </ac:spMkLst>
        </pc:spChg>
      </pc:sldChg>
      <pc:sldChg chg="delCm modNotesTx">
        <pc:chgData name="Duncan, Ellen" userId="13f0eb4f-3c2d-4204-bfb7-9f2d693e5b64" providerId="ADAL" clId="{0E9B0462-A80E-6C41-B853-2D4428506C92}" dt="2023-10-28T00:06:26.200" v="1681" actId="20577"/>
        <pc:sldMkLst>
          <pc:docMk/>
          <pc:sldMk cId="2960214513" sldId="295"/>
        </pc:sldMkLst>
        <pc:extLst>
          <p:ext xmlns:p="http://schemas.openxmlformats.org/presentationml/2006/main" uri="{D6D511B9-2390-475A-947B-AFAB55BFBCF1}">
            <pc226:cmChg xmlns:pc226="http://schemas.microsoft.com/office/powerpoint/2022/06/main/command" chg="del">
              <pc226:chgData name="Duncan, Ellen" userId="13f0eb4f-3c2d-4204-bfb7-9f2d693e5b64" providerId="ADAL" clId="{0E9B0462-A80E-6C41-B853-2D4428506C92}" dt="2023-10-28T00:05:01.515" v="1218"/>
              <pc2:cmMkLst xmlns:pc2="http://schemas.microsoft.com/office/powerpoint/2019/9/main/command">
                <pc:docMk/>
                <pc:sldMk cId="2960214513" sldId="295"/>
                <pc2:cmMk id="{DD340E5F-7C55-4130-8604-D5D4D4479F58}"/>
              </pc2:cmMkLst>
            </pc226:cmChg>
          </p:ext>
        </pc:extLst>
      </pc:sldChg>
      <pc:sldChg chg="modNotesTx">
        <pc:chgData name="Duncan, Ellen" userId="13f0eb4f-3c2d-4204-bfb7-9f2d693e5b64" providerId="ADAL" clId="{0E9B0462-A80E-6C41-B853-2D4428506C92}" dt="2023-10-28T00:04:52.446" v="1199" actId="20577"/>
        <pc:sldMkLst>
          <pc:docMk/>
          <pc:sldMk cId="3217855894" sldId="296"/>
        </pc:sldMkLst>
      </pc:sldChg>
      <pc:sldChg chg="modNotesTx">
        <pc:chgData name="Duncan, Ellen" userId="13f0eb4f-3c2d-4204-bfb7-9f2d693e5b64" providerId="ADAL" clId="{0E9B0462-A80E-6C41-B853-2D4428506C92}" dt="2023-10-28T00:00:57.623" v="142" actId="20577"/>
        <pc:sldMkLst>
          <pc:docMk/>
          <pc:sldMk cId="2501830990" sldId="305"/>
        </pc:sldMkLst>
      </pc:sldChg>
      <pc:sldChg chg="modSp mod modNotesTx">
        <pc:chgData name="Duncan, Ellen" userId="13f0eb4f-3c2d-4204-bfb7-9f2d693e5b64" providerId="ADAL" clId="{0E9B0462-A80E-6C41-B853-2D4428506C92}" dt="2023-10-28T00:04:18.463" v="998" actId="20577"/>
        <pc:sldMkLst>
          <pc:docMk/>
          <pc:sldMk cId="3853581152" sldId="309"/>
        </pc:sldMkLst>
        <pc:spChg chg="mod">
          <ac:chgData name="Duncan, Ellen" userId="13f0eb4f-3c2d-4204-bfb7-9f2d693e5b64" providerId="ADAL" clId="{0E9B0462-A80E-6C41-B853-2D4428506C92}" dt="2023-10-28T00:03:17.828" v="648" actId="20577"/>
          <ac:spMkLst>
            <pc:docMk/>
            <pc:sldMk cId="3853581152" sldId="309"/>
            <ac:spMk id="14" creationId="{00000000-0000-0000-0000-000000000000}"/>
          </ac:spMkLst>
        </pc:spChg>
      </pc:sldChg>
      <pc:sldChg chg="delCm modNotesTx">
        <pc:chgData name="Duncan, Ellen" userId="13f0eb4f-3c2d-4204-bfb7-9f2d693e5b64" providerId="ADAL" clId="{0E9B0462-A80E-6C41-B853-2D4428506C92}" dt="2023-10-28T00:07:08.643" v="1892" actId="20577"/>
        <pc:sldMkLst>
          <pc:docMk/>
          <pc:sldMk cId="1237955407" sldId="310"/>
        </pc:sldMkLst>
        <pc:extLst>
          <p:ext xmlns:p="http://schemas.openxmlformats.org/presentationml/2006/main" uri="{D6D511B9-2390-475A-947B-AFAB55BFBCF1}">
            <pc226:cmChg xmlns:pc226="http://schemas.microsoft.com/office/powerpoint/2022/06/main/command" chg="del">
              <pc226:chgData name="Duncan, Ellen" userId="13f0eb4f-3c2d-4204-bfb7-9f2d693e5b64" providerId="ADAL" clId="{0E9B0462-A80E-6C41-B853-2D4428506C92}" dt="2023-10-28T00:06:30.576" v="1682"/>
              <pc2:cmMkLst xmlns:pc2="http://schemas.microsoft.com/office/powerpoint/2019/9/main/command">
                <pc:docMk/>
                <pc:sldMk cId="1237955407" sldId="310"/>
                <pc2:cmMk id="{E648FC81-31AA-4A7F-B02A-A88A4E9F6C2E}"/>
              </pc2:cmMkLst>
            </pc226:cmChg>
          </p:ext>
        </pc:extLst>
      </pc:sldChg>
      <pc:sldChg chg="delCm modNotesTx">
        <pc:chgData name="Duncan, Ellen" userId="13f0eb4f-3c2d-4204-bfb7-9f2d693e5b64" providerId="ADAL" clId="{0E9B0462-A80E-6C41-B853-2D4428506C92}" dt="2023-10-28T00:07:26.561" v="2004" actId="20577"/>
        <pc:sldMkLst>
          <pc:docMk/>
          <pc:sldMk cId="270997585" sldId="311"/>
        </pc:sldMkLst>
        <pc:extLst>
          <p:ext xmlns:p="http://schemas.openxmlformats.org/presentationml/2006/main" uri="{D6D511B9-2390-475A-947B-AFAB55BFBCF1}">
            <pc226:cmChg xmlns:pc226="http://schemas.microsoft.com/office/powerpoint/2022/06/main/command" chg="del">
              <pc226:chgData name="Duncan, Ellen" userId="13f0eb4f-3c2d-4204-bfb7-9f2d693e5b64" providerId="ADAL" clId="{0E9B0462-A80E-6C41-B853-2D4428506C92}" dt="2023-10-28T00:07:12.162" v="1893"/>
              <pc2:cmMkLst xmlns:pc2="http://schemas.microsoft.com/office/powerpoint/2019/9/main/command">
                <pc:docMk/>
                <pc:sldMk cId="270997585" sldId="311"/>
                <pc2:cmMk id="{85FDD1BB-7924-41AE-A55B-BB27844FE1A2}"/>
              </pc2:cmMkLst>
            </pc226:cmChg>
          </p:ext>
        </pc:extLst>
      </pc:sldChg>
      <pc:sldChg chg="add modNotesTx">
        <pc:chgData name="Duncan, Ellen" userId="13f0eb4f-3c2d-4204-bfb7-9f2d693e5b64" providerId="ADAL" clId="{0E9B0462-A80E-6C41-B853-2D4428506C92}" dt="2023-10-28T00:10:01.210" v="2757" actId="20577"/>
        <pc:sldMkLst>
          <pc:docMk/>
          <pc:sldMk cId="1127798271" sldId="398"/>
        </pc:sldMkLst>
      </pc:sldChg>
      <pc:sldChg chg="add modNotesTx">
        <pc:chgData name="Duncan, Ellen" userId="13f0eb4f-3c2d-4204-bfb7-9f2d693e5b64" providerId="ADAL" clId="{0E9B0462-A80E-6C41-B853-2D4428506C92}" dt="2023-10-28T00:10:11.182" v="2825" actId="20577"/>
        <pc:sldMkLst>
          <pc:docMk/>
          <pc:sldMk cId="2431484239" sldId="399"/>
        </pc:sldMkLst>
      </pc:sldChg>
      <pc:sldChg chg="add modNotesTx">
        <pc:chgData name="Duncan, Ellen" userId="13f0eb4f-3c2d-4204-bfb7-9f2d693e5b64" providerId="ADAL" clId="{0E9B0462-A80E-6C41-B853-2D4428506C92}" dt="2023-10-28T00:10:23.653" v="2920" actId="20577"/>
        <pc:sldMkLst>
          <pc:docMk/>
          <pc:sldMk cId="28464993" sldId="400"/>
        </pc:sldMkLst>
      </pc:sldChg>
    </pc:docChg>
  </pc:docChgLst>
  <pc:docChgLst>
    <pc:chgData name="Duncan, Ellen" userId="13f0eb4f-3c2d-4204-bfb7-9f2d693e5b64" providerId="ADAL" clId="{B6391D44-9351-114C-8835-A6D6D5FA13BD}"/>
    <pc:docChg chg="custSel modSld modMainMaster">
      <pc:chgData name="Duncan, Ellen" userId="13f0eb4f-3c2d-4204-bfb7-9f2d693e5b64" providerId="ADAL" clId="{B6391D44-9351-114C-8835-A6D6D5FA13BD}" dt="2024-03-11T16:32:40.586" v="34" actId="478"/>
      <pc:docMkLst>
        <pc:docMk/>
      </pc:docMkLst>
      <pc:sldChg chg="delSp modSp mod">
        <pc:chgData name="Duncan, Ellen" userId="13f0eb4f-3c2d-4204-bfb7-9f2d693e5b64" providerId="ADAL" clId="{B6391D44-9351-114C-8835-A6D6D5FA13BD}" dt="2024-03-11T16:32:30.374" v="33" actId="478"/>
        <pc:sldMkLst>
          <pc:docMk/>
          <pc:sldMk cId="3017569055" sldId="258"/>
        </pc:sldMkLst>
        <pc:spChg chg="del">
          <ac:chgData name="Duncan, Ellen" userId="13f0eb4f-3c2d-4204-bfb7-9f2d693e5b64" providerId="ADAL" clId="{B6391D44-9351-114C-8835-A6D6D5FA13BD}" dt="2024-03-11T16:32:30.374" v="33" actId="478"/>
          <ac:spMkLst>
            <pc:docMk/>
            <pc:sldMk cId="3017569055" sldId="258"/>
            <ac:spMk id="4" creationId="{D9EF6089-E582-7474-0099-D16306B1D31C}"/>
          </ac:spMkLst>
        </pc:spChg>
        <pc:spChg chg="mod">
          <ac:chgData name="Duncan, Ellen" userId="13f0eb4f-3c2d-4204-bfb7-9f2d693e5b64" providerId="ADAL" clId="{B6391D44-9351-114C-8835-A6D6D5FA13BD}" dt="2024-03-11T14:48:26.526" v="5"/>
          <ac:spMkLst>
            <pc:docMk/>
            <pc:sldMk cId="3017569055" sldId="258"/>
            <ac:spMk id="5" creationId="{F144A619-73EE-4C2B-A585-FBDE64404EA9}"/>
          </ac:spMkLst>
        </pc:spChg>
      </pc:sldChg>
      <pc:sldChg chg="delSp modSp mod">
        <pc:chgData name="Duncan, Ellen" userId="13f0eb4f-3c2d-4204-bfb7-9f2d693e5b64" providerId="ADAL" clId="{B6391D44-9351-114C-8835-A6D6D5FA13BD}" dt="2024-03-11T16:32:25.952" v="32" actId="478"/>
        <pc:sldMkLst>
          <pc:docMk/>
          <pc:sldMk cId="245396161" sldId="260"/>
        </pc:sldMkLst>
        <pc:spChg chg="del">
          <ac:chgData name="Duncan, Ellen" userId="13f0eb4f-3c2d-4204-bfb7-9f2d693e5b64" providerId="ADAL" clId="{B6391D44-9351-114C-8835-A6D6D5FA13BD}" dt="2024-03-11T16:32:25.952" v="32" actId="478"/>
          <ac:spMkLst>
            <pc:docMk/>
            <pc:sldMk cId="245396161" sldId="260"/>
            <ac:spMk id="4" creationId="{672219E1-B7AF-388E-2797-FE2B45857247}"/>
          </ac:spMkLst>
        </pc:spChg>
        <pc:spChg chg="mod">
          <ac:chgData name="Duncan, Ellen" userId="13f0eb4f-3c2d-4204-bfb7-9f2d693e5b64" providerId="ADAL" clId="{B6391D44-9351-114C-8835-A6D6D5FA13BD}" dt="2024-03-11T14:48:26.526" v="5"/>
          <ac:spMkLst>
            <pc:docMk/>
            <pc:sldMk cId="245396161" sldId="260"/>
            <ac:spMk id="5" creationId="{24C9A175-C11B-4547-962D-5141F6BB666D}"/>
          </ac:spMkLst>
        </pc:spChg>
      </pc:sldChg>
      <pc:sldChg chg="delSp modSp mod">
        <pc:chgData name="Duncan, Ellen" userId="13f0eb4f-3c2d-4204-bfb7-9f2d693e5b64" providerId="ADAL" clId="{B6391D44-9351-114C-8835-A6D6D5FA13BD}" dt="2024-03-11T16:32:22.649" v="31" actId="478"/>
        <pc:sldMkLst>
          <pc:docMk/>
          <pc:sldMk cId="3187644739" sldId="261"/>
        </pc:sldMkLst>
        <pc:spChg chg="del">
          <ac:chgData name="Duncan, Ellen" userId="13f0eb4f-3c2d-4204-bfb7-9f2d693e5b64" providerId="ADAL" clId="{B6391D44-9351-114C-8835-A6D6D5FA13BD}" dt="2024-03-11T16:32:22.649" v="31" actId="478"/>
          <ac:spMkLst>
            <pc:docMk/>
            <pc:sldMk cId="3187644739" sldId="261"/>
            <ac:spMk id="2" creationId="{4AF109AB-5CB7-9BB9-493B-EA3A57800664}"/>
          </ac:spMkLst>
        </pc:spChg>
        <pc:spChg chg="mod">
          <ac:chgData name="Duncan, Ellen" userId="13f0eb4f-3c2d-4204-bfb7-9f2d693e5b64" providerId="ADAL" clId="{B6391D44-9351-114C-8835-A6D6D5FA13BD}" dt="2024-03-11T14:48:26.526" v="5"/>
          <ac:spMkLst>
            <pc:docMk/>
            <pc:sldMk cId="3187644739" sldId="261"/>
            <ac:spMk id="3" creationId="{00000000-0000-0000-0000-000000000000}"/>
          </ac:spMkLst>
        </pc:spChg>
      </pc:sldChg>
      <pc:sldChg chg="modSp">
        <pc:chgData name="Duncan, Ellen" userId="13f0eb4f-3c2d-4204-bfb7-9f2d693e5b64" providerId="ADAL" clId="{B6391D44-9351-114C-8835-A6D6D5FA13BD}" dt="2024-03-11T14:48:26.526" v="5"/>
        <pc:sldMkLst>
          <pc:docMk/>
          <pc:sldMk cId="3584599968" sldId="262"/>
        </pc:sldMkLst>
        <pc:spChg chg="mod">
          <ac:chgData name="Duncan, Ellen" userId="13f0eb4f-3c2d-4204-bfb7-9f2d693e5b64" providerId="ADAL" clId="{B6391D44-9351-114C-8835-A6D6D5FA13BD}" dt="2024-03-11T14:48:26.526" v="5"/>
          <ac:spMkLst>
            <pc:docMk/>
            <pc:sldMk cId="3584599968" sldId="262"/>
            <ac:spMk id="15" creationId="{00000000-0000-0000-0000-000000000000}"/>
          </ac:spMkLst>
        </pc:spChg>
      </pc:sldChg>
      <pc:sldChg chg="delSp modSp mod">
        <pc:chgData name="Duncan, Ellen" userId="13f0eb4f-3c2d-4204-bfb7-9f2d693e5b64" providerId="ADAL" clId="{B6391D44-9351-114C-8835-A6D6D5FA13BD}" dt="2024-03-11T16:32:19.205" v="30" actId="478"/>
        <pc:sldMkLst>
          <pc:docMk/>
          <pc:sldMk cId="2570269277" sldId="263"/>
        </pc:sldMkLst>
        <pc:spChg chg="mod">
          <ac:chgData name="Duncan, Ellen" userId="13f0eb4f-3c2d-4204-bfb7-9f2d693e5b64" providerId="ADAL" clId="{B6391D44-9351-114C-8835-A6D6D5FA13BD}" dt="2024-03-11T14:48:26.526" v="5"/>
          <ac:spMkLst>
            <pc:docMk/>
            <pc:sldMk cId="2570269277" sldId="263"/>
            <ac:spMk id="2" creationId="{318C2E42-3D95-4A0E-B893-5689EF5D1002}"/>
          </ac:spMkLst>
        </pc:spChg>
        <pc:spChg chg="mod">
          <ac:chgData name="Duncan, Ellen" userId="13f0eb4f-3c2d-4204-bfb7-9f2d693e5b64" providerId="ADAL" clId="{B6391D44-9351-114C-8835-A6D6D5FA13BD}" dt="2024-03-11T14:48:26.526" v="5"/>
          <ac:spMkLst>
            <pc:docMk/>
            <pc:sldMk cId="2570269277" sldId="263"/>
            <ac:spMk id="3" creationId="{F6E22F5D-1CB0-4E49-8321-D052EE985432}"/>
          </ac:spMkLst>
        </pc:spChg>
        <pc:spChg chg="del">
          <ac:chgData name="Duncan, Ellen" userId="13f0eb4f-3c2d-4204-bfb7-9f2d693e5b64" providerId="ADAL" clId="{B6391D44-9351-114C-8835-A6D6D5FA13BD}" dt="2024-03-11T16:32:19.205" v="30" actId="478"/>
          <ac:spMkLst>
            <pc:docMk/>
            <pc:sldMk cId="2570269277" sldId="263"/>
            <ac:spMk id="4" creationId="{22578CE9-12D8-1AD7-0B9D-CE5B0992279C}"/>
          </ac:spMkLst>
        </pc:spChg>
        <pc:spChg chg="mod">
          <ac:chgData name="Duncan, Ellen" userId="13f0eb4f-3c2d-4204-bfb7-9f2d693e5b64" providerId="ADAL" clId="{B6391D44-9351-114C-8835-A6D6D5FA13BD}" dt="2024-03-11T14:48:26.526" v="5"/>
          <ac:spMkLst>
            <pc:docMk/>
            <pc:sldMk cId="2570269277" sldId="263"/>
            <ac:spMk id="5" creationId="{ADB6DC06-A7BB-47BF-98A7-F863210C07A3}"/>
          </ac:spMkLst>
        </pc:spChg>
      </pc:sldChg>
      <pc:sldChg chg="modSp">
        <pc:chgData name="Duncan, Ellen" userId="13f0eb4f-3c2d-4204-bfb7-9f2d693e5b64" providerId="ADAL" clId="{B6391D44-9351-114C-8835-A6D6D5FA13BD}" dt="2024-03-11T14:48:26.526" v="5"/>
        <pc:sldMkLst>
          <pc:docMk/>
          <pc:sldMk cId="4201050054" sldId="264"/>
        </pc:sldMkLst>
        <pc:spChg chg="mod">
          <ac:chgData name="Duncan, Ellen" userId="13f0eb4f-3c2d-4204-bfb7-9f2d693e5b64" providerId="ADAL" clId="{B6391D44-9351-114C-8835-A6D6D5FA13BD}" dt="2024-03-11T14:48:26.526" v="5"/>
          <ac:spMkLst>
            <pc:docMk/>
            <pc:sldMk cId="4201050054" sldId="264"/>
            <ac:spMk id="15" creationId="{00000000-0000-0000-0000-000000000000}"/>
          </ac:spMkLst>
        </pc:spChg>
      </pc:sldChg>
      <pc:sldChg chg="delSp modSp mod">
        <pc:chgData name="Duncan, Ellen" userId="13f0eb4f-3c2d-4204-bfb7-9f2d693e5b64" providerId="ADAL" clId="{B6391D44-9351-114C-8835-A6D6D5FA13BD}" dt="2024-03-11T16:32:14.918" v="29" actId="478"/>
        <pc:sldMkLst>
          <pc:docMk/>
          <pc:sldMk cId="4278517905" sldId="265"/>
        </pc:sldMkLst>
        <pc:spChg chg="del">
          <ac:chgData name="Duncan, Ellen" userId="13f0eb4f-3c2d-4204-bfb7-9f2d693e5b64" providerId="ADAL" clId="{B6391D44-9351-114C-8835-A6D6D5FA13BD}" dt="2024-03-11T16:32:14.918" v="29" actId="478"/>
          <ac:spMkLst>
            <pc:docMk/>
            <pc:sldMk cId="4278517905" sldId="265"/>
            <ac:spMk id="2" creationId="{6A0DE606-5922-4D50-220A-1939B1E5F3B2}"/>
          </ac:spMkLst>
        </pc:spChg>
        <pc:spChg chg="mod">
          <ac:chgData name="Duncan, Ellen" userId="13f0eb4f-3c2d-4204-bfb7-9f2d693e5b64" providerId="ADAL" clId="{B6391D44-9351-114C-8835-A6D6D5FA13BD}" dt="2024-03-11T14:48:26.526" v="5"/>
          <ac:spMkLst>
            <pc:docMk/>
            <pc:sldMk cId="4278517905" sldId="265"/>
            <ac:spMk id="7" creationId="{00000000-0000-0000-0000-000000000000}"/>
          </ac:spMkLst>
        </pc:spChg>
      </pc:sldChg>
      <pc:sldChg chg="delSp modSp mod">
        <pc:chgData name="Duncan, Ellen" userId="13f0eb4f-3c2d-4204-bfb7-9f2d693e5b64" providerId="ADAL" clId="{B6391D44-9351-114C-8835-A6D6D5FA13BD}" dt="2024-03-11T16:32:09.583" v="28" actId="478"/>
        <pc:sldMkLst>
          <pc:docMk/>
          <pc:sldMk cId="267503431" sldId="269"/>
        </pc:sldMkLst>
        <pc:spChg chg="del">
          <ac:chgData name="Duncan, Ellen" userId="13f0eb4f-3c2d-4204-bfb7-9f2d693e5b64" providerId="ADAL" clId="{B6391D44-9351-114C-8835-A6D6D5FA13BD}" dt="2024-03-11T16:32:09.583" v="28" actId="478"/>
          <ac:spMkLst>
            <pc:docMk/>
            <pc:sldMk cId="267503431" sldId="269"/>
            <ac:spMk id="4" creationId="{1B42E06F-A0E6-D95E-7C51-0B6D102ABDC2}"/>
          </ac:spMkLst>
        </pc:spChg>
        <pc:spChg chg="mod">
          <ac:chgData name="Duncan, Ellen" userId="13f0eb4f-3c2d-4204-bfb7-9f2d693e5b64" providerId="ADAL" clId="{B6391D44-9351-114C-8835-A6D6D5FA13BD}" dt="2024-03-11T14:48:26.526" v="5"/>
          <ac:spMkLst>
            <pc:docMk/>
            <pc:sldMk cId="267503431" sldId="269"/>
            <ac:spMk id="5" creationId="{F2FED725-C689-480E-A39F-A13E38706A51}"/>
          </ac:spMkLst>
        </pc:spChg>
      </pc:sldChg>
      <pc:sldChg chg="modSp">
        <pc:chgData name="Duncan, Ellen" userId="13f0eb4f-3c2d-4204-bfb7-9f2d693e5b64" providerId="ADAL" clId="{B6391D44-9351-114C-8835-A6D6D5FA13BD}" dt="2024-03-11T14:48:26.526" v="5"/>
        <pc:sldMkLst>
          <pc:docMk/>
          <pc:sldMk cId="2762859102" sldId="270"/>
        </pc:sldMkLst>
        <pc:spChg chg="mod">
          <ac:chgData name="Duncan, Ellen" userId="13f0eb4f-3c2d-4204-bfb7-9f2d693e5b64" providerId="ADAL" clId="{B6391D44-9351-114C-8835-A6D6D5FA13BD}" dt="2024-03-11T14:48:26.526" v="5"/>
          <ac:spMkLst>
            <pc:docMk/>
            <pc:sldMk cId="2762859102" sldId="270"/>
            <ac:spMk id="15" creationId="{00000000-0000-0000-0000-000000000000}"/>
          </ac:spMkLst>
        </pc:spChg>
      </pc:sldChg>
      <pc:sldChg chg="delSp modSp mod">
        <pc:chgData name="Duncan, Ellen" userId="13f0eb4f-3c2d-4204-bfb7-9f2d693e5b64" providerId="ADAL" clId="{B6391D44-9351-114C-8835-A6D6D5FA13BD}" dt="2024-03-11T16:32:05.458" v="27" actId="478"/>
        <pc:sldMkLst>
          <pc:docMk/>
          <pc:sldMk cId="614994627" sldId="271"/>
        </pc:sldMkLst>
        <pc:spChg chg="del">
          <ac:chgData name="Duncan, Ellen" userId="13f0eb4f-3c2d-4204-bfb7-9f2d693e5b64" providerId="ADAL" clId="{B6391D44-9351-114C-8835-A6D6D5FA13BD}" dt="2024-03-11T16:32:05.458" v="27" actId="478"/>
          <ac:spMkLst>
            <pc:docMk/>
            <pc:sldMk cId="614994627" sldId="271"/>
            <ac:spMk id="2" creationId="{93F8AED8-E5A7-BA7F-FCC5-AC44077A86A0}"/>
          </ac:spMkLst>
        </pc:spChg>
        <pc:spChg chg="mod">
          <ac:chgData name="Duncan, Ellen" userId="13f0eb4f-3c2d-4204-bfb7-9f2d693e5b64" providerId="ADAL" clId="{B6391D44-9351-114C-8835-A6D6D5FA13BD}" dt="2024-03-11T14:48:26.526" v="5"/>
          <ac:spMkLst>
            <pc:docMk/>
            <pc:sldMk cId="614994627" sldId="271"/>
            <ac:spMk id="7" creationId="{00000000-0000-0000-0000-000000000000}"/>
          </ac:spMkLst>
        </pc:spChg>
      </pc:sldChg>
      <pc:sldChg chg="delSp modSp mod">
        <pc:chgData name="Duncan, Ellen" userId="13f0eb4f-3c2d-4204-bfb7-9f2d693e5b64" providerId="ADAL" clId="{B6391D44-9351-114C-8835-A6D6D5FA13BD}" dt="2024-03-11T16:31:55.125" v="24" actId="478"/>
        <pc:sldMkLst>
          <pc:docMk/>
          <pc:sldMk cId="2960214513" sldId="295"/>
        </pc:sldMkLst>
        <pc:spChg chg="del">
          <ac:chgData name="Duncan, Ellen" userId="13f0eb4f-3c2d-4204-bfb7-9f2d693e5b64" providerId="ADAL" clId="{B6391D44-9351-114C-8835-A6D6D5FA13BD}" dt="2024-03-11T16:31:55.125" v="24" actId="478"/>
          <ac:spMkLst>
            <pc:docMk/>
            <pc:sldMk cId="2960214513" sldId="295"/>
            <ac:spMk id="3" creationId="{E78B14C1-1F16-9824-046C-92F9A2C31B17}"/>
          </ac:spMkLst>
        </pc:spChg>
        <pc:spChg chg="mod">
          <ac:chgData name="Duncan, Ellen" userId="13f0eb4f-3c2d-4204-bfb7-9f2d693e5b64" providerId="ADAL" clId="{B6391D44-9351-114C-8835-A6D6D5FA13BD}" dt="2024-03-11T14:48:26.526" v="5"/>
          <ac:spMkLst>
            <pc:docMk/>
            <pc:sldMk cId="2960214513" sldId="295"/>
            <ac:spMk id="7" creationId="{00000000-0000-0000-0000-000000000000}"/>
          </ac:spMkLst>
        </pc:spChg>
      </pc:sldChg>
      <pc:sldChg chg="delSp modSp mod">
        <pc:chgData name="Duncan, Ellen" userId="13f0eb4f-3c2d-4204-bfb7-9f2d693e5b64" providerId="ADAL" clId="{B6391D44-9351-114C-8835-A6D6D5FA13BD}" dt="2024-03-11T16:31:51.948" v="23" actId="478"/>
        <pc:sldMkLst>
          <pc:docMk/>
          <pc:sldMk cId="3217855894" sldId="296"/>
        </pc:sldMkLst>
        <pc:spChg chg="del">
          <ac:chgData name="Duncan, Ellen" userId="13f0eb4f-3c2d-4204-bfb7-9f2d693e5b64" providerId="ADAL" clId="{B6391D44-9351-114C-8835-A6D6D5FA13BD}" dt="2024-03-11T16:31:51.948" v="23" actId="478"/>
          <ac:spMkLst>
            <pc:docMk/>
            <pc:sldMk cId="3217855894" sldId="296"/>
            <ac:spMk id="4" creationId="{0053BB54-7591-FCE5-C364-9ECDC1B04D8D}"/>
          </ac:spMkLst>
        </pc:spChg>
        <pc:spChg chg="mod">
          <ac:chgData name="Duncan, Ellen" userId="13f0eb4f-3c2d-4204-bfb7-9f2d693e5b64" providerId="ADAL" clId="{B6391D44-9351-114C-8835-A6D6D5FA13BD}" dt="2024-03-11T14:48:26.526" v="5"/>
          <ac:spMkLst>
            <pc:docMk/>
            <pc:sldMk cId="3217855894" sldId="296"/>
            <ac:spMk id="5" creationId="{39FB0557-AA6D-4A0D-A1D3-3E8C0C180956}"/>
          </ac:spMkLst>
        </pc:spChg>
      </pc:sldChg>
      <pc:sldChg chg="modSp">
        <pc:chgData name="Duncan, Ellen" userId="13f0eb4f-3c2d-4204-bfb7-9f2d693e5b64" providerId="ADAL" clId="{B6391D44-9351-114C-8835-A6D6D5FA13BD}" dt="2024-03-11T14:48:26.526" v="5"/>
        <pc:sldMkLst>
          <pc:docMk/>
          <pc:sldMk cId="483309127" sldId="297"/>
        </pc:sldMkLst>
        <pc:spChg chg="mod">
          <ac:chgData name="Duncan, Ellen" userId="13f0eb4f-3c2d-4204-bfb7-9f2d693e5b64" providerId="ADAL" clId="{B6391D44-9351-114C-8835-A6D6D5FA13BD}" dt="2024-03-11T14:48:26.526" v="5"/>
          <ac:spMkLst>
            <pc:docMk/>
            <pc:sldMk cId="483309127" sldId="297"/>
            <ac:spMk id="15" creationId="{00000000-0000-0000-0000-000000000000}"/>
          </ac:spMkLst>
        </pc:spChg>
      </pc:sldChg>
      <pc:sldChg chg="delSp modSp mod">
        <pc:chgData name="Duncan, Ellen" userId="13f0eb4f-3c2d-4204-bfb7-9f2d693e5b64" providerId="ADAL" clId="{B6391D44-9351-114C-8835-A6D6D5FA13BD}" dt="2024-03-11T16:31:46.874" v="22" actId="478"/>
        <pc:sldMkLst>
          <pc:docMk/>
          <pc:sldMk cId="2743119629" sldId="298"/>
        </pc:sldMkLst>
        <pc:spChg chg="del">
          <ac:chgData name="Duncan, Ellen" userId="13f0eb4f-3c2d-4204-bfb7-9f2d693e5b64" providerId="ADAL" clId="{B6391D44-9351-114C-8835-A6D6D5FA13BD}" dt="2024-03-11T16:31:46.874" v="22" actId="478"/>
          <ac:spMkLst>
            <pc:docMk/>
            <pc:sldMk cId="2743119629" sldId="298"/>
            <ac:spMk id="2" creationId="{159469D0-8D2C-E3A4-44F7-AE78C656500A}"/>
          </ac:spMkLst>
        </pc:spChg>
        <pc:spChg chg="mod">
          <ac:chgData name="Duncan, Ellen" userId="13f0eb4f-3c2d-4204-bfb7-9f2d693e5b64" providerId="ADAL" clId="{B6391D44-9351-114C-8835-A6D6D5FA13BD}" dt="2024-03-11T14:48:26.526" v="5"/>
          <ac:spMkLst>
            <pc:docMk/>
            <pc:sldMk cId="2743119629" sldId="298"/>
            <ac:spMk id="7" creationId="{00000000-0000-0000-0000-000000000000}"/>
          </ac:spMkLst>
        </pc:spChg>
      </pc:sldChg>
      <pc:sldChg chg="delSp modSp mod">
        <pc:chgData name="Duncan, Ellen" userId="13f0eb4f-3c2d-4204-bfb7-9f2d693e5b64" providerId="ADAL" clId="{B6391D44-9351-114C-8835-A6D6D5FA13BD}" dt="2024-03-11T16:31:40.372" v="20" actId="478"/>
        <pc:sldMkLst>
          <pc:docMk/>
          <pc:sldMk cId="2501830990" sldId="305"/>
        </pc:sldMkLst>
        <pc:spChg chg="del">
          <ac:chgData name="Duncan, Ellen" userId="13f0eb4f-3c2d-4204-bfb7-9f2d693e5b64" providerId="ADAL" clId="{B6391D44-9351-114C-8835-A6D6D5FA13BD}" dt="2024-03-11T16:31:40.372" v="20" actId="478"/>
          <ac:spMkLst>
            <pc:docMk/>
            <pc:sldMk cId="2501830990" sldId="305"/>
            <ac:spMk id="2" creationId="{B6525422-2D6E-A069-0B65-85BA67F29C42}"/>
          </ac:spMkLst>
        </pc:spChg>
        <pc:spChg chg="mod">
          <ac:chgData name="Duncan, Ellen" userId="13f0eb4f-3c2d-4204-bfb7-9f2d693e5b64" providerId="ADAL" clId="{B6391D44-9351-114C-8835-A6D6D5FA13BD}" dt="2024-03-11T14:48:26.526" v="5"/>
          <ac:spMkLst>
            <pc:docMk/>
            <pc:sldMk cId="2501830990" sldId="305"/>
            <ac:spMk id="7" creationId="{00000000-0000-0000-0000-000000000000}"/>
          </ac:spMkLst>
        </pc:spChg>
      </pc:sldChg>
      <pc:sldChg chg="modSp">
        <pc:chgData name="Duncan, Ellen" userId="13f0eb4f-3c2d-4204-bfb7-9f2d693e5b64" providerId="ADAL" clId="{B6391D44-9351-114C-8835-A6D6D5FA13BD}" dt="2024-03-11T14:48:26.526" v="5"/>
        <pc:sldMkLst>
          <pc:docMk/>
          <pc:sldMk cId="3107070248" sldId="306"/>
        </pc:sldMkLst>
        <pc:spChg chg="mod">
          <ac:chgData name="Duncan, Ellen" userId="13f0eb4f-3c2d-4204-bfb7-9f2d693e5b64" providerId="ADAL" clId="{B6391D44-9351-114C-8835-A6D6D5FA13BD}" dt="2024-03-11T14:48:26.526" v="5"/>
          <ac:spMkLst>
            <pc:docMk/>
            <pc:sldMk cId="3107070248" sldId="306"/>
            <ac:spMk id="15" creationId="{00000000-0000-0000-0000-000000000000}"/>
          </ac:spMkLst>
        </pc:spChg>
      </pc:sldChg>
      <pc:sldChg chg="delSp modSp mod">
        <pc:chgData name="Duncan, Ellen" userId="13f0eb4f-3c2d-4204-bfb7-9f2d693e5b64" providerId="ADAL" clId="{B6391D44-9351-114C-8835-A6D6D5FA13BD}" dt="2024-03-11T16:31:36.204" v="19" actId="478"/>
        <pc:sldMkLst>
          <pc:docMk/>
          <pc:sldMk cId="2790284329" sldId="307"/>
        </pc:sldMkLst>
        <pc:spChg chg="mod">
          <ac:chgData name="Duncan, Ellen" userId="13f0eb4f-3c2d-4204-bfb7-9f2d693e5b64" providerId="ADAL" clId="{B6391D44-9351-114C-8835-A6D6D5FA13BD}" dt="2024-03-11T14:48:26.526" v="5"/>
          <ac:spMkLst>
            <pc:docMk/>
            <pc:sldMk cId="2790284329" sldId="307"/>
            <ac:spMk id="7" creationId="{00000000-0000-0000-0000-000000000000}"/>
          </ac:spMkLst>
        </pc:spChg>
        <pc:spChg chg="del">
          <ac:chgData name="Duncan, Ellen" userId="13f0eb4f-3c2d-4204-bfb7-9f2d693e5b64" providerId="ADAL" clId="{B6391D44-9351-114C-8835-A6D6D5FA13BD}" dt="2024-03-11T16:31:36.204" v="19" actId="478"/>
          <ac:spMkLst>
            <pc:docMk/>
            <pc:sldMk cId="2790284329" sldId="307"/>
            <ac:spMk id="8" creationId="{E5BA2668-3AAC-D0CC-E850-2313C0A4AA2F}"/>
          </ac:spMkLst>
        </pc:spChg>
      </pc:sldChg>
      <pc:sldChg chg="addSp delSp modSp mod">
        <pc:chgData name="Duncan, Ellen" userId="13f0eb4f-3c2d-4204-bfb7-9f2d693e5b64" providerId="ADAL" clId="{B6391D44-9351-114C-8835-A6D6D5FA13BD}" dt="2024-03-11T16:31:24.299" v="16" actId="1076"/>
        <pc:sldMkLst>
          <pc:docMk/>
          <pc:sldMk cId="3157483606" sldId="308"/>
        </pc:sldMkLst>
        <pc:spChg chg="add del mod">
          <ac:chgData name="Duncan, Ellen" userId="13f0eb4f-3c2d-4204-bfb7-9f2d693e5b64" providerId="ADAL" clId="{B6391D44-9351-114C-8835-A6D6D5FA13BD}" dt="2024-03-11T14:48:13.452" v="2"/>
          <ac:spMkLst>
            <pc:docMk/>
            <pc:sldMk cId="3157483606" sldId="308"/>
            <ac:spMk id="2" creationId="{3F1864FC-0ECB-265E-2951-BED7CF0D7DD1}"/>
          </ac:spMkLst>
        </pc:spChg>
        <pc:spChg chg="add del mod">
          <ac:chgData name="Duncan, Ellen" userId="13f0eb4f-3c2d-4204-bfb7-9f2d693e5b64" providerId="ADAL" clId="{B6391D44-9351-114C-8835-A6D6D5FA13BD}" dt="2024-03-11T14:48:31.634" v="8"/>
          <ac:spMkLst>
            <pc:docMk/>
            <pc:sldMk cId="3157483606" sldId="308"/>
            <ac:spMk id="3" creationId="{7B204262-B979-9BAD-50E4-6787E0AAFF35}"/>
          </ac:spMkLst>
        </pc:spChg>
        <pc:spChg chg="add del mod">
          <ac:chgData name="Duncan, Ellen" userId="13f0eb4f-3c2d-4204-bfb7-9f2d693e5b64" providerId="ADAL" clId="{B6391D44-9351-114C-8835-A6D6D5FA13BD}" dt="2024-03-11T16:31:19.534" v="15" actId="478"/>
          <ac:spMkLst>
            <pc:docMk/>
            <pc:sldMk cId="3157483606" sldId="308"/>
            <ac:spMk id="5" creationId="{8BD1AFA1-20B9-A371-B7EB-CB1B8B8CCFBD}"/>
          </ac:spMkLst>
        </pc:spChg>
        <pc:spChg chg="del">
          <ac:chgData name="Duncan, Ellen" userId="13f0eb4f-3c2d-4204-bfb7-9f2d693e5b64" providerId="ADAL" clId="{B6391D44-9351-114C-8835-A6D6D5FA13BD}" dt="2024-03-11T16:31:18.119" v="14" actId="478"/>
          <ac:spMkLst>
            <pc:docMk/>
            <pc:sldMk cId="3157483606" sldId="308"/>
            <ac:spMk id="6" creationId="{00000000-0000-0000-0000-000000000000}"/>
          </ac:spMkLst>
        </pc:spChg>
        <pc:spChg chg="mod">
          <ac:chgData name="Duncan, Ellen" userId="13f0eb4f-3c2d-4204-bfb7-9f2d693e5b64" providerId="ADAL" clId="{B6391D44-9351-114C-8835-A6D6D5FA13BD}" dt="2024-03-11T16:31:24.299" v="16" actId="1076"/>
          <ac:spMkLst>
            <pc:docMk/>
            <pc:sldMk cId="3157483606" sldId="308"/>
            <ac:spMk id="7" creationId="{71C7DDC3-85A4-4B25-AFC1-9A71D91B72A2}"/>
          </ac:spMkLst>
        </pc:spChg>
      </pc:sldChg>
      <pc:sldChg chg="delSp modSp mod">
        <pc:chgData name="Duncan, Ellen" userId="13f0eb4f-3c2d-4204-bfb7-9f2d693e5b64" providerId="ADAL" clId="{B6391D44-9351-114C-8835-A6D6D5FA13BD}" dt="2024-03-11T16:31:43.561" v="21" actId="478"/>
        <pc:sldMkLst>
          <pc:docMk/>
          <pc:sldMk cId="3853581152" sldId="309"/>
        </pc:sldMkLst>
        <pc:spChg chg="del">
          <ac:chgData name="Duncan, Ellen" userId="13f0eb4f-3c2d-4204-bfb7-9f2d693e5b64" providerId="ADAL" clId="{B6391D44-9351-114C-8835-A6D6D5FA13BD}" dt="2024-03-11T16:31:43.561" v="21" actId="478"/>
          <ac:spMkLst>
            <pc:docMk/>
            <pc:sldMk cId="3853581152" sldId="309"/>
            <ac:spMk id="3" creationId="{CEA247B2-7387-5C56-085C-40E556D14324}"/>
          </ac:spMkLst>
        </pc:spChg>
        <pc:spChg chg="mod">
          <ac:chgData name="Duncan, Ellen" userId="13f0eb4f-3c2d-4204-bfb7-9f2d693e5b64" providerId="ADAL" clId="{B6391D44-9351-114C-8835-A6D6D5FA13BD}" dt="2024-03-11T14:48:26.526" v="5"/>
          <ac:spMkLst>
            <pc:docMk/>
            <pc:sldMk cId="3853581152" sldId="309"/>
            <ac:spMk id="7" creationId="{00000000-0000-0000-0000-000000000000}"/>
          </ac:spMkLst>
        </pc:spChg>
      </pc:sldChg>
      <pc:sldChg chg="delSp modSp mod">
        <pc:chgData name="Duncan, Ellen" userId="13f0eb4f-3c2d-4204-bfb7-9f2d693e5b64" providerId="ADAL" clId="{B6391D44-9351-114C-8835-A6D6D5FA13BD}" dt="2024-03-11T16:31:57.913" v="25" actId="478"/>
        <pc:sldMkLst>
          <pc:docMk/>
          <pc:sldMk cId="1237955407" sldId="310"/>
        </pc:sldMkLst>
        <pc:spChg chg="del">
          <ac:chgData name="Duncan, Ellen" userId="13f0eb4f-3c2d-4204-bfb7-9f2d693e5b64" providerId="ADAL" clId="{B6391D44-9351-114C-8835-A6D6D5FA13BD}" dt="2024-03-11T16:31:57.913" v="25" actId="478"/>
          <ac:spMkLst>
            <pc:docMk/>
            <pc:sldMk cId="1237955407" sldId="310"/>
            <ac:spMk id="2" creationId="{979BCB06-8D9C-346C-A0B0-1FADE7FE6E6B}"/>
          </ac:spMkLst>
        </pc:spChg>
        <pc:spChg chg="mod">
          <ac:chgData name="Duncan, Ellen" userId="13f0eb4f-3c2d-4204-bfb7-9f2d693e5b64" providerId="ADAL" clId="{B6391D44-9351-114C-8835-A6D6D5FA13BD}" dt="2024-03-11T14:48:26.526" v="5"/>
          <ac:spMkLst>
            <pc:docMk/>
            <pc:sldMk cId="1237955407" sldId="310"/>
            <ac:spMk id="7" creationId="{00000000-0000-0000-0000-000000000000}"/>
          </ac:spMkLst>
        </pc:spChg>
        <pc:spChg chg="mod">
          <ac:chgData name="Duncan, Ellen" userId="13f0eb4f-3c2d-4204-bfb7-9f2d693e5b64" providerId="ADAL" clId="{B6391D44-9351-114C-8835-A6D6D5FA13BD}" dt="2024-03-11T14:48:26.526" v="5"/>
          <ac:spMkLst>
            <pc:docMk/>
            <pc:sldMk cId="1237955407" sldId="310"/>
            <ac:spMk id="9" creationId="{00000000-0000-0000-0000-000000000000}"/>
          </ac:spMkLst>
        </pc:spChg>
      </pc:sldChg>
      <pc:sldChg chg="delSp modSp mod">
        <pc:chgData name="Duncan, Ellen" userId="13f0eb4f-3c2d-4204-bfb7-9f2d693e5b64" providerId="ADAL" clId="{B6391D44-9351-114C-8835-A6D6D5FA13BD}" dt="2024-03-11T16:32:01.693" v="26" actId="478"/>
        <pc:sldMkLst>
          <pc:docMk/>
          <pc:sldMk cId="270997585" sldId="311"/>
        </pc:sldMkLst>
        <pc:spChg chg="del">
          <ac:chgData name="Duncan, Ellen" userId="13f0eb4f-3c2d-4204-bfb7-9f2d693e5b64" providerId="ADAL" clId="{B6391D44-9351-114C-8835-A6D6D5FA13BD}" dt="2024-03-11T16:32:01.693" v="26" actId="478"/>
          <ac:spMkLst>
            <pc:docMk/>
            <pc:sldMk cId="270997585" sldId="311"/>
            <ac:spMk id="3" creationId="{2A10EAF0-E20E-8F67-6F2E-A02641067143}"/>
          </ac:spMkLst>
        </pc:spChg>
        <pc:spChg chg="mod">
          <ac:chgData name="Duncan, Ellen" userId="13f0eb4f-3c2d-4204-bfb7-9f2d693e5b64" providerId="ADAL" clId="{B6391D44-9351-114C-8835-A6D6D5FA13BD}" dt="2024-03-11T14:48:26.526" v="5"/>
          <ac:spMkLst>
            <pc:docMk/>
            <pc:sldMk cId="270997585" sldId="311"/>
            <ac:spMk id="7" creationId="{00000000-0000-0000-0000-000000000000}"/>
          </ac:spMkLst>
        </pc:spChg>
        <pc:spChg chg="mod">
          <ac:chgData name="Duncan, Ellen" userId="13f0eb4f-3c2d-4204-bfb7-9f2d693e5b64" providerId="ADAL" clId="{B6391D44-9351-114C-8835-A6D6D5FA13BD}" dt="2024-03-11T14:48:26.526" v="5"/>
          <ac:spMkLst>
            <pc:docMk/>
            <pc:sldMk cId="270997585" sldId="311"/>
            <ac:spMk id="9" creationId="{00000000-0000-0000-0000-000000000000}"/>
          </ac:spMkLst>
        </pc:spChg>
      </pc:sldChg>
      <pc:sldChg chg="delSp modSp mod">
        <pc:chgData name="Duncan, Ellen" userId="13f0eb4f-3c2d-4204-bfb7-9f2d693e5b64" providerId="ADAL" clId="{B6391D44-9351-114C-8835-A6D6D5FA13BD}" dt="2024-03-11T16:31:28.388" v="17" actId="478"/>
        <pc:sldMkLst>
          <pc:docMk/>
          <pc:sldMk cId="2340474459" sldId="313"/>
        </pc:sldMkLst>
        <pc:spChg chg="mod">
          <ac:chgData name="Duncan, Ellen" userId="13f0eb4f-3c2d-4204-bfb7-9f2d693e5b64" providerId="ADAL" clId="{B6391D44-9351-114C-8835-A6D6D5FA13BD}" dt="2024-03-11T14:48:26.526" v="5"/>
          <ac:spMkLst>
            <pc:docMk/>
            <pc:sldMk cId="2340474459" sldId="313"/>
            <ac:spMk id="2" creationId="{AE62F8B3-52F4-4267-8390-7BEAA3A7A6AB}"/>
          </ac:spMkLst>
        </pc:spChg>
        <pc:spChg chg="mod">
          <ac:chgData name="Duncan, Ellen" userId="13f0eb4f-3c2d-4204-bfb7-9f2d693e5b64" providerId="ADAL" clId="{B6391D44-9351-114C-8835-A6D6D5FA13BD}" dt="2024-03-11T14:48:26.526" v="5"/>
          <ac:spMkLst>
            <pc:docMk/>
            <pc:sldMk cId="2340474459" sldId="313"/>
            <ac:spMk id="3" creationId="{A339D4AF-8E0D-40A6-88D1-785C765D71A9}"/>
          </ac:spMkLst>
        </pc:spChg>
        <pc:spChg chg="mod">
          <ac:chgData name="Duncan, Ellen" userId="13f0eb4f-3c2d-4204-bfb7-9f2d693e5b64" providerId="ADAL" clId="{B6391D44-9351-114C-8835-A6D6D5FA13BD}" dt="2024-03-11T14:48:26.526" v="5"/>
          <ac:spMkLst>
            <pc:docMk/>
            <pc:sldMk cId="2340474459" sldId="313"/>
            <ac:spMk id="5" creationId="{46897AAD-5FB7-468E-9C33-C242EAFC2D9F}"/>
          </ac:spMkLst>
        </pc:spChg>
        <pc:spChg chg="del">
          <ac:chgData name="Duncan, Ellen" userId="13f0eb4f-3c2d-4204-bfb7-9f2d693e5b64" providerId="ADAL" clId="{B6391D44-9351-114C-8835-A6D6D5FA13BD}" dt="2024-03-11T16:31:28.388" v="17" actId="478"/>
          <ac:spMkLst>
            <pc:docMk/>
            <pc:sldMk cId="2340474459" sldId="313"/>
            <ac:spMk id="9" creationId="{B5C304E8-CB8A-868D-E9AC-AD0A346E1BDF}"/>
          </ac:spMkLst>
        </pc:spChg>
      </pc:sldChg>
      <pc:sldChg chg="delSp modSp mod">
        <pc:chgData name="Duncan, Ellen" userId="13f0eb4f-3c2d-4204-bfb7-9f2d693e5b64" providerId="ADAL" clId="{B6391D44-9351-114C-8835-A6D6D5FA13BD}" dt="2024-03-11T16:31:33.667" v="18" actId="478"/>
        <pc:sldMkLst>
          <pc:docMk/>
          <pc:sldMk cId="715599888" sldId="314"/>
        </pc:sldMkLst>
        <pc:spChg chg="mod">
          <ac:chgData name="Duncan, Ellen" userId="13f0eb4f-3c2d-4204-bfb7-9f2d693e5b64" providerId="ADAL" clId="{B6391D44-9351-114C-8835-A6D6D5FA13BD}" dt="2024-03-11T14:48:26.526" v="5"/>
          <ac:spMkLst>
            <pc:docMk/>
            <pc:sldMk cId="715599888" sldId="314"/>
            <ac:spMk id="2" creationId="{82AA3C0D-CC4C-AA35-6367-FE90B033DCC5}"/>
          </ac:spMkLst>
        </pc:spChg>
        <pc:spChg chg="mod">
          <ac:chgData name="Duncan, Ellen" userId="13f0eb4f-3c2d-4204-bfb7-9f2d693e5b64" providerId="ADAL" clId="{B6391D44-9351-114C-8835-A6D6D5FA13BD}" dt="2024-03-11T14:48:26.526" v="5"/>
          <ac:spMkLst>
            <pc:docMk/>
            <pc:sldMk cId="715599888" sldId="314"/>
            <ac:spMk id="3" creationId="{82E4A652-B00D-7DFA-55D1-7BA188DB9466}"/>
          </ac:spMkLst>
        </pc:spChg>
        <pc:spChg chg="mod">
          <ac:chgData name="Duncan, Ellen" userId="13f0eb4f-3c2d-4204-bfb7-9f2d693e5b64" providerId="ADAL" clId="{B6391D44-9351-114C-8835-A6D6D5FA13BD}" dt="2024-03-11T14:48:26.526" v="5"/>
          <ac:spMkLst>
            <pc:docMk/>
            <pc:sldMk cId="715599888" sldId="314"/>
            <ac:spMk id="5" creationId="{738FCBBB-F571-3CC2-3C81-E208542661EC}"/>
          </ac:spMkLst>
        </pc:spChg>
        <pc:spChg chg="del">
          <ac:chgData name="Duncan, Ellen" userId="13f0eb4f-3c2d-4204-bfb7-9f2d693e5b64" providerId="ADAL" clId="{B6391D44-9351-114C-8835-A6D6D5FA13BD}" dt="2024-03-11T16:31:33.667" v="18" actId="478"/>
          <ac:spMkLst>
            <pc:docMk/>
            <pc:sldMk cId="715599888" sldId="314"/>
            <ac:spMk id="8" creationId="{CA4AF7A7-3831-0DDE-D200-9F9286180AAD}"/>
          </ac:spMkLst>
        </pc:spChg>
      </pc:sldChg>
      <pc:sldChg chg="modSp">
        <pc:chgData name="Duncan, Ellen" userId="13f0eb4f-3c2d-4204-bfb7-9f2d693e5b64" providerId="ADAL" clId="{B6391D44-9351-114C-8835-A6D6D5FA13BD}" dt="2024-03-11T14:48:26.526" v="5"/>
        <pc:sldMkLst>
          <pc:docMk/>
          <pc:sldMk cId="1127798271" sldId="398"/>
        </pc:sldMkLst>
        <pc:spChg chg="mod">
          <ac:chgData name="Duncan, Ellen" userId="13f0eb4f-3c2d-4204-bfb7-9f2d693e5b64" providerId="ADAL" clId="{B6391D44-9351-114C-8835-A6D6D5FA13BD}" dt="2024-03-11T14:48:26.526" v="5"/>
          <ac:spMkLst>
            <pc:docMk/>
            <pc:sldMk cId="1127798271" sldId="398"/>
            <ac:spMk id="3" creationId="{42E776EB-BAB5-3643-13F2-1D36B5CFF9F9}"/>
          </ac:spMkLst>
        </pc:spChg>
      </pc:sldChg>
      <pc:sldChg chg="modSp">
        <pc:chgData name="Duncan, Ellen" userId="13f0eb4f-3c2d-4204-bfb7-9f2d693e5b64" providerId="ADAL" clId="{B6391D44-9351-114C-8835-A6D6D5FA13BD}" dt="2024-03-11T14:48:26.526" v="5"/>
        <pc:sldMkLst>
          <pc:docMk/>
          <pc:sldMk cId="2431484239" sldId="399"/>
        </pc:sldMkLst>
        <pc:spChg chg="mod">
          <ac:chgData name="Duncan, Ellen" userId="13f0eb4f-3c2d-4204-bfb7-9f2d693e5b64" providerId="ADAL" clId="{B6391D44-9351-114C-8835-A6D6D5FA13BD}" dt="2024-03-11T14:48:26.526" v="5"/>
          <ac:spMkLst>
            <pc:docMk/>
            <pc:sldMk cId="2431484239" sldId="399"/>
            <ac:spMk id="3" creationId="{B907A617-20B2-98C2-DBF9-CF046B1B340B}"/>
          </ac:spMkLst>
        </pc:spChg>
      </pc:sldChg>
      <pc:sldChg chg="modSp">
        <pc:chgData name="Duncan, Ellen" userId="13f0eb4f-3c2d-4204-bfb7-9f2d693e5b64" providerId="ADAL" clId="{B6391D44-9351-114C-8835-A6D6D5FA13BD}" dt="2024-03-11T14:48:26.526" v="5"/>
        <pc:sldMkLst>
          <pc:docMk/>
          <pc:sldMk cId="28464993" sldId="400"/>
        </pc:sldMkLst>
        <pc:spChg chg="mod">
          <ac:chgData name="Duncan, Ellen" userId="13f0eb4f-3c2d-4204-bfb7-9f2d693e5b64" providerId="ADAL" clId="{B6391D44-9351-114C-8835-A6D6D5FA13BD}" dt="2024-03-11T14:48:26.526" v="5"/>
          <ac:spMkLst>
            <pc:docMk/>
            <pc:sldMk cId="28464993" sldId="400"/>
            <ac:spMk id="3" creationId="{BD4FA4BF-8E70-D26F-9728-5FF3C6FEB0EF}"/>
          </ac:spMkLst>
        </pc:spChg>
      </pc:sldChg>
      <pc:sldMasterChg chg="delSp mod modSldLayout">
        <pc:chgData name="Duncan, Ellen" userId="13f0eb4f-3c2d-4204-bfb7-9f2d693e5b64" providerId="ADAL" clId="{B6391D44-9351-114C-8835-A6D6D5FA13BD}" dt="2024-03-11T16:32:40.586" v="34" actId="478"/>
        <pc:sldMasterMkLst>
          <pc:docMk/>
          <pc:sldMasterMk cId="3915546746" sldId="2147483688"/>
        </pc:sldMasterMkLst>
        <pc:spChg chg="del">
          <ac:chgData name="Duncan, Ellen" userId="13f0eb4f-3c2d-4204-bfb7-9f2d693e5b64" providerId="ADAL" clId="{B6391D44-9351-114C-8835-A6D6D5FA13BD}" dt="2024-03-11T16:30:56.394" v="9" actId="478"/>
          <ac:spMkLst>
            <pc:docMk/>
            <pc:sldMasterMk cId="3915546746" sldId="2147483688"/>
            <ac:spMk id="11" creationId="{00000000-0000-0000-0000-000000000000}"/>
          </ac:spMkLst>
        </pc:spChg>
        <pc:sldLayoutChg chg="delSp mod">
          <pc:chgData name="Duncan, Ellen" userId="13f0eb4f-3c2d-4204-bfb7-9f2d693e5b64" providerId="ADAL" clId="{B6391D44-9351-114C-8835-A6D6D5FA13BD}" dt="2024-03-11T16:30:58.771" v="10" actId="478"/>
          <pc:sldLayoutMkLst>
            <pc:docMk/>
            <pc:sldMasterMk cId="3915546746" sldId="2147483688"/>
            <pc:sldLayoutMk cId="1802042577" sldId="2147483689"/>
          </pc:sldLayoutMkLst>
          <pc:spChg chg="del">
            <ac:chgData name="Duncan, Ellen" userId="13f0eb4f-3c2d-4204-bfb7-9f2d693e5b64" providerId="ADAL" clId="{B6391D44-9351-114C-8835-A6D6D5FA13BD}" dt="2024-03-11T16:30:58.771" v="10" actId="478"/>
            <ac:spMkLst>
              <pc:docMk/>
              <pc:sldMasterMk cId="3915546746" sldId="2147483688"/>
              <pc:sldLayoutMk cId="1802042577" sldId="2147483689"/>
              <ac:spMk id="7" creationId="{00000000-0000-0000-0000-000000000000}"/>
            </ac:spMkLst>
          </pc:spChg>
        </pc:sldLayoutChg>
        <pc:sldLayoutChg chg="delSp mod">
          <pc:chgData name="Duncan, Ellen" userId="13f0eb4f-3c2d-4204-bfb7-9f2d693e5b64" providerId="ADAL" clId="{B6391D44-9351-114C-8835-A6D6D5FA13BD}" dt="2024-03-11T16:31:03.835" v="11" actId="478"/>
          <pc:sldLayoutMkLst>
            <pc:docMk/>
            <pc:sldMasterMk cId="3915546746" sldId="2147483688"/>
            <pc:sldLayoutMk cId="1009804930" sldId="2147483691"/>
          </pc:sldLayoutMkLst>
          <pc:spChg chg="del">
            <ac:chgData name="Duncan, Ellen" userId="13f0eb4f-3c2d-4204-bfb7-9f2d693e5b64" providerId="ADAL" clId="{B6391D44-9351-114C-8835-A6D6D5FA13BD}" dt="2024-03-11T16:31:03.835" v="11" actId="478"/>
            <ac:spMkLst>
              <pc:docMk/>
              <pc:sldMasterMk cId="3915546746" sldId="2147483688"/>
              <pc:sldLayoutMk cId="1009804930" sldId="2147483691"/>
              <ac:spMk id="4" creationId="{00000000-0000-0000-0000-000000000000}"/>
            </ac:spMkLst>
          </pc:spChg>
        </pc:sldLayoutChg>
        <pc:sldLayoutChg chg="delSp mod">
          <pc:chgData name="Duncan, Ellen" userId="13f0eb4f-3c2d-4204-bfb7-9f2d693e5b64" providerId="ADAL" clId="{B6391D44-9351-114C-8835-A6D6D5FA13BD}" dt="2024-03-11T16:31:09.351" v="12" actId="478"/>
          <pc:sldLayoutMkLst>
            <pc:docMk/>
            <pc:sldMasterMk cId="3915546746" sldId="2147483688"/>
            <pc:sldLayoutMk cId="996940701" sldId="2147483695"/>
          </pc:sldLayoutMkLst>
          <pc:spChg chg="del">
            <ac:chgData name="Duncan, Ellen" userId="13f0eb4f-3c2d-4204-bfb7-9f2d693e5b64" providerId="ADAL" clId="{B6391D44-9351-114C-8835-A6D6D5FA13BD}" dt="2024-03-11T16:31:09.351" v="12" actId="478"/>
            <ac:spMkLst>
              <pc:docMk/>
              <pc:sldMasterMk cId="3915546746" sldId="2147483688"/>
              <pc:sldLayoutMk cId="996940701" sldId="2147483695"/>
              <ac:spMk id="7" creationId="{00000000-0000-0000-0000-000000000000}"/>
            </ac:spMkLst>
          </pc:spChg>
        </pc:sldLayoutChg>
        <pc:sldLayoutChg chg="delSp mod">
          <pc:chgData name="Duncan, Ellen" userId="13f0eb4f-3c2d-4204-bfb7-9f2d693e5b64" providerId="ADAL" clId="{B6391D44-9351-114C-8835-A6D6D5FA13BD}" dt="2024-03-11T16:31:12.074" v="13" actId="478"/>
          <pc:sldLayoutMkLst>
            <pc:docMk/>
            <pc:sldMasterMk cId="3915546746" sldId="2147483688"/>
            <pc:sldLayoutMk cId="3676879287" sldId="2147483696"/>
          </pc:sldLayoutMkLst>
          <pc:spChg chg="del">
            <ac:chgData name="Duncan, Ellen" userId="13f0eb4f-3c2d-4204-bfb7-9f2d693e5b64" providerId="ADAL" clId="{B6391D44-9351-114C-8835-A6D6D5FA13BD}" dt="2024-03-11T16:31:12.074" v="13" actId="478"/>
            <ac:spMkLst>
              <pc:docMk/>
              <pc:sldMasterMk cId="3915546746" sldId="2147483688"/>
              <pc:sldLayoutMk cId="3676879287" sldId="2147483696"/>
              <ac:spMk id="11" creationId="{00000000-0000-0000-0000-000000000000}"/>
            </ac:spMkLst>
          </pc:spChg>
        </pc:sldLayoutChg>
        <pc:sldLayoutChg chg="delSp mod">
          <pc:chgData name="Duncan, Ellen" userId="13f0eb4f-3c2d-4204-bfb7-9f2d693e5b64" providerId="ADAL" clId="{B6391D44-9351-114C-8835-A6D6D5FA13BD}" dt="2024-03-11T16:32:40.586" v="34" actId="478"/>
          <pc:sldLayoutMkLst>
            <pc:docMk/>
            <pc:sldMasterMk cId="3915546746" sldId="2147483688"/>
            <pc:sldLayoutMk cId="279760036" sldId="2147483698"/>
          </pc:sldLayoutMkLst>
          <pc:spChg chg="del">
            <ac:chgData name="Duncan, Ellen" userId="13f0eb4f-3c2d-4204-bfb7-9f2d693e5b64" providerId="ADAL" clId="{B6391D44-9351-114C-8835-A6D6D5FA13BD}" dt="2024-03-11T16:32:40.586" v="34" actId="478"/>
            <ac:spMkLst>
              <pc:docMk/>
              <pc:sldMasterMk cId="3915546746" sldId="2147483688"/>
              <pc:sldLayoutMk cId="279760036" sldId="2147483698"/>
              <ac:spMk id="6" creationId="{00000000-0000-0000-0000-000000000000}"/>
            </ac:spMkLst>
          </pc:spChg>
        </pc:sldLayoutChg>
      </pc:sldMasterChg>
    </pc:docChg>
  </pc:docChgLst>
  <pc:docChgLst>
    <pc:chgData name="Sagalowsky, Selin" userId="S::selin.sagalowsky@nyulangone.org::9be54335-ee71-4fe8-b292-c8d8bb8574b1" providerId="AD" clId="Web-{9615C04A-D5E1-F91A-5AE3-2607E7209022}"/>
    <pc:docChg chg="modSld">
      <pc:chgData name="Sagalowsky, Selin" userId="S::selin.sagalowsky@nyulangone.org::9be54335-ee71-4fe8-b292-c8d8bb8574b1" providerId="AD" clId="Web-{9615C04A-D5E1-F91A-5AE3-2607E7209022}" dt="2023-11-05T01:41:35.151" v="53"/>
      <pc:docMkLst>
        <pc:docMk/>
      </pc:docMkLst>
      <pc:sldChg chg="modNotes">
        <pc:chgData name="Sagalowsky, Selin" userId="S::selin.sagalowsky@nyulangone.org::9be54335-ee71-4fe8-b292-c8d8bb8574b1" providerId="AD" clId="Web-{9615C04A-D5E1-F91A-5AE3-2607E7209022}" dt="2023-11-05T01:41:08.353" v="49"/>
        <pc:sldMkLst>
          <pc:docMk/>
          <pc:sldMk cId="1127798271" sldId="398"/>
        </pc:sldMkLst>
      </pc:sldChg>
      <pc:sldChg chg="addSp delSp modSp">
        <pc:chgData name="Sagalowsky, Selin" userId="S::selin.sagalowsky@nyulangone.org::9be54335-ee71-4fe8-b292-c8d8bb8574b1" providerId="AD" clId="Web-{9615C04A-D5E1-F91A-5AE3-2607E7209022}" dt="2023-11-05T01:41:35.151" v="53"/>
        <pc:sldMkLst>
          <pc:docMk/>
          <pc:sldMk cId="28464993" sldId="400"/>
        </pc:sldMkLst>
        <pc:spChg chg="add del mod">
          <ac:chgData name="Sagalowsky, Selin" userId="S::selin.sagalowsky@nyulangone.org::9be54335-ee71-4fe8-b292-c8d8bb8574b1" providerId="AD" clId="Web-{9615C04A-D5E1-F91A-5AE3-2607E7209022}" dt="2023-11-05T01:41:35.151" v="53"/>
          <ac:spMkLst>
            <pc:docMk/>
            <pc:sldMk cId="28464993" sldId="400"/>
            <ac:spMk id="2" creationId="{168C1236-DEB5-3CF8-111C-59F55A6A2074}"/>
          </ac:spMkLst>
        </pc:spChg>
      </pc:sldChg>
    </pc:docChg>
  </pc:docChgLst>
  <pc:docChgLst>
    <pc:chgData name="Sagalowsky, Selin" userId="S::selin.sagalowsky@nyulangone.org::9be54335-ee71-4fe8-b292-c8d8bb8574b1" providerId="AD" clId="Web-{4A5BC7C4-88CA-CD02-CEB5-5E8022278A9F}"/>
    <pc:docChg chg="modSld">
      <pc:chgData name="Sagalowsky, Selin" userId="S::selin.sagalowsky@nyulangone.org::9be54335-ee71-4fe8-b292-c8d8bb8574b1" providerId="AD" clId="Web-{4A5BC7C4-88CA-CD02-CEB5-5E8022278A9F}" dt="2023-11-08T23:40:10.496" v="4"/>
      <pc:docMkLst>
        <pc:docMk/>
      </pc:docMkLst>
      <pc:sldChg chg="modNotes">
        <pc:chgData name="Sagalowsky, Selin" userId="S::selin.sagalowsky@nyulangone.org::9be54335-ee71-4fe8-b292-c8d8bb8574b1" providerId="AD" clId="Web-{4A5BC7C4-88CA-CD02-CEB5-5E8022278A9F}" dt="2023-11-08T23:40:10.496" v="4"/>
        <pc:sldMkLst>
          <pc:docMk/>
          <pc:sldMk cId="3853581152" sldId="309"/>
        </pc:sldMkLst>
      </pc:sldChg>
    </pc:docChg>
  </pc:docChgLst>
  <pc:docChgLst>
    <pc:chgData name="Duncan, Ellen" userId="S::ellen.duncan@nyulangone.org::13f0eb4f-3c2d-4204-bfb7-9f2d693e5b64" providerId="AD" clId="Web-{7DB3F8C8-7EEB-C076-4FC8-8845903BA8D7}"/>
    <pc:docChg chg="modSld">
      <pc:chgData name="Duncan, Ellen" userId="S::ellen.duncan@nyulangone.org::13f0eb4f-3c2d-4204-bfb7-9f2d693e5b64" providerId="AD" clId="Web-{7DB3F8C8-7EEB-C076-4FC8-8845903BA8D7}" dt="2023-09-06T20:46:38.281" v="3" actId="20577"/>
      <pc:docMkLst>
        <pc:docMk/>
      </pc:docMkLst>
      <pc:sldChg chg="modSp">
        <pc:chgData name="Duncan, Ellen" userId="S::ellen.duncan@nyulangone.org::13f0eb4f-3c2d-4204-bfb7-9f2d693e5b64" providerId="AD" clId="Web-{7DB3F8C8-7EEB-C076-4FC8-8845903BA8D7}" dt="2023-09-06T20:46:38.281" v="3" actId="20577"/>
        <pc:sldMkLst>
          <pc:docMk/>
          <pc:sldMk cId="2340474459" sldId="313"/>
        </pc:sldMkLst>
        <pc:spChg chg="mod">
          <ac:chgData name="Duncan, Ellen" userId="S::ellen.duncan@nyulangone.org::13f0eb4f-3c2d-4204-bfb7-9f2d693e5b64" providerId="AD" clId="Web-{7DB3F8C8-7EEB-C076-4FC8-8845903BA8D7}" dt="2023-09-06T20:46:38.281" v="3" actId="20577"/>
          <ac:spMkLst>
            <pc:docMk/>
            <pc:sldMk cId="2340474459" sldId="313"/>
            <ac:spMk id="2" creationId="{AE62F8B3-52F4-4267-8390-7BEAA3A7A6AB}"/>
          </ac:spMkLst>
        </pc:spChg>
      </pc:sldChg>
    </pc:docChg>
  </pc:docChgLst>
  <pc:docChgLst>
    <pc:chgData name="Duncan, Ellen" userId="S::ellen.duncan@nyulangone.org::13f0eb4f-3c2d-4204-bfb7-9f2d693e5b64" providerId="AD" clId="Web-{0D0AB5AF-E504-C60F-4435-9EE73AC35429}"/>
    <pc:docChg chg="modSld">
      <pc:chgData name="Duncan, Ellen" userId="S::ellen.duncan@nyulangone.org::13f0eb4f-3c2d-4204-bfb7-9f2d693e5b64" providerId="AD" clId="Web-{0D0AB5AF-E504-C60F-4435-9EE73AC35429}" dt="2023-10-27T23:59:06.121" v="2"/>
      <pc:docMkLst>
        <pc:docMk/>
      </pc:docMkLst>
      <pc:sldChg chg="modNotes">
        <pc:chgData name="Duncan, Ellen" userId="S::ellen.duncan@nyulangone.org::13f0eb4f-3c2d-4204-bfb7-9f2d693e5b64" providerId="AD" clId="Web-{0D0AB5AF-E504-C60F-4435-9EE73AC35429}" dt="2023-10-27T23:59:06.121" v="2"/>
        <pc:sldMkLst>
          <pc:docMk/>
          <pc:sldMk cId="2501830990" sldId="305"/>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36B3063-962D-47A3-8940-A4800DAE305B}" type="datetimeFigureOut">
              <a:rPr lang="en-US"/>
              <a:t>4/1/24</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4B58406-6D69-4953-9053-BB0A8E3B641C}" type="slidenum">
              <a:rPr lang="en-US"/>
              <a:t>‹#›</a:t>
            </a:fld>
            <a:endParaRPr lang="en-US"/>
          </a:p>
        </p:txBody>
      </p:sp>
    </p:spTree>
    <p:extLst>
      <p:ext uri="{BB962C8B-B14F-4D97-AF65-F5344CB8AC3E}">
        <p14:creationId xmlns:p14="http://schemas.microsoft.com/office/powerpoint/2010/main" val="344113189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C4B58406-6D69-4953-9053-BB0A8E3B641C}" type="slidenum">
              <a:rPr lang="en-US" smtClean="0"/>
              <a:t>2</a:t>
            </a:fld>
            <a:endParaRPr lang="en-US"/>
          </a:p>
        </p:txBody>
      </p:sp>
    </p:spTree>
    <p:extLst>
      <p:ext uri="{BB962C8B-B14F-4D97-AF65-F5344CB8AC3E}">
        <p14:creationId xmlns:p14="http://schemas.microsoft.com/office/powerpoint/2010/main" val="1815740594"/>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SPEAKER NOTES: </a:t>
            </a:r>
            <a:r>
              <a:rPr lang="en-US" dirty="0"/>
              <a:t>Here we see the example behaviors for the anxious personality type, as well as if/then statements that lead to either increasing or decreasing anxiety.</a:t>
            </a:r>
          </a:p>
        </p:txBody>
      </p:sp>
      <p:sp>
        <p:nvSpPr>
          <p:cNvPr id="4" name="Slide Number Placeholder 3"/>
          <p:cNvSpPr>
            <a:spLocks noGrp="1"/>
          </p:cNvSpPr>
          <p:nvPr>
            <p:ph type="sldNum" sz="quarter" idx="10"/>
          </p:nvPr>
        </p:nvSpPr>
        <p:spPr/>
        <p:txBody>
          <a:bodyPr/>
          <a:lstStyle/>
          <a:p>
            <a:fld id="{073B1B5E-696F-8A4A-9730-0DDA82FF5A34}" type="slidenum">
              <a:rPr lang="en-US" smtClean="0"/>
              <a:t>13</a:t>
            </a:fld>
            <a:endParaRPr lang="en-US"/>
          </a:p>
        </p:txBody>
      </p:sp>
    </p:spTree>
    <p:extLst>
      <p:ext uri="{BB962C8B-B14F-4D97-AF65-F5344CB8AC3E}">
        <p14:creationId xmlns:p14="http://schemas.microsoft.com/office/powerpoint/2010/main" val="1814257448"/>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SPEAKER NOTES: </a:t>
            </a:r>
            <a:r>
              <a:rPr lang="en-US" dirty="0"/>
              <a:t>This slide shows the quiet personality type, also with example behaviors and sample if/then statements.</a:t>
            </a:r>
          </a:p>
        </p:txBody>
      </p:sp>
      <p:sp>
        <p:nvSpPr>
          <p:cNvPr id="4" name="Slide Number Placeholder 3"/>
          <p:cNvSpPr>
            <a:spLocks noGrp="1"/>
          </p:cNvSpPr>
          <p:nvPr>
            <p:ph type="sldNum" sz="quarter" idx="10"/>
          </p:nvPr>
        </p:nvSpPr>
        <p:spPr/>
        <p:txBody>
          <a:bodyPr/>
          <a:lstStyle/>
          <a:p>
            <a:fld id="{073B1B5E-696F-8A4A-9730-0DDA82FF5A34}" type="slidenum">
              <a:rPr lang="en-US" smtClean="0"/>
              <a:t>14</a:t>
            </a:fld>
            <a:endParaRPr lang="en-US"/>
          </a:p>
        </p:txBody>
      </p:sp>
    </p:spTree>
    <p:extLst>
      <p:ext uri="{BB962C8B-B14F-4D97-AF65-F5344CB8AC3E}">
        <p14:creationId xmlns:p14="http://schemas.microsoft.com/office/powerpoint/2010/main" val="2021737736"/>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073B1B5E-696F-8A4A-9730-0DDA82FF5A34}" type="slidenum">
              <a:rPr lang="en-US" smtClean="0"/>
              <a:t>15</a:t>
            </a:fld>
            <a:endParaRPr lang="en-US"/>
          </a:p>
        </p:txBody>
      </p:sp>
    </p:spTree>
    <p:extLst>
      <p:ext uri="{BB962C8B-B14F-4D97-AF65-F5344CB8AC3E}">
        <p14:creationId xmlns:p14="http://schemas.microsoft.com/office/powerpoint/2010/main" val="2231096890"/>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SPEAKER NOTES: </a:t>
            </a:r>
            <a:r>
              <a:rPr lang="en-US" dirty="0"/>
              <a:t>The FPF curriculum describes key FPF behaviors, namely respect and value; information sharing; non-verbal communication; and summary and follow-up. In the next three slides, we will show the novel FPF Simulation Assessment Tool, which you will fill out after each simulation.</a:t>
            </a:r>
          </a:p>
        </p:txBody>
      </p:sp>
      <p:sp>
        <p:nvSpPr>
          <p:cNvPr id="4" name="Slide Number Placeholder 3"/>
          <p:cNvSpPr>
            <a:spLocks noGrp="1"/>
          </p:cNvSpPr>
          <p:nvPr>
            <p:ph type="sldNum" sz="quarter" idx="5"/>
          </p:nvPr>
        </p:nvSpPr>
        <p:spPr/>
        <p:txBody>
          <a:bodyPr/>
          <a:lstStyle/>
          <a:p>
            <a:fld id="{073B1B5E-696F-8A4A-9730-0DDA82FF5A34}" type="slidenum">
              <a:rPr lang="en-US" smtClean="0"/>
              <a:t>17</a:t>
            </a:fld>
            <a:endParaRPr lang="en-US"/>
          </a:p>
        </p:txBody>
      </p:sp>
    </p:spTree>
    <p:extLst>
      <p:ext uri="{BB962C8B-B14F-4D97-AF65-F5344CB8AC3E}">
        <p14:creationId xmlns:p14="http://schemas.microsoft.com/office/powerpoint/2010/main" val="867823062"/>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SPEAKER NOTES: </a:t>
            </a:r>
            <a:r>
              <a:rPr lang="en-US" dirty="0"/>
              <a:t>This part of the FPF-SAT shows each of the key behaviors within the respect and value domain, with behavioral anchors for each of the not done, partly done, and well done categories. Please note that there is a “not applicable/cannot evaluate” column for some of the behaviors. </a:t>
            </a:r>
          </a:p>
          <a:p>
            <a:endParaRPr lang="en-US" dirty="0">
              <a:ea typeface="Calibri"/>
              <a:cs typeface="Calibri"/>
            </a:endParaRPr>
          </a:p>
          <a:p>
            <a:r>
              <a:rPr lang="en-US" dirty="0">
                <a:ea typeface="Calibri"/>
                <a:cs typeface="Calibri"/>
              </a:rPr>
              <a:t>[Instructor should read through each behavioral anchor for each behavior in the FPF-SAT] </a:t>
            </a:r>
          </a:p>
        </p:txBody>
      </p:sp>
      <p:sp>
        <p:nvSpPr>
          <p:cNvPr id="4" name="Slide Number Placeholder 3"/>
          <p:cNvSpPr>
            <a:spLocks noGrp="1"/>
          </p:cNvSpPr>
          <p:nvPr>
            <p:ph type="sldNum" sz="quarter" idx="5"/>
          </p:nvPr>
        </p:nvSpPr>
        <p:spPr/>
        <p:txBody>
          <a:bodyPr/>
          <a:lstStyle/>
          <a:p>
            <a:fld id="{C4B58406-6D69-4953-9053-BB0A8E3B641C}" type="slidenum">
              <a:rPr lang="en-US" smtClean="0"/>
              <a:t>18</a:t>
            </a:fld>
            <a:endParaRPr lang="en-US"/>
          </a:p>
        </p:txBody>
      </p:sp>
    </p:spTree>
    <p:extLst>
      <p:ext uri="{BB962C8B-B14F-4D97-AF65-F5344CB8AC3E}">
        <p14:creationId xmlns:p14="http://schemas.microsoft.com/office/powerpoint/2010/main" val="163770488"/>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SPEAKER NOTES: </a:t>
            </a:r>
            <a:r>
              <a:rPr lang="en-US" dirty="0"/>
              <a:t>Here we see the behaviors within the information sharing domain.</a:t>
            </a:r>
          </a:p>
        </p:txBody>
      </p:sp>
      <p:sp>
        <p:nvSpPr>
          <p:cNvPr id="4" name="Slide Number Placeholder 3"/>
          <p:cNvSpPr>
            <a:spLocks noGrp="1"/>
          </p:cNvSpPr>
          <p:nvPr>
            <p:ph type="sldNum" sz="quarter" idx="5"/>
          </p:nvPr>
        </p:nvSpPr>
        <p:spPr/>
        <p:txBody>
          <a:bodyPr/>
          <a:lstStyle/>
          <a:p>
            <a:fld id="{C4B58406-6D69-4953-9053-BB0A8E3B641C}" type="slidenum">
              <a:rPr lang="en-US" smtClean="0"/>
              <a:t>19</a:t>
            </a:fld>
            <a:endParaRPr lang="en-US"/>
          </a:p>
        </p:txBody>
      </p:sp>
    </p:spTree>
    <p:extLst>
      <p:ext uri="{BB962C8B-B14F-4D97-AF65-F5344CB8AC3E}">
        <p14:creationId xmlns:p14="http://schemas.microsoft.com/office/powerpoint/2010/main" val="1393625977"/>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SPEAKER NOTES: </a:t>
            </a:r>
            <a:r>
              <a:rPr lang="en-US" dirty="0"/>
              <a:t>The last two domains are non-verbal communication and summary and follow-up, both shown here.</a:t>
            </a:r>
          </a:p>
        </p:txBody>
      </p:sp>
      <p:sp>
        <p:nvSpPr>
          <p:cNvPr id="4" name="Slide Number Placeholder 3"/>
          <p:cNvSpPr>
            <a:spLocks noGrp="1"/>
          </p:cNvSpPr>
          <p:nvPr>
            <p:ph type="sldNum" sz="quarter" idx="5"/>
          </p:nvPr>
        </p:nvSpPr>
        <p:spPr/>
        <p:txBody>
          <a:bodyPr/>
          <a:lstStyle/>
          <a:p>
            <a:fld id="{C4B58406-6D69-4953-9053-BB0A8E3B641C}" type="slidenum">
              <a:rPr lang="en-US" smtClean="0"/>
              <a:t>20</a:t>
            </a:fld>
            <a:endParaRPr lang="en-US"/>
          </a:p>
        </p:txBody>
      </p:sp>
    </p:spTree>
    <p:extLst>
      <p:ext uri="{BB962C8B-B14F-4D97-AF65-F5344CB8AC3E}">
        <p14:creationId xmlns:p14="http://schemas.microsoft.com/office/powerpoint/2010/main" val="2017798555"/>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073B1B5E-696F-8A4A-9730-0DDA82FF5A34}" type="slidenum">
              <a:rPr lang="en-US" smtClean="0"/>
              <a:t>21</a:t>
            </a:fld>
            <a:endParaRPr lang="en-US"/>
          </a:p>
        </p:txBody>
      </p:sp>
    </p:spTree>
    <p:extLst>
      <p:ext uri="{BB962C8B-B14F-4D97-AF65-F5344CB8AC3E}">
        <p14:creationId xmlns:p14="http://schemas.microsoft.com/office/powerpoint/2010/main" val="494688327"/>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SPEAKER NOTES: </a:t>
            </a:r>
            <a:r>
              <a:rPr lang="en-US" dirty="0"/>
              <a:t>You will now have a chance to read the scripted resuscitations provided with the training, along with the opportunity to role-play each of the family member personality types with an FPF</a:t>
            </a:r>
          </a:p>
        </p:txBody>
      </p:sp>
      <p:sp>
        <p:nvSpPr>
          <p:cNvPr id="4" name="Slide Number Placeholder 3"/>
          <p:cNvSpPr>
            <a:spLocks noGrp="1"/>
          </p:cNvSpPr>
          <p:nvPr>
            <p:ph type="sldNum" sz="quarter" idx="5"/>
          </p:nvPr>
        </p:nvSpPr>
        <p:spPr/>
        <p:txBody>
          <a:bodyPr/>
          <a:lstStyle/>
          <a:p>
            <a:fld id="{C4B58406-6D69-4953-9053-BB0A8E3B641C}" type="slidenum">
              <a:rPr lang="en-US" smtClean="0"/>
              <a:t>23</a:t>
            </a:fld>
            <a:endParaRPr lang="en-US"/>
          </a:p>
        </p:txBody>
      </p:sp>
    </p:spTree>
    <p:extLst>
      <p:ext uri="{BB962C8B-B14F-4D97-AF65-F5344CB8AC3E}">
        <p14:creationId xmlns:p14="http://schemas.microsoft.com/office/powerpoint/2010/main" val="1412420292"/>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073B1B5E-696F-8A4A-9730-0DDA82FF5A34}" type="slidenum">
              <a:rPr lang="en-US" smtClean="0"/>
              <a:t>27</a:t>
            </a:fld>
            <a:endParaRPr lang="en-US"/>
          </a:p>
        </p:txBody>
      </p:sp>
    </p:spTree>
    <p:extLst>
      <p:ext uri="{BB962C8B-B14F-4D97-AF65-F5344CB8AC3E}">
        <p14:creationId xmlns:p14="http://schemas.microsoft.com/office/powerpoint/2010/main" val="68693334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C4B58406-6D69-4953-9053-BB0A8E3B641C}" type="slidenum">
              <a:rPr lang="en-US" smtClean="0"/>
              <a:t>3</a:t>
            </a:fld>
            <a:endParaRPr lang="en-US"/>
          </a:p>
        </p:txBody>
      </p:sp>
    </p:spTree>
    <p:extLst>
      <p:ext uri="{BB962C8B-B14F-4D97-AF65-F5344CB8AC3E}">
        <p14:creationId xmlns:p14="http://schemas.microsoft.com/office/powerpoint/2010/main" val="357789608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cs typeface="Calibri"/>
            </a:endParaRPr>
          </a:p>
        </p:txBody>
      </p:sp>
      <p:sp>
        <p:nvSpPr>
          <p:cNvPr id="4" name="Slide Number Placeholder 3"/>
          <p:cNvSpPr>
            <a:spLocks noGrp="1"/>
          </p:cNvSpPr>
          <p:nvPr>
            <p:ph type="sldNum" sz="quarter" idx="10"/>
          </p:nvPr>
        </p:nvSpPr>
        <p:spPr/>
        <p:txBody>
          <a:bodyPr/>
          <a:lstStyle/>
          <a:p>
            <a:fld id="{073B1B5E-696F-8A4A-9730-0DDA82FF5A34}" type="slidenum">
              <a:rPr lang="en-US" smtClean="0"/>
              <a:t>4</a:t>
            </a:fld>
            <a:endParaRPr lang="en-US"/>
          </a:p>
        </p:txBody>
      </p:sp>
    </p:spTree>
    <p:extLst>
      <p:ext uri="{BB962C8B-B14F-4D97-AF65-F5344CB8AC3E}">
        <p14:creationId xmlns:p14="http://schemas.microsoft.com/office/powerpoint/2010/main" val="153034628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defRPr/>
            </a:pPr>
            <a:r>
              <a:rPr lang="en-US" dirty="0">
                <a:cs typeface="Calibri"/>
              </a:rPr>
              <a:t>SPEAKER NOTES: The goal of the curriculum is to empower all members of the healthcare team to serve as a family presence facilitator during pediatric resuscitations. In this curriculum, a family presence facilitator, or FPF, is defined as a designated staff member who is responsible for providing emotional support for patients and families during pediatric resuscitations. Simulated participants are crucial to helping us prepare our team members to serve in the FPF role.</a:t>
            </a:r>
          </a:p>
        </p:txBody>
      </p:sp>
      <p:sp>
        <p:nvSpPr>
          <p:cNvPr id="4" name="Slide Number Placeholder 3"/>
          <p:cNvSpPr>
            <a:spLocks noGrp="1"/>
          </p:cNvSpPr>
          <p:nvPr>
            <p:ph type="sldNum" sz="quarter" idx="10"/>
          </p:nvPr>
        </p:nvSpPr>
        <p:spPr/>
        <p:txBody>
          <a:bodyPr/>
          <a:lstStyle/>
          <a:p>
            <a:fld id="{073B1B5E-696F-8A4A-9730-0DDA82FF5A34}" type="slidenum">
              <a:rPr lang="en-US" smtClean="0"/>
              <a:t>6</a:t>
            </a:fld>
            <a:endParaRPr lang="en-US"/>
          </a:p>
        </p:txBody>
      </p:sp>
    </p:spTree>
    <p:extLst>
      <p:ext uri="{BB962C8B-B14F-4D97-AF65-F5344CB8AC3E}">
        <p14:creationId xmlns:p14="http://schemas.microsoft.com/office/powerpoint/2010/main" val="230475499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SPEAKER NOTES: By the end of this training, you should be able to articulate the purpose and benefits of the FPF role; list the 4 major components of the role; and demonstrate the key personality types in a role-play scenario</a:t>
            </a:r>
          </a:p>
          <a:p>
            <a:endParaRPr lang="en-US" dirty="0">
              <a:cs typeface="Calibri"/>
            </a:endParaRPr>
          </a:p>
        </p:txBody>
      </p:sp>
      <p:sp>
        <p:nvSpPr>
          <p:cNvPr id="4" name="Slide Number Placeholder 3"/>
          <p:cNvSpPr>
            <a:spLocks noGrp="1"/>
          </p:cNvSpPr>
          <p:nvPr>
            <p:ph type="sldNum" sz="quarter" idx="10"/>
          </p:nvPr>
        </p:nvSpPr>
        <p:spPr/>
        <p:txBody>
          <a:bodyPr/>
          <a:lstStyle/>
          <a:p>
            <a:fld id="{073B1B5E-696F-8A4A-9730-0DDA82FF5A34}" type="slidenum">
              <a:rPr lang="en-US" smtClean="0"/>
              <a:t>7</a:t>
            </a:fld>
            <a:endParaRPr lang="en-US"/>
          </a:p>
        </p:txBody>
      </p:sp>
    </p:spTree>
    <p:extLst>
      <p:ext uri="{BB962C8B-B14F-4D97-AF65-F5344CB8AC3E}">
        <p14:creationId xmlns:p14="http://schemas.microsoft.com/office/powerpoint/2010/main" val="230475499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spcBef>
                <a:spcPts val="800"/>
              </a:spcBef>
              <a:buFont typeface="Arial"/>
              <a:buNone/>
            </a:pPr>
            <a:r>
              <a:rPr lang="en-US" dirty="0">
                <a:cs typeface="Calibri"/>
              </a:rPr>
              <a:t>SPEAKER NOTES: </a:t>
            </a:r>
            <a:endParaRPr lang="en-US" strike="noStrike" dirty="0">
              <a:cs typeface="Calibri"/>
            </a:endParaRPr>
          </a:p>
          <a:p>
            <a:pPr marL="229870" indent="-229870">
              <a:spcBef>
                <a:spcPts val="800"/>
              </a:spcBef>
              <a:buFont typeface="Arial"/>
              <a:buChar char="•"/>
            </a:pPr>
            <a:r>
              <a:rPr lang="en-US" strike="noStrike" dirty="0">
                <a:cs typeface="Calibri"/>
              </a:rPr>
              <a:t>Each simulation begins with a 5-10 minute </a:t>
            </a:r>
            <a:r>
              <a:rPr lang="en-US" strike="noStrike" dirty="0" err="1">
                <a:cs typeface="Calibri"/>
              </a:rPr>
              <a:t>prebrief</a:t>
            </a:r>
            <a:r>
              <a:rPr lang="en-US" strike="noStrike" dirty="0">
                <a:cs typeface="Calibri"/>
              </a:rPr>
              <a:t>, in which the simulation leader creates an environment of psychological safety; asks learners to introduce themselves; describes the manikin capabilities; and answers any questions. This is followed by the simulation, which takes 15-20 minutes, in which the SP will portray a family member; and by </a:t>
            </a:r>
            <a:r>
              <a:rPr lang="en-US" dirty="0">
                <a:cs typeface="Calibri"/>
              </a:rPr>
              <a:t>a 30-40 min </a:t>
            </a:r>
            <a:r>
              <a:rPr lang="en-US" strike="noStrike" dirty="0">
                <a:cs typeface="Calibri"/>
              </a:rPr>
              <a:t>debrief, in which the team has the opportunity to share their emotional reactions and discuss the medical, teamwork, and communication aspects of the cases.</a:t>
            </a:r>
          </a:p>
          <a:p>
            <a:pPr marL="229870" indent="-229870">
              <a:spcBef>
                <a:spcPts val="800"/>
              </a:spcBef>
              <a:buFont typeface="Arial"/>
              <a:buChar char="•"/>
            </a:pPr>
            <a:endParaRPr lang="en-US" strike="noStrike" dirty="0">
              <a:cs typeface="Calibri"/>
            </a:endParaRPr>
          </a:p>
          <a:p>
            <a:pPr marL="229870" indent="-229870">
              <a:spcBef>
                <a:spcPts val="800"/>
              </a:spcBef>
              <a:buFont typeface="Arial"/>
              <a:buChar char="•"/>
            </a:pPr>
            <a:r>
              <a:rPr lang="en-US" strike="noStrike" dirty="0">
                <a:cs typeface="Calibri"/>
              </a:rPr>
              <a:t>There are multiple different types of cases, including those listed here.</a:t>
            </a:r>
          </a:p>
        </p:txBody>
      </p:sp>
      <p:sp>
        <p:nvSpPr>
          <p:cNvPr id="4" name="Slide Number Placeholder 3"/>
          <p:cNvSpPr>
            <a:spLocks noGrp="1"/>
          </p:cNvSpPr>
          <p:nvPr>
            <p:ph type="sldNum" sz="quarter" idx="10"/>
          </p:nvPr>
        </p:nvSpPr>
        <p:spPr/>
        <p:txBody>
          <a:bodyPr/>
          <a:lstStyle/>
          <a:p>
            <a:fld id="{073B1B5E-696F-8A4A-9730-0DDA82FF5A34}" type="slidenum">
              <a:rPr lang="en-US" smtClean="0"/>
              <a:t>8</a:t>
            </a:fld>
            <a:endParaRPr lang="en-US"/>
          </a:p>
        </p:txBody>
      </p:sp>
    </p:spTree>
    <p:extLst>
      <p:ext uri="{BB962C8B-B14F-4D97-AF65-F5344CB8AC3E}">
        <p14:creationId xmlns:p14="http://schemas.microsoft.com/office/powerpoint/2010/main" val="363046204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073B1B5E-696F-8A4A-9730-0DDA82FF5A34}" type="slidenum">
              <a:rPr lang="en-US" smtClean="0"/>
              <a:t>9</a:t>
            </a:fld>
            <a:endParaRPr lang="en-US"/>
          </a:p>
        </p:txBody>
      </p:sp>
    </p:spTree>
    <p:extLst>
      <p:ext uri="{BB962C8B-B14F-4D97-AF65-F5344CB8AC3E}">
        <p14:creationId xmlns:p14="http://schemas.microsoft.com/office/powerpoint/2010/main" val="340458147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spcBef>
                <a:spcPts val="600"/>
              </a:spcBef>
              <a:buFont typeface="Arial"/>
              <a:buNone/>
            </a:pPr>
            <a:r>
              <a:rPr lang="en-US" dirty="0">
                <a:cs typeface="Calibri"/>
              </a:rPr>
              <a:t>SPEAKER NOTES: </a:t>
            </a:r>
            <a:r>
              <a:rPr lang="en-US" b="0" strike="noStrike" dirty="0"/>
              <a:t>There are many different types of personality traits. For the purposes of this training and the curriculum, we will focus on three: agitated, anxious, and quiet.</a:t>
            </a:r>
            <a:endParaRPr lang="en-US" b="0" strike="noStrike" dirty="0">
              <a:cs typeface="Calibri"/>
            </a:endParaRPr>
          </a:p>
        </p:txBody>
      </p:sp>
      <p:sp>
        <p:nvSpPr>
          <p:cNvPr id="4" name="Slide Number Placeholder 3"/>
          <p:cNvSpPr>
            <a:spLocks noGrp="1"/>
          </p:cNvSpPr>
          <p:nvPr>
            <p:ph type="sldNum" sz="quarter" idx="5"/>
          </p:nvPr>
        </p:nvSpPr>
        <p:spPr/>
        <p:txBody>
          <a:bodyPr/>
          <a:lstStyle/>
          <a:p>
            <a:fld id="{073B1B5E-696F-8A4A-9730-0DDA82FF5A34}" type="slidenum">
              <a:rPr lang="en-US" smtClean="0"/>
              <a:t>11</a:t>
            </a:fld>
            <a:endParaRPr lang="en-US"/>
          </a:p>
        </p:txBody>
      </p:sp>
    </p:spTree>
    <p:extLst>
      <p:ext uri="{BB962C8B-B14F-4D97-AF65-F5344CB8AC3E}">
        <p14:creationId xmlns:p14="http://schemas.microsoft.com/office/powerpoint/2010/main" val="4167823958"/>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SPEAKER NOTES: </a:t>
            </a:r>
            <a:r>
              <a:rPr lang="en-US" dirty="0"/>
              <a:t>Each of the following slides describes behaviors that exemplify the different personality traits, in order of escalation. The righthand image provides if/then statements and the adjustment in emotional intensity based on the support provided by the FPF. </a:t>
            </a:r>
          </a:p>
          <a:p>
            <a:endParaRPr lang="en-US" dirty="0"/>
          </a:p>
          <a:p>
            <a:r>
              <a:rPr lang="en-US" dirty="0"/>
              <a:t>For the agitated family member, de-escalation may be required. The DESC technique is described here.</a:t>
            </a:r>
          </a:p>
        </p:txBody>
      </p:sp>
      <p:sp>
        <p:nvSpPr>
          <p:cNvPr id="4" name="Slide Number Placeholder 3"/>
          <p:cNvSpPr>
            <a:spLocks noGrp="1"/>
          </p:cNvSpPr>
          <p:nvPr>
            <p:ph type="sldNum" sz="quarter" idx="10"/>
          </p:nvPr>
        </p:nvSpPr>
        <p:spPr/>
        <p:txBody>
          <a:bodyPr/>
          <a:lstStyle/>
          <a:p>
            <a:fld id="{073B1B5E-696F-8A4A-9730-0DDA82FF5A34}" type="slidenum">
              <a:rPr lang="en-US" smtClean="0"/>
              <a:t>12</a:t>
            </a:fld>
            <a:endParaRPr lang="en-US"/>
          </a:p>
        </p:txBody>
      </p:sp>
    </p:spTree>
    <p:extLst>
      <p:ext uri="{BB962C8B-B14F-4D97-AF65-F5344CB8AC3E}">
        <p14:creationId xmlns:p14="http://schemas.microsoft.com/office/powerpoint/2010/main" val="253481126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preserve="1" userDrawn="1">
  <p:cSld name="Title Slide">
    <p:bg>
      <p:bgPr>
        <a:solidFill>
          <a:schemeClr val="tx2"/>
        </a:solidFill>
        <a:effectLst/>
      </p:bgPr>
    </p:bg>
    <p:spTree>
      <p:nvGrpSpPr>
        <p:cNvPr id="1" name=""/>
        <p:cNvGrpSpPr/>
        <p:nvPr/>
      </p:nvGrpSpPr>
      <p:grpSpPr>
        <a:xfrm>
          <a:off x="0" y="0"/>
          <a:ext cx="0" cy="0"/>
          <a:chOff x="0" y="0"/>
          <a:chExt cx="0" cy="0"/>
        </a:xfrm>
      </p:grpSpPr>
      <p:sp>
        <p:nvSpPr>
          <p:cNvPr id="2" name="Title 1"/>
          <p:cNvSpPr>
            <a:spLocks noGrp="1"/>
          </p:cNvSpPr>
          <p:nvPr>
            <p:ph type="ctrTitle"/>
          </p:nvPr>
        </p:nvSpPr>
        <p:spPr>
          <a:xfrm>
            <a:off x="907725" y="2267713"/>
            <a:ext cx="10674676" cy="1294372"/>
          </a:xfrm>
        </p:spPr>
        <p:txBody>
          <a:bodyPr wrap="square" lIns="0" tIns="0" rIns="0" bIns="0" anchor="ctr" anchorCtr="0">
            <a:spAutoFit/>
          </a:bodyPr>
          <a:lstStyle>
            <a:lvl1pPr>
              <a:lnSpc>
                <a:spcPct val="83000"/>
              </a:lnSpc>
              <a:defRPr sz="5067" cap="all">
                <a:solidFill>
                  <a:srgbClr val="FFFFFF"/>
                </a:solidFill>
              </a:defRPr>
            </a:lvl1pPr>
          </a:lstStyle>
          <a:p>
            <a:r>
              <a:rPr lang="en-US"/>
              <a:t>Click to edit Master title style</a:t>
            </a:r>
          </a:p>
        </p:txBody>
      </p:sp>
      <p:sp>
        <p:nvSpPr>
          <p:cNvPr id="3" name="Subtitle 2"/>
          <p:cNvSpPr>
            <a:spLocks noGrp="1"/>
          </p:cNvSpPr>
          <p:nvPr>
            <p:ph type="subTitle" idx="1" hasCustomPrompt="1"/>
          </p:nvPr>
        </p:nvSpPr>
        <p:spPr>
          <a:xfrm>
            <a:off x="907725" y="4076835"/>
            <a:ext cx="10674676" cy="328231"/>
          </a:xfrm>
        </p:spPr>
        <p:txBody>
          <a:bodyPr wrap="square" lIns="0" tIns="0" rIns="0" bIns="0" anchor="ctr" anchorCtr="0">
            <a:spAutoFit/>
          </a:bodyPr>
          <a:lstStyle>
            <a:lvl1pPr marL="0" indent="0" algn="l">
              <a:buNone/>
              <a:defRPr sz="2133" b="0" i="0" cap="none" baseline="0">
                <a:solidFill>
                  <a:srgbClr val="FFFFFF"/>
                </a:solidFill>
              </a:defRPr>
            </a:lvl1pPr>
            <a:lvl2pPr marL="457189" indent="0" algn="ctr">
              <a:buNone/>
              <a:defRPr>
                <a:solidFill>
                  <a:schemeClr val="tx1">
                    <a:tint val="75000"/>
                  </a:schemeClr>
                </a:solidFill>
              </a:defRPr>
            </a:lvl2pPr>
            <a:lvl3pPr marL="914377" indent="0" algn="ctr">
              <a:buNone/>
              <a:defRPr>
                <a:solidFill>
                  <a:schemeClr val="tx1">
                    <a:tint val="75000"/>
                  </a:schemeClr>
                </a:solidFill>
              </a:defRPr>
            </a:lvl3pPr>
            <a:lvl4pPr marL="1371566" indent="0" algn="ctr">
              <a:buNone/>
              <a:defRPr>
                <a:solidFill>
                  <a:schemeClr val="tx1">
                    <a:tint val="75000"/>
                  </a:schemeClr>
                </a:solidFill>
              </a:defRPr>
            </a:lvl4pPr>
            <a:lvl5pPr marL="1828754" indent="0" algn="ctr">
              <a:buNone/>
              <a:defRPr>
                <a:solidFill>
                  <a:schemeClr val="tx1">
                    <a:tint val="75000"/>
                  </a:schemeClr>
                </a:solidFill>
              </a:defRPr>
            </a:lvl5pPr>
            <a:lvl6pPr marL="2285943" indent="0" algn="ctr">
              <a:buNone/>
              <a:defRPr>
                <a:solidFill>
                  <a:schemeClr val="tx1">
                    <a:tint val="75000"/>
                  </a:schemeClr>
                </a:solidFill>
              </a:defRPr>
            </a:lvl6pPr>
            <a:lvl7pPr marL="2743131" indent="0" algn="ctr">
              <a:buNone/>
              <a:defRPr>
                <a:solidFill>
                  <a:schemeClr val="tx1">
                    <a:tint val="75000"/>
                  </a:schemeClr>
                </a:solidFill>
              </a:defRPr>
            </a:lvl7pPr>
            <a:lvl8pPr marL="3200320" indent="0" algn="ctr">
              <a:buNone/>
              <a:defRPr>
                <a:solidFill>
                  <a:schemeClr val="tx1">
                    <a:tint val="75000"/>
                  </a:schemeClr>
                </a:solidFill>
              </a:defRPr>
            </a:lvl8pPr>
            <a:lvl9pPr marL="3657509" indent="0" algn="ctr">
              <a:buNone/>
              <a:defRPr>
                <a:solidFill>
                  <a:schemeClr val="tx1">
                    <a:tint val="75000"/>
                  </a:schemeClr>
                </a:solidFill>
              </a:defRPr>
            </a:lvl9pPr>
          </a:lstStyle>
          <a:p>
            <a:r>
              <a:rPr lang="en-US"/>
              <a:t>Click To Edit Master Subtitle Style</a:t>
            </a:r>
          </a:p>
        </p:txBody>
      </p:sp>
      <p:sp>
        <p:nvSpPr>
          <p:cNvPr id="17" name="Picture Placeholder 16"/>
          <p:cNvSpPr>
            <a:spLocks noGrp="1"/>
          </p:cNvSpPr>
          <p:nvPr>
            <p:ph type="pic" sz="quarter" idx="10"/>
          </p:nvPr>
        </p:nvSpPr>
        <p:spPr>
          <a:xfrm>
            <a:off x="496" y="5071677"/>
            <a:ext cx="12189389" cy="1789499"/>
          </a:xfrm>
          <a:custGeom>
            <a:avLst/>
            <a:gdLst>
              <a:gd name="connsiteX0" fmla="*/ 0 w 9142413"/>
              <a:gd name="connsiteY0" fmla="*/ 0 h 1360841"/>
              <a:gd name="connsiteX1" fmla="*/ 9142413 w 9142413"/>
              <a:gd name="connsiteY1" fmla="*/ 0 h 1360841"/>
              <a:gd name="connsiteX2" fmla="*/ 9142413 w 9142413"/>
              <a:gd name="connsiteY2" fmla="*/ 1360841 h 1360841"/>
              <a:gd name="connsiteX3" fmla="*/ 0 w 9142413"/>
              <a:gd name="connsiteY3" fmla="*/ 1360841 h 1360841"/>
              <a:gd name="connsiteX4" fmla="*/ 0 w 9142413"/>
              <a:gd name="connsiteY4" fmla="*/ 0 h 1360841"/>
              <a:gd name="connsiteX0" fmla="*/ 0 w 9142413"/>
              <a:gd name="connsiteY0" fmla="*/ 0 h 1360841"/>
              <a:gd name="connsiteX1" fmla="*/ 702469 w 9142413"/>
              <a:gd name="connsiteY1" fmla="*/ 1147 h 1360841"/>
              <a:gd name="connsiteX2" fmla="*/ 9142413 w 9142413"/>
              <a:gd name="connsiteY2" fmla="*/ 0 h 1360841"/>
              <a:gd name="connsiteX3" fmla="*/ 9142413 w 9142413"/>
              <a:gd name="connsiteY3" fmla="*/ 1360841 h 1360841"/>
              <a:gd name="connsiteX4" fmla="*/ 0 w 9142413"/>
              <a:gd name="connsiteY4" fmla="*/ 1360841 h 1360841"/>
              <a:gd name="connsiteX5" fmla="*/ 0 w 9142413"/>
              <a:gd name="connsiteY5" fmla="*/ 0 h 1360841"/>
              <a:gd name="connsiteX0" fmla="*/ 0 w 9142413"/>
              <a:gd name="connsiteY0" fmla="*/ 1234 h 1362075"/>
              <a:gd name="connsiteX1" fmla="*/ 702469 w 9142413"/>
              <a:gd name="connsiteY1" fmla="*/ 2381 h 1362075"/>
              <a:gd name="connsiteX2" fmla="*/ 966788 w 9142413"/>
              <a:gd name="connsiteY2" fmla="*/ 0 h 1362075"/>
              <a:gd name="connsiteX3" fmla="*/ 9142413 w 9142413"/>
              <a:gd name="connsiteY3" fmla="*/ 1234 h 1362075"/>
              <a:gd name="connsiteX4" fmla="*/ 9142413 w 9142413"/>
              <a:gd name="connsiteY4" fmla="*/ 1362075 h 1362075"/>
              <a:gd name="connsiteX5" fmla="*/ 0 w 9142413"/>
              <a:gd name="connsiteY5" fmla="*/ 1362075 h 1362075"/>
              <a:gd name="connsiteX6" fmla="*/ 0 w 9142413"/>
              <a:gd name="connsiteY6" fmla="*/ 1234 h 1362075"/>
              <a:gd name="connsiteX0" fmla="*/ 0 w 9142413"/>
              <a:gd name="connsiteY0" fmla="*/ 1234 h 1362075"/>
              <a:gd name="connsiteX1" fmla="*/ 702469 w 9142413"/>
              <a:gd name="connsiteY1" fmla="*/ 2381 h 1362075"/>
              <a:gd name="connsiteX2" fmla="*/ 838200 w 9142413"/>
              <a:gd name="connsiteY2" fmla="*/ 2381 h 1362075"/>
              <a:gd name="connsiteX3" fmla="*/ 966788 w 9142413"/>
              <a:gd name="connsiteY3" fmla="*/ 0 h 1362075"/>
              <a:gd name="connsiteX4" fmla="*/ 9142413 w 9142413"/>
              <a:gd name="connsiteY4" fmla="*/ 1234 h 1362075"/>
              <a:gd name="connsiteX5" fmla="*/ 9142413 w 9142413"/>
              <a:gd name="connsiteY5" fmla="*/ 1362075 h 1362075"/>
              <a:gd name="connsiteX6" fmla="*/ 0 w 9142413"/>
              <a:gd name="connsiteY6" fmla="*/ 1362075 h 1362075"/>
              <a:gd name="connsiteX7" fmla="*/ 0 w 9142413"/>
              <a:gd name="connsiteY7" fmla="*/ 1234 h 1362075"/>
              <a:gd name="connsiteX0" fmla="*/ 0 w 9142413"/>
              <a:gd name="connsiteY0" fmla="*/ 1234 h 1362075"/>
              <a:gd name="connsiteX1" fmla="*/ 702469 w 9142413"/>
              <a:gd name="connsiteY1" fmla="*/ 2381 h 1362075"/>
              <a:gd name="connsiteX2" fmla="*/ 826294 w 9142413"/>
              <a:gd name="connsiteY2" fmla="*/ 240506 h 1362075"/>
              <a:gd name="connsiteX3" fmla="*/ 966788 w 9142413"/>
              <a:gd name="connsiteY3" fmla="*/ 0 h 1362075"/>
              <a:gd name="connsiteX4" fmla="*/ 9142413 w 9142413"/>
              <a:gd name="connsiteY4" fmla="*/ 1234 h 1362075"/>
              <a:gd name="connsiteX5" fmla="*/ 9142413 w 9142413"/>
              <a:gd name="connsiteY5" fmla="*/ 1362075 h 1362075"/>
              <a:gd name="connsiteX6" fmla="*/ 0 w 9142413"/>
              <a:gd name="connsiteY6" fmla="*/ 1362075 h 1362075"/>
              <a:gd name="connsiteX7" fmla="*/ 0 w 9142413"/>
              <a:gd name="connsiteY7" fmla="*/ 1234 h 1362075"/>
              <a:gd name="connsiteX0" fmla="*/ 0 w 9142413"/>
              <a:gd name="connsiteY0" fmla="*/ 1234 h 1362075"/>
              <a:gd name="connsiteX1" fmla="*/ 702469 w 9142413"/>
              <a:gd name="connsiteY1" fmla="*/ 2381 h 1362075"/>
              <a:gd name="connsiteX2" fmla="*/ 826294 w 9142413"/>
              <a:gd name="connsiteY2" fmla="*/ 235744 h 1362075"/>
              <a:gd name="connsiteX3" fmla="*/ 966788 w 9142413"/>
              <a:gd name="connsiteY3" fmla="*/ 0 h 1362075"/>
              <a:gd name="connsiteX4" fmla="*/ 9142413 w 9142413"/>
              <a:gd name="connsiteY4" fmla="*/ 1234 h 1362075"/>
              <a:gd name="connsiteX5" fmla="*/ 9142413 w 9142413"/>
              <a:gd name="connsiteY5" fmla="*/ 1362075 h 1362075"/>
              <a:gd name="connsiteX6" fmla="*/ 0 w 9142413"/>
              <a:gd name="connsiteY6" fmla="*/ 1362075 h 1362075"/>
              <a:gd name="connsiteX7" fmla="*/ 0 w 9142413"/>
              <a:gd name="connsiteY7" fmla="*/ 1234 h 1362075"/>
              <a:gd name="connsiteX0" fmla="*/ 0 w 9142413"/>
              <a:gd name="connsiteY0" fmla="*/ 1234 h 1362075"/>
              <a:gd name="connsiteX1" fmla="*/ 702469 w 9142413"/>
              <a:gd name="connsiteY1" fmla="*/ 2381 h 1362075"/>
              <a:gd name="connsiteX2" fmla="*/ 842962 w 9142413"/>
              <a:gd name="connsiteY2" fmla="*/ 235744 h 1362075"/>
              <a:gd name="connsiteX3" fmla="*/ 966788 w 9142413"/>
              <a:gd name="connsiteY3" fmla="*/ 0 h 1362075"/>
              <a:gd name="connsiteX4" fmla="*/ 9142413 w 9142413"/>
              <a:gd name="connsiteY4" fmla="*/ 1234 h 1362075"/>
              <a:gd name="connsiteX5" fmla="*/ 9142413 w 9142413"/>
              <a:gd name="connsiteY5" fmla="*/ 1362075 h 1362075"/>
              <a:gd name="connsiteX6" fmla="*/ 0 w 9142413"/>
              <a:gd name="connsiteY6" fmla="*/ 1362075 h 1362075"/>
              <a:gd name="connsiteX7" fmla="*/ 0 w 9142413"/>
              <a:gd name="connsiteY7" fmla="*/ 1234 h 1362075"/>
              <a:gd name="connsiteX0" fmla="*/ 0 w 9142413"/>
              <a:gd name="connsiteY0" fmla="*/ 1234 h 1362075"/>
              <a:gd name="connsiteX1" fmla="*/ 702469 w 9142413"/>
              <a:gd name="connsiteY1" fmla="*/ 2381 h 1362075"/>
              <a:gd name="connsiteX2" fmla="*/ 842962 w 9142413"/>
              <a:gd name="connsiteY2" fmla="*/ 235744 h 1362075"/>
              <a:gd name="connsiteX3" fmla="*/ 966788 w 9142413"/>
              <a:gd name="connsiteY3" fmla="*/ 0 h 1362075"/>
              <a:gd name="connsiteX4" fmla="*/ 9142413 w 9142413"/>
              <a:gd name="connsiteY4" fmla="*/ 1234 h 1362075"/>
              <a:gd name="connsiteX5" fmla="*/ 9142413 w 9142413"/>
              <a:gd name="connsiteY5" fmla="*/ 1362075 h 1362075"/>
              <a:gd name="connsiteX6" fmla="*/ 0 w 9142413"/>
              <a:gd name="connsiteY6" fmla="*/ 1362075 h 1362075"/>
              <a:gd name="connsiteX7" fmla="*/ 0 w 9142413"/>
              <a:gd name="connsiteY7" fmla="*/ 1234 h 1362075"/>
              <a:gd name="connsiteX0" fmla="*/ 0 w 9142413"/>
              <a:gd name="connsiteY0" fmla="*/ 1234 h 1362075"/>
              <a:gd name="connsiteX1" fmla="*/ 702469 w 9142413"/>
              <a:gd name="connsiteY1" fmla="*/ 2381 h 1362075"/>
              <a:gd name="connsiteX2" fmla="*/ 842962 w 9142413"/>
              <a:gd name="connsiteY2" fmla="*/ 235744 h 1362075"/>
              <a:gd name="connsiteX3" fmla="*/ 966788 w 9142413"/>
              <a:gd name="connsiteY3" fmla="*/ 0 h 1362075"/>
              <a:gd name="connsiteX4" fmla="*/ 9142413 w 9142413"/>
              <a:gd name="connsiteY4" fmla="*/ 1234 h 1362075"/>
              <a:gd name="connsiteX5" fmla="*/ 9142413 w 9142413"/>
              <a:gd name="connsiteY5" fmla="*/ 1362075 h 1362075"/>
              <a:gd name="connsiteX6" fmla="*/ 0 w 9142413"/>
              <a:gd name="connsiteY6" fmla="*/ 1362075 h 1362075"/>
              <a:gd name="connsiteX7" fmla="*/ 0 w 9142413"/>
              <a:gd name="connsiteY7" fmla="*/ 1234 h 1362075"/>
              <a:gd name="connsiteX0" fmla="*/ 0 w 9142413"/>
              <a:gd name="connsiteY0" fmla="*/ 1234 h 1362075"/>
              <a:gd name="connsiteX1" fmla="*/ 702469 w 9142413"/>
              <a:gd name="connsiteY1" fmla="*/ 2381 h 1362075"/>
              <a:gd name="connsiteX2" fmla="*/ 842962 w 9142413"/>
              <a:gd name="connsiteY2" fmla="*/ 235744 h 1362075"/>
              <a:gd name="connsiteX3" fmla="*/ 966788 w 9142413"/>
              <a:gd name="connsiteY3" fmla="*/ 0 h 1362075"/>
              <a:gd name="connsiteX4" fmla="*/ 9142413 w 9142413"/>
              <a:gd name="connsiteY4" fmla="*/ 1234 h 1362075"/>
              <a:gd name="connsiteX5" fmla="*/ 9142413 w 9142413"/>
              <a:gd name="connsiteY5" fmla="*/ 1362075 h 1362075"/>
              <a:gd name="connsiteX6" fmla="*/ 0 w 9142413"/>
              <a:gd name="connsiteY6" fmla="*/ 1362075 h 1362075"/>
              <a:gd name="connsiteX7" fmla="*/ 0 w 9142413"/>
              <a:gd name="connsiteY7" fmla="*/ 1234 h 1362075"/>
              <a:gd name="connsiteX0" fmla="*/ 0 w 9142413"/>
              <a:gd name="connsiteY0" fmla="*/ 1234 h 1362075"/>
              <a:gd name="connsiteX1" fmla="*/ 702469 w 9142413"/>
              <a:gd name="connsiteY1" fmla="*/ 2381 h 1362075"/>
              <a:gd name="connsiteX2" fmla="*/ 842962 w 9142413"/>
              <a:gd name="connsiteY2" fmla="*/ 235744 h 1362075"/>
              <a:gd name="connsiteX3" fmla="*/ 966788 w 9142413"/>
              <a:gd name="connsiteY3" fmla="*/ 0 h 1362075"/>
              <a:gd name="connsiteX4" fmla="*/ 9142413 w 9142413"/>
              <a:gd name="connsiteY4" fmla="*/ 1234 h 1362075"/>
              <a:gd name="connsiteX5" fmla="*/ 9142413 w 9142413"/>
              <a:gd name="connsiteY5" fmla="*/ 1362075 h 1362075"/>
              <a:gd name="connsiteX6" fmla="*/ 0 w 9142413"/>
              <a:gd name="connsiteY6" fmla="*/ 1362075 h 1362075"/>
              <a:gd name="connsiteX7" fmla="*/ 0 w 9142413"/>
              <a:gd name="connsiteY7" fmla="*/ 1234 h 1362075"/>
              <a:gd name="connsiteX0" fmla="*/ 0 w 9142413"/>
              <a:gd name="connsiteY0" fmla="*/ 1234 h 1362075"/>
              <a:gd name="connsiteX1" fmla="*/ 702469 w 9142413"/>
              <a:gd name="connsiteY1" fmla="*/ 2381 h 1362075"/>
              <a:gd name="connsiteX2" fmla="*/ 842962 w 9142413"/>
              <a:gd name="connsiteY2" fmla="*/ 235744 h 1362075"/>
              <a:gd name="connsiteX3" fmla="*/ 966788 w 9142413"/>
              <a:gd name="connsiteY3" fmla="*/ 0 h 1362075"/>
              <a:gd name="connsiteX4" fmla="*/ 9142413 w 9142413"/>
              <a:gd name="connsiteY4" fmla="*/ 1234 h 1362075"/>
              <a:gd name="connsiteX5" fmla="*/ 9142413 w 9142413"/>
              <a:gd name="connsiteY5" fmla="*/ 1362075 h 1362075"/>
              <a:gd name="connsiteX6" fmla="*/ 0 w 9142413"/>
              <a:gd name="connsiteY6" fmla="*/ 1362075 h 1362075"/>
              <a:gd name="connsiteX7" fmla="*/ 0 w 9142413"/>
              <a:gd name="connsiteY7" fmla="*/ 1234 h 1362075"/>
              <a:gd name="connsiteX0" fmla="*/ 0 w 9142413"/>
              <a:gd name="connsiteY0" fmla="*/ 1234 h 1362075"/>
              <a:gd name="connsiteX1" fmla="*/ 702469 w 9142413"/>
              <a:gd name="connsiteY1" fmla="*/ 2381 h 1362075"/>
              <a:gd name="connsiteX2" fmla="*/ 842962 w 9142413"/>
              <a:gd name="connsiteY2" fmla="*/ 235744 h 1362075"/>
              <a:gd name="connsiteX3" fmla="*/ 966788 w 9142413"/>
              <a:gd name="connsiteY3" fmla="*/ 0 h 1362075"/>
              <a:gd name="connsiteX4" fmla="*/ 9142413 w 9142413"/>
              <a:gd name="connsiteY4" fmla="*/ 1234 h 1362075"/>
              <a:gd name="connsiteX5" fmla="*/ 9142413 w 9142413"/>
              <a:gd name="connsiteY5" fmla="*/ 1362075 h 1362075"/>
              <a:gd name="connsiteX6" fmla="*/ 0 w 9142413"/>
              <a:gd name="connsiteY6" fmla="*/ 1362075 h 1362075"/>
              <a:gd name="connsiteX7" fmla="*/ 0 w 9142413"/>
              <a:gd name="connsiteY7" fmla="*/ 1234 h 1362075"/>
              <a:gd name="connsiteX0" fmla="*/ 0 w 9142413"/>
              <a:gd name="connsiteY0" fmla="*/ 1234 h 1362075"/>
              <a:gd name="connsiteX1" fmla="*/ 702469 w 9142413"/>
              <a:gd name="connsiteY1" fmla="*/ 2381 h 1362075"/>
              <a:gd name="connsiteX2" fmla="*/ 842962 w 9142413"/>
              <a:gd name="connsiteY2" fmla="*/ 235744 h 1362075"/>
              <a:gd name="connsiteX3" fmla="*/ 966788 w 9142413"/>
              <a:gd name="connsiteY3" fmla="*/ 0 h 1362075"/>
              <a:gd name="connsiteX4" fmla="*/ 9142413 w 9142413"/>
              <a:gd name="connsiteY4" fmla="*/ 1234 h 1362075"/>
              <a:gd name="connsiteX5" fmla="*/ 9142413 w 9142413"/>
              <a:gd name="connsiteY5" fmla="*/ 1362075 h 1362075"/>
              <a:gd name="connsiteX6" fmla="*/ 0 w 9142413"/>
              <a:gd name="connsiteY6" fmla="*/ 1362075 h 1362075"/>
              <a:gd name="connsiteX7" fmla="*/ 0 w 9142413"/>
              <a:gd name="connsiteY7" fmla="*/ 1234 h 1362075"/>
              <a:gd name="connsiteX0" fmla="*/ 0 w 9142413"/>
              <a:gd name="connsiteY0" fmla="*/ 1234 h 1362075"/>
              <a:gd name="connsiteX1" fmla="*/ 702469 w 9142413"/>
              <a:gd name="connsiteY1" fmla="*/ 2381 h 1362075"/>
              <a:gd name="connsiteX2" fmla="*/ 842962 w 9142413"/>
              <a:gd name="connsiteY2" fmla="*/ 235744 h 1362075"/>
              <a:gd name="connsiteX3" fmla="*/ 966788 w 9142413"/>
              <a:gd name="connsiteY3" fmla="*/ 0 h 1362075"/>
              <a:gd name="connsiteX4" fmla="*/ 9142413 w 9142413"/>
              <a:gd name="connsiteY4" fmla="*/ 1234 h 1362075"/>
              <a:gd name="connsiteX5" fmla="*/ 9142413 w 9142413"/>
              <a:gd name="connsiteY5" fmla="*/ 1362075 h 1362075"/>
              <a:gd name="connsiteX6" fmla="*/ 0 w 9142413"/>
              <a:gd name="connsiteY6" fmla="*/ 1362075 h 1362075"/>
              <a:gd name="connsiteX7" fmla="*/ 0 w 9142413"/>
              <a:gd name="connsiteY7" fmla="*/ 1234 h 1362075"/>
              <a:gd name="connsiteX0" fmla="*/ 0 w 9142413"/>
              <a:gd name="connsiteY0" fmla="*/ 1234 h 1362075"/>
              <a:gd name="connsiteX1" fmla="*/ 702469 w 9142413"/>
              <a:gd name="connsiteY1" fmla="*/ 2381 h 1362075"/>
              <a:gd name="connsiteX2" fmla="*/ 842962 w 9142413"/>
              <a:gd name="connsiteY2" fmla="*/ 235744 h 1362075"/>
              <a:gd name="connsiteX3" fmla="*/ 966788 w 9142413"/>
              <a:gd name="connsiteY3" fmla="*/ 0 h 1362075"/>
              <a:gd name="connsiteX4" fmla="*/ 9142413 w 9142413"/>
              <a:gd name="connsiteY4" fmla="*/ 1234 h 1362075"/>
              <a:gd name="connsiteX5" fmla="*/ 9142413 w 9142413"/>
              <a:gd name="connsiteY5" fmla="*/ 1362075 h 1362075"/>
              <a:gd name="connsiteX6" fmla="*/ 0 w 9142413"/>
              <a:gd name="connsiteY6" fmla="*/ 1362075 h 1362075"/>
              <a:gd name="connsiteX7" fmla="*/ 0 w 9142413"/>
              <a:gd name="connsiteY7" fmla="*/ 1234 h 1362075"/>
              <a:gd name="connsiteX0" fmla="*/ 0 w 9142413"/>
              <a:gd name="connsiteY0" fmla="*/ 1234 h 1362075"/>
              <a:gd name="connsiteX1" fmla="*/ 702469 w 9142413"/>
              <a:gd name="connsiteY1" fmla="*/ 2381 h 1362075"/>
              <a:gd name="connsiteX2" fmla="*/ 842962 w 9142413"/>
              <a:gd name="connsiteY2" fmla="*/ 235744 h 1362075"/>
              <a:gd name="connsiteX3" fmla="*/ 966788 w 9142413"/>
              <a:gd name="connsiteY3" fmla="*/ 0 h 1362075"/>
              <a:gd name="connsiteX4" fmla="*/ 9142413 w 9142413"/>
              <a:gd name="connsiteY4" fmla="*/ 1234 h 1362075"/>
              <a:gd name="connsiteX5" fmla="*/ 9142413 w 9142413"/>
              <a:gd name="connsiteY5" fmla="*/ 1362075 h 1362075"/>
              <a:gd name="connsiteX6" fmla="*/ 0 w 9142413"/>
              <a:gd name="connsiteY6" fmla="*/ 1362075 h 1362075"/>
              <a:gd name="connsiteX7" fmla="*/ 0 w 9142413"/>
              <a:gd name="connsiteY7" fmla="*/ 1234 h 1362075"/>
              <a:gd name="connsiteX0" fmla="*/ 0 w 9149186"/>
              <a:gd name="connsiteY0" fmla="*/ 28327 h 1362075"/>
              <a:gd name="connsiteX1" fmla="*/ 709242 w 9149186"/>
              <a:gd name="connsiteY1" fmla="*/ 2381 h 1362075"/>
              <a:gd name="connsiteX2" fmla="*/ 849735 w 9149186"/>
              <a:gd name="connsiteY2" fmla="*/ 235744 h 1362075"/>
              <a:gd name="connsiteX3" fmla="*/ 973561 w 9149186"/>
              <a:gd name="connsiteY3" fmla="*/ 0 h 1362075"/>
              <a:gd name="connsiteX4" fmla="*/ 9149186 w 9149186"/>
              <a:gd name="connsiteY4" fmla="*/ 1234 h 1362075"/>
              <a:gd name="connsiteX5" fmla="*/ 9149186 w 9149186"/>
              <a:gd name="connsiteY5" fmla="*/ 1362075 h 1362075"/>
              <a:gd name="connsiteX6" fmla="*/ 6773 w 9149186"/>
              <a:gd name="connsiteY6" fmla="*/ 1362075 h 1362075"/>
              <a:gd name="connsiteX7" fmla="*/ 0 w 9149186"/>
              <a:gd name="connsiteY7" fmla="*/ 28327 h 1362075"/>
              <a:gd name="connsiteX0" fmla="*/ 0 w 9149186"/>
              <a:gd name="connsiteY0" fmla="*/ 28327 h 1362075"/>
              <a:gd name="connsiteX1" fmla="*/ 688922 w 9149186"/>
              <a:gd name="connsiteY1" fmla="*/ 29475 h 1362075"/>
              <a:gd name="connsiteX2" fmla="*/ 849735 w 9149186"/>
              <a:gd name="connsiteY2" fmla="*/ 235744 h 1362075"/>
              <a:gd name="connsiteX3" fmla="*/ 973561 w 9149186"/>
              <a:gd name="connsiteY3" fmla="*/ 0 h 1362075"/>
              <a:gd name="connsiteX4" fmla="*/ 9149186 w 9149186"/>
              <a:gd name="connsiteY4" fmla="*/ 1234 h 1362075"/>
              <a:gd name="connsiteX5" fmla="*/ 9149186 w 9149186"/>
              <a:gd name="connsiteY5" fmla="*/ 1362075 h 1362075"/>
              <a:gd name="connsiteX6" fmla="*/ 6773 w 9149186"/>
              <a:gd name="connsiteY6" fmla="*/ 1362075 h 1362075"/>
              <a:gd name="connsiteX7" fmla="*/ 0 w 9149186"/>
              <a:gd name="connsiteY7" fmla="*/ 28327 h 1362075"/>
              <a:gd name="connsiteX0" fmla="*/ 0 w 9149186"/>
              <a:gd name="connsiteY0" fmla="*/ 27093 h 1360841"/>
              <a:gd name="connsiteX1" fmla="*/ 688922 w 9149186"/>
              <a:gd name="connsiteY1" fmla="*/ 28241 h 1360841"/>
              <a:gd name="connsiteX2" fmla="*/ 849735 w 9149186"/>
              <a:gd name="connsiteY2" fmla="*/ 234510 h 1360841"/>
              <a:gd name="connsiteX3" fmla="*/ 953241 w 9149186"/>
              <a:gd name="connsiteY3" fmla="*/ 25860 h 1360841"/>
              <a:gd name="connsiteX4" fmla="*/ 9149186 w 9149186"/>
              <a:gd name="connsiteY4" fmla="*/ 0 h 1360841"/>
              <a:gd name="connsiteX5" fmla="*/ 9149186 w 9149186"/>
              <a:gd name="connsiteY5" fmla="*/ 1360841 h 1360841"/>
              <a:gd name="connsiteX6" fmla="*/ 6773 w 9149186"/>
              <a:gd name="connsiteY6" fmla="*/ 1360841 h 1360841"/>
              <a:gd name="connsiteX7" fmla="*/ 0 w 9149186"/>
              <a:gd name="connsiteY7" fmla="*/ 27093 h 1360841"/>
              <a:gd name="connsiteX0" fmla="*/ 0 w 9149186"/>
              <a:gd name="connsiteY0" fmla="*/ 1233 h 1334981"/>
              <a:gd name="connsiteX1" fmla="*/ 688922 w 9149186"/>
              <a:gd name="connsiteY1" fmla="*/ 2381 h 1334981"/>
              <a:gd name="connsiteX2" fmla="*/ 849735 w 9149186"/>
              <a:gd name="connsiteY2" fmla="*/ 208650 h 1334981"/>
              <a:gd name="connsiteX3" fmla="*/ 953241 w 9149186"/>
              <a:gd name="connsiteY3" fmla="*/ 0 h 1334981"/>
              <a:gd name="connsiteX4" fmla="*/ 9149186 w 9149186"/>
              <a:gd name="connsiteY4" fmla="*/ 1233 h 1334981"/>
              <a:gd name="connsiteX5" fmla="*/ 9149186 w 9149186"/>
              <a:gd name="connsiteY5" fmla="*/ 1334981 h 1334981"/>
              <a:gd name="connsiteX6" fmla="*/ 6773 w 9149186"/>
              <a:gd name="connsiteY6" fmla="*/ 1334981 h 1334981"/>
              <a:gd name="connsiteX7" fmla="*/ 0 w 9149186"/>
              <a:gd name="connsiteY7" fmla="*/ 1233 h 1334981"/>
              <a:gd name="connsiteX0" fmla="*/ 0 w 9149186"/>
              <a:gd name="connsiteY0" fmla="*/ 1233 h 1334981"/>
              <a:gd name="connsiteX1" fmla="*/ 688922 w 9149186"/>
              <a:gd name="connsiteY1" fmla="*/ 2381 h 1334981"/>
              <a:gd name="connsiteX2" fmla="*/ 815868 w 9149186"/>
              <a:gd name="connsiteY2" fmla="*/ 235743 h 1334981"/>
              <a:gd name="connsiteX3" fmla="*/ 953241 w 9149186"/>
              <a:gd name="connsiteY3" fmla="*/ 0 h 1334981"/>
              <a:gd name="connsiteX4" fmla="*/ 9149186 w 9149186"/>
              <a:gd name="connsiteY4" fmla="*/ 1233 h 1334981"/>
              <a:gd name="connsiteX5" fmla="*/ 9149186 w 9149186"/>
              <a:gd name="connsiteY5" fmla="*/ 1334981 h 1334981"/>
              <a:gd name="connsiteX6" fmla="*/ 6773 w 9149186"/>
              <a:gd name="connsiteY6" fmla="*/ 1334981 h 1334981"/>
              <a:gd name="connsiteX7" fmla="*/ 0 w 9149186"/>
              <a:gd name="connsiteY7" fmla="*/ 1233 h 1334981"/>
              <a:gd name="connsiteX0" fmla="*/ 3193 w 9142854"/>
              <a:gd name="connsiteY0" fmla="*/ 5995 h 1334981"/>
              <a:gd name="connsiteX1" fmla="*/ 682590 w 9142854"/>
              <a:gd name="connsiteY1" fmla="*/ 2381 h 1334981"/>
              <a:gd name="connsiteX2" fmla="*/ 809536 w 9142854"/>
              <a:gd name="connsiteY2" fmla="*/ 235743 h 1334981"/>
              <a:gd name="connsiteX3" fmla="*/ 946909 w 9142854"/>
              <a:gd name="connsiteY3" fmla="*/ 0 h 1334981"/>
              <a:gd name="connsiteX4" fmla="*/ 9142854 w 9142854"/>
              <a:gd name="connsiteY4" fmla="*/ 1233 h 1334981"/>
              <a:gd name="connsiteX5" fmla="*/ 9142854 w 9142854"/>
              <a:gd name="connsiteY5" fmla="*/ 1334981 h 1334981"/>
              <a:gd name="connsiteX6" fmla="*/ 441 w 9142854"/>
              <a:gd name="connsiteY6" fmla="*/ 1334981 h 1334981"/>
              <a:gd name="connsiteX7" fmla="*/ 3193 w 9142854"/>
              <a:gd name="connsiteY7" fmla="*/ 5995 h 1334981"/>
              <a:gd name="connsiteX0" fmla="*/ 982 w 9143024"/>
              <a:gd name="connsiteY0" fmla="*/ 0 h 1338511"/>
              <a:gd name="connsiteX1" fmla="*/ 682760 w 9143024"/>
              <a:gd name="connsiteY1" fmla="*/ 5911 h 1338511"/>
              <a:gd name="connsiteX2" fmla="*/ 809706 w 9143024"/>
              <a:gd name="connsiteY2" fmla="*/ 239273 h 1338511"/>
              <a:gd name="connsiteX3" fmla="*/ 947079 w 9143024"/>
              <a:gd name="connsiteY3" fmla="*/ 3530 h 1338511"/>
              <a:gd name="connsiteX4" fmla="*/ 9143024 w 9143024"/>
              <a:gd name="connsiteY4" fmla="*/ 4763 h 1338511"/>
              <a:gd name="connsiteX5" fmla="*/ 9143024 w 9143024"/>
              <a:gd name="connsiteY5" fmla="*/ 1338511 h 1338511"/>
              <a:gd name="connsiteX6" fmla="*/ 611 w 9143024"/>
              <a:gd name="connsiteY6" fmla="*/ 1338511 h 1338511"/>
              <a:gd name="connsiteX7" fmla="*/ 982 w 9143024"/>
              <a:gd name="connsiteY7" fmla="*/ 0 h 1338511"/>
              <a:gd name="connsiteX0" fmla="*/ 982 w 9143024"/>
              <a:gd name="connsiteY0" fmla="*/ 0 h 1338511"/>
              <a:gd name="connsiteX1" fmla="*/ 673235 w 9143024"/>
              <a:gd name="connsiteY1" fmla="*/ 1149 h 1338511"/>
              <a:gd name="connsiteX2" fmla="*/ 809706 w 9143024"/>
              <a:gd name="connsiteY2" fmla="*/ 239273 h 1338511"/>
              <a:gd name="connsiteX3" fmla="*/ 947079 w 9143024"/>
              <a:gd name="connsiteY3" fmla="*/ 3530 h 1338511"/>
              <a:gd name="connsiteX4" fmla="*/ 9143024 w 9143024"/>
              <a:gd name="connsiteY4" fmla="*/ 4763 h 1338511"/>
              <a:gd name="connsiteX5" fmla="*/ 9143024 w 9143024"/>
              <a:gd name="connsiteY5" fmla="*/ 1338511 h 1338511"/>
              <a:gd name="connsiteX6" fmla="*/ 611 w 9143024"/>
              <a:gd name="connsiteY6" fmla="*/ 1338511 h 1338511"/>
              <a:gd name="connsiteX7" fmla="*/ 982 w 9143024"/>
              <a:gd name="connsiteY7" fmla="*/ 0 h 1338511"/>
              <a:gd name="connsiteX0" fmla="*/ 982 w 9143024"/>
              <a:gd name="connsiteY0" fmla="*/ 0 h 1338511"/>
              <a:gd name="connsiteX1" fmla="*/ 673235 w 9143024"/>
              <a:gd name="connsiteY1" fmla="*/ 1149 h 1338511"/>
              <a:gd name="connsiteX2" fmla="*/ 809706 w 9143024"/>
              <a:gd name="connsiteY2" fmla="*/ 239273 h 1338511"/>
              <a:gd name="connsiteX3" fmla="*/ 947079 w 9143024"/>
              <a:gd name="connsiteY3" fmla="*/ 3530 h 1338511"/>
              <a:gd name="connsiteX4" fmla="*/ 9143024 w 9143024"/>
              <a:gd name="connsiteY4" fmla="*/ 4763 h 1338511"/>
              <a:gd name="connsiteX5" fmla="*/ 9143024 w 9143024"/>
              <a:gd name="connsiteY5" fmla="*/ 1338511 h 1338511"/>
              <a:gd name="connsiteX6" fmla="*/ 611 w 9143024"/>
              <a:gd name="connsiteY6" fmla="*/ 1338511 h 1338511"/>
              <a:gd name="connsiteX7" fmla="*/ 982 w 9143024"/>
              <a:gd name="connsiteY7" fmla="*/ 0 h 1338511"/>
              <a:gd name="connsiteX0" fmla="*/ 982 w 9143024"/>
              <a:gd name="connsiteY0" fmla="*/ 3614 h 1342125"/>
              <a:gd name="connsiteX1" fmla="*/ 673235 w 9143024"/>
              <a:gd name="connsiteY1" fmla="*/ 4763 h 1342125"/>
              <a:gd name="connsiteX2" fmla="*/ 809706 w 9143024"/>
              <a:gd name="connsiteY2" fmla="*/ 242887 h 1342125"/>
              <a:gd name="connsiteX3" fmla="*/ 937554 w 9143024"/>
              <a:gd name="connsiteY3" fmla="*/ 0 h 1342125"/>
              <a:gd name="connsiteX4" fmla="*/ 9143024 w 9143024"/>
              <a:gd name="connsiteY4" fmla="*/ 8377 h 1342125"/>
              <a:gd name="connsiteX5" fmla="*/ 9143024 w 9143024"/>
              <a:gd name="connsiteY5" fmla="*/ 1342125 h 1342125"/>
              <a:gd name="connsiteX6" fmla="*/ 611 w 9143024"/>
              <a:gd name="connsiteY6" fmla="*/ 1342125 h 1342125"/>
              <a:gd name="connsiteX7" fmla="*/ 982 w 9143024"/>
              <a:gd name="connsiteY7" fmla="*/ 3614 h 1342125"/>
              <a:gd name="connsiteX0" fmla="*/ 982 w 9143024"/>
              <a:gd name="connsiteY0" fmla="*/ 3614 h 1342125"/>
              <a:gd name="connsiteX1" fmla="*/ 673235 w 9143024"/>
              <a:gd name="connsiteY1" fmla="*/ 4763 h 1342125"/>
              <a:gd name="connsiteX2" fmla="*/ 800181 w 9143024"/>
              <a:gd name="connsiteY2" fmla="*/ 200024 h 1342125"/>
              <a:gd name="connsiteX3" fmla="*/ 937554 w 9143024"/>
              <a:gd name="connsiteY3" fmla="*/ 0 h 1342125"/>
              <a:gd name="connsiteX4" fmla="*/ 9143024 w 9143024"/>
              <a:gd name="connsiteY4" fmla="*/ 8377 h 1342125"/>
              <a:gd name="connsiteX5" fmla="*/ 9143024 w 9143024"/>
              <a:gd name="connsiteY5" fmla="*/ 1342125 h 1342125"/>
              <a:gd name="connsiteX6" fmla="*/ 611 w 9143024"/>
              <a:gd name="connsiteY6" fmla="*/ 1342125 h 1342125"/>
              <a:gd name="connsiteX7" fmla="*/ 982 w 9143024"/>
              <a:gd name="connsiteY7" fmla="*/ 3614 h 1342125"/>
              <a:gd name="connsiteX0" fmla="*/ 982 w 9143024"/>
              <a:gd name="connsiteY0" fmla="*/ 3614 h 1342125"/>
              <a:gd name="connsiteX1" fmla="*/ 673235 w 9143024"/>
              <a:gd name="connsiteY1" fmla="*/ 4763 h 1342125"/>
              <a:gd name="connsiteX2" fmla="*/ 800181 w 9143024"/>
              <a:gd name="connsiteY2" fmla="*/ 238124 h 1342125"/>
              <a:gd name="connsiteX3" fmla="*/ 937554 w 9143024"/>
              <a:gd name="connsiteY3" fmla="*/ 0 h 1342125"/>
              <a:gd name="connsiteX4" fmla="*/ 9143024 w 9143024"/>
              <a:gd name="connsiteY4" fmla="*/ 8377 h 1342125"/>
              <a:gd name="connsiteX5" fmla="*/ 9143024 w 9143024"/>
              <a:gd name="connsiteY5" fmla="*/ 1342125 h 1342125"/>
              <a:gd name="connsiteX6" fmla="*/ 611 w 9143024"/>
              <a:gd name="connsiteY6" fmla="*/ 1342125 h 1342125"/>
              <a:gd name="connsiteX7" fmla="*/ 982 w 9143024"/>
              <a:gd name="connsiteY7" fmla="*/ 3614 h 1342125"/>
              <a:gd name="connsiteX0" fmla="*/ 982 w 9143024"/>
              <a:gd name="connsiteY0" fmla="*/ 3614 h 1342125"/>
              <a:gd name="connsiteX1" fmla="*/ 673235 w 9143024"/>
              <a:gd name="connsiteY1" fmla="*/ 4763 h 1342125"/>
              <a:gd name="connsiteX2" fmla="*/ 800181 w 9143024"/>
              <a:gd name="connsiteY2" fmla="*/ 238124 h 1342125"/>
              <a:gd name="connsiteX3" fmla="*/ 937554 w 9143024"/>
              <a:gd name="connsiteY3" fmla="*/ 0 h 1342125"/>
              <a:gd name="connsiteX4" fmla="*/ 9143024 w 9143024"/>
              <a:gd name="connsiteY4" fmla="*/ 8377 h 1342125"/>
              <a:gd name="connsiteX5" fmla="*/ 9143024 w 9143024"/>
              <a:gd name="connsiteY5" fmla="*/ 1342125 h 1342125"/>
              <a:gd name="connsiteX6" fmla="*/ 611 w 9143024"/>
              <a:gd name="connsiteY6" fmla="*/ 1342125 h 1342125"/>
              <a:gd name="connsiteX7" fmla="*/ 982 w 9143024"/>
              <a:gd name="connsiteY7" fmla="*/ 3614 h 1342125"/>
              <a:gd name="connsiteX0" fmla="*/ 982 w 9143024"/>
              <a:gd name="connsiteY0" fmla="*/ 3614 h 1342125"/>
              <a:gd name="connsiteX1" fmla="*/ 673235 w 9143024"/>
              <a:gd name="connsiteY1" fmla="*/ 4763 h 1342125"/>
              <a:gd name="connsiteX2" fmla="*/ 800181 w 9143024"/>
              <a:gd name="connsiteY2" fmla="*/ 238124 h 1342125"/>
              <a:gd name="connsiteX3" fmla="*/ 937554 w 9143024"/>
              <a:gd name="connsiteY3" fmla="*/ 0 h 1342125"/>
              <a:gd name="connsiteX4" fmla="*/ 9143024 w 9143024"/>
              <a:gd name="connsiteY4" fmla="*/ 8377 h 1342125"/>
              <a:gd name="connsiteX5" fmla="*/ 9143024 w 9143024"/>
              <a:gd name="connsiteY5" fmla="*/ 1342125 h 1342125"/>
              <a:gd name="connsiteX6" fmla="*/ 611 w 9143024"/>
              <a:gd name="connsiteY6" fmla="*/ 1342125 h 1342125"/>
              <a:gd name="connsiteX7" fmla="*/ 982 w 9143024"/>
              <a:gd name="connsiteY7" fmla="*/ 3614 h 1342125"/>
              <a:gd name="connsiteX0" fmla="*/ 982 w 9143024"/>
              <a:gd name="connsiteY0" fmla="*/ 3614 h 1342125"/>
              <a:gd name="connsiteX1" fmla="*/ 661329 w 9143024"/>
              <a:gd name="connsiteY1" fmla="*/ 2382 h 1342125"/>
              <a:gd name="connsiteX2" fmla="*/ 800181 w 9143024"/>
              <a:gd name="connsiteY2" fmla="*/ 238124 h 1342125"/>
              <a:gd name="connsiteX3" fmla="*/ 937554 w 9143024"/>
              <a:gd name="connsiteY3" fmla="*/ 0 h 1342125"/>
              <a:gd name="connsiteX4" fmla="*/ 9143024 w 9143024"/>
              <a:gd name="connsiteY4" fmla="*/ 8377 h 1342125"/>
              <a:gd name="connsiteX5" fmla="*/ 9143024 w 9143024"/>
              <a:gd name="connsiteY5" fmla="*/ 1342125 h 1342125"/>
              <a:gd name="connsiteX6" fmla="*/ 611 w 9143024"/>
              <a:gd name="connsiteY6" fmla="*/ 1342125 h 1342125"/>
              <a:gd name="connsiteX7" fmla="*/ 982 w 9143024"/>
              <a:gd name="connsiteY7" fmla="*/ 3614 h 1342125"/>
              <a:gd name="connsiteX0" fmla="*/ 982 w 9143024"/>
              <a:gd name="connsiteY0" fmla="*/ 3614 h 1342125"/>
              <a:gd name="connsiteX1" fmla="*/ 668473 w 9143024"/>
              <a:gd name="connsiteY1" fmla="*/ 2382 h 1342125"/>
              <a:gd name="connsiteX2" fmla="*/ 800181 w 9143024"/>
              <a:gd name="connsiteY2" fmla="*/ 238124 h 1342125"/>
              <a:gd name="connsiteX3" fmla="*/ 937554 w 9143024"/>
              <a:gd name="connsiteY3" fmla="*/ 0 h 1342125"/>
              <a:gd name="connsiteX4" fmla="*/ 9143024 w 9143024"/>
              <a:gd name="connsiteY4" fmla="*/ 8377 h 1342125"/>
              <a:gd name="connsiteX5" fmla="*/ 9143024 w 9143024"/>
              <a:gd name="connsiteY5" fmla="*/ 1342125 h 1342125"/>
              <a:gd name="connsiteX6" fmla="*/ 611 w 9143024"/>
              <a:gd name="connsiteY6" fmla="*/ 1342125 h 1342125"/>
              <a:gd name="connsiteX7" fmla="*/ 982 w 9143024"/>
              <a:gd name="connsiteY7" fmla="*/ 3614 h 1342125"/>
              <a:gd name="connsiteX0" fmla="*/ 982 w 9143024"/>
              <a:gd name="connsiteY0" fmla="*/ 3614 h 1342125"/>
              <a:gd name="connsiteX1" fmla="*/ 668473 w 9143024"/>
              <a:gd name="connsiteY1" fmla="*/ 2382 h 1342125"/>
              <a:gd name="connsiteX2" fmla="*/ 800181 w 9143024"/>
              <a:gd name="connsiteY2" fmla="*/ 238124 h 1342125"/>
              <a:gd name="connsiteX3" fmla="*/ 937554 w 9143024"/>
              <a:gd name="connsiteY3" fmla="*/ 0 h 1342125"/>
              <a:gd name="connsiteX4" fmla="*/ 9143024 w 9143024"/>
              <a:gd name="connsiteY4" fmla="*/ 8377 h 1342125"/>
              <a:gd name="connsiteX5" fmla="*/ 9143024 w 9143024"/>
              <a:gd name="connsiteY5" fmla="*/ 1342125 h 1342125"/>
              <a:gd name="connsiteX6" fmla="*/ 611 w 9143024"/>
              <a:gd name="connsiteY6" fmla="*/ 1342125 h 1342125"/>
              <a:gd name="connsiteX7" fmla="*/ 982 w 9143024"/>
              <a:gd name="connsiteY7" fmla="*/ 3614 h 1342125"/>
              <a:gd name="connsiteX0" fmla="*/ 982 w 9143024"/>
              <a:gd name="connsiteY0" fmla="*/ 3614 h 1342125"/>
              <a:gd name="connsiteX1" fmla="*/ 668473 w 9143024"/>
              <a:gd name="connsiteY1" fmla="*/ 2382 h 1342125"/>
              <a:gd name="connsiteX2" fmla="*/ 804944 w 9143024"/>
              <a:gd name="connsiteY2" fmla="*/ 247649 h 1342125"/>
              <a:gd name="connsiteX3" fmla="*/ 937554 w 9143024"/>
              <a:gd name="connsiteY3" fmla="*/ 0 h 1342125"/>
              <a:gd name="connsiteX4" fmla="*/ 9143024 w 9143024"/>
              <a:gd name="connsiteY4" fmla="*/ 8377 h 1342125"/>
              <a:gd name="connsiteX5" fmla="*/ 9143024 w 9143024"/>
              <a:gd name="connsiteY5" fmla="*/ 1342125 h 1342125"/>
              <a:gd name="connsiteX6" fmla="*/ 611 w 9143024"/>
              <a:gd name="connsiteY6" fmla="*/ 1342125 h 1342125"/>
              <a:gd name="connsiteX7" fmla="*/ 982 w 9143024"/>
              <a:gd name="connsiteY7" fmla="*/ 3614 h 1342125"/>
              <a:gd name="connsiteX0" fmla="*/ 982 w 9143024"/>
              <a:gd name="connsiteY0" fmla="*/ 3614 h 1342125"/>
              <a:gd name="connsiteX1" fmla="*/ 668473 w 9143024"/>
              <a:gd name="connsiteY1" fmla="*/ 2382 h 1342125"/>
              <a:gd name="connsiteX2" fmla="*/ 804944 w 9143024"/>
              <a:gd name="connsiteY2" fmla="*/ 247649 h 1342125"/>
              <a:gd name="connsiteX3" fmla="*/ 937554 w 9143024"/>
              <a:gd name="connsiteY3" fmla="*/ 0 h 1342125"/>
              <a:gd name="connsiteX4" fmla="*/ 9143024 w 9143024"/>
              <a:gd name="connsiteY4" fmla="*/ 8377 h 1342125"/>
              <a:gd name="connsiteX5" fmla="*/ 9143024 w 9143024"/>
              <a:gd name="connsiteY5" fmla="*/ 1342125 h 1342125"/>
              <a:gd name="connsiteX6" fmla="*/ 611 w 9143024"/>
              <a:gd name="connsiteY6" fmla="*/ 1342125 h 1342125"/>
              <a:gd name="connsiteX7" fmla="*/ 982 w 9143024"/>
              <a:gd name="connsiteY7" fmla="*/ 3614 h 1342125"/>
              <a:gd name="connsiteX0" fmla="*/ 982 w 9143024"/>
              <a:gd name="connsiteY0" fmla="*/ 3614 h 1342125"/>
              <a:gd name="connsiteX1" fmla="*/ 668473 w 9143024"/>
              <a:gd name="connsiteY1" fmla="*/ 2382 h 1342125"/>
              <a:gd name="connsiteX2" fmla="*/ 804944 w 9143024"/>
              <a:gd name="connsiteY2" fmla="*/ 247649 h 1342125"/>
              <a:gd name="connsiteX3" fmla="*/ 937554 w 9143024"/>
              <a:gd name="connsiteY3" fmla="*/ 0 h 1342125"/>
              <a:gd name="connsiteX4" fmla="*/ 9143024 w 9143024"/>
              <a:gd name="connsiteY4" fmla="*/ 8377 h 1342125"/>
              <a:gd name="connsiteX5" fmla="*/ 9143024 w 9143024"/>
              <a:gd name="connsiteY5" fmla="*/ 1342125 h 1342125"/>
              <a:gd name="connsiteX6" fmla="*/ 611 w 9143024"/>
              <a:gd name="connsiteY6" fmla="*/ 1342125 h 1342125"/>
              <a:gd name="connsiteX7" fmla="*/ 982 w 9143024"/>
              <a:gd name="connsiteY7" fmla="*/ 3614 h 1342125"/>
              <a:gd name="connsiteX0" fmla="*/ 982 w 9143024"/>
              <a:gd name="connsiteY0" fmla="*/ 3614 h 1342125"/>
              <a:gd name="connsiteX1" fmla="*/ 668473 w 9143024"/>
              <a:gd name="connsiteY1" fmla="*/ 2382 h 1342125"/>
              <a:gd name="connsiteX2" fmla="*/ 804944 w 9143024"/>
              <a:gd name="connsiteY2" fmla="*/ 247649 h 1342125"/>
              <a:gd name="connsiteX3" fmla="*/ 937554 w 9143024"/>
              <a:gd name="connsiteY3" fmla="*/ 0 h 1342125"/>
              <a:gd name="connsiteX4" fmla="*/ 9143024 w 9143024"/>
              <a:gd name="connsiteY4" fmla="*/ 3615 h 1342125"/>
              <a:gd name="connsiteX5" fmla="*/ 9143024 w 9143024"/>
              <a:gd name="connsiteY5" fmla="*/ 1342125 h 1342125"/>
              <a:gd name="connsiteX6" fmla="*/ 611 w 9143024"/>
              <a:gd name="connsiteY6" fmla="*/ 1342125 h 1342125"/>
              <a:gd name="connsiteX7" fmla="*/ 982 w 9143024"/>
              <a:gd name="connsiteY7" fmla="*/ 3614 h 1342125"/>
              <a:gd name="connsiteX0" fmla="*/ 982 w 9143024"/>
              <a:gd name="connsiteY0" fmla="*/ 3614 h 1342125"/>
              <a:gd name="connsiteX1" fmla="*/ 668473 w 9143024"/>
              <a:gd name="connsiteY1" fmla="*/ 2382 h 1342125"/>
              <a:gd name="connsiteX2" fmla="*/ 804944 w 9143024"/>
              <a:gd name="connsiteY2" fmla="*/ 247649 h 1342125"/>
              <a:gd name="connsiteX3" fmla="*/ 937554 w 9143024"/>
              <a:gd name="connsiteY3" fmla="*/ 0 h 1342125"/>
              <a:gd name="connsiteX4" fmla="*/ 9143024 w 9143024"/>
              <a:gd name="connsiteY4" fmla="*/ 3615 h 1342125"/>
              <a:gd name="connsiteX5" fmla="*/ 9143024 w 9143024"/>
              <a:gd name="connsiteY5" fmla="*/ 1342125 h 1342125"/>
              <a:gd name="connsiteX6" fmla="*/ 611 w 9143024"/>
              <a:gd name="connsiteY6" fmla="*/ 1342125 h 1342125"/>
              <a:gd name="connsiteX7" fmla="*/ 982 w 9143024"/>
              <a:gd name="connsiteY7" fmla="*/ 3614 h 1342125"/>
              <a:gd name="connsiteX0" fmla="*/ 982 w 9143024"/>
              <a:gd name="connsiteY0" fmla="*/ 1232 h 1339743"/>
              <a:gd name="connsiteX1" fmla="*/ 668473 w 9143024"/>
              <a:gd name="connsiteY1" fmla="*/ 0 h 1339743"/>
              <a:gd name="connsiteX2" fmla="*/ 804944 w 9143024"/>
              <a:gd name="connsiteY2" fmla="*/ 245267 h 1339743"/>
              <a:gd name="connsiteX3" fmla="*/ 947079 w 9143024"/>
              <a:gd name="connsiteY3" fmla="*/ 0 h 1339743"/>
              <a:gd name="connsiteX4" fmla="*/ 9143024 w 9143024"/>
              <a:gd name="connsiteY4" fmla="*/ 1233 h 1339743"/>
              <a:gd name="connsiteX5" fmla="*/ 9143024 w 9143024"/>
              <a:gd name="connsiteY5" fmla="*/ 1339743 h 1339743"/>
              <a:gd name="connsiteX6" fmla="*/ 611 w 9143024"/>
              <a:gd name="connsiteY6" fmla="*/ 1339743 h 1339743"/>
              <a:gd name="connsiteX7" fmla="*/ 982 w 9143024"/>
              <a:gd name="connsiteY7" fmla="*/ 1232 h 1339743"/>
              <a:gd name="connsiteX0" fmla="*/ 982 w 9143024"/>
              <a:gd name="connsiteY0" fmla="*/ 1232 h 1339743"/>
              <a:gd name="connsiteX1" fmla="*/ 668473 w 9143024"/>
              <a:gd name="connsiteY1" fmla="*/ 0 h 1339743"/>
              <a:gd name="connsiteX2" fmla="*/ 804944 w 9143024"/>
              <a:gd name="connsiteY2" fmla="*/ 245267 h 1339743"/>
              <a:gd name="connsiteX3" fmla="*/ 947079 w 9143024"/>
              <a:gd name="connsiteY3" fmla="*/ 0 h 1339743"/>
              <a:gd name="connsiteX4" fmla="*/ 9143024 w 9143024"/>
              <a:gd name="connsiteY4" fmla="*/ 1233 h 1339743"/>
              <a:gd name="connsiteX5" fmla="*/ 9143024 w 9143024"/>
              <a:gd name="connsiteY5" fmla="*/ 1339743 h 1339743"/>
              <a:gd name="connsiteX6" fmla="*/ 611 w 9143024"/>
              <a:gd name="connsiteY6" fmla="*/ 1339743 h 1339743"/>
              <a:gd name="connsiteX7" fmla="*/ 982 w 9143024"/>
              <a:gd name="connsiteY7" fmla="*/ 1232 h 1339743"/>
              <a:gd name="connsiteX0" fmla="*/ 982 w 9143024"/>
              <a:gd name="connsiteY0" fmla="*/ 1232 h 1339743"/>
              <a:gd name="connsiteX1" fmla="*/ 668473 w 9143024"/>
              <a:gd name="connsiteY1" fmla="*/ 0 h 1339743"/>
              <a:gd name="connsiteX2" fmla="*/ 760230 w 9143024"/>
              <a:gd name="connsiteY2" fmla="*/ 211031 h 1339743"/>
              <a:gd name="connsiteX3" fmla="*/ 804944 w 9143024"/>
              <a:gd name="connsiteY3" fmla="*/ 245267 h 1339743"/>
              <a:gd name="connsiteX4" fmla="*/ 947079 w 9143024"/>
              <a:gd name="connsiteY4" fmla="*/ 0 h 1339743"/>
              <a:gd name="connsiteX5" fmla="*/ 9143024 w 9143024"/>
              <a:gd name="connsiteY5" fmla="*/ 1233 h 1339743"/>
              <a:gd name="connsiteX6" fmla="*/ 9143024 w 9143024"/>
              <a:gd name="connsiteY6" fmla="*/ 1339743 h 1339743"/>
              <a:gd name="connsiteX7" fmla="*/ 611 w 9143024"/>
              <a:gd name="connsiteY7" fmla="*/ 1339743 h 1339743"/>
              <a:gd name="connsiteX8" fmla="*/ 982 w 9143024"/>
              <a:gd name="connsiteY8" fmla="*/ 1232 h 1339743"/>
              <a:gd name="connsiteX0" fmla="*/ 982 w 9143024"/>
              <a:gd name="connsiteY0" fmla="*/ 1232 h 1339743"/>
              <a:gd name="connsiteX1" fmla="*/ 668473 w 9143024"/>
              <a:gd name="connsiteY1" fmla="*/ 0 h 1339743"/>
              <a:gd name="connsiteX2" fmla="*/ 760230 w 9143024"/>
              <a:gd name="connsiteY2" fmla="*/ 211031 h 1339743"/>
              <a:gd name="connsiteX3" fmla="*/ 804944 w 9143024"/>
              <a:gd name="connsiteY3" fmla="*/ 245267 h 1339743"/>
              <a:gd name="connsiteX4" fmla="*/ 836430 w 9143024"/>
              <a:gd name="connsiteY4" fmla="*/ 199124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0230 w 9143024"/>
              <a:gd name="connsiteY2" fmla="*/ 211031 h 1339743"/>
              <a:gd name="connsiteX3" fmla="*/ 804944 w 9143024"/>
              <a:gd name="connsiteY3" fmla="*/ 245267 h 1339743"/>
              <a:gd name="connsiteX4" fmla="*/ 843574 w 9143024"/>
              <a:gd name="connsiteY4" fmla="*/ 213412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0230 w 9143024"/>
              <a:gd name="connsiteY2" fmla="*/ 211031 h 1339743"/>
              <a:gd name="connsiteX3" fmla="*/ 804944 w 9143024"/>
              <a:gd name="connsiteY3" fmla="*/ 245267 h 1339743"/>
              <a:gd name="connsiteX4" fmla="*/ 843574 w 9143024"/>
              <a:gd name="connsiteY4" fmla="*/ 213412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0230 w 9143024"/>
              <a:gd name="connsiteY2" fmla="*/ 211031 h 1339743"/>
              <a:gd name="connsiteX3" fmla="*/ 804944 w 9143024"/>
              <a:gd name="connsiteY3" fmla="*/ 245267 h 1339743"/>
              <a:gd name="connsiteX4" fmla="*/ 843574 w 9143024"/>
              <a:gd name="connsiteY4" fmla="*/ 213412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0230 w 9143024"/>
              <a:gd name="connsiteY2" fmla="*/ 211031 h 1339743"/>
              <a:gd name="connsiteX3" fmla="*/ 804944 w 9143024"/>
              <a:gd name="connsiteY3" fmla="*/ 245267 h 1339743"/>
              <a:gd name="connsiteX4" fmla="*/ 843574 w 9143024"/>
              <a:gd name="connsiteY4" fmla="*/ 213412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0230 w 9143024"/>
              <a:gd name="connsiteY2" fmla="*/ 211031 h 1339743"/>
              <a:gd name="connsiteX3" fmla="*/ 804944 w 9143024"/>
              <a:gd name="connsiteY3" fmla="*/ 245267 h 1339743"/>
              <a:gd name="connsiteX4" fmla="*/ 843574 w 9143024"/>
              <a:gd name="connsiteY4" fmla="*/ 213412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0230 w 9143024"/>
              <a:gd name="connsiteY2" fmla="*/ 211031 h 1339743"/>
              <a:gd name="connsiteX3" fmla="*/ 804944 w 9143024"/>
              <a:gd name="connsiteY3" fmla="*/ 245267 h 1339743"/>
              <a:gd name="connsiteX4" fmla="*/ 843574 w 9143024"/>
              <a:gd name="connsiteY4" fmla="*/ 213412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0230 w 9143024"/>
              <a:gd name="connsiteY2" fmla="*/ 211031 h 1339743"/>
              <a:gd name="connsiteX3" fmla="*/ 804944 w 9143024"/>
              <a:gd name="connsiteY3" fmla="*/ 245267 h 1339743"/>
              <a:gd name="connsiteX4" fmla="*/ 843574 w 9143024"/>
              <a:gd name="connsiteY4" fmla="*/ 213412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0230 w 9143024"/>
              <a:gd name="connsiteY2" fmla="*/ 211031 h 1339743"/>
              <a:gd name="connsiteX3" fmla="*/ 804944 w 9143024"/>
              <a:gd name="connsiteY3" fmla="*/ 245267 h 1339743"/>
              <a:gd name="connsiteX4" fmla="*/ 848337 w 9143024"/>
              <a:gd name="connsiteY4" fmla="*/ 203887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0230 w 9143024"/>
              <a:gd name="connsiteY2" fmla="*/ 211031 h 1339743"/>
              <a:gd name="connsiteX3" fmla="*/ 804944 w 9143024"/>
              <a:gd name="connsiteY3" fmla="*/ 245267 h 1339743"/>
              <a:gd name="connsiteX4" fmla="*/ 848337 w 9143024"/>
              <a:gd name="connsiteY4" fmla="*/ 203887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7374 w 9143024"/>
              <a:gd name="connsiteY2" fmla="*/ 206268 h 1339743"/>
              <a:gd name="connsiteX3" fmla="*/ 804944 w 9143024"/>
              <a:gd name="connsiteY3" fmla="*/ 245267 h 1339743"/>
              <a:gd name="connsiteX4" fmla="*/ 848337 w 9143024"/>
              <a:gd name="connsiteY4" fmla="*/ 203887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7374 w 9143024"/>
              <a:gd name="connsiteY2" fmla="*/ 206268 h 1339743"/>
              <a:gd name="connsiteX3" fmla="*/ 804944 w 9143024"/>
              <a:gd name="connsiteY3" fmla="*/ 245267 h 1339743"/>
              <a:gd name="connsiteX4" fmla="*/ 848337 w 9143024"/>
              <a:gd name="connsiteY4" fmla="*/ 203887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7374 w 9143024"/>
              <a:gd name="connsiteY2" fmla="*/ 206268 h 1339743"/>
              <a:gd name="connsiteX3" fmla="*/ 804944 w 9143024"/>
              <a:gd name="connsiteY3" fmla="*/ 245267 h 1339743"/>
              <a:gd name="connsiteX4" fmla="*/ 848337 w 9143024"/>
              <a:gd name="connsiteY4" fmla="*/ 203887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7374 w 9143024"/>
              <a:gd name="connsiteY2" fmla="*/ 206268 h 1339743"/>
              <a:gd name="connsiteX3" fmla="*/ 804944 w 9143024"/>
              <a:gd name="connsiteY3" fmla="*/ 245267 h 1339743"/>
              <a:gd name="connsiteX4" fmla="*/ 843574 w 9143024"/>
              <a:gd name="connsiteY4" fmla="*/ 199125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7374 w 9143024"/>
              <a:gd name="connsiteY2" fmla="*/ 199124 h 1339743"/>
              <a:gd name="connsiteX3" fmla="*/ 804944 w 9143024"/>
              <a:gd name="connsiteY3" fmla="*/ 245267 h 1339743"/>
              <a:gd name="connsiteX4" fmla="*/ 843574 w 9143024"/>
              <a:gd name="connsiteY4" fmla="*/ 199125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7374 w 9143024"/>
              <a:gd name="connsiteY2" fmla="*/ 199124 h 1339743"/>
              <a:gd name="connsiteX3" fmla="*/ 804944 w 9143024"/>
              <a:gd name="connsiteY3" fmla="*/ 245267 h 1339743"/>
              <a:gd name="connsiteX4" fmla="*/ 843574 w 9143024"/>
              <a:gd name="connsiteY4" fmla="*/ 199125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55468 w 9143024"/>
              <a:gd name="connsiteY2" fmla="*/ 232462 h 1339743"/>
              <a:gd name="connsiteX3" fmla="*/ 804944 w 9143024"/>
              <a:gd name="connsiteY3" fmla="*/ 245267 h 1339743"/>
              <a:gd name="connsiteX4" fmla="*/ 843574 w 9143024"/>
              <a:gd name="connsiteY4" fmla="*/ 199125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4993 w 9143024"/>
              <a:gd name="connsiteY2" fmla="*/ 201506 h 1339743"/>
              <a:gd name="connsiteX3" fmla="*/ 804944 w 9143024"/>
              <a:gd name="connsiteY3" fmla="*/ 245267 h 1339743"/>
              <a:gd name="connsiteX4" fmla="*/ 843574 w 9143024"/>
              <a:gd name="connsiteY4" fmla="*/ 199125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4993 w 9143024"/>
              <a:gd name="connsiteY2" fmla="*/ 201506 h 1339743"/>
              <a:gd name="connsiteX3" fmla="*/ 804944 w 9143024"/>
              <a:gd name="connsiteY3" fmla="*/ 245267 h 1339743"/>
              <a:gd name="connsiteX4" fmla="*/ 843574 w 9143024"/>
              <a:gd name="connsiteY4" fmla="*/ 199125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4993 w 9143024"/>
              <a:gd name="connsiteY2" fmla="*/ 201506 h 1339743"/>
              <a:gd name="connsiteX3" fmla="*/ 804944 w 9143024"/>
              <a:gd name="connsiteY3" fmla="*/ 245267 h 1339743"/>
              <a:gd name="connsiteX4" fmla="*/ 843574 w 9143024"/>
              <a:gd name="connsiteY4" fmla="*/ 199125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4993 w 9143024"/>
              <a:gd name="connsiteY2" fmla="*/ 201506 h 1339743"/>
              <a:gd name="connsiteX3" fmla="*/ 785894 w 9143024"/>
              <a:gd name="connsiteY3" fmla="*/ 245267 h 1339743"/>
              <a:gd name="connsiteX4" fmla="*/ 843574 w 9143024"/>
              <a:gd name="connsiteY4" fmla="*/ 199125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4993 w 9143024"/>
              <a:gd name="connsiteY2" fmla="*/ 201506 h 1339743"/>
              <a:gd name="connsiteX3" fmla="*/ 797800 w 9143024"/>
              <a:gd name="connsiteY3" fmla="*/ 245267 h 1339743"/>
              <a:gd name="connsiteX4" fmla="*/ 843574 w 9143024"/>
              <a:gd name="connsiteY4" fmla="*/ 199125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4993 w 9143024"/>
              <a:gd name="connsiteY2" fmla="*/ 201506 h 1339743"/>
              <a:gd name="connsiteX3" fmla="*/ 797800 w 9143024"/>
              <a:gd name="connsiteY3" fmla="*/ 245267 h 1339743"/>
              <a:gd name="connsiteX4" fmla="*/ 843574 w 9143024"/>
              <a:gd name="connsiteY4" fmla="*/ 199125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4993 w 9143024"/>
              <a:gd name="connsiteY2" fmla="*/ 201506 h 1339743"/>
              <a:gd name="connsiteX3" fmla="*/ 797800 w 9143024"/>
              <a:gd name="connsiteY3" fmla="*/ 245267 h 1339743"/>
              <a:gd name="connsiteX4" fmla="*/ 843574 w 9143024"/>
              <a:gd name="connsiteY4" fmla="*/ 199125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4993 w 9143024"/>
              <a:gd name="connsiteY2" fmla="*/ 201506 h 1339743"/>
              <a:gd name="connsiteX3" fmla="*/ 797800 w 9143024"/>
              <a:gd name="connsiteY3" fmla="*/ 245267 h 1339743"/>
              <a:gd name="connsiteX4" fmla="*/ 843574 w 9143024"/>
              <a:gd name="connsiteY4" fmla="*/ 199125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4993 w 9143024"/>
              <a:gd name="connsiteY2" fmla="*/ 201506 h 1339743"/>
              <a:gd name="connsiteX3" fmla="*/ 802562 w 9143024"/>
              <a:gd name="connsiteY3" fmla="*/ 245267 h 1339743"/>
              <a:gd name="connsiteX4" fmla="*/ 843574 w 9143024"/>
              <a:gd name="connsiteY4" fmla="*/ 199125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4993 w 9143024"/>
              <a:gd name="connsiteY2" fmla="*/ 201506 h 1339743"/>
              <a:gd name="connsiteX3" fmla="*/ 804943 w 9143024"/>
              <a:gd name="connsiteY3" fmla="*/ 242886 h 1339743"/>
              <a:gd name="connsiteX4" fmla="*/ 843574 w 9143024"/>
              <a:gd name="connsiteY4" fmla="*/ 199125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4993 w 9143024"/>
              <a:gd name="connsiteY2" fmla="*/ 201506 h 1339743"/>
              <a:gd name="connsiteX3" fmla="*/ 804943 w 9143024"/>
              <a:gd name="connsiteY3" fmla="*/ 242886 h 1339743"/>
              <a:gd name="connsiteX4" fmla="*/ 843574 w 9143024"/>
              <a:gd name="connsiteY4" fmla="*/ 199125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0 w 9142042"/>
              <a:gd name="connsiteY0" fmla="*/ 1232 h 1339743"/>
              <a:gd name="connsiteX1" fmla="*/ 667491 w 9142042"/>
              <a:gd name="connsiteY1" fmla="*/ 0 h 1339743"/>
              <a:gd name="connsiteX2" fmla="*/ 764011 w 9142042"/>
              <a:gd name="connsiteY2" fmla="*/ 201506 h 1339743"/>
              <a:gd name="connsiteX3" fmla="*/ 803961 w 9142042"/>
              <a:gd name="connsiteY3" fmla="*/ 242886 h 1339743"/>
              <a:gd name="connsiteX4" fmla="*/ 842592 w 9142042"/>
              <a:gd name="connsiteY4" fmla="*/ 199125 h 1339743"/>
              <a:gd name="connsiteX5" fmla="*/ 946097 w 9142042"/>
              <a:gd name="connsiteY5" fmla="*/ 0 h 1339743"/>
              <a:gd name="connsiteX6" fmla="*/ 9142042 w 9142042"/>
              <a:gd name="connsiteY6" fmla="*/ 1233 h 1339743"/>
              <a:gd name="connsiteX7" fmla="*/ 9142042 w 9142042"/>
              <a:gd name="connsiteY7" fmla="*/ 1339743 h 1339743"/>
              <a:gd name="connsiteX8" fmla="*/ 121073 w 9142042"/>
              <a:gd name="connsiteY8" fmla="*/ 1215918 h 1339743"/>
              <a:gd name="connsiteX9" fmla="*/ 0 w 9142042"/>
              <a:gd name="connsiteY9" fmla="*/ 1232 h 1339743"/>
              <a:gd name="connsiteX0" fmla="*/ 982 w 9143024"/>
              <a:gd name="connsiteY0" fmla="*/ 1232 h 1342124"/>
              <a:gd name="connsiteX1" fmla="*/ 668473 w 9143024"/>
              <a:gd name="connsiteY1" fmla="*/ 0 h 1342124"/>
              <a:gd name="connsiteX2" fmla="*/ 764993 w 9143024"/>
              <a:gd name="connsiteY2" fmla="*/ 201506 h 1342124"/>
              <a:gd name="connsiteX3" fmla="*/ 804943 w 9143024"/>
              <a:gd name="connsiteY3" fmla="*/ 242886 h 1342124"/>
              <a:gd name="connsiteX4" fmla="*/ 843574 w 9143024"/>
              <a:gd name="connsiteY4" fmla="*/ 199125 h 1342124"/>
              <a:gd name="connsiteX5" fmla="*/ 947079 w 9143024"/>
              <a:gd name="connsiteY5" fmla="*/ 0 h 1342124"/>
              <a:gd name="connsiteX6" fmla="*/ 9143024 w 9143024"/>
              <a:gd name="connsiteY6" fmla="*/ 1233 h 1342124"/>
              <a:gd name="connsiteX7" fmla="*/ 9143024 w 9143024"/>
              <a:gd name="connsiteY7" fmla="*/ 1339743 h 1342124"/>
              <a:gd name="connsiteX8" fmla="*/ 611 w 9143024"/>
              <a:gd name="connsiteY8" fmla="*/ 1342124 h 1342124"/>
              <a:gd name="connsiteX9" fmla="*/ 982 w 9143024"/>
              <a:gd name="connsiteY9" fmla="*/ 1232 h 1342124"/>
              <a:gd name="connsiteX0" fmla="*/ 371 w 9142413"/>
              <a:gd name="connsiteY0" fmla="*/ 1232 h 1342124"/>
              <a:gd name="connsiteX1" fmla="*/ 667862 w 9142413"/>
              <a:gd name="connsiteY1" fmla="*/ 0 h 1342124"/>
              <a:gd name="connsiteX2" fmla="*/ 764382 w 9142413"/>
              <a:gd name="connsiteY2" fmla="*/ 201506 h 1342124"/>
              <a:gd name="connsiteX3" fmla="*/ 804332 w 9142413"/>
              <a:gd name="connsiteY3" fmla="*/ 242886 h 1342124"/>
              <a:gd name="connsiteX4" fmla="*/ 842963 w 9142413"/>
              <a:gd name="connsiteY4" fmla="*/ 199125 h 1342124"/>
              <a:gd name="connsiteX5" fmla="*/ 946468 w 9142413"/>
              <a:gd name="connsiteY5" fmla="*/ 0 h 1342124"/>
              <a:gd name="connsiteX6" fmla="*/ 9142413 w 9142413"/>
              <a:gd name="connsiteY6" fmla="*/ 1233 h 1342124"/>
              <a:gd name="connsiteX7" fmla="*/ 9142413 w 9142413"/>
              <a:gd name="connsiteY7" fmla="*/ 1339743 h 1342124"/>
              <a:gd name="connsiteX8" fmla="*/ 0 w 9142413"/>
              <a:gd name="connsiteY8" fmla="*/ 1342124 h 1342124"/>
              <a:gd name="connsiteX9" fmla="*/ 371 w 9142413"/>
              <a:gd name="connsiteY9" fmla="*/ 1232 h 1342124"/>
              <a:gd name="connsiteX0" fmla="*/ 371 w 9142413"/>
              <a:gd name="connsiteY0" fmla="*/ 1232 h 1342124"/>
              <a:gd name="connsiteX1" fmla="*/ 667862 w 9142413"/>
              <a:gd name="connsiteY1" fmla="*/ 0 h 1342124"/>
              <a:gd name="connsiteX2" fmla="*/ 764382 w 9142413"/>
              <a:gd name="connsiteY2" fmla="*/ 201506 h 1342124"/>
              <a:gd name="connsiteX3" fmla="*/ 804332 w 9142413"/>
              <a:gd name="connsiteY3" fmla="*/ 242886 h 1342124"/>
              <a:gd name="connsiteX4" fmla="*/ 842963 w 9142413"/>
              <a:gd name="connsiteY4" fmla="*/ 199125 h 1342124"/>
              <a:gd name="connsiteX5" fmla="*/ 946468 w 9142413"/>
              <a:gd name="connsiteY5" fmla="*/ 0 h 1342124"/>
              <a:gd name="connsiteX6" fmla="*/ 9142413 w 9142413"/>
              <a:gd name="connsiteY6" fmla="*/ 1233 h 1342124"/>
              <a:gd name="connsiteX7" fmla="*/ 9142413 w 9142413"/>
              <a:gd name="connsiteY7" fmla="*/ 1339743 h 1342124"/>
              <a:gd name="connsiteX8" fmla="*/ 0 w 9142413"/>
              <a:gd name="connsiteY8" fmla="*/ 1342124 h 1342124"/>
              <a:gd name="connsiteX9" fmla="*/ 371 w 9142413"/>
              <a:gd name="connsiteY9" fmla="*/ 1232 h 1342124"/>
              <a:gd name="connsiteX0" fmla="*/ 0 w 9142042"/>
              <a:gd name="connsiteY0" fmla="*/ 1232 h 1339743"/>
              <a:gd name="connsiteX1" fmla="*/ 667491 w 9142042"/>
              <a:gd name="connsiteY1" fmla="*/ 0 h 1339743"/>
              <a:gd name="connsiteX2" fmla="*/ 764011 w 9142042"/>
              <a:gd name="connsiteY2" fmla="*/ 201506 h 1339743"/>
              <a:gd name="connsiteX3" fmla="*/ 803961 w 9142042"/>
              <a:gd name="connsiteY3" fmla="*/ 242886 h 1339743"/>
              <a:gd name="connsiteX4" fmla="*/ 842592 w 9142042"/>
              <a:gd name="connsiteY4" fmla="*/ 199125 h 1339743"/>
              <a:gd name="connsiteX5" fmla="*/ 946097 w 9142042"/>
              <a:gd name="connsiteY5" fmla="*/ 0 h 1339743"/>
              <a:gd name="connsiteX6" fmla="*/ 9142042 w 9142042"/>
              <a:gd name="connsiteY6" fmla="*/ 1233 h 1339743"/>
              <a:gd name="connsiteX7" fmla="*/ 9142042 w 9142042"/>
              <a:gd name="connsiteY7" fmla="*/ 1339743 h 1339743"/>
              <a:gd name="connsiteX8" fmla="*/ 97260 w 9142042"/>
              <a:gd name="connsiteY8" fmla="*/ 1177817 h 1339743"/>
              <a:gd name="connsiteX9" fmla="*/ 0 w 9142042"/>
              <a:gd name="connsiteY9" fmla="*/ 1232 h 1339743"/>
              <a:gd name="connsiteX0" fmla="*/ 0 w 9142042"/>
              <a:gd name="connsiteY0" fmla="*/ 1232 h 1342124"/>
              <a:gd name="connsiteX1" fmla="*/ 667491 w 9142042"/>
              <a:gd name="connsiteY1" fmla="*/ 0 h 1342124"/>
              <a:gd name="connsiteX2" fmla="*/ 764011 w 9142042"/>
              <a:gd name="connsiteY2" fmla="*/ 201506 h 1342124"/>
              <a:gd name="connsiteX3" fmla="*/ 803961 w 9142042"/>
              <a:gd name="connsiteY3" fmla="*/ 242886 h 1342124"/>
              <a:gd name="connsiteX4" fmla="*/ 842592 w 9142042"/>
              <a:gd name="connsiteY4" fmla="*/ 199125 h 1342124"/>
              <a:gd name="connsiteX5" fmla="*/ 946097 w 9142042"/>
              <a:gd name="connsiteY5" fmla="*/ 0 h 1342124"/>
              <a:gd name="connsiteX6" fmla="*/ 9142042 w 9142042"/>
              <a:gd name="connsiteY6" fmla="*/ 1233 h 1342124"/>
              <a:gd name="connsiteX7" fmla="*/ 9142042 w 9142042"/>
              <a:gd name="connsiteY7" fmla="*/ 1339743 h 1342124"/>
              <a:gd name="connsiteX8" fmla="*/ 2010 w 9142042"/>
              <a:gd name="connsiteY8" fmla="*/ 1342124 h 1342124"/>
              <a:gd name="connsiteX9" fmla="*/ 0 w 9142042"/>
              <a:gd name="connsiteY9" fmla="*/ 1232 h 1342124"/>
              <a:gd name="connsiteX0" fmla="*/ 0 w 9142042"/>
              <a:gd name="connsiteY0" fmla="*/ 1232 h 1342124"/>
              <a:gd name="connsiteX1" fmla="*/ 667491 w 9142042"/>
              <a:gd name="connsiteY1" fmla="*/ 0 h 1342124"/>
              <a:gd name="connsiteX2" fmla="*/ 764011 w 9142042"/>
              <a:gd name="connsiteY2" fmla="*/ 201506 h 1342124"/>
              <a:gd name="connsiteX3" fmla="*/ 803961 w 9142042"/>
              <a:gd name="connsiteY3" fmla="*/ 242886 h 1342124"/>
              <a:gd name="connsiteX4" fmla="*/ 842592 w 9142042"/>
              <a:gd name="connsiteY4" fmla="*/ 199125 h 1342124"/>
              <a:gd name="connsiteX5" fmla="*/ 946097 w 9142042"/>
              <a:gd name="connsiteY5" fmla="*/ 0 h 1342124"/>
              <a:gd name="connsiteX6" fmla="*/ 9142042 w 9142042"/>
              <a:gd name="connsiteY6" fmla="*/ 1233 h 1342124"/>
              <a:gd name="connsiteX7" fmla="*/ 9142042 w 9142042"/>
              <a:gd name="connsiteY7" fmla="*/ 1339743 h 1342124"/>
              <a:gd name="connsiteX8" fmla="*/ 2010 w 9142042"/>
              <a:gd name="connsiteY8" fmla="*/ 1342124 h 1342124"/>
              <a:gd name="connsiteX9" fmla="*/ 0 w 9142042"/>
              <a:gd name="connsiteY9" fmla="*/ 1232 h 1342124"/>
              <a:gd name="connsiteX0" fmla="*/ 0 w 9142042"/>
              <a:gd name="connsiteY0" fmla="*/ 1232 h 1342124"/>
              <a:gd name="connsiteX1" fmla="*/ 667491 w 9142042"/>
              <a:gd name="connsiteY1" fmla="*/ 0 h 1342124"/>
              <a:gd name="connsiteX2" fmla="*/ 764011 w 9142042"/>
              <a:gd name="connsiteY2" fmla="*/ 201506 h 1342124"/>
              <a:gd name="connsiteX3" fmla="*/ 803961 w 9142042"/>
              <a:gd name="connsiteY3" fmla="*/ 242886 h 1342124"/>
              <a:gd name="connsiteX4" fmla="*/ 842592 w 9142042"/>
              <a:gd name="connsiteY4" fmla="*/ 199125 h 1342124"/>
              <a:gd name="connsiteX5" fmla="*/ 946097 w 9142042"/>
              <a:gd name="connsiteY5" fmla="*/ 0 h 1342124"/>
              <a:gd name="connsiteX6" fmla="*/ 9142042 w 9142042"/>
              <a:gd name="connsiteY6" fmla="*/ 1233 h 1342124"/>
              <a:gd name="connsiteX7" fmla="*/ 9142042 w 9142042"/>
              <a:gd name="connsiteY7" fmla="*/ 1339743 h 1342124"/>
              <a:gd name="connsiteX8" fmla="*/ 2010 w 9142042"/>
              <a:gd name="connsiteY8" fmla="*/ 1342124 h 1342124"/>
              <a:gd name="connsiteX9" fmla="*/ 0 w 9142042"/>
              <a:gd name="connsiteY9" fmla="*/ 1232 h 1342124"/>
              <a:gd name="connsiteX0" fmla="*/ 0 w 9142042"/>
              <a:gd name="connsiteY0" fmla="*/ 1232 h 1342124"/>
              <a:gd name="connsiteX1" fmla="*/ 667491 w 9142042"/>
              <a:gd name="connsiteY1" fmla="*/ 0 h 1342124"/>
              <a:gd name="connsiteX2" fmla="*/ 764011 w 9142042"/>
              <a:gd name="connsiteY2" fmla="*/ 201506 h 1342124"/>
              <a:gd name="connsiteX3" fmla="*/ 803961 w 9142042"/>
              <a:gd name="connsiteY3" fmla="*/ 242886 h 1342124"/>
              <a:gd name="connsiteX4" fmla="*/ 842592 w 9142042"/>
              <a:gd name="connsiteY4" fmla="*/ 199125 h 1342124"/>
              <a:gd name="connsiteX5" fmla="*/ 946097 w 9142042"/>
              <a:gd name="connsiteY5" fmla="*/ 0 h 1342124"/>
              <a:gd name="connsiteX6" fmla="*/ 9142042 w 9142042"/>
              <a:gd name="connsiteY6" fmla="*/ 1233 h 1342124"/>
              <a:gd name="connsiteX7" fmla="*/ 9142042 w 9142042"/>
              <a:gd name="connsiteY7" fmla="*/ 1339743 h 1342124"/>
              <a:gd name="connsiteX8" fmla="*/ 2010 w 9142042"/>
              <a:gd name="connsiteY8" fmla="*/ 1342124 h 1342124"/>
              <a:gd name="connsiteX9" fmla="*/ 0 w 9142042"/>
              <a:gd name="connsiteY9" fmla="*/ 1232 h 1342124"/>
              <a:gd name="connsiteX0" fmla="*/ 0 w 9142042"/>
              <a:gd name="connsiteY0" fmla="*/ 1232 h 1342124"/>
              <a:gd name="connsiteX1" fmla="*/ 667491 w 9142042"/>
              <a:gd name="connsiteY1" fmla="*/ 0 h 1342124"/>
              <a:gd name="connsiteX2" fmla="*/ 764011 w 9142042"/>
              <a:gd name="connsiteY2" fmla="*/ 201506 h 1342124"/>
              <a:gd name="connsiteX3" fmla="*/ 803961 w 9142042"/>
              <a:gd name="connsiteY3" fmla="*/ 242886 h 1342124"/>
              <a:gd name="connsiteX4" fmla="*/ 842592 w 9142042"/>
              <a:gd name="connsiteY4" fmla="*/ 199125 h 1342124"/>
              <a:gd name="connsiteX5" fmla="*/ 946097 w 9142042"/>
              <a:gd name="connsiteY5" fmla="*/ 0 h 1342124"/>
              <a:gd name="connsiteX6" fmla="*/ 9142042 w 9142042"/>
              <a:gd name="connsiteY6" fmla="*/ 1233 h 1342124"/>
              <a:gd name="connsiteX7" fmla="*/ 9142042 w 9142042"/>
              <a:gd name="connsiteY7" fmla="*/ 1339743 h 1342124"/>
              <a:gd name="connsiteX8" fmla="*/ 2010 w 9142042"/>
              <a:gd name="connsiteY8" fmla="*/ 1342124 h 1342124"/>
              <a:gd name="connsiteX9" fmla="*/ 0 w 9142042"/>
              <a:gd name="connsiteY9" fmla="*/ 1232 h 1342124"/>
              <a:gd name="connsiteX0" fmla="*/ 0 w 9142042"/>
              <a:gd name="connsiteY0" fmla="*/ 1232 h 1342124"/>
              <a:gd name="connsiteX1" fmla="*/ 667491 w 9142042"/>
              <a:gd name="connsiteY1" fmla="*/ 0 h 1342124"/>
              <a:gd name="connsiteX2" fmla="*/ 764011 w 9142042"/>
              <a:gd name="connsiteY2" fmla="*/ 201506 h 1342124"/>
              <a:gd name="connsiteX3" fmla="*/ 803961 w 9142042"/>
              <a:gd name="connsiteY3" fmla="*/ 242886 h 1342124"/>
              <a:gd name="connsiteX4" fmla="*/ 842592 w 9142042"/>
              <a:gd name="connsiteY4" fmla="*/ 199125 h 1342124"/>
              <a:gd name="connsiteX5" fmla="*/ 946097 w 9142042"/>
              <a:gd name="connsiteY5" fmla="*/ 0 h 1342124"/>
              <a:gd name="connsiteX6" fmla="*/ 9142042 w 9142042"/>
              <a:gd name="connsiteY6" fmla="*/ 1233 h 1342124"/>
              <a:gd name="connsiteX7" fmla="*/ 9142042 w 9142042"/>
              <a:gd name="connsiteY7" fmla="*/ 1339743 h 1342124"/>
              <a:gd name="connsiteX8" fmla="*/ 2010 w 9142042"/>
              <a:gd name="connsiteY8" fmla="*/ 1342124 h 1342124"/>
              <a:gd name="connsiteX9" fmla="*/ 0 w 9142042"/>
              <a:gd name="connsiteY9" fmla="*/ 1232 h 134212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9142042" h="1342124">
                <a:moveTo>
                  <a:pt x="0" y="1232"/>
                </a:moveTo>
                <a:lnTo>
                  <a:pt x="667491" y="0"/>
                </a:lnTo>
                <a:cubicBezTo>
                  <a:pt x="720213" y="108785"/>
                  <a:pt x="750791" y="175313"/>
                  <a:pt x="764011" y="201506"/>
                </a:cubicBezTo>
                <a:cubicBezTo>
                  <a:pt x="777231" y="227699"/>
                  <a:pt x="783720" y="243371"/>
                  <a:pt x="803961" y="242886"/>
                </a:cubicBezTo>
                <a:cubicBezTo>
                  <a:pt x="814677" y="242629"/>
                  <a:pt x="828428" y="227700"/>
                  <a:pt x="842592" y="199125"/>
                </a:cubicBezTo>
                <a:cubicBezTo>
                  <a:pt x="856756" y="170550"/>
                  <a:pt x="880877" y="123469"/>
                  <a:pt x="946097" y="0"/>
                </a:cubicBezTo>
                <a:lnTo>
                  <a:pt x="9142042" y="1233"/>
                </a:lnTo>
                <a:lnTo>
                  <a:pt x="9142042" y="1339743"/>
                </a:lnTo>
                <a:lnTo>
                  <a:pt x="2010" y="1342124"/>
                </a:lnTo>
                <a:cubicBezTo>
                  <a:pt x="-247" y="945166"/>
                  <a:pt x="2258" y="445815"/>
                  <a:pt x="0" y="1232"/>
                </a:cubicBezTo>
                <a:close/>
              </a:path>
            </a:pathLst>
          </a:custGeom>
        </p:spPr>
        <p:txBody>
          <a:bodyPr anchor="ctr" anchorCtr="0"/>
          <a:lstStyle>
            <a:lvl1pPr marL="0" indent="0" algn="ctr">
              <a:buNone/>
              <a:defRPr/>
            </a:lvl1pPr>
          </a:lstStyle>
          <a:p>
            <a:r>
              <a:rPr lang="en-US"/>
              <a:t>Click icon to add picture</a:t>
            </a:r>
          </a:p>
        </p:txBody>
      </p:sp>
      <p:sp>
        <p:nvSpPr>
          <p:cNvPr id="6" name="Text Placeholder 5"/>
          <p:cNvSpPr>
            <a:spLocks noGrp="1"/>
          </p:cNvSpPr>
          <p:nvPr>
            <p:ph type="body" sz="quarter" idx="11"/>
          </p:nvPr>
        </p:nvSpPr>
        <p:spPr>
          <a:xfrm>
            <a:off x="6675968" y="605957"/>
            <a:ext cx="4906433" cy="328231"/>
          </a:xfrm>
        </p:spPr>
        <p:txBody>
          <a:bodyPr anchor="ctr" anchorCtr="0">
            <a:spAutoFit/>
          </a:bodyPr>
          <a:lstStyle>
            <a:lvl1pPr marL="0" indent="0" algn="r">
              <a:buNone/>
              <a:defRPr sz="2133">
                <a:solidFill>
                  <a:schemeClr val="bg1"/>
                </a:solidFill>
              </a:defRPr>
            </a:lvl1pPr>
            <a:lvl2pPr marL="306910" indent="0">
              <a:buNone/>
              <a:defRPr/>
            </a:lvl2pPr>
          </a:lstStyle>
          <a:p>
            <a:pPr lvl="0"/>
            <a:r>
              <a:rPr lang="en-US"/>
              <a:t>Click to edit Master text styles</a:t>
            </a:r>
          </a:p>
        </p:txBody>
      </p:sp>
    </p:spTree>
    <p:extLst>
      <p:ext uri="{BB962C8B-B14F-4D97-AF65-F5344CB8AC3E}">
        <p14:creationId xmlns:p14="http://schemas.microsoft.com/office/powerpoint/2010/main" val="180204257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Thank You">
    <p:bg>
      <p:bgPr>
        <a:solidFill>
          <a:schemeClr val="tx2"/>
        </a:solidFill>
        <a:effectLst/>
      </p:bgPr>
    </p:bg>
    <p:spTree>
      <p:nvGrpSpPr>
        <p:cNvPr id="1" name=""/>
        <p:cNvGrpSpPr/>
        <p:nvPr/>
      </p:nvGrpSpPr>
      <p:grpSpPr>
        <a:xfrm>
          <a:off x="0" y="0"/>
          <a:ext cx="0" cy="0"/>
          <a:chOff x="0" y="0"/>
          <a:chExt cx="0" cy="0"/>
        </a:xfrm>
      </p:grpSpPr>
      <p:sp>
        <p:nvSpPr>
          <p:cNvPr id="3" name="Picture Placeholder 2"/>
          <p:cNvSpPr>
            <a:spLocks noGrp="1"/>
          </p:cNvSpPr>
          <p:nvPr>
            <p:ph type="pic" sz="quarter" idx="10"/>
          </p:nvPr>
        </p:nvSpPr>
        <p:spPr>
          <a:xfrm>
            <a:off x="0" y="3"/>
            <a:ext cx="12192000" cy="5362576"/>
          </a:xfrm>
          <a:custGeom>
            <a:avLst/>
            <a:gdLst>
              <a:gd name="connsiteX0" fmla="*/ 0 w 9144000"/>
              <a:gd name="connsiteY0" fmla="*/ 0 h 3783806"/>
              <a:gd name="connsiteX1" fmla="*/ 9144000 w 9144000"/>
              <a:gd name="connsiteY1" fmla="*/ 0 h 3783806"/>
              <a:gd name="connsiteX2" fmla="*/ 9144000 w 9144000"/>
              <a:gd name="connsiteY2" fmla="*/ 3783806 h 3783806"/>
              <a:gd name="connsiteX3" fmla="*/ 0 w 9144000"/>
              <a:gd name="connsiteY3" fmla="*/ 3783806 h 3783806"/>
              <a:gd name="connsiteX4" fmla="*/ 0 w 9144000"/>
              <a:gd name="connsiteY4" fmla="*/ 0 h 3783806"/>
              <a:gd name="connsiteX0" fmla="*/ 0 w 9144000"/>
              <a:gd name="connsiteY0" fmla="*/ 0 h 3783806"/>
              <a:gd name="connsiteX1" fmla="*/ 9144000 w 9144000"/>
              <a:gd name="connsiteY1" fmla="*/ 0 h 3783806"/>
              <a:gd name="connsiteX2" fmla="*/ 9144000 w 9144000"/>
              <a:gd name="connsiteY2" fmla="*/ 3783806 h 3783806"/>
              <a:gd name="connsiteX3" fmla="*/ 723900 w 9144000"/>
              <a:gd name="connsiteY3" fmla="*/ 3781425 h 3783806"/>
              <a:gd name="connsiteX4" fmla="*/ 0 w 9144000"/>
              <a:gd name="connsiteY4" fmla="*/ 3783806 h 3783806"/>
              <a:gd name="connsiteX5" fmla="*/ 0 w 9144000"/>
              <a:gd name="connsiteY5" fmla="*/ 0 h 3783806"/>
              <a:gd name="connsiteX0" fmla="*/ 0 w 9144000"/>
              <a:gd name="connsiteY0" fmla="*/ 0 h 3783806"/>
              <a:gd name="connsiteX1" fmla="*/ 9144000 w 9144000"/>
              <a:gd name="connsiteY1" fmla="*/ 0 h 3783806"/>
              <a:gd name="connsiteX2" fmla="*/ 9144000 w 9144000"/>
              <a:gd name="connsiteY2" fmla="*/ 3783806 h 3783806"/>
              <a:gd name="connsiteX3" fmla="*/ 692944 w 9144000"/>
              <a:gd name="connsiteY3" fmla="*/ 3781425 h 3783806"/>
              <a:gd name="connsiteX4" fmla="*/ 0 w 9144000"/>
              <a:gd name="connsiteY4" fmla="*/ 3783806 h 3783806"/>
              <a:gd name="connsiteX5" fmla="*/ 0 w 9144000"/>
              <a:gd name="connsiteY5" fmla="*/ 0 h 3783806"/>
              <a:gd name="connsiteX0" fmla="*/ 0 w 9144000"/>
              <a:gd name="connsiteY0" fmla="*/ 0 h 3783806"/>
              <a:gd name="connsiteX1" fmla="*/ 9144000 w 9144000"/>
              <a:gd name="connsiteY1" fmla="*/ 0 h 3783806"/>
              <a:gd name="connsiteX2" fmla="*/ 9144000 w 9144000"/>
              <a:gd name="connsiteY2" fmla="*/ 3783806 h 3783806"/>
              <a:gd name="connsiteX3" fmla="*/ 954881 w 9144000"/>
              <a:gd name="connsiteY3" fmla="*/ 3779044 h 3783806"/>
              <a:gd name="connsiteX4" fmla="*/ 692944 w 9144000"/>
              <a:gd name="connsiteY4" fmla="*/ 3781425 h 3783806"/>
              <a:gd name="connsiteX5" fmla="*/ 0 w 9144000"/>
              <a:gd name="connsiteY5" fmla="*/ 3783806 h 3783806"/>
              <a:gd name="connsiteX6" fmla="*/ 0 w 9144000"/>
              <a:gd name="connsiteY6" fmla="*/ 0 h 3783806"/>
              <a:gd name="connsiteX0" fmla="*/ 0 w 9144000"/>
              <a:gd name="connsiteY0" fmla="*/ 0 h 3783806"/>
              <a:gd name="connsiteX1" fmla="*/ 9144000 w 9144000"/>
              <a:gd name="connsiteY1" fmla="*/ 0 h 3783806"/>
              <a:gd name="connsiteX2" fmla="*/ 9144000 w 9144000"/>
              <a:gd name="connsiteY2" fmla="*/ 3783806 h 3783806"/>
              <a:gd name="connsiteX3" fmla="*/ 954881 w 9144000"/>
              <a:gd name="connsiteY3" fmla="*/ 3779044 h 3783806"/>
              <a:gd name="connsiteX4" fmla="*/ 821531 w 9144000"/>
              <a:gd name="connsiteY4" fmla="*/ 3779044 h 3783806"/>
              <a:gd name="connsiteX5" fmla="*/ 692944 w 9144000"/>
              <a:gd name="connsiteY5" fmla="*/ 3781425 h 3783806"/>
              <a:gd name="connsiteX6" fmla="*/ 0 w 9144000"/>
              <a:gd name="connsiteY6" fmla="*/ 3783806 h 3783806"/>
              <a:gd name="connsiteX7" fmla="*/ 0 w 9144000"/>
              <a:gd name="connsiteY7" fmla="*/ 0 h 3783806"/>
              <a:gd name="connsiteX0" fmla="*/ 0 w 9144000"/>
              <a:gd name="connsiteY0" fmla="*/ 0 h 4024313"/>
              <a:gd name="connsiteX1" fmla="*/ 9144000 w 9144000"/>
              <a:gd name="connsiteY1" fmla="*/ 0 h 4024313"/>
              <a:gd name="connsiteX2" fmla="*/ 9144000 w 9144000"/>
              <a:gd name="connsiteY2" fmla="*/ 3783806 h 4024313"/>
              <a:gd name="connsiteX3" fmla="*/ 954881 w 9144000"/>
              <a:gd name="connsiteY3" fmla="*/ 3779044 h 4024313"/>
              <a:gd name="connsiteX4" fmla="*/ 826293 w 9144000"/>
              <a:gd name="connsiteY4" fmla="*/ 4024313 h 4024313"/>
              <a:gd name="connsiteX5" fmla="*/ 692944 w 9144000"/>
              <a:gd name="connsiteY5" fmla="*/ 3781425 h 4024313"/>
              <a:gd name="connsiteX6" fmla="*/ 0 w 9144000"/>
              <a:gd name="connsiteY6" fmla="*/ 3783806 h 4024313"/>
              <a:gd name="connsiteX7" fmla="*/ 0 w 9144000"/>
              <a:gd name="connsiteY7" fmla="*/ 0 h 4024313"/>
              <a:gd name="connsiteX0" fmla="*/ 0 w 9144000"/>
              <a:gd name="connsiteY0" fmla="*/ 0 h 4024313"/>
              <a:gd name="connsiteX1" fmla="*/ 9144000 w 9144000"/>
              <a:gd name="connsiteY1" fmla="*/ 0 h 4024313"/>
              <a:gd name="connsiteX2" fmla="*/ 9144000 w 9144000"/>
              <a:gd name="connsiteY2" fmla="*/ 3783806 h 4024313"/>
              <a:gd name="connsiteX3" fmla="*/ 954881 w 9144000"/>
              <a:gd name="connsiteY3" fmla="*/ 3779044 h 4024313"/>
              <a:gd name="connsiteX4" fmla="*/ 826293 w 9144000"/>
              <a:gd name="connsiteY4" fmla="*/ 4024313 h 4024313"/>
              <a:gd name="connsiteX5" fmla="*/ 692944 w 9144000"/>
              <a:gd name="connsiteY5" fmla="*/ 3781425 h 4024313"/>
              <a:gd name="connsiteX6" fmla="*/ 0 w 9144000"/>
              <a:gd name="connsiteY6" fmla="*/ 3783806 h 4024313"/>
              <a:gd name="connsiteX7" fmla="*/ 0 w 9144000"/>
              <a:gd name="connsiteY7" fmla="*/ 0 h 4024313"/>
              <a:gd name="connsiteX0" fmla="*/ 0 w 9144000"/>
              <a:gd name="connsiteY0" fmla="*/ 0 h 4024313"/>
              <a:gd name="connsiteX1" fmla="*/ 9144000 w 9144000"/>
              <a:gd name="connsiteY1" fmla="*/ 0 h 4024313"/>
              <a:gd name="connsiteX2" fmla="*/ 9144000 w 9144000"/>
              <a:gd name="connsiteY2" fmla="*/ 3783806 h 4024313"/>
              <a:gd name="connsiteX3" fmla="*/ 954881 w 9144000"/>
              <a:gd name="connsiteY3" fmla="*/ 3779044 h 4024313"/>
              <a:gd name="connsiteX4" fmla="*/ 826293 w 9144000"/>
              <a:gd name="connsiteY4" fmla="*/ 4024313 h 4024313"/>
              <a:gd name="connsiteX5" fmla="*/ 692944 w 9144000"/>
              <a:gd name="connsiteY5" fmla="*/ 3781425 h 4024313"/>
              <a:gd name="connsiteX6" fmla="*/ 0 w 9144000"/>
              <a:gd name="connsiteY6" fmla="*/ 3783806 h 4024313"/>
              <a:gd name="connsiteX7" fmla="*/ 0 w 9144000"/>
              <a:gd name="connsiteY7" fmla="*/ 0 h 4024313"/>
              <a:gd name="connsiteX0" fmla="*/ 0 w 9144000"/>
              <a:gd name="connsiteY0" fmla="*/ 0 h 4024313"/>
              <a:gd name="connsiteX1" fmla="*/ 9144000 w 9144000"/>
              <a:gd name="connsiteY1" fmla="*/ 0 h 4024313"/>
              <a:gd name="connsiteX2" fmla="*/ 9144000 w 9144000"/>
              <a:gd name="connsiteY2" fmla="*/ 3783806 h 4024313"/>
              <a:gd name="connsiteX3" fmla="*/ 954881 w 9144000"/>
              <a:gd name="connsiteY3" fmla="*/ 3779044 h 4024313"/>
              <a:gd name="connsiteX4" fmla="*/ 826293 w 9144000"/>
              <a:gd name="connsiteY4" fmla="*/ 4024313 h 4024313"/>
              <a:gd name="connsiteX5" fmla="*/ 692944 w 9144000"/>
              <a:gd name="connsiteY5" fmla="*/ 3781425 h 4024313"/>
              <a:gd name="connsiteX6" fmla="*/ 0 w 9144000"/>
              <a:gd name="connsiteY6" fmla="*/ 3783806 h 4024313"/>
              <a:gd name="connsiteX7" fmla="*/ 0 w 9144000"/>
              <a:gd name="connsiteY7" fmla="*/ 0 h 4024313"/>
              <a:gd name="connsiteX0" fmla="*/ 0 w 9144000"/>
              <a:gd name="connsiteY0" fmla="*/ 0 h 4024313"/>
              <a:gd name="connsiteX1" fmla="*/ 9144000 w 9144000"/>
              <a:gd name="connsiteY1" fmla="*/ 0 h 4024313"/>
              <a:gd name="connsiteX2" fmla="*/ 9144000 w 9144000"/>
              <a:gd name="connsiteY2" fmla="*/ 3783806 h 4024313"/>
              <a:gd name="connsiteX3" fmla="*/ 954881 w 9144000"/>
              <a:gd name="connsiteY3" fmla="*/ 3779044 h 4024313"/>
              <a:gd name="connsiteX4" fmla="*/ 826293 w 9144000"/>
              <a:gd name="connsiteY4" fmla="*/ 4024313 h 4024313"/>
              <a:gd name="connsiteX5" fmla="*/ 692944 w 9144000"/>
              <a:gd name="connsiteY5" fmla="*/ 3781425 h 4024313"/>
              <a:gd name="connsiteX6" fmla="*/ 0 w 9144000"/>
              <a:gd name="connsiteY6" fmla="*/ 3783806 h 4024313"/>
              <a:gd name="connsiteX7" fmla="*/ 0 w 9144000"/>
              <a:gd name="connsiteY7" fmla="*/ 0 h 4024313"/>
              <a:gd name="connsiteX0" fmla="*/ 0 w 9144000"/>
              <a:gd name="connsiteY0" fmla="*/ 0 h 4024344"/>
              <a:gd name="connsiteX1" fmla="*/ 9144000 w 9144000"/>
              <a:gd name="connsiteY1" fmla="*/ 0 h 4024344"/>
              <a:gd name="connsiteX2" fmla="*/ 9144000 w 9144000"/>
              <a:gd name="connsiteY2" fmla="*/ 3783806 h 4024344"/>
              <a:gd name="connsiteX3" fmla="*/ 954881 w 9144000"/>
              <a:gd name="connsiteY3" fmla="*/ 3779044 h 4024344"/>
              <a:gd name="connsiteX4" fmla="*/ 826293 w 9144000"/>
              <a:gd name="connsiteY4" fmla="*/ 4024313 h 4024344"/>
              <a:gd name="connsiteX5" fmla="*/ 692944 w 9144000"/>
              <a:gd name="connsiteY5" fmla="*/ 3781425 h 4024344"/>
              <a:gd name="connsiteX6" fmla="*/ 0 w 9144000"/>
              <a:gd name="connsiteY6" fmla="*/ 3783806 h 4024344"/>
              <a:gd name="connsiteX7" fmla="*/ 0 w 9144000"/>
              <a:gd name="connsiteY7" fmla="*/ 0 h 4024344"/>
              <a:gd name="connsiteX0" fmla="*/ 0 w 9144000"/>
              <a:gd name="connsiteY0" fmla="*/ 0 h 4024665"/>
              <a:gd name="connsiteX1" fmla="*/ 9144000 w 9144000"/>
              <a:gd name="connsiteY1" fmla="*/ 0 h 4024665"/>
              <a:gd name="connsiteX2" fmla="*/ 9144000 w 9144000"/>
              <a:gd name="connsiteY2" fmla="*/ 3783806 h 4024665"/>
              <a:gd name="connsiteX3" fmla="*/ 954881 w 9144000"/>
              <a:gd name="connsiteY3" fmla="*/ 3779044 h 4024665"/>
              <a:gd name="connsiteX4" fmla="*/ 826293 w 9144000"/>
              <a:gd name="connsiteY4" fmla="*/ 4024313 h 4024665"/>
              <a:gd name="connsiteX5" fmla="*/ 692944 w 9144000"/>
              <a:gd name="connsiteY5" fmla="*/ 3781425 h 4024665"/>
              <a:gd name="connsiteX6" fmla="*/ 0 w 9144000"/>
              <a:gd name="connsiteY6" fmla="*/ 3783806 h 4024665"/>
              <a:gd name="connsiteX7" fmla="*/ 0 w 9144000"/>
              <a:gd name="connsiteY7" fmla="*/ 0 h 4024665"/>
              <a:gd name="connsiteX0" fmla="*/ 0 w 9144000"/>
              <a:gd name="connsiteY0" fmla="*/ 0 h 4024519"/>
              <a:gd name="connsiteX1" fmla="*/ 9144000 w 9144000"/>
              <a:gd name="connsiteY1" fmla="*/ 0 h 4024519"/>
              <a:gd name="connsiteX2" fmla="*/ 9144000 w 9144000"/>
              <a:gd name="connsiteY2" fmla="*/ 3783806 h 4024519"/>
              <a:gd name="connsiteX3" fmla="*/ 954881 w 9144000"/>
              <a:gd name="connsiteY3" fmla="*/ 3779044 h 4024519"/>
              <a:gd name="connsiteX4" fmla="*/ 826293 w 9144000"/>
              <a:gd name="connsiteY4" fmla="*/ 4024313 h 4024519"/>
              <a:gd name="connsiteX5" fmla="*/ 692944 w 9144000"/>
              <a:gd name="connsiteY5" fmla="*/ 3781425 h 4024519"/>
              <a:gd name="connsiteX6" fmla="*/ 0 w 9144000"/>
              <a:gd name="connsiteY6" fmla="*/ 3783806 h 4024519"/>
              <a:gd name="connsiteX7" fmla="*/ 0 w 9144000"/>
              <a:gd name="connsiteY7" fmla="*/ 0 h 4024519"/>
              <a:gd name="connsiteX0" fmla="*/ 0 w 9144000"/>
              <a:gd name="connsiteY0" fmla="*/ 0 h 4024313"/>
              <a:gd name="connsiteX1" fmla="*/ 9144000 w 9144000"/>
              <a:gd name="connsiteY1" fmla="*/ 0 h 4024313"/>
              <a:gd name="connsiteX2" fmla="*/ 9144000 w 9144000"/>
              <a:gd name="connsiteY2" fmla="*/ 3783806 h 4024313"/>
              <a:gd name="connsiteX3" fmla="*/ 964406 w 9144000"/>
              <a:gd name="connsiteY3" fmla="*/ 3781426 h 4024313"/>
              <a:gd name="connsiteX4" fmla="*/ 826293 w 9144000"/>
              <a:gd name="connsiteY4" fmla="*/ 4024313 h 4024313"/>
              <a:gd name="connsiteX5" fmla="*/ 692944 w 9144000"/>
              <a:gd name="connsiteY5" fmla="*/ 3781425 h 4024313"/>
              <a:gd name="connsiteX6" fmla="*/ 0 w 9144000"/>
              <a:gd name="connsiteY6" fmla="*/ 3783806 h 4024313"/>
              <a:gd name="connsiteX7" fmla="*/ 0 w 9144000"/>
              <a:gd name="connsiteY7" fmla="*/ 0 h 4024313"/>
              <a:gd name="connsiteX0" fmla="*/ 0 w 9144000"/>
              <a:gd name="connsiteY0" fmla="*/ 0 h 4024313"/>
              <a:gd name="connsiteX1" fmla="*/ 9144000 w 9144000"/>
              <a:gd name="connsiteY1" fmla="*/ 0 h 4024313"/>
              <a:gd name="connsiteX2" fmla="*/ 9144000 w 9144000"/>
              <a:gd name="connsiteY2" fmla="*/ 3783806 h 4024313"/>
              <a:gd name="connsiteX3" fmla="*/ 964406 w 9144000"/>
              <a:gd name="connsiteY3" fmla="*/ 3781426 h 4024313"/>
              <a:gd name="connsiteX4" fmla="*/ 826293 w 9144000"/>
              <a:gd name="connsiteY4" fmla="*/ 4024313 h 4024313"/>
              <a:gd name="connsiteX5" fmla="*/ 692944 w 9144000"/>
              <a:gd name="connsiteY5" fmla="*/ 3781425 h 4024313"/>
              <a:gd name="connsiteX6" fmla="*/ 0 w 9144000"/>
              <a:gd name="connsiteY6" fmla="*/ 3783806 h 4024313"/>
              <a:gd name="connsiteX7" fmla="*/ 0 w 9144000"/>
              <a:gd name="connsiteY7" fmla="*/ 0 h 4024313"/>
              <a:gd name="connsiteX0" fmla="*/ 0 w 9144000"/>
              <a:gd name="connsiteY0" fmla="*/ 0 h 4028131"/>
              <a:gd name="connsiteX1" fmla="*/ 9144000 w 9144000"/>
              <a:gd name="connsiteY1" fmla="*/ 0 h 4028131"/>
              <a:gd name="connsiteX2" fmla="*/ 9144000 w 9144000"/>
              <a:gd name="connsiteY2" fmla="*/ 3783806 h 4028131"/>
              <a:gd name="connsiteX3" fmla="*/ 964406 w 9144000"/>
              <a:gd name="connsiteY3" fmla="*/ 3781426 h 4028131"/>
              <a:gd name="connsiteX4" fmla="*/ 826293 w 9144000"/>
              <a:gd name="connsiteY4" fmla="*/ 4024313 h 4028131"/>
              <a:gd name="connsiteX5" fmla="*/ 692944 w 9144000"/>
              <a:gd name="connsiteY5" fmla="*/ 3781425 h 4028131"/>
              <a:gd name="connsiteX6" fmla="*/ 0 w 9144000"/>
              <a:gd name="connsiteY6" fmla="*/ 3783806 h 4028131"/>
              <a:gd name="connsiteX7" fmla="*/ 0 w 9144000"/>
              <a:gd name="connsiteY7" fmla="*/ 0 h 4028131"/>
              <a:gd name="connsiteX0" fmla="*/ 0 w 9144000"/>
              <a:gd name="connsiteY0" fmla="*/ 0 h 4024412"/>
              <a:gd name="connsiteX1" fmla="*/ 9144000 w 9144000"/>
              <a:gd name="connsiteY1" fmla="*/ 0 h 4024412"/>
              <a:gd name="connsiteX2" fmla="*/ 9144000 w 9144000"/>
              <a:gd name="connsiteY2" fmla="*/ 3783806 h 4024412"/>
              <a:gd name="connsiteX3" fmla="*/ 964406 w 9144000"/>
              <a:gd name="connsiteY3" fmla="*/ 3781426 h 4024412"/>
              <a:gd name="connsiteX4" fmla="*/ 826293 w 9144000"/>
              <a:gd name="connsiteY4" fmla="*/ 4024313 h 4024412"/>
              <a:gd name="connsiteX5" fmla="*/ 692944 w 9144000"/>
              <a:gd name="connsiteY5" fmla="*/ 3781425 h 4024412"/>
              <a:gd name="connsiteX6" fmla="*/ 0 w 9144000"/>
              <a:gd name="connsiteY6" fmla="*/ 3783806 h 4024412"/>
              <a:gd name="connsiteX7" fmla="*/ 0 w 9144000"/>
              <a:gd name="connsiteY7" fmla="*/ 0 h 4024412"/>
              <a:gd name="connsiteX0" fmla="*/ 0 w 9144000"/>
              <a:gd name="connsiteY0" fmla="*/ 0 h 4024313"/>
              <a:gd name="connsiteX1" fmla="*/ 9144000 w 9144000"/>
              <a:gd name="connsiteY1" fmla="*/ 0 h 4024313"/>
              <a:gd name="connsiteX2" fmla="*/ 9144000 w 9144000"/>
              <a:gd name="connsiteY2" fmla="*/ 3783806 h 4024313"/>
              <a:gd name="connsiteX3" fmla="*/ 964406 w 9144000"/>
              <a:gd name="connsiteY3" fmla="*/ 3781426 h 4024313"/>
              <a:gd name="connsiteX4" fmla="*/ 826293 w 9144000"/>
              <a:gd name="connsiteY4" fmla="*/ 4024313 h 4024313"/>
              <a:gd name="connsiteX5" fmla="*/ 692944 w 9144000"/>
              <a:gd name="connsiteY5" fmla="*/ 3781425 h 4024313"/>
              <a:gd name="connsiteX6" fmla="*/ 0 w 9144000"/>
              <a:gd name="connsiteY6" fmla="*/ 3783806 h 4024313"/>
              <a:gd name="connsiteX7" fmla="*/ 0 w 9144000"/>
              <a:gd name="connsiteY7" fmla="*/ 0 h 4024313"/>
              <a:gd name="connsiteX0" fmla="*/ 0 w 9144000"/>
              <a:gd name="connsiteY0" fmla="*/ 0 h 4024313"/>
              <a:gd name="connsiteX1" fmla="*/ 9144000 w 9144000"/>
              <a:gd name="connsiteY1" fmla="*/ 0 h 4024313"/>
              <a:gd name="connsiteX2" fmla="*/ 9144000 w 9144000"/>
              <a:gd name="connsiteY2" fmla="*/ 3783806 h 4024313"/>
              <a:gd name="connsiteX3" fmla="*/ 964406 w 9144000"/>
              <a:gd name="connsiteY3" fmla="*/ 3781426 h 4024313"/>
              <a:gd name="connsiteX4" fmla="*/ 826293 w 9144000"/>
              <a:gd name="connsiteY4" fmla="*/ 4024313 h 4024313"/>
              <a:gd name="connsiteX5" fmla="*/ 692944 w 9144000"/>
              <a:gd name="connsiteY5" fmla="*/ 3781425 h 4024313"/>
              <a:gd name="connsiteX6" fmla="*/ 0 w 9144000"/>
              <a:gd name="connsiteY6" fmla="*/ 3783806 h 4024313"/>
              <a:gd name="connsiteX7" fmla="*/ 0 w 9144000"/>
              <a:gd name="connsiteY7" fmla="*/ 0 h 4024313"/>
              <a:gd name="connsiteX0" fmla="*/ 0 w 9144000"/>
              <a:gd name="connsiteY0" fmla="*/ 0 h 4024313"/>
              <a:gd name="connsiteX1" fmla="*/ 9144000 w 9144000"/>
              <a:gd name="connsiteY1" fmla="*/ 0 h 4024313"/>
              <a:gd name="connsiteX2" fmla="*/ 9144000 w 9144000"/>
              <a:gd name="connsiteY2" fmla="*/ 3783806 h 4024313"/>
              <a:gd name="connsiteX3" fmla="*/ 964406 w 9144000"/>
              <a:gd name="connsiteY3" fmla="*/ 3781426 h 4024313"/>
              <a:gd name="connsiteX4" fmla="*/ 826293 w 9144000"/>
              <a:gd name="connsiteY4" fmla="*/ 4024313 h 4024313"/>
              <a:gd name="connsiteX5" fmla="*/ 692944 w 9144000"/>
              <a:gd name="connsiteY5" fmla="*/ 3781425 h 4024313"/>
              <a:gd name="connsiteX6" fmla="*/ 0 w 9144000"/>
              <a:gd name="connsiteY6" fmla="*/ 3783806 h 4024313"/>
              <a:gd name="connsiteX7" fmla="*/ 0 w 9144000"/>
              <a:gd name="connsiteY7" fmla="*/ 0 h 4024313"/>
              <a:gd name="connsiteX0" fmla="*/ 0 w 9144000"/>
              <a:gd name="connsiteY0" fmla="*/ 0 h 4024313"/>
              <a:gd name="connsiteX1" fmla="*/ 9144000 w 9144000"/>
              <a:gd name="connsiteY1" fmla="*/ 0 h 4024313"/>
              <a:gd name="connsiteX2" fmla="*/ 9144000 w 9144000"/>
              <a:gd name="connsiteY2" fmla="*/ 3783806 h 4024313"/>
              <a:gd name="connsiteX3" fmla="*/ 964406 w 9144000"/>
              <a:gd name="connsiteY3" fmla="*/ 3781426 h 4024313"/>
              <a:gd name="connsiteX4" fmla="*/ 826293 w 9144000"/>
              <a:gd name="connsiteY4" fmla="*/ 4024313 h 4024313"/>
              <a:gd name="connsiteX5" fmla="*/ 692944 w 9144000"/>
              <a:gd name="connsiteY5" fmla="*/ 3781425 h 4024313"/>
              <a:gd name="connsiteX6" fmla="*/ 0 w 9144000"/>
              <a:gd name="connsiteY6" fmla="*/ 3783806 h 4024313"/>
              <a:gd name="connsiteX7" fmla="*/ 0 w 9144000"/>
              <a:gd name="connsiteY7" fmla="*/ 0 h 4024313"/>
              <a:gd name="connsiteX0" fmla="*/ 0 w 9144000"/>
              <a:gd name="connsiteY0" fmla="*/ 0 h 4024313"/>
              <a:gd name="connsiteX1" fmla="*/ 9144000 w 9144000"/>
              <a:gd name="connsiteY1" fmla="*/ 0 h 4024313"/>
              <a:gd name="connsiteX2" fmla="*/ 9144000 w 9144000"/>
              <a:gd name="connsiteY2" fmla="*/ 3783806 h 4024313"/>
              <a:gd name="connsiteX3" fmla="*/ 964406 w 9144000"/>
              <a:gd name="connsiteY3" fmla="*/ 3781426 h 4024313"/>
              <a:gd name="connsiteX4" fmla="*/ 826293 w 9144000"/>
              <a:gd name="connsiteY4" fmla="*/ 4024313 h 4024313"/>
              <a:gd name="connsiteX5" fmla="*/ 666750 w 9144000"/>
              <a:gd name="connsiteY5" fmla="*/ 3781425 h 4024313"/>
              <a:gd name="connsiteX6" fmla="*/ 0 w 9144000"/>
              <a:gd name="connsiteY6" fmla="*/ 3783806 h 4024313"/>
              <a:gd name="connsiteX7" fmla="*/ 0 w 9144000"/>
              <a:gd name="connsiteY7" fmla="*/ 0 h 4024313"/>
              <a:gd name="connsiteX0" fmla="*/ 0 w 9144000"/>
              <a:gd name="connsiteY0" fmla="*/ 0 h 4024316"/>
              <a:gd name="connsiteX1" fmla="*/ 9144000 w 9144000"/>
              <a:gd name="connsiteY1" fmla="*/ 0 h 4024316"/>
              <a:gd name="connsiteX2" fmla="*/ 9144000 w 9144000"/>
              <a:gd name="connsiteY2" fmla="*/ 3783806 h 4024316"/>
              <a:gd name="connsiteX3" fmla="*/ 945356 w 9144000"/>
              <a:gd name="connsiteY3" fmla="*/ 3786189 h 4024316"/>
              <a:gd name="connsiteX4" fmla="*/ 826293 w 9144000"/>
              <a:gd name="connsiteY4" fmla="*/ 4024313 h 4024316"/>
              <a:gd name="connsiteX5" fmla="*/ 666750 w 9144000"/>
              <a:gd name="connsiteY5" fmla="*/ 3781425 h 4024316"/>
              <a:gd name="connsiteX6" fmla="*/ 0 w 9144000"/>
              <a:gd name="connsiteY6" fmla="*/ 3783806 h 4024316"/>
              <a:gd name="connsiteX7" fmla="*/ 0 w 9144000"/>
              <a:gd name="connsiteY7" fmla="*/ 0 h 4024316"/>
              <a:gd name="connsiteX0" fmla="*/ 0 w 9144000"/>
              <a:gd name="connsiteY0" fmla="*/ 0 h 4029078"/>
              <a:gd name="connsiteX1" fmla="*/ 9144000 w 9144000"/>
              <a:gd name="connsiteY1" fmla="*/ 0 h 4029078"/>
              <a:gd name="connsiteX2" fmla="*/ 9144000 w 9144000"/>
              <a:gd name="connsiteY2" fmla="*/ 3783806 h 4029078"/>
              <a:gd name="connsiteX3" fmla="*/ 945356 w 9144000"/>
              <a:gd name="connsiteY3" fmla="*/ 3786189 h 4029078"/>
              <a:gd name="connsiteX4" fmla="*/ 809624 w 9144000"/>
              <a:gd name="connsiteY4" fmla="*/ 4029075 h 4029078"/>
              <a:gd name="connsiteX5" fmla="*/ 666750 w 9144000"/>
              <a:gd name="connsiteY5" fmla="*/ 3781425 h 4029078"/>
              <a:gd name="connsiteX6" fmla="*/ 0 w 9144000"/>
              <a:gd name="connsiteY6" fmla="*/ 3783806 h 4029078"/>
              <a:gd name="connsiteX7" fmla="*/ 0 w 9144000"/>
              <a:gd name="connsiteY7" fmla="*/ 0 h 4029078"/>
              <a:gd name="connsiteX0" fmla="*/ 0 w 9144000"/>
              <a:gd name="connsiteY0" fmla="*/ 0 h 4029106"/>
              <a:gd name="connsiteX1" fmla="*/ 9144000 w 9144000"/>
              <a:gd name="connsiteY1" fmla="*/ 0 h 4029106"/>
              <a:gd name="connsiteX2" fmla="*/ 9144000 w 9144000"/>
              <a:gd name="connsiteY2" fmla="*/ 3783806 h 4029106"/>
              <a:gd name="connsiteX3" fmla="*/ 945356 w 9144000"/>
              <a:gd name="connsiteY3" fmla="*/ 3786189 h 4029106"/>
              <a:gd name="connsiteX4" fmla="*/ 809624 w 9144000"/>
              <a:gd name="connsiteY4" fmla="*/ 4029075 h 4029106"/>
              <a:gd name="connsiteX5" fmla="*/ 666750 w 9144000"/>
              <a:gd name="connsiteY5" fmla="*/ 3781425 h 4029106"/>
              <a:gd name="connsiteX6" fmla="*/ 0 w 9144000"/>
              <a:gd name="connsiteY6" fmla="*/ 3783806 h 4029106"/>
              <a:gd name="connsiteX7" fmla="*/ 0 w 9144000"/>
              <a:gd name="connsiteY7" fmla="*/ 0 h 4029106"/>
              <a:gd name="connsiteX0" fmla="*/ 0 w 9144000"/>
              <a:gd name="connsiteY0" fmla="*/ 0 h 4029106"/>
              <a:gd name="connsiteX1" fmla="*/ 9144000 w 9144000"/>
              <a:gd name="connsiteY1" fmla="*/ 0 h 4029106"/>
              <a:gd name="connsiteX2" fmla="*/ 9144000 w 9144000"/>
              <a:gd name="connsiteY2" fmla="*/ 3783806 h 4029106"/>
              <a:gd name="connsiteX3" fmla="*/ 945356 w 9144000"/>
              <a:gd name="connsiteY3" fmla="*/ 3786189 h 4029106"/>
              <a:gd name="connsiteX4" fmla="*/ 809624 w 9144000"/>
              <a:gd name="connsiteY4" fmla="*/ 4029075 h 4029106"/>
              <a:gd name="connsiteX5" fmla="*/ 666750 w 9144000"/>
              <a:gd name="connsiteY5" fmla="*/ 3781425 h 4029106"/>
              <a:gd name="connsiteX6" fmla="*/ 0 w 9144000"/>
              <a:gd name="connsiteY6" fmla="*/ 3783806 h 4029106"/>
              <a:gd name="connsiteX7" fmla="*/ 0 w 9144000"/>
              <a:gd name="connsiteY7" fmla="*/ 0 h 4029106"/>
              <a:gd name="connsiteX0" fmla="*/ 0 w 9144000"/>
              <a:gd name="connsiteY0" fmla="*/ 0 h 4039816"/>
              <a:gd name="connsiteX1" fmla="*/ 9144000 w 9144000"/>
              <a:gd name="connsiteY1" fmla="*/ 0 h 4039816"/>
              <a:gd name="connsiteX2" fmla="*/ 9144000 w 9144000"/>
              <a:gd name="connsiteY2" fmla="*/ 3783806 h 4039816"/>
              <a:gd name="connsiteX3" fmla="*/ 945356 w 9144000"/>
              <a:gd name="connsiteY3" fmla="*/ 3786189 h 4039816"/>
              <a:gd name="connsiteX4" fmla="*/ 854869 w 9144000"/>
              <a:gd name="connsiteY4" fmla="*/ 3974305 h 4039816"/>
              <a:gd name="connsiteX5" fmla="*/ 809624 w 9144000"/>
              <a:gd name="connsiteY5" fmla="*/ 4029075 h 4039816"/>
              <a:gd name="connsiteX6" fmla="*/ 666750 w 9144000"/>
              <a:gd name="connsiteY6" fmla="*/ 3781425 h 4039816"/>
              <a:gd name="connsiteX7" fmla="*/ 0 w 9144000"/>
              <a:gd name="connsiteY7" fmla="*/ 3783806 h 4039816"/>
              <a:gd name="connsiteX8" fmla="*/ 0 w 9144000"/>
              <a:gd name="connsiteY8" fmla="*/ 0 h 4039816"/>
              <a:gd name="connsiteX0" fmla="*/ 0 w 9144000"/>
              <a:gd name="connsiteY0" fmla="*/ 0 h 4029309"/>
              <a:gd name="connsiteX1" fmla="*/ 9144000 w 9144000"/>
              <a:gd name="connsiteY1" fmla="*/ 0 h 4029309"/>
              <a:gd name="connsiteX2" fmla="*/ 9144000 w 9144000"/>
              <a:gd name="connsiteY2" fmla="*/ 3783806 h 4029309"/>
              <a:gd name="connsiteX3" fmla="*/ 945356 w 9144000"/>
              <a:gd name="connsiteY3" fmla="*/ 3786189 h 4029309"/>
              <a:gd name="connsiteX4" fmla="*/ 854869 w 9144000"/>
              <a:gd name="connsiteY4" fmla="*/ 3974305 h 4029309"/>
              <a:gd name="connsiteX5" fmla="*/ 809624 w 9144000"/>
              <a:gd name="connsiteY5" fmla="*/ 4029075 h 4029309"/>
              <a:gd name="connsiteX6" fmla="*/ 766763 w 9144000"/>
              <a:gd name="connsiteY6" fmla="*/ 3983830 h 4029309"/>
              <a:gd name="connsiteX7" fmla="*/ 666750 w 9144000"/>
              <a:gd name="connsiteY7" fmla="*/ 3781425 h 4029309"/>
              <a:gd name="connsiteX8" fmla="*/ 0 w 9144000"/>
              <a:gd name="connsiteY8" fmla="*/ 3783806 h 4029309"/>
              <a:gd name="connsiteX9" fmla="*/ 0 w 9144000"/>
              <a:gd name="connsiteY9" fmla="*/ 0 h 4029309"/>
              <a:gd name="connsiteX0" fmla="*/ 0 w 9144000"/>
              <a:gd name="connsiteY0" fmla="*/ 0 h 4029309"/>
              <a:gd name="connsiteX1" fmla="*/ 9144000 w 9144000"/>
              <a:gd name="connsiteY1" fmla="*/ 0 h 4029309"/>
              <a:gd name="connsiteX2" fmla="*/ 9144000 w 9144000"/>
              <a:gd name="connsiteY2" fmla="*/ 3783806 h 4029309"/>
              <a:gd name="connsiteX3" fmla="*/ 945356 w 9144000"/>
              <a:gd name="connsiteY3" fmla="*/ 3786189 h 4029309"/>
              <a:gd name="connsiteX4" fmla="*/ 854869 w 9144000"/>
              <a:gd name="connsiteY4" fmla="*/ 3974305 h 4029309"/>
              <a:gd name="connsiteX5" fmla="*/ 809624 w 9144000"/>
              <a:gd name="connsiteY5" fmla="*/ 4029075 h 4029309"/>
              <a:gd name="connsiteX6" fmla="*/ 766763 w 9144000"/>
              <a:gd name="connsiteY6" fmla="*/ 3983830 h 4029309"/>
              <a:gd name="connsiteX7" fmla="*/ 666750 w 9144000"/>
              <a:gd name="connsiteY7" fmla="*/ 3781425 h 4029309"/>
              <a:gd name="connsiteX8" fmla="*/ 0 w 9144000"/>
              <a:gd name="connsiteY8" fmla="*/ 3783806 h 4029309"/>
              <a:gd name="connsiteX9" fmla="*/ 0 w 9144000"/>
              <a:gd name="connsiteY9" fmla="*/ 0 h 4029309"/>
              <a:gd name="connsiteX0" fmla="*/ 0 w 9144000"/>
              <a:gd name="connsiteY0" fmla="*/ 0 h 4029309"/>
              <a:gd name="connsiteX1" fmla="*/ 9144000 w 9144000"/>
              <a:gd name="connsiteY1" fmla="*/ 0 h 4029309"/>
              <a:gd name="connsiteX2" fmla="*/ 9144000 w 9144000"/>
              <a:gd name="connsiteY2" fmla="*/ 3783806 h 4029309"/>
              <a:gd name="connsiteX3" fmla="*/ 945356 w 9144000"/>
              <a:gd name="connsiteY3" fmla="*/ 3786189 h 4029309"/>
              <a:gd name="connsiteX4" fmla="*/ 850106 w 9144000"/>
              <a:gd name="connsiteY4" fmla="*/ 3974305 h 4029309"/>
              <a:gd name="connsiteX5" fmla="*/ 809624 w 9144000"/>
              <a:gd name="connsiteY5" fmla="*/ 4029075 h 4029309"/>
              <a:gd name="connsiteX6" fmla="*/ 766763 w 9144000"/>
              <a:gd name="connsiteY6" fmla="*/ 3983830 h 4029309"/>
              <a:gd name="connsiteX7" fmla="*/ 666750 w 9144000"/>
              <a:gd name="connsiteY7" fmla="*/ 3781425 h 4029309"/>
              <a:gd name="connsiteX8" fmla="*/ 0 w 9144000"/>
              <a:gd name="connsiteY8" fmla="*/ 3783806 h 4029309"/>
              <a:gd name="connsiteX9" fmla="*/ 0 w 9144000"/>
              <a:gd name="connsiteY9" fmla="*/ 0 h 4029309"/>
              <a:gd name="connsiteX0" fmla="*/ 0 w 9144000"/>
              <a:gd name="connsiteY0" fmla="*/ 0 h 4029309"/>
              <a:gd name="connsiteX1" fmla="*/ 9144000 w 9144000"/>
              <a:gd name="connsiteY1" fmla="*/ 0 h 4029309"/>
              <a:gd name="connsiteX2" fmla="*/ 9144000 w 9144000"/>
              <a:gd name="connsiteY2" fmla="*/ 3783806 h 4029309"/>
              <a:gd name="connsiteX3" fmla="*/ 945356 w 9144000"/>
              <a:gd name="connsiteY3" fmla="*/ 3786189 h 4029309"/>
              <a:gd name="connsiteX4" fmla="*/ 850106 w 9144000"/>
              <a:gd name="connsiteY4" fmla="*/ 3974305 h 4029309"/>
              <a:gd name="connsiteX5" fmla="*/ 809624 w 9144000"/>
              <a:gd name="connsiteY5" fmla="*/ 4029075 h 4029309"/>
              <a:gd name="connsiteX6" fmla="*/ 766763 w 9144000"/>
              <a:gd name="connsiteY6" fmla="*/ 3983830 h 4029309"/>
              <a:gd name="connsiteX7" fmla="*/ 666750 w 9144000"/>
              <a:gd name="connsiteY7" fmla="*/ 3781425 h 4029309"/>
              <a:gd name="connsiteX8" fmla="*/ 0 w 9144000"/>
              <a:gd name="connsiteY8" fmla="*/ 3783806 h 4029309"/>
              <a:gd name="connsiteX9" fmla="*/ 0 w 9144000"/>
              <a:gd name="connsiteY9" fmla="*/ 0 h 4029309"/>
              <a:gd name="connsiteX0" fmla="*/ 0 w 9144000"/>
              <a:gd name="connsiteY0" fmla="*/ 0 h 4029309"/>
              <a:gd name="connsiteX1" fmla="*/ 9144000 w 9144000"/>
              <a:gd name="connsiteY1" fmla="*/ 0 h 4029309"/>
              <a:gd name="connsiteX2" fmla="*/ 9144000 w 9144000"/>
              <a:gd name="connsiteY2" fmla="*/ 3783806 h 4029309"/>
              <a:gd name="connsiteX3" fmla="*/ 945356 w 9144000"/>
              <a:gd name="connsiteY3" fmla="*/ 3786189 h 4029309"/>
              <a:gd name="connsiteX4" fmla="*/ 850106 w 9144000"/>
              <a:gd name="connsiteY4" fmla="*/ 3974305 h 4029309"/>
              <a:gd name="connsiteX5" fmla="*/ 809624 w 9144000"/>
              <a:gd name="connsiteY5" fmla="*/ 4029075 h 4029309"/>
              <a:gd name="connsiteX6" fmla="*/ 766763 w 9144000"/>
              <a:gd name="connsiteY6" fmla="*/ 3983830 h 4029309"/>
              <a:gd name="connsiteX7" fmla="*/ 666750 w 9144000"/>
              <a:gd name="connsiteY7" fmla="*/ 3781425 h 4029309"/>
              <a:gd name="connsiteX8" fmla="*/ 0 w 9144000"/>
              <a:gd name="connsiteY8" fmla="*/ 3783806 h 4029309"/>
              <a:gd name="connsiteX9" fmla="*/ 0 w 9144000"/>
              <a:gd name="connsiteY9" fmla="*/ 0 h 4029309"/>
              <a:gd name="connsiteX0" fmla="*/ 0 w 9144000"/>
              <a:gd name="connsiteY0" fmla="*/ 0 h 4029309"/>
              <a:gd name="connsiteX1" fmla="*/ 9144000 w 9144000"/>
              <a:gd name="connsiteY1" fmla="*/ 0 h 4029309"/>
              <a:gd name="connsiteX2" fmla="*/ 9144000 w 9144000"/>
              <a:gd name="connsiteY2" fmla="*/ 3783806 h 4029309"/>
              <a:gd name="connsiteX3" fmla="*/ 945356 w 9144000"/>
              <a:gd name="connsiteY3" fmla="*/ 3786189 h 4029309"/>
              <a:gd name="connsiteX4" fmla="*/ 850106 w 9144000"/>
              <a:gd name="connsiteY4" fmla="*/ 3974305 h 4029309"/>
              <a:gd name="connsiteX5" fmla="*/ 809624 w 9144000"/>
              <a:gd name="connsiteY5" fmla="*/ 4029075 h 4029309"/>
              <a:gd name="connsiteX6" fmla="*/ 766763 w 9144000"/>
              <a:gd name="connsiteY6" fmla="*/ 3983830 h 4029309"/>
              <a:gd name="connsiteX7" fmla="*/ 666750 w 9144000"/>
              <a:gd name="connsiteY7" fmla="*/ 3781425 h 4029309"/>
              <a:gd name="connsiteX8" fmla="*/ 0 w 9144000"/>
              <a:gd name="connsiteY8" fmla="*/ 3783806 h 4029309"/>
              <a:gd name="connsiteX9" fmla="*/ 0 w 9144000"/>
              <a:gd name="connsiteY9" fmla="*/ 0 h 4029309"/>
              <a:gd name="connsiteX0" fmla="*/ 0 w 9144000"/>
              <a:gd name="connsiteY0" fmla="*/ 0 h 4088634"/>
              <a:gd name="connsiteX1" fmla="*/ 9144000 w 9144000"/>
              <a:gd name="connsiteY1" fmla="*/ 0 h 4088634"/>
              <a:gd name="connsiteX2" fmla="*/ 9144000 w 9144000"/>
              <a:gd name="connsiteY2" fmla="*/ 3783806 h 4088634"/>
              <a:gd name="connsiteX3" fmla="*/ 945356 w 9144000"/>
              <a:gd name="connsiteY3" fmla="*/ 3786189 h 4088634"/>
              <a:gd name="connsiteX4" fmla="*/ 850106 w 9144000"/>
              <a:gd name="connsiteY4" fmla="*/ 3974305 h 4088634"/>
              <a:gd name="connsiteX5" fmla="*/ 809624 w 9144000"/>
              <a:gd name="connsiteY5" fmla="*/ 4088606 h 4088634"/>
              <a:gd name="connsiteX6" fmla="*/ 766763 w 9144000"/>
              <a:gd name="connsiteY6" fmla="*/ 3983830 h 4088634"/>
              <a:gd name="connsiteX7" fmla="*/ 666750 w 9144000"/>
              <a:gd name="connsiteY7" fmla="*/ 3781425 h 4088634"/>
              <a:gd name="connsiteX8" fmla="*/ 0 w 9144000"/>
              <a:gd name="connsiteY8" fmla="*/ 3783806 h 4088634"/>
              <a:gd name="connsiteX9" fmla="*/ 0 w 9144000"/>
              <a:gd name="connsiteY9" fmla="*/ 0 h 4088634"/>
              <a:gd name="connsiteX0" fmla="*/ 0 w 9144000"/>
              <a:gd name="connsiteY0" fmla="*/ 0 h 4098155"/>
              <a:gd name="connsiteX1" fmla="*/ 9144000 w 9144000"/>
              <a:gd name="connsiteY1" fmla="*/ 0 h 4098155"/>
              <a:gd name="connsiteX2" fmla="*/ 9144000 w 9144000"/>
              <a:gd name="connsiteY2" fmla="*/ 3783806 h 4098155"/>
              <a:gd name="connsiteX3" fmla="*/ 945356 w 9144000"/>
              <a:gd name="connsiteY3" fmla="*/ 3786189 h 4098155"/>
              <a:gd name="connsiteX4" fmla="*/ 850106 w 9144000"/>
              <a:gd name="connsiteY4" fmla="*/ 3974305 h 4098155"/>
              <a:gd name="connsiteX5" fmla="*/ 814386 w 9144000"/>
              <a:gd name="connsiteY5" fmla="*/ 4098131 h 4098155"/>
              <a:gd name="connsiteX6" fmla="*/ 766763 w 9144000"/>
              <a:gd name="connsiteY6" fmla="*/ 3983830 h 4098155"/>
              <a:gd name="connsiteX7" fmla="*/ 666750 w 9144000"/>
              <a:gd name="connsiteY7" fmla="*/ 3781425 h 4098155"/>
              <a:gd name="connsiteX8" fmla="*/ 0 w 9144000"/>
              <a:gd name="connsiteY8" fmla="*/ 3783806 h 4098155"/>
              <a:gd name="connsiteX9" fmla="*/ 0 w 9144000"/>
              <a:gd name="connsiteY9" fmla="*/ 0 h 4098155"/>
              <a:gd name="connsiteX0" fmla="*/ 0 w 9144000"/>
              <a:gd name="connsiteY0" fmla="*/ 0 h 4098155"/>
              <a:gd name="connsiteX1" fmla="*/ 9144000 w 9144000"/>
              <a:gd name="connsiteY1" fmla="*/ 0 h 4098155"/>
              <a:gd name="connsiteX2" fmla="*/ 9144000 w 9144000"/>
              <a:gd name="connsiteY2" fmla="*/ 3783806 h 4098155"/>
              <a:gd name="connsiteX3" fmla="*/ 945356 w 9144000"/>
              <a:gd name="connsiteY3" fmla="*/ 3786189 h 4098155"/>
              <a:gd name="connsiteX4" fmla="*/ 850106 w 9144000"/>
              <a:gd name="connsiteY4" fmla="*/ 3974305 h 4098155"/>
              <a:gd name="connsiteX5" fmla="*/ 802480 w 9144000"/>
              <a:gd name="connsiteY5" fmla="*/ 4098131 h 4098155"/>
              <a:gd name="connsiteX6" fmla="*/ 766763 w 9144000"/>
              <a:gd name="connsiteY6" fmla="*/ 3983830 h 4098155"/>
              <a:gd name="connsiteX7" fmla="*/ 666750 w 9144000"/>
              <a:gd name="connsiteY7" fmla="*/ 3781425 h 4098155"/>
              <a:gd name="connsiteX8" fmla="*/ 0 w 9144000"/>
              <a:gd name="connsiteY8" fmla="*/ 3783806 h 4098155"/>
              <a:gd name="connsiteX9" fmla="*/ 0 w 9144000"/>
              <a:gd name="connsiteY9" fmla="*/ 0 h 4098155"/>
              <a:gd name="connsiteX0" fmla="*/ 0 w 9144000"/>
              <a:gd name="connsiteY0" fmla="*/ 0 h 4099570"/>
              <a:gd name="connsiteX1" fmla="*/ 9144000 w 9144000"/>
              <a:gd name="connsiteY1" fmla="*/ 0 h 4099570"/>
              <a:gd name="connsiteX2" fmla="*/ 9144000 w 9144000"/>
              <a:gd name="connsiteY2" fmla="*/ 3783806 h 4099570"/>
              <a:gd name="connsiteX3" fmla="*/ 945356 w 9144000"/>
              <a:gd name="connsiteY3" fmla="*/ 3786189 h 4099570"/>
              <a:gd name="connsiteX4" fmla="*/ 850106 w 9144000"/>
              <a:gd name="connsiteY4" fmla="*/ 3974305 h 4099570"/>
              <a:gd name="connsiteX5" fmla="*/ 802480 w 9144000"/>
              <a:gd name="connsiteY5" fmla="*/ 4098131 h 4099570"/>
              <a:gd name="connsiteX6" fmla="*/ 766763 w 9144000"/>
              <a:gd name="connsiteY6" fmla="*/ 3983830 h 4099570"/>
              <a:gd name="connsiteX7" fmla="*/ 666750 w 9144000"/>
              <a:gd name="connsiteY7" fmla="*/ 3781425 h 4099570"/>
              <a:gd name="connsiteX8" fmla="*/ 0 w 9144000"/>
              <a:gd name="connsiteY8" fmla="*/ 3783806 h 4099570"/>
              <a:gd name="connsiteX9" fmla="*/ 0 w 9144000"/>
              <a:gd name="connsiteY9" fmla="*/ 0 h 4099570"/>
              <a:gd name="connsiteX0" fmla="*/ 0 w 9144000"/>
              <a:gd name="connsiteY0" fmla="*/ 0 h 4098135"/>
              <a:gd name="connsiteX1" fmla="*/ 9144000 w 9144000"/>
              <a:gd name="connsiteY1" fmla="*/ 0 h 4098135"/>
              <a:gd name="connsiteX2" fmla="*/ 9144000 w 9144000"/>
              <a:gd name="connsiteY2" fmla="*/ 3783806 h 4098135"/>
              <a:gd name="connsiteX3" fmla="*/ 945356 w 9144000"/>
              <a:gd name="connsiteY3" fmla="*/ 3786189 h 4098135"/>
              <a:gd name="connsiteX4" fmla="*/ 850106 w 9144000"/>
              <a:gd name="connsiteY4" fmla="*/ 3974305 h 4098135"/>
              <a:gd name="connsiteX5" fmla="*/ 802480 w 9144000"/>
              <a:gd name="connsiteY5" fmla="*/ 4098131 h 4098135"/>
              <a:gd name="connsiteX6" fmla="*/ 766763 w 9144000"/>
              <a:gd name="connsiteY6" fmla="*/ 3983830 h 4098135"/>
              <a:gd name="connsiteX7" fmla="*/ 666750 w 9144000"/>
              <a:gd name="connsiteY7" fmla="*/ 3781425 h 4098135"/>
              <a:gd name="connsiteX8" fmla="*/ 0 w 9144000"/>
              <a:gd name="connsiteY8" fmla="*/ 3783806 h 4098135"/>
              <a:gd name="connsiteX9" fmla="*/ 0 w 9144000"/>
              <a:gd name="connsiteY9" fmla="*/ 0 h 4098135"/>
              <a:gd name="connsiteX0" fmla="*/ 0 w 9144000"/>
              <a:gd name="connsiteY0" fmla="*/ 0 h 4100517"/>
              <a:gd name="connsiteX1" fmla="*/ 9144000 w 9144000"/>
              <a:gd name="connsiteY1" fmla="*/ 0 h 4100517"/>
              <a:gd name="connsiteX2" fmla="*/ 9144000 w 9144000"/>
              <a:gd name="connsiteY2" fmla="*/ 3783806 h 4100517"/>
              <a:gd name="connsiteX3" fmla="*/ 945356 w 9144000"/>
              <a:gd name="connsiteY3" fmla="*/ 3786189 h 4100517"/>
              <a:gd name="connsiteX4" fmla="*/ 850106 w 9144000"/>
              <a:gd name="connsiteY4" fmla="*/ 3974305 h 4100517"/>
              <a:gd name="connsiteX5" fmla="*/ 816767 w 9144000"/>
              <a:gd name="connsiteY5" fmla="*/ 4100513 h 4100517"/>
              <a:gd name="connsiteX6" fmla="*/ 766763 w 9144000"/>
              <a:gd name="connsiteY6" fmla="*/ 3983830 h 4100517"/>
              <a:gd name="connsiteX7" fmla="*/ 666750 w 9144000"/>
              <a:gd name="connsiteY7" fmla="*/ 3781425 h 4100517"/>
              <a:gd name="connsiteX8" fmla="*/ 0 w 9144000"/>
              <a:gd name="connsiteY8" fmla="*/ 3783806 h 4100517"/>
              <a:gd name="connsiteX9" fmla="*/ 0 w 9144000"/>
              <a:gd name="connsiteY9" fmla="*/ 0 h 4100517"/>
              <a:gd name="connsiteX0" fmla="*/ 0 w 9144000"/>
              <a:gd name="connsiteY0" fmla="*/ 0 h 4021977"/>
              <a:gd name="connsiteX1" fmla="*/ 9144000 w 9144000"/>
              <a:gd name="connsiteY1" fmla="*/ 0 h 4021977"/>
              <a:gd name="connsiteX2" fmla="*/ 9144000 w 9144000"/>
              <a:gd name="connsiteY2" fmla="*/ 3783806 h 4021977"/>
              <a:gd name="connsiteX3" fmla="*/ 945356 w 9144000"/>
              <a:gd name="connsiteY3" fmla="*/ 3786189 h 4021977"/>
              <a:gd name="connsiteX4" fmla="*/ 850106 w 9144000"/>
              <a:gd name="connsiteY4" fmla="*/ 3974305 h 4021977"/>
              <a:gd name="connsiteX5" fmla="*/ 807242 w 9144000"/>
              <a:gd name="connsiteY5" fmla="*/ 4021931 h 4021977"/>
              <a:gd name="connsiteX6" fmla="*/ 766763 w 9144000"/>
              <a:gd name="connsiteY6" fmla="*/ 3983830 h 4021977"/>
              <a:gd name="connsiteX7" fmla="*/ 666750 w 9144000"/>
              <a:gd name="connsiteY7" fmla="*/ 3781425 h 4021977"/>
              <a:gd name="connsiteX8" fmla="*/ 0 w 9144000"/>
              <a:gd name="connsiteY8" fmla="*/ 3783806 h 4021977"/>
              <a:gd name="connsiteX9" fmla="*/ 0 w 9144000"/>
              <a:gd name="connsiteY9" fmla="*/ 0 h 4021977"/>
              <a:gd name="connsiteX0" fmla="*/ 0 w 9144000"/>
              <a:gd name="connsiteY0" fmla="*/ 0 h 4022430"/>
              <a:gd name="connsiteX1" fmla="*/ 9144000 w 9144000"/>
              <a:gd name="connsiteY1" fmla="*/ 0 h 4022430"/>
              <a:gd name="connsiteX2" fmla="*/ 9144000 w 9144000"/>
              <a:gd name="connsiteY2" fmla="*/ 3783806 h 4022430"/>
              <a:gd name="connsiteX3" fmla="*/ 945356 w 9144000"/>
              <a:gd name="connsiteY3" fmla="*/ 3786189 h 4022430"/>
              <a:gd name="connsiteX4" fmla="*/ 850106 w 9144000"/>
              <a:gd name="connsiteY4" fmla="*/ 3974305 h 4022430"/>
              <a:gd name="connsiteX5" fmla="*/ 807242 w 9144000"/>
              <a:gd name="connsiteY5" fmla="*/ 4021931 h 4022430"/>
              <a:gd name="connsiteX6" fmla="*/ 766763 w 9144000"/>
              <a:gd name="connsiteY6" fmla="*/ 3983830 h 4022430"/>
              <a:gd name="connsiteX7" fmla="*/ 666750 w 9144000"/>
              <a:gd name="connsiteY7" fmla="*/ 3781425 h 4022430"/>
              <a:gd name="connsiteX8" fmla="*/ 0 w 9144000"/>
              <a:gd name="connsiteY8" fmla="*/ 3783806 h 4022430"/>
              <a:gd name="connsiteX9" fmla="*/ 0 w 9144000"/>
              <a:gd name="connsiteY9" fmla="*/ 0 h 4022430"/>
              <a:gd name="connsiteX0" fmla="*/ 0 w 9144000"/>
              <a:gd name="connsiteY0" fmla="*/ 0 h 4022430"/>
              <a:gd name="connsiteX1" fmla="*/ 9144000 w 9144000"/>
              <a:gd name="connsiteY1" fmla="*/ 0 h 4022430"/>
              <a:gd name="connsiteX2" fmla="*/ 9144000 w 9144000"/>
              <a:gd name="connsiteY2" fmla="*/ 3783806 h 4022430"/>
              <a:gd name="connsiteX3" fmla="*/ 945356 w 9144000"/>
              <a:gd name="connsiteY3" fmla="*/ 3786189 h 4022430"/>
              <a:gd name="connsiteX4" fmla="*/ 850106 w 9144000"/>
              <a:gd name="connsiteY4" fmla="*/ 3974305 h 4022430"/>
              <a:gd name="connsiteX5" fmla="*/ 807242 w 9144000"/>
              <a:gd name="connsiteY5" fmla="*/ 4021931 h 4022430"/>
              <a:gd name="connsiteX6" fmla="*/ 766763 w 9144000"/>
              <a:gd name="connsiteY6" fmla="*/ 3983830 h 4022430"/>
              <a:gd name="connsiteX7" fmla="*/ 666750 w 9144000"/>
              <a:gd name="connsiteY7" fmla="*/ 3781425 h 4022430"/>
              <a:gd name="connsiteX8" fmla="*/ 0 w 9144000"/>
              <a:gd name="connsiteY8" fmla="*/ 3783806 h 4022430"/>
              <a:gd name="connsiteX9" fmla="*/ 0 w 9144000"/>
              <a:gd name="connsiteY9" fmla="*/ 0 h 4022430"/>
              <a:gd name="connsiteX0" fmla="*/ 0 w 9144000"/>
              <a:gd name="connsiteY0" fmla="*/ 0 h 4024744"/>
              <a:gd name="connsiteX1" fmla="*/ 9144000 w 9144000"/>
              <a:gd name="connsiteY1" fmla="*/ 0 h 4024744"/>
              <a:gd name="connsiteX2" fmla="*/ 9144000 w 9144000"/>
              <a:gd name="connsiteY2" fmla="*/ 3783806 h 4024744"/>
              <a:gd name="connsiteX3" fmla="*/ 945356 w 9144000"/>
              <a:gd name="connsiteY3" fmla="*/ 3786189 h 4024744"/>
              <a:gd name="connsiteX4" fmla="*/ 850106 w 9144000"/>
              <a:gd name="connsiteY4" fmla="*/ 3974305 h 4024744"/>
              <a:gd name="connsiteX5" fmla="*/ 804860 w 9144000"/>
              <a:gd name="connsiteY5" fmla="*/ 4024313 h 4024744"/>
              <a:gd name="connsiteX6" fmla="*/ 766763 w 9144000"/>
              <a:gd name="connsiteY6" fmla="*/ 3983830 h 4024744"/>
              <a:gd name="connsiteX7" fmla="*/ 666750 w 9144000"/>
              <a:gd name="connsiteY7" fmla="*/ 3781425 h 4024744"/>
              <a:gd name="connsiteX8" fmla="*/ 0 w 9144000"/>
              <a:gd name="connsiteY8" fmla="*/ 3783806 h 4024744"/>
              <a:gd name="connsiteX9" fmla="*/ 0 w 9144000"/>
              <a:gd name="connsiteY9" fmla="*/ 0 h 4024744"/>
              <a:gd name="connsiteX0" fmla="*/ 0 w 9144000"/>
              <a:gd name="connsiteY0" fmla="*/ 0 h 4024342"/>
              <a:gd name="connsiteX1" fmla="*/ 9144000 w 9144000"/>
              <a:gd name="connsiteY1" fmla="*/ 0 h 4024342"/>
              <a:gd name="connsiteX2" fmla="*/ 9144000 w 9144000"/>
              <a:gd name="connsiteY2" fmla="*/ 3783806 h 4024342"/>
              <a:gd name="connsiteX3" fmla="*/ 945356 w 9144000"/>
              <a:gd name="connsiteY3" fmla="*/ 3786189 h 4024342"/>
              <a:gd name="connsiteX4" fmla="*/ 850106 w 9144000"/>
              <a:gd name="connsiteY4" fmla="*/ 3974305 h 4024342"/>
              <a:gd name="connsiteX5" fmla="*/ 804860 w 9144000"/>
              <a:gd name="connsiteY5" fmla="*/ 4024313 h 4024342"/>
              <a:gd name="connsiteX6" fmla="*/ 766763 w 9144000"/>
              <a:gd name="connsiteY6" fmla="*/ 3983830 h 4024342"/>
              <a:gd name="connsiteX7" fmla="*/ 666750 w 9144000"/>
              <a:gd name="connsiteY7" fmla="*/ 3781425 h 4024342"/>
              <a:gd name="connsiteX8" fmla="*/ 0 w 9144000"/>
              <a:gd name="connsiteY8" fmla="*/ 3783806 h 4024342"/>
              <a:gd name="connsiteX9" fmla="*/ 0 w 9144000"/>
              <a:gd name="connsiteY9" fmla="*/ 0 h 4024342"/>
              <a:gd name="connsiteX0" fmla="*/ 0 w 9144000"/>
              <a:gd name="connsiteY0" fmla="*/ 0 h 4024342"/>
              <a:gd name="connsiteX1" fmla="*/ 9144000 w 9144000"/>
              <a:gd name="connsiteY1" fmla="*/ 0 h 4024342"/>
              <a:gd name="connsiteX2" fmla="*/ 9144000 w 9144000"/>
              <a:gd name="connsiteY2" fmla="*/ 3783806 h 4024342"/>
              <a:gd name="connsiteX3" fmla="*/ 945356 w 9144000"/>
              <a:gd name="connsiteY3" fmla="*/ 3786189 h 4024342"/>
              <a:gd name="connsiteX4" fmla="*/ 850106 w 9144000"/>
              <a:gd name="connsiteY4" fmla="*/ 3974305 h 4024342"/>
              <a:gd name="connsiteX5" fmla="*/ 804860 w 9144000"/>
              <a:gd name="connsiteY5" fmla="*/ 4024313 h 4024342"/>
              <a:gd name="connsiteX6" fmla="*/ 766763 w 9144000"/>
              <a:gd name="connsiteY6" fmla="*/ 3983830 h 4024342"/>
              <a:gd name="connsiteX7" fmla="*/ 666750 w 9144000"/>
              <a:gd name="connsiteY7" fmla="*/ 3781425 h 4024342"/>
              <a:gd name="connsiteX8" fmla="*/ 0 w 9144000"/>
              <a:gd name="connsiteY8" fmla="*/ 3783806 h 4024342"/>
              <a:gd name="connsiteX9" fmla="*/ 0 w 9144000"/>
              <a:gd name="connsiteY9" fmla="*/ 0 h 4024342"/>
              <a:gd name="connsiteX0" fmla="*/ 0 w 9144000"/>
              <a:gd name="connsiteY0" fmla="*/ 0 h 4024784"/>
              <a:gd name="connsiteX1" fmla="*/ 9144000 w 9144000"/>
              <a:gd name="connsiteY1" fmla="*/ 0 h 4024784"/>
              <a:gd name="connsiteX2" fmla="*/ 9144000 w 9144000"/>
              <a:gd name="connsiteY2" fmla="*/ 3783806 h 4024784"/>
              <a:gd name="connsiteX3" fmla="*/ 945356 w 9144000"/>
              <a:gd name="connsiteY3" fmla="*/ 3786189 h 4024784"/>
              <a:gd name="connsiteX4" fmla="*/ 850106 w 9144000"/>
              <a:gd name="connsiteY4" fmla="*/ 3974305 h 4024784"/>
              <a:gd name="connsiteX5" fmla="*/ 804860 w 9144000"/>
              <a:gd name="connsiteY5" fmla="*/ 4024313 h 4024784"/>
              <a:gd name="connsiteX6" fmla="*/ 766763 w 9144000"/>
              <a:gd name="connsiteY6" fmla="*/ 3983830 h 4024784"/>
              <a:gd name="connsiteX7" fmla="*/ 666750 w 9144000"/>
              <a:gd name="connsiteY7" fmla="*/ 3781425 h 4024784"/>
              <a:gd name="connsiteX8" fmla="*/ 0 w 9144000"/>
              <a:gd name="connsiteY8" fmla="*/ 3783806 h 4024784"/>
              <a:gd name="connsiteX9" fmla="*/ 0 w 9144000"/>
              <a:gd name="connsiteY9" fmla="*/ 0 h 4024784"/>
              <a:gd name="connsiteX0" fmla="*/ 0 w 9144000"/>
              <a:gd name="connsiteY0" fmla="*/ 0 h 4024784"/>
              <a:gd name="connsiteX1" fmla="*/ 9144000 w 9144000"/>
              <a:gd name="connsiteY1" fmla="*/ 0 h 4024784"/>
              <a:gd name="connsiteX2" fmla="*/ 9144000 w 9144000"/>
              <a:gd name="connsiteY2" fmla="*/ 3783806 h 4024784"/>
              <a:gd name="connsiteX3" fmla="*/ 942975 w 9144000"/>
              <a:gd name="connsiteY3" fmla="*/ 3788570 h 4024784"/>
              <a:gd name="connsiteX4" fmla="*/ 850106 w 9144000"/>
              <a:gd name="connsiteY4" fmla="*/ 3974305 h 4024784"/>
              <a:gd name="connsiteX5" fmla="*/ 804860 w 9144000"/>
              <a:gd name="connsiteY5" fmla="*/ 4024313 h 4024784"/>
              <a:gd name="connsiteX6" fmla="*/ 766763 w 9144000"/>
              <a:gd name="connsiteY6" fmla="*/ 3983830 h 4024784"/>
              <a:gd name="connsiteX7" fmla="*/ 666750 w 9144000"/>
              <a:gd name="connsiteY7" fmla="*/ 3781425 h 4024784"/>
              <a:gd name="connsiteX8" fmla="*/ 0 w 9144000"/>
              <a:gd name="connsiteY8" fmla="*/ 3783806 h 4024784"/>
              <a:gd name="connsiteX9" fmla="*/ 0 w 9144000"/>
              <a:gd name="connsiteY9" fmla="*/ 0 h 4024784"/>
              <a:gd name="connsiteX0" fmla="*/ 0 w 9144000"/>
              <a:gd name="connsiteY0" fmla="*/ 0 h 4024870"/>
              <a:gd name="connsiteX1" fmla="*/ 9144000 w 9144000"/>
              <a:gd name="connsiteY1" fmla="*/ 0 h 4024870"/>
              <a:gd name="connsiteX2" fmla="*/ 9144000 w 9144000"/>
              <a:gd name="connsiteY2" fmla="*/ 3783806 h 4024870"/>
              <a:gd name="connsiteX3" fmla="*/ 942975 w 9144000"/>
              <a:gd name="connsiteY3" fmla="*/ 3788570 h 4024870"/>
              <a:gd name="connsiteX4" fmla="*/ 850106 w 9144000"/>
              <a:gd name="connsiteY4" fmla="*/ 3971924 h 4024870"/>
              <a:gd name="connsiteX5" fmla="*/ 804860 w 9144000"/>
              <a:gd name="connsiteY5" fmla="*/ 4024313 h 4024870"/>
              <a:gd name="connsiteX6" fmla="*/ 766763 w 9144000"/>
              <a:gd name="connsiteY6" fmla="*/ 3983830 h 4024870"/>
              <a:gd name="connsiteX7" fmla="*/ 666750 w 9144000"/>
              <a:gd name="connsiteY7" fmla="*/ 3781425 h 4024870"/>
              <a:gd name="connsiteX8" fmla="*/ 0 w 9144000"/>
              <a:gd name="connsiteY8" fmla="*/ 3783806 h 4024870"/>
              <a:gd name="connsiteX9" fmla="*/ 0 w 9144000"/>
              <a:gd name="connsiteY9" fmla="*/ 0 h 4024870"/>
              <a:gd name="connsiteX0" fmla="*/ 0 w 9144000"/>
              <a:gd name="connsiteY0" fmla="*/ 0 h 4024870"/>
              <a:gd name="connsiteX1" fmla="*/ 9144000 w 9144000"/>
              <a:gd name="connsiteY1" fmla="*/ 0 h 4024870"/>
              <a:gd name="connsiteX2" fmla="*/ 9144000 w 9144000"/>
              <a:gd name="connsiteY2" fmla="*/ 3783806 h 4024870"/>
              <a:gd name="connsiteX3" fmla="*/ 940594 w 9144000"/>
              <a:gd name="connsiteY3" fmla="*/ 3786188 h 4024870"/>
              <a:gd name="connsiteX4" fmla="*/ 850106 w 9144000"/>
              <a:gd name="connsiteY4" fmla="*/ 3971924 h 4024870"/>
              <a:gd name="connsiteX5" fmla="*/ 804860 w 9144000"/>
              <a:gd name="connsiteY5" fmla="*/ 4024313 h 4024870"/>
              <a:gd name="connsiteX6" fmla="*/ 766763 w 9144000"/>
              <a:gd name="connsiteY6" fmla="*/ 3983830 h 4024870"/>
              <a:gd name="connsiteX7" fmla="*/ 666750 w 9144000"/>
              <a:gd name="connsiteY7" fmla="*/ 3781425 h 4024870"/>
              <a:gd name="connsiteX8" fmla="*/ 0 w 9144000"/>
              <a:gd name="connsiteY8" fmla="*/ 3783806 h 4024870"/>
              <a:gd name="connsiteX9" fmla="*/ 0 w 9144000"/>
              <a:gd name="connsiteY9" fmla="*/ 0 h 4024870"/>
              <a:gd name="connsiteX0" fmla="*/ 0 w 9144000"/>
              <a:gd name="connsiteY0" fmla="*/ 0 h 4024870"/>
              <a:gd name="connsiteX1" fmla="*/ 9144000 w 9144000"/>
              <a:gd name="connsiteY1" fmla="*/ 0 h 4024870"/>
              <a:gd name="connsiteX2" fmla="*/ 9144000 w 9144000"/>
              <a:gd name="connsiteY2" fmla="*/ 3783806 h 4024870"/>
              <a:gd name="connsiteX3" fmla="*/ 940594 w 9144000"/>
              <a:gd name="connsiteY3" fmla="*/ 3786188 h 4024870"/>
              <a:gd name="connsiteX4" fmla="*/ 850106 w 9144000"/>
              <a:gd name="connsiteY4" fmla="*/ 3971924 h 4024870"/>
              <a:gd name="connsiteX5" fmla="*/ 804860 w 9144000"/>
              <a:gd name="connsiteY5" fmla="*/ 4024313 h 4024870"/>
              <a:gd name="connsiteX6" fmla="*/ 766763 w 9144000"/>
              <a:gd name="connsiteY6" fmla="*/ 3983830 h 4024870"/>
              <a:gd name="connsiteX7" fmla="*/ 669131 w 9144000"/>
              <a:gd name="connsiteY7" fmla="*/ 3786188 h 4024870"/>
              <a:gd name="connsiteX8" fmla="*/ 0 w 9144000"/>
              <a:gd name="connsiteY8" fmla="*/ 3783806 h 4024870"/>
              <a:gd name="connsiteX9" fmla="*/ 0 w 9144000"/>
              <a:gd name="connsiteY9" fmla="*/ 0 h 4024870"/>
              <a:gd name="connsiteX0" fmla="*/ 0 w 9144000"/>
              <a:gd name="connsiteY0" fmla="*/ 0 h 4024870"/>
              <a:gd name="connsiteX1" fmla="*/ 9144000 w 9144000"/>
              <a:gd name="connsiteY1" fmla="*/ 0 h 4024870"/>
              <a:gd name="connsiteX2" fmla="*/ 9144000 w 9144000"/>
              <a:gd name="connsiteY2" fmla="*/ 3790950 h 4024870"/>
              <a:gd name="connsiteX3" fmla="*/ 940594 w 9144000"/>
              <a:gd name="connsiteY3" fmla="*/ 3786188 h 4024870"/>
              <a:gd name="connsiteX4" fmla="*/ 850106 w 9144000"/>
              <a:gd name="connsiteY4" fmla="*/ 3971924 h 4024870"/>
              <a:gd name="connsiteX5" fmla="*/ 804860 w 9144000"/>
              <a:gd name="connsiteY5" fmla="*/ 4024313 h 4024870"/>
              <a:gd name="connsiteX6" fmla="*/ 766763 w 9144000"/>
              <a:gd name="connsiteY6" fmla="*/ 3983830 h 4024870"/>
              <a:gd name="connsiteX7" fmla="*/ 669131 w 9144000"/>
              <a:gd name="connsiteY7" fmla="*/ 3786188 h 4024870"/>
              <a:gd name="connsiteX8" fmla="*/ 0 w 9144000"/>
              <a:gd name="connsiteY8" fmla="*/ 3783806 h 4024870"/>
              <a:gd name="connsiteX9" fmla="*/ 0 w 9144000"/>
              <a:gd name="connsiteY9" fmla="*/ 0 h 4024870"/>
              <a:gd name="connsiteX0" fmla="*/ 0 w 9144000"/>
              <a:gd name="connsiteY0" fmla="*/ 0 h 4079133"/>
              <a:gd name="connsiteX1" fmla="*/ 9144000 w 9144000"/>
              <a:gd name="connsiteY1" fmla="*/ 0 h 4079133"/>
              <a:gd name="connsiteX2" fmla="*/ 9144000 w 9144000"/>
              <a:gd name="connsiteY2" fmla="*/ 3790950 h 4079133"/>
              <a:gd name="connsiteX3" fmla="*/ 940594 w 9144000"/>
              <a:gd name="connsiteY3" fmla="*/ 3786188 h 4079133"/>
              <a:gd name="connsiteX4" fmla="*/ 850106 w 9144000"/>
              <a:gd name="connsiteY4" fmla="*/ 3971924 h 4079133"/>
              <a:gd name="connsiteX5" fmla="*/ 804860 w 9144000"/>
              <a:gd name="connsiteY5" fmla="*/ 4079082 h 4079133"/>
              <a:gd name="connsiteX6" fmla="*/ 766763 w 9144000"/>
              <a:gd name="connsiteY6" fmla="*/ 3983830 h 4079133"/>
              <a:gd name="connsiteX7" fmla="*/ 669131 w 9144000"/>
              <a:gd name="connsiteY7" fmla="*/ 3786188 h 4079133"/>
              <a:gd name="connsiteX8" fmla="*/ 0 w 9144000"/>
              <a:gd name="connsiteY8" fmla="*/ 3783806 h 4079133"/>
              <a:gd name="connsiteX9" fmla="*/ 0 w 9144000"/>
              <a:gd name="connsiteY9" fmla="*/ 0 h 4079133"/>
              <a:gd name="connsiteX0" fmla="*/ 0 w 9144000"/>
              <a:gd name="connsiteY0" fmla="*/ 0 h 4079133"/>
              <a:gd name="connsiteX1" fmla="*/ 9144000 w 9144000"/>
              <a:gd name="connsiteY1" fmla="*/ 0 h 4079133"/>
              <a:gd name="connsiteX2" fmla="*/ 9144000 w 9144000"/>
              <a:gd name="connsiteY2" fmla="*/ 3790950 h 4079133"/>
              <a:gd name="connsiteX3" fmla="*/ 940594 w 9144000"/>
              <a:gd name="connsiteY3" fmla="*/ 3786188 h 4079133"/>
              <a:gd name="connsiteX4" fmla="*/ 850106 w 9144000"/>
              <a:gd name="connsiteY4" fmla="*/ 3971924 h 4079133"/>
              <a:gd name="connsiteX5" fmla="*/ 804860 w 9144000"/>
              <a:gd name="connsiteY5" fmla="*/ 4079082 h 4079133"/>
              <a:gd name="connsiteX6" fmla="*/ 766763 w 9144000"/>
              <a:gd name="connsiteY6" fmla="*/ 3983830 h 4079133"/>
              <a:gd name="connsiteX7" fmla="*/ 669131 w 9144000"/>
              <a:gd name="connsiteY7" fmla="*/ 3786188 h 4079133"/>
              <a:gd name="connsiteX8" fmla="*/ 0 w 9144000"/>
              <a:gd name="connsiteY8" fmla="*/ 3783806 h 4079133"/>
              <a:gd name="connsiteX9" fmla="*/ 0 w 9144000"/>
              <a:gd name="connsiteY9" fmla="*/ 0 h 4079133"/>
              <a:gd name="connsiteX0" fmla="*/ 0 w 9144000"/>
              <a:gd name="connsiteY0" fmla="*/ 0 h 4022693"/>
              <a:gd name="connsiteX1" fmla="*/ 9144000 w 9144000"/>
              <a:gd name="connsiteY1" fmla="*/ 0 h 4022693"/>
              <a:gd name="connsiteX2" fmla="*/ 9144000 w 9144000"/>
              <a:gd name="connsiteY2" fmla="*/ 3790950 h 4022693"/>
              <a:gd name="connsiteX3" fmla="*/ 940594 w 9144000"/>
              <a:gd name="connsiteY3" fmla="*/ 3786188 h 4022693"/>
              <a:gd name="connsiteX4" fmla="*/ 850106 w 9144000"/>
              <a:gd name="connsiteY4" fmla="*/ 3971924 h 4022693"/>
              <a:gd name="connsiteX5" fmla="*/ 800097 w 9144000"/>
              <a:gd name="connsiteY5" fmla="*/ 4021932 h 4022693"/>
              <a:gd name="connsiteX6" fmla="*/ 766763 w 9144000"/>
              <a:gd name="connsiteY6" fmla="*/ 3983830 h 4022693"/>
              <a:gd name="connsiteX7" fmla="*/ 669131 w 9144000"/>
              <a:gd name="connsiteY7" fmla="*/ 3786188 h 4022693"/>
              <a:gd name="connsiteX8" fmla="*/ 0 w 9144000"/>
              <a:gd name="connsiteY8" fmla="*/ 3783806 h 4022693"/>
              <a:gd name="connsiteX9" fmla="*/ 0 w 9144000"/>
              <a:gd name="connsiteY9" fmla="*/ 0 h 4022693"/>
              <a:gd name="connsiteX0" fmla="*/ 0 w 9144000"/>
              <a:gd name="connsiteY0" fmla="*/ 0 h 4022693"/>
              <a:gd name="connsiteX1" fmla="*/ 9144000 w 9144000"/>
              <a:gd name="connsiteY1" fmla="*/ 0 h 4022693"/>
              <a:gd name="connsiteX2" fmla="*/ 9144000 w 9144000"/>
              <a:gd name="connsiteY2" fmla="*/ 3790950 h 4022693"/>
              <a:gd name="connsiteX3" fmla="*/ 940594 w 9144000"/>
              <a:gd name="connsiteY3" fmla="*/ 3786188 h 4022693"/>
              <a:gd name="connsiteX4" fmla="*/ 850106 w 9144000"/>
              <a:gd name="connsiteY4" fmla="*/ 3971924 h 4022693"/>
              <a:gd name="connsiteX5" fmla="*/ 800097 w 9144000"/>
              <a:gd name="connsiteY5" fmla="*/ 4021932 h 4022693"/>
              <a:gd name="connsiteX6" fmla="*/ 766763 w 9144000"/>
              <a:gd name="connsiteY6" fmla="*/ 3983830 h 4022693"/>
              <a:gd name="connsiteX7" fmla="*/ 669131 w 9144000"/>
              <a:gd name="connsiteY7" fmla="*/ 3786188 h 4022693"/>
              <a:gd name="connsiteX8" fmla="*/ 0 w 9144000"/>
              <a:gd name="connsiteY8" fmla="*/ 3783806 h 4022693"/>
              <a:gd name="connsiteX9" fmla="*/ 0 w 9144000"/>
              <a:gd name="connsiteY9" fmla="*/ 0 h 4022693"/>
              <a:gd name="connsiteX0" fmla="*/ 0 w 9144000"/>
              <a:gd name="connsiteY0" fmla="*/ 0 h 4022693"/>
              <a:gd name="connsiteX1" fmla="*/ 9144000 w 9144000"/>
              <a:gd name="connsiteY1" fmla="*/ 0 h 4022693"/>
              <a:gd name="connsiteX2" fmla="*/ 9144000 w 9144000"/>
              <a:gd name="connsiteY2" fmla="*/ 3790950 h 4022693"/>
              <a:gd name="connsiteX3" fmla="*/ 940594 w 9144000"/>
              <a:gd name="connsiteY3" fmla="*/ 3786188 h 4022693"/>
              <a:gd name="connsiteX4" fmla="*/ 850106 w 9144000"/>
              <a:gd name="connsiteY4" fmla="*/ 3971924 h 4022693"/>
              <a:gd name="connsiteX5" fmla="*/ 800097 w 9144000"/>
              <a:gd name="connsiteY5" fmla="*/ 4021932 h 4022693"/>
              <a:gd name="connsiteX6" fmla="*/ 766763 w 9144000"/>
              <a:gd name="connsiteY6" fmla="*/ 3983830 h 4022693"/>
              <a:gd name="connsiteX7" fmla="*/ 669131 w 9144000"/>
              <a:gd name="connsiteY7" fmla="*/ 3786188 h 4022693"/>
              <a:gd name="connsiteX8" fmla="*/ 0 w 9144000"/>
              <a:gd name="connsiteY8" fmla="*/ 3783806 h 4022693"/>
              <a:gd name="connsiteX9" fmla="*/ 0 w 9144000"/>
              <a:gd name="connsiteY9" fmla="*/ 0 h 4022693"/>
              <a:gd name="connsiteX0" fmla="*/ 0 w 9144000"/>
              <a:gd name="connsiteY0" fmla="*/ 0 h 4022693"/>
              <a:gd name="connsiteX1" fmla="*/ 9144000 w 9144000"/>
              <a:gd name="connsiteY1" fmla="*/ 0 h 4022693"/>
              <a:gd name="connsiteX2" fmla="*/ 9144000 w 9144000"/>
              <a:gd name="connsiteY2" fmla="*/ 3790950 h 4022693"/>
              <a:gd name="connsiteX3" fmla="*/ 940594 w 9144000"/>
              <a:gd name="connsiteY3" fmla="*/ 3786188 h 4022693"/>
              <a:gd name="connsiteX4" fmla="*/ 850106 w 9144000"/>
              <a:gd name="connsiteY4" fmla="*/ 3971924 h 4022693"/>
              <a:gd name="connsiteX5" fmla="*/ 804860 w 9144000"/>
              <a:gd name="connsiteY5" fmla="*/ 4021932 h 4022693"/>
              <a:gd name="connsiteX6" fmla="*/ 766763 w 9144000"/>
              <a:gd name="connsiteY6" fmla="*/ 3983830 h 4022693"/>
              <a:gd name="connsiteX7" fmla="*/ 669131 w 9144000"/>
              <a:gd name="connsiteY7" fmla="*/ 3786188 h 4022693"/>
              <a:gd name="connsiteX8" fmla="*/ 0 w 9144000"/>
              <a:gd name="connsiteY8" fmla="*/ 3783806 h 4022693"/>
              <a:gd name="connsiteX9" fmla="*/ 0 w 9144000"/>
              <a:gd name="connsiteY9" fmla="*/ 0 h 4022693"/>
              <a:gd name="connsiteX0" fmla="*/ 0 w 9144000"/>
              <a:gd name="connsiteY0" fmla="*/ 0 h 4021943"/>
              <a:gd name="connsiteX1" fmla="*/ 9144000 w 9144000"/>
              <a:gd name="connsiteY1" fmla="*/ 0 h 4021943"/>
              <a:gd name="connsiteX2" fmla="*/ 9144000 w 9144000"/>
              <a:gd name="connsiteY2" fmla="*/ 3790950 h 4021943"/>
              <a:gd name="connsiteX3" fmla="*/ 940594 w 9144000"/>
              <a:gd name="connsiteY3" fmla="*/ 3786188 h 4021943"/>
              <a:gd name="connsiteX4" fmla="*/ 850106 w 9144000"/>
              <a:gd name="connsiteY4" fmla="*/ 3971924 h 4021943"/>
              <a:gd name="connsiteX5" fmla="*/ 804860 w 9144000"/>
              <a:gd name="connsiteY5" fmla="*/ 4021932 h 4021943"/>
              <a:gd name="connsiteX6" fmla="*/ 766763 w 9144000"/>
              <a:gd name="connsiteY6" fmla="*/ 3983830 h 4021943"/>
              <a:gd name="connsiteX7" fmla="*/ 669131 w 9144000"/>
              <a:gd name="connsiteY7" fmla="*/ 3786188 h 4021943"/>
              <a:gd name="connsiteX8" fmla="*/ 0 w 9144000"/>
              <a:gd name="connsiteY8" fmla="*/ 3783806 h 4021943"/>
              <a:gd name="connsiteX9" fmla="*/ 0 w 9144000"/>
              <a:gd name="connsiteY9" fmla="*/ 0 h 4021943"/>
              <a:gd name="connsiteX0" fmla="*/ 0 w 9144000"/>
              <a:gd name="connsiteY0" fmla="*/ 0 h 4021943"/>
              <a:gd name="connsiteX1" fmla="*/ 9144000 w 9144000"/>
              <a:gd name="connsiteY1" fmla="*/ 0 h 4021943"/>
              <a:gd name="connsiteX2" fmla="*/ 9144000 w 9144000"/>
              <a:gd name="connsiteY2" fmla="*/ 3790950 h 4021943"/>
              <a:gd name="connsiteX3" fmla="*/ 940594 w 9144000"/>
              <a:gd name="connsiteY3" fmla="*/ 3786188 h 4021943"/>
              <a:gd name="connsiteX4" fmla="*/ 850106 w 9144000"/>
              <a:gd name="connsiteY4" fmla="*/ 3971924 h 4021943"/>
              <a:gd name="connsiteX5" fmla="*/ 804860 w 9144000"/>
              <a:gd name="connsiteY5" fmla="*/ 4021932 h 4021943"/>
              <a:gd name="connsiteX6" fmla="*/ 766763 w 9144000"/>
              <a:gd name="connsiteY6" fmla="*/ 3983830 h 4021943"/>
              <a:gd name="connsiteX7" fmla="*/ 669131 w 9144000"/>
              <a:gd name="connsiteY7" fmla="*/ 3786188 h 4021943"/>
              <a:gd name="connsiteX8" fmla="*/ 0 w 9144000"/>
              <a:gd name="connsiteY8" fmla="*/ 3783806 h 4021943"/>
              <a:gd name="connsiteX9" fmla="*/ 0 w 9144000"/>
              <a:gd name="connsiteY9" fmla="*/ 0 h 4021943"/>
              <a:gd name="connsiteX0" fmla="*/ 0 w 9144000"/>
              <a:gd name="connsiteY0" fmla="*/ 0 h 4021932"/>
              <a:gd name="connsiteX1" fmla="*/ 9144000 w 9144000"/>
              <a:gd name="connsiteY1" fmla="*/ 0 h 4021932"/>
              <a:gd name="connsiteX2" fmla="*/ 9144000 w 9144000"/>
              <a:gd name="connsiteY2" fmla="*/ 3790950 h 4021932"/>
              <a:gd name="connsiteX3" fmla="*/ 940594 w 9144000"/>
              <a:gd name="connsiteY3" fmla="*/ 3786188 h 4021932"/>
              <a:gd name="connsiteX4" fmla="*/ 850106 w 9144000"/>
              <a:gd name="connsiteY4" fmla="*/ 3971924 h 4021932"/>
              <a:gd name="connsiteX5" fmla="*/ 804860 w 9144000"/>
              <a:gd name="connsiteY5" fmla="*/ 4021932 h 4021932"/>
              <a:gd name="connsiteX6" fmla="*/ 762000 w 9144000"/>
              <a:gd name="connsiteY6" fmla="*/ 3971923 h 4021932"/>
              <a:gd name="connsiteX7" fmla="*/ 669131 w 9144000"/>
              <a:gd name="connsiteY7" fmla="*/ 3786188 h 4021932"/>
              <a:gd name="connsiteX8" fmla="*/ 0 w 9144000"/>
              <a:gd name="connsiteY8" fmla="*/ 3783806 h 4021932"/>
              <a:gd name="connsiteX9" fmla="*/ 0 w 9144000"/>
              <a:gd name="connsiteY9" fmla="*/ 0 h 4021932"/>
              <a:gd name="connsiteX0" fmla="*/ 0 w 9144000"/>
              <a:gd name="connsiteY0" fmla="*/ 0 h 4021932"/>
              <a:gd name="connsiteX1" fmla="*/ 9144000 w 9144000"/>
              <a:gd name="connsiteY1" fmla="*/ 0 h 4021932"/>
              <a:gd name="connsiteX2" fmla="*/ 9144000 w 9144000"/>
              <a:gd name="connsiteY2" fmla="*/ 3790950 h 4021932"/>
              <a:gd name="connsiteX3" fmla="*/ 940594 w 9144000"/>
              <a:gd name="connsiteY3" fmla="*/ 3786188 h 4021932"/>
              <a:gd name="connsiteX4" fmla="*/ 850106 w 9144000"/>
              <a:gd name="connsiteY4" fmla="*/ 3971924 h 4021932"/>
              <a:gd name="connsiteX5" fmla="*/ 804860 w 9144000"/>
              <a:gd name="connsiteY5" fmla="*/ 4021932 h 4021932"/>
              <a:gd name="connsiteX6" fmla="*/ 762000 w 9144000"/>
              <a:gd name="connsiteY6" fmla="*/ 3971923 h 4021932"/>
              <a:gd name="connsiteX7" fmla="*/ 669131 w 9144000"/>
              <a:gd name="connsiteY7" fmla="*/ 3786188 h 4021932"/>
              <a:gd name="connsiteX8" fmla="*/ 0 w 9144000"/>
              <a:gd name="connsiteY8" fmla="*/ 3783806 h 4021932"/>
              <a:gd name="connsiteX9" fmla="*/ 0 w 9144000"/>
              <a:gd name="connsiteY9" fmla="*/ 0 h 402193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9144000" h="4021932">
                <a:moveTo>
                  <a:pt x="0" y="0"/>
                </a:moveTo>
                <a:lnTo>
                  <a:pt x="9144000" y="0"/>
                </a:lnTo>
                <a:lnTo>
                  <a:pt x="9144000" y="3790950"/>
                </a:lnTo>
                <a:lnTo>
                  <a:pt x="940594" y="3786188"/>
                </a:lnTo>
                <a:cubicBezTo>
                  <a:pt x="897334" y="3870326"/>
                  <a:pt x="872728" y="3931443"/>
                  <a:pt x="850106" y="3971924"/>
                </a:cubicBezTo>
                <a:cubicBezTo>
                  <a:pt x="827484" y="4012405"/>
                  <a:pt x="819544" y="4021932"/>
                  <a:pt x="804860" y="4021932"/>
                </a:cubicBezTo>
                <a:cubicBezTo>
                  <a:pt x="790176" y="4021932"/>
                  <a:pt x="778668" y="4001292"/>
                  <a:pt x="762000" y="3971923"/>
                </a:cubicBezTo>
                <a:cubicBezTo>
                  <a:pt x="738188" y="3930648"/>
                  <a:pt x="711200" y="3876675"/>
                  <a:pt x="669131" y="3786188"/>
                </a:cubicBezTo>
                <a:lnTo>
                  <a:pt x="0" y="3783806"/>
                </a:lnTo>
                <a:lnTo>
                  <a:pt x="0" y="0"/>
                </a:lnTo>
                <a:close/>
              </a:path>
            </a:pathLst>
          </a:custGeom>
        </p:spPr>
        <p:txBody>
          <a:bodyPr anchor="ctr" anchorCtr="0"/>
          <a:lstStyle>
            <a:lvl1pPr marL="0" indent="0" algn="ctr">
              <a:buNone/>
              <a:defRPr/>
            </a:lvl1pPr>
          </a:lstStyle>
          <a:p>
            <a:r>
              <a:rPr lang="en-US"/>
              <a:t>Click icon to add picture</a:t>
            </a:r>
          </a:p>
        </p:txBody>
      </p:sp>
      <p:sp>
        <p:nvSpPr>
          <p:cNvPr id="4" name="TextBox 3"/>
          <p:cNvSpPr txBox="1"/>
          <p:nvPr userDrawn="1"/>
        </p:nvSpPr>
        <p:spPr>
          <a:xfrm>
            <a:off x="796873" y="5455427"/>
            <a:ext cx="4365507" cy="707886"/>
          </a:xfrm>
          <a:prstGeom prst="rect">
            <a:avLst/>
          </a:prstGeom>
          <a:noFill/>
        </p:spPr>
        <p:txBody>
          <a:bodyPr wrap="square" rtlCol="0">
            <a:spAutoFit/>
          </a:bodyPr>
          <a:lstStyle/>
          <a:p>
            <a:r>
              <a:rPr lang="en-US" sz="4000" b="1">
                <a:solidFill>
                  <a:srgbClr val="FFFFFF"/>
                </a:solidFill>
                <a:latin typeface="+mj-lt"/>
              </a:rPr>
              <a:t>THANK</a:t>
            </a:r>
            <a:r>
              <a:rPr lang="en-US" sz="4000" b="1" baseline="0">
                <a:solidFill>
                  <a:srgbClr val="FFFFFF"/>
                </a:solidFill>
                <a:latin typeface="+mj-lt"/>
              </a:rPr>
              <a:t> YOU</a:t>
            </a:r>
            <a:endParaRPr lang="en-US" sz="4000" b="1">
              <a:solidFill>
                <a:srgbClr val="FFFFFF"/>
              </a:solidFill>
              <a:latin typeface="+mj-lt"/>
            </a:endParaRPr>
          </a:p>
        </p:txBody>
      </p:sp>
    </p:spTree>
    <p:extLst>
      <p:ext uri="{BB962C8B-B14F-4D97-AF65-F5344CB8AC3E}">
        <p14:creationId xmlns:p14="http://schemas.microsoft.com/office/powerpoint/2010/main" val="27976003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Thank You Text">
    <p:spTree>
      <p:nvGrpSpPr>
        <p:cNvPr id="1" name=""/>
        <p:cNvGrpSpPr/>
        <p:nvPr/>
      </p:nvGrpSpPr>
      <p:grpSpPr>
        <a:xfrm>
          <a:off x="0" y="0"/>
          <a:ext cx="0" cy="0"/>
          <a:chOff x="0" y="0"/>
          <a:chExt cx="0" cy="0"/>
        </a:xfrm>
      </p:grpSpPr>
      <p:sp>
        <p:nvSpPr>
          <p:cNvPr id="3" name="Content Placeholder 2"/>
          <p:cNvSpPr>
            <a:spLocks noGrp="1"/>
          </p:cNvSpPr>
          <p:nvPr>
            <p:ph sz="half" idx="1"/>
          </p:nvPr>
        </p:nvSpPr>
        <p:spPr>
          <a:xfrm>
            <a:off x="609600" y="1781048"/>
            <a:ext cx="3308096" cy="4035553"/>
          </a:xfrm>
        </p:spPr>
        <p:txBody>
          <a:bodyPr vert="horz" lIns="0" tIns="0" rIns="0" bIns="0" rtlCol="0">
            <a:noAutofit/>
          </a:bodyPr>
          <a:lstStyle>
            <a:lvl1pPr marL="0" indent="0">
              <a:spcBef>
                <a:spcPts val="2000"/>
              </a:spcBef>
              <a:buNone/>
              <a:defRPr lang="en-US" sz="1600" b="1" dirty="0">
                <a:solidFill>
                  <a:schemeClr val="accent1"/>
                </a:solidFill>
              </a:defRPr>
            </a:lvl1pPr>
            <a:lvl2pPr marL="455073" indent="-455073">
              <a:spcBef>
                <a:spcPts val="0"/>
              </a:spcBef>
              <a:buNone/>
              <a:defRPr lang="en-US" sz="1600" dirty="0"/>
            </a:lvl2pPr>
            <a:lvl3pPr>
              <a:defRPr lang="en-US" dirty="0"/>
            </a:lvl3pPr>
            <a:lvl4pPr>
              <a:defRPr lang="en-US" dirty="0"/>
            </a:lvl4pPr>
            <a:lvl5pPr>
              <a:defRPr lang="en-US" dirty="0"/>
            </a:lvl5pPr>
          </a:lstStyle>
          <a:p>
            <a:pPr lvl="0"/>
            <a:r>
              <a:rPr lang="en-US"/>
              <a:t>Click to edit Master text styles</a:t>
            </a:r>
          </a:p>
          <a:p>
            <a:pPr lvl="1"/>
            <a:r>
              <a:rPr lang="en-US"/>
              <a:t>Second level</a:t>
            </a:r>
          </a:p>
        </p:txBody>
      </p:sp>
      <p:sp>
        <p:nvSpPr>
          <p:cNvPr id="7" name="Title 1"/>
          <p:cNvSpPr>
            <a:spLocks noGrp="1"/>
          </p:cNvSpPr>
          <p:nvPr>
            <p:ph type="title"/>
          </p:nvPr>
        </p:nvSpPr>
        <p:spPr>
          <a:xfrm>
            <a:off x="609599" y="609600"/>
            <a:ext cx="10972803" cy="418576"/>
          </a:xfrm>
        </p:spPr>
        <p:txBody>
          <a:bodyPr vert="horz" lIns="0" tIns="0" rIns="0" bIns="0" rtlCol="0" anchor="b" anchorCtr="0">
            <a:noAutofit/>
          </a:bodyPr>
          <a:lstStyle>
            <a:lvl1pPr>
              <a:defRPr lang="en-US" sz="3200" b="1" i="0" kern="1200" cap="none" dirty="0">
                <a:solidFill>
                  <a:schemeClr val="tx2"/>
                </a:solidFill>
                <a:latin typeface="+mj-lt"/>
                <a:ea typeface="+mj-ea"/>
                <a:cs typeface="+mj-cs"/>
              </a:defRPr>
            </a:lvl1pPr>
          </a:lstStyle>
          <a:p>
            <a:pPr lvl="0" algn="l" defTabSz="457189" rtl="0" eaLnBrk="1" latinLnBrk="0" hangingPunct="1">
              <a:lnSpc>
                <a:spcPct val="85000"/>
              </a:lnSpc>
              <a:spcBef>
                <a:spcPct val="0"/>
              </a:spcBef>
              <a:buNone/>
            </a:pPr>
            <a:r>
              <a:rPr lang="en-US"/>
              <a:t>Click to edit Master title style</a:t>
            </a:r>
          </a:p>
        </p:txBody>
      </p:sp>
      <p:sp>
        <p:nvSpPr>
          <p:cNvPr id="5" name="Text Placeholder 4"/>
          <p:cNvSpPr>
            <a:spLocks noGrp="1"/>
          </p:cNvSpPr>
          <p:nvPr>
            <p:ph type="body" sz="quarter" idx="20"/>
          </p:nvPr>
        </p:nvSpPr>
        <p:spPr>
          <a:xfrm>
            <a:off x="609600" y="1268985"/>
            <a:ext cx="10972800" cy="291592"/>
          </a:xfrm>
        </p:spPr>
        <p:txBody>
          <a:bodyPr/>
          <a:lstStyle>
            <a:lvl1pPr marL="0" indent="0">
              <a:buNone/>
              <a:defRPr sz="1867"/>
            </a:lvl1pPr>
            <a:lvl2pPr marL="306910" indent="0">
              <a:buNone/>
              <a:defRPr/>
            </a:lvl2pPr>
          </a:lstStyle>
          <a:p>
            <a:pPr lvl="0"/>
            <a:r>
              <a:rPr lang="en-US"/>
              <a:t>Click to edit Master text styles</a:t>
            </a:r>
          </a:p>
        </p:txBody>
      </p:sp>
      <p:sp>
        <p:nvSpPr>
          <p:cNvPr id="15" name="Content Placeholder 2"/>
          <p:cNvSpPr>
            <a:spLocks noGrp="1"/>
          </p:cNvSpPr>
          <p:nvPr>
            <p:ph sz="half" idx="21"/>
          </p:nvPr>
        </p:nvSpPr>
        <p:spPr>
          <a:xfrm>
            <a:off x="4267200" y="1781048"/>
            <a:ext cx="3308096" cy="4035553"/>
          </a:xfrm>
        </p:spPr>
        <p:txBody>
          <a:bodyPr vert="horz" lIns="0" tIns="0" rIns="0" bIns="0" rtlCol="0">
            <a:noAutofit/>
          </a:bodyPr>
          <a:lstStyle>
            <a:lvl1pPr marL="0" indent="0">
              <a:spcBef>
                <a:spcPts val="2000"/>
              </a:spcBef>
              <a:buNone/>
              <a:defRPr lang="en-US" sz="1600" b="1" dirty="0">
                <a:solidFill>
                  <a:schemeClr val="accent1"/>
                </a:solidFill>
              </a:defRPr>
            </a:lvl1pPr>
            <a:lvl2pPr marL="455073" indent="-455073">
              <a:spcBef>
                <a:spcPts val="0"/>
              </a:spcBef>
              <a:buNone/>
              <a:defRPr lang="en-US" sz="1600" dirty="0"/>
            </a:lvl2pPr>
            <a:lvl3pPr>
              <a:defRPr lang="en-US" dirty="0"/>
            </a:lvl3pPr>
            <a:lvl4pPr>
              <a:defRPr lang="en-US" dirty="0"/>
            </a:lvl4pPr>
            <a:lvl5pPr>
              <a:defRPr lang="en-US" dirty="0"/>
            </a:lvl5pPr>
          </a:lstStyle>
          <a:p>
            <a:pPr lvl="0"/>
            <a:r>
              <a:rPr lang="en-US"/>
              <a:t>Click to edit Master text styles</a:t>
            </a:r>
          </a:p>
          <a:p>
            <a:pPr lvl="1"/>
            <a:r>
              <a:rPr lang="en-US"/>
              <a:t>Second level</a:t>
            </a:r>
          </a:p>
        </p:txBody>
      </p:sp>
      <p:sp>
        <p:nvSpPr>
          <p:cNvPr id="16" name="Content Placeholder 2"/>
          <p:cNvSpPr>
            <a:spLocks noGrp="1"/>
          </p:cNvSpPr>
          <p:nvPr>
            <p:ph sz="half" idx="22"/>
          </p:nvPr>
        </p:nvSpPr>
        <p:spPr>
          <a:xfrm>
            <a:off x="7924800" y="1781048"/>
            <a:ext cx="3308096" cy="4035553"/>
          </a:xfrm>
        </p:spPr>
        <p:txBody>
          <a:bodyPr vert="horz" lIns="0" tIns="0" rIns="0" bIns="0" rtlCol="0">
            <a:noAutofit/>
          </a:bodyPr>
          <a:lstStyle>
            <a:lvl1pPr marL="0" indent="0">
              <a:spcBef>
                <a:spcPts val="2000"/>
              </a:spcBef>
              <a:buNone/>
              <a:defRPr lang="en-US" sz="1600" b="1" dirty="0">
                <a:solidFill>
                  <a:schemeClr val="accent1"/>
                </a:solidFill>
              </a:defRPr>
            </a:lvl1pPr>
            <a:lvl2pPr marL="455073" indent="-455073">
              <a:spcBef>
                <a:spcPts val="0"/>
              </a:spcBef>
              <a:buNone/>
              <a:defRPr lang="en-US" sz="1600" dirty="0"/>
            </a:lvl2pPr>
            <a:lvl3pPr>
              <a:defRPr lang="en-US" dirty="0"/>
            </a:lvl3pPr>
            <a:lvl4pPr>
              <a:defRPr lang="en-US" dirty="0"/>
            </a:lvl4pPr>
            <a:lvl5pPr>
              <a:defRPr lang="en-US" dirty="0"/>
            </a:lvl5pPr>
          </a:lstStyle>
          <a:p>
            <a:pPr lvl="0"/>
            <a:r>
              <a:rPr lang="en-US"/>
              <a:t>Click to edit Master text styles</a:t>
            </a:r>
          </a:p>
          <a:p>
            <a:pPr lvl="1"/>
            <a:r>
              <a:rPr lang="en-US"/>
              <a:t>Second level</a:t>
            </a:r>
          </a:p>
        </p:txBody>
      </p:sp>
      <p:sp>
        <p:nvSpPr>
          <p:cNvPr id="17" name="Footer Placeholder 4"/>
          <p:cNvSpPr>
            <a:spLocks noGrp="1"/>
          </p:cNvSpPr>
          <p:nvPr>
            <p:ph type="ftr" sz="quarter" idx="3"/>
          </p:nvPr>
        </p:nvSpPr>
        <p:spPr>
          <a:xfrm>
            <a:off x="1026597" y="6467745"/>
            <a:ext cx="4517089" cy="164148"/>
          </a:xfrm>
          <a:prstGeom prst="rect">
            <a:avLst/>
          </a:prstGeom>
        </p:spPr>
        <p:txBody>
          <a:bodyPr vert="horz" wrap="square" lIns="0" tIns="0" rIns="0" bIns="0" rtlCol="0" anchor="ctr">
            <a:spAutoFit/>
          </a:bodyPr>
          <a:lstStyle>
            <a:lvl1pPr algn="l">
              <a:defRPr sz="1067">
                <a:solidFill>
                  <a:schemeClr val="tx1"/>
                </a:solidFill>
              </a:defRPr>
            </a:lvl1pPr>
          </a:lstStyle>
          <a:p>
            <a:r>
              <a:rPr lang="en-US"/>
              <a:t>Division Name or Footer</a:t>
            </a:r>
          </a:p>
        </p:txBody>
      </p:sp>
      <p:sp>
        <p:nvSpPr>
          <p:cNvPr id="18" name="Slide Number Placeholder 5"/>
          <p:cNvSpPr>
            <a:spLocks noGrp="1"/>
          </p:cNvSpPr>
          <p:nvPr>
            <p:ph type="sldNum" sz="quarter" idx="4"/>
          </p:nvPr>
        </p:nvSpPr>
        <p:spPr>
          <a:xfrm>
            <a:off x="609601" y="6457702"/>
            <a:ext cx="339625" cy="164148"/>
          </a:xfrm>
          <a:prstGeom prst="rect">
            <a:avLst/>
          </a:prstGeom>
        </p:spPr>
        <p:txBody>
          <a:bodyPr vert="horz" wrap="square" lIns="0" tIns="0" rIns="0" bIns="0" rtlCol="0" anchor="ctr">
            <a:spAutoFit/>
          </a:bodyPr>
          <a:lstStyle>
            <a:lvl1pPr algn="l">
              <a:defRPr sz="1067">
                <a:solidFill>
                  <a:schemeClr val="tx1"/>
                </a:solidFill>
              </a:defRPr>
            </a:lvl1pPr>
          </a:lstStyle>
          <a:p>
            <a:fld id="{7FEEEA1A-CB49-3744-AA40-B896987410F9}" type="slidenum">
              <a:rPr lang="en-US" smtClean="0"/>
              <a:pPr/>
              <a:t>‹#›</a:t>
            </a:fld>
            <a:endParaRPr lang="en-US"/>
          </a:p>
        </p:txBody>
      </p:sp>
    </p:spTree>
    <p:extLst>
      <p:ext uri="{BB962C8B-B14F-4D97-AF65-F5344CB8AC3E}">
        <p14:creationId xmlns:p14="http://schemas.microsoft.com/office/powerpoint/2010/main" val="3761195032"/>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showMasterSp="0" preserve="1" userDrawn="1">
  <p:cSld name="1_Title Slide">
    <p:bg>
      <p:bgPr>
        <a:solidFill>
          <a:schemeClr val="tx2"/>
        </a:solidFill>
        <a:effectLst/>
      </p:bgPr>
    </p:bg>
    <p:spTree>
      <p:nvGrpSpPr>
        <p:cNvPr id="1" name=""/>
        <p:cNvGrpSpPr/>
        <p:nvPr/>
      </p:nvGrpSpPr>
      <p:grpSpPr>
        <a:xfrm>
          <a:off x="0" y="0"/>
          <a:ext cx="0" cy="0"/>
          <a:chOff x="0" y="0"/>
          <a:chExt cx="0" cy="0"/>
        </a:xfrm>
      </p:grpSpPr>
      <p:sp>
        <p:nvSpPr>
          <p:cNvPr id="7" name="Freeform 5"/>
          <p:cNvSpPr>
            <a:spLocks noEditPoints="1"/>
          </p:cNvSpPr>
          <p:nvPr userDrawn="1"/>
        </p:nvSpPr>
        <p:spPr bwMode="auto">
          <a:xfrm>
            <a:off x="787905" y="315918"/>
            <a:ext cx="2013840" cy="879415"/>
          </a:xfrm>
          <a:custGeom>
            <a:avLst/>
            <a:gdLst>
              <a:gd name="T0" fmla="*/ 32 w 511"/>
              <a:gd name="T1" fmla="*/ 39 h 221"/>
              <a:gd name="T2" fmla="*/ 106 w 511"/>
              <a:gd name="T3" fmla="*/ 0 h 221"/>
              <a:gd name="T4" fmla="*/ 188 w 511"/>
              <a:gd name="T5" fmla="*/ 44 h 221"/>
              <a:gd name="T6" fmla="*/ 139 w 511"/>
              <a:gd name="T7" fmla="*/ 208 h 221"/>
              <a:gd name="T8" fmla="*/ 161 w 511"/>
              <a:gd name="T9" fmla="*/ 194 h 221"/>
              <a:gd name="T10" fmla="*/ 2 w 511"/>
              <a:gd name="T11" fmla="*/ 101 h 221"/>
              <a:gd name="T12" fmla="*/ 91 w 511"/>
              <a:gd name="T13" fmla="*/ 70 h 221"/>
              <a:gd name="T14" fmla="*/ 123 w 511"/>
              <a:gd name="T15" fmla="*/ 108 h 221"/>
              <a:gd name="T16" fmla="*/ 208 w 511"/>
              <a:gd name="T17" fmla="*/ 70 h 221"/>
              <a:gd name="T18" fmla="*/ 73 w 511"/>
              <a:gd name="T19" fmla="*/ 70 h 221"/>
              <a:gd name="T20" fmla="*/ 53 w 511"/>
              <a:gd name="T21" fmla="*/ 96 h 221"/>
              <a:gd name="T22" fmla="*/ 54 w 511"/>
              <a:gd name="T23" fmla="*/ 70 h 221"/>
              <a:gd name="T24" fmla="*/ 144 w 511"/>
              <a:gd name="T25" fmla="*/ 70 h 221"/>
              <a:gd name="T26" fmla="*/ 175 w 511"/>
              <a:gd name="T27" fmla="*/ 70 h 221"/>
              <a:gd name="T28" fmla="*/ 267 w 511"/>
              <a:gd name="T29" fmla="*/ 206 h 221"/>
              <a:gd name="T30" fmla="*/ 267 w 511"/>
              <a:gd name="T31" fmla="*/ 193 h 221"/>
              <a:gd name="T32" fmla="*/ 259 w 511"/>
              <a:gd name="T33" fmla="*/ 199 h 221"/>
              <a:gd name="T34" fmla="*/ 416 w 511"/>
              <a:gd name="T35" fmla="*/ 92 h 221"/>
              <a:gd name="T36" fmla="*/ 402 w 511"/>
              <a:gd name="T37" fmla="*/ 86 h 221"/>
              <a:gd name="T38" fmla="*/ 402 w 511"/>
              <a:gd name="T39" fmla="*/ 123 h 221"/>
              <a:gd name="T40" fmla="*/ 397 w 511"/>
              <a:gd name="T41" fmla="*/ 184 h 221"/>
              <a:gd name="T42" fmla="*/ 373 w 511"/>
              <a:gd name="T43" fmla="*/ 152 h 221"/>
              <a:gd name="T44" fmla="*/ 511 w 511"/>
              <a:gd name="T45" fmla="*/ 124 h 221"/>
              <a:gd name="T46" fmla="*/ 511 w 511"/>
              <a:gd name="T47" fmla="*/ 111 h 221"/>
              <a:gd name="T48" fmla="*/ 503 w 511"/>
              <a:gd name="T49" fmla="*/ 117 h 221"/>
              <a:gd name="T50" fmla="*/ 487 w 511"/>
              <a:gd name="T51" fmla="*/ 105 h 221"/>
              <a:gd name="T52" fmla="*/ 450 w 511"/>
              <a:gd name="T53" fmla="*/ 98 h 221"/>
              <a:gd name="T54" fmla="*/ 443 w 511"/>
              <a:gd name="T55" fmla="*/ 87 h 221"/>
              <a:gd name="T56" fmla="*/ 366 w 511"/>
              <a:gd name="T57" fmla="*/ 169 h 221"/>
              <a:gd name="T58" fmla="*/ 365 w 511"/>
              <a:gd name="T59" fmla="*/ 205 h 221"/>
              <a:gd name="T60" fmla="*/ 343 w 511"/>
              <a:gd name="T61" fmla="*/ 203 h 221"/>
              <a:gd name="T62" fmla="*/ 343 w 511"/>
              <a:gd name="T63" fmla="*/ 156 h 221"/>
              <a:gd name="T64" fmla="*/ 318 w 511"/>
              <a:gd name="T65" fmla="*/ 133 h 221"/>
              <a:gd name="T66" fmla="*/ 294 w 511"/>
              <a:gd name="T67" fmla="*/ 133 h 221"/>
              <a:gd name="T68" fmla="*/ 332 w 511"/>
              <a:gd name="T69" fmla="*/ 98 h 221"/>
              <a:gd name="T70" fmla="*/ 271 w 511"/>
              <a:gd name="T71" fmla="*/ 103 h 221"/>
              <a:gd name="T72" fmla="*/ 249 w 511"/>
              <a:gd name="T73" fmla="*/ 94 h 221"/>
              <a:gd name="T74" fmla="*/ 286 w 511"/>
              <a:gd name="T75" fmla="*/ 132 h 221"/>
              <a:gd name="T76" fmla="*/ 261 w 511"/>
              <a:gd name="T77" fmla="*/ 119 h 221"/>
              <a:gd name="T78" fmla="*/ 311 w 511"/>
              <a:gd name="T79" fmla="*/ 215 h 221"/>
              <a:gd name="T80" fmla="*/ 272 w 511"/>
              <a:gd name="T81" fmla="*/ 203 h 221"/>
              <a:gd name="T82" fmla="*/ 280 w 511"/>
              <a:gd name="T83" fmla="*/ 184 h 221"/>
              <a:gd name="T84" fmla="*/ 309 w 511"/>
              <a:gd name="T85" fmla="*/ 203 h 221"/>
              <a:gd name="T86" fmla="*/ 296 w 511"/>
              <a:gd name="T87" fmla="*/ 201 h 221"/>
              <a:gd name="T88" fmla="*/ 318 w 511"/>
              <a:gd name="T89" fmla="*/ 215 h 221"/>
              <a:gd name="T90" fmla="*/ 208 w 511"/>
              <a:gd name="T91" fmla="*/ 215 h 221"/>
              <a:gd name="T92" fmla="*/ 174 w 511"/>
              <a:gd name="T93" fmla="*/ 153 h 221"/>
              <a:gd name="T94" fmla="*/ 342 w 511"/>
              <a:gd name="T95" fmla="*/ 130 h 221"/>
              <a:gd name="T96" fmla="*/ 370 w 511"/>
              <a:gd name="T97" fmla="*/ 90 h 221"/>
              <a:gd name="T98" fmla="*/ 374 w 511"/>
              <a:gd name="T99" fmla="*/ 98 h 221"/>
              <a:gd name="T100" fmla="*/ 354 w 511"/>
              <a:gd name="T101" fmla="*/ 122 h 221"/>
              <a:gd name="T102" fmla="*/ 342 w 511"/>
              <a:gd name="T103" fmla="*/ 130 h 221"/>
              <a:gd name="T104" fmla="*/ 352 w 511"/>
              <a:gd name="T105" fmla="*/ 103 h 221"/>
              <a:gd name="T106" fmla="*/ 351 w 511"/>
              <a:gd name="T107" fmla="*/ 133 h 221"/>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Lst>
            <a:rect l="0" t="0" r="r" b="b"/>
            <a:pathLst>
              <a:path w="511" h="221">
                <a:moveTo>
                  <a:pt x="188" y="44"/>
                </a:moveTo>
                <a:cubicBezTo>
                  <a:pt x="188" y="44"/>
                  <a:pt x="187" y="44"/>
                  <a:pt x="186" y="43"/>
                </a:cubicBezTo>
                <a:cubicBezTo>
                  <a:pt x="185" y="42"/>
                  <a:pt x="179" y="36"/>
                  <a:pt x="169" y="30"/>
                </a:cubicBezTo>
                <a:cubicBezTo>
                  <a:pt x="159" y="24"/>
                  <a:pt x="137" y="13"/>
                  <a:pt x="107" y="13"/>
                </a:cubicBezTo>
                <a:cubicBezTo>
                  <a:pt x="71" y="13"/>
                  <a:pt x="47" y="27"/>
                  <a:pt x="32" y="39"/>
                </a:cubicBezTo>
                <a:cubicBezTo>
                  <a:pt x="18" y="51"/>
                  <a:pt x="11" y="65"/>
                  <a:pt x="11" y="66"/>
                </a:cubicBezTo>
                <a:cubicBezTo>
                  <a:pt x="11" y="66"/>
                  <a:pt x="11" y="66"/>
                  <a:pt x="10" y="66"/>
                </a:cubicBezTo>
                <a:cubicBezTo>
                  <a:pt x="10" y="66"/>
                  <a:pt x="10" y="66"/>
                  <a:pt x="10" y="66"/>
                </a:cubicBezTo>
                <a:cubicBezTo>
                  <a:pt x="11" y="65"/>
                  <a:pt x="17" y="49"/>
                  <a:pt x="30" y="35"/>
                </a:cubicBezTo>
                <a:cubicBezTo>
                  <a:pt x="43" y="20"/>
                  <a:pt x="69" y="0"/>
                  <a:pt x="106" y="0"/>
                </a:cubicBezTo>
                <a:cubicBezTo>
                  <a:pt x="142" y="0"/>
                  <a:pt x="165" y="19"/>
                  <a:pt x="173" y="26"/>
                </a:cubicBezTo>
                <a:cubicBezTo>
                  <a:pt x="180" y="33"/>
                  <a:pt x="186" y="41"/>
                  <a:pt x="187" y="42"/>
                </a:cubicBezTo>
                <a:cubicBezTo>
                  <a:pt x="188" y="43"/>
                  <a:pt x="188" y="44"/>
                  <a:pt x="188" y="44"/>
                </a:cubicBezTo>
                <a:cubicBezTo>
                  <a:pt x="188" y="44"/>
                  <a:pt x="188" y="44"/>
                  <a:pt x="188" y="44"/>
                </a:cubicBezTo>
                <a:cubicBezTo>
                  <a:pt x="188" y="44"/>
                  <a:pt x="188" y="44"/>
                  <a:pt x="188" y="44"/>
                </a:cubicBezTo>
                <a:close/>
                <a:moveTo>
                  <a:pt x="1" y="101"/>
                </a:moveTo>
                <a:cubicBezTo>
                  <a:pt x="1" y="101"/>
                  <a:pt x="1" y="101"/>
                  <a:pt x="1" y="102"/>
                </a:cubicBezTo>
                <a:cubicBezTo>
                  <a:pt x="1" y="103"/>
                  <a:pt x="0" y="117"/>
                  <a:pt x="3" y="134"/>
                </a:cubicBezTo>
                <a:cubicBezTo>
                  <a:pt x="8" y="157"/>
                  <a:pt x="22" y="186"/>
                  <a:pt x="54" y="203"/>
                </a:cubicBezTo>
                <a:cubicBezTo>
                  <a:pt x="87" y="221"/>
                  <a:pt x="120" y="216"/>
                  <a:pt x="139" y="208"/>
                </a:cubicBezTo>
                <a:cubicBezTo>
                  <a:pt x="153" y="202"/>
                  <a:pt x="157" y="198"/>
                  <a:pt x="159" y="196"/>
                </a:cubicBezTo>
                <a:cubicBezTo>
                  <a:pt x="160" y="196"/>
                  <a:pt x="161" y="195"/>
                  <a:pt x="161" y="195"/>
                </a:cubicBezTo>
                <a:cubicBezTo>
                  <a:pt x="162" y="194"/>
                  <a:pt x="162" y="194"/>
                  <a:pt x="162" y="194"/>
                </a:cubicBezTo>
                <a:cubicBezTo>
                  <a:pt x="162" y="194"/>
                  <a:pt x="162" y="194"/>
                  <a:pt x="162" y="194"/>
                </a:cubicBezTo>
                <a:cubicBezTo>
                  <a:pt x="162" y="194"/>
                  <a:pt x="162" y="194"/>
                  <a:pt x="161" y="194"/>
                </a:cubicBezTo>
                <a:cubicBezTo>
                  <a:pt x="160" y="195"/>
                  <a:pt x="146" y="201"/>
                  <a:pt x="129" y="203"/>
                </a:cubicBezTo>
                <a:cubicBezTo>
                  <a:pt x="111" y="205"/>
                  <a:pt x="87" y="204"/>
                  <a:pt x="62" y="191"/>
                </a:cubicBezTo>
                <a:cubicBezTo>
                  <a:pt x="36" y="178"/>
                  <a:pt x="19" y="158"/>
                  <a:pt x="10" y="139"/>
                </a:cubicBezTo>
                <a:cubicBezTo>
                  <a:pt x="1" y="120"/>
                  <a:pt x="2" y="103"/>
                  <a:pt x="2" y="102"/>
                </a:cubicBezTo>
                <a:cubicBezTo>
                  <a:pt x="2" y="101"/>
                  <a:pt x="2" y="101"/>
                  <a:pt x="2" y="101"/>
                </a:cubicBezTo>
                <a:cubicBezTo>
                  <a:pt x="2" y="101"/>
                  <a:pt x="2" y="101"/>
                  <a:pt x="2" y="101"/>
                </a:cubicBezTo>
                <a:cubicBezTo>
                  <a:pt x="2" y="101"/>
                  <a:pt x="1" y="101"/>
                  <a:pt x="1" y="101"/>
                </a:cubicBezTo>
                <a:close/>
                <a:moveTo>
                  <a:pt x="108" y="133"/>
                </a:moveTo>
                <a:cubicBezTo>
                  <a:pt x="108" y="108"/>
                  <a:pt x="108" y="108"/>
                  <a:pt x="108" y="108"/>
                </a:cubicBezTo>
                <a:cubicBezTo>
                  <a:pt x="91" y="70"/>
                  <a:pt x="91" y="70"/>
                  <a:pt x="91" y="70"/>
                </a:cubicBezTo>
                <a:cubicBezTo>
                  <a:pt x="105" y="70"/>
                  <a:pt x="105" y="70"/>
                  <a:pt x="105" y="70"/>
                </a:cubicBezTo>
                <a:cubicBezTo>
                  <a:pt x="116" y="95"/>
                  <a:pt x="116" y="95"/>
                  <a:pt x="116" y="95"/>
                </a:cubicBezTo>
                <a:cubicBezTo>
                  <a:pt x="127" y="70"/>
                  <a:pt x="127" y="70"/>
                  <a:pt x="127" y="70"/>
                </a:cubicBezTo>
                <a:cubicBezTo>
                  <a:pt x="140" y="70"/>
                  <a:pt x="140" y="70"/>
                  <a:pt x="140" y="70"/>
                </a:cubicBezTo>
                <a:cubicBezTo>
                  <a:pt x="123" y="108"/>
                  <a:pt x="123" y="108"/>
                  <a:pt x="123" y="108"/>
                </a:cubicBezTo>
                <a:cubicBezTo>
                  <a:pt x="123" y="133"/>
                  <a:pt x="123" y="133"/>
                  <a:pt x="123" y="133"/>
                </a:cubicBezTo>
                <a:lnTo>
                  <a:pt x="108" y="133"/>
                </a:lnTo>
                <a:close/>
                <a:moveTo>
                  <a:pt x="241" y="133"/>
                </a:moveTo>
                <a:cubicBezTo>
                  <a:pt x="208" y="133"/>
                  <a:pt x="208" y="133"/>
                  <a:pt x="208" y="133"/>
                </a:cubicBezTo>
                <a:cubicBezTo>
                  <a:pt x="208" y="70"/>
                  <a:pt x="208" y="70"/>
                  <a:pt x="208" y="70"/>
                </a:cubicBezTo>
                <a:cubicBezTo>
                  <a:pt x="222" y="70"/>
                  <a:pt x="222" y="70"/>
                  <a:pt x="222" y="70"/>
                </a:cubicBezTo>
                <a:cubicBezTo>
                  <a:pt x="222" y="121"/>
                  <a:pt x="222" y="121"/>
                  <a:pt x="222" y="121"/>
                </a:cubicBezTo>
                <a:cubicBezTo>
                  <a:pt x="241" y="121"/>
                  <a:pt x="241" y="121"/>
                  <a:pt x="241" y="121"/>
                </a:cubicBezTo>
                <a:lnTo>
                  <a:pt x="241" y="133"/>
                </a:lnTo>
                <a:close/>
                <a:moveTo>
                  <a:pt x="73" y="70"/>
                </a:moveTo>
                <a:cubicBezTo>
                  <a:pt x="86" y="70"/>
                  <a:pt x="86" y="70"/>
                  <a:pt x="86" y="70"/>
                </a:cubicBezTo>
                <a:cubicBezTo>
                  <a:pt x="86" y="133"/>
                  <a:pt x="86" y="133"/>
                  <a:pt x="86" y="133"/>
                </a:cubicBezTo>
                <a:cubicBezTo>
                  <a:pt x="73" y="133"/>
                  <a:pt x="73" y="133"/>
                  <a:pt x="73" y="133"/>
                </a:cubicBezTo>
                <a:cubicBezTo>
                  <a:pt x="73" y="133"/>
                  <a:pt x="73" y="133"/>
                  <a:pt x="73" y="133"/>
                </a:cubicBezTo>
                <a:cubicBezTo>
                  <a:pt x="73" y="131"/>
                  <a:pt x="57" y="104"/>
                  <a:pt x="53" y="96"/>
                </a:cubicBezTo>
                <a:cubicBezTo>
                  <a:pt x="53" y="133"/>
                  <a:pt x="53" y="133"/>
                  <a:pt x="53" y="133"/>
                </a:cubicBezTo>
                <a:cubicBezTo>
                  <a:pt x="40" y="133"/>
                  <a:pt x="40" y="133"/>
                  <a:pt x="40" y="133"/>
                </a:cubicBezTo>
                <a:cubicBezTo>
                  <a:pt x="40" y="70"/>
                  <a:pt x="40" y="70"/>
                  <a:pt x="40" y="70"/>
                </a:cubicBezTo>
                <a:cubicBezTo>
                  <a:pt x="54" y="70"/>
                  <a:pt x="54" y="70"/>
                  <a:pt x="54" y="70"/>
                </a:cubicBezTo>
                <a:cubicBezTo>
                  <a:pt x="54" y="70"/>
                  <a:pt x="54" y="70"/>
                  <a:pt x="54" y="70"/>
                </a:cubicBezTo>
                <a:cubicBezTo>
                  <a:pt x="55" y="71"/>
                  <a:pt x="69" y="97"/>
                  <a:pt x="73" y="106"/>
                </a:cubicBezTo>
                <a:lnTo>
                  <a:pt x="73" y="70"/>
                </a:lnTo>
                <a:close/>
                <a:moveTo>
                  <a:pt x="166" y="134"/>
                </a:moveTo>
                <a:cubicBezTo>
                  <a:pt x="152" y="134"/>
                  <a:pt x="144" y="126"/>
                  <a:pt x="144" y="111"/>
                </a:cubicBezTo>
                <a:cubicBezTo>
                  <a:pt x="144" y="70"/>
                  <a:pt x="144" y="70"/>
                  <a:pt x="144" y="70"/>
                </a:cubicBezTo>
                <a:cubicBezTo>
                  <a:pt x="158" y="70"/>
                  <a:pt x="158" y="70"/>
                  <a:pt x="158" y="70"/>
                </a:cubicBezTo>
                <a:cubicBezTo>
                  <a:pt x="158" y="110"/>
                  <a:pt x="158" y="110"/>
                  <a:pt x="158" y="110"/>
                </a:cubicBezTo>
                <a:cubicBezTo>
                  <a:pt x="158" y="119"/>
                  <a:pt x="161" y="122"/>
                  <a:pt x="167" y="122"/>
                </a:cubicBezTo>
                <a:cubicBezTo>
                  <a:pt x="172" y="122"/>
                  <a:pt x="175" y="118"/>
                  <a:pt x="175" y="110"/>
                </a:cubicBezTo>
                <a:cubicBezTo>
                  <a:pt x="175" y="70"/>
                  <a:pt x="175" y="70"/>
                  <a:pt x="175" y="70"/>
                </a:cubicBezTo>
                <a:cubicBezTo>
                  <a:pt x="188" y="70"/>
                  <a:pt x="188" y="70"/>
                  <a:pt x="188" y="70"/>
                </a:cubicBezTo>
                <a:cubicBezTo>
                  <a:pt x="188" y="111"/>
                  <a:pt x="188" y="111"/>
                  <a:pt x="188" y="111"/>
                </a:cubicBezTo>
                <a:cubicBezTo>
                  <a:pt x="188" y="126"/>
                  <a:pt x="181" y="134"/>
                  <a:pt x="166" y="134"/>
                </a:cubicBezTo>
                <a:close/>
                <a:moveTo>
                  <a:pt x="259" y="199"/>
                </a:moveTo>
                <a:cubicBezTo>
                  <a:pt x="267" y="206"/>
                  <a:pt x="267" y="206"/>
                  <a:pt x="267" y="206"/>
                </a:cubicBezTo>
                <a:cubicBezTo>
                  <a:pt x="267" y="206"/>
                  <a:pt x="267" y="206"/>
                  <a:pt x="267" y="206"/>
                </a:cubicBezTo>
                <a:cubicBezTo>
                  <a:pt x="263" y="213"/>
                  <a:pt x="257" y="216"/>
                  <a:pt x="249" y="216"/>
                </a:cubicBezTo>
                <a:cubicBezTo>
                  <a:pt x="236" y="216"/>
                  <a:pt x="229" y="207"/>
                  <a:pt x="229" y="192"/>
                </a:cubicBezTo>
                <a:cubicBezTo>
                  <a:pt x="229" y="174"/>
                  <a:pt x="239" y="168"/>
                  <a:pt x="249" y="168"/>
                </a:cubicBezTo>
                <a:cubicBezTo>
                  <a:pt x="261" y="168"/>
                  <a:pt x="267" y="177"/>
                  <a:pt x="267" y="193"/>
                </a:cubicBezTo>
                <a:cubicBezTo>
                  <a:pt x="267" y="196"/>
                  <a:pt x="267" y="196"/>
                  <a:pt x="267" y="196"/>
                </a:cubicBezTo>
                <a:cubicBezTo>
                  <a:pt x="242" y="196"/>
                  <a:pt x="242" y="196"/>
                  <a:pt x="242" y="196"/>
                </a:cubicBezTo>
                <a:cubicBezTo>
                  <a:pt x="243" y="202"/>
                  <a:pt x="245" y="205"/>
                  <a:pt x="250" y="205"/>
                </a:cubicBezTo>
                <a:cubicBezTo>
                  <a:pt x="254" y="205"/>
                  <a:pt x="257" y="202"/>
                  <a:pt x="259" y="200"/>
                </a:cubicBezTo>
                <a:lnTo>
                  <a:pt x="259" y="199"/>
                </a:lnTo>
                <a:close/>
                <a:moveTo>
                  <a:pt x="242" y="187"/>
                </a:moveTo>
                <a:cubicBezTo>
                  <a:pt x="255" y="187"/>
                  <a:pt x="255" y="187"/>
                  <a:pt x="255" y="187"/>
                </a:cubicBezTo>
                <a:cubicBezTo>
                  <a:pt x="254" y="179"/>
                  <a:pt x="250" y="179"/>
                  <a:pt x="249" y="179"/>
                </a:cubicBezTo>
                <a:cubicBezTo>
                  <a:pt x="245" y="179"/>
                  <a:pt x="243" y="182"/>
                  <a:pt x="242" y="187"/>
                </a:cubicBezTo>
                <a:close/>
                <a:moveTo>
                  <a:pt x="416" y="92"/>
                </a:moveTo>
                <a:cubicBezTo>
                  <a:pt x="420" y="96"/>
                  <a:pt x="422" y="102"/>
                  <a:pt x="422" y="110"/>
                </a:cubicBezTo>
                <a:cubicBezTo>
                  <a:pt x="422" y="128"/>
                  <a:pt x="412" y="134"/>
                  <a:pt x="402" y="134"/>
                </a:cubicBezTo>
                <a:cubicBezTo>
                  <a:pt x="392" y="134"/>
                  <a:pt x="382" y="128"/>
                  <a:pt x="382" y="110"/>
                </a:cubicBezTo>
                <a:cubicBezTo>
                  <a:pt x="382" y="102"/>
                  <a:pt x="384" y="96"/>
                  <a:pt x="388" y="92"/>
                </a:cubicBezTo>
                <a:cubicBezTo>
                  <a:pt x="392" y="88"/>
                  <a:pt x="396" y="86"/>
                  <a:pt x="402" y="86"/>
                </a:cubicBezTo>
                <a:cubicBezTo>
                  <a:pt x="408" y="86"/>
                  <a:pt x="413" y="88"/>
                  <a:pt x="416" y="92"/>
                </a:cubicBezTo>
                <a:close/>
                <a:moveTo>
                  <a:pt x="409" y="110"/>
                </a:moveTo>
                <a:cubicBezTo>
                  <a:pt x="409" y="99"/>
                  <a:pt x="405" y="97"/>
                  <a:pt x="402" y="97"/>
                </a:cubicBezTo>
                <a:cubicBezTo>
                  <a:pt x="398" y="97"/>
                  <a:pt x="396" y="101"/>
                  <a:pt x="396" y="110"/>
                </a:cubicBezTo>
                <a:cubicBezTo>
                  <a:pt x="396" y="122"/>
                  <a:pt x="399" y="123"/>
                  <a:pt x="402" y="123"/>
                </a:cubicBezTo>
                <a:cubicBezTo>
                  <a:pt x="407" y="123"/>
                  <a:pt x="409" y="119"/>
                  <a:pt x="409" y="110"/>
                </a:cubicBezTo>
                <a:close/>
                <a:moveTo>
                  <a:pt x="410" y="180"/>
                </a:moveTo>
                <a:cubicBezTo>
                  <a:pt x="410" y="215"/>
                  <a:pt x="410" y="215"/>
                  <a:pt x="410" y="215"/>
                </a:cubicBezTo>
                <a:cubicBezTo>
                  <a:pt x="397" y="215"/>
                  <a:pt x="397" y="215"/>
                  <a:pt x="397" y="215"/>
                </a:cubicBezTo>
                <a:cubicBezTo>
                  <a:pt x="397" y="184"/>
                  <a:pt x="397" y="184"/>
                  <a:pt x="397" y="184"/>
                </a:cubicBezTo>
                <a:cubicBezTo>
                  <a:pt x="397" y="180"/>
                  <a:pt x="395" y="180"/>
                  <a:pt x="393" y="180"/>
                </a:cubicBezTo>
                <a:cubicBezTo>
                  <a:pt x="391" y="180"/>
                  <a:pt x="389" y="181"/>
                  <a:pt x="386" y="183"/>
                </a:cubicBezTo>
                <a:cubicBezTo>
                  <a:pt x="386" y="215"/>
                  <a:pt x="386" y="215"/>
                  <a:pt x="386" y="215"/>
                </a:cubicBezTo>
                <a:cubicBezTo>
                  <a:pt x="373" y="215"/>
                  <a:pt x="373" y="215"/>
                  <a:pt x="373" y="215"/>
                </a:cubicBezTo>
                <a:cubicBezTo>
                  <a:pt x="373" y="152"/>
                  <a:pt x="373" y="152"/>
                  <a:pt x="373" y="152"/>
                </a:cubicBezTo>
                <a:cubicBezTo>
                  <a:pt x="386" y="150"/>
                  <a:pt x="386" y="150"/>
                  <a:pt x="386" y="150"/>
                </a:cubicBezTo>
                <a:cubicBezTo>
                  <a:pt x="386" y="174"/>
                  <a:pt x="386" y="174"/>
                  <a:pt x="386" y="174"/>
                </a:cubicBezTo>
                <a:cubicBezTo>
                  <a:pt x="389" y="171"/>
                  <a:pt x="393" y="168"/>
                  <a:pt x="399" y="168"/>
                </a:cubicBezTo>
                <a:cubicBezTo>
                  <a:pt x="406" y="168"/>
                  <a:pt x="410" y="172"/>
                  <a:pt x="410" y="180"/>
                </a:cubicBezTo>
                <a:close/>
                <a:moveTo>
                  <a:pt x="511" y="124"/>
                </a:moveTo>
                <a:cubicBezTo>
                  <a:pt x="511" y="124"/>
                  <a:pt x="511" y="124"/>
                  <a:pt x="511" y="124"/>
                </a:cubicBezTo>
                <a:cubicBezTo>
                  <a:pt x="507" y="131"/>
                  <a:pt x="501" y="134"/>
                  <a:pt x="493" y="134"/>
                </a:cubicBezTo>
                <a:cubicBezTo>
                  <a:pt x="480" y="134"/>
                  <a:pt x="473" y="125"/>
                  <a:pt x="473" y="110"/>
                </a:cubicBezTo>
                <a:cubicBezTo>
                  <a:pt x="473" y="92"/>
                  <a:pt x="484" y="86"/>
                  <a:pt x="493" y="86"/>
                </a:cubicBezTo>
                <a:cubicBezTo>
                  <a:pt x="505" y="86"/>
                  <a:pt x="511" y="95"/>
                  <a:pt x="511" y="111"/>
                </a:cubicBezTo>
                <a:cubicBezTo>
                  <a:pt x="511" y="114"/>
                  <a:pt x="511" y="114"/>
                  <a:pt x="511" y="114"/>
                </a:cubicBezTo>
                <a:cubicBezTo>
                  <a:pt x="486" y="114"/>
                  <a:pt x="486" y="114"/>
                  <a:pt x="486" y="114"/>
                </a:cubicBezTo>
                <a:cubicBezTo>
                  <a:pt x="487" y="120"/>
                  <a:pt x="489" y="123"/>
                  <a:pt x="494" y="123"/>
                </a:cubicBezTo>
                <a:cubicBezTo>
                  <a:pt x="498" y="123"/>
                  <a:pt x="501" y="120"/>
                  <a:pt x="503" y="118"/>
                </a:cubicBezTo>
                <a:cubicBezTo>
                  <a:pt x="503" y="117"/>
                  <a:pt x="503" y="117"/>
                  <a:pt x="503" y="117"/>
                </a:cubicBezTo>
                <a:lnTo>
                  <a:pt x="511" y="124"/>
                </a:lnTo>
                <a:close/>
                <a:moveTo>
                  <a:pt x="487" y="105"/>
                </a:moveTo>
                <a:cubicBezTo>
                  <a:pt x="499" y="105"/>
                  <a:pt x="499" y="105"/>
                  <a:pt x="499" y="105"/>
                </a:cubicBezTo>
                <a:cubicBezTo>
                  <a:pt x="498" y="97"/>
                  <a:pt x="494" y="97"/>
                  <a:pt x="493" y="97"/>
                </a:cubicBezTo>
                <a:cubicBezTo>
                  <a:pt x="489" y="97"/>
                  <a:pt x="487" y="100"/>
                  <a:pt x="487" y="105"/>
                </a:cubicBezTo>
                <a:close/>
                <a:moveTo>
                  <a:pt x="467" y="98"/>
                </a:moveTo>
                <a:cubicBezTo>
                  <a:pt x="467" y="133"/>
                  <a:pt x="467" y="133"/>
                  <a:pt x="467" y="133"/>
                </a:cubicBezTo>
                <a:cubicBezTo>
                  <a:pt x="453" y="133"/>
                  <a:pt x="453" y="133"/>
                  <a:pt x="453" y="133"/>
                </a:cubicBezTo>
                <a:cubicBezTo>
                  <a:pt x="453" y="102"/>
                  <a:pt x="453" y="102"/>
                  <a:pt x="453" y="102"/>
                </a:cubicBezTo>
                <a:cubicBezTo>
                  <a:pt x="453" y="98"/>
                  <a:pt x="452" y="98"/>
                  <a:pt x="450" y="98"/>
                </a:cubicBezTo>
                <a:cubicBezTo>
                  <a:pt x="448" y="98"/>
                  <a:pt x="445" y="99"/>
                  <a:pt x="443" y="102"/>
                </a:cubicBezTo>
                <a:cubicBezTo>
                  <a:pt x="443" y="133"/>
                  <a:pt x="443" y="133"/>
                  <a:pt x="443" y="133"/>
                </a:cubicBezTo>
                <a:cubicBezTo>
                  <a:pt x="429" y="133"/>
                  <a:pt x="429" y="133"/>
                  <a:pt x="429" y="133"/>
                </a:cubicBezTo>
                <a:cubicBezTo>
                  <a:pt x="429" y="87"/>
                  <a:pt x="429" y="87"/>
                  <a:pt x="429" y="87"/>
                </a:cubicBezTo>
                <a:cubicBezTo>
                  <a:pt x="443" y="87"/>
                  <a:pt x="443" y="87"/>
                  <a:pt x="443" y="87"/>
                </a:cubicBezTo>
                <a:cubicBezTo>
                  <a:pt x="443" y="92"/>
                  <a:pt x="443" y="92"/>
                  <a:pt x="443" y="92"/>
                </a:cubicBezTo>
                <a:cubicBezTo>
                  <a:pt x="445" y="89"/>
                  <a:pt x="450" y="86"/>
                  <a:pt x="455" y="86"/>
                </a:cubicBezTo>
                <a:cubicBezTo>
                  <a:pt x="463" y="86"/>
                  <a:pt x="467" y="90"/>
                  <a:pt x="467" y="98"/>
                </a:cubicBezTo>
                <a:close/>
                <a:moveTo>
                  <a:pt x="357" y="169"/>
                </a:moveTo>
                <a:cubicBezTo>
                  <a:pt x="366" y="169"/>
                  <a:pt x="366" y="169"/>
                  <a:pt x="366" y="169"/>
                </a:cubicBezTo>
                <a:cubicBezTo>
                  <a:pt x="366" y="179"/>
                  <a:pt x="366" y="179"/>
                  <a:pt x="366" y="179"/>
                </a:cubicBezTo>
                <a:cubicBezTo>
                  <a:pt x="357" y="179"/>
                  <a:pt x="357" y="179"/>
                  <a:pt x="357" y="179"/>
                </a:cubicBezTo>
                <a:cubicBezTo>
                  <a:pt x="357" y="200"/>
                  <a:pt x="357" y="200"/>
                  <a:pt x="357" y="200"/>
                </a:cubicBezTo>
                <a:cubicBezTo>
                  <a:pt x="357" y="204"/>
                  <a:pt x="358" y="205"/>
                  <a:pt x="361" y="205"/>
                </a:cubicBezTo>
                <a:cubicBezTo>
                  <a:pt x="363" y="205"/>
                  <a:pt x="364" y="205"/>
                  <a:pt x="365" y="205"/>
                </a:cubicBezTo>
                <a:cubicBezTo>
                  <a:pt x="366" y="204"/>
                  <a:pt x="366" y="204"/>
                  <a:pt x="366" y="204"/>
                </a:cubicBezTo>
                <a:cubicBezTo>
                  <a:pt x="366" y="215"/>
                  <a:pt x="366" y="215"/>
                  <a:pt x="366" y="215"/>
                </a:cubicBezTo>
                <a:cubicBezTo>
                  <a:pt x="365" y="215"/>
                  <a:pt x="365" y="215"/>
                  <a:pt x="365" y="215"/>
                </a:cubicBezTo>
                <a:cubicBezTo>
                  <a:pt x="364" y="215"/>
                  <a:pt x="360" y="215"/>
                  <a:pt x="357" y="215"/>
                </a:cubicBezTo>
                <a:cubicBezTo>
                  <a:pt x="347" y="215"/>
                  <a:pt x="343" y="212"/>
                  <a:pt x="343" y="203"/>
                </a:cubicBezTo>
                <a:cubicBezTo>
                  <a:pt x="343" y="179"/>
                  <a:pt x="343" y="179"/>
                  <a:pt x="343" y="179"/>
                </a:cubicBezTo>
                <a:cubicBezTo>
                  <a:pt x="337" y="179"/>
                  <a:pt x="337" y="179"/>
                  <a:pt x="337" y="179"/>
                </a:cubicBezTo>
                <a:cubicBezTo>
                  <a:pt x="337" y="169"/>
                  <a:pt x="337" y="169"/>
                  <a:pt x="337" y="169"/>
                </a:cubicBezTo>
                <a:cubicBezTo>
                  <a:pt x="343" y="169"/>
                  <a:pt x="343" y="169"/>
                  <a:pt x="343" y="169"/>
                </a:cubicBezTo>
                <a:cubicBezTo>
                  <a:pt x="343" y="156"/>
                  <a:pt x="343" y="156"/>
                  <a:pt x="343" y="156"/>
                </a:cubicBezTo>
                <a:cubicBezTo>
                  <a:pt x="357" y="154"/>
                  <a:pt x="357" y="154"/>
                  <a:pt x="357" y="154"/>
                </a:cubicBezTo>
                <a:lnTo>
                  <a:pt x="357" y="169"/>
                </a:lnTo>
                <a:close/>
                <a:moveTo>
                  <a:pt x="332" y="98"/>
                </a:moveTo>
                <a:cubicBezTo>
                  <a:pt x="332" y="133"/>
                  <a:pt x="332" y="133"/>
                  <a:pt x="332" y="133"/>
                </a:cubicBezTo>
                <a:cubicBezTo>
                  <a:pt x="318" y="133"/>
                  <a:pt x="318" y="133"/>
                  <a:pt x="318" y="133"/>
                </a:cubicBezTo>
                <a:cubicBezTo>
                  <a:pt x="318" y="102"/>
                  <a:pt x="318" y="102"/>
                  <a:pt x="318" y="102"/>
                </a:cubicBezTo>
                <a:cubicBezTo>
                  <a:pt x="318" y="98"/>
                  <a:pt x="316" y="98"/>
                  <a:pt x="315" y="98"/>
                </a:cubicBezTo>
                <a:cubicBezTo>
                  <a:pt x="313" y="98"/>
                  <a:pt x="310" y="99"/>
                  <a:pt x="307" y="102"/>
                </a:cubicBezTo>
                <a:cubicBezTo>
                  <a:pt x="307" y="133"/>
                  <a:pt x="307" y="133"/>
                  <a:pt x="307" y="133"/>
                </a:cubicBezTo>
                <a:cubicBezTo>
                  <a:pt x="294" y="133"/>
                  <a:pt x="294" y="133"/>
                  <a:pt x="294" y="133"/>
                </a:cubicBezTo>
                <a:cubicBezTo>
                  <a:pt x="294" y="87"/>
                  <a:pt x="294" y="87"/>
                  <a:pt x="294" y="87"/>
                </a:cubicBezTo>
                <a:cubicBezTo>
                  <a:pt x="307" y="87"/>
                  <a:pt x="307" y="87"/>
                  <a:pt x="307" y="87"/>
                </a:cubicBezTo>
                <a:cubicBezTo>
                  <a:pt x="307" y="92"/>
                  <a:pt x="307" y="92"/>
                  <a:pt x="307" y="92"/>
                </a:cubicBezTo>
                <a:cubicBezTo>
                  <a:pt x="310" y="89"/>
                  <a:pt x="315" y="86"/>
                  <a:pt x="320" y="86"/>
                </a:cubicBezTo>
                <a:cubicBezTo>
                  <a:pt x="328" y="86"/>
                  <a:pt x="332" y="90"/>
                  <a:pt x="332" y="98"/>
                </a:cubicBezTo>
                <a:close/>
                <a:moveTo>
                  <a:pt x="272" y="132"/>
                </a:moveTo>
                <a:cubicBezTo>
                  <a:pt x="272" y="131"/>
                  <a:pt x="271" y="130"/>
                  <a:pt x="271" y="128"/>
                </a:cubicBezTo>
                <a:cubicBezTo>
                  <a:pt x="268" y="132"/>
                  <a:pt x="264" y="133"/>
                  <a:pt x="259" y="133"/>
                </a:cubicBezTo>
                <a:cubicBezTo>
                  <a:pt x="251" y="133"/>
                  <a:pt x="247" y="129"/>
                  <a:pt x="247" y="121"/>
                </a:cubicBezTo>
                <a:cubicBezTo>
                  <a:pt x="247" y="112"/>
                  <a:pt x="255" y="106"/>
                  <a:pt x="271" y="103"/>
                </a:cubicBezTo>
                <a:cubicBezTo>
                  <a:pt x="271" y="102"/>
                  <a:pt x="271" y="102"/>
                  <a:pt x="271" y="102"/>
                </a:cubicBezTo>
                <a:cubicBezTo>
                  <a:pt x="271" y="98"/>
                  <a:pt x="270" y="97"/>
                  <a:pt x="267" y="97"/>
                </a:cubicBezTo>
                <a:cubicBezTo>
                  <a:pt x="263" y="97"/>
                  <a:pt x="258" y="100"/>
                  <a:pt x="256" y="102"/>
                </a:cubicBezTo>
                <a:cubicBezTo>
                  <a:pt x="255" y="102"/>
                  <a:pt x="255" y="102"/>
                  <a:pt x="255" y="102"/>
                </a:cubicBezTo>
                <a:cubicBezTo>
                  <a:pt x="249" y="94"/>
                  <a:pt x="249" y="94"/>
                  <a:pt x="249" y="94"/>
                </a:cubicBezTo>
                <a:cubicBezTo>
                  <a:pt x="249" y="93"/>
                  <a:pt x="249" y="93"/>
                  <a:pt x="249" y="93"/>
                </a:cubicBezTo>
                <a:cubicBezTo>
                  <a:pt x="255" y="89"/>
                  <a:pt x="262" y="86"/>
                  <a:pt x="270" y="86"/>
                </a:cubicBezTo>
                <a:cubicBezTo>
                  <a:pt x="280" y="86"/>
                  <a:pt x="285" y="91"/>
                  <a:pt x="285" y="102"/>
                </a:cubicBezTo>
                <a:cubicBezTo>
                  <a:pt x="285" y="121"/>
                  <a:pt x="285" y="121"/>
                  <a:pt x="285" y="121"/>
                </a:cubicBezTo>
                <a:cubicBezTo>
                  <a:pt x="285" y="127"/>
                  <a:pt x="285" y="130"/>
                  <a:pt x="286" y="132"/>
                </a:cubicBezTo>
                <a:cubicBezTo>
                  <a:pt x="286" y="133"/>
                  <a:pt x="286" y="133"/>
                  <a:pt x="286" y="133"/>
                </a:cubicBezTo>
                <a:cubicBezTo>
                  <a:pt x="272" y="133"/>
                  <a:pt x="272" y="133"/>
                  <a:pt x="272" y="133"/>
                </a:cubicBezTo>
                <a:lnTo>
                  <a:pt x="272" y="132"/>
                </a:lnTo>
                <a:close/>
                <a:moveTo>
                  <a:pt x="271" y="111"/>
                </a:moveTo>
                <a:cubicBezTo>
                  <a:pt x="262" y="113"/>
                  <a:pt x="261" y="116"/>
                  <a:pt x="261" y="119"/>
                </a:cubicBezTo>
                <a:cubicBezTo>
                  <a:pt x="261" y="121"/>
                  <a:pt x="262" y="123"/>
                  <a:pt x="264" y="123"/>
                </a:cubicBezTo>
                <a:cubicBezTo>
                  <a:pt x="267" y="123"/>
                  <a:pt x="269" y="122"/>
                  <a:pt x="271" y="120"/>
                </a:cubicBezTo>
                <a:lnTo>
                  <a:pt x="271" y="111"/>
                </a:lnTo>
                <a:close/>
                <a:moveTo>
                  <a:pt x="310" y="214"/>
                </a:moveTo>
                <a:cubicBezTo>
                  <a:pt x="311" y="215"/>
                  <a:pt x="311" y="215"/>
                  <a:pt x="311" y="215"/>
                </a:cubicBezTo>
                <a:cubicBezTo>
                  <a:pt x="297" y="215"/>
                  <a:pt x="297" y="215"/>
                  <a:pt x="297" y="215"/>
                </a:cubicBezTo>
                <a:cubicBezTo>
                  <a:pt x="297" y="214"/>
                  <a:pt x="297" y="214"/>
                  <a:pt x="297" y="214"/>
                </a:cubicBezTo>
                <a:cubicBezTo>
                  <a:pt x="296" y="213"/>
                  <a:pt x="296" y="212"/>
                  <a:pt x="296" y="210"/>
                </a:cubicBezTo>
                <a:cubicBezTo>
                  <a:pt x="293" y="214"/>
                  <a:pt x="289" y="215"/>
                  <a:pt x="283" y="215"/>
                </a:cubicBezTo>
                <a:cubicBezTo>
                  <a:pt x="276" y="215"/>
                  <a:pt x="272" y="211"/>
                  <a:pt x="272" y="203"/>
                </a:cubicBezTo>
                <a:cubicBezTo>
                  <a:pt x="272" y="194"/>
                  <a:pt x="280" y="188"/>
                  <a:pt x="296" y="185"/>
                </a:cubicBezTo>
                <a:cubicBezTo>
                  <a:pt x="296" y="183"/>
                  <a:pt x="296" y="183"/>
                  <a:pt x="296" y="183"/>
                </a:cubicBezTo>
                <a:cubicBezTo>
                  <a:pt x="296" y="180"/>
                  <a:pt x="295" y="179"/>
                  <a:pt x="292" y="179"/>
                </a:cubicBezTo>
                <a:cubicBezTo>
                  <a:pt x="287" y="179"/>
                  <a:pt x="283" y="182"/>
                  <a:pt x="280" y="184"/>
                </a:cubicBezTo>
                <a:cubicBezTo>
                  <a:pt x="280" y="184"/>
                  <a:pt x="280" y="184"/>
                  <a:pt x="280" y="184"/>
                </a:cubicBezTo>
                <a:cubicBezTo>
                  <a:pt x="273" y="176"/>
                  <a:pt x="273" y="176"/>
                  <a:pt x="273" y="176"/>
                </a:cubicBezTo>
                <a:cubicBezTo>
                  <a:pt x="274" y="175"/>
                  <a:pt x="274" y="175"/>
                  <a:pt x="274" y="175"/>
                </a:cubicBezTo>
                <a:cubicBezTo>
                  <a:pt x="279" y="171"/>
                  <a:pt x="286" y="168"/>
                  <a:pt x="294" y="168"/>
                </a:cubicBezTo>
                <a:cubicBezTo>
                  <a:pt x="305" y="168"/>
                  <a:pt x="309" y="173"/>
                  <a:pt x="309" y="183"/>
                </a:cubicBezTo>
                <a:cubicBezTo>
                  <a:pt x="309" y="203"/>
                  <a:pt x="309" y="203"/>
                  <a:pt x="309" y="203"/>
                </a:cubicBezTo>
                <a:cubicBezTo>
                  <a:pt x="309" y="209"/>
                  <a:pt x="310" y="212"/>
                  <a:pt x="310" y="214"/>
                </a:cubicBezTo>
                <a:close/>
                <a:moveTo>
                  <a:pt x="296" y="193"/>
                </a:moveTo>
                <a:cubicBezTo>
                  <a:pt x="286" y="195"/>
                  <a:pt x="285" y="198"/>
                  <a:pt x="285" y="201"/>
                </a:cubicBezTo>
                <a:cubicBezTo>
                  <a:pt x="285" y="203"/>
                  <a:pt x="286" y="205"/>
                  <a:pt x="289" y="205"/>
                </a:cubicBezTo>
                <a:cubicBezTo>
                  <a:pt x="291" y="205"/>
                  <a:pt x="294" y="204"/>
                  <a:pt x="296" y="201"/>
                </a:cubicBezTo>
                <a:lnTo>
                  <a:pt x="296" y="193"/>
                </a:lnTo>
                <a:close/>
                <a:moveTo>
                  <a:pt x="318" y="159"/>
                </a:moveTo>
                <a:cubicBezTo>
                  <a:pt x="332" y="157"/>
                  <a:pt x="332" y="157"/>
                  <a:pt x="332" y="157"/>
                </a:cubicBezTo>
                <a:cubicBezTo>
                  <a:pt x="332" y="215"/>
                  <a:pt x="332" y="215"/>
                  <a:pt x="332" y="215"/>
                </a:cubicBezTo>
                <a:cubicBezTo>
                  <a:pt x="318" y="215"/>
                  <a:pt x="318" y="215"/>
                  <a:pt x="318" y="215"/>
                </a:cubicBezTo>
                <a:lnTo>
                  <a:pt x="318" y="159"/>
                </a:lnTo>
                <a:close/>
                <a:moveTo>
                  <a:pt x="208" y="153"/>
                </a:moveTo>
                <a:cubicBezTo>
                  <a:pt x="222" y="153"/>
                  <a:pt x="222" y="153"/>
                  <a:pt x="222" y="153"/>
                </a:cubicBezTo>
                <a:cubicBezTo>
                  <a:pt x="222" y="215"/>
                  <a:pt x="222" y="215"/>
                  <a:pt x="222" y="215"/>
                </a:cubicBezTo>
                <a:cubicBezTo>
                  <a:pt x="208" y="215"/>
                  <a:pt x="208" y="215"/>
                  <a:pt x="208" y="215"/>
                </a:cubicBezTo>
                <a:cubicBezTo>
                  <a:pt x="208" y="188"/>
                  <a:pt x="208" y="188"/>
                  <a:pt x="208" y="188"/>
                </a:cubicBezTo>
                <a:cubicBezTo>
                  <a:pt x="188" y="188"/>
                  <a:pt x="188" y="188"/>
                  <a:pt x="188" y="188"/>
                </a:cubicBezTo>
                <a:cubicBezTo>
                  <a:pt x="188" y="215"/>
                  <a:pt x="188" y="215"/>
                  <a:pt x="188" y="215"/>
                </a:cubicBezTo>
                <a:cubicBezTo>
                  <a:pt x="174" y="215"/>
                  <a:pt x="174" y="215"/>
                  <a:pt x="174" y="215"/>
                </a:cubicBezTo>
                <a:cubicBezTo>
                  <a:pt x="174" y="153"/>
                  <a:pt x="174" y="153"/>
                  <a:pt x="174" y="153"/>
                </a:cubicBezTo>
                <a:cubicBezTo>
                  <a:pt x="188" y="153"/>
                  <a:pt x="188" y="153"/>
                  <a:pt x="188" y="153"/>
                </a:cubicBezTo>
                <a:cubicBezTo>
                  <a:pt x="188" y="176"/>
                  <a:pt x="188" y="176"/>
                  <a:pt x="188" y="176"/>
                </a:cubicBezTo>
                <a:cubicBezTo>
                  <a:pt x="208" y="176"/>
                  <a:pt x="208" y="176"/>
                  <a:pt x="208" y="176"/>
                </a:cubicBezTo>
                <a:lnTo>
                  <a:pt x="208" y="153"/>
                </a:lnTo>
                <a:close/>
                <a:moveTo>
                  <a:pt x="342" y="130"/>
                </a:moveTo>
                <a:cubicBezTo>
                  <a:pt x="340" y="129"/>
                  <a:pt x="339" y="127"/>
                  <a:pt x="339" y="124"/>
                </a:cubicBezTo>
                <a:cubicBezTo>
                  <a:pt x="339" y="122"/>
                  <a:pt x="341" y="118"/>
                  <a:pt x="345" y="116"/>
                </a:cubicBezTo>
                <a:cubicBezTo>
                  <a:pt x="341" y="113"/>
                  <a:pt x="339" y="108"/>
                  <a:pt x="339" y="103"/>
                </a:cubicBezTo>
                <a:cubicBezTo>
                  <a:pt x="339" y="93"/>
                  <a:pt x="346" y="86"/>
                  <a:pt x="357" y="86"/>
                </a:cubicBezTo>
                <a:cubicBezTo>
                  <a:pt x="362" y="86"/>
                  <a:pt x="367" y="88"/>
                  <a:pt x="370" y="90"/>
                </a:cubicBezTo>
                <a:cubicBezTo>
                  <a:pt x="372" y="88"/>
                  <a:pt x="376" y="86"/>
                  <a:pt x="379" y="86"/>
                </a:cubicBezTo>
                <a:cubicBezTo>
                  <a:pt x="380" y="86"/>
                  <a:pt x="380" y="86"/>
                  <a:pt x="380" y="86"/>
                </a:cubicBezTo>
                <a:cubicBezTo>
                  <a:pt x="380" y="98"/>
                  <a:pt x="380" y="98"/>
                  <a:pt x="380" y="98"/>
                </a:cubicBezTo>
                <a:cubicBezTo>
                  <a:pt x="379" y="98"/>
                  <a:pt x="379" y="98"/>
                  <a:pt x="379" y="98"/>
                </a:cubicBezTo>
                <a:cubicBezTo>
                  <a:pt x="378" y="98"/>
                  <a:pt x="376" y="98"/>
                  <a:pt x="374" y="98"/>
                </a:cubicBezTo>
                <a:cubicBezTo>
                  <a:pt x="375" y="100"/>
                  <a:pt x="375" y="101"/>
                  <a:pt x="375" y="103"/>
                </a:cubicBezTo>
                <a:cubicBezTo>
                  <a:pt x="375" y="113"/>
                  <a:pt x="368" y="120"/>
                  <a:pt x="357" y="120"/>
                </a:cubicBezTo>
                <a:cubicBezTo>
                  <a:pt x="355" y="120"/>
                  <a:pt x="353" y="119"/>
                  <a:pt x="351" y="119"/>
                </a:cubicBezTo>
                <a:cubicBezTo>
                  <a:pt x="351" y="120"/>
                  <a:pt x="351" y="120"/>
                  <a:pt x="351" y="120"/>
                </a:cubicBezTo>
                <a:cubicBezTo>
                  <a:pt x="351" y="121"/>
                  <a:pt x="351" y="122"/>
                  <a:pt x="354" y="122"/>
                </a:cubicBezTo>
                <a:cubicBezTo>
                  <a:pt x="360" y="123"/>
                  <a:pt x="360" y="123"/>
                  <a:pt x="360" y="123"/>
                </a:cubicBezTo>
                <a:cubicBezTo>
                  <a:pt x="374" y="124"/>
                  <a:pt x="379" y="127"/>
                  <a:pt x="379" y="135"/>
                </a:cubicBezTo>
                <a:cubicBezTo>
                  <a:pt x="379" y="144"/>
                  <a:pt x="370" y="149"/>
                  <a:pt x="356" y="149"/>
                </a:cubicBezTo>
                <a:cubicBezTo>
                  <a:pt x="342" y="149"/>
                  <a:pt x="336" y="146"/>
                  <a:pt x="336" y="139"/>
                </a:cubicBezTo>
                <a:cubicBezTo>
                  <a:pt x="336" y="135"/>
                  <a:pt x="338" y="132"/>
                  <a:pt x="342" y="130"/>
                </a:cubicBezTo>
                <a:close/>
                <a:moveTo>
                  <a:pt x="352" y="103"/>
                </a:moveTo>
                <a:cubicBezTo>
                  <a:pt x="352" y="106"/>
                  <a:pt x="352" y="111"/>
                  <a:pt x="357" y="111"/>
                </a:cubicBezTo>
                <a:cubicBezTo>
                  <a:pt x="360" y="111"/>
                  <a:pt x="362" y="108"/>
                  <a:pt x="362" y="103"/>
                </a:cubicBezTo>
                <a:cubicBezTo>
                  <a:pt x="362" y="100"/>
                  <a:pt x="361" y="96"/>
                  <a:pt x="357" y="96"/>
                </a:cubicBezTo>
                <a:cubicBezTo>
                  <a:pt x="352" y="96"/>
                  <a:pt x="352" y="101"/>
                  <a:pt x="352" y="103"/>
                </a:cubicBezTo>
                <a:close/>
                <a:moveTo>
                  <a:pt x="348" y="137"/>
                </a:moveTo>
                <a:cubicBezTo>
                  <a:pt x="348" y="140"/>
                  <a:pt x="350" y="142"/>
                  <a:pt x="357" y="142"/>
                </a:cubicBezTo>
                <a:cubicBezTo>
                  <a:pt x="363" y="142"/>
                  <a:pt x="366" y="140"/>
                  <a:pt x="366" y="137"/>
                </a:cubicBezTo>
                <a:cubicBezTo>
                  <a:pt x="366" y="135"/>
                  <a:pt x="366" y="134"/>
                  <a:pt x="358" y="134"/>
                </a:cubicBezTo>
                <a:cubicBezTo>
                  <a:pt x="351" y="133"/>
                  <a:pt x="351" y="133"/>
                  <a:pt x="351" y="133"/>
                </a:cubicBezTo>
                <a:cubicBezTo>
                  <a:pt x="351" y="133"/>
                  <a:pt x="350" y="133"/>
                  <a:pt x="350" y="133"/>
                </a:cubicBezTo>
                <a:cubicBezTo>
                  <a:pt x="349" y="134"/>
                  <a:pt x="348" y="136"/>
                  <a:pt x="348" y="137"/>
                </a:cubicBezTo>
                <a:close/>
              </a:path>
            </a:pathLst>
          </a:custGeom>
          <a:solidFill>
            <a:schemeClr val="bg1"/>
          </a:solidFill>
          <a:ln>
            <a:noFill/>
          </a:ln>
        </p:spPr>
        <p:txBody>
          <a:bodyPr vert="horz" wrap="square" lIns="121920" tIns="60960" rIns="121920" bIns="60960" numCol="1" anchor="t" anchorCtr="0" compatLnSpc="1">
            <a:prstTxWarp prst="textNoShape">
              <a:avLst/>
            </a:prstTxWarp>
          </a:bodyPr>
          <a:lstStyle/>
          <a:p>
            <a:endParaRPr lang="en-US"/>
          </a:p>
        </p:txBody>
      </p:sp>
      <p:sp>
        <p:nvSpPr>
          <p:cNvPr id="2" name="Title 1"/>
          <p:cNvSpPr>
            <a:spLocks noGrp="1"/>
          </p:cNvSpPr>
          <p:nvPr>
            <p:ph type="ctrTitle"/>
          </p:nvPr>
        </p:nvSpPr>
        <p:spPr>
          <a:xfrm>
            <a:off x="907725" y="2267713"/>
            <a:ext cx="10674676" cy="1294372"/>
          </a:xfrm>
        </p:spPr>
        <p:txBody>
          <a:bodyPr wrap="square" lIns="0" tIns="0" rIns="0" bIns="0" anchor="ctr" anchorCtr="0">
            <a:spAutoFit/>
          </a:bodyPr>
          <a:lstStyle>
            <a:lvl1pPr>
              <a:lnSpc>
                <a:spcPct val="83000"/>
              </a:lnSpc>
              <a:defRPr sz="5100" cap="all">
                <a:solidFill>
                  <a:srgbClr val="FFFFFF"/>
                </a:solidFill>
              </a:defRPr>
            </a:lvl1pPr>
          </a:lstStyle>
          <a:p>
            <a:r>
              <a:rPr lang="en-US"/>
              <a:t>Click to edit Master title style</a:t>
            </a:r>
          </a:p>
        </p:txBody>
      </p:sp>
      <p:sp>
        <p:nvSpPr>
          <p:cNvPr id="3" name="Subtitle 2"/>
          <p:cNvSpPr>
            <a:spLocks noGrp="1"/>
          </p:cNvSpPr>
          <p:nvPr>
            <p:ph type="subTitle" idx="1" hasCustomPrompt="1"/>
          </p:nvPr>
        </p:nvSpPr>
        <p:spPr>
          <a:xfrm>
            <a:off x="907725" y="4079368"/>
            <a:ext cx="10674676" cy="323165"/>
          </a:xfrm>
        </p:spPr>
        <p:txBody>
          <a:bodyPr wrap="square" lIns="0" tIns="0" rIns="0" bIns="0" anchor="ctr" anchorCtr="0">
            <a:spAutoFit/>
          </a:bodyPr>
          <a:lstStyle>
            <a:lvl1pPr marL="0" indent="0" algn="l">
              <a:buNone/>
              <a:defRPr sz="2100" b="0" i="0" cap="none" baseline="0">
                <a:solidFill>
                  <a:srgbClr val="FFFFFF"/>
                </a:solidFill>
              </a:defRPr>
            </a:lvl1pPr>
            <a:lvl2pPr marL="457189" indent="0" algn="ctr">
              <a:buNone/>
              <a:defRPr>
                <a:solidFill>
                  <a:schemeClr val="tx1">
                    <a:tint val="75000"/>
                  </a:schemeClr>
                </a:solidFill>
              </a:defRPr>
            </a:lvl2pPr>
            <a:lvl3pPr marL="914377" indent="0" algn="ctr">
              <a:buNone/>
              <a:defRPr>
                <a:solidFill>
                  <a:schemeClr val="tx1">
                    <a:tint val="75000"/>
                  </a:schemeClr>
                </a:solidFill>
              </a:defRPr>
            </a:lvl3pPr>
            <a:lvl4pPr marL="1371566" indent="0" algn="ctr">
              <a:buNone/>
              <a:defRPr>
                <a:solidFill>
                  <a:schemeClr val="tx1">
                    <a:tint val="75000"/>
                  </a:schemeClr>
                </a:solidFill>
              </a:defRPr>
            </a:lvl4pPr>
            <a:lvl5pPr marL="1828754" indent="0" algn="ctr">
              <a:buNone/>
              <a:defRPr>
                <a:solidFill>
                  <a:schemeClr val="tx1">
                    <a:tint val="75000"/>
                  </a:schemeClr>
                </a:solidFill>
              </a:defRPr>
            </a:lvl5pPr>
            <a:lvl6pPr marL="2285943" indent="0" algn="ctr">
              <a:buNone/>
              <a:defRPr>
                <a:solidFill>
                  <a:schemeClr val="tx1">
                    <a:tint val="75000"/>
                  </a:schemeClr>
                </a:solidFill>
              </a:defRPr>
            </a:lvl6pPr>
            <a:lvl7pPr marL="2743131" indent="0" algn="ctr">
              <a:buNone/>
              <a:defRPr>
                <a:solidFill>
                  <a:schemeClr val="tx1">
                    <a:tint val="75000"/>
                  </a:schemeClr>
                </a:solidFill>
              </a:defRPr>
            </a:lvl7pPr>
            <a:lvl8pPr marL="3200320" indent="0" algn="ctr">
              <a:buNone/>
              <a:defRPr>
                <a:solidFill>
                  <a:schemeClr val="tx1">
                    <a:tint val="75000"/>
                  </a:schemeClr>
                </a:solidFill>
              </a:defRPr>
            </a:lvl8pPr>
            <a:lvl9pPr marL="3657509" indent="0" algn="ctr">
              <a:buNone/>
              <a:defRPr>
                <a:solidFill>
                  <a:schemeClr val="tx1">
                    <a:tint val="75000"/>
                  </a:schemeClr>
                </a:solidFill>
              </a:defRPr>
            </a:lvl9pPr>
          </a:lstStyle>
          <a:p>
            <a:r>
              <a:rPr lang="en-US"/>
              <a:t>Click To Edit Master Subtitle Style</a:t>
            </a:r>
          </a:p>
        </p:txBody>
      </p:sp>
      <p:sp>
        <p:nvSpPr>
          <p:cNvPr id="17" name="Picture Placeholder 16"/>
          <p:cNvSpPr>
            <a:spLocks noGrp="1"/>
          </p:cNvSpPr>
          <p:nvPr>
            <p:ph type="pic" sz="quarter" idx="10"/>
          </p:nvPr>
        </p:nvSpPr>
        <p:spPr>
          <a:xfrm>
            <a:off x="496" y="5071677"/>
            <a:ext cx="12189389" cy="1789499"/>
          </a:xfrm>
          <a:custGeom>
            <a:avLst/>
            <a:gdLst>
              <a:gd name="connsiteX0" fmla="*/ 0 w 9142413"/>
              <a:gd name="connsiteY0" fmla="*/ 0 h 1360841"/>
              <a:gd name="connsiteX1" fmla="*/ 9142413 w 9142413"/>
              <a:gd name="connsiteY1" fmla="*/ 0 h 1360841"/>
              <a:gd name="connsiteX2" fmla="*/ 9142413 w 9142413"/>
              <a:gd name="connsiteY2" fmla="*/ 1360841 h 1360841"/>
              <a:gd name="connsiteX3" fmla="*/ 0 w 9142413"/>
              <a:gd name="connsiteY3" fmla="*/ 1360841 h 1360841"/>
              <a:gd name="connsiteX4" fmla="*/ 0 w 9142413"/>
              <a:gd name="connsiteY4" fmla="*/ 0 h 1360841"/>
              <a:gd name="connsiteX0" fmla="*/ 0 w 9142413"/>
              <a:gd name="connsiteY0" fmla="*/ 0 h 1360841"/>
              <a:gd name="connsiteX1" fmla="*/ 702469 w 9142413"/>
              <a:gd name="connsiteY1" fmla="*/ 1147 h 1360841"/>
              <a:gd name="connsiteX2" fmla="*/ 9142413 w 9142413"/>
              <a:gd name="connsiteY2" fmla="*/ 0 h 1360841"/>
              <a:gd name="connsiteX3" fmla="*/ 9142413 w 9142413"/>
              <a:gd name="connsiteY3" fmla="*/ 1360841 h 1360841"/>
              <a:gd name="connsiteX4" fmla="*/ 0 w 9142413"/>
              <a:gd name="connsiteY4" fmla="*/ 1360841 h 1360841"/>
              <a:gd name="connsiteX5" fmla="*/ 0 w 9142413"/>
              <a:gd name="connsiteY5" fmla="*/ 0 h 1360841"/>
              <a:gd name="connsiteX0" fmla="*/ 0 w 9142413"/>
              <a:gd name="connsiteY0" fmla="*/ 1234 h 1362075"/>
              <a:gd name="connsiteX1" fmla="*/ 702469 w 9142413"/>
              <a:gd name="connsiteY1" fmla="*/ 2381 h 1362075"/>
              <a:gd name="connsiteX2" fmla="*/ 966788 w 9142413"/>
              <a:gd name="connsiteY2" fmla="*/ 0 h 1362075"/>
              <a:gd name="connsiteX3" fmla="*/ 9142413 w 9142413"/>
              <a:gd name="connsiteY3" fmla="*/ 1234 h 1362075"/>
              <a:gd name="connsiteX4" fmla="*/ 9142413 w 9142413"/>
              <a:gd name="connsiteY4" fmla="*/ 1362075 h 1362075"/>
              <a:gd name="connsiteX5" fmla="*/ 0 w 9142413"/>
              <a:gd name="connsiteY5" fmla="*/ 1362075 h 1362075"/>
              <a:gd name="connsiteX6" fmla="*/ 0 w 9142413"/>
              <a:gd name="connsiteY6" fmla="*/ 1234 h 1362075"/>
              <a:gd name="connsiteX0" fmla="*/ 0 w 9142413"/>
              <a:gd name="connsiteY0" fmla="*/ 1234 h 1362075"/>
              <a:gd name="connsiteX1" fmla="*/ 702469 w 9142413"/>
              <a:gd name="connsiteY1" fmla="*/ 2381 h 1362075"/>
              <a:gd name="connsiteX2" fmla="*/ 838200 w 9142413"/>
              <a:gd name="connsiteY2" fmla="*/ 2381 h 1362075"/>
              <a:gd name="connsiteX3" fmla="*/ 966788 w 9142413"/>
              <a:gd name="connsiteY3" fmla="*/ 0 h 1362075"/>
              <a:gd name="connsiteX4" fmla="*/ 9142413 w 9142413"/>
              <a:gd name="connsiteY4" fmla="*/ 1234 h 1362075"/>
              <a:gd name="connsiteX5" fmla="*/ 9142413 w 9142413"/>
              <a:gd name="connsiteY5" fmla="*/ 1362075 h 1362075"/>
              <a:gd name="connsiteX6" fmla="*/ 0 w 9142413"/>
              <a:gd name="connsiteY6" fmla="*/ 1362075 h 1362075"/>
              <a:gd name="connsiteX7" fmla="*/ 0 w 9142413"/>
              <a:gd name="connsiteY7" fmla="*/ 1234 h 1362075"/>
              <a:gd name="connsiteX0" fmla="*/ 0 w 9142413"/>
              <a:gd name="connsiteY0" fmla="*/ 1234 h 1362075"/>
              <a:gd name="connsiteX1" fmla="*/ 702469 w 9142413"/>
              <a:gd name="connsiteY1" fmla="*/ 2381 h 1362075"/>
              <a:gd name="connsiteX2" fmla="*/ 826294 w 9142413"/>
              <a:gd name="connsiteY2" fmla="*/ 240506 h 1362075"/>
              <a:gd name="connsiteX3" fmla="*/ 966788 w 9142413"/>
              <a:gd name="connsiteY3" fmla="*/ 0 h 1362075"/>
              <a:gd name="connsiteX4" fmla="*/ 9142413 w 9142413"/>
              <a:gd name="connsiteY4" fmla="*/ 1234 h 1362075"/>
              <a:gd name="connsiteX5" fmla="*/ 9142413 w 9142413"/>
              <a:gd name="connsiteY5" fmla="*/ 1362075 h 1362075"/>
              <a:gd name="connsiteX6" fmla="*/ 0 w 9142413"/>
              <a:gd name="connsiteY6" fmla="*/ 1362075 h 1362075"/>
              <a:gd name="connsiteX7" fmla="*/ 0 w 9142413"/>
              <a:gd name="connsiteY7" fmla="*/ 1234 h 1362075"/>
              <a:gd name="connsiteX0" fmla="*/ 0 w 9142413"/>
              <a:gd name="connsiteY0" fmla="*/ 1234 h 1362075"/>
              <a:gd name="connsiteX1" fmla="*/ 702469 w 9142413"/>
              <a:gd name="connsiteY1" fmla="*/ 2381 h 1362075"/>
              <a:gd name="connsiteX2" fmla="*/ 826294 w 9142413"/>
              <a:gd name="connsiteY2" fmla="*/ 235744 h 1362075"/>
              <a:gd name="connsiteX3" fmla="*/ 966788 w 9142413"/>
              <a:gd name="connsiteY3" fmla="*/ 0 h 1362075"/>
              <a:gd name="connsiteX4" fmla="*/ 9142413 w 9142413"/>
              <a:gd name="connsiteY4" fmla="*/ 1234 h 1362075"/>
              <a:gd name="connsiteX5" fmla="*/ 9142413 w 9142413"/>
              <a:gd name="connsiteY5" fmla="*/ 1362075 h 1362075"/>
              <a:gd name="connsiteX6" fmla="*/ 0 w 9142413"/>
              <a:gd name="connsiteY6" fmla="*/ 1362075 h 1362075"/>
              <a:gd name="connsiteX7" fmla="*/ 0 w 9142413"/>
              <a:gd name="connsiteY7" fmla="*/ 1234 h 1362075"/>
              <a:gd name="connsiteX0" fmla="*/ 0 w 9142413"/>
              <a:gd name="connsiteY0" fmla="*/ 1234 h 1362075"/>
              <a:gd name="connsiteX1" fmla="*/ 702469 w 9142413"/>
              <a:gd name="connsiteY1" fmla="*/ 2381 h 1362075"/>
              <a:gd name="connsiteX2" fmla="*/ 842962 w 9142413"/>
              <a:gd name="connsiteY2" fmla="*/ 235744 h 1362075"/>
              <a:gd name="connsiteX3" fmla="*/ 966788 w 9142413"/>
              <a:gd name="connsiteY3" fmla="*/ 0 h 1362075"/>
              <a:gd name="connsiteX4" fmla="*/ 9142413 w 9142413"/>
              <a:gd name="connsiteY4" fmla="*/ 1234 h 1362075"/>
              <a:gd name="connsiteX5" fmla="*/ 9142413 w 9142413"/>
              <a:gd name="connsiteY5" fmla="*/ 1362075 h 1362075"/>
              <a:gd name="connsiteX6" fmla="*/ 0 w 9142413"/>
              <a:gd name="connsiteY6" fmla="*/ 1362075 h 1362075"/>
              <a:gd name="connsiteX7" fmla="*/ 0 w 9142413"/>
              <a:gd name="connsiteY7" fmla="*/ 1234 h 1362075"/>
              <a:gd name="connsiteX0" fmla="*/ 0 w 9142413"/>
              <a:gd name="connsiteY0" fmla="*/ 1234 h 1362075"/>
              <a:gd name="connsiteX1" fmla="*/ 702469 w 9142413"/>
              <a:gd name="connsiteY1" fmla="*/ 2381 h 1362075"/>
              <a:gd name="connsiteX2" fmla="*/ 842962 w 9142413"/>
              <a:gd name="connsiteY2" fmla="*/ 235744 h 1362075"/>
              <a:gd name="connsiteX3" fmla="*/ 966788 w 9142413"/>
              <a:gd name="connsiteY3" fmla="*/ 0 h 1362075"/>
              <a:gd name="connsiteX4" fmla="*/ 9142413 w 9142413"/>
              <a:gd name="connsiteY4" fmla="*/ 1234 h 1362075"/>
              <a:gd name="connsiteX5" fmla="*/ 9142413 w 9142413"/>
              <a:gd name="connsiteY5" fmla="*/ 1362075 h 1362075"/>
              <a:gd name="connsiteX6" fmla="*/ 0 w 9142413"/>
              <a:gd name="connsiteY6" fmla="*/ 1362075 h 1362075"/>
              <a:gd name="connsiteX7" fmla="*/ 0 w 9142413"/>
              <a:gd name="connsiteY7" fmla="*/ 1234 h 1362075"/>
              <a:gd name="connsiteX0" fmla="*/ 0 w 9142413"/>
              <a:gd name="connsiteY0" fmla="*/ 1234 h 1362075"/>
              <a:gd name="connsiteX1" fmla="*/ 702469 w 9142413"/>
              <a:gd name="connsiteY1" fmla="*/ 2381 h 1362075"/>
              <a:gd name="connsiteX2" fmla="*/ 842962 w 9142413"/>
              <a:gd name="connsiteY2" fmla="*/ 235744 h 1362075"/>
              <a:gd name="connsiteX3" fmla="*/ 966788 w 9142413"/>
              <a:gd name="connsiteY3" fmla="*/ 0 h 1362075"/>
              <a:gd name="connsiteX4" fmla="*/ 9142413 w 9142413"/>
              <a:gd name="connsiteY4" fmla="*/ 1234 h 1362075"/>
              <a:gd name="connsiteX5" fmla="*/ 9142413 w 9142413"/>
              <a:gd name="connsiteY5" fmla="*/ 1362075 h 1362075"/>
              <a:gd name="connsiteX6" fmla="*/ 0 w 9142413"/>
              <a:gd name="connsiteY6" fmla="*/ 1362075 h 1362075"/>
              <a:gd name="connsiteX7" fmla="*/ 0 w 9142413"/>
              <a:gd name="connsiteY7" fmla="*/ 1234 h 1362075"/>
              <a:gd name="connsiteX0" fmla="*/ 0 w 9142413"/>
              <a:gd name="connsiteY0" fmla="*/ 1234 h 1362075"/>
              <a:gd name="connsiteX1" fmla="*/ 702469 w 9142413"/>
              <a:gd name="connsiteY1" fmla="*/ 2381 h 1362075"/>
              <a:gd name="connsiteX2" fmla="*/ 842962 w 9142413"/>
              <a:gd name="connsiteY2" fmla="*/ 235744 h 1362075"/>
              <a:gd name="connsiteX3" fmla="*/ 966788 w 9142413"/>
              <a:gd name="connsiteY3" fmla="*/ 0 h 1362075"/>
              <a:gd name="connsiteX4" fmla="*/ 9142413 w 9142413"/>
              <a:gd name="connsiteY4" fmla="*/ 1234 h 1362075"/>
              <a:gd name="connsiteX5" fmla="*/ 9142413 w 9142413"/>
              <a:gd name="connsiteY5" fmla="*/ 1362075 h 1362075"/>
              <a:gd name="connsiteX6" fmla="*/ 0 w 9142413"/>
              <a:gd name="connsiteY6" fmla="*/ 1362075 h 1362075"/>
              <a:gd name="connsiteX7" fmla="*/ 0 w 9142413"/>
              <a:gd name="connsiteY7" fmla="*/ 1234 h 1362075"/>
              <a:gd name="connsiteX0" fmla="*/ 0 w 9142413"/>
              <a:gd name="connsiteY0" fmla="*/ 1234 h 1362075"/>
              <a:gd name="connsiteX1" fmla="*/ 702469 w 9142413"/>
              <a:gd name="connsiteY1" fmla="*/ 2381 h 1362075"/>
              <a:gd name="connsiteX2" fmla="*/ 842962 w 9142413"/>
              <a:gd name="connsiteY2" fmla="*/ 235744 h 1362075"/>
              <a:gd name="connsiteX3" fmla="*/ 966788 w 9142413"/>
              <a:gd name="connsiteY3" fmla="*/ 0 h 1362075"/>
              <a:gd name="connsiteX4" fmla="*/ 9142413 w 9142413"/>
              <a:gd name="connsiteY4" fmla="*/ 1234 h 1362075"/>
              <a:gd name="connsiteX5" fmla="*/ 9142413 w 9142413"/>
              <a:gd name="connsiteY5" fmla="*/ 1362075 h 1362075"/>
              <a:gd name="connsiteX6" fmla="*/ 0 w 9142413"/>
              <a:gd name="connsiteY6" fmla="*/ 1362075 h 1362075"/>
              <a:gd name="connsiteX7" fmla="*/ 0 w 9142413"/>
              <a:gd name="connsiteY7" fmla="*/ 1234 h 1362075"/>
              <a:gd name="connsiteX0" fmla="*/ 0 w 9142413"/>
              <a:gd name="connsiteY0" fmla="*/ 1234 h 1362075"/>
              <a:gd name="connsiteX1" fmla="*/ 702469 w 9142413"/>
              <a:gd name="connsiteY1" fmla="*/ 2381 h 1362075"/>
              <a:gd name="connsiteX2" fmla="*/ 842962 w 9142413"/>
              <a:gd name="connsiteY2" fmla="*/ 235744 h 1362075"/>
              <a:gd name="connsiteX3" fmla="*/ 966788 w 9142413"/>
              <a:gd name="connsiteY3" fmla="*/ 0 h 1362075"/>
              <a:gd name="connsiteX4" fmla="*/ 9142413 w 9142413"/>
              <a:gd name="connsiteY4" fmla="*/ 1234 h 1362075"/>
              <a:gd name="connsiteX5" fmla="*/ 9142413 w 9142413"/>
              <a:gd name="connsiteY5" fmla="*/ 1362075 h 1362075"/>
              <a:gd name="connsiteX6" fmla="*/ 0 w 9142413"/>
              <a:gd name="connsiteY6" fmla="*/ 1362075 h 1362075"/>
              <a:gd name="connsiteX7" fmla="*/ 0 w 9142413"/>
              <a:gd name="connsiteY7" fmla="*/ 1234 h 1362075"/>
              <a:gd name="connsiteX0" fmla="*/ 0 w 9142413"/>
              <a:gd name="connsiteY0" fmla="*/ 1234 h 1362075"/>
              <a:gd name="connsiteX1" fmla="*/ 702469 w 9142413"/>
              <a:gd name="connsiteY1" fmla="*/ 2381 h 1362075"/>
              <a:gd name="connsiteX2" fmla="*/ 842962 w 9142413"/>
              <a:gd name="connsiteY2" fmla="*/ 235744 h 1362075"/>
              <a:gd name="connsiteX3" fmla="*/ 966788 w 9142413"/>
              <a:gd name="connsiteY3" fmla="*/ 0 h 1362075"/>
              <a:gd name="connsiteX4" fmla="*/ 9142413 w 9142413"/>
              <a:gd name="connsiteY4" fmla="*/ 1234 h 1362075"/>
              <a:gd name="connsiteX5" fmla="*/ 9142413 w 9142413"/>
              <a:gd name="connsiteY5" fmla="*/ 1362075 h 1362075"/>
              <a:gd name="connsiteX6" fmla="*/ 0 w 9142413"/>
              <a:gd name="connsiteY6" fmla="*/ 1362075 h 1362075"/>
              <a:gd name="connsiteX7" fmla="*/ 0 w 9142413"/>
              <a:gd name="connsiteY7" fmla="*/ 1234 h 1362075"/>
              <a:gd name="connsiteX0" fmla="*/ 0 w 9142413"/>
              <a:gd name="connsiteY0" fmla="*/ 1234 h 1362075"/>
              <a:gd name="connsiteX1" fmla="*/ 702469 w 9142413"/>
              <a:gd name="connsiteY1" fmla="*/ 2381 h 1362075"/>
              <a:gd name="connsiteX2" fmla="*/ 842962 w 9142413"/>
              <a:gd name="connsiteY2" fmla="*/ 235744 h 1362075"/>
              <a:gd name="connsiteX3" fmla="*/ 966788 w 9142413"/>
              <a:gd name="connsiteY3" fmla="*/ 0 h 1362075"/>
              <a:gd name="connsiteX4" fmla="*/ 9142413 w 9142413"/>
              <a:gd name="connsiteY4" fmla="*/ 1234 h 1362075"/>
              <a:gd name="connsiteX5" fmla="*/ 9142413 w 9142413"/>
              <a:gd name="connsiteY5" fmla="*/ 1362075 h 1362075"/>
              <a:gd name="connsiteX6" fmla="*/ 0 w 9142413"/>
              <a:gd name="connsiteY6" fmla="*/ 1362075 h 1362075"/>
              <a:gd name="connsiteX7" fmla="*/ 0 w 9142413"/>
              <a:gd name="connsiteY7" fmla="*/ 1234 h 1362075"/>
              <a:gd name="connsiteX0" fmla="*/ 0 w 9142413"/>
              <a:gd name="connsiteY0" fmla="*/ 1234 h 1362075"/>
              <a:gd name="connsiteX1" fmla="*/ 702469 w 9142413"/>
              <a:gd name="connsiteY1" fmla="*/ 2381 h 1362075"/>
              <a:gd name="connsiteX2" fmla="*/ 842962 w 9142413"/>
              <a:gd name="connsiteY2" fmla="*/ 235744 h 1362075"/>
              <a:gd name="connsiteX3" fmla="*/ 966788 w 9142413"/>
              <a:gd name="connsiteY3" fmla="*/ 0 h 1362075"/>
              <a:gd name="connsiteX4" fmla="*/ 9142413 w 9142413"/>
              <a:gd name="connsiteY4" fmla="*/ 1234 h 1362075"/>
              <a:gd name="connsiteX5" fmla="*/ 9142413 w 9142413"/>
              <a:gd name="connsiteY5" fmla="*/ 1362075 h 1362075"/>
              <a:gd name="connsiteX6" fmla="*/ 0 w 9142413"/>
              <a:gd name="connsiteY6" fmla="*/ 1362075 h 1362075"/>
              <a:gd name="connsiteX7" fmla="*/ 0 w 9142413"/>
              <a:gd name="connsiteY7" fmla="*/ 1234 h 1362075"/>
              <a:gd name="connsiteX0" fmla="*/ 0 w 9142413"/>
              <a:gd name="connsiteY0" fmla="*/ 1234 h 1362075"/>
              <a:gd name="connsiteX1" fmla="*/ 702469 w 9142413"/>
              <a:gd name="connsiteY1" fmla="*/ 2381 h 1362075"/>
              <a:gd name="connsiteX2" fmla="*/ 842962 w 9142413"/>
              <a:gd name="connsiteY2" fmla="*/ 235744 h 1362075"/>
              <a:gd name="connsiteX3" fmla="*/ 966788 w 9142413"/>
              <a:gd name="connsiteY3" fmla="*/ 0 h 1362075"/>
              <a:gd name="connsiteX4" fmla="*/ 9142413 w 9142413"/>
              <a:gd name="connsiteY4" fmla="*/ 1234 h 1362075"/>
              <a:gd name="connsiteX5" fmla="*/ 9142413 w 9142413"/>
              <a:gd name="connsiteY5" fmla="*/ 1362075 h 1362075"/>
              <a:gd name="connsiteX6" fmla="*/ 0 w 9142413"/>
              <a:gd name="connsiteY6" fmla="*/ 1362075 h 1362075"/>
              <a:gd name="connsiteX7" fmla="*/ 0 w 9142413"/>
              <a:gd name="connsiteY7" fmla="*/ 1234 h 1362075"/>
              <a:gd name="connsiteX0" fmla="*/ 0 w 9142413"/>
              <a:gd name="connsiteY0" fmla="*/ 1234 h 1362075"/>
              <a:gd name="connsiteX1" fmla="*/ 702469 w 9142413"/>
              <a:gd name="connsiteY1" fmla="*/ 2381 h 1362075"/>
              <a:gd name="connsiteX2" fmla="*/ 842962 w 9142413"/>
              <a:gd name="connsiteY2" fmla="*/ 235744 h 1362075"/>
              <a:gd name="connsiteX3" fmla="*/ 966788 w 9142413"/>
              <a:gd name="connsiteY3" fmla="*/ 0 h 1362075"/>
              <a:gd name="connsiteX4" fmla="*/ 9142413 w 9142413"/>
              <a:gd name="connsiteY4" fmla="*/ 1234 h 1362075"/>
              <a:gd name="connsiteX5" fmla="*/ 9142413 w 9142413"/>
              <a:gd name="connsiteY5" fmla="*/ 1362075 h 1362075"/>
              <a:gd name="connsiteX6" fmla="*/ 0 w 9142413"/>
              <a:gd name="connsiteY6" fmla="*/ 1362075 h 1362075"/>
              <a:gd name="connsiteX7" fmla="*/ 0 w 9142413"/>
              <a:gd name="connsiteY7" fmla="*/ 1234 h 1362075"/>
              <a:gd name="connsiteX0" fmla="*/ 0 w 9149186"/>
              <a:gd name="connsiteY0" fmla="*/ 28327 h 1362075"/>
              <a:gd name="connsiteX1" fmla="*/ 709242 w 9149186"/>
              <a:gd name="connsiteY1" fmla="*/ 2381 h 1362075"/>
              <a:gd name="connsiteX2" fmla="*/ 849735 w 9149186"/>
              <a:gd name="connsiteY2" fmla="*/ 235744 h 1362075"/>
              <a:gd name="connsiteX3" fmla="*/ 973561 w 9149186"/>
              <a:gd name="connsiteY3" fmla="*/ 0 h 1362075"/>
              <a:gd name="connsiteX4" fmla="*/ 9149186 w 9149186"/>
              <a:gd name="connsiteY4" fmla="*/ 1234 h 1362075"/>
              <a:gd name="connsiteX5" fmla="*/ 9149186 w 9149186"/>
              <a:gd name="connsiteY5" fmla="*/ 1362075 h 1362075"/>
              <a:gd name="connsiteX6" fmla="*/ 6773 w 9149186"/>
              <a:gd name="connsiteY6" fmla="*/ 1362075 h 1362075"/>
              <a:gd name="connsiteX7" fmla="*/ 0 w 9149186"/>
              <a:gd name="connsiteY7" fmla="*/ 28327 h 1362075"/>
              <a:gd name="connsiteX0" fmla="*/ 0 w 9149186"/>
              <a:gd name="connsiteY0" fmla="*/ 28327 h 1362075"/>
              <a:gd name="connsiteX1" fmla="*/ 688922 w 9149186"/>
              <a:gd name="connsiteY1" fmla="*/ 29475 h 1362075"/>
              <a:gd name="connsiteX2" fmla="*/ 849735 w 9149186"/>
              <a:gd name="connsiteY2" fmla="*/ 235744 h 1362075"/>
              <a:gd name="connsiteX3" fmla="*/ 973561 w 9149186"/>
              <a:gd name="connsiteY3" fmla="*/ 0 h 1362075"/>
              <a:gd name="connsiteX4" fmla="*/ 9149186 w 9149186"/>
              <a:gd name="connsiteY4" fmla="*/ 1234 h 1362075"/>
              <a:gd name="connsiteX5" fmla="*/ 9149186 w 9149186"/>
              <a:gd name="connsiteY5" fmla="*/ 1362075 h 1362075"/>
              <a:gd name="connsiteX6" fmla="*/ 6773 w 9149186"/>
              <a:gd name="connsiteY6" fmla="*/ 1362075 h 1362075"/>
              <a:gd name="connsiteX7" fmla="*/ 0 w 9149186"/>
              <a:gd name="connsiteY7" fmla="*/ 28327 h 1362075"/>
              <a:gd name="connsiteX0" fmla="*/ 0 w 9149186"/>
              <a:gd name="connsiteY0" fmla="*/ 27093 h 1360841"/>
              <a:gd name="connsiteX1" fmla="*/ 688922 w 9149186"/>
              <a:gd name="connsiteY1" fmla="*/ 28241 h 1360841"/>
              <a:gd name="connsiteX2" fmla="*/ 849735 w 9149186"/>
              <a:gd name="connsiteY2" fmla="*/ 234510 h 1360841"/>
              <a:gd name="connsiteX3" fmla="*/ 953241 w 9149186"/>
              <a:gd name="connsiteY3" fmla="*/ 25860 h 1360841"/>
              <a:gd name="connsiteX4" fmla="*/ 9149186 w 9149186"/>
              <a:gd name="connsiteY4" fmla="*/ 0 h 1360841"/>
              <a:gd name="connsiteX5" fmla="*/ 9149186 w 9149186"/>
              <a:gd name="connsiteY5" fmla="*/ 1360841 h 1360841"/>
              <a:gd name="connsiteX6" fmla="*/ 6773 w 9149186"/>
              <a:gd name="connsiteY6" fmla="*/ 1360841 h 1360841"/>
              <a:gd name="connsiteX7" fmla="*/ 0 w 9149186"/>
              <a:gd name="connsiteY7" fmla="*/ 27093 h 1360841"/>
              <a:gd name="connsiteX0" fmla="*/ 0 w 9149186"/>
              <a:gd name="connsiteY0" fmla="*/ 1233 h 1334981"/>
              <a:gd name="connsiteX1" fmla="*/ 688922 w 9149186"/>
              <a:gd name="connsiteY1" fmla="*/ 2381 h 1334981"/>
              <a:gd name="connsiteX2" fmla="*/ 849735 w 9149186"/>
              <a:gd name="connsiteY2" fmla="*/ 208650 h 1334981"/>
              <a:gd name="connsiteX3" fmla="*/ 953241 w 9149186"/>
              <a:gd name="connsiteY3" fmla="*/ 0 h 1334981"/>
              <a:gd name="connsiteX4" fmla="*/ 9149186 w 9149186"/>
              <a:gd name="connsiteY4" fmla="*/ 1233 h 1334981"/>
              <a:gd name="connsiteX5" fmla="*/ 9149186 w 9149186"/>
              <a:gd name="connsiteY5" fmla="*/ 1334981 h 1334981"/>
              <a:gd name="connsiteX6" fmla="*/ 6773 w 9149186"/>
              <a:gd name="connsiteY6" fmla="*/ 1334981 h 1334981"/>
              <a:gd name="connsiteX7" fmla="*/ 0 w 9149186"/>
              <a:gd name="connsiteY7" fmla="*/ 1233 h 1334981"/>
              <a:gd name="connsiteX0" fmla="*/ 0 w 9149186"/>
              <a:gd name="connsiteY0" fmla="*/ 1233 h 1334981"/>
              <a:gd name="connsiteX1" fmla="*/ 688922 w 9149186"/>
              <a:gd name="connsiteY1" fmla="*/ 2381 h 1334981"/>
              <a:gd name="connsiteX2" fmla="*/ 815868 w 9149186"/>
              <a:gd name="connsiteY2" fmla="*/ 235743 h 1334981"/>
              <a:gd name="connsiteX3" fmla="*/ 953241 w 9149186"/>
              <a:gd name="connsiteY3" fmla="*/ 0 h 1334981"/>
              <a:gd name="connsiteX4" fmla="*/ 9149186 w 9149186"/>
              <a:gd name="connsiteY4" fmla="*/ 1233 h 1334981"/>
              <a:gd name="connsiteX5" fmla="*/ 9149186 w 9149186"/>
              <a:gd name="connsiteY5" fmla="*/ 1334981 h 1334981"/>
              <a:gd name="connsiteX6" fmla="*/ 6773 w 9149186"/>
              <a:gd name="connsiteY6" fmla="*/ 1334981 h 1334981"/>
              <a:gd name="connsiteX7" fmla="*/ 0 w 9149186"/>
              <a:gd name="connsiteY7" fmla="*/ 1233 h 1334981"/>
              <a:gd name="connsiteX0" fmla="*/ 3193 w 9142854"/>
              <a:gd name="connsiteY0" fmla="*/ 5995 h 1334981"/>
              <a:gd name="connsiteX1" fmla="*/ 682590 w 9142854"/>
              <a:gd name="connsiteY1" fmla="*/ 2381 h 1334981"/>
              <a:gd name="connsiteX2" fmla="*/ 809536 w 9142854"/>
              <a:gd name="connsiteY2" fmla="*/ 235743 h 1334981"/>
              <a:gd name="connsiteX3" fmla="*/ 946909 w 9142854"/>
              <a:gd name="connsiteY3" fmla="*/ 0 h 1334981"/>
              <a:gd name="connsiteX4" fmla="*/ 9142854 w 9142854"/>
              <a:gd name="connsiteY4" fmla="*/ 1233 h 1334981"/>
              <a:gd name="connsiteX5" fmla="*/ 9142854 w 9142854"/>
              <a:gd name="connsiteY5" fmla="*/ 1334981 h 1334981"/>
              <a:gd name="connsiteX6" fmla="*/ 441 w 9142854"/>
              <a:gd name="connsiteY6" fmla="*/ 1334981 h 1334981"/>
              <a:gd name="connsiteX7" fmla="*/ 3193 w 9142854"/>
              <a:gd name="connsiteY7" fmla="*/ 5995 h 1334981"/>
              <a:gd name="connsiteX0" fmla="*/ 982 w 9143024"/>
              <a:gd name="connsiteY0" fmla="*/ 0 h 1338511"/>
              <a:gd name="connsiteX1" fmla="*/ 682760 w 9143024"/>
              <a:gd name="connsiteY1" fmla="*/ 5911 h 1338511"/>
              <a:gd name="connsiteX2" fmla="*/ 809706 w 9143024"/>
              <a:gd name="connsiteY2" fmla="*/ 239273 h 1338511"/>
              <a:gd name="connsiteX3" fmla="*/ 947079 w 9143024"/>
              <a:gd name="connsiteY3" fmla="*/ 3530 h 1338511"/>
              <a:gd name="connsiteX4" fmla="*/ 9143024 w 9143024"/>
              <a:gd name="connsiteY4" fmla="*/ 4763 h 1338511"/>
              <a:gd name="connsiteX5" fmla="*/ 9143024 w 9143024"/>
              <a:gd name="connsiteY5" fmla="*/ 1338511 h 1338511"/>
              <a:gd name="connsiteX6" fmla="*/ 611 w 9143024"/>
              <a:gd name="connsiteY6" fmla="*/ 1338511 h 1338511"/>
              <a:gd name="connsiteX7" fmla="*/ 982 w 9143024"/>
              <a:gd name="connsiteY7" fmla="*/ 0 h 1338511"/>
              <a:gd name="connsiteX0" fmla="*/ 982 w 9143024"/>
              <a:gd name="connsiteY0" fmla="*/ 0 h 1338511"/>
              <a:gd name="connsiteX1" fmla="*/ 673235 w 9143024"/>
              <a:gd name="connsiteY1" fmla="*/ 1149 h 1338511"/>
              <a:gd name="connsiteX2" fmla="*/ 809706 w 9143024"/>
              <a:gd name="connsiteY2" fmla="*/ 239273 h 1338511"/>
              <a:gd name="connsiteX3" fmla="*/ 947079 w 9143024"/>
              <a:gd name="connsiteY3" fmla="*/ 3530 h 1338511"/>
              <a:gd name="connsiteX4" fmla="*/ 9143024 w 9143024"/>
              <a:gd name="connsiteY4" fmla="*/ 4763 h 1338511"/>
              <a:gd name="connsiteX5" fmla="*/ 9143024 w 9143024"/>
              <a:gd name="connsiteY5" fmla="*/ 1338511 h 1338511"/>
              <a:gd name="connsiteX6" fmla="*/ 611 w 9143024"/>
              <a:gd name="connsiteY6" fmla="*/ 1338511 h 1338511"/>
              <a:gd name="connsiteX7" fmla="*/ 982 w 9143024"/>
              <a:gd name="connsiteY7" fmla="*/ 0 h 1338511"/>
              <a:gd name="connsiteX0" fmla="*/ 982 w 9143024"/>
              <a:gd name="connsiteY0" fmla="*/ 0 h 1338511"/>
              <a:gd name="connsiteX1" fmla="*/ 673235 w 9143024"/>
              <a:gd name="connsiteY1" fmla="*/ 1149 h 1338511"/>
              <a:gd name="connsiteX2" fmla="*/ 809706 w 9143024"/>
              <a:gd name="connsiteY2" fmla="*/ 239273 h 1338511"/>
              <a:gd name="connsiteX3" fmla="*/ 947079 w 9143024"/>
              <a:gd name="connsiteY3" fmla="*/ 3530 h 1338511"/>
              <a:gd name="connsiteX4" fmla="*/ 9143024 w 9143024"/>
              <a:gd name="connsiteY4" fmla="*/ 4763 h 1338511"/>
              <a:gd name="connsiteX5" fmla="*/ 9143024 w 9143024"/>
              <a:gd name="connsiteY5" fmla="*/ 1338511 h 1338511"/>
              <a:gd name="connsiteX6" fmla="*/ 611 w 9143024"/>
              <a:gd name="connsiteY6" fmla="*/ 1338511 h 1338511"/>
              <a:gd name="connsiteX7" fmla="*/ 982 w 9143024"/>
              <a:gd name="connsiteY7" fmla="*/ 0 h 1338511"/>
              <a:gd name="connsiteX0" fmla="*/ 982 w 9143024"/>
              <a:gd name="connsiteY0" fmla="*/ 3614 h 1342125"/>
              <a:gd name="connsiteX1" fmla="*/ 673235 w 9143024"/>
              <a:gd name="connsiteY1" fmla="*/ 4763 h 1342125"/>
              <a:gd name="connsiteX2" fmla="*/ 809706 w 9143024"/>
              <a:gd name="connsiteY2" fmla="*/ 242887 h 1342125"/>
              <a:gd name="connsiteX3" fmla="*/ 937554 w 9143024"/>
              <a:gd name="connsiteY3" fmla="*/ 0 h 1342125"/>
              <a:gd name="connsiteX4" fmla="*/ 9143024 w 9143024"/>
              <a:gd name="connsiteY4" fmla="*/ 8377 h 1342125"/>
              <a:gd name="connsiteX5" fmla="*/ 9143024 w 9143024"/>
              <a:gd name="connsiteY5" fmla="*/ 1342125 h 1342125"/>
              <a:gd name="connsiteX6" fmla="*/ 611 w 9143024"/>
              <a:gd name="connsiteY6" fmla="*/ 1342125 h 1342125"/>
              <a:gd name="connsiteX7" fmla="*/ 982 w 9143024"/>
              <a:gd name="connsiteY7" fmla="*/ 3614 h 1342125"/>
              <a:gd name="connsiteX0" fmla="*/ 982 w 9143024"/>
              <a:gd name="connsiteY0" fmla="*/ 3614 h 1342125"/>
              <a:gd name="connsiteX1" fmla="*/ 673235 w 9143024"/>
              <a:gd name="connsiteY1" fmla="*/ 4763 h 1342125"/>
              <a:gd name="connsiteX2" fmla="*/ 800181 w 9143024"/>
              <a:gd name="connsiteY2" fmla="*/ 200024 h 1342125"/>
              <a:gd name="connsiteX3" fmla="*/ 937554 w 9143024"/>
              <a:gd name="connsiteY3" fmla="*/ 0 h 1342125"/>
              <a:gd name="connsiteX4" fmla="*/ 9143024 w 9143024"/>
              <a:gd name="connsiteY4" fmla="*/ 8377 h 1342125"/>
              <a:gd name="connsiteX5" fmla="*/ 9143024 w 9143024"/>
              <a:gd name="connsiteY5" fmla="*/ 1342125 h 1342125"/>
              <a:gd name="connsiteX6" fmla="*/ 611 w 9143024"/>
              <a:gd name="connsiteY6" fmla="*/ 1342125 h 1342125"/>
              <a:gd name="connsiteX7" fmla="*/ 982 w 9143024"/>
              <a:gd name="connsiteY7" fmla="*/ 3614 h 1342125"/>
              <a:gd name="connsiteX0" fmla="*/ 982 w 9143024"/>
              <a:gd name="connsiteY0" fmla="*/ 3614 h 1342125"/>
              <a:gd name="connsiteX1" fmla="*/ 673235 w 9143024"/>
              <a:gd name="connsiteY1" fmla="*/ 4763 h 1342125"/>
              <a:gd name="connsiteX2" fmla="*/ 800181 w 9143024"/>
              <a:gd name="connsiteY2" fmla="*/ 238124 h 1342125"/>
              <a:gd name="connsiteX3" fmla="*/ 937554 w 9143024"/>
              <a:gd name="connsiteY3" fmla="*/ 0 h 1342125"/>
              <a:gd name="connsiteX4" fmla="*/ 9143024 w 9143024"/>
              <a:gd name="connsiteY4" fmla="*/ 8377 h 1342125"/>
              <a:gd name="connsiteX5" fmla="*/ 9143024 w 9143024"/>
              <a:gd name="connsiteY5" fmla="*/ 1342125 h 1342125"/>
              <a:gd name="connsiteX6" fmla="*/ 611 w 9143024"/>
              <a:gd name="connsiteY6" fmla="*/ 1342125 h 1342125"/>
              <a:gd name="connsiteX7" fmla="*/ 982 w 9143024"/>
              <a:gd name="connsiteY7" fmla="*/ 3614 h 1342125"/>
              <a:gd name="connsiteX0" fmla="*/ 982 w 9143024"/>
              <a:gd name="connsiteY0" fmla="*/ 3614 h 1342125"/>
              <a:gd name="connsiteX1" fmla="*/ 673235 w 9143024"/>
              <a:gd name="connsiteY1" fmla="*/ 4763 h 1342125"/>
              <a:gd name="connsiteX2" fmla="*/ 800181 w 9143024"/>
              <a:gd name="connsiteY2" fmla="*/ 238124 h 1342125"/>
              <a:gd name="connsiteX3" fmla="*/ 937554 w 9143024"/>
              <a:gd name="connsiteY3" fmla="*/ 0 h 1342125"/>
              <a:gd name="connsiteX4" fmla="*/ 9143024 w 9143024"/>
              <a:gd name="connsiteY4" fmla="*/ 8377 h 1342125"/>
              <a:gd name="connsiteX5" fmla="*/ 9143024 w 9143024"/>
              <a:gd name="connsiteY5" fmla="*/ 1342125 h 1342125"/>
              <a:gd name="connsiteX6" fmla="*/ 611 w 9143024"/>
              <a:gd name="connsiteY6" fmla="*/ 1342125 h 1342125"/>
              <a:gd name="connsiteX7" fmla="*/ 982 w 9143024"/>
              <a:gd name="connsiteY7" fmla="*/ 3614 h 1342125"/>
              <a:gd name="connsiteX0" fmla="*/ 982 w 9143024"/>
              <a:gd name="connsiteY0" fmla="*/ 3614 h 1342125"/>
              <a:gd name="connsiteX1" fmla="*/ 673235 w 9143024"/>
              <a:gd name="connsiteY1" fmla="*/ 4763 h 1342125"/>
              <a:gd name="connsiteX2" fmla="*/ 800181 w 9143024"/>
              <a:gd name="connsiteY2" fmla="*/ 238124 h 1342125"/>
              <a:gd name="connsiteX3" fmla="*/ 937554 w 9143024"/>
              <a:gd name="connsiteY3" fmla="*/ 0 h 1342125"/>
              <a:gd name="connsiteX4" fmla="*/ 9143024 w 9143024"/>
              <a:gd name="connsiteY4" fmla="*/ 8377 h 1342125"/>
              <a:gd name="connsiteX5" fmla="*/ 9143024 w 9143024"/>
              <a:gd name="connsiteY5" fmla="*/ 1342125 h 1342125"/>
              <a:gd name="connsiteX6" fmla="*/ 611 w 9143024"/>
              <a:gd name="connsiteY6" fmla="*/ 1342125 h 1342125"/>
              <a:gd name="connsiteX7" fmla="*/ 982 w 9143024"/>
              <a:gd name="connsiteY7" fmla="*/ 3614 h 1342125"/>
              <a:gd name="connsiteX0" fmla="*/ 982 w 9143024"/>
              <a:gd name="connsiteY0" fmla="*/ 3614 h 1342125"/>
              <a:gd name="connsiteX1" fmla="*/ 661329 w 9143024"/>
              <a:gd name="connsiteY1" fmla="*/ 2382 h 1342125"/>
              <a:gd name="connsiteX2" fmla="*/ 800181 w 9143024"/>
              <a:gd name="connsiteY2" fmla="*/ 238124 h 1342125"/>
              <a:gd name="connsiteX3" fmla="*/ 937554 w 9143024"/>
              <a:gd name="connsiteY3" fmla="*/ 0 h 1342125"/>
              <a:gd name="connsiteX4" fmla="*/ 9143024 w 9143024"/>
              <a:gd name="connsiteY4" fmla="*/ 8377 h 1342125"/>
              <a:gd name="connsiteX5" fmla="*/ 9143024 w 9143024"/>
              <a:gd name="connsiteY5" fmla="*/ 1342125 h 1342125"/>
              <a:gd name="connsiteX6" fmla="*/ 611 w 9143024"/>
              <a:gd name="connsiteY6" fmla="*/ 1342125 h 1342125"/>
              <a:gd name="connsiteX7" fmla="*/ 982 w 9143024"/>
              <a:gd name="connsiteY7" fmla="*/ 3614 h 1342125"/>
              <a:gd name="connsiteX0" fmla="*/ 982 w 9143024"/>
              <a:gd name="connsiteY0" fmla="*/ 3614 h 1342125"/>
              <a:gd name="connsiteX1" fmla="*/ 668473 w 9143024"/>
              <a:gd name="connsiteY1" fmla="*/ 2382 h 1342125"/>
              <a:gd name="connsiteX2" fmla="*/ 800181 w 9143024"/>
              <a:gd name="connsiteY2" fmla="*/ 238124 h 1342125"/>
              <a:gd name="connsiteX3" fmla="*/ 937554 w 9143024"/>
              <a:gd name="connsiteY3" fmla="*/ 0 h 1342125"/>
              <a:gd name="connsiteX4" fmla="*/ 9143024 w 9143024"/>
              <a:gd name="connsiteY4" fmla="*/ 8377 h 1342125"/>
              <a:gd name="connsiteX5" fmla="*/ 9143024 w 9143024"/>
              <a:gd name="connsiteY5" fmla="*/ 1342125 h 1342125"/>
              <a:gd name="connsiteX6" fmla="*/ 611 w 9143024"/>
              <a:gd name="connsiteY6" fmla="*/ 1342125 h 1342125"/>
              <a:gd name="connsiteX7" fmla="*/ 982 w 9143024"/>
              <a:gd name="connsiteY7" fmla="*/ 3614 h 1342125"/>
              <a:gd name="connsiteX0" fmla="*/ 982 w 9143024"/>
              <a:gd name="connsiteY0" fmla="*/ 3614 h 1342125"/>
              <a:gd name="connsiteX1" fmla="*/ 668473 w 9143024"/>
              <a:gd name="connsiteY1" fmla="*/ 2382 h 1342125"/>
              <a:gd name="connsiteX2" fmla="*/ 800181 w 9143024"/>
              <a:gd name="connsiteY2" fmla="*/ 238124 h 1342125"/>
              <a:gd name="connsiteX3" fmla="*/ 937554 w 9143024"/>
              <a:gd name="connsiteY3" fmla="*/ 0 h 1342125"/>
              <a:gd name="connsiteX4" fmla="*/ 9143024 w 9143024"/>
              <a:gd name="connsiteY4" fmla="*/ 8377 h 1342125"/>
              <a:gd name="connsiteX5" fmla="*/ 9143024 w 9143024"/>
              <a:gd name="connsiteY5" fmla="*/ 1342125 h 1342125"/>
              <a:gd name="connsiteX6" fmla="*/ 611 w 9143024"/>
              <a:gd name="connsiteY6" fmla="*/ 1342125 h 1342125"/>
              <a:gd name="connsiteX7" fmla="*/ 982 w 9143024"/>
              <a:gd name="connsiteY7" fmla="*/ 3614 h 1342125"/>
              <a:gd name="connsiteX0" fmla="*/ 982 w 9143024"/>
              <a:gd name="connsiteY0" fmla="*/ 3614 h 1342125"/>
              <a:gd name="connsiteX1" fmla="*/ 668473 w 9143024"/>
              <a:gd name="connsiteY1" fmla="*/ 2382 h 1342125"/>
              <a:gd name="connsiteX2" fmla="*/ 804944 w 9143024"/>
              <a:gd name="connsiteY2" fmla="*/ 247649 h 1342125"/>
              <a:gd name="connsiteX3" fmla="*/ 937554 w 9143024"/>
              <a:gd name="connsiteY3" fmla="*/ 0 h 1342125"/>
              <a:gd name="connsiteX4" fmla="*/ 9143024 w 9143024"/>
              <a:gd name="connsiteY4" fmla="*/ 8377 h 1342125"/>
              <a:gd name="connsiteX5" fmla="*/ 9143024 w 9143024"/>
              <a:gd name="connsiteY5" fmla="*/ 1342125 h 1342125"/>
              <a:gd name="connsiteX6" fmla="*/ 611 w 9143024"/>
              <a:gd name="connsiteY6" fmla="*/ 1342125 h 1342125"/>
              <a:gd name="connsiteX7" fmla="*/ 982 w 9143024"/>
              <a:gd name="connsiteY7" fmla="*/ 3614 h 1342125"/>
              <a:gd name="connsiteX0" fmla="*/ 982 w 9143024"/>
              <a:gd name="connsiteY0" fmla="*/ 3614 h 1342125"/>
              <a:gd name="connsiteX1" fmla="*/ 668473 w 9143024"/>
              <a:gd name="connsiteY1" fmla="*/ 2382 h 1342125"/>
              <a:gd name="connsiteX2" fmla="*/ 804944 w 9143024"/>
              <a:gd name="connsiteY2" fmla="*/ 247649 h 1342125"/>
              <a:gd name="connsiteX3" fmla="*/ 937554 w 9143024"/>
              <a:gd name="connsiteY3" fmla="*/ 0 h 1342125"/>
              <a:gd name="connsiteX4" fmla="*/ 9143024 w 9143024"/>
              <a:gd name="connsiteY4" fmla="*/ 8377 h 1342125"/>
              <a:gd name="connsiteX5" fmla="*/ 9143024 w 9143024"/>
              <a:gd name="connsiteY5" fmla="*/ 1342125 h 1342125"/>
              <a:gd name="connsiteX6" fmla="*/ 611 w 9143024"/>
              <a:gd name="connsiteY6" fmla="*/ 1342125 h 1342125"/>
              <a:gd name="connsiteX7" fmla="*/ 982 w 9143024"/>
              <a:gd name="connsiteY7" fmla="*/ 3614 h 1342125"/>
              <a:gd name="connsiteX0" fmla="*/ 982 w 9143024"/>
              <a:gd name="connsiteY0" fmla="*/ 3614 h 1342125"/>
              <a:gd name="connsiteX1" fmla="*/ 668473 w 9143024"/>
              <a:gd name="connsiteY1" fmla="*/ 2382 h 1342125"/>
              <a:gd name="connsiteX2" fmla="*/ 804944 w 9143024"/>
              <a:gd name="connsiteY2" fmla="*/ 247649 h 1342125"/>
              <a:gd name="connsiteX3" fmla="*/ 937554 w 9143024"/>
              <a:gd name="connsiteY3" fmla="*/ 0 h 1342125"/>
              <a:gd name="connsiteX4" fmla="*/ 9143024 w 9143024"/>
              <a:gd name="connsiteY4" fmla="*/ 8377 h 1342125"/>
              <a:gd name="connsiteX5" fmla="*/ 9143024 w 9143024"/>
              <a:gd name="connsiteY5" fmla="*/ 1342125 h 1342125"/>
              <a:gd name="connsiteX6" fmla="*/ 611 w 9143024"/>
              <a:gd name="connsiteY6" fmla="*/ 1342125 h 1342125"/>
              <a:gd name="connsiteX7" fmla="*/ 982 w 9143024"/>
              <a:gd name="connsiteY7" fmla="*/ 3614 h 1342125"/>
              <a:gd name="connsiteX0" fmla="*/ 982 w 9143024"/>
              <a:gd name="connsiteY0" fmla="*/ 3614 h 1342125"/>
              <a:gd name="connsiteX1" fmla="*/ 668473 w 9143024"/>
              <a:gd name="connsiteY1" fmla="*/ 2382 h 1342125"/>
              <a:gd name="connsiteX2" fmla="*/ 804944 w 9143024"/>
              <a:gd name="connsiteY2" fmla="*/ 247649 h 1342125"/>
              <a:gd name="connsiteX3" fmla="*/ 937554 w 9143024"/>
              <a:gd name="connsiteY3" fmla="*/ 0 h 1342125"/>
              <a:gd name="connsiteX4" fmla="*/ 9143024 w 9143024"/>
              <a:gd name="connsiteY4" fmla="*/ 3615 h 1342125"/>
              <a:gd name="connsiteX5" fmla="*/ 9143024 w 9143024"/>
              <a:gd name="connsiteY5" fmla="*/ 1342125 h 1342125"/>
              <a:gd name="connsiteX6" fmla="*/ 611 w 9143024"/>
              <a:gd name="connsiteY6" fmla="*/ 1342125 h 1342125"/>
              <a:gd name="connsiteX7" fmla="*/ 982 w 9143024"/>
              <a:gd name="connsiteY7" fmla="*/ 3614 h 1342125"/>
              <a:gd name="connsiteX0" fmla="*/ 982 w 9143024"/>
              <a:gd name="connsiteY0" fmla="*/ 3614 h 1342125"/>
              <a:gd name="connsiteX1" fmla="*/ 668473 w 9143024"/>
              <a:gd name="connsiteY1" fmla="*/ 2382 h 1342125"/>
              <a:gd name="connsiteX2" fmla="*/ 804944 w 9143024"/>
              <a:gd name="connsiteY2" fmla="*/ 247649 h 1342125"/>
              <a:gd name="connsiteX3" fmla="*/ 937554 w 9143024"/>
              <a:gd name="connsiteY3" fmla="*/ 0 h 1342125"/>
              <a:gd name="connsiteX4" fmla="*/ 9143024 w 9143024"/>
              <a:gd name="connsiteY4" fmla="*/ 3615 h 1342125"/>
              <a:gd name="connsiteX5" fmla="*/ 9143024 w 9143024"/>
              <a:gd name="connsiteY5" fmla="*/ 1342125 h 1342125"/>
              <a:gd name="connsiteX6" fmla="*/ 611 w 9143024"/>
              <a:gd name="connsiteY6" fmla="*/ 1342125 h 1342125"/>
              <a:gd name="connsiteX7" fmla="*/ 982 w 9143024"/>
              <a:gd name="connsiteY7" fmla="*/ 3614 h 1342125"/>
              <a:gd name="connsiteX0" fmla="*/ 982 w 9143024"/>
              <a:gd name="connsiteY0" fmla="*/ 1232 h 1339743"/>
              <a:gd name="connsiteX1" fmla="*/ 668473 w 9143024"/>
              <a:gd name="connsiteY1" fmla="*/ 0 h 1339743"/>
              <a:gd name="connsiteX2" fmla="*/ 804944 w 9143024"/>
              <a:gd name="connsiteY2" fmla="*/ 245267 h 1339743"/>
              <a:gd name="connsiteX3" fmla="*/ 947079 w 9143024"/>
              <a:gd name="connsiteY3" fmla="*/ 0 h 1339743"/>
              <a:gd name="connsiteX4" fmla="*/ 9143024 w 9143024"/>
              <a:gd name="connsiteY4" fmla="*/ 1233 h 1339743"/>
              <a:gd name="connsiteX5" fmla="*/ 9143024 w 9143024"/>
              <a:gd name="connsiteY5" fmla="*/ 1339743 h 1339743"/>
              <a:gd name="connsiteX6" fmla="*/ 611 w 9143024"/>
              <a:gd name="connsiteY6" fmla="*/ 1339743 h 1339743"/>
              <a:gd name="connsiteX7" fmla="*/ 982 w 9143024"/>
              <a:gd name="connsiteY7" fmla="*/ 1232 h 1339743"/>
              <a:gd name="connsiteX0" fmla="*/ 982 w 9143024"/>
              <a:gd name="connsiteY0" fmla="*/ 1232 h 1339743"/>
              <a:gd name="connsiteX1" fmla="*/ 668473 w 9143024"/>
              <a:gd name="connsiteY1" fmla="*/ 0 h 1339743"/>
              <a:gd name="connsiteX2" fmla="*/ 804944 w 9143024"/>
              <a:gd name="connsiteY2" fmla="*/ 245267 h 1339743"/>
              <a:gd name="connsiteX3" fmla="*/ 947079 w 9143024"/>
              <a:gd name="connsiteY3" fmla="*/ 0 h 1339743"/>
              <a:gd name="connsiteX4" fmla="*/ 9143024 w 9143024"/>
              <a:gd name="connsiteY4" fmla="*/ 1233 h 1339743"/>
              <a:gd name="connsiteX5" fmla="*/ 9143024 w 9143024"/>
              <a:gd name="connsiteY5" fmla="*/ 1339743 h 1339743"/>
              <a:gd name="connsiteX6" fmla="*/ 611 w 9143024"/>
              <a:gd name="connsiteY6" fmla="*/ 1339743 h 1339743"/>
              <a:gd name="connsiteX7" fmla="*/ 982 w 9143024"/>
              <a:gd name="connsiteY7" fmla="*/ 1232 h 1339743"/>
              <a:gd name="connsiteX0" fmla="*/ 982 w 9143024"/>
              <a:gd name="connsiteY0" fmla="*/ 1232 h 1339743"/>
              <a:gd name="connsiteX1" fmla="*/ 668473 w 9143024"/>
              <a:gd name="connsiteY1" fmla="*/ 0 h 1339743"/>
              <a:gd name="connsiteX2" fmla="*/ 760230 w 9143024"/>
              <a:gd name="connsiteY2" fmla="*/ 211031 h 1339743"/>
              <a:gd name="connsiteX3" fmla="*/ 804944 w 9143024"/>
              <a:gd name="connsiteY3" fmla="*/ 245267 h 1339743"/>
              <a:gd name="connsiteX4" fmla="*/ 947079 w 9143024"/>
              <a:gd name="connsiteY4" fmla="*/ 0 h 1339743"/>
              <a:gd name="connsiteX5" fmla="*/ 9143024 w 9143024"/>
              <a:gd name="connsiteY5" fmla="*/ 1233 h 1339743"/>
              <a:gd name="connsiteX6" fmla="*/ 9143024 w 9143024"/>
              <a:gd name="connsiteY6" fmla="*/ 1339743 h 1339743"/>
              <a:gd name="connsiteX7" fmla="*/ 611 w 9143024"/>
              <a:gd name="connsiteY7" fmla="*/ 1339743 h 1339743"/>
              <a:gd name="connsiteX8" fmla="*/ 982 w 9143024"/>
              <a:gd name="connsiteY8" fmla="*/ 1232 h 1339743"/>
              <a:gd name="connsiteX0" fmla="*/ 982 w 9143024"/>
              <a:gd name="connsiteY0" fmla="*/ 1232 h 1339743"/>
              <a:gd name="connsiteX1" fmla="*/ 668473 w 9143024"/>
              <a:gd name="connsiteY1" fmla="*/ 0 h 1339743"/>
              <a:gd name="connsiteX2" fmla="*/ 760230 w 9143024"/>
              <a:gd name="connsiteY2" fmla="*/ 211031 h 1339743"/>
              <a:gd name="connsiteX3" fmla="*/ 804944 w 9143024"/>
              <a:gd name="connsiteY3" fmla="*/ 245267 h 1339743"/>
              <a:gd name="connsiteX4" fmla="*/ 836430 w 9143024"/>
              <a:gd name="connsiteY4" fmla="*/ 199124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0230 w 9143024"/>
              <a:gd name="connsiteY2" fmla="*/ 211031 h 1339743"/>
              <a:gd name="connsiteX3" fmla="*/ 804944 w 9143024"/>
              <a:gd name="connsiteY3" fmla="*/ 245267 h 1339743"/>
              <a:gd name="connsiteX4" fmla="*/ 843574 w 9143024"/>
              <a:gd name="connsiteY4" fmla="*/ 213412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0230 w 9143024"/>
              <a:gd name="connsiteY2" fmla="*/ 211031 h 1339743"/>
              <a:gd name="connsiteX3" fmla="*/ 804944 w 9143024"/>
              <a:gd name="connsiteY3" fmla="*/ 245267 h 1339743"/>
              <a:gd name="connsiteX4" fmla="*/ 843574 w 9143024"/>
              <a:gd name="connsiteY4" fmla="*/ 213412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0230 w 9143024"/>
              <a:gd name="connsiteY2" fmla="*/ 211031 h 1339743"/>
              <a:gd name="connsiteX3" fmla="*/ 804944 w 9143024"/>
              <a:gd name="connsiteY3" fmla="*/ 245267 h 1339743"/>
              <a:gd name="connsiteX4" fmla="*/ 843574 w 9143024"/>
              <a:gd name="connsiteY4" fmla="*/ 213412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0230 w 9143024"/>
              <a:gd name="connsiteY2" fmla="*/ 211031 h 1339743"/>
              <a:gd name="connsiteX3" fmla="*/ 804944 w 9143024"/>
              <a:gd name="connsiteY3" fmla="*/ 245267 h 1339743"/>
              <a:gd name="connsiteX4" fmla="*/ 843574 w 9143024"/>
              <a:gd name="connsiteY4" fmla="*/ 213412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0230 w 9143024"/>
              <a:gd name="connsiteY2" fmla="*/ 211031 h 1339743"/>
              <a:gd name="connsiteX3" fmla="*/ 804944 w 9143024"/>
              <a:gd name="connsiteY3" fmla="*/ 245267 h 1339743"/>
              <a:gd name="connsiteX4" fmla="*/ 843574 w 9143024"/>
              <a:gd name="connsiteY4" fmla="*/ 213412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0230 w 9143024"/>
              <a:gd name="connsiteY2" fmla="*/ 211031 h 1339743"/>
              <a:gd name="connsiteX3" fmla="*/ 804944 w 9143024"/>
              <a:gd name="connsiteY3" fmla="*/ 245267 h 1339743"/>
              <a:gd name="connsiteX4" fmla="*/ 843574 w 9143024"/>
              <a:gd name="connsiteY4" fmla="*/ 213412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0230 w 9143024"/>
              <a:gd name="connsiteY2" fmla="*/ 211031 h 1339743"/>
              <a:gd name="connsiteX3" fmla="*/ 804944 w 9143024"/>
              <a:gd name="connsiteY3" fmla="*/ 245267 h 1339743"/>
              <a:gd name="connsiteX4" fmla="*/ 843574 w 9143024"/>
              <a:gd name="connsiteY4" fmla="*/ 213412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0230 w 9143024"/>
              <a:gd name="connsiteY2" fmla="*/ 211031 h 1339743"/>
              <a:gd name="connsiteX3" fmla="*/ 804944 w 9143024"/>
              <a:gd name="connsiteY3" fmla="*/ 245267 h 1339743"/>
              <a:gd name="connsiteX4" fmla="*/ 848337 w 9143024"/>
              <a:gd name="connsiteY4" fmla="*/ 203887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0230 w 9143024"/>
              <a:gd name="connsiteY2" fmla="*/ 211031 h 1339743"/>
              <a:gd name="connsiteX3" fmla="*/ 804944 w 9143024"/>
              <a:gd name="connsiteY3" fmla="*/ 245267 h 1339743"/>
              <a:gd name="connsiteX4" fmla="*/ 848337 w 9143024"/>
              <a:gd name="connsiteY4" fmla="*/ 203887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7374 w 9143024"/>
              <a:gd name="connsiteY2" fmla="*/ 206268 h 1339743"/>
              <a:gd name="connsiteX3" fmla="*/ 804944 w 9143024"/>
              <a:gd name="connsiteY3" fmla="*/ 245267 h 1339743"/>
              <a:gd name="connsiteX4" fmla="*/ 848337 w 9143024"/>
              <a:gd name="connsiteY4" fmla="*/ 203887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7374 w 9143024"/>
              <a:gd name="connsiteY2" fmla="*/ 206268 h 1339743"/>
              <a:gd name="connsiteX3" fmla="*/ 804944 w 9143024"/>
              <a:gd name="connsiteY3" fmla="*/ 245267 h 1339743"/>
              <a:gd name="connsiteX4" fmla="*/ 848337 w 9143024"/>
              <a:gd name="connsiteY4" fmla="*/ 203887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7374 w 9143024"/>
              <a:gd name="connsiteY2" fmla="*/ 206268 h 1339743"/>
              <a:gd name="connsiteX3" fmla="*/ 804944 w 9143024"/>
              <a:gd name="connsiteY3" fmla="*/ 245267 h 1339743"/>
              <a:gd name="connsiteX4" fmla="*/ 848337 w 9143024"/>
              <a:gd name="connsiteY4" fmla="*/ 203887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7374 w 9143024"/>
              <a:gd name="connsiteY2" fmla="*/ 206268 h 1339743"/>
              <a:gd name="connsiteX3" fmla="*/ 804944 w 9143024"/>
              <a:gd name="connsiteY3" fmla="*/ 245267 h 1339743"/>
              <a:gd name="connsiteX4" fmla="*/ 843574 w 9143024"/>
              <a:gd name="connsiteY4" fmla="*/ 199125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7374 w 9143024"/>
              <a:gd name="connsiteY2" fmla="*/ 199124 h 1339743"/>
              <a:gd name="connsiteX3" fmla="*/ 804944 w 9143024"/>
              <a:gd name="connsiteY3" fmla="*/ 245267 h 1339743"/>
              <a:gd name="connsiteX4" fmla="*/ 843574 w 9143024"/>
              <a:gd name="connsiteY4" fmla="*/ 199125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7374 w 9143024"/>
              <a:gd name="connsiteY2" fmla="*/ 199124 h 1339743"/>
              <a:gd name="connsiteX3" fmla="*/ 804944 w 9143024"/>
              <a:gd name="connsiteY3" fmla="*/ 245267 h 1339743"/>
              <a:gd name="connsiteX4" fmla="*/ 843574 w 9143024"/>
              <a:gd name="connsiteY4" fmla="*/ 199125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55468 w 9143024"/>
              <a:gd name="connsiteY2" fmla="*/ 232462 h 1339743"/>
              <a:gd name="connsiteX3" fmla="*/ 804944 w 9143024"/>
              <a:gd name="connsiteY3" fmla="*/ 245267 h 1339743"/>
              <a:gd name="connsiteX4" fmla="*/ 843574 w 9143024"/>
              <a:gd name="connsiteY4" fmla="*/ 199125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4993 w 9143024"/>
              <a:gd name="connsiteY2" fmla="*/ 201506 h 1339743"/>
              <a:gd name="connsiteX3" fmla="*/ 804944 w 9143024"/>
              <a:gd name="connsiteY3" fmla="*/ 245267 h 1339743"/>
              <a:gd name="connsiteX4" fmla="*/ 843574 w 9143024"/>
              <a:gd name="connsiteY4" fmla="*/ 199125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4993 w 9143024"/>
              <a:gd name="connsiteY2" fmla="*/ 201506 h 1339743"/>
              <a:gd name="connsiteX3" fmla="*/ 804944 w 9143024"/>
              <a:gd name="connsiteY3" fmla="*/ 245267 h 1339743"/>
              <a:gd name="connsiteX4" fmla="*/ 843574 w 9143024"/>
              <a:gd name="connsiteY4" fmla="*/ 199125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4993 w 9143024"/>
              <a:gd name="connsiteY2" fmla="*/ 201506 h 1339743"/>
              <a:gd name="connsiteX3" fmla="*/ 804944 w 9143024"/>
              <a:gd name="connsiteY3" fmla="*/ 245267 h 1339743"/>
              <a:gd name="connsiteX4" fmla="*/ 843574 w 9143024"/>
              <a:gd name="connsiteY4" fmla="*/ 199125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4993 w 9143024"/>
              <a:gd name="connsiteY2" fmla="*/ 201506 h 1339743"/>
              <a:gd name="connsiteX3" fmla="*/ 785894 w 9143024"/>
              <a:gd name="connsiteY3" fmla="*/ 245267 h 1339743"/>
              <a:gd name="connsiteX4" fmla="*/ 843574 w 9143024"/>
              <a:gd name="connsiteY4" fmla="*/ 199125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4993 w 9143024"/>
              <a:gd name="connsiteY2" fmla="*/ 201506 h 1339743"/>
              <a:gd name="connsiteX3" fmla="*/ 797800 w 9143024"/>
              <a:gd name="connsiteY3" fmla="*/ 245267 h 1339743"/>
              <a:gd name="connsiteX4" fmla="*/ 843574 w 9143024"/>
              <a:gd name="connsiteY4" fmla="*/ 199125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4993 w 9143024"/>
              <a:gd name="connsiteY2" fmla="*/ 201506 h 1339743"/>
              <a:gd name="connsiteX3" fmla="*/ 797800 w 9143024"/>
              <a:gd name="connsiteY3" fmla="*/ 245267 h 1339743"/>
              <a:gd name="connsiteX4" fmla="*/ 843574 w 9143024"/>
              <a:gd name="connsiteY4" fmla="*/ 199125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4993 w 9143024"/>
              <a:gd name="connsiteY2" fmla="*/ 201506 h 1339743"/>
              <a:gd name="connsiteX3" fmla="*/ 797800 w 9143024"/>
              <a:gd name="connsiteY3" fmla="*/ 245267 h 1339743"/>
              <a:gd name="connsiteX4" fmla="*/ 843574 w 9143024"/>
              <a:gd name="connsiteY4" fmla="*/ 199125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4993 w 9143024"/>
              <a:gd name="connsiteY2" fmla="*/ 201506 h 1339743"/>
              <a:gd name="connsiteX3" fmla="*/ 797800 w 9143024"/>
              <a:gd name="connsiteY3" fmla="*/ 245267 h 1339743"/>
              <a:gd name="connsiteX4" fmla="*/ 843574 w 9143024"/>
              <a:gd name="connsiteY4" fmla="*/ 199125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4993 w 9143024"/>
              <a:gd name="connsiteY2" fmla="*/ 201506 h 1339743"/>
              <a:gd name="connsiteX3" fmla="*/ 802562 w 9143024"/>
              <a:gd name="connsiteY3" fmla="*/ 245267 h 1339743"/>
              <a:gd name="connsiteX4" fmla="*/ 843574 w 9143024"/>
              <a:gd name="connsiteY4" fmla="*/ 199125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4993 w 9143024"/>
              <a:gd name="connsiteY2" fmla="*/ 201506 h 1339743"/>
              <a:gd name="connsiteX3" fmla="*/ 804943 w 9143024"/>
              <a:gd name="connsiteY3" fmla="*/ 242886 h 1339743"/>
              <a:gd name="connsiteX4" fmla="*/ 843574 w 9143024"/>
              <a:gd name="connsiteY4" fmla="*/ 199125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982 w 9143024"/>
              <a:gd name="connsiteY0" fmla="*/ 1232 h 1339743"/>
              <a:gd name="connsiteX1" fmla="*/ 668473 w 9143024"/>
              <a:gd name="connsiteY1" fmla="*/ 0 h 1339743"/>
              <a:gd name="connsiteX2" fmla="*/ 764993 w 9143024"/>
              <a:gd name="connsiteY2" fmla="*/ 201506 h 1339743"/>
              <a:gd name="connsiteX3" fmla="*/ 804943 w 9143024"/>
              <a:gd name="connsiteY3" fmla="*/ 242886 h 1339743"/>
              <a:gd name="connsiteX4" fmla="*/ 843574 w 9143024"/>
              <a:gd name="connsiteY4" fmla="*/ 199125 h 1339743"/>
              <a:gd name="connsiteX5" fmla="*/ 947079 w 9143024"/>
              <a:gd name="connsiteY5" fmla="*/ 0 h 1339743"/>
              <a:gd name="connsiteX6" fmla="*/ 9143024 w 9143024"/>
              <a:gd name="connsiteY6" fmla="*/ 1233 h 1339743"/>
              <a:gd name="connsiteX7" fmla="*/ 9143024 w 9143024"/>
              <a:gd name="connsiteY7" fmla="*/ 1339743 h 1339743"/>
              <a:gd name="connsiteX8" fmla="*/ 611 w 9143024"/>
              <a:gd name="connsiteY8" fmla="*/ 1339743 h 1339743"/>
              <a:gd name="connsiteX9" fmla="*/ 982 w 9143024"/>
              <a:gd name="connsiteY9" fmla="*/ 1232 h 1339743"/>
              <a:gd name="connsiteX0" fmla="*/ 0 w 9142042"/>
              <a:gd name="connsiteY0" fmla="*/ 1232 h 1339743"/>
              <a:gd name="connsiteX1" fmla="*/ 667491 w 9142042"/>
              <a:gd name="connsiteY1" fmla="*/ 0 h 1339743"/>
              <a:gd name="connsiteX2" fmla="*/ 764011 w 9142042"/>
              <a:gd name="connsiteY2" fmla="*/ 201506 h 1339743"/>
              <a:gd name="connsiteX3" fmla="*/ 803961 w 9142042"/>
              <a:gd name="connsiteY3" fmla="*/ 242886 h 1339743"/>
              <a:gd name="connsiteX4" fmla="*/ 842592 w 9142042"/>
              <a:gd name="connsiteY4" fmla="*/ 199125 h 1339743"/>
              <a:gd name="connsiteX5" fmla="*/ 946097 w 9142042"/>
              <a:gd name="connsiteY5" fmla="*/ 0 h 1339743"/>
              <a:gd name="connsiteX6" fmla="*/ 9142042 w 9142042"/>
              <a:gd name="connsiteY6" fmla="*/ 1233 h 1339743"/>
              <a:gd name="connsiteX7" fmla="*/ 9142042 w 9142042"/>
              <a:gd name="connsiteY7" fmla="*/ 1339743 h 1339743"/>
              <a:gd name="connsiteX8" fmla="*/ 121073 w 9142042"/>
              <a:gd name="connsiteY8" fmla="*/ 1215918 h 1339743"/>
              <a:gd name="connsiteX9" fmla="*/ 0 w 9142042"/>
              <a:gd name="connsiteY9" fmla="*/ 1232 h 1339743"/>
              <a:gd name="connsiteX0" fmla="*/ 982 w 9143024"/>
              <a:gd name="connsiteY0" fmla="*/ 1232 h 1342124"/>
              <a:gd name="connsiteX1" fmla="*/ 668473 w 9143024"/>
              <a:gd name="connsiteY1" fmla="*/ 0 h 1342124"/>
              <a:gd name="connsiteX2" fmla="*/ 764993 w 9143024"/>
              <a:gd name="connsiteY2" fmla="*/ 201506 h 1342124"/>
              <a:gd name="connsiteX3" fmla="*/ 804943 w 9143024"/>
              <a:gd name="connsiteY3" fmla="*/ 242886 h 1342124"/>
              <a:gd name="connsiteX4" fmla="*/ 843574 w 9143024"/>
              <a:gd name="connsiteY4" fmla="*/ 199125 h 1342124"/>
              <a:gd name="connsiteX5" fmla="*/ 947079 w 9143024"/>
              <a:gd name="connsiteY5" fmla="*/ 0 h 1342124"/>
              <a:gd name="connsiteX6" fmla="*/ 9143024 w 9143024"/>
              <a:gd name="connsiteY6" fmla="*/ 1233 h 1342124"/>
              <a:gd name="connsiteX7" fmla="*/ 9143024 w 9143024"/>
              <a:gd name="connsiteY7" fmla="*/ 1339743 h 1342124"/>
              <a:gd name="connsiteX8" fmla="*/ 611 w 9143024"/>
              <a:gd name="connsiteY8" fmla="*/ 1342124 h 1342124"/>
              <a:gd name="connsiteX9" fmla="*/ 982 w 9143024"/>
              <a:gd name="connsiteY9" fmla="*/ 1232 h 1342124"/>
              <a:gd name="connsiteX0" fmla="*/ 371 w 9142413"/>
              <a:gd name="connsiteY0" fmla="*/ 1232 h 1342124"/>
              <a:gd name="connsiteX1" fmla="*/ 667862 w 9142413"/>
              <a:gd name="connsiteY1" fmla="*/ 0 h 1342124"/>
              <a:gd name="connsiteX2" fmla="*/ 764382 w 9142413"/>
              <a:gd name="connsiteY2" fmla="*/ 201506 h 1342124"/>
              <a:gd name="connsiteX3" fmla="*/ 804332 w 9142413"/>
              <a:gd name="connsiteY3" fmla="*/ 242886 h 1342124"/>
              <a:gd name="connsiteX4" fmla="*/ 842963 w 9142413"/>
              <a:gd name="connsiteY4" fmla="*/ 199125 h 1342124"/>
              <a:gd name="connsiteX5" fmla="*/ 946468 w 9142413"/>
              <a:gd name="connsiteY5" fmla="*/ 0 h 1342124"/>
              <a:gd name="connsiteX6" fmla="*/ 9142413 w 9142413"/>
              <a:gd name="connsiteY6" fmla="*/ 1233 h 1342124"/>
              <a:gd name="connsiteX7" fmla="*/ 9142413 w 9142413"/>
              <a:gd name="connsiteY7" fmla="*/ 1339743 h 1342124"/>
              <a:gd name="connsiteX8" fmla="*/ 0 w 9142413"/>
              <a:gd name="connsiteY8" fmla="*/ 1342124 h 1342124"/>
              <a:gd name="connsiteX9" fmla="*/ 371 w 9142413"/>
              <a:gd name="connsiteY9" fmla="*/ 1232 h 1342124"/>
              <a:gd name="connsiteX0" fmla="*/ 371 w 9142413"/>
              <a:gd name="connsiteY0" fmla="*/ 1232 h 1342124"/>
              <a:gd name="connsiteX1" fmla="*/ 667862 w 9142413"/>
              <a:gd name="connsiteY1" fmla="*/ 0 h 1342124"/>
              <a:gd name="connsiteX2" fmla="*/ 764382 w 9142413"/>
              <a:gd name="connsiteY2" fmla="*/ 201506 h 1342124"/>
              <a:gd name="connsiteX3" fmla="*/ 804332 w 9142413"/>
              <a:gd name="connsiteY3" fmla="*/ 242886 h 1342124"/>
              <a:gd name="connsiteX4" fmla="*/ 842963 w 9142413"/>
              <a:gd name="connsiteY4" fmla="*/ 199125 h 1342124"/>
              <a:gd name="connsiteX5" fmla="*/ 946468 w 9142413"/>
              <a:gd name="connsiteY5" fmla="*/ 0 h 1342124"/>
              <a:gd name="connsiteX6" fmla="*/ 9142413 w 9142413"/>
              <a:gd name="connsiteY6" fmla="*/ 1233 h 1342124"/>
              <a:gd name="connsiteX7" fmla="*/ 9142413 w 9142413"/>
              <a:gd name="connsiteY7" fmla="*/ 1339743 h 1342124"/>
              <a:gd name="connsiteX8" fmla="*/ 0 w 9142413"/>
              <a:gd name="connsiteY8" fmla="*/ 1342124 h 1342124"/>
              <a:gd name="connsiteX9" fmla="*/ 371 w 9142413"/>
              <a:gd name="connsiteY9" fmla="*/ 1232 h 1342124"/>
              <a:gd name="connsiteX0" fmla="*/ 0 w 9142042"/>
              <a:gd name="connsiteY0" fmla="*/ 1232 h 1339743"/>
              <a:gd name="connsiteX1" fmla="*/ 667491 w 9142042"/>
              <a:gd name="connsiteY1" fmla="*/ 0 h 1339743"/>
              <a:gd name="connsiteX2" fmla="*/ 764011 w 9142042"/>
              <a:gd name="connsiteY2" fmla="*/ 201506 h 1339743"/>
              <a:gd name="connsiteX3" fmla="*/ 803961 w 9142042"/>
              <a:gd name="connsiteY3" fmla="*/ 242886 h 1339743"/>
              <a:gd name="connsiteX4" fmla="*/ 842592 w 9142042"/>
              <a:gd name="connsiteY4" fmla="*/ 199125 h 1339743"/>
              <a:gd name="connsiteX5" fmla="*/ 946097 w 9142042"/>
              <a:gd name="connsiteY5" fmla="*/ 0 h 1339743"/>
              <a:gd name="connsiteX6" fmla="*/ 9142042 w 9142042"/>
              <a:gd name="connsiteY6" fmla="*/ 1233 h 1339743"/>
              <a:gd name="connsiteX7" fmla="*/ 9142042 w 9142042"/>
              <a:gd name="connsiteY7" fmla="*/ 1339743 h 1339743"/>
              <a:gd name="connsiteX8" fmla="*/ 97260 w 9142042"/>
              <a:gd name="connsiteY8" fmla="*/ 1177817 h 1339743"/>
              <a:gd name="connsiteX9" fmla="*/ 0 w 9142042"/>
              <a:gd name="connsiteY9" fmla="*/ 1232 h 1339743"/>
              <a:gd name="connsiteX0" fmla="*/ 0 w 9142042"/>
              <a:gd name="connsiteY0" fmla="*/ 1232 h 1342124"/>
              <a:gd name="connsiteX1" fmla="*/ 667491 w 9142042"/>
              <a:gd name="connsiteY1" fmla="*/ 0 h 1342124"/>
              <a:gd name="connsiteX2" fmla="*/ 764011 w 9142042"/>
              <a:gd name="connsiteY2" fmla="*/ 201506 h 1342124"/>
              <a:gd name="connsiteX3" fmla="*/ 803961 w 9142042"/>
              <a:gd name="connsiteY3" fmla="*/ 242886 h 1342124"/>
              <a:gd name="connsiteX4" fmla="*/ 842592 w 9142042"/>
              <a:gd name="connsiteY4" fmla="*/ 199125 h 1342124"/>
              <a:gd name="connsiteX5" fmla="*/ 946097 w 9142042"/>
              <a:gd name="connsiteY5" fmla="*/ 0 h 1342124"/>
              <a:gd name="connsiteX6" fmla="*/ 9142042 w 9142042"/>
              <a:gd name="connsiteY6" fmla="*/ 1233 h 1342124"/>
              <a:gd name="connsiteX7" fmla="*/ 9142042 w 9142042"/>
              <a:gd name="connsiteY7" fmla="*/ 1339743 h 1342124"/>
              <a:gd name="connsiteX8" fmla="*/ 2010 w 9142042"/>
              <a:gd name="connsiteY8" fmla="*/ 1342124 h 1342124"/>
              <a:gd name="connsiteX9" fmla="*/ 0 w 9142042"/>
              <a:gd name="connsiteY9" fmla="*/ 1232 h 1342124"/>
              <a:gd name="connsiteX0" fmla="*/ 0 w 9142042"/>
              <a:gd name="connsiteY0" fmla="*/ 1232 h 1342124"/>
              <a:gd name="connsiteX1" fmla="*/ 667491 w 9142042"/>
              <a:gd name="connsiteY1" fmla="*/ 0 h 1342124"/>
              <a:gd name="connsiteX2" fmla="*/ 764011 w 9142042"/>
              <a:gd name="connsiteY2" fmla="*/ 201506 h 1342124"/>
              <a:gd name="connsiteX3" fmla="*/ 803961 w 9142042"/>
              <a:gd name="connsiteY3" fmla="*/ 242886 h 1342124"/>
              <a:gd name="connsiteX4" fmla="*/ 842592 w 9142042"/>
              <a:gd name="connsiteY4" fmla="*/ 199125 h 1342124"/>
              <a:gd name="connsiteX5" fmla="*/ 946097 w 9142042"/>
              <a:gd name="connsiteY5" fmla="*/ 0 h 1342124"/>
              <a:gd name="connsiteX6" fmla="*/ 9142042 w 9142042"/>
              <a:gd name="connsiteY6" fmla="*/ 1233 h 1342124"/>
              <a:gd name="connsiteX7" fmla="*/ 9142042 w 9142042"/>
              <a:gd name="connsiteY7" fmla="*/ 1339743 h 1342124"/>
              <a:gd name="connsiteX8" fmla="*/ 2010 w 9142042"/>
              <a:gd name="connsiteY8" fmla="*/ 1342124 h 1342124"/>
              <a:gd name="connsiteX9" fmla="*/ 0 w 9142042"/>
              <a:gd name="connsiteY9" fmla="*/ 1232 h 1342124"/>
              <a:gd name="connsiteX0" fmla="*/ 0 w 9142042"/>
              <a:gd name="connsiteY0" fmla="*/ 1232 h 1342124"/>
              <a:gd name="connsiteX1" fmla="*/ 667491 w 9142042"/>
              <a:gd name="connsiteY1" fmla="*/ 0 h 1342124"/>
              <a:gd name="connsiteX2" fmla="*/ 764011 w 9142042"/>
              <a:gd name="connsiteY2" fmla="*/ 201506 h 1342124"/>
              <a:gd name="connsiteX3" fmla="*/ 803961 w 9142042"/>
              <a:gd name="connsiteY3" fmla="*/ 242886 h 1342124"/>
              <a:gd name="connsiteX4" fmla="*/ 842592 w 9142042"/>
              <a:gd name="connsiteY4" fmla="*/ 199125 h 1342124"/>
              <a:gd name="connsiteX5" fmla="*/ 946097 w 9142042"/>
              <a:gd name="connsiteY5" fmla="*/ 0 h 1342124"/>
              <a:gd name="connsiteX6" fmla="*/ 9142042 w 9142042"/>
              <a:gd name="connsiteY6" fmla="*/ 1233 h 1342124"/>
              <a:gd name="connsiteX7" fmla="*/ 9142042 w 9142042"/>
              <a:gd name="connsiteY7" fmla="*/ 1339743 h 1342124"/>
              <a:gd name="connsiteX8" fmla="*/ 2010 w 9142042"/>
              <a:gd name="connsiteY8" fmla="*/ 1342124 h 1342124"/>
              <a:gd name="connsiteX9" fmla="*/ 0 w 9142042"/>
              <a:gd name="connsiteY9" fmla="*/ 1232 h 1342124"/>
              <a:gd name="connsiteX0" fmla="*/ 0 w 9142042"/>
              <a:gd name="connsiteY0" fmla="*/ 1232 h 1342124"/>
              <a:gd name="connsiteX1" fmla="*/ 667491 w 9142042"/>
              <a:gd name="connsiteY1" fmla="*/ 0 h 1342124"/>
              <a:gd name="connsiteX2" fmla="*/ 764011 w 9142042"/>
              <a:gd name="connsiteY2" fmla="*/ 201506 h 1342124"/>
              <a:gd name="connsiteX3" fmla="*/ 803961 w 9142042"/>
              <a:gd name="connsiteY3" fmla="*/ 242886 h 1342124"/>
              <a:gd name="connsiteX4" fmla="*/ 842592 w 9142042"/>
              <a:gd name="connsiteY4" fmla="*/ 199125 h 1342124"/>
              <a:gd name="connsiteX5" fmla="*/ 946097 w 9142042"/>
              <a:gd name="connsiteY5" fmla="*/ 0 h 1342124"/>
              <a:gd name="connsiteX6" fmla="*/ 9142042 w 9142042"/>
              <a:gd name="connsiteY6" fmla="*/ 1233 h 1342124"/>
              <a:gd name="connsiteX7" fmla="*/ 9142042 w 9142042"/>
              <a:gd name="connsiteY7" fmla="*/ 1339743 h 1342124"/>
              <a:gd name="connsiteX8" fmla="*/ 2010 w 9142042"/>
              <a:gd name="connsiteY8" fmla="*/ 1342124 h 1342124"/>
              <a:gd name="connsiteX9" fmla="*/ 0 w 9142042"/>
              <a:gd name="connsiteY9" fmla="*/ 1232 h 1342124"/>
              <a:gd name="connsiteX0" fmla="*/ 0 w 9142042"/>
              <a:gd name="connsiteY0" fmla="*/ 1232 h 1342124"/>
              <a:gd name="connsiteX1" fmla="*/ 667491 w 9142042"/>
              <a:gd name="connsiteY1" fmla="*/ 0 h 1342124"/>
              <a:gd name="connsiteX2" fmla="*/ 764011 w 9142042"/>
              <a:gd name="connsiteY2" fmla="*/ 201506 h 1342124"/>
              <a:gd name="connsiteX3" fmla="*/ 803961 w 9142042"/>
              <a:gd name="connsiteY3" fmla="*/ 242886 h 1342124"/>
              <a:gd name="connsiteX4" fmla="*/ 842592 w 9142042"/>
              <a:gd name="connsiteY4" fmla="*/ 199125 h 1342124"/>
              <a:gd name="connsiteX5" fmla="*/ 946097 w 9142042"/>
              <a:gd name="connsiteY5" fmla="*/ 0 h 1342124"/>
              <a:gd name="connsiteX6" fmla="*/ 9142042 w 9142042"/>
              <a:gd name="connsiteY6" fmla="*/ 1233 h 1342124"/>
              <a:gd name="connsiteX7" fmla="*/ 9142042 w 9142042"/>
              <a:gd name="connsiteY7" fmla="*/ 1339743 h 1342124"/>
              <a:gd name="connsiteX8" fmla="*/ 2010 w 9142042"/>
              <a:gd name="connsiteY8" fmla="*/ 1342124 h 1342124"/>
              <a:gd name="connsiteX9" fmla="*/ 0 w 9142042"/>
              <a:gd name="connsiteY9" fmla="*/ 1232 h 1342124"/>
              <a:gd name="connsiteX0" fmla="*/ 0 w 9142042"/>
              <a:gd name="connsiteY0" fmla="*/ 1232 h 1342124"/>
              <a:gd name="connsiteX1" fmla="*/ 667491 w 9142042"/>
              <a:gd name="connsiteY1" fmla="*/ 0 h 1342124"/>
              <a:gd name="connsiteX2" fmla="*/ 764011 w 9142042"/>
              <a:gd name="connsiteY2" fmla="*/ 201506 h 1342124"/>
              <a:gd name="connsiteX3" fmla="*/ 803961 w 9142042"/>
              <a:gd name="connsiteY3" fmla="*/ 242886 h 1342124"/>
              <a:gd name="connsiteX4" fmla="*/ 842592 w 9142042"/>
              <a:gd name="connsiteY4" fmla="*/ 199125 h 1342124"/>
              <a:gd name="connsiteX5" fmla="*/ 946097 w 9142042"/>
              <a:gd name="connsiteY5" fmla="*/ 0 h 1342124"/>
              <a:gd name="connsiteX6" fmla="*/ 9142042 w 9142042"/>
              <a:gd name="connsiteY6" fmla="*/ 1233 h 1342124"/>
              <a:gd name="connsiteX7" fmla="*/ 9142042 w 9142042"/>
              <a:gd name="connsiteY7" fmla="*/ 1339743 h 1342124"/>
              <a:gd name="connsiteX8" fmla="*/ 2010 w 9142042"/>
              <a:gd name="connsiteY8" fmla="*/ 1342124 h 1342124"/>
              <a:gd name="connsiteX9" fmla="*/ 0 w 9142042"/>
              <a:gd name="connsiteY9" fmla="*/ 1232 h 134212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9142042" h="1342124">
                <a:moveTo>
                  <a:pt x="0" y="1232"/>
                </a:moveTo>
                <a:lnTo>
                  <a:pt x="667491" y="0"/>
                </a:lnTo>
                <a:cubicBezTo>
                  <a:pt x="720213" y="108785"/>
                  <a:pt x="750791" y="175313"/>
                  <a:pt x="764011" y="201506"/>
                </a:cubicBezTo>
                <a:cubicBezTo>
                  <a:pt x="777231" y="227699"/>
                  <a:pt x="783720" y="243371"/>
                  <a:pt x="803961" y="242886"/>
                </a:cubicBezTo>
                <a:cubicBezTo>
                  <a:pt x="814677" y="242629"/>
                  <a:pt x="828428" y="227700"/>
                  <a:pt x="842592" y="199125"/>
                </a:cubicBezTo>
                <a:cubicBezTo>
                  <a:pt x="856756" y="170550"/>
                  <a:pt x="880877" y="123469"/>
                  <a:pt x="946097" y="0"/>
                </a:cubicBezTo>
                <a:lnTo>
                  <a:pt x="9142042" y="1233"/>
                </a:lnTo>
                <a:lnTo>
                  <a:pt x="9142042" y="1339743"/>
                </a:lnTo>
                <a:lnTo>
                  <a:pt x="2010" y="1342124"/>
                </a:lnTo>
                <a:cubicBezTo>
                  <a:pt x="-247" y="945166"/>
                  <a:pt x="2258" y="445815"/>
                  <a:pt x="0" y="1232"/>
                </a:cubicBezTo>
                <a:close/>
              </a:path>
            </a:pathLst>
          </a:custGeom>
        </p:spPr>
        <p:txBody>
          <a:bodyPr anchor="ctr" anchorCtr="0"/>
          <a:lstStyle>
            <a:lvl1pPr marL="0" indent="0" algn="ctr">
              <a:buNone/>
              <a:defRPr/>
            </a:lvl1pPr>
          </a:lstStyle>
          <a:p>
            <a:r>
              <a:rPr lang="en-US"/>
              <a:t>Click icon to add picture</a:t>
            </a:r>
          </a:p>
        </p:txBody>
      </p:sp>
      <p:sp>
        <p:nvSpPr>
          <p:cNvPr id="6" name="Text Placeholder 5"/>
          <p:cNvSpPr>
            <a:spLocks noGrp="1"/>
          </p:cNvSpPr>
          <p:nvPr>
            <p:ph type="body" sz="quarter" idx="11"/>
          </p:nvPr>
        </p:nvSpPr>
        <p:spPr>
          <a:xfrm>
            <a:off x="6675968" y="608490"/>
            <a:ext cx="4906433" cy="323165"/>
          </a:xfrm>
        </p:spPr>
        <p:txBody>
          <a:bodyPr anchor="ctr" anchorCtr="0">
            <a:spAutoFit/>
          </a:bodyPr>
          <a:lstStyle>
            <a:lvl1pPr marL="0" indent="0" algn="r">
              <a:buNone/>
              <a:defRPr sz="2100">
                <a:solidFill>
                  <a:schemeClr val="bg1"/>
                </a:solidFill>
              </a:defRPr>
            </a:lvl1pPr>
            <a:lvl2pPr marL="306910" indent="0">
              <a:buNone/>
              <a:defRPr/>
            </a:lvl2pPr>
          </a:lstStyle>
          <a:p>
            <a:pPr lvl="0"/>
            <a:r>
              <a:rPr lang="en-US"/>
              <a:t>Click to edit Master text styles</a:t>
            </a:r>
          </a:p>
        </p:txBody>
      </p:sp>
    </p:spTree>
    <p:extLst>
      <p:ext uri="{BB962C8B-B14F-4D97-AF65-F5344CB8AC3E}">
        <p14:creationId xmlns:p14="http://schemas.microsoft.com/office/powerpoint/2010/main" val="1802042577"/>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userDrawn="1">
  <p:cSld name="1_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609599" y="1048512"/>
            <a:ext cx="10972803" cy="418576"/>
          </a:xfrm>
        </p:spPr>
        <p:txBody>
          <a:bodyPr vert="horz" lIns="0" tIns="0" rIns="0" bIns="0" rtlCol="0" anchor="b" anchorCtr="0">
            <a:noAutofit/>
          </a:bodyPr>
          <a:lstStyle>
            <a:lvl1pPr>
              <a:defRPr lang="en-US" sz="3200" b="1" i="0" kern="1200" cap="none" dirty="0">
                <a:solidFill>
                  <a:schemeClr val="tx2"/>
                </a:solidFill>
                <a:latin typeface="+mj-lt"/>
                <a:ea typeface="+mj-ea"/>
                <a:cs typeface="+mj-cs"/>
              </a:defRPr>
            </a:lvl1pPr>
          </a:lstStyle>
          <a:p>
            <a:pPr lvl="0" algn="l" defTabSz="457189" rtl="0" eaLnBrk="1" latinLnBrk="0" hangingPunct="1">
              <a:lnSpc>
                <a:spcPct val="85000"/>
              </a:lnSpc>
              <a:spcBef>
                <a:spcPct val="0"/>
              </a:spcBef>
              <a:buNone/>
            </a:pPr>
            <a:r>
              <a:rPr lang="en-US"/>
              <a:t>Click to edit Master title style</a:t>
            </a:r>
          </a:p>
        </p:txBody>
      </p:sp>
      <p:sp>
        <p:nvSpPr>
          <p:cNvPr id="9" name="Content Placeholder 8"/>
          <p:cNvSpPr>
            <a:spLocks noGrp="1"/>
          </p:cNvSpPr>
          <p:nvPr>
            <p:ph sz="quarter" idx="13"/>
          </p:nvPr>
        </p:nvSpPr>
        <p:spPr>
          <a:xfrm>
            <a:off x="609600" y="1780032"/>
            <a:ext cx="10972801" cy="4036568"/>
          </a:xfrm>
        </p:spPr>
        <p:txBody>
          <a:bodyPr vert="horz" lIns="0" tIns="0" rIns="0" bIns="0" rtlCol="0">
            <a:noAutofit/>
          </a:bodyPr>
          <a:lstStyle>
            <a:lvl1pPr>
              <a:defRPr lang="en-US" dirty="0" smtClean="0"/>
            </a:lvl1pPr>
            <a:lvl2pPr>
              <a:defRPr lang="en-US" dirty="0" smtClean="0"/>
            </a:lvl2pPr>
            <a:lvl3pPr>
              <a:defRPr lang="en-US" dirty="0" smtClean="0"/>
            </a:lvl3pPr>
            <a:lvl4pPr>
              <a:defRPr lang="en-US" dirty="0" smtClean="0"/>
            </a:lvl4pPr>
            <a:lvl5pPr>
              <a:defRPr lang="en-US" dirty="0"/>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4"/>
          <p:cNvSpPr>
            <a:spLocks noGrp="1"/>
          </p:cNvSpPr>
          <p:nvPr>
            <p:ph type="ftr" sz="quarter" idx="3"/>
          </p:nvPr>
        </p:nvSpPr>
        <p:spPr>
          <a:xfrm>
            <a:off x="1026597" y="6465181"/>
            <a:ext cx="4517089" cy="169277"/>
          </a:xfrm>
          <a:prstGeom prst="rect">
            <a:avLst/>
          </a:prstGeom>
        </p:spPr>
        <p:txBody>
          <a:bodyPr vert="horz" wrap="square" lIns="0" tIns="0" rIns="0" bIns="0" rtlCol="0" anchor="ctr">
            <a:spAutoFit/>
          </a:bodyPr>
          <a:lstStyle>
            <a:lvl1pPr algn="l">
              <a:defRPr sz="1100">
                <a:solidFill>
                  <a:schemeClr val="tx1"/>
                </a:solidFill>
              </a:defRPr>
            </a:lvl1pPr>
          </a:lstStyle>
          <a:p>
            <a:r>
              <a:rPr lang="en-US"/>
              <a:t>Division Name or Footer</a:t>
            </a:r>
          </a:p>
        </p:txBody>
      </p:sp>
      <p:sp>
        <p:nvSpPr>
          <p:cNvPr id="7" name="Slide Number Placeholder 5"/>
          <p:cNvSpPr>
            <a:spLocks noGrp="1"/>
          </p:cNvSpPr>
          <p:nvPr>
            <p:ph type="sldNum" sz="quarter" idx="4"/>
          </p:nvPr>
        </p:nvSpPr>
        <p:spPr>
          <a:xfrm>
            <a:off x="609601" y="6455138"/>
            <a:ext cx="339625" cy="169277"/>
          </a:xfrm>
          <a:prstGeom prst="rect">
            <a:avLst/>
          </a:prstGeom>
        </p:spPr>
        <p:txBody>
          <a:bodyPr vert="horz" wrap="square" lIns="0" tIns="0" rIns="0" bIns="0" rtlCol="0" anchor="ctr">
            <a:spAutoFit/>
          </a:bodyPr>
          <a:lstStyle>
            <a:lvl1pPr algn="l">
              <a:defRPr sz="1100">
                <a:solidFill>
                  <a:schemeClr val="tx1"/>
                </a:solidFill>
              </a:defRPr>
            </a:lvl1pPr>
          </a:lstStyle>
          <a:p>
            <a:fld id="{7FEEEA1A-CB49-3744-AA40-B896987410F9}" type="slidenum">
              <a:rPr lang="en-US" smtClean="0"/>
              <a:pPr/>
              <a:t>‹#›</a:t>
            </a:fld>
            <a:endParaRPr lang="en-US"/>
          </a:p>
        </p:txBody>
      </p:sp>
    </p:spTree>
    <p:extLst>
      <p:ext uri="{BB962C8B-B14F-4D97-AF65-F5344CB8AC3E}">
        <p14:creationId xmlns:p14="http://schemas.microsoft.com/office/powerpoint/2010/main" val="1133491212"/>
      </p:ext>
    </p:extLst>
  </p:cSld>
  <p:clrMapOvr>
    <a:masterClrMapping/>
  </p:clrMapOvr>
  <p:extLst>
    <p:ext uri="{DCECCB84-F9BA-43D5-87BE-67443E8EF086}">
      <p15:sldGuideLst xmlns:p15="http://schemas.microsoft.com/office/powerpoint/2012/main">
        <p15:guide id="1" orient="horz" pos="3824" userDrawn="1">
          <p15:clr>
            <a:srgbClr val="FBAE40"/>
          </p15:clr>
        </p15:guide>
        <p15:guide id="2" pos="3840" userDrawn="1">
          <p15:clr>
            <a:srgbClr val="FBAE40"/>
          </p15:clr>
        </p15:guide>
        <p15:guide id="4" pos="576" userDrawn="1">
          <p15:clr>
            <a:srgbClr val="FBAE40"/>
          </p15:clr>
        </p15:guide>
      </p15:sldGuideLst>
    </p:ext>
  </p:extLst>
</p:sldLayout>
</file>

<file path=ppt/slideLayouts/slideLayout14.xml><?xml version="1.0" encoding="utf-8"?>
<p:sldLayout xmlns:a="http://schemas.openxmlformats.org/drawingml/2006/main" xmlns:r="http://schemas.openxmlformats.org/officeDocument/2006/relationships" xmlns:p="http://schemas.openxmlformats.org/presentationml/2006/main" showMasterSp="0" preserve="1" userDrawn="1">
  <p:cSld name="1_Section Header">
    <p:bg>
      <p:bgPr>
        <a:solidFill>
          <a:schemeClr val="tx2"/>
        </a:solidFill>
        <a:effectLst/>
      </p:bgPr>
    </p:bg>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917363" y="1949471"/>
            <a:ext cx="10685412" cy="4088141"/>
          </a:xfrm>
        </p:spPr>
        <p:txBody>
          <a:bodyPr anchor="b" anchorCtr="0">
            <a:noAutofit/>
          </a:bodyPr>
          <a:lstStyle>
            <a:lvl1pPr algn="l">
              <a:defRPr sz="7200" b="1" cap="all">
                <a:solidFill>
                  <a:srgbClr val="FFFFFF"/>
                </a:solidFill>
              </a:defRPr>
            </a:lvl1pPr>
          </a:lstStyle>
          <a:p>
            <a:r>
              <a:rPr lang="en-US"/>
              <a:t>Click to edit Master title </a:t>
            </a:r>
            <a:br>
              <a:rPr lang="en-US"/>
            </a:br>
            <a:r>
              <a:rPr lang="en-US"/>
              <a:t>style</a:t>
            </a:r>
          </a:p>
        </p:txBody>
      </p:sp>
      <p:sp>
        <p:nvSpPr>
          <p:cNvPr id="4" name="Freeform 5"/>
          <p:cNvSpPr>
            <a:spLocks noEditPoints="1"/>
          </p:cNvSpPr>
          <p:nvPr userDrawn="1"/>
        </p:nvSpPr>
        <p:spPr bwMode="auto">
          <a:xfrm>
            <a:off x="10559823" y="6163226"/>
            <a:ext cx="1022352" cy="446447"/>
          </a:xfrm>
          <a:custGeom>
            <a:avLst/>
            <a:gdLst>
              <a:gd name="T0" fmla="*/ 32 w 511"/>
              <a:gd name="T1" fmla="*/ 39 h 221"/>
              <a:gd name="T2" fmla="*/ 106 w 511"/>
              <a:gd name="T3" fmla="*/ 0 h 221"/>
              <a:gd name="T4" fmla="*/ 188 w 511"/>
              <a:gd name="T5" fmla="*/ 44 h 221"/>
              <a:gd name="T6" fmla="*/ 139 w 511"/>
              <a:gd name="T7" fmla="*/ 208 h 221"/>
              <a:gd name="T8" fmla="*/ 161 w 511"/>
              <a:gd name="T9" fmla="*/ 194 h 221"/>
              <a:gd name="T10" fmla="*/ 2 w 511"/>
              <a:gd name="T11" fmla="*/ 101 h 221"/>
              <a:gd name="T12" fmla="*/ 91 w 511"/>
              <a:gd name="T13" fmla="*/ 70 h 221"/>
              <a:gd name="T14" fmla="*/ 123 w 511"/>
              <a:gd name="T15" fmla="*/ 108 h 221"/>
              <a:gd name="T16" fmla="*/ 208 w 511"/>
              <a:gd name="T17" fmla="*/ 70 h 221"/>
              <a:gd name="T18" fmla="*/ 73 w 511"/>
              <a:gd name="T19" fmla="*/ 70 h 221"/>
              <a:gd name="T20" fmla="*/ 53 w 511"/>
              <a:gd name="T21" fmla="*/ 96 h 221"/>
              <a:gd name="T22" fmla="*/ 54 w 511"/>
              <a:gd name="T23" fmla="*/ 70 h 221"/>
              <a:gd name="T24" fmla="*/ 144 w 511"/>
              <a:gd name="T25" fmla="*/ 70 h 221"/>
              <a:gd name="T26" fmla="*/ 175 w 511"/>
              <a:gd name="T27" fmla="*/ 70 h 221"/>
              <a:gd name="T28" fmla="*/ 267 w 511"/>
              <a:gd name="T29" fmla="*/ 206 h 221"/>
              <a:gd name="T30" fmla="*/ 267 w 511"/>
              <a:gd name="T31" fmla="*/ 193 h 221"/>
              <a:gd name="T32" fmla="*/ 259 w 511"/>
              <a:gd name="T33" fmla="*/ 199 h 221"/>
              <a:gd name="T34" fmla="*/ 416 w 511"/>
              <a:gd name="T35" fmla="*/ 92 h 221"/>
              <a:gd name="T36" fmla="*/ 402 w 511"/>
              <a:gd name="T37" fmla="*/ 86 h 221"/>
              <a:gd name="T38" fmla="*/ 402 w 511"/>
              <a:gd name="T39" fmla="*/ 123 h 221"/>
              <a:gd name="T40" fmla="*/ 397 w 511"/>
              <a:gd name="T41" fmla="*/ 184 h 221"/>
              <a:gd name="T42" fmla="*/ 373 w 511"/>
              <a:gd name="T43" fmla="*/ 152 h 221"/>
              <a:gd name="T44" fmla="*/ 511 w 511"/>
              <a:gd name="T45" fmla="*/ 124 h 221"/>
              <a:gd name="T46" fmla="*/ 511 w 511"/>
              <a:gd name="T47" fmla="*/ 111 h 221"/>
              <a:gd name="T48" fmla="*/ 503 w 511"/>
              <a:gd name="T49" fmla="*/ 117 h 221"/>
              <a:gd name="T50" fmla="*/ 487 w 511"/>
              <a:gd name="T51" fmla="*/ 105 h 221"/>
              <a:gd name="T52" fmla="*/ 450 w 511"/>
              <a:gd name="T53" fmla="*/ 98 h 221"/>
              <a:gd name="T54" fmla="*/ 443 w 511"/>
              <a:gd name="T55" fmla="*/ 87 h 221"/>
              <a:gd name="T56" fmla="*/ 366 w 511"/>
              <a:gd name="T57" fmla="*/ 169 h 221"/>
              <a:gd name="T58" fmla="*/ 365 w 511"/>
              <a:gd name="T59" fmla="*/ 205 h 221"/>
              <a:gd name="T60" fmla="*/ 343 w 511"/>
              <a:gd name="T61" fmla="*/ 203 h 221"/>
              <a:gd name="T62" fmla="*/ 343 w 511"/>
              <a:gd name="T63" fmla="*/ 156 h 221"/>
              <a:gd name="T64" fmla="*/ 318 w 511"/>
              <a:gd name="T65" fmla="*/ 133 h 221"/>
              <a:gd name="T66" fmla="*/ 294 w 511"/>
              <a:gd name="T67" fmla="*/ 133 h 221"/>
              <a:gd name="T68" fmla="*/ 332 w 511"/>
              <a:gd name="T69" fmla="*/ 98 h 221"/>
              <a:gd name="T70" fmla="*/ 271 w 511"/>
              <a:gd name="T71" fmla="*/ 103 h 221"/>
              <a:gd name="T72" fmla="*/ 249 w 511"/>
              <a:gd name="T73" fmla="*/ 94 h 221"/>
              <a:gd name="T74" fmla="*/ 286 w 511"/>
              <a:gd name="T75" fmla="*/ 132 h 221"/>
              <a:gd name="T76" fmla="*/ 261 w 511"/>
              <a:gd name="T77" fmla="*/ 119 h 221"/>
              <a:gd name="T78" fmla="*/ 311 w 511"/>
              <a:gd name="T79" fmla="*/ 215 h 221"/>
              <a:gd name="T80" fmla="*/ 272 w 511"/>
              <a:gd name="T81" fmla="*/ 203 h 221"/>
              <a:gd name="T82" fmla="*/ 280 w 511"/>
              <a:gd name="T83" fmla="*/ 184 h 221"/>
              <a:gd name="T84" fmla="*/ 309 w 511"/>
              <a:gd name="T85" fmla="*/ 203 h 221"/>
              <a:gd name="T86" fmla="*/ 296 w 511"/>
              <a:gd name="T87" fmla="*/ 201 h 221"/>
              <a:gd name="T88" fmla="*/ 318 w 511"/>
              <a:gd name="T89" fmla="*/ 215 h 221"/>
              <a:gd name="T90" fmla="*/ 208 w 511"/>
              <a:gd name="T91" fmla="*/ 215 h 221"/>
              <a:gd name="T92" fmla="*/ 174 w 511"/>
              <a:gd name="T93" fmla="*/ 153 h 221"/>
              <a:gd name="T94" fmla="*/ 342 w 511"/>
              <a:gd name="T95" fmla="*/ 130 h 221"/>
              <a:gd name="T96" fmla="*/ 370 w 511"/>
              <a:gd name="T97" fmla="*/ 90 h 221"/>
              <a:gd name="T98" fmla="*/ 374 w 511"/>
              <a:gd name="T99" fmla="*/ 98 h 221"/>
              <a:gd name="T100" fmla="*/ 354 w 511"/>
              <a:gd name="T101" fmla="*/ 122 h 221"/>
              <a:gd name="T102" fmla="*/ 342 w 511"/>
              <a:gd name="T103" fmla="*/ 130 h 221"/>
              <a:gd name="T104" fmla="*/ 352 w 511"/>
              <a:gd name="T105" fmla="*/ 103 h 221"/>
              <a:gd name="T106" fmla="*/ 351 w 511"/>
              <a:gd name="T107" fmla="*/ 133 h 221"/>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Lst>
            <a:rect l="0" t="0" r="r" b="b"/>
            <a:pathLst>
              <a:path w="511" h="221">
                <a:moveTo>
                  <a:pt x="188" y="44"/>
                </a:moveTo>
                <a:cubicBezTo>
                  <a:pt x="188" y="44"/>
                  <a:pt x="187" y="44"/>
                  <a:pt x="186" y="43"/>
                </a:cubicBezTo>
                <a:cubicBezTo>
                  <a:pt x="185" y="42"/>
                  <a:pt x="179" y="36"/>
                  <a:pt x="169" y="30"/>
                </a:cubicBezTo>
                <a:cubicBezTo>
                  <a:pt x="159" y="24"/>
                  <a:pt x="137" y="13"/>
                  <a:pt x="107" y="13"/>
                </a:cubicBezTo>
                <a:cubicBezTo>
                  <a:pt x="71" y="13"/>
                  <a:pt x="47" y="27"/>
                  <a:pt x="32" y="39"/>
                </a:cubicBezTo>
                <a:cubicBezTo>
                  <a:pt x="18" y="51"/>
                  <a:pt x="11" y="65"/>
                  <a:pt x="11" y="66"/>
                </a:cubicBezTo>
                <a:cubicBezTo>
                  <a:pt x="11" y="66"/>
                  <a:pt x="11" y="66"/>
                  <a:pt x="10" y="66"/>
                </a:cubicBezTo>
                <a:cubicBezTo>
                  <a:pt x="10" y="66"/>
                  <a:pt x="10" y="66"/>
                  <a:pt x="10" y="66"/>
                </a:cubicBezTo>
                <a:cubicBezTo>
                  <a:pt x="11" y="65"/>
                  <a:pt x="17" y="49"/>
                  <a:pt x="30" y="35"/>
                </a:cubicBezTo>
                <a:cubicBezTo>
                  <a:pt x="43" y="20"/>
                  <a:pt x="69" y="0"/>
                  <a:pt x="106" y="0"/>
                </a:cubicBezTo>
                <a:cubicBezTo>
                  <a:pt x="142" y="0"/>
                  <a:pt x="165" y="19"/>
                  <a:pt x="173" y="26"/>
                </a:cubicBezTo>
                <a:cubicBezTo>
                  <a:pt x="180" y="33"/>
                  <a:pt x="186" y="41"/>
                  <a:pt x="187" y="42"/>
                </a:cubicBezTo>
                <a:cubicBezTo>
                  <a:pt x="188" y="43"/>
                  <a:pt x="188" y="44"/>
                  <a:pt x="188" y="44"/>
                </a:cubicBezTo>
                <a:cubicBezTo>
                  <a:pt x="188" y="44"/>
                  <a:pt x="188" y="44"/>
                  <a:pt x="188" y="44"/>
                </a:cubicBezTo>
                <a:cubicBezTo>
                  <a:pt x="188" y="44"/>
                  <a:pt x="188" y="44"/>
                  <a:pt x="188" y="44"/>
                </a:cubicBezTo>
                <a:close/>
                <a:moveTo>
                  <a:pt x="1" y="101"/>
                </a:moveTo>
                <a:cubicBezTo>
                  <a:pt x="1" y="101"/>
                  <a:pt x="1" y="101"/>
                  <a:pt x="1" y="102"/>
                </a:cubicBezTo>
                <a:cubicBezTo>
                  <a:pt x="1" y="103"/>
                  <a:pt x="0" y="117"/>
                  <a:pt x="3" y="134"/>
                </a:cubicBezTo>
                <a:cubicBezTo>
                  <a:pt x="8" y="157"/>
                  <a:pt x="22" y="186"/>
                  <a:pt x="54" y="203"/>
                </a:cubicBezTo>
                <a:cubicBezTo>
                  <a:pt x="87" y="221"/>
                  <a:pt x="120" y="216"/>
                  <a:pt x="139" y="208"/>
                </a:cubicBezTo>
                <a:cubicBezTo>
                  <a:pt x="153" y="202"/>
                  <a:pt x="157" y="198"/>
                  <a:pt x="159" y="196"/>
                </a:cubicBezTo>
                <a:cubicBezTo>
                  <a:pt x="160" y="196"/>
                  <a:pt x="161" y="195"/>
                  <a:pt x="161" y="195"/>
                </a:cubicBezTo>
                <a:cubicBezTo>
                  <a:pt x="162" y="194"/>
                  <a:pt x="162" y="194"/>
                  <a:pt x="162" y="194"/>
                </a:cubicBezTo>
                <a:cubicBezTo>
                  <a:pt x="162" y="194"/>
                  <a:pt x="162" y="194"/>
                  <a:pt x="162" y="194"/>
                </a:cubicBezTo>
                <a:cubicBezTo>
                  <a:pt x="162" y="194"/>
                  <a:pt x="162" y="194"/>
                  <a:pt x="161" y="194"/>
                </a:cubicBezTo>
                <a:cubicBezTo>
                  <a:pt x="160" y="195"/>
                  <a:pt x="146" y="201"/>
                  <a:pt x="129" y="203"/>
                </a:cubicBezTo>
                <a:cubicBezTo>
                  <a:pt x="111" y="205"/>
                  <a:pt x="87" y="204"/>
                  <a:pt x="62" y="191"/>
                </a:cubicBezTo>
                <a:cubicBezTo>
                  <a:pt x="36" y="178"/>
                  <a:pt x="19" y="158"/>
                  <a:pt x="10" y="139"/>
                </a:cubicBezTo>
                <a:cubicBezTo>
                  <a:pt x="1" y="120"/>
                  <a:pt x="2" y="103"/>
                  <a:pt x="2" y="102"/>
                </a:cubicBezTo>
                <a:cubicBezTo>
                  <a:pt x="2" y="101"/>
                  <a:pt x="2" y="101"/>
                  <a:pt x="2" y="101"/>
                </a:cubicBezTo>
                <a:cubicBezTo>
                  <a:pt x="2" y="101"/>
                  <a:pt x="2" y="101"/>
                  <a:pt x="2" y="101"/>
                </a:cubicBezTo>
                <a:cubicBezTo>
                  <a:pt x="2" y="101"/>
                  <a:pt x="1" y="101"/>
                  <a:pt x="1" y="101"/>
                </a:cubicBezTo>
                <a:close/>
                <a:moveTo>
                  <a:pt x="108" y="133"/>
                </a:moveTo>
                <a:cubicBezTo>
                  <a:pt x="108" y="108"/>
                  <a:pt x="108" y="108"/>
                  <a:pt x="108" y="108"/>
                </a:cubicBezTo>
                <a:cubicBezTo>
                  <a:pt x="91" y="70"/>
                  <a:pt x="91" y="70"/>
                  <a:pt x="91" y="70"/>
                </a:cubicBezTo>
                <a:cubicBezTo>
                  <a:pt x="105" y="70"/>
                  <a:pt x="105" y="70"/>
                  <a:pt x="105" y="70"/>
                </a:cubicBezTo>
                <a:cubicBezTo>
                  <a:pt x="116" y="95"/>
                  <a:pt x="116" y="95"/>
                  <a:pt x="116" y="95"/>
                </a:cubicBezTo>
                <a:cubicBezTo>
                  <a:pt x="127" y="70"/>
                  <a:pt x="127" y="70"/>
                  <a:pt x="127" y="70"/>
                </a:cubicBezTo>
                <a:cubicBezTo>
                  <a:pt x="140" y="70"/>
                  <a:pt x="140" y="70"/>
                  <a:pt x="140" y="70"/>
                </a:cubicBezTo>
                <a:cubicBezTo>
                  <a:pt x="123" y="108"/>
                  <a:pt x="123" y="108"/>
                  <a:pt x="123" y="108"/>
                </a:cubicBezTo>
                <a:cubicBezTo>
                  <a:pt x="123" y="133"/>
                  <a:pt x="123" y="133"/>
                  <a:pt x="123" y="133"/>
                </a:cubicBezTo>
                <a:lnTo>
                  <a:pt x="108" y="133"/>
                </a:lnTo>
                <a:close/>
                <a:moveTo>
                  <a:pt x="241" y="133"/>
                </a:moveTo>
                <a:cubicBezTo>
                  <a:pt x="208" y="133"/>
                  <a:pt x="208" y="133"/>
                  <a:pt x="208" y="133"/>
                </a:cubicBezTo>
                <a:cubicBezTo>
                  <a:pt x="208" y="70"/>
                  <a:pt x="208" y="70"/>
                  <a:pt x="208" y="70"/>
                </a:cubicBezTo>
                <a:cubicBezTo>
                  <a:pt x="222" y="70"/>
                  <a:pt x="222" y="70"/>
                  <a:pt x="222" y="70"/>
                </a:cubicBezTo>
                <a:cubicBezTo>
                  <a:pt x="222" y="121"/>
                  <a:pt x="222" y="121"/>
                  <a:pt x="222" y="121"/>
                </a:cubicBezTo>
                <a:cubicBezTo>
                  <a:pt x="241" y="121"/>
                  <a:pt x="241" y="121"/>
                  <a:pt x="241" y="121"/>
                </a:cubicBezTo>
                <a:lnTo>
                  <a:pt x="241" y="133"/>
                </a:lnTo>
                <a:close/>
                <a:moveTo>
                  <a:pt x="73" y="70"/>
                </a:moveTo>
                <a:cubicBezTo>
                  <a:pt x="86" y="70"/>
                  <a:pt x="86" y="70"/>
                  <a:pt x="86" y="70"/>
                </a:cubicBezTo>
                <a:cubicBezTo>
                  <a:pt x="86" y="133"/>
                  <a:pt x="86" y="133"/>
                  <a:pt x="86" y="133"/>
                </a:cubicBezTo>
                <a:cubicBezTo>
                  <a:pt x="73" y="133"/>
                  <a:pt x="73" y="133"/>
                  <a:pt x="73" y="133"/>
                </a:cubicBezTo>
                <a:cubicBezTo>
                  <a:pt x="73" y="133"/>
                  <a:pt x="73" y="133"/>
                  <a:pt x="73" y="133"/>
                </a:cubicBezTo>
                <a:cubicBezTo>
                  <a:pt x="73" y="131"/>
                  <a:pt x="57" y="104"/>
                  <a:pt x="53" y="96"/>
                </a:cubicBezTo>
                <a:cubicBezTo>
                  <a:pt x="53" y="133"/>
                  <a:pt x="53" y="133"/>
                  <a:pt x="53" y="133"/>
                </a:cubicBezTo>
                <a:cubicBezTo>
                  <a:pt x="40" y="133"/>
                  <a:pt x="40" y="133"/>
                  <a:pt x="40" y="133"/>
                </a:cubicBezTo>
                <a:cubicBezTo>
                  <a:pt x="40" y="70"/>
                  <a:pt x="40" y="70"/>
                  <a:pt x="40" y="70"/>
                </a:cubicBezTo>
                <a:cubicBezTo>
                  <a:pt x="54" y="70"/>
                  <a:pt x="54" y="70"/>
                  <a:pt x="54" y="70"/>
                </a:cubicBezTo>
                <a:cubicBezTo>
                  <a:pt x="54" y="70"/>
                  <a:pt x="54" y="70"/>
                  <a:pt x="54" y="70"/>
                </a:cubicBezTo>
                <a:cubicBezTo>
                  <a:pt x="55" y="71"/>
                  <a:pt x="69" y="97"/>
                  <a:pt x="73" y="106"/>
                </a:cubicBezTo>
                <a:lnTo>
                  <a:pt x="73" y="70"/>
                </a:lnTo>
                <a:close/>
                <a:moveTo>
                  <a:pt x="166" y="134"/>
                </a:moveTo>
                <a:cubicBezTo>
                  <a:pt x="152" y="134"/>
                  <a:pt x="144" y="126"/>
                  <a:pt x="144" y="111"/>
                </a:cubicBezTo>
                <a:cubicBezTo>
                  <a:pt x="144" y="70"/>
                  <a:pt x="144" y="70"/>
                  <a:pt x="144" y="70"/>
                </a:cubicBezTo>
                <a:cubicBezTo>
                  <a:pt x="158" y="70"/>
                  <a:pt x="158" y="70"/>
                  <a:pt x="158" y="70"/>
                </a:cubicBezTo>
                <a:cubicBezTo>
                  <a:pt x="158" y="110"/>
                  <a:pt x="158" y="110"/>
                  <a:pt x="158" y="110"/>
                </a:cubicBezTo>
                <a:cubicBezTo>
                  <a:pt x="158" y="119"/>
                  <a:pt x="161" y="122"/>
                  <a:pt x="167" y="122"/>
                </a:cubicBezTo>
                <a:cubicBezTo>
                  <a:pt x="172" y="122"/>
                  <a:pt x="175" y="118"/>
                  <a:pt x="175" y="110"/>
                </a:cubicBezTo>
                <a:cubicBezTo>
                  <a:pt x="175" y="70"/>
                  <a:pt x="175" y="70"/>
                  <a:pt x="175" y="70"/>
                </a:cubicBezTo>
                <a:cubicBezTo>
                  <a:pt x="188" y="70"/>
                  <a:pt x="188" y="70"/>
                  <a:pt x="188" y="70"/>
                </a:cubicBezTo>
                <a:cubicBezTo>
                  <a:pt x="188" y="111"/>
                  <a:pt x="188" y="111"/>
                  <a:pt x="188" y="111"/>
                </a:cubicBezTo>
                <a:cubicBezTo>
                  <a:pt x="188" y="126"/>
                  <a:pt x="181" y="134"/>
                  <a:pt x="166" y="134"/>
                </a:cubicBezTo>
                <a:close/>
                <a:moveTo>
                  <a:pt x="259" y="199"/>
                </a:moveTo>
                <a:cubicBezTo>
                  <a:pt x="267" y="206"/>
                  <a:pt x="267" y="206"/>
                  <a:pt x="267" y="206"/>
                </a:cubicBezTo>
                <a:cubicBezTo>
                  <a:pt x="267" y="206"/>
                  <a:pt x="267" y="206"/>
                  <a:pt x="267" y="206"/>
                </a:cubicBezTo>
                <a:cubicBezTo>
                  <a:pt x="263" y="213"/>
                  <a:pt x="257" y="216"/>
                  <a:pt x="249" y="216"/>
                </a:cubicBezTo>
                <a:cubicBezTo>
                  <a:pt x="236" y="216"/>
                  <a:pt x="229" y="207"/>
                  <a:pt x="229" y="192"/>
                </a:cubicBezTo>
                <a:cubicBezTo>
                  <a:pt x="229" y="174"/>
                  <a:pt x="239" y="168"/>
                  <a:pt x="249" y="168"/>
                </a:cubicBezTo>
                <a:cubicBezTo>
                  <a:pt x="261" y="168"/>
                  <a:pt x="267" y="177"/>
                  <a:pt x="267" y="193"/>
                </a:cubicBezTo>
                <a:cubicBezTo>
                  <a:pt x="267" y="196"/>
                  <a:pt x="267" y="196"/>
                  <a:pt x="267" y="196"/>
                </a:cubicBezTo>
                <a:cubicBezTo>
                  <a:pt x="242" y="196"/>
                  <a:pt x="242" y="196"/>
                  <a:pt x="242" y="196"/>
                </a:cubicBezTo>
                <a:cubicBezTo>
                  <a:pt x="243" y="202"/>
                  <a:pt x="245" y="205"/>
                  <a:pt x="250" y="205"/>
                </a:cubicBezTo>
                <a:cubicBezTo>
                  <a:pt x="254" y="205"/>
                  <a:pt x="257" y="202"/>
                  <a:pt x="259" y="200"/>
                </a:cubicBezTo>
                <a:lnTo>
                  <a:pt x="259" y="199"/>
                </a:lnTo>
                <a:close/>
                <a:moveTo>
                  <a:pt x="242" y="187"/>
                </a:moveTo>
                <a:cubicBezTo>
                  <a:pt x="255" y="187"/>
                  <a:pt x="255" y="187"/>
                  <a:pt x="255" y="187"/>
                </a:cubicBezTo>
                <a:cubicBezTo>
                  <a:pt x="254" y="179"/>
                  <a:pt x="250" y="179"/>
                  <a:pt x="249" y="179"/>
                </a:cubicBezTo>
                <a:cubicBezTo>
                  <a:pt x="245" y="179"/>
                  <a:pt x="243" y="182"/>
                  <a:pt x="242" y="187"/>
                </a:cubicBezTo>
                <a:close/>
                <a:moveTo>
                  <a:pt x="416" y="92"/>
                </a:moveTo>
                <a:cubicBezTo>
                  <a:pt x="420" y="96"/>
                  <a:pt x="422" y="102"/>
                  <a:pt x="422" y="110"/>
                </a:cubicBezTo>
                <a:cubicBezTo>
                  <a:pt x="422" y="128"/>
                  <a:pt x="412" y="134"/>
                  <a:pt x="402" y="134"/>
                </a:cubicBezTo>
                <a:cubicBezTo>
                  <a:pt x="392" y="134"/>
                  <a:pt x="382" y="128"/>
                  <a:pt x="382" y="110"/>
                </a:cubicBezTo>
                <a:cubicBezTo>
                  <a:pt x="382" y="102"/>
                  <a:pt x="384" y="96"/>
                  <a:pt x="388" y="92"/>
                </a:cubicBezTo>
                <a:cubicBezTo>
                  <a:pt x="392" y="88"/>
                  <a:pt x="396" y="86"/>
                  <a:pt x="402" y="86"/>
                </a:cubicBezTo>
                <a:cubicBezTo>
                  <a:pt x="408" y="86"/>
                  <a:pt x="413" y="88"/>
                  <a:pt x="416" y="92"/>
                </a:cubicBezTo>
                <a:close/>
                <a:moveTo>
                  <a:pt x="409" y="110"/>
                </a:moveTo>
                <a:cubicBezTo>
                  <a:pt x="409" y="99"/>
                  <a:pt x="405" y="97"/>
                  <a:pt x="402" y="97"/>
                </a:cubicBezTo>
                <a:cubicBezTo>
                  <a:pt x="398" y="97"/>
                  <a:pt x="396" y="101"/>
                  <a:pt x="396" y="110"/>
                </a:cubicBezTo>
                <a:cubicBezTo>
                  <a:pt x="396" y="122"/>
                  <a:pt x="399" y="123"/>
                  <a:pt x="402" y="123"/>
                </a:cubicBezTo>
                <a:cubicBezTo>
                  <a:pt x="407" y="123"/>
                  <a:pt x="409" y="119"/>
                  <a:pt x="409" y="110"/>
                </a:cubicBezTo>
                <a:close/>
                <a:moveTo>
                  <a:pt x="410" y="180"/>
                </a:moveTo>
                <a:cubicBezTo>
                  <a:pt x="410" y="215"/>
                  <a:pt x="410" y="215"/>
                  <a:pt x="410" y="215"/>
                </a:cubicBezTo>
                <a:cubicBezTo>
                  <a:pt x="397" y="215"/>
                  <a:pt x="397" y="215"/>
                  <a:pt x="397" y="215"/>
                </a:cubicBezTo>
                <a:cubicBezTo>
                  <a:pt x="397" y="184"/>
                  <a:pt x="397" y="184"/>
                  <a:pt x="397" y="184"/>
                </a:cubicBezTo>
                <a:cubicBezTo>
                  <a:pt x="397" y="180"/>
                  <a:pt x="395" y="180"/>
                  <a:pt x="393" y="180"/>
                </a:cubicBezTo>
                <a:cubicBezTo>
                  <a:pt x="391" y="180"/>
                  <a:pt x="389" y="181"/>
                  <a:pt x="386" y="183"/>
                </a:cubicBezTo>
                <a:cubicBezTo>
                  <a:pt x="386" y="215"/>
                  <a:pt x="386" y="215"/>
                  <a:pt x="386" y="215"/>
                </a:cubicBezTo>
                <a:cubicBezTo>
                  <a:pt x="373" y="215"/>
                  <a:pt x="373" y="215"/>
                  <a:pt x="373" y="215"/>
                </a:cubicBezTo>
                <a:cubicBezTo>
                  <a:pt x="373" y="152"/>
                  <a:pt x="373" y="152"/>
                  <a:pt x="373" y="152"/>
                </a:cubicBezTo>
                <a:cubicBezTo>
                  <a:pt x="386" y="150"/>
                  <a:pt x="386" y="150"/>
                  <a:pt x="386" y="150"/>
                </a:cubicBezTo>
                <a:cubicBezTo>
                  <a:pt x="386" y="174"/>
                  <a:pt x="386" y="174"/>
                  <a:pt x="386" y="174"/>
                </a:cubicBezTo>
                <a:cubicBezTo>
                  <a:pt x="389" y="171"/>
                  <a:pt x="393" y="168"/>
                  <a:pt x="399" y="168"/>
                </a:cubicBezTo>
                <a:cubicBezTo>
                  <a:pt x="406" y="168"/>
                  <a:pt x="410" y="172"/>
                  <a:pt x="410" y="180"/>
                </a:cubicBezTo>
                <a:close/>
                <a:moveTo>
                  <a:pt x="511" y="124"/>
                </a:moveTo>
                <a:cubicBezTo>
                  <a:pt x="511" y="124"/>
                  <a:pt x="511" y="124"/>
                  <a:pt x="511" y="124"/>
                </a:cubicBezTo>
                <a:cubicBezTo>
                  <a:pt x="507" y="131"/>
                  <a:pt x="501" y="134"/>
                  <a:pt x="493" y="134"/>
                </a:cubicBezTo>
                <a:cubicBezTo>
                  <a:pt x="480" y="134"/>
                  <a:pt x="473" y="125"/>
                  <a:pt x="473" y="110"/>
                </a:cubicBezTo>
                <a:cubicBezTo>
                  <a:pt x="473" y="92"/>
                  <a:pt x="484" y="86"/>
                  <a:pt x="493" y="86"/>
                </a:cubicBezTo>
                <a:cubicBezTo>
                  <a:pt x="505" y="86"/>
                  <a:pt x="511" y="95"/>
                  <a:pt x="511" y="111"/>
                </a:cubicBezTo>
                <a:cubicBezTo>
                  <a:pt x="511" y="114"/>
                  <a:pt x="511" y="114"/>
                  <a:pt x="511" y="114"/>
                </a:cubicBezTo>
                <a:cubicBezTo>
                  <a:pt x="486" y="114"/>
                  <a:pt x="486" y="114"/>
                  <a:pt x="486" y="114"/>
                </a:cubicBezTo>
                <a:cubicBezTo>
                  <a:pt x="487" y="120"/>
                  <a:pt x="489" y="123"/>
                  <a:pt x="494" y="123"/>
                </a:cubicBezTo>
                <a:cubicBezTo>
                  <a:pt x="498" y="123"/>
                  <a:pt x="501" y="120"/>
                  <a:pt x="503" y="118"/>
                </a:cubicBezTo>
                <a:cubicBezTo>
                  <a:pt x="503" y="117"/>
                  <a:pt x="503" y="117"/>
                  <a:pt x="503" y="117"/>
                </a:cubicBezTo>
                <a:lnTo>
                  <a:pt x="511" y="124"/>
                </a:lnTo>
                <a:close/>
                <a:moveTo>
                  <a:pt x="487" y="105"/>
                </a:moveTo>
                <a:cubicBezTo>
                  <a:pt x="499" y="105"/>
                  <a:pt x="499" y="105"/>
                  <a:pt x="499" y="105"/>
                </a:cubicBezTo>
                <a:cubicBezTo>
                  <a:pt x="498" y="97"/>
                  <a:pt x="494" y="97"/>
                  <a:pt x="493" y="97"/>
                </a:cubicBezTo>
                <a:cubicBezTo>
                  <a:pt x="489" y="97"/>
                  <a:pt x="487" y="100"/>
                  <a:pt x="487" y="105"/>
                </a:cubicBezTo>
                <a:close/>
                <a:moveTo>
                  <a:pt x="467" y="98"/>
                </a:moveTo>
                <a:cubicBezTo>
                  <a:pt x="467" y="133"/>
                  <a:pt x="467" y="133"/>
                  <a:pt x="467" y="133"/>
                </a:cubicBezTo>
                <a:cubicBezTo>
                  <a:pt x="453" y="133"/>
                  <a:pt x="453" y="133"/>
                  <a:pt x="453" y="133"/>
                </a:cubicBezTo>
                <a:cubicBezTo>
                  <a:pt x="453" y="102"/>
                  <a:pt x="453" y="102"/>
                  <a:pt x="453" y="102"/>
                </a:cubicBezTo>
                <a:cubicBezTo>
                  <a:pt x="453" y="98"/>
                  <a:pt x="452" y="98"/>
                  <a:pt x="450" y="98"/>
                </a:cubicBezTo>
                <a:cubicBezTo>
                  <a:pt x="448" y="98"/>
                  <a:pt x="445" y="99"/>
                  <a:pt x="443" y="102"/>
                </a:cubicBezTo>
                <a:cubicBezTo>
                  <a:pt x="443" y="133"/>
                  <a:pt x="443" y="133"/>
                  <a:pt x="443" y="133"/>
                </a:cubicBezTo>
                <a:cubicBezTo>
                  <a:pt x="429" y="133"/>
                  <a:pt x="429" y="133"/>
                  <a:pt x="429" y="133"/>
                </a:cubicBezTo>
                <a:cubicBezTo>
                  <a:pt x="429" y="87"/>
                  <a:pt x="429" y="87"/>
                  <a:pt x="429" y="87"/>
                </a:cubicBezTo>
                <a:cubicBezTo>
                  <a:pt x="443" y="87"/>
                  <a:pt x="443" y="87"/>
                  <a:pt x="443" y="87"/>
                </a:cubicBezTo>
                <a:cubicBezTo>
                  <a:pt x="443" y="92"/>
                  <a:pt x="443" y="92"/>
                  <a:pt x="443" y="92"/>
                </a:cubicBezTo>
                <a:cubicBezTo>
                  <a:pt x="445" y="89"/>
                  <a:pt x="450" y="86"/>
                  <a:pt x="455" y="86"/>
                </a:cubicBezTo>
                <a:cubicBezTo>
                  <a:pt x="463" y="86"/>
                  <a:pt x="467" y="90"/>
                  <a:pt x="467" y="98"/>
                </a:cubicBezTo>
                <a:close/>
                <a:moveTo>
                  <a:pt x="357" y="169"/>
                </a:moveTo>
                <a:cubicBezTo>
                  <a:pt x="366" y="169"/>
                  <a:pt x="366" y="169"/>
                  <a:pt x="366" y="169"/>
                </a:cubicBezTo>
                <a:cubicBezTo>
                  <a:pt x="366" y="179"/>
                  <a:pt x="366" y="179"/>
                  <a:pt x="366" y="179"/>
                </a:cubicBezTo>
                <a:cubicBezTo>
                  <a:pt x="357" y="179"/>
                  <a:pt x="357" y="179"/>
                  <a:pt x="357" y="179"/>
                </a:cubicBezTo>
                <a:cubicBezTo>
                  <a:pt x="357" y="200"/>
                  <a:pt x="357" y="200"/>
                  <a:pt x="357" y="200"/>
                </a:cubicBezTo>
                <a:cubicBezTo>
                  <a:pt x="357" y="204"/>
                  <a:pt x="358" y="205"/>
                  <a:pt x="361" y="205"/>
                </a:cubicBezTo>
                <a:cubicBezTo>
                  <a:pt x="363" y="205"/>
                  <a:pt x="364" y="205"/>
                  <a:pt x="365" y="205"/>
                </a:cubicBezTo>
                <a:cubicBezTo>
                  <a:pt x="366" y="204"/>
                  <a:pt x="366" y="204"/>
                  <a:pt x="366" y="204"/>
                </a:cubicBezTo>
                <a:cubicBezTo>
                  <a:pt x="366" y="215"/>
                  <a:pt x="366" y="215"/>
                  <a:pt x="366" y="215"/>
                </a:cubicBezTo>
                <a:cubicBezTo>
                  <a:pt x="365" y="215"/>
                  <a:pt x="365" y="215"/>
                  <a:pt x="365" y="215"/>
                </a:cubicBezTo>
                <a:cubicBezTo>
                  <a:pt x="364" y="215"/>
                  <a:pt x="360" y="215"/>
                  <a:pt x="357" y="215"/>
                </a:cubicBezTo>
                <a:cubicBezTo>
                  <a:pt x="347" y="215"/>
                  <a:pt x="343" y="212"/>
                  <a:pt x="343" y="203"/>
                </a:cubicBezTo>
                <a:cubicBezTo>
                  <a:pt x="343" y="179"/>
                  <a:pt x="343" y="179"/>
                  <a:pt x="343" y="179"/>
                </a:cubicBezTo>
                <a:cubicBezTo>
                  <a:pt x="337" y="179"/>
                  <a:pt x="337" y="179"/>
                  <a:pt x="337" y="179"/>
                </a:cubicBezTo>
                <a:cubicBezTo>
                  <a:pt x="337" y="169"/>
                  <a:pt x="337" y="169"/>
                  <a:pt x="337" y="169"/>
                </a:cubicBezTo>
                <a:cubicBezTo>
                  <a:pt x="343" y="169"/>
                  <a:pt x="343" y="169"/>
                  <a:pt x="343" y="169"/>
                </a:cubicBezTo>
                <a:cubicBezTo>
                  <a:pt x="343" y="156"/>
                  <a:pt x="343" y="156"/>
                  <a:pt x="343" y="156"/>
                </a:cubicBezTo>
                <a:cubicBezTo>
                  <a:pt x="357" y="154"/>
                  <a:pt x="357" y="154"/>
                  <a:pt x="357" y="154"/>
                </a:cubicBezTo>
                <a:lnTo>
                  <a:pt x="357" y="169"/>
                </a:lnTo>
                <a:close/>
                <a:moveTo>
                  <a:pt x="332" y="98"/>
                </a:moveTo>
                <a:cubicBezTo>
                  <a:pt x="332" y="133"/>
                  <a:pt x="332" y="133"/>
                  <a:pt x="332" y="133"/>
                </a:cubicBezTo>
                <a:cubicBezTo>
                  <a:pt x="318" y="133"/>
                  <a:pt x="318" y="133"/>
                  <a:pt x="318" y="133"/>
                </a:cubicBezTo>
                <a:cubicBezTo>
                  <a:pt x="318" y="102"/>
                  <a:pt x="318" y="102"/>
                  <a:pt x="318" y="102"/>
                </a:cubicBezTo>
                <a:cubicBezTo>
                  <a:pt x="318" y="98"/>
                  <a:pt x="316" y="98"/>
                  <a:pt x="315" y="98"/>
                </a:cubicBezTo>
                <a:cubicBezTo>
                  <a:pt x="313" y="98"/>
                  <a:pt x="310" y="99"/>
                  <a:pt x="307" y="102"/>
                </a:cubicBezTo>
                <a:cubicBezTo>
                  <a:pt x="307" y="133"/>
                  <a:pt x="307" y="133"/>
                  <a:pt x="307" y="133"/>
                </a:cubicBezTo>
                <a:cubicBezTo>
                  <a:pt x="294" y="133"/>
                  <a:pt x="294" y="133"/>
                  <a:pt x="294" y="133"/>
                </a:cubicBezTo>
                <a:cubicBezTo>
                  <a:pt x="294" y="87"/>
                  <a:pt x="294" y="87"/>
                  <a:pt x="294" y="87"/>
                </a:cubicBezTo>
                <a:cubicBezTo>
                  <a:pt x="307" y="87"/>
                  <a:pt x="307" y="87"/>
                  <a:pt x="307" y="87"/>
                </a:cubicBezTo>
                <a:cubicBezTo>
                  <a:pt x="307" y="92"/>
                  <a:pt x="307" y="92"/>
                  <a:pt x="307" y="92"/>
                </a:cubicBezTo>
                <a:cubicBezTo>
                  <a:pt x="310" y="89"/>
                  <a:pt x="315" y="86"/>
                  <a:pt x="320" y="86"/>
                </a:cubicBezTo>
                <a:cubicBezTo>
                  <a:pt x="328" y="86"/>
                  <a:pt x="332" y="90"/>
                  <a:pt x="332" y="98"/>
                </a:cubicBezTo>
                <a:close/>
                <a:moveTo>
                  <a:pt x="272" y="132"/>
                </a:moveTo>
                <a:cubicBezTo>
                  <a:pt x="272" y="131"/>
                  <a:pt x="271" y="130"/>
                  <a:pt x="271" y="128"/>
                </a:cubicBezTo>
                <a:cubicBezTo>
                  <a:pt x="268" y="132"/>
                  <a:pt x="264" y="133"/>
                  <a:pt x="259" y="133"/>
                </a:cubicBezTo>
                <a:cubicBezTo>
                  <a:pt x="251" y="133"/>
                  <a:pt x="247" y="129"/>
                  <a:pt x="247" y="121"/>
                </a:cubicBezTo>
                <a:cubicBezTo>
                  <a:pt x="247" y="112"/>
                  <a:pt x="255" y="106"/>
                  <a:pt x="271" y="103"/>
                </a:cubicBezTo>
                <a:cubicBezTo>
                  <a:pt x="271" y="102"/>
                  <a:pt x="271" y="102"/>
                  <a:pt x="271" y="102"/>
                </a:cubicBezTo>
                <a:cubicBezTo>
                  <a:pt x="271" y="98"/>
                  <a:pt x="270" y="97"/>
                  <a:pt x="267" y="97"/>
                </a:cubicBezTo>
                <a:cubicBezTo>
                  <a:pt x="263" y="97"/>
                  <a:pt x="258" y="100"/>
                  <a:pt x="256" y="102"/>
                </a:cubicBezTo>
                <a:cubicBezTo>
                  <a:pt x="255" y="102"/>
                  <a:pt x="255" y="102"/>
                  <a:pt x="255" y="102"/>
                </a:cubicBezTo>
                <a:cubicBezTo>
                  <a:pt x="249" y="94"/>
                  <a:pt x="249" y="94"/>
                  <a:pt x="249" y="94"/>
                </a:cubicBezTo>
                <a:cubicBezTo>
                  <a:pt x="249" y="93"/>
                  <a:pt x="249" y="93"/>
                  <a:pt x="249" y="93"/>
                </a:cubicBezTo>
                <a:cubicBezTo>
                  <a:pt x="255" y="89"/>
                  <a:pt x="262" y="86"/>
                  <a:pt x="270" y="86"/>
                </a:cubicBezTo>
                <a:cubicBezTo>
                  <a:pt x="280" y="86"/>
                  <a:pt x="285" y="91"/>
                  <a:pt x="285" y="102"/>
                </a:cubicBezTo>
                <a:cubicBezTo>
                  <a:pt x="285" y="121"/>
                  <a:pt x="285" y="121"/>
                  <a:pt x="285" y="121"/>
                </a:cubicBezTo>
                <a:cubicBezTo>
                  <a:pt x="285" y="127"/>
                  <a:pt x="285" y="130"/>
                  <a:pt x="286" y="132"/>
                </a:cubicBezTo>
                <a:cubicBezTo>
                  <a:pt x="286" y="133"/>
                  <a:pt x="286" y="133"/>
                  <a:pt x="286" y="133"/>
                </a:cubicBezTo>
                <a:cubicBezTo>
                  <a:pt x="272" y="133"/>
                  <a:pt x="272" y="133"/>
                  <a:pt x="272" y="133"/>
                </a:cubicBezTo>
                <a:lnTo>
                  <a:pt x="272" y="132"/>
                </a:lnTo>
                <a:close/>
                <a:moveTo>
                  <a:pt x="271" y="111"/>
                </a:moveTo>
                <a:cubicBezTo>
                  <a:pt x="262" y="113"/>
                  <a:pt x="261" y="116"/>
                  <a:pt x="261" y="119"/>
                </a:cubicBezTo>
                <a:cubicBezTo>
                  <a:pt x="261" y="121"/>
                  <a:pt x="262" y="123"/>
                  <a:pt x="264" y="123"/>
                </a:cubicBezTo>
                <a:cubicBezTo>
                  <a:pt x="267" y="123"/>
                  <a:pt x="269" y="122"/>
                  <a:pt x="271" y="120"/>
                </a:cubicBezTo>
                <a:lnTo>
                  <a:pt x="271" y="111"/>
                </a:lnTo>
                <a:close/>
                <a:moveTo>
                  <a:pt x="310" y="214"/>
                </a:moveTo>
                <a:cubicBezTo>
                  <a:pt x="311" y="215"/>
                  <a:pt x="311" y="215"/>
                  <a:pt x="311" y="215"/>
                </a:cubicBezTo>
                <a:cubicBezTo>
                  <a:pt x="297" y="215"/>
                  <a:pt x="297" y="215"/>
                  <a:pt x="297" y="215"/>
                </a:cubicBezTo>
                <a:cubicBezTo>
                  <a:pt x="297" y="214"/>
                  <a:pt x="297" y="214"/>
                  <a:pt x="297" y="214"/>
                </a:cubicBezTo>
                <a:cubicBezTo>
                  <a:pt x="296" y="213"/>
                  <a:pt x="296" y="212"/>
                  <a:pt x="296" y="210"/>
                </a:cubicBezTo>
                <a:cubicBezTo>
                  <a:pt x="293" y="214"/>
                  <a:pt x="289" y="215"/>
                  <a:pt x="283" y="215"/>
                </a:cubicBezTo>
                <a:cubicBezTo>
                  <a:pt x="276" y="215"/>
                  <a:pt x="272" y="211"/>
                  <a:pt x="272" y="203"/>
                </a:cubicBezTo>
                <a:cubicBezTo>
                  <a:pt x="272" y="194"/>
                  <a:pt x="280" y="188"/>
                  <a:pt x="296" y="185"/>
                </a:cubicBezTo>
                <a:cubicBezTo>
                  <a:pt x="296" y="183"/>
                  <a:pt x="296" y="183"/>
                  <a:pt x="296" y="183"/>
                </a:cubicBezTo>
                <a:cubicBezTo>
                  <a:pt x="296" y="180"/>
                  <a:pt x="295" y="179"/>
                  <a:pt x="292" y="179"/>
                </a:cubicBezTo>
                <a:cubicBezTo>
                  <a:pt x="287" y="179"/>
                  <a:pt x="283" y="182"/>
                  <a:pt x="280" y="184"/>
                </a:cubicBezTo>
                <a:cubicBezTo>
                  <a:pt x="280" y="184"/>
                  <a:pt x="280" y="184"/>
                  <a:pt x="280" y="184"/>
                </a:cubicBezTo>
                <a:cubicBezTo>
                  <a:pt x="273" y="176"/>
                  <a:pt x="273" y="176"/>
                  <a:pt x="273" y="176"/>
                </a:cubicBezTo>
                <a:cubicBezTo>
                  <a:pt x="274" y="175"/>
                  <a:pt x="274" y="175"/>
                  <a:pt x="274" y="175"/>
                </a:cubicBezTo>
                <a:cubicBezTo>
                  <a:pt x="279" y="171"/>
                  <a:pt x="286" y="168"/>
                  <a:pt x="294" y="168"/>
                </a:cubicBezTo>
                <a:cubicBezTo>
                  <a:pt x="305" y="168"/>
                  <a:pt x="309" y="173"/>
                  <a:pt x="309" y="183"/>
                </a:cubicBezTo>
                <a:cubicBezTo>
                  <a:pt x="309" y="203"/>
                  <a:pt x="309" y="203"/>
                  <a:pt x="309" y="203"/>
                </a:cubicBezTo>
                <a:cubicBezTo>
                  <a:pt x="309" y="209"/>
                  <a:pt x="310" y="212"/>
                  <a:pt x="310" y="214"/>
                </a:cubicBezTo>
                <a:close/>
                <a:moveTo>
                  <a:pt x="296" y="193"/>
                </a:moveTo>
                <a:cubicBezTo>
                  <a:pt x="286" y="195"/>
                  <a:pt x="285" y="198"/>
                  <a:pt x="285" y="201"/>
                </a:cubicBezTo>
                <a:cubicBezTo>
                  <a:pt x="285" y="203"/>
                  <a:pt x="286" y="205"/>
                  <a:pt x="289" y="205"/>
                </a:cubicBezTo>
                <a:cubicBezTo>
                  <a:pt x="291" y="205"/>
                  <a:pt x="294" y="204"/>
                  <a:pt x="296" y="201"/>
                </a:cubicBezTo>
                <a:lnTo>
                  <a:pt x="296" y="193"/>
                </a:lnTo>
                <a:close/>
                <a:moveTo>
                  <a:pt x="318" y="159"/>
                </a:moveTo>
                <a:cubicBezTo>
                  <a:pt x="332" y="157"/>
                  <a:pt x="332" y="157"/>
                  <a:pt x="332" y="157"/>
                </a:cubicBezTo>
                <a:cubicBezTo>
                  <a:pt x="332" y="215"/>
                  <a:pt x="332" y="215"/>
                  <a:pt x="332" y="215"/>
                </a:cubicBezTo>
                <a:cubicBezTo>
                  <a:pt x="318" y="215"/>
                  <a:pt x="318" y="215"/>
                  <a:pt x="318" y="215"/>
                </a:cubicBezTo>
                <a:lnTo>
                  <a:pt x="318" y="159"/>
                </a:lnTo>
                <a:close/>
                <a:moveTo>
                  <a:pt x="208" y="153"/>
                </a:moveTo>
                <a:cubicBezTo>
                  <a:pt x="222" y="153"/>
                  <a:pt x="222" y="153"/>
                  <a:pt x="222" y="153"/>
                </a:cubicBezTo>
                <a:cubicBezTo>
                  <a:pt x="222" y="215"/>
                  <a:pt x="222" y="215"/>
                  <a:pt x="222" y="215"/>
                </a:cubicBezTo>
                <a:cubicBezTo>
                  <a:pt x="208" y="215"/>
                  <a:pt x="208" y="215"/>
                  <a:pt x="208" y="215"/>
                </a:cubicBezTo>
                <a:cubicBezTo>
                  <a:pt x="208" y="188"/>
                  <a:pt x="208" y="188"/>
                  <a:pt x="208" y="188"/>
                </a:cubicBezTo>
                <a:cubicBezTo>
                  <a:pt x="188" y="188"/>
                  <a:pt x="188" y="188"/>
                  <a:pt x="188" y="188"/>
                </a:cubicBezTo>
                <a:cubicBezTo>
                  <a:pt x="188" y="215"/>
                  <a:pt x="188" y="215"/>
                  <a:pt x="188" y="215"/>
                </a:cubicBezTo>
                <a:cubicBezTo>
                  <a:pt x="174" y="215"/>
                  <a:pt x="174" y="215"/>
                  <a:pt x="174" y="215"/>
                </a:cubicBezTo>
                <a:cubicBezTo>
                  <a:pt x="174" y="153"/>
                  <a:pt x="174" y="153"/>
                  <a:pt x="174" y="153"/>
                </a:cubicBezTo>
                <a:cubicBezTo>
                  <a:pt x="188" y="153"/>
                  <a:pt x="188" y="153"/>
                  <a:pt x="188" y="153"/>
                </a:cubicBezTo>
                <a:cubicBezTo>
                  <a:pt x="188" y="176"/>
                  <a:pt x="188" y="176"/>
                  <a:pt x="188" y="176"/>
                </a:cubicBezTo>
                <a:cubicBezTo>
                  <a:pt x="208" y="176"/>
                  <a:pt x="208" y="176"/>
                  <a:pt x="208" y="176"/>
                </a:cubicBezTo>
                <a:lnTo>
                  <a:pt x="208" y="153"/>
                </a:lnTo>
                <a:close/>
                <a:moveTo>
                  <a:pt x="342" y="130"/>
                </a:moveTo>
                <a:cubicBezTo>
                  <a:pt x="340" y="129"/>
                  <a:pt x="339" y="127"/>
                  <a:pt x="339" y="124"/>
                </a:cubicBezTo>
                <a:cubicBezTo>
                  <a:pt x="339" y="122"/>
                  <a:pt x="341" y="118"/>
                  <a:pt x="345" y="116"/>
                </a:cubicBezTo>
                <a:cubicBezTo>
                  <a:pt x="341" y="113"/>
                  <a:pt x="339" y="108"/>
                  <a:pt x="339" y="103"/>
                </a:cubicBezTo>
                <a:cubicBezTo>
                  <a:pt x="339" y="93"/>
                  <a:pt x="346" y="86"/>
                  <a:pt x="357" y="86"/>
                </a:cubicBezTo>
                <a:cubicBezTo>
                  <a:pt x="362" y="86"/>
                  <a:pt x="367" y="88"/>
                  <a:pt x="370" y="90"/>
                </a:cubicBezTo>
                <a:cubicBezTo>
                  <a:pt x="372" y="88"/>
                  <a:pt x="376" y="86"/>
                  <a:pt x="379" y="86"/>
                </a:cubicBezTo>
                <a:cubicBezTo>
                  <a:pt x="380" y="86"/>
                  <a:pt x="380" y="86"/>
                  <a:pt x="380" y="86"/>
                </a:cubicBezTo>
                <a:cubicBezTo>
                  <a:pt x="380" y="98"/>
                  <a:pt x="380" y="98"/>
                  <a:pt x="380" y="98"/>
                </a:cubicBezTo>
                <a:cubicBezTo>
                  <a:pt x="379" y="98"/>
                  <a:pt x="379" y="98"/>
                  <a:pt x="379" y="98"/>
                </a:cubicBezTo>
                <a:cubicBezTo>
                  <a:pt x="378" y="98"/>
                  <a:pt x="376" y="98"/>
                  <a:pt x="374" y="98"/>
                </a:cubicBezTo>
                <a:cubicBezTo>
                  <a:pt x="375" y="100"/>
                  <a:pt x="375" y="101"/>
                  <a:pt x="375" y="103"/>
                </a:cubicBezTo>
                <a:cubicBezTo>
                  <a:pt x="375" y="113"/>
                  <a:pt x="368" y="120"/>
                  <a:pt x="357" y="120"/>
                </a:cubicBezTo>
                <a:cubicBezTo>
                  <a:pt x="355" y="120"/>
                  <a:pt x="353" y="119"/>
                  <a:pt x="351" y="119"/>
                </a:cubicBezTo>
                <a:cubicBezTo>
                  <a:pt x="351" y="120"/>
                  <a:pt x="351" y="120"/>
                  <a:pt x="351" y="120"/>
                </a:cubicBezTo>
                <a:cubicBezTo>
                  <a:pt x="351" y="121"/>
                  <a:pt x="351" y="122"/>
                  <a:pt x="354" y="122"/>
                </a:cubicBezTo>
                <a:cubicBezTo>
                  <a:pt x="360" y="123"/>
                  <a:pt x="360" y="123"/>
                  <a:pt x="360" y="123"/>
                </a:cubicBezTo>
                <a:cubicBezTo>
                  <a:pt x="374" y="124"/>
                  <a:pt x="379" y="127"/>
                  <a:pt x="379" y="135"/>
                </a:cubicBezTo>
                <a:cubicBezTo>
                  <a:pt x="379" y="144"/>
                  <a:pt x="370" y="149"/>
                  <a:pt x="356" y="149"/>
                </a:cubicBezTo>
                <a:cubicBezTo>
                  <a:pt x="342" y="149"/>
                  <a:pt x="336" y="146"/>
                  <a:pt x="336" y="139"/>
                </a:cubicBezTo>
                <a:cubicBezTo>
                  <a:pt x="336" y="135"/>
                  <a:pt x="338" y="132"/>
                  <a:pt x="342" y="130"/>
                </a:cubicBezTo>
                <a:close/>
                <a:moveTo>
                  <a:pt x="352" y="103"/>
                </a:moveTo>
                <a:cubicBezTo>
                  <a:pt x="352" y="106"/>
                  <a:pt x="352" y="111"/>
                  <a:pt x="357" y="111"/>
                </a:cubicBezTo>
                <a:cubicBezTo>
                  <a:pt x="360" y="111"/>
                  <a:pt x="362" y="108"/>
                  <a:pt x="362" y="103"/>
                </a:cubicBezTo>
                <a:cubicBezTo>
                  <a:pt x="362" y="100"/>
                  <a:pt x="361" y="96"/>
                  <a:pt x="357" y="96"/>
                </a:cubicBezTo>
                <a:cubicBezTo>
                  <a:pt x="352" y="96"/>
                  <a:pt x="352" y="101"/>
                  <a:pt x="352" y="103"/>
                </a:cubicBezTo>
                <a:close/>
                <a:moveTo>
                  <a:pt x="348" y="137"/>
                </a:moveTo>
                <a:cubicBezTo>
                  <a:pt x="348" y="140"/>
                  <a:pt x="350" y="142"/>
                  <a:pt x="357" y="142"/>
                </a:cubicBezTo>
                <a:cubicBezTo>
                  <a:pt x="363" y="142"/>
                  <a:pt x="366" y="140"/>
                  <a:pt x="366" y="137"/>
                </a:cubicBezTo>
                <a:cubicBezTo>
                  <a:pt x="366" y="135"/>
                  <a:pt x="366" y="134"/>
                  <a:pt x="358" y="134"/>
                </a:cubicBezTo>
                <a:cubicBezTo>
                  <a:pt x="351" y="133"/>
                  <a:pt x="351" y="133"/>
                  <a:pt x="351" y="133"/>
                </a:cubicBezTo>
                <a:cubicBezTo>
                  <a:pt x="351" y="133"/>
                  <a:pt x="350" y="133"/>
                  <a:pt x="350" y="133"/>
                </a:cubicBezTo>
                <a:cubicBezTo>
                  <a:pt x="349" y="134"/>
                  <a:pt x="348" y="136"/>
                  <a:pt x="348" y="137"/>
                </a:cubicBezTo>
                <a:close/>
              </a:path>
            </a:pathLst>
          </a:custGeom>
          <a:solidFill>
            <a:schemeClr val="bg1"/>
          </a:solidFill>
          <a:ln>
            <a:noFill/>
          </a:ln>
        </p:spPr>
        <p:txBody>
          <a:bodyPr vert="horz" wrap="square" lIns="121920" tIns="60960" rIns="121920" bIns="60960" numCol="1" anchor="t" anchorCtr="0" compatLnSpc="1">
            <a:prstTxWarp prst="textNoShape">
              <a:avLst/>
            </a:prstTxWarp>
          </a:bodyPr>
          <a:lstStyle/>
          <a:p>
            <a:endParaRPr lang="en-US"/>
          </a:p>
        </p:txBody>
      </p:sp>
    </p:spTree>
    <p:extLst>
      <p:ext uri="{BB962C8B-B14F-4D97-AF65-F5344CB8AC3E}">
        <p14:creationId xmlns:p14="http://schemas.microsoft.com/office/powerpoint/2010/main" val="1009804930"/>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userDrawn="1">
  <p:cSld name="1_Two Content">
    <p:spTree>
      <p:nvGrpSpPr>
        <p:cNvPr id="1" name=""/>
        <p:cNvGrpSpPr/>
        <p:nvPr/>
      </p:nvGrpSpPr>
      <p:grpSpPr>
        <a:xfrm>
          <a:off x="0" y="0"/>
          <a:ext cx="0" cy="0"/>
          <a:chOff x="0" y="0"/>
          <a:chExt cx="0" cy="0"/>
        </a:xfrm>
      </p:grpSpPr>
      <p:sp>
        <p:nvSpPr>
          <p:cNvPr id="3" name="Content Placeholder 2"/>
          <p:cNvSpPr>
            <a:spLocks noGrp="1"/>
          </p:cNvSpPr>
          <p:nvPr>
            <p:ph sz="half" idx="1"/>
          </p:nvPr>
        </p:nvSpPr>
        <p:spPr>
          <a:xfrm>
            <a:off x="609600" y="1780032"/>
            <a:ext cx="5181600" cy="4036568"/>
          </a:xfrm>
        </p:spPr>
        <p:txBody>
          <a:bodyPr vert="horz" lIns="0" tIns="0" rIns="0" bIns="0" rtlCol="0">
            <a:noAutofit/>
          </a:bodyPr>
          <a:lstStyle>
            <a:lvl1pPr>
              <a:defRPr lang="en-US" dirty="0"/>
            </a:lvl1pPr>
            <a:lvl2pPr>
              <a:defRPr lang="en-US" dirty="0"/>
            </a:lvl2pPr>
            <a:lvl3pPr>
              <a:defRPr lang="en-US" dirty="0"/>
            </a:lvl3pPr>
            <a:lvl4pPr>
              <a:defRPr lang="en-US" dirty="0"/>
            </a:lvl4pPr>
            <a:lvl5pPr>
              <a:defRPr lang="en-US" dirty="0"/>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14" name="Content Placeholder 2"/>
          <p:cNvSpPr>
            <a:spLocks noGrp="1"/>
          </p:cNvSpPr>
          <p:nvPr>
            <p:ph sz="half" idx="15"/>
          </p:nvPr>
        </p:nvSpPr>
        <p:spPr>
          <a:xfrm>
            <a:off x="6400800" y="1780032"/>
            <a:ext cx="5181600" cy="4036568"/>
          </a:xfrm>
        </p:spPr>
        <p:txBody>
          <a:bodyPr vert="horz" lIns="0" tIns="0" rIns="0" bIns="0" rtlCol="0">
            <a:noAutofit/>
          </a:bodyPr>
          <a:lstStyle>
            <a:lvl1pPr>
              <a:defRPr lang="en-US" dirty="0"/>
            </a:lvl1pPr>
            <a:lvl2pPr>
              <a:defRPr lang="en-US" dirty="0"/>
            </a:lvl2pPr>
            <a:lvl3pPr>
              <a:defRPr lang="en-US" dirty="0"/>
            </a:lvl3pPr>
            <a:lvl4pPr>
              <a:defRPr lang="en-US" dirty="0"/>
            </a:lvl4pPr>
            <a:lvl5pPr>
              <a:defRPr lang="en-US" dirty="0"/>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10" name="Footer Placeholder 4"/>
          <p:cNvSpPr>
            <a:spLocks noGrp="1"/>
          </p:cNvSpPr>
          <p:nvPr>
            <p:ph type="ftr" sz="quarter" idx="3"/>
          </p:nvPr>
        </p:nvSpPr>
        <p:spPr>
          <a:xfrm>
            <a:off x="1026597" y="6465181"/>
            <a:ext cx="4517089" cy="169277"/>
          </a:xfrm>
          <a:prstGeom prst="rect">
            <a:avLst/>
          </a:prstGeom>
        </p:spPr>
        <p:txBody>
          <a:bodyPr vert="horz" wrap="square" lIns="0" tIns="0" rIns="0" bIns="0" rtlCol="0" anchor="ctr">
            <a:spAutoFit/>
          </a:bodyPr>
          <a:lstStyle>
            <a:lvl1pPr algn="l">
              <a:defRPr sz="1100">
                <a:solidFill>
                  <a:schemeClr val="tx1"/>
                </a:solidFill>
              </a:defRPr>
            </a:lvl1pPr>
          </a:lstStyle>
          <a:p>
            <a:r>
              <a:rPr lang="en-US"/>
              <a:t>Division Name or Footer</a:t>
            </a:r>
          </a:p>
        </p:txBody>
      </p:sp>
      <p:sp>
        <p:nvSpPr>
          <p:cNvPr id="11" name="Slide Number Placeholder 5"/>
          <p:cNvSpPr>
            <a:spLocks noGrp="1"/>
          </p:cNvSpPr>
          <p:nvPr>
            <p:ph type="sldNum" sz="quarter" idx="4"/>
          </p:nvPr>
        </p:nvSpPr>
        <p:spPr>
          <a:xfrm>
            <a:off x="609601" y="6455138"/>
            <a:ext cx="339625" cy="169277"/>
          </a:xfrm>
          <a:prstGeom prst="rect">
            <a:avLst/>
          </a:prstGeom>
        </p:spPr>
        <p:txBody>
          <a:bodyPr vert="horz" wrap="square" lIns="0" tIns="0" rIns="0" bIns="0" rtlCol="0" anchor="ctr">
            <a:spAutoFit/>
          </a:bodyPr>
          <a:lstStyle>
            <a:lvl1pPr algn="l">
              <a:defRPr sz="1100">
                <a:solidFill>
                  <a:schemeClr val="tx1"/>
                </a:solidFill>
              </a:defRPr>
            </a:lvl1pPr>
          </a:lstStyle>
          <a:p>
            <a:fld id="{7FEEEA1A-CB49-3744-AA40-B896987410F9}" type="slidenum">
              <a:rPr lang="en-US" smtClean="0"/>
              <a:pPr/>
              <a:t>‹#›</a:t>
            </a:fld>
            <a:endParaRPr lang="en-US"/>
          </a:p>
        </p:txBody>
      </p:sp>
      <p:sp>
        <p:nvSpPr>
          <p:cNvPr id="7" name="Title 1"/>
          <p:cNvSpPr>
            <a:spLocks noGrp="1"/>
          </p:cNvSpPr>
          <p:nvPr>
            <p:ph type="title"/>
          </p:nvPr>
        </p:nvSpPr>
        <p:spPr>
          <a:xfrm>
            <a:off x="609599" y="1048512"/>
            <a:ext cx="10972803" cy="418576"/>
          </a:xfrm>
        </p:spPr>
        <p:txBody>
          <a:bodyPr vert="horz" lIns="0" tIns="0" rIns="0" bIns="0" rtlCol="0" anchor="b" anchorCtr="0">
            <a:noAutofit/>
          </a:bodyPr>
          <a:lstStyle>
            <a:lvl1pPr>
              <a:defRPr lang="en-US" sz="3200" b="1" i="0" kern="1200" cap="none" dirty="0">
                <a:solidFill>
                  <a:schemeClr val="tx2"/>
                </a:solidFill>
                <a:latin typeface="+mj-lt"/>
                <a:ea typeface="+mj-ea"/>
                <a:cs typeface="+mj-cs"/>
              </a:defRPr>
            </a:lvl1pPr>
          </a:lstStyle>
          <a:p>
            <a:pPr lvl="0" algn="l" defTabSz="457189" rtl="0" eaLnBrk="1" latinLnBrk="0" hangingPunct="1">
              <a:lnSpc>
                <a:spcPct val="85000"/>
              </a:lnSpc>
              <a:spcBef>
                <a:spcPct val="0"/>
              </a:spcBef>
              <a:buNone/>
            </a:pPr>
            <a:r>
              <a:rPr lang="en-US"/>
              <a:t>Click to edit Master title style</a:t>
            </a:r>
          </a:p>
        </p:txBody>
      </p:sp>
    </p:spTree>
    <p:extLst>
      <p:ext uri="{BB962C8B-B14F-4D97-AF65-F5344CB8AC3E}">
        <p14:creationId xmlns:p14="http://schemas.microsoft.com/office/powerpoint/2010/main" val="2147290319"/>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preserve="1" userDrawn="1">
  <p:cSld name="1_Comparison">
    <p:spTree>
      <p:nvGrpSpPr>
        <p:cNvPr id="1" name=""/>
        <p:cNvGrpSpPr/>
        <p:nvPr/>
      </p:nvGrpSpPr>
      <p:grpSpPr>
        <a:xfrm>
          <a:off x="0" y="0"/>
          <a:ext cx="0" cy="0"/>
          <a:chOff x="0" y="0"/>
          <a:chExt cx="0" cy="0"/>
        </a:xfrm>
      </p:grpSpPr>
      <p:sp>
        <p:nvSpPr>
          <p:cNvPr id="19" name="Text Placeholder 11"/>
          <p:cNvSpPr>
            <a:spLocks noGrp="1"/>
          </p:cNvSpPr>
          <p:nvPr>
            <p:ph type="body" sz="quarter" idx="13"/>
          </p:nvPr>
        </p:nvSpPr>
        <p:spPr>
          <a:xfrm>
            <a:off x="609600" y="1689917"/>
            <a:ext cx="5181600" cy="406265"/>
          </a:xfrm>
        </p:spPr>
        <p:txBody>
          <a:bodyPr anchor="b" anchorCtr="0">
            <a:noAutofit/>
          </a:bodyPr>
          <a:lstStyle>
            <a:lvl1pPr marL="0" indent="0">
              <a:lnSpc>
                <a:spcPct val="90000"/>
              </a:lnSpc>
              <a:buNone/>
              <a:defRPr sz="2400" b="1"/>
            </a:lvl1pPr>
            <a:lvl2pPr marL="306910" indent="0">
              <a:buNone/>
              <a:defRPr/>
            </a:lvl2pPr>
          </a:lstStyle>
          <a:p>
            <a:pPr lvl="0"/>
            <a:r>
              <a:rPr lang="en-US"/>
              <a:t>Click to edit Master text styles</a:t>
            </a:r>
          </a:p>
        </p:txBody>
      </p:sp>
      <p:sp>
        <p:nvSpPr>
          <p:cNvPr id="20" name="Text Placeholder 11"/>
          <p:cNvSpPr>
            <a:spLocks noGrp="1"/>
          </p:cNvSpPr>
          <p:nvPr>
            <p:ph type="body" sz="quarter" idx="14"/>
          </p:nvPr>
        </p:nvSpPr>
        <p:spPr>
          <a:xfrm>
            <a:off x="6400800" y="1689917"/>
            <a:ext cx="5181600" cy="406265"/>
          </a:xfrm>
        </p:spPr>
        <p:txBody>
          <a:bodyPr anchor="b" anchorCtr="0">
            <a:noAutofit/>
          </a:bodyPr>
          <a:lstStyle>
            <a:lvl1pPr marL="0" indent="0">
              <a:lnSpc>
                <a:spcPct val="90000"/>
              </a:lnSpc>
              <a:buNone/>
              <a:defRPr sz="2400" b="1"/>
            </a:lvl1pPr>
            <a:lvl2pPr marL="306910" indent="0">
              <a:buNone/>
              <a:defRPr/>
            </a:lvl2pPr>
          </a:lstStyle>
          <a:p>
            <a:pPr lvl="0"/>
            <a:r>
              <a:rPr lang="en-US"/>
              <a:t>Click to edit Master text styles</a:t>
            </a:r>
          </a:p>
        </p:txBody>
      </p:sp>
      <p:sp>
        <p:nvSpPr>
          <p:cNvPr id="21" name="Content Placeholder 2"/>
          <p:cNvSpPr>
            <a:spLocks noGrp="1"/>
          </p:cNvSpPr>
          <p:nvPr>
            <p:ph sz="half" idx="15"/>
          </p:nvPr>
        </p:nvSpPr>
        <p:spPr>
          <a:xfrm>
            <a:off x="6400800" y="2231137"/>
            <a:ext cx="5181600" cy="3674876"/>
          </a:xfrm>
        </p:spPr>
        <p:txBody>
          <a:bodyPr vert="horz" lIns="0" tIns="0" rIns="0" bIns="0" rtlCol="0">
            <a:noAutofit/>
          </a:bodyPr>
          <a:lstStyle>
            <a:lvl1pPr>
              <a:defRPr lang="en-US"/>
            </a:lvl1pPr>
            <a:lvl2pPr>
              <a:defRPr lang="en-US"/>
            </a:lvl2pPr>
            <a:lvl3pPr>
              <a:defRPr lang="en-US"/>
            </a:lvl3pPr>
            <a:lvl4pPr>
              <a:defRPr lang="en-US"/>
            </a:lvl4pPr>
            <a:lvl5pPr>
              <a:defRPr lang="en-US" dirty="0"/>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9" name="Footer Placeholder 4"/>
          <p:cNvSpPr>
            <a:spLocks noGrp="1"/>
          </p:cNvSpPr>
          <p:nvPr>
            <p:ph type="ftr" sz="quarter" idx="3"/>
          </p:nvPr>
        </p:nvSpPr>
        <p:spPr>
          <a:xfrm>
            <a:off x="1026597" y="6465181"/>
            <a:ext cx="4517089" cy="169277"/>
          </a:xfrm>
          <a:prstGeom prst="rect">
            <a:avLst/>
          </a:prstGeom>
        </p:spPr>
        <p:txBody>
          <a:bodyPr vert="horz" wrap="square" lIns="0" tIns="0" rIns="0" bIns="0" rtlCol="0" anchor="ctr">
            <a:spAutoFit/>
          </a:bodyPr>
          <a:lstStyle>
            <a:lvl1pPr algn="l">
              <a:defRPr sz="1100">
                <a:solidFill>
                  <a:schemeClr val="tx1"/>
                </a:solidFill>
              </a:defRPr>
            </a:lvl1pPr>
          </a:lstStyle>
          <a:p>
            <a:r>
              <a:rPr lang="en-US"/>
              <a:t>Division Name or Footer</a:t>
            </a:r>
          </a:p>
        </p:txBody>
      </p:sp>
      <p:sp>
        <p:nvSpPr>
          <p:cNvPr id="11" name="Slide Number Placeholder 5"/>
          <p:cNvSpPr>
            <a:spLocks noGrp="1"/>
          </p:cNvSpPr>
          <p:nvPr>
            <p:ph type="sldNum" sz="quarter" idx="4"/>
          </p:nvPr>
        </p:nvSpPr>
        <p:spPr>
          <a:xfrm>
            <a:off x="609601" y="6455138"/>
            <a:ext cx="339625" cy="169277"/>
          </a:xfrm>
          <a:prstGeom prst="rect">
            <a:avLst/>
          </a:prstGeom>
        </p:spPr>
        <p:txBody>
          <a:bodyPr vert="horz" wrap="square" lIns="0" tIns="0" rIns="0" bIns="0" rtlCol="0" anchor="ctr">
            <a:spAutoFit/>
          </a:bodyPr>
          <a:lstStyle>
            <a:lvl1pPr algn="l">
              <a:defRPr sz="1100">
                <a:solidFill>
                  <a:schemeClr val="tx1"/>
                </a:solidFill>
              </a:defRPr>
            </a:lvl1pPr>
          </a:lstStyle>
          <a:p>
            <a:fld id="{7FEEEA1A-CB49-3744-AA40-B896987410F9}" type="slidenum">
              <a:rPr lang="en-US" smtClean="0"/>
              <a:pPr/>
              <a:t>‹#›</a:t>
            </a:fld>
            <a:endParaRPr lang="en-US"/>
          </a:p>
        </p:txBody>
      </p:sp>
      <p:sp>
        <p:nvSpPr>
          <p:cNvPr id="12" name="Title 1"/>
          <p:cNvSpPr>
            <a:spLocks noGrp="1"/>
          </p:cNvSpPr>
          <p:nvPr>
            <p:ph type="title"/>
          </p:nvPr>
        </p:nvSpPr>
        <p:spPr>
          <a:xfrm>
            <a:off x="609599" y="1048512"/>
            <a:ext cx="10972803" cy="418576"/>
          </a:xfrm>
        </p:spPr>
        <p:txBody>
          <a:bodyPr vert="horz" lIns="0" tIns="0" rIns="0" bIns="0" rtlCol="0" anchor="b" anchorCtr="0">
            <a:noAutofit/>
          </a:bodyPr>
          <a:lstStyle>
            <a:lvl1pPr>
              <a:defRPr lang="en-US" sz="3200" b="1" i="0" kern="1200" cap="none" dirty="0">
                <a:solidFill>
                  <a:schemeClr val="tx2"/>
                </a:solidFill>
                <a:latin typeface="+mj-lt"/>
                <a:ea typeface="+mj-ea"/>
                <a:cs typeface="+mj-cs"/>
              </a:defRPr>
            </a:lvl1pPr>
          </a:lstStyle>
          <a:p>
            <a:pPr lvl="0" algn="l" defTabSz="457189" rtl="0" eaLnBrk="1" latinLnBrk="0" hangingPunct="1">
              <a:lnSpc>
                <a:spcPct val="85000"/>
              </a:lnSpc>
              <a:spcBef>
                <a:spcPct val="0"/>
              </a:spcBef>
              <a:buNone/>
            </a:pPr>
            <a:r>
              <a:rPr lang="en-US"/>
              <a:t>Click to edit Master title style</a:t>
            </a:r>
          </a:p>
        </p:txBody>
      </p:sp>
      <p:sp>
        <p:nvSpPr>
          <p:cNvPr id="10" name="Content Placeholder 2"/>
          <p:cNvSpPr>
            <a:spLocks noGrp="1"/>
          </p:cNvSpPr>
          <p:nvPr>
            <p:ph sz="half" idx="1"/>
          </p:nvPr>
        </p:nvSpPr>
        <p:spPr>
          <a:xfrm>
            <a:off x="609599" y="2236614"/>
            <a:ext cx="5181600" cy="3669399"/>
          </a:xfrm>
        </p:spPr>
        <p:txBody>
          <a:bodyPr vert="horz" lIns="0" tIns="0" rIns="0" bIns="0" rtlCol="0">
            <a:noAutofit/>
          </a:bodyPr>
          <a:lstStyle>
            <a:lvl1pPr>
              <a:defRPr lang="en-US" dirty="0"/>
            </a:lvl1pPr>
            <a:lvl2pPr>
              <a:defRPr lang="en-US" dirty="0"/>
            </a:lvl2pPr>
            <a:lvl3pPr>
              <a:defRPr lang="en-US" dirty="0"/>
            </a:lvl3pPr>
            <a:lvl4pPr>
              <a:defRPr lang="en-US" dirty="0"/>
            </a:lvl4pPr>
            <a:lvl5pPr>
              <a:defRPr lang="en-US" dirty="0"/>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444209338"/>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preserve="1" userDrawn="1">
  <p:cSld name="1_Title Only">
    <p:spTree>
      <p:nvGrpSpPr>
        <p:cNvPr id="1" name=""/>
        <p:cNvGrpSpPr/>
        <p:nvPr/>
      </p:nvGrpSpPr>
      <p:grpSpPr>
        <a:xfrm>
          <a:off x="0" y="0"/>
          <a:ext cx="0" cy="0"/>
          <a:chOff x="0" y="0"/>
          <a:chExt cx="0" cy="0"/>
        </a:xfrm>
      </p:grpSpPr>
      <p:sp>
        <p:nvSpPr>
          <p:cNvPr id="5" name="Footer Placeholder 4"/>
          <p:cNvSpPr>
            <a:spLocks noGrp="1"/>
          </p:cNvSpPr>
          <p:nvPr>
            <p:ph type="ftr" sz="quarter" idx="3"/>
          </p:nvPr>
        </p:nvSpPr>
        <p:spPr>
          <a:xfrm>
            <a:off x="1026597" y="6465181"/>
            <a:ext cx="4517089" cy="169277"/>
          </a:xfrm>
          <a:prstGeom prst="rect">
            <a:avLst/>
          </a:prstGeom>
        </p:spPr>
        <p:txBody>
          <a:bodyPr vert="horz" wrap="square" lIns="0" tIns="0" rIns="0" bIns="0" rtlCol="0" anchor="ctr">
            <a:spAutoFit/>
          </a:bodyPr>
          <a:lstStyle>
            <a:lvl1pPr algn="l">
              <a:defRPr sz="1100">
                <a:solidFill>
                  <a:schemeClr val="tx1"/>
                </a:solidFill>
              </a:defRPr>
            </a:lvl1pPr>
          </a:lstStyle>
          <a:p>
            <a:r>
              <a:rPr lang="en-US"/>
              <a:t>Division Name or Footer</a:t>
            </a:r>
          </a:p>
        </p:txBody>
      </p:sp>
      <p:sp>
        <p:nvSpPr>
          <p:cNvPr id="7" name="Slide Number Placeholder 5"/>
          <p:cNvSpPr>
            <a:spLocks noGrp="1"/>
          </p:cNvSpPr>
          <p:nvPr>
            <p:ph type="sldNum" sz="quarter" idx="4"/>
          </p:nvPr>
        </p:nvSpPr>
        <p:spPr>
          <a:xfrm>
            <a:off x="609601" y="6455138"/>
            <a:ext cx="339625" cy="169277"/>
          </a:xfrm>
          <a:prstGeom prst="rect">
            <a:avLst/>
          </a:prstGeom>
        </p:spPr>
        <p:txBody>
          <a:bodyPr vert="horz" wrap="square" lIns="0" tIns="0" rIns="0" bIns="0" rtlCol="0" anchor="ctr">
            <a:spAutoFit/>
          </a:bodyPr>
          <a:lstStyle>
            <a:lvl1pPr algn="l">
              <a:defRPr sz="1100">
                <a:solidFill>
                  <a:schemeClr val="tx1"/>
                </a:solidFill>
              </a:defRPr>
            </a:lvl1pPr>
          </a:lstStyle>
          <a:p>
            <a:fld id="{7FEEEA1A-CB49-3744-AA40-B896987410F9}" type="slidenum">
              <a:rPr lang="en-US" smtClean="0"/>
              <a:pPr/>
              <a:t>‹#›</a:t>
            </a:fld>
            <a:endParaRPr lang="en-US"/>
          </a:p>
        </p:txBody>
      </p:sp>
      <p:sp>
        <p:nvSpPr>
          <p:cNvPr id="8" name="Title 1"/>
          <p:cNvSpPr>
            <a:spLocks noGrp="1"/>
          </p:cNvSpPr>
          <p:nvPr>
            <p:ph type="title"/>
          </p:nvPr>
        </p:nvSpPr>
        <p:spPr>
          <a:xfrm>
            <a:off x="609599" y="1048512"/>
            <a:ext cx="10972803" cy="418576"/>
          </a:xfrm>
        </p:spPr>
        <p:txBody>
          <a:bodyPr vert="horz" lIns="0" tIns="0" rIns="0" bIns="0" rtlCol="0" anchor="b" anchorCtr="0">
            <a:noAutofit/>
          </a:bodyPr>
          <a:lstStyle>
            <a:lvl1pPr>
              <a:defRPr lang="en-US" sz="3200" b="1" i="0" kern="1200" cap="none" dirty="0">
                <a:solidFill>
                  <a:schemeClr val="tx2"/>
                </a:solidFill>
                <a:latin typeface="+mj-lt"/>
                <a:ea typeface="+mj-ea"/>
                <a:cs typeface="+mj-cs"/>
              </a:defRPr>
            </a:lvl1pPr>
          </a:lstStyle>
          <a:p>
            <a:pPr lvl="0" algn="l" defTabSz="457189" rtl="0" eaLnBrk="1" latinLnBrk="0" hangingPunct="1">
              <a:lnSpc>
                <a:spcPct val="85000"/>
              </a:lnSpc>
              <a:spcBef>
                <a:spcPct val="0"/>
              </a:spcBef>
              <a:buNone/>
            </a:pPr>
            <a:r>
              <a:rPr lang="en-US"/>
              <a:t>Click to edit Master title style</a:t>
            </a:r>
          </a:p>
        </p:txBody>
      </p:sp>
    </p:spTree>
    <p:extLst>
      <p:ext uri="{BB962C8B-B14F-4D97-AF65-F5344CB8AC3E}">
        <p14:creationId xmlns:p14="http://schemas.microsoft.com/office/powerpoint/2010/main" val="2040078433"/>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showMasterSp="0" preserve="1" userDrawn="1">
  <p:cSld name="1_Content with Caption">
    <p:bg>
      <p:bgPr>
        <a:solidFill>
          <a:schemeClr val="bg1"/>
        </a:solidFill>
        <a:effectLst/>
      </p:bgPr>
    </p:bg>
    <p:spTree>
      <p:nvGrpSpPr>
        <p:cNvPr id="1" name=""/>
        <p:cNvGrpSpPr/>
        <p:nvPr/>
      </p:nvGrpSpPr>
      <p:grpSpPr>
        <a:xfrm>
          <a:off x="0" y="0"/>
          <a:ext cx="0" cy="0"/>
          <a:chOff x="0" y="0"/>
          <a:chExt cx="0" cy="0"/>
        </a:xfrm>
      </p:grpSpPr>
      <p:sp>
        <p:nvSpPr>
          <p:cNvPr id="5" name="Rectangle 4"/>
          <p:cNvSpPr/>
          <p:nvPr userDrawn="1"/>
        </p:nvSpPr>
        <p:spPr>
          <a:xfrm>
            <a:off x="-1" y="-20491"/>
            <a:ext cx="6784975" cy="6878491"/>
          </a:xfrm>
          <a:prstGeom prst="rect">
            <a:avLst/>
          </a:prstGeom>
          <a:solidFill>
            <a:schemeClr val="tx2"/>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7" name="Picture Placeholder 6"/>
          <p:cNvSpPr>
            <a:spLocks noGrp="1"/>
          </p:cNvSpPr>
          <p:nvPr>
            <p:ph type="pic" sz="quarter" idx="10"/>
          </p:nvPr>
        </p:nvSpPr>
        <p:spPr>
          <a:xfrm>
            <a:off x="6784973" y="0"/>
            <a:ext cx="5407027" cy="3918136"/>
          </a:xfrm>
          <a:custGeom>
            <a:avLst/>
            <a:gdLst>
              <a:gd name="connsiteX0" fmla="*/ 0 w 4035853"/>
              <a:gd name="connsiteY0" fmla="*/ 0 h 2697096"/>
              <a:gd name="connsiteX1" fmla="*/ 4035853 w 4035853"/>
              <a:gd name="connsiteY1" fmla="*/ 0 h 2697096"/>
              <a:gd name="connsiteX2" fmla="*/ 4035853 w 4035853"/>
              <a:gd name="connsiteY2" fmla="*/ 2697096 h 2697096"/>
              <a:gd name="connsiteX3" fmla="*/ 0 w 4035853"/>
              <a:gd name="connsiteY3" fmla="*/ 2697096 h 2697096"/>
              <a:gd name="connsiteX4" fmla="*/ 0 w 4035853"/>
              <a:gd name="connsiteY4" fmla="*/ 0 h 2697096"/>
              <a:gd name="connsiteX0" fmla="*/ 0 w 4035853"/>
              <a:gd name="connsiteY0" fmla="*/ 0 h 2700356"/>
              <a:gd name="connsiteX1" fmla="*/ 4035853 w 4035853"/>
              <a:gd name="connsiteY1" fmla="*/ 0 h 2700356"/>
              <a:gd name="connsiteX2" fmla="*/ 4035853 w 4035853"/>
              <a:gd name="connsiteY2" fmla="*/ 2697096 h 2700356"/>
              <a:gd name="connsiteX3" fmla="*/ 323823 w 4035853"/>
              <a:gd name="connsiteY3" fmla="*/ 2700356 h 2700356"/>
              <a:gd name="connsiteX4" fmla="*/ 0 w 4035853"/>
              <a:gd name="connsiteY4" fmla="*/ 2697096 h 2700356"/>
              <a:gd name="connsiteX5" fmla="*/ 0 w 4035853"/>
              <a:gd name="connsiteY5" fmla="*/ 0 h 2700356"/>
              <a:gd name="connsiteX0" fmla="*/ 0 w 4035853"/>
              <a:gd name="connsiteY0" fmla="*/ 0 h 2700356"/>
              <a:gd name="connsiteX1" fmla="*/ 4035853 w 4035853"/>
              <a:gd name="connsiteY1" fmla="*/ 0 h 2700356"/>
              <a:gd name="connsiteX2" fmla="*/ 4035853 w 4035853"/>
              <a:gd name="connsiteY2" fmla="*/ 2697096 h 2700356"/>
              <a:gd name="connsiteX3" fmla="*/ 323823 w 4035853"/>
              <a:gd name="connsiteY3" fmla="*/ 2700356 h 2700356"/>
              <a:gd name="connsiteX4" fmla="*/ 0 w 4035853"/>
              <a:gd name="connsiteY4" fmla="*/ 2697096 h 2700356"/>
              <a:gd name="connsiteX5" fmla="*/ 0 w 4035853"/>
              <a:gd name="connsiteY5" fmla="*/ 0 h 2700356"/>
              <a:gd name="connsiteX0" fmla="*/ 0 w 4035853"/>
              <a:gd name="connsiteY0" fmla="*/ 0 h 2700356"/>
              <a:gd name="connsiteX1" fmla="*/ 4035853 w 4035853"/>
              <a:gd name="connsiteY1" fmla="*/ 0 h 2700356"/>
              <a:gd name="connsiteX2" fmla="*/ 4035853 w 4035853"/>
              <a:gd name="connsiteY2" fmla="*/ 2697096 h 2700356"/>
              <a:gd name="connsiteX3" fmla="*/ 612823 w 4035853"/>
              <a:gd name="connsiteY3" fmla="*/ 2689412 h 2700356"/>
              <a:gd name="connsiteX4" fmla="*/ 323823 w 4035853"/>
              <a:gd name="connsiteY4" fmla="*/ 2700356 h 2700356"/>
              <a:gd name="connsiteX5" fmla="*/ 0 w 4035853"/>
              <a:gd name="connsiteY5" fmla="*/ 2697096 h 2700356"/>
              <a:gd name="connsiteX6" fmla="*/ 0 w 4035853"/>
              <a:gd name="connsiteY6" fmla="*/ 0 h 2700356"/>
              <a:gd name="connsiteX0" fmla="*/ 0 w 4035853"/>
              <a:gd name="connsiteY0" fmla="*/ 0 h 2700356"/>
              <a:gd name="connsiteX1" fmla="*/ 4035853 w 4035853"/>
              <a:gd name="connsiteY1" fmla="*/ 0 h 2700356"/>
              <a:gd name="connsiteX2" fmla="*/ 4035853 w 4035853"/>
              <a:gd name="connsiteY2" fmla="*/ 2697096 h 2700356"/>
              <a:gd name="connsiteX3" fmla="*/ 612823 w 4035853"/>
              <a:gd name="connsiteY3" fmla="*/ 2689412 h 2700356"/>
              <a:gd name="connsiteX4" fmla="*/ 323823 w 4035853"/>
              <a:gd name="connsiteY4" fmla="*/ 2700356 h 2700356"/>
              <a:gd name="connsiteX5" fmla="*/ 0 w 4035853"/>
              <a:gd name="connsiteY5" fmla="*/ 2697096 h 2700356"/>
              <a:gd name="connsiteX6" fmla="*/ 0 w 4035853"/>
              <a:gd name="connsiteY6" fmla="*/ 0 h 2700356"/>
              <a:gd name="connsiteX0" fmla="*/ 0 w 4035853"/>
              <a:gd name="connsiteY0" fmla="*/ 0 h 2700356"/>
              <a:gd name="connsiteX1" fmla="*/ 4035853 w 4035853"/>
              <a:gd name="connsiteY1" fmla="*/ 0 h 2700356"/>
              <a:gd name="connsiteX2" fmla="*/ 4035853 w 4035853"/>
              <a:gd name="connsiteY2" fmla="*/ 2697096 h 2700356"/>
              <a:gd name="connsiteX3" fmla="*/ 612823 w 4035853"/>
              <a:gd name="connsiteY3" fmla="*/ 2689412 h 2700356"/>
              <a:gd name="connsiteX4" fmla="*/ 323823 w 4035853"/>
              <a:gd name="connsiteY4" fmla="*/ 2700356 h 2700356"/>
              <a:gd name="connsiteX5" fmla="*/ 0 w 4035853"/>
              <a:gd name="connsiteY5" fmla="*/ 2697096 h 2700356"/>
              <a:gd name="connsiteX6" fmla="*/ 0 w 4035853"/>
              <a:gd name="connsiteY6" fmla="*/ 0 h 2700356"/>
              <a:gd name="connsiteX0" fmla="*/ 0 w 4035853"/>
              <a:gd name="connsiteY0" fmla="*/ 0 h 2700645"/>
              <a:gd name="connsiteX1" fmla="*/ 4035853 w 4035853"/>
              <a:gd name="connsiteY1" fmla="*/ 0 h 2700645"/>
              <a:gd name="connsiteX2" fmla="*/ 4035853 w 4035853"/>
              <a:gd name="connsiteY2" fmla="*/ 2697096 h 2700645"/>
              <a:gd name="connsiteX3" fmla="*/ 612823 w 4035853"/>
              <a:gd name="connsiteY3" fmla="*/ 2689412 h 2700645"/>
              <a:gd name="connsiteX4" fmla="*/ 323823 w 4035853"/>
              <a:gd name="connsiteY4" fmla="*/ 2700356 h 2700645"/>
              <a:gd name="connsiteX5" fmla="*/ 0 w 4035853"/>
              <a:gd name="connsiteY5" fmla="*/ 2697096 h 2700645"/>
              <a:gd name="connsiteX6" fmla="*/ 0 w 4035853"/>
              <a:gd name="connsiteY6" fmla="*/ 0 h 2700645"/>
              <a:gd name="connsiteX0" fmla="*/ 0 w 4035853"/>
              <a:gd name="connsiteY0" fmla="*/ 0 h 2700645"/>
              <a:gd name="connsiteX1" fmla="*/ 4035853 w 4035853"/>
              <a:gd name="connsiteY1" fmla="*/ 0 h 2700645"/>
              <a:gd name="connsiteX2" fmla="*/ 4035853 w 4035853"/>
              <a:gd name="connsiteY2" fmla="*/ 2697096 h 2700645"/>
              <a:gd name="connsiteX3" fmla="*/ 612823 w 4035853"/>
              <a:gd name="connsiteY3" fmla="*/ 2689412 h 2700645"/>
              <a:gd name="connsiteX4" fmla="*/ 171423 w 4035853"/>
              <a:gd name="connsiteY4" fmla="*/ 2700356 h 2700645"/>
              <a:gd name="connsiteX5" fmla="*/ 0 w 4035853"/>
              <a:gd name="connsiteY5" fmla="*/ 2697096 h 2700645"/>
              <a:gd name="connsiteX6" fmla="*/ 0 w 4035853"/>
              <a:gd name="connsiteY6" fmla="*/ 0 h 2700645"/>
              <a:gd name="connsiteX0" fmla="*/ 0 w 4035853"/>
              <a:gd name="connsiteY0" fmla="*/ 0 h 2700645"/>
              <a:gd name="connsiteX1" fmla="*/ 4035853 w 4035853"/>
              <a:gd name="connsiteY1" fmla="*/ 0 h 2700645"/>
              <a:gd name="connsiteX2" fmla="*/ 4035853 w 4035853"/>
              <a:gd name="connsiteY2" fmla="*/ 2697096 h 2700645"/>
              <a:gd name="connsiteX3" fmla="*/ 612823 w 4035853"/>
              <a:gd name="connsiteY3" fmla="*/ 2689412 h 2700645"/>
              <a:gd name="connsiteX4" fmla="*/ 171423 w 4035853"/>
              <a:gd name="connsiteY4" fmla="*/ 2700356 h 2700645"/>
              <a:gd name="connsiteX5" fmla="*/ 0 w 4035853"/>
              <a:gd name="connsiteY5" fmla="*/ 2697096 h 2700645"/>
              <a:gd name="connsiteX6" fmla="*/ 0 w 4035853"/>
              <a:gd name="connsiteY6" fmla="*/ 0 h 2700645"/>
              <a:gd name="connsiteX0" fmla="*/ 0 w 4035853"/>
              <a:gd name="connsiteY0" fmla="*/ 0 h 2700356"/>
              <a:gd name="connsiteX1" fmla="*/ 4035853 w 4035853"/>
              <a:gd name="connsiteY1" fmla="*/ 0 h 2700356"/>
              <a:gd name="connsiteX2" fmla="*/ 4035853 w 4035853"/>
              <a:gd name="connsiteY2" fmla="*/ 2697096 h 2700356"/>
              <a:gd name="connsiteX3" fmla="*/ 612823 w 4035853"/>
              <a:gd name="connsiteY3" fmla="*/ 2689412 h 2700356"/>
              <a:gd name="connsiteX4" fmla="*/ 171423 w 4035853"/>
              <a:gd name="connsiteY4" fmla="*/ 2700356 h 2700356"/>
              <a:gd name="connsiteX5" fmla="*/ 0 w 4035853"/>
              <a:gd name="connsiteY5" fmla="*/ 2697096 h 2700356"/>
              <a:gd name="connsiteX6" fmla="*/ 0 w 4035853"/>
              <a:gd name="connsiteY6" fmla="*/ 0 h 2700356"/>
              <a:gd name="connsiteX0" fmla="*/ 0 w 4035853"/>
              <a:gd name="connsiteY0" fmla="*/ 0 h 2697975"/>
              <a:gd name="connsiteX1" fmla="*/ 4035853 w 4035853"/>
              <a:gd name="connsiteY1" fmla="*/ 0 h 2697975"/>
              <a:gd name="connsiteX2" fmla="*/ 4035853 w 4035853"/>
              <a:gd name="connsiteY2" fmla="*/ 2697096 h 2697975"/>
              <a:gd name="connsiteX3" fmla="*/ 612823 w 4035853"/>
              <a:gd name="connsiteY3" fmla="*/ 2689412 h 2697975"/>
              <a:gd name="connsiteX4" fmla="*/ 171423 w 4035853"/>
              <a:gd name="connsiteY4" fmla="*/ 2697975 h 2697975"/>
              <a:gd name="connsiteX5" fmla="*/ 0 w 4035853"/>
              <a:gd name="connsiteY5" fmla="*/ 2697096 h 2697975"/>
              <a:gd name="connsiteX6" fmla="*/ 0 w 4035853"/>
              <a:gd name="connsiteY6" fmla="*/ 0 h 2697975"/>
              <a:gd name="connsiteX0" fmla="*/ 0 w 4035853"/>
              <a:gd name="connsiteY0" fmla="*/ 0 h 2698065"/>
              <a:gd name="connsiteX1" fmla="*/ 4035853 w 4035853"/>
              <a:gd name="connsiteY1" fmla="*/ 0 h 2698065"/>
              <a:gd name="connsiteX2" fmla="*/ 4035853 w 4035853"/>
              <a:gd name="connsiteY2" fmla="*/ 2697096 h 2698065"/>
              <a:gd name="connsiteX3" fmla="*/ 612823 w 4035853"/>
              <a:gd name="connsiteY3" fmla="*/ 2689412 h 2698065"/>
              <a:gd name="connsiteX4" fmla="*/ 171423 w 4035853"/>
              <a:gd name="connsiteY4" fmla="*/ 2697975 h 2698065"/>
              <a:gd name="connsiteX5" fmla="*/ 0 w 4035853"/>
              <a:gd name="connsiteY5" fmla="*/ 2697096 h 2698065"/>
              <a:gd name="connsiteX6" fmla="*/ 0 w 4035853"/>
              <a:gd name="connsiteY6" fmla="*/ 0 h 2698065"/>
              <a:gd name="connsiteX0" fmla="*/ 0 w 4035853"/>
              <a:gd name="connsiteY0" fmla="*/ 0 h 2697975"/>
              <a:gd name="connsiteX1" fmla="*/ 4035853 w 4035853"/>
              <a:gd name="connsiteY1" fmla="*/ 0 h 2697975"/>
              <a:gd name="connsiteX2" fmla="*/ 4035853 w 4035853"/>
              <a:gd name="connsiteY2" fmla="*/ 2697096 h 2697975"/>
              <a:gd name="connsiteX3" fmla="*/ 581867 w 4035853"/>
              <a:gd name="connsiteY3" fmla="*/ 2696556 h 2697975"/>
              <a:gd name="connsiteX4" fmla="*/ 171423 w 4035853"/>
              <a:gd name="connsiteY4" fmla="*/ 2697975 h 2697975"/>
              <a:gd name="connsiteX5" fmla="*/ 0 w 4035853"/>
              <a:gd name="connsiteY5" fmla="*/ 2697096 h 2697975"/>
              <a:gd name="connsiteX6" fmla="*/ 0 w 4035853"/>
              <a:gd name="connsiteY6" fmla="*/ 0 h 2697975"/>
              <a:gd name="connsiteX0" fmla="*/ 0 w 4035853"/>
              <a:gd name="connsiteY0" fmla="*/ 0 h 2697975"/>
              <a:gd name="connsiteX1" fmla="*/ 4035853 w 4035853"/>
              <a:gd name="connsiteY1" fmla="*/ 0 h 2697975"/>
              <a:gd name="connsiteX2" fmla="*/ 4035853 w 4035853"/>
              <a:gd name="connsiteY2" fmla="*/ 2697096 h 2697975"/>
              <a:gd name="connsiteX3" fmla="*/ 581867 w 4035853"/>
              <a:gd name="connsiteY3" fmla="*/ 2696556 h 2697975"/>
              <a:gd name="connsiteX4" fmla="*/ 171423 w 4035853"/>
              <a:gd name="connsiteY4" fmla="*/ 2697975 h 2697975"/>
              <a:gd name="connsiteX5" fmla="*/ 0 w 4035853"/>
              <a:gd name="connsiteY5" fmla="*/ 2697096 h 2697975"/>
              <a:gd name="connsiteX6" fmla="*/ 0 w 4035853"/>
              <a:gd name="connsiteY6" fmla="*/ 0 h 2697975"/>
              <a:gd name="connsiteX0" fmla="*/ 0 w 4035853"/>
              <a:gd name="connsiteY0" fmla="*/ 0 h 2698071"/>
              <a:gd name="connsiteX1" fmla="*/ 4035853 w 4035853"/>
              <a:gd name="connsiteY1" fmla="*/ 0 h 2698071"/>
              <a:gd name="connsiteX2" fmla="*/ 4035853 w 4035853"/>
              <a:gd name="connsiteY2" fmla="*/ 2697096 h 2698071"/>
              <a:gd name="connsiteX3" fmla="*/ 438992 w 4035853"/>
              <a:gd name="connsiteY3" fmla="*/ 2696556 h 2698071"/>
              <a:gd name="connsiteX4" fmla="*/ 171423 w 4035853"/>
              <a:gd name="connsiteY4" fmla="*/ 2697975 h 2698071"/>
              <a:gd name="connsiteX5" fmla="*/ 0 w 4035853"/>
              <a:gd name="connsiteY5" fmla="*/ 2697096 h 2698071"/>
              <a:gd name="connsiteX6" fmla="*/ 0 w 4035853"/>
              <a:gd name="connsiteY6" fmla="*/ 0 h 2698071"/>
              <a:gd name="connsiteX0" fmla="*/ 0 w 4035853"/>
              <a:gd name="connsiteY0" fmla="*/ 0 h 2698071"/>
              <a:gd name="connsiteX1" fmla="*/ 4035853 w 4035853"/>
              <a:gd name="connsiteY1" fmla="*/ 0 h 2698071"/>
              <a:gd name="connsiteX2" fmla="*/ 4035853 w 4035853"/>
              <a:gd name="connsiteY2" fmla="*/ 2697096 h 2698071"/>
              <a:gd name="connsiteX3" fmla="*/ 441373 w 4035853"/>
              <a:gd name="connsiteY3" fmla="*/ 2696556 h 2698071"/>
              <a:gd name="connsiteX4" fmla="*/ 171423 w 4035853"/>
              <a:gd name="connsiteY4" fmla="*/ 2697975 h 2698071"/>
              <a:gd name="connsiteX5" fmla="*/ 0 w 4035853"/>
              <a:gd name="connsiteY5" fmla="*/ 2697096 h 2698071"/>
              <a:gd name="connsiteX6" fmla="*/ 0 w 4035853"/>
              <a:gd name="connsiteY6" fmla="*/ 0 h 2698071"/>
              <a:gd name="connsiteX0" fmla="*/ 0 w 4035853"/>
              <a:gd name="connsiteY0" fmla="*/ 0 h 2700356"/>
              <a:gd name="connsiteX1" fmla="*/ 4035853 w 4035853"/>
              <a:gd name="connsiteY1" fmla="*/ 0 h 2700356"/>
              <a:gd name="connsiteX2" fmla="*/ 4035853 w 4035853"/>
              <a:gd name="connsiteY2" fmla="*/ 2697096 h 2700356"/>
              <a:gd name="connsiteX3" fmla="*/ 441373 w 4035853"/>
              <a:gd name="connsiteY3" fmla="*/ 2696556 h 2700356"/>
              <a:gd name="connsiteX4" fmla="*/ 173804 w 4035853"/>
              <a:gd name="connsiteY4" fmla="*/ 2700356 h 2700356"/>
              <a:gd name="connsiteX5" fmla="*/ 0 w 4035853"/>
              <a:gd name="connsiteY5" fmla="*/ 2697096 h 2700356"/>
              <a:gd name="connsiteX6" fmla="*/ 0 w 4035853"/>
              <a:gd name="connsiteY6" fmla="*/ 0 h 2700356"/>
              <a:gd name="connsiteX0" fmla="*/ 0 w 4035853"/>
              <a:gd name="connsiteY0" fmla="*/ 0 h 2700356"/>
              <a:gd name="connsiteX1" fmla="*/ 4035853 w 4035853"/>
              <a:gd name="connsiteY1" fmla="*/ 0 h 2700356"/>
              <a:gd name="connsiteX2" fmla="*/ 4035853 w 4035853"/>
              <a:gd name="connsiteY2" fmla="*/ 2697096 h 2700356"/>
              <a:gd name="connsiteX3" fmla="*/ 441373 w 4035853"/>
              <a:gd name="connsiteY3" fmla="*/ 2696556 h 2700356"/>
              <a:gd name="connsiteX4" fmla="*/ 173804 w 4035853"/>
              <a:gd name="connsiteY4" fmla="*/ 2700356 h 2700356"/>
              <a:gd name="connsiteX5" fmla="*/ 0 w 4035853"/>
              <a:gd name="connsiteY5" fmla="*/ 2697096 h 2700356"/>
              <a:gd name="connsiteX6" fmla="*/ 0 w 4035853"/>
              <a:gd name="connsiteY6" fmla="*/ 0 h 2700356"/>
              <a:gd name="connsiteX0" fmla="*/ 0 w 4035853"/>
              <a:gd name="connsiteY0" fmla="*/ 0 h 2700356"/>
              <a:gd name="connsiteX1" fmla="*/ 4035853 w 4035853"/>
              <a:gd name="connsiteY1" fmla="*/ 0 h 2700356"/>
              <a:gd name="connsiteX2" fmla="*/ 4035853 w 4035853"/>
              <a:gd name="connsiteY2" fmla="*/ 2697096 h 2700356"/>
              <a:gd name="connsiteX3" fmla="*/ 441373 w 4035853"/>
              <a:gd name="connsiteY3" fmla="*/ 2696556 h 2700356"/>
              <a:gd name="connsiteX4" fmla="*/ 173804 w 4035853"/>
              <a:gd name="connsiteY4" fmla="*/ 2700356 h 2700356"/>
              <a:gd name="connsiteX5" fmla="*/ 0 w 4035853"/>
              <a:gd name="connsiteY5" fmla="*/ 2697096 h 2700356"/>
              <a:gd name="connsiteX6" fmla="*/ 0 w 4035853"/>
              <a:gd name="connsiteY6" fmla="*/ 0 h 2700356"/>
              <a:gd name="connsiteX0" fmla="*/ 0 w 4035853"/>
              <a:gd name="connsiteY0" fmla="*/ 0 h 2700356"/>
              <a:gd name="connsiteX1" fmla="*/ 4035853 w 4035853"/>
              <a:gd name="connsiteY1" fmla="*/ 0 h 2700356"/>
              <a:gd name="connsiteX2" fmla="*/ 4035853 w 4035853"/>
              <a:gd name="connsiteY2" fmla="*/ 2697096 h 2700356"/>
              <a:gd name="connsiteX3" fmla="*/ 441373 w 4035853"/>
              <a:gd name="connsiteY3" fmla="*/ 2696556 h 2700356"/>
              <a:gd name="connsiteX4" fmla="*/ 164279 w 4035853"/>
              <a:gd name="connsiteY4" fmla="*/ 2700356 h 2700356"/>
              <a:gd name="connsiteX5" fmla="*/ 0 w 4035853"/>
              <a:gd name="connsiteY5" fmla="*/ 2697096 h 2700356"/>
              <a:gd name="connsiteX6" fmla="*/ 0 w 4035853"/>
              <a:gd name="connsiteY6" fmla="*/ 0 h 2700356"/>
              <a:gd name="connsiteX0" fmla="*/ 0 w 4035853"/>
              <a:gd name="connsiteY0" fmla="*/ 0 h 2700357"/>
              <a:gd name="connsiteX1" fmla="*/ 4035853 w 4035853"/>
              <a:gd name="connsiteY1" fmla="*/ 0 h 2700357"/>
              <a:gd name="connsiteX2" fmla="*/ 4035853 w 4035853"/>
              <a:gd name="connsiteY2" fmla="*/ 2697096 h 2700357"/>
              <a:gd name="connsiteX3" fmla="*/ 434229 w 4035853"/>
              <a:gd name="connsiteY3" fmla="*/ 2696556 h 2700357"/>
              <a:gd name="connsiteX4" fmla="*/ 164279 w 4035853"/>
              <a:gd name="connsiteY4" fmla="*/ 2700356 h 2700357"/>
              <a:gd name="connsiteX5" fmla="*/ 0 w 4035853"/>
              <a:gd name="connsiteY5" fmla="*/ 2697096 h 2700357"/>
              <a:gd name="connsiteX6" fmla="*/ 0 w 4035853"/>
              <a:gd name="connsiteY6" fmla="*/ 0 h 2700357"/>
              <a:gd name="connsiteX0" fmla="*/ 0 w 4035853"/>
              <a:gd name="connsiteY0" fmla="*/ 0 h 2701319"/>
              <a:gd name="connsiteX1" fmla="*/ 4035853 w 4035853"/>
              <a:gd name="connsiteY1" fmla="*/ 0 h 2701319"/>
              <a:gd name="connsiteX2" fmla="*/ 4035853 w 4035853"/>
              <a:gd name="connsiteY2" fmla="*/ 2697096 h 2701319"/>
              <a:gd name="connsiteX3" fmla="*/ 431848 w 4035853"/>
              <a:gd name="connsiteY3" fmla="*/ 2701319 h 2701319"/>
              <a:gd name="connsiteX4" fmla="*/ 164279 w 4035853"/>
              <a:gd name="connsiteY4" fmla="*/ 2700356 h 2701319"/>
              <a:gd name="connsiteX5" fmla="*/ 0 w 4035853"/>
              <a:gd name="connsiteY5" fmla="*/ 2697096 h 2701319"/>
              <a:gd name="connsiteX6" fmla="*/ 0 w 4035853"/>
              <a:gd name="connsiteY6" fmla="*/ 0 h 2701319"/>
              <a:gd name="connsiteX0" fmla="*/ 0 w 4035853"/>
              <a:gd name="connsiteY0" fmla="*/ 0 h 2701319"/>
              <a:gd name="connsiteX1" fmla="*/ 4035853 w 4035853"/>
              <a:gd name="connsiteY1" fmla="*/ 0 h 2701319"/>
              <a:gd name="connsiteX2" fmla="*/ 4035853 w 4035853"/>
              <a:gd name="connsiteY2" fmla="*/ 2697096 h 2701319"/>
              <a:gd name="connsiteX3" fmla="*/ 431848 w 4035853"/>
              <a:gd name="connsiteY3" fmla="*/ 2701319 h 2701319"/>
              <a:gd name="connsiteX4" fmla="*/ 311945 w 4035853"/>
              <a:gd name="connsiteY4" fmla="*/ 2697956 h 2701319"/>
              <a:gd name="connsiteX5" fmla="*/ 164279 w 4035853"/>
              <a:gd name="connsiteY5" fmla="*/ 2700356 h 2701319"/>
              <a:gd name="connsiteX6" fmla="*/ 0 w 4035853"/>
              <a:gd name="connsiteY6" fmla="*/ 2697096 h 2701319"/>
              <a:gd name="connsiteX7" fmla="*/ 0 w 4035853"/>
              <a:gd name="connsiteY7" fmla="*/ 0 h 2701319"/>
              <a:gd name="connsiteX0" fmla="*/ 0 w 4035853"/>
              <a:gd name="connsiteY0" fmla="*/ 0 h 2943225"/>
              <a:gd name="connsiteX1" fmla="*/ 4035853 w 4035853"/>
              <a:gd name="connsiteY1" fmla="*/ 0 h 2943225"/>
              <a:gd name="connsiteX2" fmla="*/ 4035853 w 4035853"/>
              <a:gd name="connsiteY2" fmla="*/ 2697096 h 2943225"/>
              <a:gd name="connsiteX3" fmla="*/ 431848 w 4035853"/>
              <a:gd name="connsiteY3" fmla="*/ 2701319 h 2943225"/>
              <a:gd name="connsiteX4" fmla="*/ 307182 w 4035853"/>
              <a:gd name="connsiteY4" fmla="*/ 2943225 h 2943225"/>
              <a:gd name="connsiteX5" fmla="*/ 164279 w 4035853"/>
              <a:gd name="connsiteY5" fmla="*/ 2700356 h 2943225"/>
              <a:gd name="connsiteX6" fmla="*/ 0 w 4035853"/>
              <a:gd name="connsiteY6" fmla="*/ 2697096 h 2943225"/>
              <a:gd name="connsiteX7" fmla="*/ 0 w 4035853"/>
              <a:gd name="connsiteY7" fmla="*/ 0 h 2943225"/>
              <a:gd name="connsiteX0" fmla="*/ 0 w 4035853"/>
              <a:gd name="connsiteY0" fmla="*/ 0 h 2943225"/>
              <a:gd name="connsiteX1" fmla="*/ 4035853 w 4035853"/>
              <a:gd name="connsiteY1" fmla="*/ 0 h 2943225"/>
              <a:gd name="connsiteX2" fmla="*/ 4035853 w 4035853"/>
              <a:gd name="connsiteY2" fmla="*/ 2697096 h 2943225"/>
              <a:gd name="connsiteX3" fmla="*/ 431848 w 4035853"/>
              <a:gd name="connsiteY3" fmla="*/ 2701319 h 2943225"/>
              <a:gd name="connsiteX4" fmla="*/ 307182 w 4035853"/>
              <a:gd name="connsiteY4" fmla="*/ 2943225 h 2943225"/>
              <a:gd name="connsiteX5" fmla="*/ 164279 w 4035853"/>
              <a:gd name="connsiteY5" fmla="*/ 2700356 h 2943225"/>
              <a:gd name="connsiteX6" fmla="*/ 0 w 4035853"/>
              <a:gd name="connsiteY6" fmla="*/ 2697096 h 2943225"/>
              <a:gd name="connsiteX7" fmla="*/ 0 w 4035853"/>
              <a:gd name="connsiteY7" fmla="*/ 0 h 2943225"/>
              <a:gd name="connsiteX0" fmla="*/ 0 w 4035853"/>
              <a:gd name="connsiteY0" fmla="*/ 0 h 2943225"/>
              <a:gd name="connsiteX1" fmla="*/ 4035853 w 4035853"/>
              <a:gd name="connsiteY1" fmla="*/ 0 h 2943225"/>
              <a:gd name="connsiteX2" fmla="*/ 4035853 w 4035853"/>
              <a:gd name="connsiteY2" fmla="*/ 2697096 h 2943225"/>
              <a:gd name="connsiteX3" fmla="*/ 431848 w 4035853"/>
              <a:gd name="connsiteY3" fmla="*/ 2701319 h 2943225"/>
              <a:gd name="connsiteX4" fmla="*/ 307182 w 4035853"/>
              <a:gd name="connsiteY4" fmla="*/ 2943225 h 2943225"/>
              <a:gd name="connsiteX5" fmla="*/ 164279 w 4035853"/>
              <a:gd name="connsiteY5" fmla="*/ 2700356 h 2943225"/>
              <a:gd name="connsiteX6" fmla="*/ 0 w 4035853"/>
              <a:gd name="connsiteY6" fmla="*/ 2697096 h 2943225"/>
              <a:gd name="connsiteX7" fmla="*/ 0 w 4035853"/>
              <a:gd name="connsiteY7" fmla="*/ 0 h 2943225"/>
              <a:gd name="connsiteX0" fmla="*/ 0 w 4035853"/>
              <a:gd name="connsiteY0" fmla="*/ 0 h 2943225"/>
              <a:gd name="connsiteX1" fmla="*/ 4035853 w 4035853"/>
              <a:gd name="connsiteY1" fmla="*/ 0 h 2943225"/>
              <a:gd name="connsiteX2" fmla="*/ 4035853 w 4035853"/>
              <a:gd name="connsiteY2" fmla="*/ 2697096 h 2943225"/>
              <a:gd name="connsiteX3" fmla="*/ 431848 w 4035853"/>
              <a:gd name="connsiteY3" fmla="*/ 2701319 h 2943225"/>
              <a:gd name="connsiteX4" fmla="*/ 307182 w 4035853"/>
              <a:gd name="connsiteY4" fmla="*/ 2943225 h 2943225"/>
              <a:gd name="connsiteX5" fmla="*/ 164279 w 4035853"/>
              <a:gd name="connsiteY5" fmla="*/ 2700356 h 2943225"/>
              <a:gd name="connsiteX6" fmla="*/ 0 w 4035853"/>
              <a:gd name="connsiteY6" fmla="*/ 2697096 h 2943225"/>
              <a:gd name="connsiteX7" fmla="*/ 0 w 4035853"/>
              <a:gd name="connsiteY7" fmla="*/ 0 h 2943225"/>
              <a:gd name="connsiteX0" fmla="*/ 0 w 4035853"/>
              <a:gd name="connsiteY0" fmla="*/ 0 h 2943225"/>
              <a:gd name="connsiteX1" fmla="*/ 4035853 w 4035853"/>
              <a:gd name="connsiteY1" fmla="*/ 0 h 2943225"/>
              <a:gd name="connsiteX2" fmla="*/ 4035853 w 4035853"/>
              <a:gd name="connsiteY2" fmla="*/ 2697096 h 2943225"/>
              <a:gd name="connsiteX3" fmla="*/ 431848 w 4035853"/>
              <a:gd name="connsiteY3" fmla="*/ 2701319 h 2943225"/>
              <a:gd name="connsiteX4" fmla="*/ 307182 w 4035853"/>
              <a:gd name="connsiteY4" fmla="*/ 2943225 h 2943225"/>
              <a:gd name="connsiteX5" fmla="*/ 164279 w 4035853"/>
              <a:gd name="connsiteY5" fmla="*/ 2700356 h 2943225"/>
              <a:gd name="connsiteX6" fmla="*/ 0 w 4035853"/>
              <a:gd name="connsiteY6" fmla="*/ 2697096 h 2943225"/>
              <a:gd name="connsiteX7" fmla="*/ 0 w 4035853"/>
              <a:gd name="connsiteY7" fmla="*/ 0 h 2943225"/>
              <a:gd name="connsiteX0" fmla="*/ 0 w 4035853"/>
              <a:gd name="connsiteY0" fmla="*/ 0 h 2936082"/>
              <a:gd name="connsiteX1" fmla="*/ 4035853 w 4035853"/>
              <a:gd name="connsiteY1" fmla="*/ 0 h 2936082"/>
              <a:gd name="connsiteX2" fmla="*/ 4035853 w 4035853"/>
              <a:gd name="connsiteY2" fmla="*/ 2697096 h 2936082"/>
              <a:gd name="connsiteX3" fmla="*/ 431848 w 4035853"/>
              <a:gd name="connsiteY3" fmla="*/ 2701319 h 2936082"/>
              <a:gd name="connsiteX4" fmla="*/ 302420 w 4035853"/>
              <a:gd name="connsiteY4" fmla="*/ 2936082 h 2936082"/>
              <a:gd name="connsiteX5" fmla="*/ 164279 w 4035853"/>
              <a:gd name="connsiteY5" fmla="*/ 2700356 h 2936082"/>
              <a:gd name="connsiteX6" fmla="*/ 0 w 4035853"/>
              <a:gd name="connsiteY6" fmla="*/ 2697096 h 2936082"/>
              <a:gd name="connsiteX7" fmla="*/ 0 w 4035853"/>
              <a:gd name="connsiteY7" fmla="*/ 0 h 2936082"/>
              <a:gd name="connsiteX0" fmla="*/ 0 w 4035853"/>
              <a:gd name="connsiteY0" fmla="*/ 0 h 2936082"/>
              <a:gd name="connsiteX1" fmla="*/ 4035853 w 4035853"/>
              <a:gd name="connsiteY1" fmla="*/ 0 h 2936082"/>
              <a:gd name="connsiteX2" fmla="*/ 4035853 w 4035853"/>
              <a:gd name="connsiteY2" fmla="*/ 2697096 h 2936082"/>
              <a:gd name="connsiteX3" fmla="*/ 431848 w 4035853"/>
              <a:gd name="connsiteY3" fmla="*/ 2701319 h 2936082"/>
              <a:gd name="connsiteX4" fmla="*/ 302420 w 4035853"/>
              <a:gd name="connsiteY4" fmla="*/ 2936082 h 2936082"/>
              <a:gd name="connsiteX5" fmla="*/ 164279 w 4035853"/>
              <a:gd name="connsiteY5" fmla="*/ 2700356 h 2936082"/>
              <a:gd name="connsiteX6" fmla="*/ 0 w 4035853"/>
              <a:gd name="connsiteY6" fmla="*/ 2697096 h 2936082"/>
              <a:gd name="connsiteX7" fmla="*/ 0 w 4035853"/>
              <a:gd name="connsiteY7" fmla="*/ 0 h 2936082"/>
              <a:gd name="connsiteX0" fmla="*/ 0 w 4035853"/>
              <a:gd name="connsiteY0" fmla="*/ 0 h 2936082"/>
              <a:gd name="connsiteX1" fmla="*/ 4035853 w 4035853"/>
              <a:gd name="connsiteY1" fmla="*/ 0 h 2936082"/>
              <a:gd name="connsiteX2" fmla="*/ 4035853 w 4035853"/>
              <a:gd name="connsiteY2" fmla="*/ 2697096 h 2936082"/>
              <a:gd name="connsiteX3" fmla="*/ 431848 w 4035853"/>
              <a:gd name="connsiteY3" fmla="*/ 2701319 h 2936082"/>
              <a:gd name="connsiteX4" fmla="*/ 302420 w 4035853"/>
              <a:gd name="connsiteY4" fmla="*/ 2936082 h 2936082"/>
              <a:gd name="connsiteX5" fmla="*/ 164279 w 4035853"/>
              <a:gd name="connsiteY5" fmla="*/ 2700356 h 2936082"/>
              <a:gd name="connsiteX6" fmla="*/ 0 w 4035853"/>
              <a:gd name="connsiteY6" fmla="*/ 2697096 h 2936082"/>
              <a:gd name="connsiteX7" fmla="*/ 0 w 4035853"/>
              <a:gd name="connsiteY7" fmla="*/ 0 h 2936082"/>
              <a:gd name="connsiteX0" fmla="*/ 0 w 4035853"/>
              <a:gd name="connsiteY0" fmla="*/ 0 h 2936085"/>
              <a:gd name="connsiteX1" fmla="*/ 4035853 w 4035853"/>
              <a:gd name="connsiteY1" fmla="*/ 0 h 2936085"/>
              <a:gd name="connsiteX2" fmla="*/ 4035853 w 4035853"/>
              <a:gd name="connsiteY2" fmla="*/ 2697096 h 2936085"/>
              <a:gd name="connsiteX3" fmla="*/ 431848 w 4035853"/>
              <a:gd name="connsiteY3" fmla="*/ 2701319 h 2936085"/>
              <a:gd name="connsiteX4" fmla="*/ 302420 w 4035853"/>
              <a:gd name="connsiteY4" fmla="*/ 2936082 h 2936085"/>
              <a:gd name="connsiteX5" fmla="*/ 166660 w 4035853"/>
              <a:gd name="connsiteY5" fmla="*/ 2695594 h 2936085"/>
              <a:gd name="connsiteX6" fmla="*/ 0 w 4035853"/>
              <a:gd name="connsiteY6" fmla="*/ 2697096 h 2936085"/>
              <a:gd name="connsiteX7" fmla="*/ 0 w 4035853"/>
              <a:gd name="connsiteY7" fmla="*/ 0 h 2936085"/>
              <a:gd name="connsiteX0" fmla="*/ 0 w 4035853"/>
              <a:gd name="connsiteY0" fmla="*/ 0 h 2936085"/>
              <a:gd name="connsiteX1" fmla="*/ 4035853 w 4035853"/>
              <a:gd name="connsiteY1" fmla="*/ 0 h 2936085"/>
              <a:gd name="connsiteX2" fmla="*/ 4035853 w 4035853"/>
              <a:gd name="connsiteY2" fmla="*/ 2697096 h 2936085"/>
              <a:gd name="connsiteX3" fmla="*/ 431848 w 4035853"/>
              <a:gd name="connsiteY3" fmla="*/ 2701319 h 2936085"/>
              <a:gd name="connsiteX4" fmla="*/ 302420 w 4035853"/>
              <a:gd name="connsiteY4" fmla="*/ 2936082 h 2936085"/>
              <a:gd name="connsiteX5" fmla="*/ 166660 w 4035853"/>
              <a:gd name="connsiteY5" fmla="*/ 2695594 h 2936085"/>
              <a:gd name="connsiteX6" fmla="*/ 0 w 4035853"/>
              <a:gd name="connsiteY6" fmla="*/ 2697096 h 2936085"/>
              <a:gd name="connsiteX7" fmla="*/ 0 w 4035853"/>
              <a:gd name="connsiteY7" fmla="*/ 0 h 2936085"/>
              <a:gd name="connsiteX0" fmla="*/ 0 w 4035853"/>
              <a:gd name="connsiteY0" fmla="*/ 0 h 2936085"/>
              <a:gd name="connsiteX1" fmla="*/ 4035853 w 4035853"/>
              <a:gd name="connsiteY1" fmla="*/ 0 h 2936085"/>
              <a:gd name="connsiteX2" fmla="*/ 4035853 w 4035853"/>
              <a:gd name="connsiteY2" fmla="*/ 2697096 h 2936085"/>
              <a:gd name="connsiteX3" fmla="*/ 431848 w 4035853"/>
              <a:gd name="connsiteY3" fmla="*/ 2701319 h 2936085"/>
              <a:gd name="connsiteX4" fmla="*/ 302420 w 4035853"/>
              <a:gd name="connsiteY4" fmla="*/ 2936082 h 2936085"/>
              <a:gd name="connsiteX5" fmla="*/ 166660 w 4035853"/>
              <a:gd name="connsiteY5" fmla="*/ 2695594 h 2936085"/>
              <a:gd name="connsiteX6" fmla="*/ 0 w 4035853"/>
              <a:gd name="connsiteY6" fmla="*/ 2697096 h 2936085"/>
              <a:gd name="connsiteX7" fmla="*/ 0 w 4035853"/>
              <a:gd name="connsiteY7" fmla="*/ 0 h 2936085"/>
              <a:gd name="connsiteX0" fmla="*/ 0 w 4035853"/>
              <a:gd name="connsiteY0" fmla="*/ 0 h 2936090"/>
              <a:gd name="connsiteX1" fmla="*/ 4035853 w 4035853"/>
              <a:gd name="connsiteY1" fmla="*/ 0 h 2936090"/>
              <a:gd name="connsiteX2" fmla="*/ 4035853 w 4035853"/>
              <a:gd name="connsiteY2" fmla="*/ 2697096 h 2936090"/>
              <a:gd name="connsiteX3" fmla="*/ 431848 w 4035853"/>
              <a:gd name="connsiteY3" fmla="*/ 2701319 h 2936090"/>
              <a:gd name="connsiteX4" fmla="*/ 302420 w 4035853"/>
              <a:gd name="connsiteY4" fmla="*/ 2936082 h 2936090"/>
              <a:gd name="connsiteX5" fmla="*/ 166660 w 4035853"/>
              <a:gd name="connsiteY5" fmla="*/ 2695594 h 2936090"/>
              <a:gd name="connsiteX6" fmla="*/ 0 w 4035853"/>
              <a:gd name="connsiteY6" fmla="*/ 2697096 h 2936090"/>
              <a:gd name="connsiteX7" fmla="*/ 0 w 4035853"/>
              <a:gd name="connsiteY7" fmla="*/ 0 h 2936090"/>
              <a:gd name="connsiteX0" fmla="*/ 0 w 4035853"/>
              <a:gd name="connsiteY0" fmla="*/ 0 h 2936082"/>
              <a:gd name="connsiteX1" fmla="*/ 4035853 w 4035853"/>
              <a:gd name="connsiteY1" fmla="*/ 0 h 2936082"/>
              <a:gd name="connsiteX2" fmla="*/ 4035853 w 4035853"/>
              <a:gd name="connsiteY2" fmla="*/ 2697096 h 2936082"/>
              <a:gd name="connsiteX3" fmla="*/ 431848 w 4035853"/>
              <a:gd name="connsiteY3" fmla="*/ 2696556 h 2936082"/>
              <a:gd name="connsiteX4" fmla="*/ 302420 w 4035853"/>
              <a:gd name="connsiteY4" fmla="*/ 2936082 h 2936082"/>
              <a:gd name="connsiteX5" fmla="*/ 166660 w 4035853"/>
              <a:gd name="connsiteY5" fmla="*/ 2695594 h 2936082"/>
              <a:gd name="connsiteX6" fmla="*/ 0 w 4035853"/>
              <a:gd name="connsiteY6" fmla="*/ 2697096 h 2936082"/>
              <a:gd name="connsiteX7" fmla="*/ 0 w 4035853"/>
              <a:gd name="connsiteY7" fmla="*/ 0 h 2936082"/>
              <a:gd name="connsiteX0" fmla="*/ 0 w 4035853"/>
              <a:gd name="connsiteY0" fmla="*/ 0 h 2967038"/>
              <a:gd name="connsiteX1" fmla="*/ 4035853 w 4035853"/>
              <a:gd name="connsiteY1" fmla="*/ 0 h 2967038"/>
              <a:gd name="connsiteX2" fmla="*/ 4035853 w 4035853"/>
              <a:gd name="connsiteY2" fmla="*/ 2697096 h 2967038"/>
              <a:gd name="connsiteX3" fmla="*/ 431848 w 4035853"/>
              <a:gd name="connsiteY3" fmla="*/ 2696556 h 2967038"/>
              <a:gd name="connsiteX4" fmla="*/ 300039 w 4035853"/>
              <a:gd name="connsiteY4" fmla="*/ 2967038 h 2967038"/>
              <a:gd name="connsiteX5" fmla="*/ 166660 w 4035853"/>
              <a:gd name="connsiteY5" fmla="*/ 2695594 h 2967038"/>
              <a:gd name="connsiteX6" fmla="*/ 0 w 4035853"/>
              <a:gd name="connsiteY6" fmla="*/ 2697096 h 2967038"/>
              <a:gd name="connsiteX7" fmla="*/ 0 w 4035853"/>
              <a:gd name="connsiteY7" fmla="*/ 0 h 2967038"/>
              <a:gd name="connsiteX0" fmla="*/ 0 w 4035853"/>
              <a:gd name="connsiteY0" fmla="*/ 0 h 2933700"/>
              <a:gd name="connsiteX1" fmla="*/ 4035853 w 4035853"/>
              <a:gd name="connsiteY1" fmla="*/ 0 h 2933700"/>
              <a:gd name="connsiteX2" fmla="*/ 4035853 w 4035853"/>
              <a:gd name="connsiteY2" fmla="*/ 2697096 h 2933700"/>
              <a:gd name="connsiteX3" fmla="*/ 431848 w 4035853"/>
              <a:gd name="connsiteY3" fmla="*/ 2696556 h 2933700"/>
              <a:gd name="connsiteX4" fmla="*/ 302420 w 4035853"/>
              <a:gd name="connsiteY4" fmla="*/ 2933700 h 2933700"/>
              <a:gd name="connsiteX5" fmla="*/ 166660 w 4035853"/>
              <a:gd name="connsiteY5" fmla="*/ 2695594 h 2933700"/>
              <a:gd name="connsiteX6" fmla="*/ 0 w 4035853"/>
              <a:gd name="connsiteY6" fmla="*/ 2697096 h 2933700"/>
              <a:gd name="connsiteX7" fmla="*/ 0 w 4035853"/>
              <a:gd name="connsiteY7" fmla="*/ 0 h 2933700"/>
              <a:gd name="connsiteX0" fmla="*/ 0 w 4035853"/>
              <a:gd name="connsiteY0" fmla="*/ 0 h 2933700"/>
              <a:gd name="connsiteX1" fmla="*/ 4035853 w 4035853"/>
              <a:gd name="connsiteY1" fmla="*/ 0 h 2933700"/>
              <a:gd name="connsiteX2" fmla="*/ 4035853 w 4035853"/>
              <a:gd name="connsiteY2" fmla="*/ 2697096 h 2933700"/>
              <a:gd name="connsiteX3" fmla="*/ 431848 w 4035853"/>
              <a:gd name="connsiteY3" fmla="*/ 2696556 h 2933700"/>
              <a:gd name="connsiteX4" fmla="*/ 302420 w 4035853"/>
              <a:gd name="connsiteY4" fmla="*/ 2933700 h 2933700"/>
              <a:gd name="connsiteX5" fmla="*/ 166660 w 4035853"/>
              <a:gd name="connsiteY5" fmla="*/ 2695594 h 2933700"/>
              <a:gd name="connsiteX6" fmla="*/ 0 w 4035853"/>
              <a:gd name="connsiteY6" fmla="*/ 2697096 h 2933700"/>
              <a:gd name="connsiteX7" fmla="*/ 0 w 4035853"/>
              <a:gd name="connsiteY7" fmla="*/ 0 h 2933700"/>
              <a:gd name="connsiteX0" fmla="*/ 0 w 4035853"/>
              <a:gd name="connsiteY0" fmla="*/ 0 h 2933700"/>
              <a:gd name="connsiteX1" fmla="*/ 4035853 w 4035853"/>
              <a:gd name="connsiteY1" fmla="*/ 0 h 2933700"/>
              <a:gd name="connsiteX2" fmla="*/ 4035853 w 4035853"/>
              <a:gd name="connsiteY2" fmla="*/ 2697096 h 2933700"/>
              <a:gd name="connsiteX3" fmla="*/ 431848 w 4035853"/>
              <a:gd name="connsiteY3" fmla="*/ 2696556 h 2933700"/>
              <a:gd name="connsiteX4" fmla="*/ 302420 w 4035853"/>
              <a:gd name="connsiteY4" fmla="*/ 2933700 h 2933700"/>
              <a:gd name="connsiteX5" fmla="*/ 154811 w 4035853"/>
              <a:gd name="connsiteY5" fmla="*/ 2695594 h 2933700"/>
              <a:gd name="connsiteX6" fmla="*/ 0 w 4035853"/>
              <a:gd name="connsiteY6" fmla="*/ 2697096 h 2933700"/>
              <a:gd name="connsiteX7" fmla="*/ 0 w 4035853"/>
              <a:gd name="connsiteY7" fmla="*/ 0 h 2933700"/>
              <a:gd name="connsiteX0" fmla="*/ 0 w 4035853"/>
              <a:gd name="connsiteY0" fmla="*/ 0 h 2947646"/>
              <a:gd name="connsiteX1" fmla="*/ 4035853 w 4035853"/>
              <a:gd name="connsiteY1" fmla="*/ 0 h 2947646"/>
              <a:gd name="connsiteX2" fmla="*/ 4035853 w 4035853"/>
              <a:gd name="connsiteY2" fmla="*/ 2697096 h 2947646"/>
              <a:gd name="connsiteX3" fmla="*/ 431848 w 4035853"/>
              <a:gd name="connsiteY3" fmla="*/ 2696556 h 2947646"/>
              <a:gd name="connsiteX4" fmla="*/ 341259 w 4035853"/>
              <a:gd name="connsiteY4" fmla="*/ 2895599 h 2947646"/>
              <a:gd name="connsiteX5" fmla="*/ 302420 w 4035853"/>
              <a:gd name="connsiteY5" fmla="*/ 2933700 h 2947646"/>
              <a:gd name="connsiteX6" fmla="*/ 154811 w 4035853"/>
              <a:gd name="connsiteY6" fmla="*/ 2695594 h 2947646"/>
              <a:gd name="connsiteX7" fmla="*/ 0 w 4035853"/>
              <a:gd name="connsiteY7" fmla="*/ 2697096 h 2947646"/>
              <a:gd name="connsiteX8" fmla="*/ 0 w 4035853"/>
              <a:gd name="connsiteY8" fmla="*/ 0 h 2947646"/>
              <a:gd name="connsiteX0" fmla="*/ 0 w 4035853"/>
              <a:gd name="connsiteY0" fmla="*/ 0 h 2947646"/>
              <a:gd name="connsiteX1" fmla="*/ 4035853 w 4035853"/>
              <a:gd name="connsiteY1" fmla="*/ 0 h 2947646"/>
              <a:gd name="connsiteX2" fmla="*/ 4035853 w 4035853"/>
              <a:gd name="connsiteY2" fmla="*/ 2697096 h 2947646"/>
              <a:gd name="connsiteX3" fmla="*/ 431848 w 4035853"/>
              <a:gd name="connsiteY3" fmla="*/ 2696556 h 2947646"/>
              <a:gd name="connsiteX4" fmla="*/ 341259 w 4035853"/>
              <a:gd name="connsiteY4" fmla="*/ 2895599 h 2947646"/>
              <a:gd name="connsiteX5" fmla="*/ 302420 w 4035853"/>
              <a:gd name="connsiteY5" fmla="*/ 2933700 h 2947646"/>
              <a:gd name="connsiteX6" fmla="*/ 154811 w 4035853"/>
              <a:gd name="connsiteY6" fmla="*/ 2695594 h 2947646"/>
              <a:gd name="connsiteX7" fmla="*/ 0 w 4035853"/>
              <a:gd name="connsiteY7" fmla="*/ 2697096 h 2947646"/>
              <a:gd name="connsiteX8" fmla="*/ 0 w 4035853"/>
              <a:gd name="connsiteY8" fmla="*/ 0 h 2947646"/>
              <a:gd name="connsiteX0" fmla="*/ 0 w 4035853"/>
              <a:gd name="connsiteY0" fmla="*/ 0 h 2933799"/>
              <a:gd name="connsiteX1" fmla="*/ 4035853 w 4035853"/>
              <a:gd name="connsiteY1" fmla="*/ 0 h 2933799"/>
              <a:gd name="connsiteX2" fmla="*/ 4035853 w 4035853"/>
              <a:gd name="connsiteY2" fmla="*/ 2697096 h 2933799"/>
              <a:gd name="connsiteX3" fmla="*/ 431848 w 4035853"/>
              <a:gd name="connsiteY3" fmla="*/ 2696556 h 2933799"/>
              <a:gd name="connsiteX4" fmla="*/ 341259 w 4035853"/>
              <a:gd name="connsiteY4" fmla="*/ 2895599 h 2933799"/>
              <a:gd name="connsiteX5" fmla="*/ 302420 w 4035853"/>
              <a:gd name="connsiteY5" fmla="*/ 2933700 h 2933799"/>
              <a:gd name="connsiteX6" fmla="*/ 272534 w 4035853"/>
              <a:gd name="connsiteY6" fmla="*/ 2893218 h 2933799"/>
              <a:gd name="connsiteX7" fmla="*/ 154811 w 4035853"/>
              <a:gd name="connsiteY7" fmla="*/ 2695594 h 2933799"/>
              <a:gd name="connsiteX8" fmla="*/ 0 w 4035853"/>
              <a:gd name="connsiteY8" fmla="*/ 2697096 h 2933799"/>
              <a:gd name="connsiteX9" fmla="*/ 0 w 4035853"/>
              <a:gd name="connsiteY9" fmla="*/ 0 h 2933799"/>
              <a:gd name="connsiteX0" fmla="*/ 0 w 4035853"/>
              <a:gd name="connsiteY0" fmla="*/ 0 h 2933799"/>
              <a:gd name="connsiteX1" fmla="*/ 4035853 w 4035853"/>
              <a:gd name="connsiteY1" fmla="*/ 0 h 2933799"/>
              <a:gd name="connsiteX2" fmla="*/ 4035853 w 4035853"/>
              <a:gd name="connsiteY2" fmla="*/ 2697096 h 2933799"/>
              <a:gd name="connsiteX3" fmla="*/ 431848 w 4035853"/>
              <a:gd name="connsiteY3" fmla="*/ 2696556 h 2933799"/>
              <a:gd name="connsiteX4" fmla="*/ 341259 w 4035853"/>
              <a:gd name="connsiteY4" fmla="*/ 2895599 h 2933799"/>
              <a:gd name="connsiteX5" fmla="*/ 302420 w 4035853"/>
              <a:gd name="connsiteY5" fmla="*/ 2933700 h 2933799"/>
              <a:gd name="connsiteX6" fmla="*/ 260684 w 4035853"/>
              <a:gd name="connsiteY6" fmla="*/ 2893218 h 2933799"/>
              <a:gd name="connsiteX7" fmla="*/ 154811 w 4035853"/>
              <a:gd name="connsiteY7" fmla="*/ 2695594 h 2933799"/>
              <a:gd name="connsiteX8" fmla="*/ 0 w 4035853"/>
              <a:gd name="connsiteY8" fmla="*/ 2697096 h 2933799"/>
              <a:gd name="connsiteX9" fmla="*/ 0 w 4035853"/>
              <a:gd name="connsiteY9" fmla="*/ 0 h 2933799"/>
              <a:gd name="connsiteX0" fmla="*/ 0 w 4035853"/>
              <a:gd name="connsiteY0" fmla="*/ 0 h 2933799"/>
              <a:gd name="connsiteX1" fmla="*/ 4035853 w 4035853"/>
              <a:gd name="connsiteY1" fmla="*/ 0 h 2933799"/>
              <a:gd name="connsiteX2" fmla="*/ 4035853 w 4035853"/>
              <a:gd name="connsiteY2" fmla="*/ 2697096 h 2933799"/>
              <a:gd name="connsiteX3" fmla="*/ 431848 w 4035853"/>
              <a:gd name="connsiteY3" fmla="*/ 2696556 h 2933799"/>
              <a:gd name="connsiteX4" fmla="*/ 341259 w 4035853"/>
              <a:gd name="connsiteY4" fmla="*/ 2895599 h 2933799"/>
              <a:gd name="connsiteX5" fmla="*/ 302420 w 4035853"/>
              <a:gd name="connsiteY5" fmla="*/ 2933700 h 2933799"/>
              <a:gd name="connsiteX6" fmla="*/ 260684 w 4035853"/>
              <a:gd name="connsiteY6" fmla="*/ 2893218 h 2933799"/>
              <a:gd name="connsiteX7" fmla="*/ 154811 w 4035853"/>
              <a:gd name="connsiteY7" fmla="*/ 2695594 h 2933799"/>
              <a:gd name="connsiteX8" fmla="*/ 0 w 4035853"/>
              <a:gd name="connsiteY8" fmla="*/ 2697096 h 2933799"/>
              <a:gd name="connsiteX9" fmla="*/ 0 w 4035853"/>
              <a:gd name="connsiteY9" fmla="*/ 0 h 2933799"/>
              <a:gd name="connsiteX0" fmla="*/ 0 w 4035853"/>
              <a:gd name="connsiteY0" fmla="*/ 0 h 2940861"/>
              <a:gd name="connsiteX1" fmla="*/ 4035853 w 4035853"/>
              <a:gd name="connsiteY1" fmla="*/ 0 h 2940861"/>
              <a:gd name="connsiteX2" fmla="*/ 4035853 w 4035853"/>
              <a:gd name="connsiteY2" fmla="*/ 2697096 h 2940861"/>
              <a:gd name="connsiteX3" fmla="*/ 431848 w 4035853"/>
              <a:gd name="connsiteY3" fmla="*/ 2696556 h 2940861"/>
              <a:gd name="connsiteX4" fmla="*/ 341259 w 4035853"/>
              <a:gd name="connsiteY4" fmla="*/ 2895599 h 2940861"/>
              <a:gd name="connsiteX5" fmla="*/ 295311 w 4035853"/>
              <a:gd name="connsiteY5" fmla="*/ 2940844 h 2940861"/>
              <a:gd name="connsiteX6" fmla="*/ 260684 w 4035853"/>
              <a:gd name="connsiteY6" fmla="*/ 2893218 h 2940861"/>
              <a:gd name="connsiteX7" fmla="*/ 154811 w 4035853"/>
              <a:gd name="connsiteY7" fmla="*/ 2695594 h 2940861"/>
              <a:gd name="connsiteX8" fmla="*/ 0 w 4035853"/>
              <a:gd name="connsiteY8" fmla="*/ 2697096 h 2940861"/>
              <a:gd name="connsiteX9" fmla="*/ 0 w 4035853"/>
              <a:gd name="connsiteY9" fmla="*/ 0 h 2940861"/>
              <a:gd name="connsiteX0" fmla="*/ 0 w 4035853"/>
              <a:gd name="connsiteY0" fmla="*/ 0 h 2940861"/>
              <a:gd name="connsiteX1" fmla="*/ 4035853 w 4035853"/>
              <a:gd name="connsiteY1" fmla="*/ 0 h 2940861"/>
              <a:gd name="connsiteX2" fmla="*/ 4035853 w 4035853"/>
              <a:gd name="connsiteY2" fmla="*/ 2697096 h 2940861"/>
              <a:gd name="connsiteX3" fmla="*/ 431848 w 4035853"/>
              <a:gd name="connsiteY3" fmla="*/ 2696556 h 2940861"/>
              <a:gd name="connsiteX4" fmla="*/ 334149 w 4035853"/>
              <a:gd name="connsiteY4" fmla="*/ 2895599 h 2940861"/>
              <a:gd name="connsiteX5" fmla="*/ 295311 w 4035853"/>
              <a:gd name="connsiteY5" fmla="*/ 2940844 h 2940861"/>
              <a:gd name="connsiteX6" fmla="*/ 260684 w 4035853"/>
              <a:gd name="connsiteY6" fmla="*/ 2893218 h 2940861"/>
              <a:gd name="connsiteX7" fmla="*/ 154811 w 4035853"/>
              <a:gd name="connsiteY7" fmla="*/ 2695594 h 2940861"/>
              <a:gd name="connsiteX8" fmla="*/ 0 w 4035853"/>
              <a:gd name="connsiteY8" fmla="*/ 2697096 h 2940861"/>
              <a:gd name="connsiteX9" fmla="*/ 0 w 4035853"/>
              <a:gd name="connsiteY9" fmla="*/ 0 h 2940861"/>
              <a:gd name="connsiteX0" fmla="*/ 0 w 4035853"/>
              <a:gd name="connsiteY0" fmla="*/ 0 h 2940861"/>
              <a:gd name="connsiteX1" fmla="*/ 4035853 w 4035853"/>
              <a:gd name="connsiteY1" fmla="*/ 0 h 2940861"/>
              <a:gd name="connsiteX2" fmla="*/ 4035853 w 4035853"/>
              <a:gd name="connsiteY2" fmla="*/ 2697096 h 2940861"/>
              <a:gd name="connsiteX3" fmla="*/ 431848 w 4035853"/>
              <a:gd name="connsiteY3" fmla="*/ 2696556 h 2940861"/>
              <a:gd name="connsiteX4" fmla="*/ 334149 w 4035853"/>
              <a:gd name="connsiteY4" fmla="*/ 2895599 h 2940861"/>
              <a:gd name="connsiteX5" fmla="*/ 295311 w 4035853"/>
              <a:gd name="connsiteY5" fmla="*/ 2940844 h 2940861"/>
              <a:gd name="connsiteX6" fmla="*/ 260684 w 4035853"/>
              <a:gd name="connsiteY6" fmla="*/ 2893218 h 2940861"/>
              <a:gd name="connsiteX7" fmla="*/ 154811 w 4035853"/>
              <a:gd name="connsiteY7" fmla="*/ 2695594 h 2940861"/>
              <a:gd name="connsiteX8" fmla="*/ 0 w 4035853"/>
              <a:gd name="connsiteY8" fmla="*/ 2697096 h 2940861"/>
              <a:gd name="connsiteX9" fmla="*/ 0 w 4035853"/>
              <a:gd name="connsiteY9" fmla="*/ 0 h 2940861"/>
              <a:gd name="connsiteX0" fmla="*/ 0 w 4035853"/>
              <a:gd name="connsiteY0" fmla="*/ 0 h 2941325"/>
              <a:gd name="connsiteX1" fmla="*/ 4035853 w 4035853"/>
              <a:gd name="connsiteY1" fmla="*/ 0 h 2941325"/>
              <a:gd name="connsiteX2" fmla="*/ 4035853 w 4035853"/>
              <a:gd name="connsiteY2" fmla="*/ 2697096 h 2941325"/>
              <a:gd name="connsiteX3" fmla="*/ 431848 w 4035853"/>
              <a:gd name="connsiteY3" fmla="*/ 2696556 h 2941325"/>
              <a:gd name="connsiteX4" fmla="*/ 334149 w 4035853"/>
              <a:gd name="connsiteY4" fmla="*/ 2895599 h 2941325"/>
              <a:gd name="connsiteX5" fmla="*/ 295311 w 4035853"/>
              <a:gd name="connsiteY5" fmla="*/ 2940844 h 2941325"/>
              <a:gd name="connsiteX6" fmla="*/ 260684 w 4035853"/>
              <a:gd name="connsiteY6" fmla="*/ 2893218 h 2941325"/>
              <a:gd name="connsiteX7" fmla="*/ 154811 w 4035853"/>
              <a:gd name="connsiteY7" fmla="*/ 2695594 h 2941325"/>
              <a:gd name="connsiteX8" fmla="*/ 0 w 4035853"/>
              <a:gd name="connsiteY8" fmla="*/ 2697096 h 2941325"/>
              <a:gd name="connsiteX9" fmla="*/ 0 w 4035853"/>
              <a:gd name="connsiteY9" fmla="*/ 0 h 2941325"/>
              <a:gd name="connsiteX0" fmla="*/ 0 w 4035853"/>
              <a:gd name="connsiteY0" fmla="*/ 0 h 2940861"/>
              <a:gd name="connsiteX1" fmla="*/ 4035853 w 4035853"/>
              <a:gd name="connsiteY1" fmla="*/ 0 h 2940861"/>
              <a:gd name="connsiteX2" fmla="*/ 4035853 w 4035853"/>
              <a:gd name="connsiteY2" fmla="*/ 2697096 h 2940861"/>
              <a:gd name="connsiteX3" fmla="*/ 431848 w 4035853"/>
              <a:gd name="connsiteY3" fmla="*/ 2696556 h 2940861"/>
              <a:gd name="connsiteX4" fmla="*/ 334149 w 4035853"/>
              <a:gd name="connsiteY4" fmla="*/ 2895599 h 2940861"/>
              <a:gd name="connsiteX5" fmla="*/ 295311 w 4035853"/>
              <a:gd name="connsiteY5" fmla="*/ 2940844 h 2940861"/>
              <a:gd name="connsiteX6" fmla="*/ 260684 w 4035853"/>
              <a:gd name="connsiteY6" fmla="*/ 2893218 h 2940861"/>
              <a:gd name="connsiteX7" fmla="*/ 154811 w 4035853"/>
              <a:gd name="connsiteY7" fmla="*/ 2695594 h 2940861"/>
              <a:gd name="connsiteX8" fmla="*/ 0 w 4035853"/>
              <a:gd name="connsiteY8" fmla="*/ 2697096 h 2940861"/>
              <a:gd name="connsiteX9" fmla="*/ 0 w 4035853"/>
              <a:gd name="connsiteY9" fmla="*/ 0 h 2940861"/>
              <a:gd name="connsiteX0" fmla="*/ 0 w 4035853"/>
              <a:gd name="connsiteY0" fmla="*/ 0 h 2940861"/>
              <a:gd name="connsiteX1" fmla="*/ 4035853 w 4035853"/>
              <a:gd name="connsiteY1" fmla="*/ 0 h 2940861"/>
              <a:gd name="connsiteX2" fmla="*/ 4035853 w 4035853"/>
              <a:gd name="connsiteY2" fmla="*/ 2697096 h 2940861"/>
              <a:gd name="connsiteX3" fmla="*/ 431848 w 4035853"/>
              <a:gd name="connsiteY3" fmla="*/ 2696556 h 2940861"/>
              <a:gd name="connsiteX4" fmla="*/ 334149 w 4035853"/>
              <a:gd name="connsiteY4" fmla="*/ 2895599 h 2940861"/>
              <a:gd name="connsiteX5" fmla="*/ 295311 w 4035853"/>
              <a:gd name="connsiteY5" fmla="*/ 2940844 h 2940861"/>
              <a:gd name="connsiteX6" fmla="*/ 260684 w 4035853"/>
              <a:gd name="connsiteY6" fmla="*/ 2893218 h 2940861"/>
              <a:gd name="connsiteX7" fmla="*/ 154811 w 4035853"/>
              <a:gd name="connsiteY7" fmla="*/ 2695594 h 2940861"/>
              <a:gd name="connsiteX8" fmla="*/ 0 w 4035853"/>
              <a:gd name="connsiteY8" fmla="*/ 2697096 h 2940861"/>
              <a:gd name="connsiteX9" fmla="*/ 0 w 4035853"/>
              <a:gd name="connsiteY9" fmla="*/ 0 h 2940861"/>
              <a:gd name="connsiteX0" fmla="*/ 0 w 4035853"/>
              <a:gd name="connsiteY0" fmla="*/ 0 h 2938488"/>
              <a:gd name="connsiteX1" fmla="*/ 4035853 w 4035853"/>
              <a:gd name="connsiteY1" fmla="*/ 0 h 2938488"/>
              <a:gd name="connsiteX2" fmla="*/ 4035853 w 4035853"/>
              <a:gd name="connsiteY2" fmla="*/ 2697096 h 2938488"/>
              <a:gd name="connsiteX3" fmla="*/ 431848 w 4035853"/>
              <a:gd name="connsiteY3" fmla="*/ 2696556 h 2938488"/>
              <a:gd name="connsiteX4" fmla="*/ 334149 w 4035853"/>
              <a:gd name="connsiteY4" fmla="*/ 2895599 h 2938488"/>
              <a:gd name="connsiteX5" fmla="*/ 295311 w 4035853"/>
              <a:gd name="connsiteY5" fmla="*/ 2938463 h 2938488"/>
              <a:gd name="connsiteX6" fmla="*/ 260684 w 4035853"/>
              <a:gd name="connsiteY6" fmla="*/ 2893218 h 2938488"/>
              <a:gd name="connsiteX7" fmla="*/ 154811 w 4035853"/>
              <a:gd name="connsiteY7" fmla="*/ 2695594 h 2938488"/>
              <a:gd name="connsiteX8" fmla="*/ 0 w 4035853"/>
              <a:gd name="connsiteY8" fmla="*/ 2697096 h 2938488"/>
              <a:gd name="connsiteX9" fmla="*/ 0 w 4035853"/>
              <a:gd name="connsiteY9" fmla="*/ 0 h 2938488"/>
              <a:gd name="connsiteX0" fmla="*/ 0 w 4035853"/>
              <a:gd name="connsiteY0" fmla="*/ 0 h 2938488"/>
              <a:gd name="connsiteX1" fmla="*/ 4035853 w 4035853"/>
              <a:gd name="connsiteY1" fmla="*/ 0 h 2938488"/>
              <a:gd name="connsiteX2" fmla="*/ 4035853 w 4035853"/>
              <a:gd name="connsiteY2" fmla="*/ 2697096 h 2938488"/>
              <a:gd name="connsiteX3" fmla="*/ 431848 w 4035853"/>
              <a:gd name="connsiteY3" fmla="*/ 2696556 h 2938488"/>
              <a:gd name="connsiteX4" fmla="*/ 334149 w 4035853"/>
              <a:gd name="connsiteY4" fmla="*/ 2895599 h 2938488"/>
              <a:gd name="connsiteX5" fmla="*/ 295311 w 4035853"/>
              <a:gd name="connsiteY5" fmla="*/ 2938463 h 2938488"/>
              <a:gd name="connsiteX6" fmla="*/ 260684 w 4035853"/>
              <a:gd name="connsiteY6" fmla="*/ 2893218 h 2938488"/>
              <a:gd name="connsiteX7" fmla="*/ 159550 w 4035853"/>
              <a:gd name="connsiteY7" fmla="*/ 2695594 h 2938488"/>
              <a:gd name="connsiteX8" fmla="*/ 0 w 4035853"/>
              <a:gd name="connsiteY8" fmla="*/ 2697096 h 2938488"/>
              <a:gd name="connsiteX9" fmla="*/ 0 w 4035853"/>
              <a:gd name="connsiteY9" fmla="*/ 0 h 2938488"/>
              <a:gd name="connsiteX0" fmla="*/ 0 w 4035853"/>
              <a:gd name="connsiteY0" fmla="*/ 0 h 2938488"/>
              <a:gd name="connsiteX1" fmla="*/ 4035853 w 4035853"/>
              <a:gd name="connsiteY1" fmla="*/ 0 h 2938488"/>
              <a:gd name="connsiteX2" fmla="*/ 4035853 w 4035853"/>
              <a:gd name="connsiteY2" fmla="*/ 2697096 h 2938488"/>
              <a:gd name="connsiteX3" fmla="*/ 431848 w 4035853"/>
              <a:gd name="connsiteY3" fmla="*/ 2696556 h 2938488"/>
              <a:gd name="connsiteX4" fmla="*/ 334149 w 4035853"/>
              <a:gd name="connsiteY4" fmla="*/ 2895599 h 2938488"/>
              <a:gd name="connsiteX5" fmla="*/ 295311 w 4035853"/>
              <a:gd name="connsiteY5" fmla="*/ 2938463 h 2938488"/>
              <a:gd name="connsiteX6" fmla="*/ 260684 w 4035853"/>
              <a:gd name="connsiteY6" fmla="*/ 2893218 h 2938488"/>
              <a:gd name="connsiteX7" fmla="*/ 159550 w 4035853"/>
              <a:gd name="connsiteY7" fmla="*/ 2695594 h 2938488"/>
              <a:gd name="connsiteX8" fmla="*/ 0 w 4035853"/>
              <a:gd name="connsiteY8" fmla="*/ 2697096 h 2938488"/>
              <a:gd name="connsiteX9" fmla="*/ 0 w 4035853"/>
              <a:gd name="connsiteY9" fmla="*/ 0 h 2938488"/>
              <a:gd name="connsiteX0" fmla="*/ 0 w 4035853"/>
              <a:gd name="connsiteY0" fmla="*/ 0 h 2938488"/>
              <a:gd name="connsiteX1" fmla="*/ 4035853 w 4035853"/>
              <a:gd name="connsiteY1" fmla="*/ 0 h 2938488"/>
              <a:gd name="connsiteX2" fmla="*/ 4035853 w 4035853"/>
              <a:gd name="connsiteY2" fmla="*/ 2697096 h 2938488"/>
              <a:gd name="connsiteX3" fmla="*/ 431848 w 4035853"/>
              <a:gd name="connsiteY3" fmla="*/ 2696556 h 2938488"/>
              <a:gd name="connsiteX4" fmla="*/ 334149 w 4035853"/>
              <a:gd name="connsiteY4" fmla="*/ 2895599 h 2938488"/>
              <a:gd name="connsiteX5" fmla="*/ 300051 w 4035853"/>
              <a:gd name="connsiteY5" fmla="*/ 2938463 h 2938488"/>
              <a:gd name="connsiteX6" fmla="*/ 260684 w 4035853"/>
              <a:gd name="connsiteY6" fmla="*/ 2893218 h 2938488"/>
              <a:gd name="connsiteX7" fmla="*/ 159550 w 4035853"/>
              <a:gd name="connsiteY7" fmla="*/ 2695594 h 2938488"/>
              <a:gd name="connsiteX8" fmla="*/ 0 w 4035853"/>
              <a:gd name="connsiteY8" fmla="*/ 2697096 h 2938488"/>
              <a:gd name="connsiteX9" fmla="*/ 0 w 4035853"/>
              <a:gd name="connsiteY9" fmla="*/ 0 h 2938488"/>
              <a:gd name="connsiteX0" fmla="*/ 0 w 4035853"/>
              <a:gd name="connsiteY0" fmla="*/ 0 h 2938470"/>
              <a:gd name="connsiteX1" fmla="*/ 4035853 w 4035853"/>
              <a:gd name="connsiteY1" fmla="*/ 0 h 2938470"/>
              <a:gd name="connsiteX2" fmla="*/ 4035853 w 4035853"/>
              <a:gd name="connsiteY2" fmla="*/ 2697096 h 2938470"/>
              <a:gd name="connsiteX3" fmla="*/ 431848 w 4035853"/>
              <a:gd name="connsiteY3" fmla="*/ 2696556 h 2938470"/>
              <a:gd name="connsiteX4" fmla="*/ 334149 w 4035853"/>
              <a:gd name="connsiteY4" fmla="*/ 2895599 h 2938470"/>
              <a:gd name="connsiteX5" fmla="*/ 300051 w 4035853"/>
              <a:gd name="connsiteY5" fmla="*/ 2938463 h 2938470"/>
              <a:gd name="connsiteX6" fmla="*/ 260684 w 4035853"/>
              <a:gd name="connsiteY6" fmla="*/ 2893218 h 2938470"/>
              <a:gd name="connsiteX7" fmla="*/ 159550 w 4035853"/>
              <a:gd name="connsiteY7" fmla="*/ 2695594 h 2938470"/>
              <a:gd name="connsiteX8" fmla="*/ 0 w 4035853"/>
              <a:gd name="connsiteY8" fmla="*/ 2697096 h 2938470"/>
              <a:gd name="connsiteX9" fmla="*/ 0 w 4035853"/>
              <a:gd name="connsiteY9" fmla="*/ 0 h 2938470"/>
              <a:gd name="connsiteX0" fmla="*/ 0 w 4035853"/>
              <a:gd name="connsiteY0" fmla="*/ 0 h 2938470"/>
              <a:gd name="connsiteX1" fmla="*/ 4035853 w 4035853"/>
              <a:gd name="connsiteY1" fmla="*/ 0 h 2938470"/>
              <a:gd name="connsiteX2" fmla="*/ 4035853 w 4035853"/>
              <a:gd name="connsiteY2" fmla="*/ 2697096 h 2938470"/>
              <a:gd name="connsiteX3" fmla="*/ 431848 w 4035853"/>
              <a:gd name="connsiteY3" fmla="*/ 2696556 h 2938470"/>
              <a:gd name="connsiteX4" fmla="*/ 334149 w 4035853"/>
              <a:gd name="connsiteY4" fmla="*/ 2895599 h 2938470"/>
              <a:gd name="connsiteX5" fmla="*/ 300051 w 4035853"/>
              <a:gd name="connsiteY5" fmla="*/ 2938463 h 2938470"/>
              <a:gd name="connsiteX6" fmla="*/ 260684 w 4035853"/>
              <a:gd name="connsiteY6" fmla="*/ 2893218 h 2938470"/>
              <a:gd name="connsiteX7" fmla="*/ 159550 w 4035853"/>
              <a:gd name="connsiteY7" fmla="*/ 2695594 h 2938470"/>
              <a:gd name="connsiteX8" fmla="*/ 0 w 4035853"/>
              <a:gd name="connsiteY8" fmla="*/ 2697096 h 2938470"/>
              <a:gd name="connsiteX9" fmla="*/ 0 w 4035853"/>
              <a:gd name="connsiteY9" fmla="*/ 0 h 2938470"/>
              <a:gd name="connsiteX0" fmla="*/ 0 w 4035853"/>
              <a:gd name="connsiteY0" fmla="*/ 0 h 2938470"/>
              <a:gd name="connsiteX1" fmla="*/ 4035853 w 4035853"/>
              <a:gd name="connsiteY1" fmla="*/ 0 h 2938470"/>
              <a:gd name="connsiteX2" fmla="*/ 4035853 w 4035853"/>
              <a:gd name="connsiteY2" fmla="*/ 2697096 h 2938470"/>
              <a:gd name="connsiteX3" fmla="*/ 431848 w 4035853"/>
              <a:gd name="connsiteY3" fmla="*/ 2696556 h 2938470"/>
              <a:gd name="connsiteX4" fmla="*/ 334149 w 4035853"/>
              <a:gd name="connsiteY4" fmla="*/ 2895599 h 2938470"/>
              <a:gd name="connsiteX5" fmla="*/ 300051 w 4035853"/>
              <a:gd name="connsiteY5" fmla="*/ 2938463 h 2938470"/>
              <a:gd name="connsiteX6" fmla="*/ 260684 w 4035853"/>
              <a:gd name="connsiteY6" fmla="*/ 2893218 h 2938470"/>
              <a:gd name="connsiteX7" fmla="*/ 159550 w 4035853"/>
              <a:gd name="connsiteY7" fmla="*/ 2695594 h 2938470"/>
              <a:gd name="connsiteX8" fmla="*/ 0 w 4035853"/>
              <a:gd name="connsiteY8" fmla="*/ 2697096 h 2938470"/>
              <a:gd name="connsiteX9" fmla="*/ 0 w 4035853"/>
              <a:gd name="connsiteY9" fmla="*/ 0 h 2938470"/>
              <a:gd name="connsiteX0" fmla="*/ 0 w 4035853"/>
              <a:gd name="connsiteY0" fmla="*/ 0 h 2938470"/>
              <a:gd name="connsiteX1" fmla="*/ 4035853 w 4035853"/>
              <a:gd name="connsiteY1" fmla="*/ 0 h 2938470"/>
              <a:gd name="connsiteX2" fmla="*/ 4035853 w 4035853"/>
              <a:gd name="connsiteY2" fmla="*/ 2697096 h 2938470"/>
              <a:gd name="connsiteX3" fmla="*/ 431848 w 4035853"/>
              <a:gd name="connsiteY3" fmla="*/ 2696556 h 2938470"/>
              <a:gd name="connsiteX4" fmla="*/ 334149 w 4035853"/>
              <a:gd name="connsiteY4" fmla="*/ 2895599 h 2938470"/>
              <a:gd name="connsiteX5" fmla="*/ 300051 w 4035853"/>
              <a:gd name="connsiteY5" fmla="*/ 2938463 h 2938470"/>
              <a:gd name="connsiteX6" fmla="*/ 260684 w 4035853"/>
              <a:gd name="connsiteY6" fmla="*/ 2893218 h 2938470"/>
              <a:gd name="connsiteX7" fmla="*/ 159550 w 4035853"/>
              <a:gd name="connsiteY7" fmla="*/ 2695594 h 2938470"/>
              <a:gd name="connsiteX8" fmla="*/ 0 w 4035853"/>
              <a:gd name="connsiteY8" fmla="*/ 2697096 h 2938470"/>
              <a:gd name="connsiteX9" fmla="*/ 0 w 4035853"/>
              <a:gd name="connsiteY9" fmla="*/ 0 h 2938470"/>
              <a:gd name="connsiteX0" fmla="*/ 0 w 4035853"/>
              <a:gd name="connsiteY0" fmla="*/ 0 h 2948969"/>
              <a:gd name="connsiteX1" fmla="*/ 4035853 w 4035853"/>
              <a:gd name="connsiteY1" fmla="*/ 0 h 2948969"/>
              <a:gd name="connsiteX2" fmla="*/ 4035853 w 4035853"/>
              <a:gd name="connsiteY2" fmla="*/ 2697096 h 2948969"/>
              <a:gd name="connsiteX3" fmla="*/ 431848 w 4035853"/>
              <a:gd name="connsiteY3" fmla="*/ 2696556 h 2948969"/>
              <a:gd name="connsiteX4" fmla="*/ 334149 w 4035853"/>
              <a:gd name="connsiteY4" fmla="*/ 2895599 h 2948969"/>
              <a:gd name="connsiteX5" fmla="*/ 300051 w 4035853"/>
              <a:gd name="connsiteY5" fmla="*/ 2938463 h 2948969"/>
              <a:gd name="connsiteX6" fmla="*/ 260684 w 4035853"/>
              <a:gd name="connsiteY6" fmla="*/ 2893218 h 2948969"/>
              <a:gd name="connsiteX7" fmla="*/ 159550 w 4035853"/>
              <a:gd name="connsiteY7" fmla="*/ 2695594 h 2948969"/>
              <a:gd name="connsiteX8" fmla="*/ 0 w 4035853"/>
              <a:gd name="connsiteY8" fmla="*/ 2697096 h 2948969"/>
              <a:gd name="connsiteX9" fmla="*/ 0 w 4035853"/>
              <a:gd name="connsiteY9" fmla="*/ 0 h 2948969"/>
              <a:gd name="connsiteX0" fmla="*/ 0 w 4035853"/>
              <a:gd name="connsiteY0" fmla="*/ 0 h 2938468"/>
              <a:gd name="connsiteX1" fmla="*/ 4035853 w 4035853"/>
              <a:gd name="connsiteY1" fmla="*/ 0 h 2938468"/>
              <a:gd name="connsiteX2" fmla="*/ 4035853 w 4035853"/>
              <a:gd name="connsiteY2" fmla="*/ 2697096 h 2938468"/>
              <a:gd name="connsiteX3" fmla="*/ 431848 w 4035853"/>
              <a:gd name="connsiteY3" fmla="*/ 2696556 h 2938468"/>
              <a:gd name="connsiteX4" fmla="*/ 334149 w 4035853"/>
              <a:gd name="connsiteY4" fmla="*/ 2895599 h 2938468"/>
              <a:gd name="connsiteX5" fmla="*/ 300051 w 4035853"/>
              <a:gd name="connsiteY5" fmla="*/ 2938463 h 2938468"/>
              <a:gd name="connsiteX6" fmla="*/ 260684 w 4035853"/>
              <a:gd name="connsiteY6" fmla="*/ 2893218 h 2938468"/>
              <a:gd name="connsiteX7" fmla="*/ 159550 w 4035853"/>
              <a:gd name="connsiteY7" fmla="*/ 2695594 h 2938468"/>
              <a:gd name="connsiteX8" fmla="*/ 0 w 4035853"/>
              <a:gd name="connsiteY8" fmla="*/ 2697096 h 2938468"/>
              <a:gd name="connsiteX9" fmla="*/ 0 w 4035853"/>
              <a:gd name="connsiteY9" fmla="*/ 0 h 2938468"/>
              <a:gd name="connsiteX0" fmla="*/ 0 w 4035853"/>
              <a:gd name="connsiteY0" fmla="*/ 0 h 2938468"/>
              <a:gd name="connsiteX1" fmla="*/ 4035853 w 4035853"/>
              <a:gd name="connsiteY1" fmla="*/ 0 h 2938468"/>
              <a:gd name="connsiteX2" fmla="*/ 4035853 w 4035853"/>
              <a:gd name="connsiteY2" fmla="*/ 2697096 h 2938468"/>
              <a:gd name="connsiteX3" fmla="*/ 431848 w 4035853"/>
              <a:gd name="connsiteY3" fmla="*/ 2696556 h 2938468"/>
              <a:gd name="connsiteX4" fmla="*/ 334149 w 4035853"/>
              <a:gd name="connsiteY4" fmla="*/ 2895599 h 2938468"/>
              <a:gd name="connsiteX5" fmla="*/ 300051 w 4035853"/>
              <a:gd name="connsiteY5" fmla="*/ 2938463 h 2938468"/>
              <a:gd name="connsiteX6" fmla="*/ 260684 w 4035853"/>
              <a:gd name="connsiteY6" fmla="*/ 2893218 h 2938468"/>
              <a:gd name="connsiteX7" fmla="*/ 159550 w 4035853"/>
              <a:gd name="connsiteY7" fmla="*/ 2695594 h 2938468"/>
              <a:gd name="connsiteX8" fmla="*/ 0 w 4035853"/>
              <a:gd name="connsiteY8" fmla="*/ 2697096 h 2938468"/>
              <a:gd name="connsiteX9" fmla="*/ 0 w 4035853"/>
              <a:gd name="connsiteY9" fmla="*/ 0 h 2938468"/>
              <a:gd name="connsiteX0" fmla="*/ 0 w 4035853"/>
              <a:gd name="connsiteY0" fmla="*/ 0 h 2938468"/>
              <a:gd name="connsiteX1" fmla="*/ 4035853 w 4035853"/>
              <a:gd name="connsiteY1" fmla="*/ 0 h 2938468"/>
              <a:gd name="connsiteX2" fmla="*/ 4035853 w 4035853"/>
              <a:gd name="connsiteY2" fmla="*/ 2697096 h 2938468"/>
              <a:gd name="connsiteX3" fmla="*/ 431848 w 4035853"/>
              <a:gd name="connsiteY3" fmla="*/ 2696556 h 2938468"/>
              <a:gd name="connsiteX4" fmla="*/ 334149 w 4035853"/>
              <a:gd name="connsiteY4" fmla="*/ 2895599 h 2938468"/>
              <a:gd name="connsiteX5" fmla="*/ 300051 w 4035853"/>
              <a:gd name="connsiteY5" fmla="*/ 2938463 h 2938468"/>
              <a:gd name="connsiteX6" fmla="*/ 260684 w 4035853"/>
              <a:gd name="connsiteY6" fmla="*/ 2893218 h 2938468"/>
              <a:gd name="connsiteX7" fmla="*/ 159550 w 4035853"/>
              <a:gd name="connsiteY7" fmla="*/ 2695594 h 2938468"/>
              <a:gd name="connsiteX8" fmla="*/ 0 w 4035853"/>
              <a:gd name="connsiteY8" fmla="*/ 2697096 h 2938468"/>
              <a:gd name="connsiteX9" fmla="*/ 0 w 4035853"/>
              <a:gd name="connsiteY9" fmla="*/ 0 h 2938468"/>
              <a:gd name="connsiteX0" fmla="*/ 0 w 4035853"/>
              <a:gd name="connsiteY0" fmla="*/ 0 h 2938602"/>
              <a:gd name="connsiteX1" fmla="*/ 4035853 w 4035853"/>
              <a:gd name="connsiteY1" fmla="*/ 0 h 2938602"/>
              <a:gd name="connsiteX2" fmla="*/ 4035853 w 4035853"/>
              <a:gd name="connsiteY2" fmla="*/ 2697096 h 2938602"/>
              <a:gd name="connsiteX3" fmla="*/ 431848 w 4035853"/>
              <a:gd name="connsiteY3" fmla="*/ 2696556 h 2938602"/>
              <a:gd name="connsiteX4" fmla="*/ 334149 w 4035853"/>
              <a:gd name="connsiteY4" fmla="*/ 2895599 h 2938602"/>
              <a:gd name="connsiteX5" fmla="*/ 300051 w 4035853"/>
              <a:gd name="connsiteY5" fmla="*/ 2938463 h 2938602"/>
              <a:gd name="connsiteX6" fmla="*/ 260684 w 4035853"/>
              <a:gd name="connsiteY6" fmla="*/ 2893218 h 2938602"/>
              <a:gd name="connsiteX7" fmla="*/ 159550 w 4035853"/>
              <a:gd name="connsiteY7" fmla="*/ 2695594 h 2938602"/>
              <a:gd name="connsiteX8" fmla="*/ 0 w 4035853"/>
              <a:gd name="connsiteY8" fmla="*/ 2697096 h 2938602"/>
              <a:gd name="connsiteX9" fmla="*/ 0 w 4035853"/>
              <a:gd name="connsiteY9" fmla="*/ 0 h 293860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4035853" h="2938602">
                <a:moveTo>
                  <a:pt x="0" y="0"/>
                </a:moveTo>
                <a:lnTo>
                  <a:pt x="4035853" y="0"/>
                </a:lnTo>
                <a:lnTo>
                  <a:pt x="4035853" y="2697096"/>
                </a:lnTo>
                <a:lnTo>
                  <a:pt x="431848" y="2696556"/>
                </a:lnTo>
                <a:cubicBezTo>
                  <a:pt x="397879" y="2770121"/>
                  <a:pt x="343870" y="2875126"/>
                  <a:pt x="334149" y="2895599"/>
                </a:cubicBezTo>
                <a:cubicBezTo>
                  <a:pt x="324428" y="2916072"/>
                  <a:pt x="321774" y="2936479"/>
                  <a:pt x="300051" y="2938463"/>
                </a:cubicBezTo>
                <a:cubicBezTo>
                  <a:pt x="278328" y="2940447"/>
                  <a:pt x="275806" y="2920996"/>
                  <a:pt x="260684" y="2893218"/>
                </a:cubicBezTo>
                <a:cubicBezTo>
                  <a:pt x="245562" y="2865440"/>
                  <a:pt x="186012" y="2752094"/>
                  <a:pt x="159550" y="2695594"/>
                </a:cubicBezTo>
                <a:lnTo>
                  <a:pt x="0" y="2697096"/>
                </a:lnTo>
                <a:lnTo>
                  <a:pt x="0" y="0"/>
                </a:lnTo>
                <a:close/>
              </a:path>
            </a:pathLst>
          </a:custGeom>
        </p:spPr>
        <p:txBody>
          <a:bodyPr anchor="ctr" anchorCtr="1"/>
          <a:lstStyle>
            <a:lvl1pPr marL="0" indent="0">
              <a:buNone/>
              <a:defRPr>
                <a:solidFill>
                  <a:schemeClr val="tx1"/>
                </a:solidFill>
              </a:defRPr>
            </a:lvl1pPr>
          </a:lstStyle>
          <a:p>
            <a:r>
              <a:rPr lang="en-US"/>
              <a:t>Click icon to add picture</a:t>
            </a:r>
          </a:p>
        </p:txBody>
      </p:sp>
      <p:sp>
        <p:nvSpPr>
          <p:cNvPr id="14" name="Content Placeholder 12"/>
          <p:cNvSpPr>
            <a:spLocks noGrp="1"/>
          </p:cNvSpPr>
          <p:nvPr>
            <p:ph sz="quarter" idx="12" hasCustomPrompt="1"/>
          </p:nvPr>
        </p:nvSpPr>
        <p:spPr>
          <a:xfrm>
            <a:off x="6976108" y="4076701"/>
            <a:ext cx="4606291" cy="1955800"/>
          </a:xfrm>
        </p:spPr>
        <p:txBody>
          <a:bodyPr/>
          <a:lstStyle>
            <a:lvl1pPr marL="0" indent="0">
              <a:buNone/>
              <a:defRPr sz="1600" b="1">
                <a:solidFill>
                  <a:schemeClr val="tx1"/>
                </a:solidFill>
              </a:defRPr>
            </a:lvl1pPr>
            <a:lvl2pPr marL="0" indent="0">
              <a:buNone/>
              <a:defRPr sz="1600">
                <a:solidFill>
                  <a:schemeClr val="tx1"/>
                </a:solidFill>
              </a:defRPr>
            </a:lvl2pPr>
            <a:lvl3pPr marL="304792" indent="-304792">
              <a:buFont typeface="Arial" panose="020B0604020202020204" pitchFamily="34" charset="0"/>
              <a:buChar char="•"/>
              <a:defRPr sz="1600">
                <a:solidFill>
                  <a:schemeClr val="tx1"/>
                </a:solidFill>
              </a:defRPr>
            </a:lvl3pPr>
            <a:lvl4pPr marL="621776" indent="-298443">
              <a:buFont typeface="Arial" panose="020B0604020202020204" pitchFamily="34" charset="0"/>
              <a:buChar char="–"/>
              <a:defRPr sz="1600">
                <a:solidFill>
                  <a:schemeClr val="tx1"/>
                </a:solidFill>
              </a:defRPr>
            </a:lvl4pPr>
            <a:lvl5pPr marL="914377">
              <a:defRPr sz="1600">
                <a:solidFill>
                  <a:schemeClr val="tx1"/>
                </a:solidFill>
              </a:defRPr>
            </a:lvl5pPr>
          </a:lstStyle>
          <a:p>
            <a:pPr lvl="0"/>
            <a:r>
              <a:rPr lang="en-US"/>
              <a:t>Caption for content above</a:t>
            </a:r>
          </a:p>
          <a:p>
            <a:pPr lvl="1"/>
            <a:r>
              <a:rPr lang="en-US"/>
              <a:t>Second level</a:t>
            </a:r>
          </a:p>
          <a:p>
            <a:pPr lvl="2"/>
            <a:r>
              <a:rPr lang="en-US"/>
              <a:t>Third level</a:t>
            </a:r>
          </a:p>
          <a:p>
            <a:pPr lvl="3"/>
            <a:r>
              <a:rPr lang="en-US"/>
              <a:t>Fourth level</a:t>
            </a:r>
          </a:p>
          <a:p>
            <a:pPr lvl="4"/>
            <a:r>
              <a:rPr lang="en-US"/>
              <a:t>Fifth level</a:t>
            </a:r>
          </a:p>
        </p:txBody>
      </p:sp>
      <p:sp>
        <p:nvSpPr>
          <p:cNvPr id="19" name="Footer Placeholder 4"/>
          <p:cNvSpPr>
            <a:spLocks noGrp="1"/>
          </p:cNvSpPr>
          <p:nvPr>
            <p:ph type="ftr" sz="quarter" idx="3"/>
          </p:nvPr>
        </p:nvSpPr>
        <p:spPr>
          <a:xfrm>
            <a:off x="1026597" y="6465181"/>
            <a:ext cx="4517089" cy="169277"/>
          </a:xfrm>
          <a:prstGeom prst="rect">
            <a:avLst/>
          </a:prstGeom>
        </p:spPr>
        <p:txBody>
          <a:bodyPr vert="horz" wrap="square" lIns="0" tIns="0" rIns="0" bIns="0" rtlCol="0" anchor="ctr">
            <a:spAutoFit/>
          </a:bodyPr>
          <a:lstStyle>
            <a:lvl1pPr algn="l">
              <a:defRPr sz="1100">
                <a:solidFill>
                  <a:schemeClr val="bg1"/>
                </a:solidFill>
              </a:defRPr>
            </a:lvl1pPr>
          </a:lstStyle>
          <a:p>
            <a:r>
              <a:rPr lang="en-US"/>
              <a:t>Division Name or Footer</a:t>
            </a:r>
          </a:p>
        </p:txBody>
      </p:sp>
      <p:sp>
        <p:nvSpPr>
          <p:cNvPr id="20" name="Slide Number Placeholder 5"/>
          <p:cNvSpPr>
            <a:spLocks noGrp="1"/>
          </p:cNvSpPr>
          <p:nvPr>
            <p:ph type="sldNum" sz="quarter" idx="4"/>
          </p:nvPr>
        </p:nvSpPr>
        <p:spPr>
          <a:xfrm>
            <a:off x="609601" y="6455138"/>
            <a:ext cx="339625" cy="169277"/>
          </a:xfrm>
          <a:prstGeom prst="rect">
            <a:avLst/>
          </a:prstGeom>
        </p:spPr>
        <p:txBody>
          <a:bodyPr vert="horz" wrap="square" lIns="0" tIns="0" rIns="0" bIns="0" rtlCol="0" anchor="ctr">
            <a:spAutoFit/>
          </a:bodyPr>
          <a:lstStyle>
            <a:lvl1pPr algn="l">
              <a:defRPr sz="1100">
                <a:solidFill>
                  <a:schemeClr val="bg1"/>
                </a:solidFill>
              </a:defRPr>
            </a:lvl1pPr>
          </a:lstStyle>
          <a:p>
            <a:fld id="{7FEEEA1A-CB49-3744-AA40-B896987410F9}" type="slidenum">
              <a:rPr lang="en-US" smtClean="0"/>
              <a:pPr/>
              <a:t>‹#›</a:t>
            </a:fld>
            <a:endParaRPr lang="en-US"/>
          </a:p>
        </p:txBody>
      </p:sp>
      <p:sp>
        <p:nvSpPr>
          <p:cNvPr id="11" name="Freeform 5"/>
          <p:cNvSpPr>
            <a:spLocks noEditPoints="1"/>
          </p:cNvSpPr>
          <p:nvPr userDrawn="1"/>
        </p:nvSpPr>
        <p:spPr bwMode="auto">
          <a:xfrm>
            <a:off x="10559823" y="6163226"/>
            <a:ext cx="1022352" cy="446447"/>
          </a:xfrm>
          <a:custGeom>
            <a:avLst/>
            <a:gdLst>
              <a:gd name="T0" fmla="*/ 32 w 511"/>
              <a:gd name="T1" fmla="*/ 39 h 221"/>
              <a:gd name="T2" fmla="*/ 106 w 511"/>
              <a:gd name="T3" fmla="*/ 0 h 221"/>
              <a:gd name="T4" fmla="*/ 188 w 511"/>
              <a:gd name="T5" fmla="*/ 44 h 221"/>
              <a:gd name="T6" fmla="*/ 139 w 511"/>
              <a:gd name="T7" fmla="*/ 208 h 221"/>
              <a:gd name="T8" fmla="*/ 161 w 511"/>
              <a:gd name="T9" fmla="*/ 194 h 221"/>
              <a:gd name="T10" fmla="*/ 2 w 511"/>
              <a:gd name="T11" fmla="*/ 101 h 221"/>
              <a:gd name="T12" fmla="*/ 91 w 511"/>
              <a:gd name="T13" fmla="*/ 70 h 221"/>
              <a:gd name="T14" fmla="*/ 123 w 511"/>
              <a:gd name="T15" fmla="*/ 108 h 221"/>
              <a:gd name="T16" fmla="*/ 208 w 511"/>
              <a:gd name="T17" fmla="*/ 70 h 221"/>
              <a:gd name="T18" fmla="*/ 73 w 511"/>
              <a:gd name="T19" fmla="*/ 70 h 221"/>
              <a:gd name="T20" fmla="*/ 53 w 511"/>
              <a:gd name="T21" fmla="*/ 96 h 221"/>
              <a:gd name="T22" fmla="*/ 54 w 511"/>
              <a:gd name="T23" fmla="*/ 70 h 221"/>
              <a:gd name="T24" fmla="*/ 144 w 511"/>
              <a:gd name="T25" fmla="*/ 70 h 221"/>
              <a:gd name="T26" fmla="*/ 175 w 511"/>
              <a:gd name="T27" fmla="*/ 70 h 221"/>
              <a:gd name="T28" fmla="*/ 267 w 511"/>
              <a:gd name="T29" fmla="*/ 206 h 221"/>
              <a:gd name="T30" fmla="*/ 267 w 511"/>
              <a:gd name="T31" fmla="*/ 193 h 221"/>
              <a:gd name="T32" fmla="*/ 259 w 511"/>
              <a:gd name="T33" fmla="*/ 199 h 221"/>
              <a:gd name="T34" fmla="*/ 416 w 511"/>
              <a:gd name="T35" fmla="*/ 92 h 221"/>
              <a:gd name="T36" fmla="*/ 402 w 511"/>
              <a:gd name="T37" fmla="*/ 86 h 221"/>
              <a:gd name="T38" fmla="*/ 402 w 511"/>
              <a:gd name="T39" fmla="*/ 123 h 221"/>
              <a:gd name="T40" fmla="*/ 397 w 511"/>
              <a:gd name="T41" fmla="*/ 184 h 221"/>
              <a:gd name="T42" fmla="*/ 373 w 511"/>
              <a:gd name="T43" fmla="*/ 152 h 221"/>
              <a:gd name="T44" fmla="*/ 511 w 511"/>
              <a:gd name="T45" fmla="*/ 124 h 221"/>
              <a:gd name="T46" fmla="*/ 511 w 511"/>
              <a:gd name="T47" fmla="*/ 111 h 221"/>
              <a:gd name="T48" fmla="*/ 503 w 511"/>
              <a:gd name="T49" fmla="*/ 117 h 221"/>
              <a:gd name="T50" fmla="*/ 487 w 511"/>
              <a:gd name="T51" fmla="*/ 105 h 221"/>
              <a:gd name="T52" fmla="*/ 450 w 511"/>
              <a:gd name="T53" fmla="*/ 98 h 221"/>
              <a:gd name="T54" fmla="*/ 443 w 511"/>
              <a:gd name="T55" fmla="*/ 87 h 221"/>
              <a:gd name="T56" fmla="*/ 366 w 511"/>
              <a:gd name="T57" fmla="*/ 169 h 221"/>
              <a:gd name="T58" fmla="*/ 365 w 511"/>
              <a:gd name="T59" fmla="*/ 205 h 221"/>
              <a:gd name="T60" fmla="*/ 343 w 511"/>
              <a:gd name="T61" fmla="*/ 203 h 221"/>
              <a:gd name="T62" fmla="*/ 343 w 511"/>
              <a:gd name="T63" fmla="*/ 156 h 221"/>
              <a:gd name="T64" fmla="*/ 318 w 511"/>
              <a:gd name="T65" fmla="*/ 133 h 221"/>
              <a:gd name="T66" fmla="*/ 294 w 511"/>
              <a:gd name="T67" fmla="*/ 133 h 221"/>
              <a:gd name="T68" fmla="*/ 332 w 511"/>
              <a:gd name="T69" fmla="*/ 98 h 221"/>
              <a:gd name="T70" fmla="*/ 271 w 511"/>
              <a:gd name="T71" fmla="*/ 103 h 221"/>
              <a:gd name="T72" fmla="*/ 249 w 511"/>
              <a:gd name="T73" fmla="*/ 94 h 221"/>
              <a:gd name="T74" fmla="*/ 286 w 511"/>
              <a:gd name="T75" fmla="*/ 132 h 221"/>
              <a:gd name="T76" fmla="*/ 261 w 511"/>
              <a:gd name="T77" fmla="*/ 119 h 221"/>
              <a:gd name="T78" fmla="*/ 311 w 511"/>
              <a:gd name="T79" fmla="*/ 215 h 221"/>
              <a:gd name="T80" fmla="*/ 272 w 511"/>
              <a:gd name="T81" fmla="*/ 203 h 221"/>
              <a:gd name="T82" fmla="*/ 280 w 511"/>
              <a:gd name="T83" fmla="*/ 184 h 221"/>
              <a:gd name="T84" fmla="*/ 309 w 511"/>
              <a:gd name="T85" fmla="*/ 203 h 221"/>
              <a:gd name="T86" fmla="*/ 296 w 511"/>
              <a:gd name="T87" fmla="*/ 201 h 221"/>
              <a:gd name="T88" fmla="*/ 318 w 511"/>
              <a:gd name="T89" fmla="*/ 215 h 221"/>
              <a:gd name="T90" fmla="*/ 208 w 511"/>
              <a:gd name="T91" fmla="*/ 215 h 221"/>
              <a:gd name="T92" fmla="*/ 174 w 511"/>
              <a:gd name="T93" fmla="*/ 153 h 221"/>
              <a:gd name="T94" fmla="*/ 342 w 511"/>
              <a:gd name="T95" fmla="*/ 130 h 221"/>
              <a:gd name="T96" fmla="*/ 370 w 511"/>
              <a:gd name="T97" fmla="*/ 90 h 221"/>
              <a:gd name="T98" fmla="*/ 374 w 511"/>
              <a:gd name="T99" fmla="*/ 98 h 221"/>
              <a:gd name="T100" fmla="*/ 354 w 511"/>
              <a:gd name="T101" fmla="*/ 122 h 221"/>
              <a:gd name="T102" fmla="*/ 342 w 511"/>
              <a:gd name="T103" fmla="*/ 130 h 221"/>
              <a:gd name="T104" fmla="*/ 352 w 511"/>
              <a:gd name="T105" fmla="*/ 103 h 221"/>
              <a:gd name="T106" fmla="*/ 351 w 511"/>
              <a:gd name="T107" fmla="*/ 133 h 221"/>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Lst>
            <a:rect l="0" t="0" r="r" b="b"/>
            <a:pathLst>
              <a:path w="511" h="221">
                <a:moveTo>
                  <a:pt x="188" y="44"/>
                </a:moveTo>
                <a:cubicBezTo>
                  <a:pt x="188" y="44"/>
                  <a:pt x="187" y="44"/>
                  <a:pt x="186" y="43"/>
                </a:cubicBezTo>
                <a:cubicBezTo>
                  <a:pt x="185" y="42"/>
                  <a:pt x="179" y="36"/>
                  <a:pt x="169" y="30"/>
                </a:cubicBezTo>
                <a:cubicBezTo>
                  <a:pt x="159" y="24"/>
                  <a:pt x="137" y="13"/>
                  <a:pt x="107" y="13"/>
                </a:cubicBezTo>
                <a:cubicBezTo>
                  <a:pt x="71" y="13"/>
                  <a:pt x="47" y="27"/>
                  <a:pt x="32" y="39"/>
                </a:cubicBezTo>
                <a:cubicBezTo>
                  <a:pt x="18" y="51"/>
                  <a:pt x="11" y="65"/>
                  <a:pt x="11" y="66"/>
                </a:cubicBezTo>
                <a:cubicBezTo>
                  <a:pt x="11" y="66"/>
                  <a:pt x="11" y="66"/>
                  <a:pt x="10" y="66"/>
                </a:cubicBezTo>
                <a:cubicBezTo>
                  <a:pt x="10" y="66"/>
                  <a:pt x="10" y="66"/>
                  <a:pt x="10" y="66"/>
                </a:cubicBezTo>
                <a:cubicBezTo>
                  <a:pt x="11" y="65"/>
                  <a:pt x="17" y="49"/>
                  <a:pt x="30" y="35"/>
                </a:cubicBezTo>
                <a:cubicBezTo>
                  <a:pt x="43" y="20"/>
                  <a:pt x="69" y="0"/>
                  <a:pt x="106" y="0"/>
                </a:cubicBezTo>
                <a:cubicBezTo>
                  <a:pt x="142" y="0"/>
                  <a:pt x="165" y="19"/>
                  <a:pt x="173" y="26"/>
                </a:cubicBezTo>
                <a:cubicBezTo>
                  <a:pt x="180" y="33"/>
                  <a:pt x="186" y="41"/>
                  <a:pt x="187" y="42"/>
                </a:cubicBezTo>
                <a:cubicBezTo>
                  <a:pt x="188" y="43"/>
                  <a:pt x="188" y="44"/>
                  <a:pt x="188" y="44"/>
                </a:cubicBezTo>
                <a:cubicBezTo>
                  <a:pt x="188" y="44"/>
                  <a:pt x="188" y="44"/>
                  <a:pt x="188" y="44"/>
                </a:cubicBezTo>
                <a:cubicBezTo>
                  <a:pt x="188" y="44"/>
                  <a:pt x="188" y="44"/>
                  <a:pt x="188" y="44"/>
                </a:cubicBezTo>
                <a:close/>
                <a:moveTo>
                  <a:pt x="1" y="101"/>
                </a:moveTo>
                <a:cubicBezTo>
                  <a:pt x="1" y="101"/>
                  <a:pt x="1" y="101"/>
                  <a:pt x="1" y="102"/>
                </a:cubicBezTo>
                <a:cubicBezTo>
                  <a:pt x="1" y="103"/>
                  <a:pt x="0" y="117"/>
                  <a:pt x="3" y="134"/>
                </a:cubicBezTo>
                <a:cubicBezTo>
                  <a:pt x="8" y="157"/>
                  <a:pt x="22" y="186"/>
                  <a:pt x="54" y="203"/>
                </a:cubicBezTo>
                <a:cubicBezTo>
                  <a:pt x="87" y="221"/>
                  <a:pt x="120" y="216"/>
                  <a:pt x="139" y="208"/>
                </a:cubicBezTo>
                <a:cubicBezTo>
                  <a:pt x="153" y="202"/>
                  <a:pt x="157" y="198"/>
                  <a:pt x="159" y="196"/>
                </a:cubicBezTo>
                <a:cubicBezTo>
                  <a:pt x="160" y="196"/>
                  <a:pt x="161" y="195"/>
                  <a:pt x="161" y="195"/>
                </a:cubicBezTo>
                <a:cubicBezTo>
                  <a:pt x="162" y="194"/>
                  <a:pt x="162" y="194"/>
                  <a:pt x="162" y="194"/>
                </a:cubicBezTo>
                <a:cubicBezTo>
                  <a:pt x="162" y="194"/>
                  <a:pt x="162" y="194"/>
                  <a:pt x="162" y="194"/>
                </a:cubicBezTo>
                <a:cubicBezTo>
                  <a:pt x="162" y="194"/>
                  <a:pt x="162" y="194"/>
                  <a:pt x="161" y="194"/>
                </a:cubicBezTo>
                <a:cubicBezTo>
                  <a:pt x="160" y="195"/>
                  <a:pt x="146" y="201"/>
                  <a:pt x="129" y="203"/>
                </a:cubicBezTo>
                <a:cubicBezTo>
                  <a:pt x="111" y="205"/>
                  <a:pt x="87" y="204"/>
                  <a:pt x="62" y="191"/>
                </a:cubicBezTo>
                <a:cubicBezTo>
                  <a:pt x="36" y="178"/>
                  <a:pt x="19" y="158"/>
                  <a:pt x="10" y="139"/>
                </a:cubicBezTo>
                <a:cubicBezTo>
                  <a:pt x="1" y="120"/>
                  <a:pt x="2" y="103"/>
                  <a:pt x="2" y="102"/>
                </a:cubicBezTo>
                <a:cubicBezTo>
                  <a:pt x="2" y="101"/>
                  <a:pt x="2" y="101"/>
                  <a:pt x="2" y="101"/>
                </a:cubicBezTo>
                <a:cubicBezTo>
                  <a:pt x="2" y="101"/>
                  <a:pt x="2" y="101"/>
                  <a:pt x="2" y="101"/>
                </a:cubicBezTo>
                <a:cubicBezTo>
                  <a:pt x="2" y="101"/>
                  <a:pt x="1" y="101"/>
                  <a:pt x="1" y="101"/>
                </a:cubicBezTo>
                <a:close/>
                <a:moveTo>
                  <a:pt x="108" y="133"/>
                </a:moveTo>
                <a:cubicBezTo>
                  <a:pt x="108" y="108"/>
                  <a:pt x="108" y="108"/>
                  <a:pt x="108" y="108"/>
                </a:cubicBezTo>
                <a:cubicBezTo>
                  <a:pt x="91" y="70"/>
                  <a:pt x="91" y="70"/>
                  <a:pt x="91" y="70"/>
                </a:cubicBezTo>
                <a:cubicBezTo>
                  <a:pt x="105" y="70"/>
                  <a:pt x="105" y="70"/>
                  <a:pt x="105" y="70"/>
                </a:cubicBezTo>
                <a:cubicBezTo>
                  <a:pt x="116" y="95"/>
                  <a:pt x="116" y="95"/>
                  <a:pt x="116" y="95"/>
                </a:cubicBezTo>
                <a:cubicBezTo>
                  <a:pt x="127" y="70"/>
                  <a:pt x="127" y="70"/>
                  <a:pt x="127" y="70"/>
                </a:cubicBezTo>
                <a:cubicBezTo>
                  <a:pt x="140" y="70"/>
                  <a:pt x="140" y="70"/>
                  <a:pt x="140" y="70"/>
                </a:cubicBezTo>
                <a:cubicBezTo>
                  <a:pt x="123" y="108"/>
                  <a:pt x="123" y="108"/>
                  <a:pt x="123" y="108"/>
                </a:cubicBezTo>
                <a:cubicBezTo>
                  <a:pt x="123" y="133"/>
                  <a:pt x="123" y="133"/>
                  <a:pt x="123" y="133"/>
                </a:cubicBezTo>
                <a:lnTo>
                  <a:pt x="108" y="133"/>
                </a:lnTo>
                <a:close/>
                <a:moveTo>
                  <a:pt x="241" y="133"/>
                </a:moveTo>
                <a:cubicBezTo>
                  <a:pt x="208" y="133"/>
                  <a:pt x="208" y="133"/>
                  <a:pt x="208" y="133"/>
                </a:cubicBezTo>
                <a:cubicBezTo>
                  <a:pt x="208" y="70"/>
                  <a:pt x="208" y="70"/>
                  <a:pt x="208" y="70"/>
                </a:cubicBezTo>
                <a:cubicBezTo>
                  <a:pt x="222" y="70"/>
                  <a:pt x="222" y="70"/>
                  <a:pt x="222" y="70"/>
                </a:cubicBezTo>
                <a:cubicBezTo>
                  <a:pt x="222" y="121"/>
                  <a:pt x="222" y="121"/>
                  <a:pt x="222" y="121"/>
                </a:cubicBezTo>
                <a:cubicBezTo>
                  <a:pt x="241" y="121"/>
                  <a:pt x="241" y="121"/>
                  <a:pt x="241" y="121"/>
                </a:cubicBezTo>
                <a:lnTo>
                  <a:pt x="241" y="133"/>
                </a:lnTo>
                <a:close/>
                <a:moveTo>
                  <a:pt x="73" y="70"/>
                </a:moveTo>
                <a:cubicBezTo>
                  <a:pt x="86" y="70"/>
                  <a:pt x="86" y="70"/>
                  <a:pt x="86" y="70"/>
                </a:cubicBezTo>
                <a:cubicBezTo>
                  <a:pt x="86" y="133"/>
                  <a:pt x="86" y="133"/>
                  <a:pt x="86" y="133"/>
                </a:cubicBezTo>
                <a:cubicBezTo>
                  <a:pt x="73" y="133"/>
                  <a:pt x="73" y="133"/>
                  <a:pt x="73" y="133"/>
                </a:cubicBezTo>
                <a:cubicBezTo>
                  <a:pt x="73" y="133"/>
                  <a:pt x="73" y="133"/>
                  <a:pt x="73" y="133"/>
                </a:cubicBezTo>
                <a:cubicBezTo>
                  <a:pt x="73" y="131"/>
                  <a:pt x="57" y="104"/>
                  <a:pt x="53" y="96"/>
                </a:cubicBezTo>
                <a:cubicBezTo>
                  <a:pt x="53" y="133"/>
                  <a:pt x="53" y="133"/>
                  <a:pt x="53" y="133"/>
                </a:cubicBezTo>
                <a:cubicBezTo>
                  <a:pt x="40" y="133"/>
                  <a:pt x="40" y="133"/>
                  <a:pt x="40" y="133"/>
                </a:cubicBezTo>
                <a:cubicBezTo>
                  <a:pt x="40" y="70"/>
                  <a:pt x="40" y="70"/>
                  <a:pt x="40" y="70"/>
                </a:cubicBezTo>
                <a:cubicBezTo>
                  <a:pt x="54" y="70"/>
                  <a:pt x="54" y="70"/>
                  <a:pt x="54" y="70"/>
                </a:cubicBezTo>
                <a:cubicBezTo>
                  <a:pt x="54" y="70"/>
                  <a:pt x="54" y="70"/>
                  <a:pt x="54" y="70"/>
                </a:cubicBezTo>
                <a:cubicBezTo>
                  <a:pt x="55" y="71"/>
                  <a:pt x="69" y="97"/>
                  <a:pt x="73" y="106"/>
                </a:cubicBezTo>
                <a:lnTo>
                  <a:pt x="73" y="70"/>
                </a:lnTo>
                <a:close/>
                <a:moveTo>
                  <a:pt x="166" y="134"/>
                </a:moveTo>
                <a:cubicBezTo>
                  <a:pt x="152" y="134"/>
                  <a:pt x="144" y="126"/>
                  <a:pt x="144" y="111"/>
                </a:cubicBezTo>
                <a:cubicBezTo>
                  <a:pt x="144" y="70"/>
                  <a:pt x="144" y="70"/>
                  <a:pt x="144" y="70"/>
                </a:cubicBezTo>
                <a:cubicBezTo>
                  <a:pt x="158" y="70"/>
                  <a:pt x="158" y="70"/>
                  <a:pt x="158" y="70"/>
                </a:cubicBezTo>
                <a:cubicBezTo>
                  <a:pt x="158" y="110"/>
                  <a:pt x="158" y="110"/>
                  <a:pt x="158" y="110"/>
                </a:cubicBezTo>
                <a:cubicBezTo>
                  <a:pt x="158" y="119"/>
                  <a:pt x="161" y="122"/>
                  <a:pt x="167" y="122"/>
                </a:cubicBezTo>
                <a:cubicBezTo>
                  <a:pt x="172" y="122"/>
                  <a:pt x="175" y="118"/>
                  <a:pt x="175" y="110"/>
                </a:cubicBezTo>
                <a:cubicBezTo>
                  <a:pt x="175" y="70"/>
                  <a:pt x="175" y="70"/>
                  <a:pt x="175" y="70"/>
                </a:cubicBezTo>
                <a:cubicBezTo>
                  <a:pt x="188" y="70"/>
                  <a:pt x="188" y="70"/>
                  <a:pt x="188" y="70"/>
                </a:cubicBezTo>
                <a:cubicBezTo>
                  <a:pt x="188" y="111"/>
                  <a:pt x="188" y="111"/>
                  <a:pt x="188" y="111"/>
                </a:cubicBezTo>
                <a:cubicBezTo>
                  <a:pt x="188" y="126"/>
                  <a:pt x="181" y="134"/>
                  <a:pt x="166" y="134"/>
                </a:cubicBezTo>
                <a:close/>
                <a:moveTo>
                  <a:pt x="259" y="199"/>
                </a:moveTo>
                <a:cubicBezTo>
                  <a:pt x="267" y="206"/>
                  <a:pt x="267" y="206"/>
                  <a:pt x="267" y="206"/>
                </a:cubicBezTo>
                <a:cubicBezTo>
                  <a:pt x="267" y="206"/>
                  <a:pt x="267" y="206"/>
                  <a:pt x="267" y="206"/>
                </a:cubicBezTo>
                <a:cubicBezTo>
                  <a:pt x="263" y="213"/>
                  <a:pt x="257" y="216"/>
                  <a:pt x="249" y="216"/>
                </a:cubicBezTo>
                <a:cubicBezTo>
                  <a:pt x="236" y="216"/>
                  <a:pt x="229" y="207"/>
                  <a:pt x="229" y="192"/>
                </a:cubicBezTo>
                <a:cubicBezTo>
                  <a:pt x="229" y="174"/>
                  <a:pt x="239" y="168"/>
                  <a:pt x="249" y="168"/>
                </a:cubicBezTo>
                <a:cubicBezTo>
                  <a:pt x="261" y="168"/>
                  <a:pt x="267" y="177"/>
                  <a:pt x="267" y="193"/>
                </a:cubicBezTo>
                <a:cubicBezTo>
                  <a:pt x="267" y="196"/>
                  <a:pt x="267" y="196"/>
                  <a:pt x="267" y="196"/>
                </a:cubicBezTo>
                <a:cubicBezTo>
                  <a:pt x="242" y="196"/>
                  <a:pt x="242" y="196"/>
                  <a:pt x="242" y="196"/>
                </a:cubicBezTo>
                <a:cubicBezTo>
                  <a:pt x="243" y="202"/>
                  <a:pt x="245" y="205"/>
                  <a:pt x="250" y="205"/>
                </a:cubicBezTo>
                <a:cubicBezTo>
                  <a:pt x="254" y="205"/>
                  <a:pt x="257" y="202"/>
                  <a:pt x="259" y="200"/>
                </a:cubicBezTo>
                <a:lnTo>
                  <a:pt x="259" y="199"/>
                </a:lnTo>
                <a:close/>
                <a:moveTo>
                  <a:pt x="242" y="187"/>
                </a:moveTo>
                <a:cubicBezTo>
                  <a:pt x="255" y="187"/>
                  <a:pt x="255" y="187"/>
                  <a:pt x="255" y="187"/>
                </a:cubicBezTo>
                <a:cubicBezTo>
                  <a:pt x="254" y="179"/>
                  <a:pt x="250" y="179"/>
                  <a:pt x="249" y="179"/>
                </a:cubicBezTo>
                <a:cubicBezTo>
                  <a:pt x="245" y="179"/>
                  <a:pt x="243" y="182"/>
                  <a:pt x="242" y="187"/>
                </a:cubicBezTo>
                <a:close/>
                <a:moveTo>
                  <a:pt x="416" y="92"/>
                </a:moveTo>
                <a:cubicBezTo>
                  <a:pt x="420" y="96"/>
                  <a:pt x="422" y="102"/>
                  <a:pt x="422" y="110"/>
                </a:cubicBezTo>
                <a:cubicBezTo>
                  <a:pt x="422" y="128"/>
                  <a:pt x="412" y="134"/>
                  <a:pt x="402" y="134"/>
                </a:cubicBezTo>
                <a:cubicBezTo>
                  <a:pt x="392" y="134"/>
                  <a:pt x="382" y="128"/>
                  <a:pt x="382" y="110"/>
                </a:cubicBezTo>
                <a:cubicBezTo>
                  <a:pt x="382" y="102"/>
                  <a:pt x="384" y="96"/>
                  <a:pt x="388" y="92"/>
                </a:cubicBezTo>
                <a:cubicBezTo>
                  <a:pt x="392" y="88"/>
                  <a:pt x="396" y="86"/>
                  <a:pt x="402" y="86"/>
                </a:cubicBezTo>
                <a:cubicBezTo>
                  <a:pt x="408" y="86"/>
                  <a:pt x="413" y="88"/>
                  <a:pt x="416" y="92"/>
                </a:cubicBezTo>
                <a:close/>
                <a:moveTo>
                  <a:pt x="409" y="110"/>
                </a:moveTo>
                <a:cubicBezTo>
                  <a:pt x="409" y="99"/>
                  <a:pt x="405" y="97"/>
                  <a:pt x="402" y="97"/>
                </a:cubicBezTo>
                <a:cubicBezTo>
                  <a:pt x="398" y="97"/>
                  <a:pt x="396" y="101"/>
                  <a:pt x="396" y="110"/>
                </a:cubicBezTo>
                <a:cubicBezTo>
                  <a:pt x="396" y="122"/>
                  <a:pt x="399" y="123"/>
                  <a:pt x="402" y="123"/>
                </a:cubicBezTo>
                <a:cubicBezTo>
                  <a:pt x="407" y="123"/>
                  <a:pt x="409" y="119"/>
                  <a:pt x="409" y="110"/>
                </a:cubicBezTo>
                <a:close/>
                <a:moveTo>
                  <a:pt x="410" y="180"/>
                </a:moveTo>
                <a:cubicBezTo>
                  <a:pt x="410" y="215"/>
                  <a:pt x="410" y="215"/>
                  <a:pt x="410" y="215"/>
                </a:cubicBezTo>
                <a:cubicBezTo>
                  <a:pt x="397" y="215"/>
                  <a:pt x="397" y="215"/>
                  <a:pt x="397" y="215"/>
                </a:cubicBezTo>
                <a:cubicBezTo>
                  <a:pt x="397" y="184"/>
                  <a:pt x="397" y="184"/>
                  <a:pt x="397" y="184"/>
                </a:cubicBezTo>
                <a:cubicBezTo>
                  <a:pt x="397" y="180"/>
                  <a:pt x="395" y="180"/>
                  <a:pt x="393" y="180"/>
                </a:cubicBezTo>
                <a:cubicBezTo>
                  <a:pt x="391" y="180"/>
                  <a:pt x="389" y="181"/>
                  <a:pt x="386" y="183"/>
                </a:cubicBezTo>
                <a:cubicBezTo>
                  <a:pt x="386" y="215"/>
                  <a:pt x="386" y="215"/>
                  <a:pt x="386" y="215"/>
                </a:cubicBezTo>
                <a:cubicBezTo>
                  <a:pt x="373" y="215"/>
                  <a:pt x="373" y="215"/>
                  <a:pt x="373" y="215"/>
                </a:cubicBezTo>
                <a:cubicBezTo>
                  <a:pt x="373" y="152"/>
                  <a:pt x="373" y="152"/>
                  <a:pt x="373" y="152"/>
                </a:cubicBezTo>
                <a:cubicBezTo>
                  <a:pt x="386" y="150"/>
                  <a:pt x="386" y="150"/>
                  <a:pt x="386" y="150"/>
                </a:cubicBezTo>
                <a:cubicBezTo>
                  <a:pt x="386" y="174"/>
                  <a:pt x="386" y="174"/>
                  <a:pt x="386" y="174"/>
                </a:cubicBezTo>
                <a:cubicBezTo>
                  <a:pt x="389" y="171"/>
                  <a:pt x="393" y="168"/>
                  <a:pt x="399" y="168"/>
                </a:cubicBezTo>
                <a:cubicBezTo>
                  <a:pt x="406" y="168"/>
                  <a:pt x="410" y="172"/>
                  <a:pt x="410" y="180"/>
                </a:cubicBezTo>
                <a:close/>
                <a:moveTo>
                  <a:pt x="511" y="124"/>
                </a:moveTo>
                <a:cubicBezTo>
                  <a:pt x="511" y="124"/>
                  <a:pt x="511" y="124"/>
                  <a:pt x="511" y="124"/>
                </a:cubicBezTo>
                <a:cubicBezTo>
                  <a:pt x="507" y="131"/>
                  <a:pt x="501" y="134"/>
                  <a:pt x="493" y="134"/>
                </a:cubicBezTo>
                <a:cubicBezTo>
                  <a:pt x="480" y="134"/>
                  <a:pt x="473" y="125"/>
                  <a:pt x="473" y="110"/>
                </a:cubicBezTo>
                <a:cubicBezTo>
                  <a:pt x="473" y="92"/>
                  <a:pt x="484" y="86"/>
                  <a:pt x="493" y="86"/>
                </a:cubicBezTo>
                <a:cubicBezTo>
                  <a:pt x="505" y="86"/>
                  <a:pt x="511" y="95"/>
                  <a:pt x="511" y="111"/>
                </a:cubicBezTo>
                <a:cubicBezTo>
                  <a:pt x="511" y="114"/>
                  <a:pt x="511" y="114"/>
                  <a:pt x="511" y="114"/>
                </a:cubicBezTo>
                <a:cubicBezTo>
                  <a:pt x="486" y="114"/>
                  <a:pt x="486" y="114"/>
                  <a:pt x="486" y="114"/>
                </a:cubicBezTo>
                <a:cubicBezTo>
                  <a:pt x="487" y="120"/>
                  <a:pt x="489" y="123"/>
                  <a:pt x="494" y="123"/>
                </a:cubicBezTo>
                <a:cubicBezTo>
                  <a:pt x="498" y="123"/>
                  <a:pt x="501" y="120"/>
                  <a:pt x="503" y="118"/>
                </a:cubicBezTo>
                <a:cubicBezTo>
                  <a:pt x="503" y="117"/>
                  <a:pt x="503" y="117"/>
                  <a:pt x="503" y="117"/>
                </a:cubicBezTo>
                <a:lnTo>
                  <a:pt x="511" y="124"/>
                </a:lnTo>
                <a:close/>
                <a:moveTo>
                  <a:pt x="487" y="105"/>
                </a:moveTo>
                <a:cubicBezTo>
                  <a:pt x="499" y="105"/>
                  <a:pt x="499" y="105"/>
                  <a:pt x="499" y="105"/>
                </a:cubicBezTo>
                <a:cubicBezTo>
                  <a:pt x="498" y="97"/>
                  <a:pt x="494" y="97"/>
                  <a:pt x="493" y="97"/>
                </a:cubicBezTo>
                <a:cubicBezTo>
                  <a:pt x="489" y="97"/>
                  <a:pt x="487" y="100"/>
                  <a:pt x="487" y="105"/>
                </a:cubicBezTo>
                <a:close/>
                <a:moveTo>
                  <a:pt x="467" y="98"/>
                </a:moveTo>
                <a:cubicBezTo>
                  <a:pt x="467" y="133"/>
                  <a:pt x="467" y="133"/>
                  <a:pt x="467" y="133"/>
                </a:cubicBezTo>
                <a:cubicBezTo>
                  <a:pt x="453" y="133"/>
                  <a:pt x="453" y="133"/>
                  <a:pt x="453" y="133"/>
                </a:cubicBezTo>
                <a:cubicBezTo>
                  <a:pt x="453" y="102"/>
                  <a:pt x="453" y="102"/>
                  <a:pt x="453" y="102"/>
                </a:cubicBezTo>
                <a:cubicBezTo>
                  <a:pt x="453" y="98"/>
                  <a:pt x="452" y="98"/>
                  <a:pt x="450" y="98"/>
                </a:cubicBezTo>
                <a:cubicBezTo>
                  <a:pt x="448" y="98"/>
                  <a:pt x="445" y="99"/>
                  <a:pt x="443" y="102"/>
                </a:cubicBezTo>
                <a:cubicBezTo>
                  <a:pt x="443" y="133"/>
                  <a:pt x="443" y="133"/>
                  <a:pt x="443" y="133"/>
                </a:cubicBezTo>
                <a:cubicBezTo>
                  <a:pt x="429" y="133"/>
                  <a:pt x="429" y="133"/>
                  <a:pt x="429" y="133"/>
                </a:cubicBezTo>
                <a:cubicBezTo>
                  <a:pt x="429" y="87"/>
                  <a:pt x="429" y="87"/>
                  <a:pt x="429" y="87"/>
                </a:cubicBezTo>
                <a:cubicBezTo>
                  <a:pt x="443" y="87"/>
                  <a:pt x="443" y="87"/>
                  <a:pt x="443" y="87"/>
                </a:cubicBezTo>
                <a:cubicBezTo>
                  <a:pt x="443" y="92"/>
                  <a:pt x="443" y="92"/>
                  <a:pt x="443" y="92"/>
                </a:cubicBezTo>
                <a:cubicBezTo>
                  <a:pt x="445" y="89"/>
                  <a:pt x="450" y="86"/>
                  <a:pt x="455" y="86"/>
                </a:cubicBezTo>
                <a:cubicBezTo>
                  <a:pt x="463" y="86"/>
                  <a:pt x="467" y="90"/>
                  <a:pt x="467" y="98"/>
                </a:cubicBezTo>
                <a:close/>
                <a:moveTo>
                  <a:pt x="357" y="169"/>
                </a:moveTo>
                <a:cubicBezTo>
                  <a:pt x="366" y="169"/>
                  <a:pt x="366" y="169"/>
                  <a:pt x="366" y="169"/>
                </a:cubicBezTo>
                <a:cubicBezTo>
                  <a:pt x="366" y="179"/>
                  <a:pt x="366" y="179"/>
                  <a:pt x="366" y="179"/>
                </a:cubicBezTo>
                <a:cubicBezTo>
                  <a:pt x="357" y="179"/>
                  <a:pt x="357" y="179"/>
                  <a:pt x="357" y="179"/>
                </a:cubicBezTo>
                <a:cubicBezTo>
                  <a:pt x="357" y="200"/>
                  <a:pt x="357" y="200"/>
                  <a:pt x="357" y="200"/>
                </a:cubicBezTo>
                <a:cubicBezTo>
                  <a:pt x="357" y="204"/>
                  <a:pt x="358" y="205"/>
                  <a:pt x="361" y="205"/>
                </a:cubicBezTo>
                <a:cubicBezTo>
                  <a:pt x="363" y="205"/>
                  <a:pt x="364" y="205"/>
                  <a:pt x="365" y="205"/>
                </a:cubicBezTo>
                <a:cubicBezTo>
                  <a:pt x="366" y="204"/>
                  <a:pt x="366" y="204"/>
                  <a:pt x="366" y="204"/>
                </a:cubicBezTo>
                <a:cubicBezTo>
                  <a:pt x="366" y="215"/>
                  <a:pt x="366" y="215"/>
                  <a:pt x="366" y="215"/>
                </a:cubicBezTo>
                <a:cubicBezTo>
                  <a:pt x="365" y="215"/>
                  <a:pt x="365" y="215"/>
                  <a:pt x="365" y="215"/>
                </a:cubicBezTo>
                <a:cubicBezTo>
                  <a:pt x="364" y="215"/>
                  <a:pt x="360" y="215"/>
                  <a:pt x="357" y="215"/>
                </a:cubicBezTo>
                <a:cubicBezTo>
                  <a:pt x="347" y="215"/>
                  <a:pt x="343" y="212"/>
                  <a:pt x="343" y="203"/>
                </a:cubicBezTo>
                <a:cubicBezTo>
                  <a:pt x="343" y="179"/>
                  <a:pt x="343" y="179"/>
                  <a:pt x="343" y="179"/>
                </a:cubicBezTo>
                <a:cubicBezTo>
                  <a:pt x="337" y="179"/>
                  <a:pt x="337" y="179"/>
                  <a:pt x="337" y="179"/>
                </a:cubicBezTo>
                <a:cubicBezTo>
                  <a:pt x="337" y="169"/>
                  <a:pt x="337" y="169"/>
                  <a:pt x="337" y="169"/>
                </a:cubicBezTo>
                <a:cubicBezTo>
                  <a:pt x="343" y="169"/>
                  <a:pt x="343" y="169"/>
                  <a:pt x="343" y="169"/>
                </a:cubicBezTo>
                <a:cubicBezTo>
                  <a:pt x="343" y="156"/>
                  <a:pt x="343" y="156"/>
                  <a:pt x="343" y="156"/>
                </a:cubicBezTo>
                <a:cubicBezTo>
                  <a:pt x="357" y="154"/>
                  <a:pt x="357" y="154"/>
                  <a:pt x="357" y="154"/>
                </a:cubicBezTo>
                <a:lnTo>
                  <a:pt x="357" y="169"/>
                </a:lnTo>
                <a:close/>
                <a:moveTo>
                  <a:pt x="332" y="98"/>
                </a:moveTo>
                <a:cubicBezTo>
                  <a:pt x="332" y="133"/>
                  <a:pt x="332" y="133"/>
                  <a:pt x="332" y="133"/>
                </a:cubicBezTo>
                <a:cubicBezTo>
                  <a:pt x="318" y="133"/>
                  <a:pt x="318" y="133"/>
                  <a:pt x="318" y="133"/>
                </a:cubicBezTo>
                <a:cubicBezTo>
                  <a:pt x="318" y="102"/>
                  <a:pt x="318" y="102"/>
                  <a:pt x="318" y="102"/>
                </a:cubicBezTo>
                <a:cubicBezTo>
                  <a:pt x="318" y="98"/>
                  <a:pt x="316" y="98"/>
                  <a:pt x="315" y="98"/>
                </a:cubicBezTo>
                <a:cubicBezTo>
                  <a:pt x="313" y="98"/>
                  <a:pt x="310" y="99"/>
                  <a:pt x="307" y="102"/>
                </a:cubicBezTo>
                <a:cubicBezTo>
                  <a:pt x="307" y="133"/>
                  <a:pt x="307" y="133"/>
                  <a:pt x="307" y="133"/>
                </a:cubicBezTo>
                <a:cubicBezTo>
                  <a:pt x="294" y="133"/>
                  <a:pt x="294" y="133"/>
                  <a:pt x="294" y="133"/>
                </a:cubicBezTo>
                <a:cubicBezTo>
                  <a:pt x="294" y="87"/>
                  <a:pt x="294" y="87"/>
                  <a:pt x="294" y="87"/>
                </a:cubicBezTo>
                <a:cubicBezTo>
                  <a:pt x="307" y="87"/>
                  <a:pt x="307" y="87"/>
                  <a:pt x="307" y="87"/>
                </a:cubicBezTo>
                <a:cubicBezTo>
                  <a:pt x="307" y="92"/>
                  <a:pt x="307" y="92"/>
                  <a:pt x="307" y="92"/>
                </a:cubicBezTo>
                <a:cubicBezTo>
                  <a:pt x="310" y="89"/>
                  <a:pt x="315" y="86"/>
                  <a:pt x="320" y="86"/>
                </a:cubicBezTo>
                <a:cubicBezTo>
                  <a:pt x="328" y="86"/>
                  <a:pt x="332" y="90"/>
                  <a:pt x="332" y="98"/>
                </a:cubicBezTo>
                <a:close/>
                <a:moveTo>
                  <a:pt x="272" y="132"/>
                </a:moveTo>
                <a:cubicBezTo>
                  <a:pt x="272" y="131"/>
                  <a:pt x="271" y="130"/>
                  <a:pt x="271" y="128"/>
                </a:cubicBezTo>
                <a:cubicBezTo>
                  <a:pt x="268" y="132"/>
                  <a:pt x="264" y="133"/>
                  <a:pt x="259" y="133"/>
                </a:cubicBezTo>
                <a:cubicBezTo>
                  <a:pt x="251" y="133"/>
                  <a:pt x="247" y="129"/>
                  <a:pt x="247" y="121"/>
                </a:cubicBezTo>
                <a:cubicBezTo>
                  <a:pt x="247" y="112"/>
                  <a:pt x="255" y="106"/>
                  <a:pt x="271" y="103"/>
                </a:cubicBezTo>
                <a:cubicBezTo>
                  <a:pt x="271" y="102"/>
                  <a:pt x="271" y="102"/>
                  <a:pt x="271" y="102"/>
                </a:cubicBezTo>
                <a:cubicBezTo>
                  <a:pt x="271" y="98"/>
                  <a:pt x="270" y="97"/>
                  <a:pt x="267" y="97"/>
                </a:cubicBezTo>
                <a:cubicBezTo>
                  <a:pt x="263" y="97"/>
                  <a:pt x="258" y="100"/>
                  <a:pt x="256" y="102"/>
                </a:cubicBezTo>
                <a:cubicBezTo>
                  <a:pt x="255" y="102"/>
                  <a:pt x="255" y="102"/>
                  <a:pt x="255" y="102"/>
                </a:cubicBezTo>
                <a:cubicBezTo>
                  <a:pt x="249" y="94"/>
                  <a:pt x="249" y="94"/>
                  <a:pt x="249" y="94"/>
                </a:cubicBezTo>
                <a:cubicBezTo>
                  <a:pt x="249" y="93"/>
                  <a:pt x="249" y="93"/>
                  <a:pt x="249" y="93"/>
                </a:cubicBezTo>
                <a:cubicBezTo>
                  <a:pt x="255" y="89"/>
                  <a:pt x="262" y="86"/>
                  <a:pt x="270" y="86"/>
                </a:cubicBezTo>
                <a:cubicBezTo>
                  <a:pt x="280" y="86"/>
                  <a:pt x="285" y="91"/>
                  <a:pt x="285" y="102"/>
                </a:cubicBezTo>
                <a:cubicBezTo>
                  <a:pt x="285" y="121"/>
                  <a:pt x="285" y="121"/>
                  <a:pt x="285" y="121"/>
                </a:cubicBezTo>
                <a:cubicBezTo>
                  <a:pt x="285" y="127"/>
                  <a:pt x="285" y="130"/>
                  <a:pt x="286" y="132"/>
                </a:cubicBezTo>
                <a:cubicBezTo>
                  <a:pt x="286" y="133"/>
                  <a:pt x="286" y="133"/>
                  <a:pt x="286" y="133"/>
                </a:cubicBezTo>
                <a:cubicBezTo>
                  <a:pt x="272" y="133"/>
                  <a:pt x="272" y="133"/>
                  <a:pt x="272" y="133"/>
                </a:cubicBezTo>
                <a:lnTo>
                  <a:pt x="272" y="132"/>
                </a:lnTo>
                <a:close/>
                <a:moveTo>
                  <a:pt x="271" y="111"/>
                </a:moveTo>
                <a:cubicBezTo>
                  <a:pt x="262" y="113"/>
                  <a:pt x="261" y="116"/>
                  <a:pt x="261" y="119"/>
                </a:cubicBezTo>
                <a:cubicBezTo>
                  <a:pt x="261" y="121"/>
                  <a:pt x="262" y="123"/>
                  <a:pt x="264" y="123"/>
                </a:cubicBezTo>
                <a:cubicBezTo>
                  <a:pt x="267" y="123"/>
                  <a:pt x="269" y="122"/>
                  <a:pt x="271" y="120"/>
                </a:cubicBezTo>
                <a:lnTo>
                  <a:pt x="271" y="111"/>
                </a:lnTo>
                <a:close/>
                <a:moveTo>
                  <a:pt x="310" y="214"/>
                </a:moveTo>
                <a:cubicBezTo>
                  <a:pt x="311" y="215"/>
                  <a:pt x="311" y="215"/>
                  <a:pt x="311" y="215"/>
                </a:cubicBezTo>
                <a:cubicBezTo>
                  <a:pt x="297" y="215"/>
                  <a:pt x="297" y="215"/>
                  <a:pt x="297" y="215"/>
                </a:cubicBezTo>
                <a:cubicBezTo>
                  <a:pt x="297" y="214"/>
                  <a:pt x="297" y="214"/>
                  <a:pt x="297" y="214"/>
                </a:cubicBezTo>
                <a:cubicBezTo>
                  <a:pt x="296" y="213"/>
                  <a:pt x="296" y="212"/>
                  <a:pt x="296" y="210"/>
                </a:cubicBezTo>
                <a:cubicBezTo>
                  <a:pt x="293" y="214"/>
                  <a:pt x="289" y="215"/>
                  <a:pt x="283" y="215"/>
                </a:cubicBezTo>
                <a:cubicBezTo>
                  <a:pt x="276" y="215"/>
                  <a:pt x="272" y="211"/>
                  <a:pt x="272" y="203"/>
                </a:cubicBezTo>
                <a:cubicBezTo>
                  <a:pt x="272" y="194"/>
                  <a:pt x="280" y="188"/>
                  <a:pt x="296" y="185"/>
                </a:cubicBezTo>
                <a:cubicBezTo>
                  <a:pt x="296" y="183"/>
                  <a:pt x="296" y="183"/>
                  <a:pt x="296" y="183"/>
                </a:cubicBezTo>
                <a:cubicBezTo>
                  <a:pt x="296" y="180"/>
                  <a:pt x="295" y="179"/>
                  <a:pt x="292" y="179"/>
                </a:cubicBezTo>
                <a:cubicBezTo>
                  <a:pt x="287" y="179"/>
                  <a:pt x="283" y="182"/>
                  <a:pt x="280" y="184"/>
                </a:cubicBezTo>
                <a:cubicBezTo>
                  <a:pt x="280" y="184"/>
                  <a:pt x="280" y="184"/>
                  <a:pt x="280" y="184"/>
                </a:cubicBezTo>
                <a:cubicBezTo>
                  <a:pt x="273" y="176"/>
                  <a:pt x="273" y="176"/>
                  <a:pt x="273" y="176"/>
                </a:cubicBezTo>
                <a:cubicBezTo>
                  <a:pt x="274" y="175"/>
                  <a:pt x="274" y="175"/>
                  <a:pt x="274" y="175"/>
                </a:cubicBezTo>
                <a:cubicBezTo>
                  <a:pt x="279" y="171"/>
                  <a:pt x="286" y="168"/>
                  <a:pt x="294" y="168"/>
                </a:cubicBezTo>
                <a:cubicBezTo>
                  <a:pt x="305" y="168"/>
                  <a:pt x="309" y="173"/>
                  <a:pt x="309" y="183"/>
                </a:cubicBezTo>
                <a:cubicBezTo>
                  <a:pt x="309" y="203"/>
                  <a:pt x="309" y="203"/>
                  <a:pt x="309" y="203"/>
                </a:cubicBezTo>
                <a:cubicBezTo>
                  <a:pt x="309" y="209"/>
                  <a:pt x="310" y="212"/>
                  <a:pt x="310" y="214"/>
                </a:cubicBezTo>
                <a:close/>
                <a:moveTo>
                  <a:pt x="296" y="193"/>
                </a:moveTo>
                <a:cubicBezTo>
                  <a:pt x="286" y="195"/>
                  <a:pt x="285" y="198"/>
                  <a:pt x="285" y="201"/>
                </a:cubicBezTo>
                <a:cubicBezTo>
                  <a:pt x="285" y="203"/>
                  <a:pt x="286" y="205"/>
                  <a:pt x="289" y="205"/>
                </a:cubicBezTo>
                <a:cubicBezTo>
                  <a:pt x="291" y="205"/>
                  <a:pt x="294" y="204"/>
                  <a:pt x="296" y="201"/>
                </a:cubicBezTo>
                <a:lnTo>
                  <a:pt x="296" y="193"/>
                </a:lnTo>
                <a:close/>
                <a:moveTo>
                  <a:pt x="318" y="159"/>
                </a:moveTo>
                <a:cubicBezTo>
                  <a:pt x="332" y="157"/>
                  <a:pt x="332" y="157"/>
                  <a:pt x="332" y="157"/>
                </a:cubicBezTo>
                <a:cubicBezTo>
                  <a:pt x="332" y="215"/>
                  <a:pt x="332" y="215"/>
                  <a:pt x="332" y="215"/>
                </a:cubicBezTo>
                <a:cubicBezTo>
                  <a:pt x="318" y="215"/>
                  <a:pt x="318" y="215"/>
                  <a:pt x="318" y="215"/>
                </a:cubicBezTo>
                <a:lnTo>
                  <a:pt x="318" y="159"/>
                </a:lnTo>
                <a:close/>
                <a:moveTo>
                  <a:pt x="208" y="153"/>
                </a:moveTo>
                <a:cubicBezTo>
                  <a:pt x="222" y="153"/>
                  <a:pt x="222" y="153"/>
                  <a:pt x="222" y="153"/>
                </a:cubicBezTo>
                <a:cubicBezTo>
                  <a:pt x="222" y="215"/>
                  <a:pt x="222" y="215"/>
                  <a:pt x="222" y="215"/>
                </a:cubicBezTo>
                <a:cubicBezTo>
                  <a:pt x="208" y="215"/>
                  <a:pt x="208" y="215"/>
                  <a:pt x="208" y="215"/>
                </a:cubicBezTo>
                <a:cubicBezTo>
                  <a:pt x="208" y="188"/>
                  <a:pt x="208" y="188"/>
                  <a:pt x="208" y="188"/>
                </a:cubicBezTo>
                <a:cubicBezTo>
                  <a:pt x="188" y="188"/>
                  <a:pt x="188" y="188"/>
                  <a:pt x="188" y="188"/>
                </a:cubicBezTo>
                <a:cubicBezTo>
                  <a:pt x="188" y="215"/>
                  <a:pt x="188" y="215"/>
                  <a:pt x="188" y="215"/>
                </a:cubicBezTo>
                <a:cubicBezTo>
                  <a:pt x="174" y="215"/>
                  <a:pt x="174" y="215"/>
                  <a:pt x="174" y="215"/>
                </a:cubicBezTo>
                <a:cubicBezTo>
                  <a:pt x="174" y="153"/>
                  <a:pt x="174" y="153"/>
                  <a:pt x="174" y="153"/>
                </a:cubicBezTo>
                <a:cubicBezTo>
                  <a:pt x="188" y="153"/>
                  <a:pt x="188" y="153"/>
                  <a:pt x="188" y="153"/>
                </a:cubicBezTo>
                <a:cubicBezTo>
                  <a:pt x="188" y="176"/>
                  <a:pt x="188" y="176"/>
                  <a:pt x="188" y="176"/>
                </a:cubicBezTo>
                <a:cubicBezTo>
                  <a:pt x="208" y="176"/>
                  <a:pt x="208" y="176"/>
                  <a:pt x="208" y="176"/>
                </a:cubicBezTo>
                <a:lnTo>
                  <a:pt x="208" y="153"/>
                </a:lnTo>
                <a:close/>
                <a:moveTo>
                  <a:pt x="342" y="130"/>
                </a:moveTo>
                <a:cubicBezTo>
                  <a:pt x="340" y="129"/>
                  <a:pt x="339" y="127"/>
                  <a:pt x="339" y="124"/>
                </a:cubicBezTo>
                <a:cubicBezTo>
                  <a:pt x="339" y="122"/>
                  <a:pt x="341" y="118"/>
                  <a:pt x="345" y="116"/>
                </a:cubicBezTo>
                <a:cubicBezTo>
                  <a:pt x="341" y="113"/>
                  <a:pt x="339" y="108"/>
                  <a:pt x="339" y="103"/>
                </a:cubicBezTo>
                <a:cubicBezTo>
                  <a:pt x="339" y="93"/>
                  <a:pt x="346" y="86"/>
                  <a:pt x="357" y="86"/>
                </a:cubicBezTo>
                <a:cubicBezTo>
                  <a:pt x="362" y="86"/>
                  <a:pt x="367" y="88"/>
                  <a:pt x="370" y="90"/>
                </a:cubicBezTo>
                <a:cubicBezTo>
                  <a:pt x="372" y="88"/>
                  <a:pt x="376" y="86"/>
                  <a:pt x="379" y="86"/>
                </a:cubicBezTo>
                <a:cubicBezTo>
                  <a:pt x="380" y="86"/>
                  <a:pt x="380" y="86"/>
                  <a:pt x="380" y="86"/>
                </a:cubicBezTo>
                <a:cubicBezTo>
                  <a:pt x="380" y="98"/>
                  <a:pt x="380" y="98"/>
                  <a:pt x="380" y="98"/>
                </a:cubicBezTo>
                <a:cubicBezTo>
                  <a:pt x="379" y="98"/>
                  <a:pt x="379" y="98"/>
                  <a:pt x="379" y="98"/>
                </a:cubicBezTo>
                <a:cubicBezTo>
                  <a:pt x="378" y="98"/>
                  <a:pt x="376" y="98"/>
                  <a:pt x="374" y="98"/>
                </a:cubicBezTo>
                <a:cubicBezTo>
                  <a:pt x="375" y="100"/>
                  <a:pt x="375" y="101"/>
                  <a:pt x="375" y="103"/>
                </a:cubicBezTo>
                <a:cubicBezTo>
                  <a:pt x="375" y="113"/>
                  <a:pt x="368" y="120"/>
                  <a:pt x="357" y="120"/>
                </a:cubicBezTo>
                <a:cubicBezTo>
                  <a:pt x="355" y="120"/>
                  <a:pt x="353" y="119"/>
                  <a:pt x="351" y="119"/>
                </a:cubicBezTo>
                <a:cubicBezTo>
                  <a:pt x="351" y="120"/>
                  <a:pt x="351" y="120"/>
                  <a:pt x="351" y="120"/>
                </a:cubicBezTo>
                <a:cubicBezTo>
                  <a:pt x="351" y="121"/>
                  <a:pt x="351" y="122"/>
                  <a:pt x="354" y="122"/>
                </a:cubicBezTo>
                <a:cubicBezTo>
                  <a:pt x="360" y="123"/>
                  <a:pt x="360" y="123"/>
                  <a:pt x="360" y="123"/>
                </a:cubicBezTo>
                <a:cubicBezTo>
                  <a:pt x="374" y="124"/>
                  <a:pt x="379" y="127"/>
                  <a:pt x="379" y="135"/>
                </a:cubicBezTo>
                <a:cubicBezTo>
                  <a:pt x="379" y="144"/>
                  <a:pt x="370" y="149"/>
                  <a:pt x="356" y="149"/>
                </a:cubicBezTo>
                <a:cubicBezTo>
                  <a:pt x="342" y="149"/>
                  <a:pt x="336" y="146"/>
                  <a:pt x="336" y="139"/>
                </a:cubicBezTo>
                <a:cubicBezTo>
                  <a:pt x="336" y="135"/>
                  <a:pt x="338" y="132"/>
                  <a:pt x="342" y="130"/>
                </a:cubicBezTo>
                <a:close/>
                <a:moveTo>
                  <a:pt x="352" y="103"/>
                </a:moveTo>
                <a:cubicBezTo>
                  <a:pt x="352" y="106"/>
                  <a:pt x="352" y="111"/>
                  <a:pt x="357" y="111"/>
                </a:cubicBezTo>
                <a:cubicBezTo>
                  <a:pt x="360" y="111"/>
                  <a:pt x="362" y="108"/>
                  <a:pt x="362" y="103"/>
                </a:cubicBezTo>
                <a:cubicBezTo>
                  <a:pt x="362" y="100"/>
                  <a:pt x="361" y="96"/>
                  <a:pt x="357" y="96"/>
                </a:cubicBezTo>
                <a:cubicBezTo>
                  <a:pt x="352" y="96"/>
                  <a:pt x="352" y="101"/>
                  <a:pt x="352" y="103"/>
                </a:cubicBezTo>
                <a:close/>
                <a:moveTo>
                  <a:pt x="348" y="137"/>
                </a:moveTo>
                <a:cubicBezTo>
                  <a:pt x="348" y="140"/>
                  <a:pt x="350" y="142"/>
                  <a:pt x="357" y="142"/>
                </a:cubicBezTo>
                <a:cubicBezTo>
                  <a:pt x="363" y="142"/>
                  <a:pt x="366" y="140"/>
                  <a:pt x="366" y="137"/>
                </a:cubicBezTo>
                <a:cubicBezTo>
                  <a:pt x="366" y="135"/>
                  <a:pt x="366" y="134"/>
                  <a:pt x="358" y="134"/>
                </a:cubicBezTo>
                <a:cubicBezTo>
                  <a:pt x="351" y="133"/>
                  <a:pt x="351" y="133"/>
                  <a:pt x="351" y="133"/>
                </a:cubicBezTo>
                <a:cubicBezTo>
                  <a:pt x="351" y="133"/>
                  <a:pt x="350" y="133"/>
                  <a:pt x="350" y="133"/>
                </a:cubicBezTo>
                <a:cubicBezTo>
                  <a:pt x="349" y="134"/>
                  <a:pt x="348" y="136"/>
                  <a:pt x="348" y="137"/>
                </a:cubicBezTo>
                <a:close/>
              </a:path>
            </a:pathLst>
          </a:custGeom>
          <a:solidFill>
            <a:schemeClr val="tx2"/>
          </a:solidFill>
          <a:ln>
            <a:noFill/>
          </a:ln>
        </p:spPr>
        <p:txBody>
          <a:bodyPr vert="horz" wrap="square" lIns="121920" tIns="60960" rIns="121920" bIns="60960" numCol="1" anchor="t" anchorCtr="0" compatLnSpc="1">
            <a:prstTxWarp prst="textNoShape">
              <a:avLst/>
            </a:prstTxWarp>
          </a:bodyPr>
          <a:lstStyle/>
          <a:p>
            <a:endParaRPr lang="en-US"/>
          </a:p>
        </p:txBody>
      </p:sp>
      <p:sp>
        <p:nvSpPr>
          <p:cNvPr id="12" name="Title 1"/>
          <p:cNvSpPr>
            <a:spLocks noGrp="1"/>
          </p:cNvSpPr>
          <p:nvPr>
            <p:ph type="title"/>
          </p:nvPr>
        </p:nvSpPr>
        <p:spPr>
          <a:xfrm>
            <a:off x="609595" y="1572768"/>
            <a:ext cx="5473460" cy="348813"/>
          </a:xfrm>
        </p:spPr>
        <p:txBody>
          <a:bodyPr vert="horz" lIns="0" tIns="0" rIns="0" bIns="0" rtlCol="0" anchor="b" anchorCtr="0">
            <a:noAutofit/>
          </a:bodyPr>
          <a:lstStyle>
            <a:lvl1pPr>
              <a:defRPr lang="en-US" sz="2700" b="1" i="0" kern="1200" cap="none" dirty="0">
                <a:solidFill>
                  <a:schemeClr val="bg1"/>
                </a:solidFill>
                <a:latin typeface="+mj-lt"/>
                <a:ea typeface="+mj-ea"/>
                <a:cs typeface="+mj-cs"/>
              </a:defRPr>
            </a:lvl1pPr>
          </a:lstStyle>
          <a:p>
            <a:pPr lvl="0" algn="l" defTabSz="457189" rtl="0" eaLnBrk="1" latinLnBrk="0" hangingPunct="1">
              <a:lnSpc>
                <a:spcPct val="85000"/>
              </a:lnSpc>
              <a:spcBef>
                <a:spcPct val="0"/>
              </a:spcBef>
              <a:buNone/>
            </a:pPr>
            <a:r>
              <a:rPr lang="en-US"/>
              <a:t>Click to edit Master title style</a:t>
            </a:r>
          </a:p>
        </p:txBody>
      </p:sp>
      <p:sp>
        <p:nvSpPr>
          <p:cNvPr id="15" name="Content Placeholder 12"/>
          <p:cNvSpPr>
            <a:spLocks noGrp="1"/>
          </p:cNvSpPr>
          <p:nvPr>
            <p:ph sz="quarter" idx="11"/>
          </p:nvPr>
        </p:nvSpPr>
        <p:spPr>
          <a:xfrm>
            <a:off x="609601" y="1987296"/>
            <a:ext cx="5473455" cy="3707384"/>
          </a:xfrm>
        </p:spPr>
        <p:txBody>
          <a:bodyPr/>
          <a:lstStyle>
            <a:lvl1pPr>
              <a:lnSpc>
                <a:spcPct val="100000"/>
              </a:lnSpc>
              <a:buClr>
                <a:schemeClr val="bg1"/>
              </a:buClr>
              <a:defRPr>
                <a:solidFill>
                  <a:schemeClr val="bg1"/>
                </a:solidFill>
              </a:defRPr>
            </a:lvl1pPr>
            <a:lvl2pPr>
              <a:lnSpc>
                <a:spcPct val="100000"/>
              </a:lnSpc>
              <a:buClr>
                <a:schemeClr val="bg1"/>
              </a:buClr>
              <a:defRPr>
                <a:solidFill>
                  <a:schemeClr val="bg1"/>
                </a:solidFill>
              </a:defRPr>
            </a:lvl2pPr>
            <a:lvl3pPr>
              <a:lnSpc>
                <a:spcPct val="100000"/>
              </a:lnSpc>
              <a:buClr>
                <a:schemeClr val="bg1"/>
              </a:buClr>
              <a:defRPr>
                <a:solidFill>
                  <a:schemeClr val="bg1"/>
                </a:solidFill>
              </a:defRPr>
            </a:lvl3pPr>
            <a:lvl4pPr>
              <a:lnSpc>
                <a:spcPct val="100000"/>
              </a:lnSpc>
              <a:buClr>
                <a:schemeClr val="bg1"/>
              </a:buClr>
              <a:defRPr>
                <a:solidFill>
                  <a:schemeClr val="bg1"/>
                </a:solidFill>
              </a:defRPr>
            </a:lvl4pPr>
            <a:lvl5pPr>
              <a:lnSpc>
                <a:spcPct val="100000"/>
              </a:lnSpc>
              <a:buClr>
                <a:schemeClr val="bg1"/>
              </a:buClr>
              <a:defRPr>
                <a:solidFill>
                  <a:schemeClr val="bg1"/>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3676879287"/>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userDrawn="1">
  <p:cSld name="1_Full Page Photo">
    <p:spTree>
      <p:nvGrpSpPr>
        <p:cNvPr id="1" name=""/>
        <p:cNvGrpSpPr/>
        <p:nvPr/>
      </p:nvGrpSpPr>
      <p:grpSpPr>
        <a:xfrm>
          <a:off x="0" y="0"/>
          <a:ext cx="0" cy="0"/>
          <a:chOff x="0" y="0"/>
          <a:chExt cx="0" cy="0"/>
        </a:xfrm>
      </p:grpSpPr>
      <p:sp>
        <p:nvSpPr>
          <p:cNvPr id="10" name="Title 1"/>
          <p:cNvSpPr>
            <a:spLocks noGrp="1"/>
          </p:cNvSpPr>
          <p:nvPr>
            <p:ph type="title"/>
          </p:nvPr>
        </p:nvSpPr>
        <p:spPr>
          <a:xfrm>
            <a:off x="609600" y="5663796"/>
            <a:ext cx="10972800" cy="418576"/>
          </a:xfrm>
        </p:spPr>
        <p:txBody>
          <a:bodyPr vert="horz" lIns="0" tIns="0" rIns="0" bIns="0" rtlCol="0" anchor="b" anchorCtr="0">
            <a:noAutofit/>
          </a:bodyPr>
          <a:lstStyle>
            <a:lvl1pPr>
              <a:defRPr lang="en-US" sz="3200" b="1" i="0" kern="1200" cap="none" dirty="0">
                <a:solidFill>
                  <a:schemeClr val="tx2"/>
                </a:solidFill>
                <a:latin typeface="+mj-lt"/>
                <a:ea typeface="+mj-ea"/>
                <a:cs typeface="+mj-cs"/>
              </a:defRPr>
            </a:lvl1pPr>
          </a:lstStyle>
          <a:p>
            <a:pPr lvl="0" algn="l" defTabSz="457189" rtl="0" eaLnBrk="1" latinLnBrk="0" hangingPunct="1">
              <a:lnSpc>
                <a:spcPct val="85000"/>
              </a:lnSpc>
              <a:spcBef>
                <a:spcPct val="0"/>
              </a:spcBef>
              <a:buNone/>
            </a:pPr>
            <a:r>
              <a:rPr lang="en-US"/>
              <a:t>Click to edit Master title style</a:t>
            </a:r>
          </a:p>
        </p:txBody>
      </p:sp>
      <p:sp>
        <p:nvSpPr>
          <p:cNvPr id="4" name="Picture Placeholder 3"/>
          <p:cNvSpPr>
            <a:spLocks noGrp="1"/>
          </p:cNvSpPr>
          <p:nvPr>
            <p:ph type="pic" sz="quarter" idx="10" hasCustomPrompt="1"/>
          </p:nvPr>
        </p:nvSpPr>
        <p:spPr>
          <a:xfrm>
            <a:off x="2117" y="1"/>
            <a:ext cx="12189883" cy="5072879"/>
          </a:xfrm>
          <a:solidFill>
            <a:schemeClr val="bg2">
              <a:lumMod val="50000"/>
            </a:schemeClr>
          </a:solidFill>
        </p:spPr>
        <p:txBody>
          <a:bodyPr/>
          <a:lstStyle>
            <a:lvl1pPr marL="0" indent="0" algn="ctr">
              <a:buNone/>
              <a:defRPr>
                <a:solidFill>
                  <a:schemeClr val="bg1"/>
                </a:solidFill>
              </a:defRPr>
            </a:lvl1pPr>
          </a:lstStyle>
          <a:p>
            <a:br>
              <a:rPr lang="en-US"/>
            </a:br>
            <a:br>
              <a:rPr lang="en-US"/>
            </a:br>
            <a:br>
              <a:rPr lang="en-US"/>
            </a:br>
            <a:br>
              <a:rPr lang="en-US"/>
            </a:br>
            <a:br>
              <a:rPr lang="en-US"/>
            </a:br>
            <a:r>
              <a:rPr lang="en-US"/>
              <a:t>Click on icon to insert picture</a:t>
            </a:r>
          </a:p>
        </p:txBody>
      </p:sp>
      <p:sp>
        <p:nvSpPr>
          <p:cNvPr id="8" name="Footer Placeholder 4"/>
          <p:cNvSpPr>
            <a:spLocks noGrp="1"/>
          </p:cNvSpPr>
          <p:nvPr>
            <p:ph type="ftr" sz="quarter" idx="3"/>
          </p:nvPr>
        </p:nvSpPr>
        <p:spPr>
          <a:xfrm>
            <a:off x="1026597" y="6465181"/>
            <a:ext cx="4517089" cy="169277"/>
          </a:xfrm>
          <a:prstGeom prst="rect">
            <a:avLst/>
          </a:prstGeom>
        </p:spPr>
        <p:txBody>
          <a:bodyPr vert="horz" wrap="square" lIns="0" tIns="0" rIns="0" bIns="0" rtlCol="0" anchor="ctr">
            <a:spAutoFit/>
          </a:bodyPr>
          <a:lstStyle>
            <a:lvl1pPr algn="l">
              <a:defRPr sz="1100">
                <a:solidFill>
                  <a:schemeClr val="tx1"/>
                </a:solidFill>
              </a:defRPr>
            </a:lvl1pPr>
          </a:lstStyle>
          <a:p>
            <a:r>
              <a:rPr lang="en-US"/>
              <a:t>Division Name or Footer</a:t>
            </a:r>
          </a:p>
        </p:txBody>
      </p:sp>
      <p:sp>
        <p:nvSpPr>
          <p:cNvPr id="9" name="Slide Number Placeholder 5"/>
          <p:cNvSpPr>
            <a:spLocks noGrp="1"/>
          </p:cNvSpPr>
          <p:nvPr>
            <p:ph type="sldNum" sz="quarter" idx="4"/>
          </p:nvPr>
        </p:nvSpPr>
        <p:spPr>
          <a:xfrm>
            <a:off x="609601" y="6455138"/>
            <a:ext cx="339625" cy="169277"/>
          </a:xfrm>
          <a:prstGeom prst="rect">
            <a:avLst/>
          </a:prstGeom>
        </p:spPr>
        <p:txBody>
          <a:bodyPr vert="horz" wrap="square" lIns="0" tIns="0" rIns="0" bIns="0" rtlCol="0" anchor="ctr">
            <a:spAutoFit/>
          </a:bodyPr>
          <a:lstStyle>
            <a:lvl1pPr algn="l">
              <a:defRPr sz="1100">
                <a:solidFill>
                  <a:schemeClr val="tx1"/>
                </a:solidFill>
              </a:defRPr>
            </a:lvl1pPr>
          </a:lstStyle>
          <a:p>
            <a:fld id="{7FEEEA1A-CB49-3744-AA40-B896987410F9}" type="slidenum">
              <a:rPr lang="en-US" smtClean="0"/>
              <a:pPr/>
              <a:t>‹#›</a:t>
            </a:fld>
            <a:endParaRPr lang="en-US"/>
          </a:p>
        </p:txBody>
      </p:sp>
    </p:spTree>
    <p:extLst>
      <p:ext uri="{BB962C8B-B14F-4D97-AF65-F5344CB8AC3E}">
        <p14:creationId xmlns:p14="http://schemas.microsoft.com/office/powerpoint/2010/main" val="413027338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609599" y="1048512"/>
            <a:ext cx="10972803" cy="418576"/>
          </a:xfrm>
        </p:spPr>
        <p:txBody>
          <a:bodyPr vert="horz" lIns="0" tIns="0" rIns="0" bIns="0" rtlCol="0" anchor="b" anchorCtr="0">
            <a:noAutofit/>
          </a:bodyPr>
          <a:lstStyle>
            <a:lvl1pPr>
              <a:defRPr lang="en-US" sz="3200" b="1" i="0" kern="1200" cap="none" dirty="0">
                <a:solidFill>
                  <a:schemeClr val="tx2"/>
                </a:solidFill>
                <a:latin typeface="+mj-lt"/>
                <a:ea typeface="+mj-ea"/>
                <a:cs typeface="+mj-cs"/>
              </a:defRPr>
            </a:lvl1pPr>
          </a:lstStyle>
          <a:p>
            <a:pPr lvl="0" algn="l" defTabSz="457189" rtl="0" eaLnBrk="1" latinLnBrk="0" hangingPunct="1">
              <a:lnSpc>
                <a:spcPct val="85000"/>
              </a:lnSpc>
              <a:spcBef>
                <a:spcPct val="0"/>
              </a:spcBef>
              <a:buNone/>
            </a:pPr>
            <a:r>
              <a:rPr lang="en-US"/>
              <a:t>Click to edit Master title style</a:t>
            </a:r>
          </a:p>
        </p:txBody>
      </p:sp>
      <p:sp>
        <p:nvSpPr>
          <p:cNvPr id="9" name="Content Placeholder 8"/>
          <p:cNvSpPr>
            <a:spLocks noGrp="1"/>
          </p:cNvSpPr>
          <p:nvPr>
            <p:ph sz="quarter" idx="13"/>
          </p:nvPr>
        </p:nvSpPr>
        <p:spPr>
          <a:xfrm>
            <a:off x="609600" y="1780032"/>
            <a:ext cx="10972801" cy="4036568"/>
          </a:xfrm>
        </p:spPr>
        <p:txBody>
          <a:bodyPr vert="horz" lIns="0" tIns="0" rIns="0" bIns="0" rtlCol="0">
            <a:noAutofit/>
          </a:bodyPr>
          <a:lstStyle>
            <a:lvl1pPr>
              <a:defRPr lang="en-US" dirty="0" smtClean="0"/>
            </a:lvl1pPr>
            <a:lvl2pPr>
              <a:defRPr lang="en-US" dirty="0" smtClean="0"/>
            </a:lvl2pPr>
            <a:lvl3pPr>
              <a:defRPr lang="en-US" dirty="0" smtClean="0"/>
            </a:lvl3pPr>
            <a:lvl4pPr>
              <a:defRPr lang="en-US" dirty="0" smtClean="0"/>
            </a:lvl4pPr>
            <a:lvl5pPr>
              <a:defRPr lang="en-US" dirty="0"/>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4"/>
          <p:cNvSpPr>
            <a:spLocks noGrp="1"/>
          </p:cNvSpPr>
          <p:nvPr>
            <p:ph type="ftr" sz="quarter" idx="3"/>
          </p:nvPr>
        </p:nvSpPr>
        <p:spPr>
          <a:xfrm>
            <a:off x="1026597" y="6467745"/>
            <a:ext cx="4517089" cy="164148"/>
          </a:xfrm>
          <a:prstGeom prst="rect">
            <a:avLst/>
          </a:prstGeom>
        </p:spPr>
        <p:txBody>
          <a:bodyPr vert="horz" wrap="square" lIns="0" tIns="0" rIns="0" bIns="0" rtlCol="0" anchor="ctr">
            <a:spAutoFit/>
          </a:bodyPr>
          <a:lstStyle>
            <a:lvl1pPr algn="l">
              <a:defRPr sz="1067">
                <a:solidFill>
                  <a:schemeClr val="tx1"/>
                </a:solidFill>
              </a:defRPr>
            </a:lvl1pPr>
          </a:lstStyle>
          <a:p>
            <a:r>
              <a:rPr lang="en-US"/>
              <a:t>Division Name or Footer</a:t>
            </a:r>
          </a:p>
        </p:txBody>
      </p:sp>
      <p:sp>
        <p:nvSpPr>
          <p:cNvPr id="7" name="Slide Number Placeholder 5"/>
          <p:cNvSpPr>
            <a:spLocks noGrp="1"/>
          </p:cNvSpPr>
          <p:nvPr>
            <p:ph type="sldNum" sz="quarter" idx="4"/>
          </p:nvPr>
        </p:nvSpPr>
        <p:spPr>
          <a:xfrm>
            <a:off x="609601" y="6457702"/>
            <a:ext cx="339625" cy="164148"/>
          </a:xfrm>
          <a:prstGeom prst="rect">
            <a:avLst/>
          </a:prstGeom>
        </p:spPr>
        <p:txBody>
          <a:bodyPr vert="horz" wrap="square" lIns="0" tIns="0" rIns="0" bIns="0" rtlCol="0" anchor="ctr">
            <a:spAutoFit/>
          </a:bodyPr>
          <a:lstStyle>
            <a:lvl1pPr algn="l">
              <a:defRPr sz="1067">
                <a:solidFill>
                  <a:schemeClr val="tx1"/>
                </a:solidFill>
              </a:defRPr>
            </a:lvl1pPr>
          </a:lstStyle>
          <a:p>
            <a:fld id="{7FEEEA1A-CB49-3744-AA40-B896987410F9}" type="slidenum">
              <a:rPr lang="en-US" smtClean="0"/>
              <a:pPr/>
              <a:t>‹#›</a:t>
            </a:fld>
            <a:endParaRPr lang="en-US"/>
          </a:p>
        </p:txBody>
      </p:sp>
    </p:spTree>
    <p:extLst>
      <p:ext uri="{BB962C8B-B14F-4D97-AF65-F5344CB8AC3E}">
        <p14:creationId xmlns:p14="http://schemas.microsoft.com/office/powerpoint/2010/main" val="1133491212"/>
      </p:ext>
    </p:extLst>
  </p:cSld>
  <p:clrMapOvr>
    <a:masterClrMapping/>
  </p:clrMapOvr>
  <p:extLst>
    <p:ext uri="{DCECCB84-F9BA-43D5-87BE-67443E8EF086}">
      <p15:sldGuideLst xmlns:p15="http://schemas.microsoft.com/office/powerpoint/2012/main">
        <p15:guide id="1" orient="horz" pos="3824" userDrawn="1">
          <p15:clr>
            <a:srgbClr val="FBAE40"/>
          </p15:clr>
        </p15:guide>
        <p15:guide id="2" pos="3840" userDrawn="1">
          <p15:clr>
            <a:srgbClr val="FBAE40"/>
          </p15:clr>
        </p15:guide>
        <p15:guide id="4" pos="576" userDrawn="1">
          <p15:clr>
            <a:srgbClr val="FBAE40"/>
          </p15:clr>
        </p15:guide>
      </p15:sldGuideLst>
    </p:ext>
  </p:extLst>
</p:sldLayout>
</file>

<file path=ppt/slideLayouts/slideLayout20.xml><?xml version="1.0" encoding="utf-8"?>
<p:sldLayout xmlns:a="http://schemas.openxmlformats.org/drawingml/2006/main" xmlns:r="http://schemas.openxmlformats.org/officeDocument/2006/relationships" xmlns:p="http://schemas.openxmlformats.org/presentationml/2006/main" preserve="1" userDrawn="1">
  <p:cSld name="1_Thank You">
    <p:bg>
      <p:bgPr>
        <a:solidFill>
          <a:schemeClr val="tx2"/>
        </a:solidFill>
        <a:effectLst/>
      </p:bgPr>
    </p:bg>
    <p:spTree>
      <p:nvGrpSpPr>
        <p:cNvPr id="1" name=""/>
        <p:cNvGrpSpPr/>
        <p:nvPr/>
      </p:nvGrpSpPr>
      <p:grpSpPr>
        <a:xfrm>
          <a:off x="0" y="0"/>
          <a:ext cx="0" cy="0"/>
          <a:chOff x="0" y="0"/>
          <a:chExt cx="0" cy="0"/>
        </a:xfrm>
      </p:grpSpPr>
      <p:sp>
        <p:nvSpPr>
          <p:cNvPr id="6" name="Freeform 5"/>
          <p:cNvSpPr>
            <a:spLocks noEditPoints="1"/>
          </p:cNvSpPr>
          <p:nvPr userDrawn="1"/>
        </p:nvSpPr>
        <p:spPr bwMode="auto">
          <a:xfrm>
            <a:off x="9565381" y="5480825"/>
            <a:ext cx="2013840" cy="879415"/>
          </a:xfrm>
          <a:custGeom>
            <a:avLst/>
            <a:gdLst>
              <a:gd name="T0" fmla="*/ 32 w 511"/>
              <a:gd name="T1" fmla="*/ 39 h 221"/>
              <a:gd name="T2" fmla="*/ 106 w 511"/>
              <a:gd name="T3" fmla="*/ 0 h 221"/>
              <a:gd name="T4" fmla="*/ 188 w 511"/>
              <a:gd name="T5" fmla="*/ 44 h 221"/>
              <a:gd name="T6" fmla="*/ 139 w 511"/>
              <a:gd name="T7" fmla="*/ 208 h 221"/>
              <a:gd name="T8" fmla="*/ 161 w 511"/>
              <a:gd name="T9" fmla="*/ 194 h 221"/>
              <a:gd name="T10" fmla="*/ 2 w 511"/>
              <a:gd name="T11" fmla="*/ 101 h 221"/>
              <a:gd name="T12" fmla="*/ 91 w 511"/>
              <a:gd name="T13" fmla="*/ 70 h 221"/>
              <a:gd name="T14" fmla="*/ 123 w 511"/>
              <a:gd name="T15" fmla="*/ 108 h 221"/>
              <a:gd name="T16" fmla="*/ 208 w 511"/>
              <a:gd name="T17" fmla="*/ 70 h 221"/>
              <a:gd name="T18" fmla="*/ 73 w 511"/>
              <a:gd name="T19" fmla="*/ 70 h 221"/>
              <a:gd name="T20" fmla="*/ 53 w 511"/>
              <a:gd name="T21" fmla="*/ 96 h 221"/>
              <a:gd name="T22" fmla="*/ 54 w 511"/>
              <a:gd name="T23" fmla="*/ 70 h 221"/>
              <a:gd name="T24" fmla="*/ 144 w 511"/>
              <a:gd name="T25" fmla="*/ 70 h 221"/>
              <a:gd name="T26" fmla="*/ 175 w 511"/>
              <a:gd name="T27" fmla="*/ 70 h 221"/>
              <a:gd name="T28" fmla="*/ 267 w 511"/>
              <a:gd name="T29" fmla="*/ 206 h 221"/>
              <a:gd name="T30" fmla="*/ 267 w 511"/>
              <a:gd name="T31" fmla="*/ 193 h 221"/>
              <a:gd name="T32" fmla="*/ 259 w 511"/>
              <a:gd name="T33" fmla="*/ 199 h 221"/>
              <a:gd name="T34" fmla="*/ 416 w 511"/>
              <a:gd name="T35" fmla="*/ 92 h 221"/>
              <a:gd name="T36" fmla="*/ 402 w 511"/>
              <a:gd name="T37" fmla="*/ 86 h 221"/>
              <a:gd name="T38" fmla="*/ 402 w 511"/>
              <a:gd name="T39" fmla="*/ 123 h 221"/>
              <a:gd name="T40" fmla="*/ 397 w 511"/>
              <a:gd name="T41" fmla="*/ 184 h 221"/>
              <a:gd name="T42" fmla="*/ 373 w 511"/>
              <a:gd name="T43" fmla="*/ 152 h 221"/>
              <a:gd name="T44" fmla="*/ 511 w 511"/>
              <a:gd name="T45" fmla="*/ 124 h 221"/>
              <a:gd name="T46" fmla="*/ 511 w 511"/>
              <a:gd name="T47" fmla="*/ 111 h 221"/>
              <a:gd name="T48" fmla="*/ 503 w 511"/>
              <a:gd name="T49" fmla="*/ 117 h 221"/>
              <a:gd name="T50" fmla="*/ 487 w 511"/>
              <a:gd name="T51" fmla="*/ 105 h 221"/>
              <a:gd name="T52" fmla="*/ 450 w 511"/>
              <a:gd name="T53" fmla="*/ 98 h 221"/>
              <a:gd name="T54" fmla="*/ 443 w 511"/>
              <a:gd name="T55" fmla="*/ 87 h 221"/>
              <a:gd name="T56" fmla="*/ 366 w 511"/>
              <a:gd name="T57" fmla="*/ 169 h 221"/>
              <a:gd name="T58" fmla="*/ 365 w 511"/>
              <a:gd name="T59" fmla="*/ 205 h 221"/>
              <a:gd name="T60" fmla="*/ 343 w 511"/>
              <a:gd name="T61" fmla="*/ 203 h 221"/>
              <a:gd name="T62" fmla="*/ 343 w 511"/>
              <a:gd name="T63" fmla="*/ 156 h 221"/>
              <a:gd name="T64" fmla="*/ 318 w 511"/>
              <a:gd name="T65" fmla="*/ 133 h 221"/>
              <a:gd name="T66" fmla="*/ 294 w 511"/>
              <a:gd name="T67" fmla="*/ 133 h 221"/>
              <a:gd name="T68" fmla="*/ 332 w 511"/>
              <a:gd name="T69" fmla="*/ 98 h 221"/>
              <a:gd name="T70" fmla="*/ 271 w 511"/>
              <a:gd name="T71" fmla="*/ 103 h 221"/>
              <a:gd name="T72" fmla="*/ 249 w 511"/>
              <a:gd name="T73" fmla="*/ 94 h 221"/>
              <a:gd name="T74" fmla="*/ 286 w 511"/>
              <a:gd name="T75" fmla="*/ 132 h 221"/>
              <a:gd name="T76" fmla="*/ 261 w 511"/>
              <a:gd name="T77" fmla="*/ 119 h 221"/>
              <a:gd name="T78" fmla="*/ 311 w 511"/>
              <a:gd name="T79" fmla="*/ 215 h 221"/>
              <a:gd name="T80" fmla="*/ 272 w 511"/>
              <a:gd name="T81" fmla="*/ 203 h 221"/>
              <a:gd name="T82" fmla="*/ 280 w 511"/>
              <a:gd name="T83" fmla="*/ 184 h 221"/>
              <a:gd name="T84" fmla="*/ 309 w 511"/>
              <a:gd name="T85" fmla="*/ 203 h 221"/>
              <a:gd name="T86" fmla="*/ 296 w 511"/>
              <a:gd name="T87" fmla="*/ 201 h 221"/>
              <a:gd name="T88" fmla="*/ 318 w 511"/>
              <a:gd name="T89" fmla="*/ 215 h 221"/>
              <a:gd name="T90" fmla="*/ 208 w 511"/>
              <a:gd name="T91" fmla="*/ 215 h 221"/>
              <a:gd name="T92" fmla="*/ 174 w 511"/>
              <a:gd name="T93" fmla="*/ 153 h 221"/>
              <a:gd name="T94" fmla="*/ 342 w 511"/>
              <a:gd name="T95" fmla="*/ 130 h 221"/>
              <a:gd name="T96" fmla="*/ 370 w 511"/>
              <a:gd name="T97" fmla="*/ 90 h 221"/>
              <a:gd name="T98" fmla="*/ 374 w 511"/>
              <a:gd name="T99" fmla="*/ 98 h 221"/>
              <a:gd name="T100" fmla="*/ 354 w 511"/>
              <a:gd name="T101" fmla="*/ 122 h 221"/>
              <a:gd name="T102" fmla="*/ 342 w 511"/>
              <a:gd name="T103" fmla="*/ 130 h 221"/>
              <a:gd name="T104" fmla="*/ 352 w 511"/>
              <a:gd name="T105" fmla="*/ 103 h 221"/>
              <a:gd name="T106" fmla="*/ 351 w 511"/>
              <a:gd name="T107" fmla="*/ 133 h 221"/>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Lst>
            <a:rect l="0" t="0" r="r" b="b"/>
            <a:pathLst>
              <a:path w="511" h="221">
                <a:moveTo>
                  <a:pt x="188" y="44"/>
                </a:moveTo>
                <a:cubicBezTo>
                  <a:pt x="188" y="44"/>
                  <a:pt x="187" y="44"/>
                  <a:pt x="186" y="43"/>
                </a:cubicBezTo>
                <a:cubicBezTo>
                  <a:pt x="185" y="42"/>
                  <a:pt x="179" y="36"/>
                  <a:pt x="169" y="30"/>
                </a:cubicBezTo>
                <a:cubicBezTo>
                  <a:pt x="159" y="24"/>
                  <a:pt x="137" y="13"/>
                  <a:pt x="107" y="13"/>
                </a:cubicBezTo>
                <a:cubicBezTo>
                  <a:pt x="71" y="13"/>
                  <a:pt x="47" y="27"/>
                  <a:pt x="32" y="39"/>
                </a:cubicBezTo>
                <a:cubicBezTo>
                  <a:pt x="18" y="51"/>
                  <a:pt x="11" y="65"/>
                  <a:pt x="11" y="66"/>
                </a:cubicBezTo>
                <a:cubicBezTo>
                  <a:pt x="11" y="66"/>
                  <a:pt x="11" y="66"/>
                  <a:pt x="10" y="66"/>
                </a:cubicBezTo>
                <a:cubicBezTo>
                  <a:pt x="10" y="66"/>
                  <a:pt x="10" y="66"/>
                  <a:pt x="10" y="66"/>
                </a:cubicBezTo>
                <a:cubicBezTo>
                  <a:pt x="11" y="65"/>
                  <a:pt x="17" y="49"/>
                  <a:pt x="30" y="35"/>
                </a:cubicBezTo>
                <a:cubicBezTo>
                  <a:pt x="43" y="20"/>
                  <a:pt x="69" y="0"/>
                  <a:pt x="106" y="0"/>
                </a:cubicBezTo>
                <a:cubicBezTo>
                  <a:pt x="142" y="0"/>
                  <a:pt x="165" y="19"/>
                  <a:pt x="173" y="26"/>
                </a:cubicBezTo>
                <a:cubicBezTo>
                  <a:pt x="180" y="33"/>
                  <a:pt x="186" y="41"/>
                  <a:pt x="187" y="42"/>
                </a:cubicBezTo>
                <a:cubicBezTo>
                  <a:pt x="188" y="43"/>
                  <a:pt x="188" y="44"/>
                  <a:pt x="188" y="44"/>
                </a:cubicBezTo>
                <a:cubicBezTo>
                  <a:pt x="188" y="44"/>
                  <a:pt x="188" y="44"/>
                  <a:pt x="188" y="44"/>
                </a:cubicBezTo>
                <a:cubicBezTo>
                  <a:pt x="188" y="44"/>
                  <a:pt x="188" y="44"/>
                  <a:pt x="188" y="44"/>
                </a:cubicBezTo>
                <a:close/>
                <a:moveTo>
                  <a:pt x="1" y="101"/>
                </a:moveTo>
                <a:cubicBezTo>
                  <a:pt x="1" y="101"/>
                  <a:pt x="1" y="101"/>
                  <a:pt x="1" y="102"/>
                </a:cubicBezTo>
                <a:cubicBezTo>
                  <a:pt x="1" y="103"/>
                  <a:pt x="0" y="117"/>
                  <a:pt x="3" y="134"/>
                </a:cubicBezTo>
                <a:cubicBezTo>
                  <a:pt x="8" y="157"/>
                  <a:pt x="22" y="186"/>
                  <a:pt x="54" y="203"/>
                </a:cubicBezTo>
                <a:cubicBezTo>
                  <a:pt x="87" y="221"/>
                  <a:pt x="120" y="216"/>
                  <a:pt x="139" y="208"/>
                </a:cubicBezTo>
                <a:cubicBezTo>
                  <a:pt x="153" y="202"/>
                  <a:pt x="157" y="198"/>
                  <a:pt x="159" y="196"/>
                </a:cubicBezTo>
                <a:cubicBezTo>
                  <a:pt x="160" y="196"/>
                  <a:pt x="161" y="195"/>
                  <a:pt x="161" y="195"/>
                </a:cubicBezTo>
                <a:cubicBezTo>
                  <a:pt x="162" y="194"/>
                  <a:pt x="162" y="194"/>
                  <a:pt x="162" y="194"/>
                </a:cubicBezTo>
                <a:cubicBezTo>
                  <a:pt x="162" y="194"/>
                  <a:pt x="162" y="194"/>
                  <a:pt x="162" y="194"/>
                </a:cubicBezTo>
                <a:cubicBezTo>
                  <a:pt x="162" y="194"/>
                  <a:pt x="162" y="194"/>
                  <a:pt x="161" y="194"/>
                </a:cubicBezTo>
                <a:cubicBezTo>
                  <a:pt x="160" y="195"/>
                  <a:pt x="146" y="201"/>
                  <a:pt x="129" y="203"/>
                </a:cubicBezTo>
                <a:cubicBezTo>
                  <a:pt x="111" y="205"/>
                  <a:pt x="87" y="204"/>
                  <a:pt x="62" y="191"/>
                </a:cubicBezTo>
                <a:cubicBezTo>
                  <a:pt x="36" y="178"/>
                  <a:pt x="19" y="158"/>
                  <a:pt x="10" y="139"/>
                </a:cubicBezTo>
                <a:cubicBezTo>
                  <a:pt x="1" y="120"/>
                  <a:pt x="2" y="103"/>
                  <a:pt x="2" y="102"/>
                </a:cubicBezTo>
                <a:cubicBezTo>
                  <a:pt x="2" y="101"/>
                  <a:pt x="2" y="101"/>
                  <a:pt x="2" y="101"/>
                </a:cubicBezTo>
                <a:cubicBezTo>
                  <a:pt x="2" y="101"/>
                  <a:pt x="2" y="101"/>
                  <a:pt x="2" y="101"/>
                </a:cubicBezTo>
                <a:cubicBezTo>
                  <a:pt x="2" y="101"/>
                  <a:pt x="1" y="101"/>
                  <a:pt x="1" y="101"/>
                </a:cubicBezTo>
                <a:close/>
                <a:moveTo>
                  <a:pt x="108" y="133"/>
                </a:moveTo>
                <a:cubicBezTo>
                  <a:pt x="108" y="108"/>
                  <a:pt x="108" y="108"/>
                  <a:pt x="108" y="108"/>
                </a:cubicBezTo>
                <a:cubicBezTo>
                  <a:pt x="91" y="70"/>
                  <a:pt x="91" y="70"/>
                  <a:pt x="91" y="70"/>
                </a:cubicBezTo>
                <a:cubicBezTo>
                  <a:pt x="105" y="70"/>
                  <a:pt x="105" y="70"/>
                  <a:pt x="105" y="70"/>
                </a:cubicBezTo>
                <a:cubicBezTo>
                  <a:pt x="116" y="95"/>
                  <a:pt x="116" y="95"/>
                  <a:pt x="116" y="95"/>
                </a:cubicBezTo>
                <a:cubicBezTo>
                  <a:pt x="127" y="70"/>
                  <a:pt x="127" y="70"/>
                  <a:pt x="127" y="70"/>
                </a:cubicBezTo>
                <a:cubicBezTo>
                  <a:pt x="140" y="70"/>
                  <a:pt x="140" y="70"/>
                  <a:pt x="140" y="70"/>
                </a:cubicBezTo>
                <a:cubicBezTo>
                  <a:pt x="123" y="108"/>
                  <a:pt x="123" y="108"/>
                  <a:pt x="123" y="108"/>
                </a:cubicBezTo>
                <a:cubicBezTo>
                  <a:pt x="123" y="133"/>
                  <a:pt x="123" y="133"/>
                  <a:pt x="123" y="133"/>
                </a:cubicBezTo>
                <a:lnTo>
                  <a:pt x="108" y="133"/>
                </a:lnTo>
                <a:close/>
                <a:moveTo>
                  <a:pt x="241" y="133"/>
                </a:moveTo>
                <a:cubicBezTo>
                  <a:pt x="208" y="133"/>
                  <a:pt x="208" y="133"/>
                  <a:pt x="208" y="133"/>
                </a:cubicBezTo>
                <a:cubicBezTo>
                  <a:pt x="208" y="70"/>
                  <a:pt x="208" y="70"/>
                  <a:pt x="208" y="70"/>
                </a:cubicBezTo>
                <a:cubicBezTo>
                  <a:pt x="222" y="70"/>
                  <a:pt x="222" y="70"/>
                  <a:pt x="222" y="70"/>
                </a:cubicBezTo>
                <a:cubicBezTo>
                  <a:pt x="222" y="121"/>
                  <a:pt x="222" y="121"/>
                  <a:pt x="222" y="121"/>
                </a:cubicBezTo>
                <a:cubicBezTo>
                  <a:pt x="241" y="121"/>
                  <a:pt x="241" y="121"/>
                  <a:pt x="241" y="121"/>
                </a:cubicBezTo>
                <a:lnTo>
                  <a:pt x="241" y="133"/>
                </a:lnTo>
                <a:close/>
                <a:moveTo>
                  <a:pt x="73" y="70"/>
                </a:moveTo>
                <a:cubicBezTo>
                  <a:pt x="86" y="70"/>
                  <a:pt x="86" y="70"/>
                  <a:pt x="86" y="70"/>
                </a:cubicBezTo>
                <a:cubicBezTo>
                  <a:pt x="86" y="133"/>
                  <a:pt x="86" y="133"/>
                  <a:pt x="86" y="133"/>
                </a:cubicBezTo>
                <a:cubicBezTo>
                  <a:pt x="73" y="133"/>
                  <a:pt x="73" y="133"/>
                  <a:pt x="73" y="133"/>
                </a:cubicBezTo>
                <a:cubicBezTo>
                  <a:pt x="73" y="133"/>
                  <a:pt x="73" y="133"/>
                  <a:pt x="73" y="133"/>
                </a:cubicBezTo>
                <a:cubicBezTo>
                  <a:pt x="73" y="131"/>
                  <a:pt x="57" y="104"/>
                  <a:pt x="53" y="96"/>
                </a:cubicBezTo>
                <a:cubicBezTo>
                  <a:pt x="53" y="133"/>
                  <a:pt x="53" y="133"/>
                  <a:pt x="53" y="133"/>
                </a:cubicBezTo>
                <a:cubicBezTo>
                  <a:pt x="40" y="133"/>
                  <a:pt x="40" y="133"/>
                  <a:pt x="40" y="133"/>
                </a:cubicBezTo>
                <a:cubicBezTo>
                  <a:pt x="40" y="70"/>
                  <a:pt x="40" y="70"/>
                  <a:pt x="40" y="70"/>
                </a:cubicBezTo>
                <a:cubicBezTo>
                  <a:pt x="54" y="70"/>
                  <a:pt x="54" y="70"/>
                  <a:pt x="54" y="70"/>
                </a:cubicBezTo>
                <a:cubicBezTo>
                  <a:pt x="54" y="70"/>
                  <a:pt x="54" y="70"/>
                  <a:pt x="54" y="70"/>
                </a:cubicBezTo>
                <a:cubicBezTo>
                  <a:pt x="55" y="71"/>
                  <a:pt x="69" y="97"/>
                  <a:pt x="73" y="106"/>
                </a:cubicBezTo>
                <a:lnTo>
                  <a:pt x="73" y="70"/>
                </a:lnTo>
                <a:close/>
                <a:moveTo>
                  <a:pt x="166" y="134"/>
                </a:moveTo>
                <a:cubicBezTo>
                  <a:pt x="152" y="134"/>
                  <a:pt x="144" y="126"/>
                  <a:pt x="144" y="111"/>
                </a:cubicBezTo>
                <a:cubicBezTo>
                  <a:pt x="144" y="70"/>
                  <a:pt x="144" y="70"/>
                  <a:pt x="144" y="70"/>
                </a:cubicBezTo>
                <a:cubicBezTo>
                  <a:pt x="158" y="70"/>
                  <a:pt x="158" y="70"/>
                  <a:pt x="158" y="70"/>
                </a:cubicBezTo>
                <a:cubicBezTo>
                  <a:pt x="158" y="110"/>
                  <a:pt x="158" y="110"/>
                  <a:pt x="158" y="110"/>
                </a:cubicBezTo>
                <a:cubicBezTo>
                  <a:pt x="158" y="119"/>
                  <a:pt x="161" y="122"/>
                  <a:pt x="167" y="122"/>
                </a:cubicBezTo>
                <a:cubicBezTo>
                  <a:pt x="172" y="122"/>
                  <a:pt x="175" y="118"/>
                  <a:pt x="175" y="110"/>
                </a:cubicBezTo>
                <a:cubicBezTo>
                  <a:pt x="175" y="70"/>
                  <a:pt x="175" y="70"/>
                  <a:pt x="175" y="70"/>
                </a:cubicBezTo>
                <a:cubicBezTo>
                  <a:pt x="188" y="70"/>
                  <a:pt x="188" y="70"/>
                  <a:pt x="188" y="70"/>
                </a:cubicBezTo>
                <a:cubicBezTo>
                  <a:pt x="188" y="111"/>
                  <a:pt x="188" y="111"/>
                  <a:pt x="188" y="111"/>
                </a:cubicBezTo>
                <a:cubicBezTo>
                  <a:pt x="188" y="126"/>
                  <a:pt x="181" y="134"/>
                  <a:pt x="166" y="134"/>
                </a:cubicBezTo>
                <a:close/>
                <a:moveTo>
                  <a:pt x="259" y="199"/>
                </a:moveTo>
                <a:cubicBezTo>
                  <a:pt x="267" y="206"/>
                  <a:pt x="267" y="206"/>
                  <a:pt x="267" y="206"/>
                </a:cubicBezTo>
                <a:cubicBezTo>
                  <a:pt x="267" y="206"/>
                  <a:pt x="267" y="206"/>
                  <a:pt x="267" y="206"/>
                </a:cubicBezTo>
                <a:cubicBezTo>
                  <a:pt x="263" y="213"/>
                  <a:pt x="257" y="216"/>
                  <a:pt x="249" y="216"/>
                </a:cubicBezTo>
                <a:cubicBezTo>
                  <a:pt x="236" y="216"/>
                  <a:pt x="229" y="207"/>
                  <a:pt x="229" y="192"/>
                </a:cubicBezTo>
                <a:cubicBezTo>
                  <a:pt x="229" y="174"/>
                  <a:pt x="239" y="168"/>
                  <a:pt x="249" y="168"/>
                </a:cubicBezTo>
                <a:cubicBezTo>
                  <a:pt x="261" y="168"/>
                  <a:pt x="267" y="177"/>
                  <a:pt x="267" y="193"/>
                </a:cubicBezTo>
                <a:cubicBezTo>
                  <a:pt x="267" y="196"/>
                  <a:pt x="267" y="196"/>
                  <a:pt x="267" y="196"/>
                </a:cubicBezTo>
                <a:cubicBezTo>
                  <a:pt x="242" y="196"/>
                  <a:pt x="242" y="196"/>
                  <a:pt x="242" y="196"/>
                </a:cubicBezTo>
                <a:cubicBezTo>
                  <a:pt x="243" y="202"/>
                  <a:pt x="245" y="205"/>
                  <a:pt x="250" y="205"/>
                </a:cubicBezTo>
                <a:cubicBezTo>
                  <a:pt x="254" y="205"/>
                  <a:pt x="257" y="202"/>
                  <a:pt x="259" y="200"/>
                </a:cubicBezTo>
                <a:lnTo>
                  <a:pt x="259" y="199"/>
                </a:lnTo>
                <a:close/>
                <a:moveTo>
                  <a:pt x="242" y="187"/>
                </a:moveTo>
                <a:cubicBezTo>
                  <a:pt x="255" y="187"/>
                  <a:pt x="255" y="187"/>
                  <a:pt x="255" y="187"/>
                </a:cubicBezTo>
                <a:cubicBezTo>
                  <a:pt x="254" y="179"/>
                  <a:pt x="250" y="179"/>
                  <a:pt x="249" y="179"/>
                </a:cubicBezTo>
                <a:cubicBezTo>
                  <a:pt x="245" y="179"/>
                  <a:pt x="243" y="182"/>
                  <a:pt x="242" y="187"/>
                </a:cubicBezTo>
                <a:close/>
                <a:moveTo>
                  <a:pt x="416" y="92"/>
                </a:moveTo>
                <a:cubicBezTo>
                  <a:pt x="420" y="96"/>
                  <a:pt x="422" y="102"/>
                  <a:pt x="422" y="110"/>
                </a:cubicBezTo>
                <a:cubicBezTo>
                  <a:pt x="422" y="128"/>
                  <a:pt x="412" y="134"/>
                  <a:pt x="402" y="134"/>
                </a:cubicBezTo>
                <a:cubicBezTo>
                  <a:pt x="392" y="134"/>
                  <a:pt x="382" y="128"/>
                  <a:pt x="382" y="110"/>
                </a:cubicBezTo>
                <a:cubicBezTo>
                  <a:pt x="382" y="102"/>
                  <a:pt x="384" y="96"/>
                  <a:pt x="388" y="92"/>
                </a:cubicBezTo>
                <a:cubicBezTo>
                  <a:pt x="392" y="88"/>
                  <a:pt x="396" y="86"/>
                  <a:pt x="402" y="86"/>
                </a:cubicBezTo>
                <a:cubicBezTo>
                  <a:pt x="408" y="86"/>
                  <a:pt x="413" y="88"/>
                  <a:pt x="416" y="92"/>
                </a:cubicBezTo>
                <a:close/>
                <a:moveTo>
                  <a:pt x="409" y="110"/>
                </a:moveTo>
                <a:cubicBezTo>
                  <a:pt x="409" y="99"/>
                  <a:pt x="405" y="97"/>
                  <a:pt x="402" y="97"/>
                </a:cubicBezTo>
                <a:cubicBezTo>
                  <a:pt x="398" y="97"/>
                  <a:pt x="396" y="101"/>
                  <a:pt x="396" y="110"/>
                </a:cubicBezTo>
                <a:cubicBezTo>
                  <a:pt x="396" y="122"/>
                  <a:pt x="399" y="123"/>
                  <a:pt x="402" y="123"/>
                </a:cubicBezTo>
                <a:cubicBezTo>
                  <a:pt x="407" y="123"/>
                  <a:pt x="409" y="119"/>
                  <a:pt x="409" y="110"/>
                </a:cubicBezTo>
                <a:close/>
                <a:moveTo>
                  <a:pt x="410" y="180"/>
                </a:moveTo>
                <a:cubicBezTo>
                  <a:pt x="410" y="215"/>
                  <a:pt x="410" y="215"/>
                  <a:pt x="410" y="215"/>
                </a:cubicBezTo>
                <a:cubicBezTo>
                  <a:pt x="397" y="215"/>
                  <a:pt x="397" y="215"/>
                  <a:pt x="397" y="215"/>
                </a:cubicBezTo>
                <a:cubicBezTo>
                  <a:pt x="397" y="184"/>
                  <a:pt x="397" y="184"/>
                  <a:pt x="397" y="184"/>
                </a:cubicBezTo>
                <a:cubicBezTo>
                  <a:pt x="397" y="180"/>
                  <a:pt x="395" y="180"/>
                  <a:pt x="393" y="180"/>
                </a:cubicBezTo>
                <a:cubicBezTo>
                  <a:pt x="391" y="180"/>
                  <a:pt x="389" y="181"/>
                  <a:pt x="386" y="183"/>
                </a:cubicBezTo>
                <a:cubicBezTo>
                  <a:pt x="386" y="215"/>
                  <a:pt x="386" y="215"/>
                  <a:pt x="386" y="215"/>
                </a:cubicBezTo>
                <a:cubicBezTo>
                  <a:pt x="373" y="215"/>
                  <a:pt x="373" y="215"/>
                  <a:pt x="373" y="215"/>
                </a:cubicBezTo>
                <a:cubicBezTo>
                  <a:pt x="373" y="152"/>
                  <a:pt x="373" y="152"/>
                  <a:pt x="373" y="152"/>
                </a:cubicBezTo>
                <a:cubicBezTo>
                  <a:pt x="386" y="150"/>
                  <a:pt x="386" y="150"/>
                  <a:pt x="386" y="150"/>
                </a:cubicBezTo>
                <a:cubicBezTo>
                  <a:pt x="386" y="174"/>
                  <a:pt x="386" y="174"/>
                  <a:pt x="386" y="174"/>
                </a:cubicBezTo>
                <a:cubicBezTo>
                  <a:pt x="389" y="171"/>
                  <a:pt x="393" y="168"/>
                  <a:pt x="399" y="168"/>
                </a:cubicBezTo>
                <a:cubicBezTo>
                  <a:pt x="406" y="168"/>
                  <a:pt x="410" y="172"/>
                  <a:pt x="410" y="180"/>
                </a:cubicBezTo>
                <a:close/>
                <a:moveTo>
                  <a:pt x="511" y="124"/>
                </a:moveTo>
                <a:cubicBezTo>
                  <a:pt x="511" y="124"/>
                  <a:pt x="511" y="124"/>
                  <a:pt x="511" y="124"/>
                </a:cubicBezTo>
                <a:cubicBezTo>
                  <a:pt x="507" y="131"/>
                  <a:pt x="501" y="134"/>
                  <a:pt x="493" y="134"/>
                </a:cubicBezTo>
                <a:cubicBezTo>
                  <a:pt x="480" y="134"/>
                  <a:pt x="473" y="125"/>
                  <a:pt x="473" y="110"/>
                </a:cubicBezTo>
                <a:cubicBezTo>
                  <a:pt x="473" y="92"/>
                  <a:pt x="484" y="86"/>
                  <a:pt x="493" y="86"/>
                </a:cubicBezTo>
                <a:cubicBezTo>
                  <a:pt x="505" y="86"/>
                  <a:pt x="511" y="95"/>
                  <a:pt x="511" y="111"/>
                </a:cubicBezTo>
                <a:cubicBezTo>
                  <a:pt x="511" y="114"/>
                  <a:pt x="511" y="114"/>
                  <a:pt x="511" y="114"/>
                </a:cubicBezTo>
                <a:cubicBezTo>
                  <a:pt x="486" y="114"/>
                  <a:pt x="486" y="114"/>
                  <a:pt x="486" y="114"/>
                </a:cubicBezTo>
                <a:cubicBezTo>
                  <a:pt x="487" y="120"/>
                  <a:pt x="489" y="123"/>
                  <a:pt x="494" y="123"/>
                </a:cubicBezTo>
                <a:cubicBezTo>
                  <a:pt x="498" y="123"/>
                  <a:pt x="501" y="120"/>
                  <a:pt x="503" y="118"/>
                </a:cubicBezTo>
                <a:cubicBezTo>
                  <a:pt x="503" y="117"/>
                  <a:pt x="503" y="117"/>
                  <a:pt x="503" y="117"/>
                </a:cubicBezTo>
                <a:lnTo>
                  <a:pt x="511" y="124"/>
                </a:lnTo>
                <a:close/>
                <a:moveTo>
                  <a:pt x="487" y="105"/>
                </a:moveTo>
                <a:cubicBezTo>
                  <a:pt x="499" y="105"/>
                  <a:pt x="499" y="105"/>
                  <a:pt x="499" y="105"/>
                </a:cubicBezTo>
                <a:cubicBezTo>
                  <a:pt x="498" y="97"/>
                  <a:pt x="494" y="97"/>
                  <a:pt x="493" y="97"/>
                </a:cubicBezTo>
                <a:cubicBezTo>
                  <a:pt x="489" y="97"/>
                  <a:pt x="487" y="100"/>
                  <a:pt x="487" y="105"/>
                </a:cubicBezTo>
                <a:close/>
                <a:moveTo>
                  <a:pt x="467" y="98"/>
                </a:moveTo>
                <a:cubicBezTo>
                  <a:pt x="467" y="133"/>
                  <a:pt x="467" y="133"/>
                  <a:pt x="467" y="133"/>
                </a:cubicBezTo>
                <a:cubicBezTo>
                  <a:pt x="453" y="133"/>
                  <a:pt x="453" y="133"/>
                  <a:pt x="453" y="133"/>
                </a:cubicBezTo>
                <a:cubicBezTo>
                  <a:pt x="453" y="102"/>
                  <a:pt x="453" y="102"/>
                  <a:pt x="453" y="102"/>
                </a:cubicBezTo>
                <a:cubicBezTo>
                  <a:pt x="453" y="98"/>
                  <a:pt x="452" y="98"/>
                  <a:pt x="450" y="98"/>
                </a:cubicBezTo>
                <a:cubicBezTo>
                  <a:pt x="448" y="98"/>
                  <a:pt x="445" y="99"/>
                  <a:pt x="443" y="102"/>
                </a:cubicBezTo>
                <a:cubicBezTo>
                  <a:pt x="443" y="133"/>
                  <a:pt x="443" y="133"/>
                  <a:pt x="443" y="133"/>
                </a:cubicBezTo>
                <a:cubicBezTo>
                  <a:pt x="429" y="133"/>
                  <a:pt x="429" y="133"/>
                  <a:pt x="429" y="133"/>
                </a:cubicBezTo>
                <a:cubicBezTo>
                  <a:pt x="429" y="87"/>
                  <a:pt x="429" y="87"/>
                  <a:pt x="429" y="87"/>
                </a:cubicBezTo>
                <a:cubicBezTo>
                  <a:pt x="443" y="87"/>
                  <a:pt x="443" y="87"/>
                  <a:pt x="443" y="87"/>
                </a:cubicBezTo>
                <a:cubicBezTo>
                  <a:pt x="443" y="92"/>
                  <a:pt x="443" y="92"/>
                  <a:pt x="443" y="92"/>
                </a:cubicBezTo>
                <a:cubicBezTo>
                  <a:pt x="445" y="89"/>
                  <a:pt x="450" y="86"/>
                  <a:pt x="455" y="86"/>
                </a:cubicBezTo>
                <a:cubicBezTo>
                  <a:pt x="463" y="86"/>
                  <a:pt x="467" y="90"/>
                  <a:pt x="467" y="98"/>
                </a:cubicBezTo>
                <a:close/>
                <a:moveTo>
                  <a:pt x="357" y="169"/>
                </a:moveTo>
                <a:cubicBezTo>
                  <a:pt x="366" y="169"/>
                  <a:pt x="366" y="169"/>
                  <a:pt x="366" y="169"/>
                </a:cubicBezTo>
                <a:cubicBezTo>
                  <a:pt x="366" y="179"/>
                  <a:pt x="366" y="179"/>
                  <a:pt x="366" y="179"/>
                </a:cubicBezTo>
                <a:cubicBezTo>
                  <a:pt x="357" y="179"/>
                  <a:pt x="357" y="179"/>
                  <a:pt x="357" y="179"/>
                </a:cubicBezTo>
                <a:cubicBezTo>
                  <a:pt x="357" y="200"/>
                  <a:pt x="357" y="200"/>
                  <a:pt x="357" y="200"/>
                </a:cubicBezTo>
                <a:cubicBezTo>
                  <a:pt x="357" y="204"/>
                  <a:pt x="358" y="205"/>
                  <a:pt x="361" y="205"/>
                </a:cubicBezTo>
                <a:cubicBezTo>
                  <a:pt x="363" y="205"/>
                  <a:pt x="364" y="205"/>
                  <a:pt x="365" y="205"/>
                </a:cubicBezTo>
                <a:cubicBezTo>
                  <a:pt x="366" y="204"/>
                  <a:pt x="366" y="204"/>
                  <a:pt x="366" y="204"/>
                </a:cubicBezTo>
                <a:cubicBezTo>
                  <a:pt x="366" y="215"/>
                  <a:pt x="366" y="215"/>
                  <a:pt x="366" y="215"/>
                </a:cubicBezTo>
                <a:cubicBezTo>
                  <a:pt x="365" y="215"/>
                  <a:pt x="365" y="215"/>
                  <a:pt x="365" y="215"/>
                </a:cubicBezTo>
                <a:cubicBezTo>
                  <a:pt x="364" y="215"/>
                  <a:pt x="360" y="215"/>
                  <a:pt x="357" y="215"/>
                </a:cubicBezTo>
                <a:cubicBezTo>
                  <a:pt x="347" y="215"/>
                  <a:pt x="343" y="212"/>
                  <a:pt x="343" y="203"/>
                </a:cubicBezTo>
                <a:cubicBezTo>
                  <a:pt x="343" y="179"/>
                  <a:pt x="343" y="179"/>
                  <a:pt x="343" y="179"/>
                </a:cubicBezTo>
                <a:cubicBezTo>
                  <a:pt x="337" y="179"/>
                  <a:pt x="337" y="179"/>
                  <a:pt x="337" y="179"/>
                </a:cubicBezTo>
                <a:cubicBezTo>
                  <a:pt x="337" y="169"/>
                  <a:pt x="337" y="169"/>
                  <a:pt x="337" y="169"/>
                </a:cubicBezTo>
                <a:cubicBezTo>
                  <a:pt x="343" y="169"/>
                  <a:pt x="343" y="169"/>
                  <a:pt x="343" y="169"/>
                </a:cubicBezTo>
                <a:cubicBezTo>
                  <a:pt x="343" y="156"/>
                  <a:pt x="343" y="156"/>
                  <a:pt x="343" y="156"/>
                </a:cubicBezTo>
                <a:cubicBezTo>
                  <a:pt x="357" y="154"/>
                  <a:pt x="357" y="154"/>
                  <a:pt x="357" y="154"/>
                </a:cubicBezTo>
                <a:lnTo>
                  <a:pt x="357" y="169"/>
                </a:lnTo>
                <a:close/>
                <a:moveTo>
                  <a:pt x="332" y="98"/>
                </a:moveTo>
                <a:cubicBezTo>
                  <a:pt x="332" y="133"/>
                  <a:pt x="332" y="133"/>
                  <a:pt x="332" y="133"/>
                </a:cubicBezTo>
                <a:cubicBezTo>
                  <a:pt x="318" y="133"/>
                  <a:pt x="318" y="133"/>
                  <a:pt x="318" y="133"/>
                </a:cubicBezTo>
                <a:cubicBezTo>
                  <a:pt x="318" y="102"/>
                  <a:pt x="318" y="102"/>
                  <a:pt x="318" y="102"/>
                </a:cubicBezTo>
                <a:cubicBezTo>
                  <a:pt x="318" y="98"/>
                  <a:pt x="316" y="98"/>
                  <a:pt x="315" y="98"/>
                </a:cubicBezTo>
                <a:cubicBezTo>
                  <a:pt x="313" y="98"/>
                  <a:pt x="310" y="99"/>
                  <a:pt x="307" y="102"/>
                </a:cubicBezTo>
                <a:cubicBezTo>
                  <a:pt x="307" y="133"/>
                  <a:pt x="307" y="133"/>
                  <a:pt x="307" y="133"/>
                </a:cubicBezTo>
                <a:cubicBezTo>
                  <a:pt x="294" y="133"/>
                  <a:pt x="294" y="133"/>
                  <a:pt x="294" y="133"/>
                </a:cubicBezTo>
                <a:cubicBezTo>
                  <a:pt x="294" y="87"/>
                  <a:pt x="294" y="87"/>
                  <a:pt x="294" y="87"/>
                </a:cubicBezTo>
                <a:cubicBezTo>
                  <a:pt x="307" y="87"/>
                  <a:pt x="307" y="87"/>
                  <a:pt x="307" y="87"/>
                </a:cubicBezTo>
                <a:cubicBezTo>
                  <a:pt x="307" y="92"/>
                  <a:pt x="307" y="92"/>
                  <a:pt x="307" y="92"/>
                </a:cubicBezTo>
                <a:cubicBezTo>
                  <a:pt x="310" y="89"/>
                  <a:pt x="315" y="86"/>
                  <a:pt x="320" y="86"/>
                </a:cubicBezTo>
                <a:cubicBezTo>
                  <a:pt x="328" y="86"/>
                  <a:pt x="332" y="90"/>
                  <a:pt x="332" y="98"/>
                </a:cubicBezTo>
                <a:close/>
                <a:moveTo>
                  <a:pt x="272" y="132"/>
                </a:moveTo>
                <a:cubicBezTo>
                  <a:pt x="272" y="131"/>
                  <a:pt x="271" y="130"/>
                  <a:pt x="271" y="128"/>
                </a:cubicBezTo>
                <a:cubicBezTo>
                  <a:pt x="268" y="132"/>
                  <a:pt x="264" y="133"/>
                  <a:pt x="259" y="133"/>
                </a:cubicBezTo>
                <a:cubicBezTo>
                  <a:pt x="251" y="133"/>
                  <a:pt x="247" y="129"/>
                  <a:pt x="247" y="121"/>
                </a:cubicBezTo>
                <a:cubicBezTo>
                  <a:pt x="247" y="112"/>
                  <a:pt x="255" y="106"/>
                  <a:pt x="271" y="103"/>
                </a:cubicBezTo>
                <a:cubicBezTo>
                  <a:pt x="271" y="102"/>
                  <a:pt x="271" y="102"/>
                  <a:pt x="271" y="102"/>
                </a:cubicBezTo>
                <a:cubicBezTo>
                  <a:pt x="271" y="98"/>
                  <a:pt x="270" y="97"/>
                  <a:pt x="267" y="97"/>
                </a:cubicBezTo>
                <a:cubicBezTo>
                  <a:pt x="263" y="97"/>
                  <a:pt x="258" y="100"/>
                  <a:pt x="256" y="102"/>
                </a:cubicBezTo>
                <a:cubicBezTo>
                  <a:pt x="255" y="102"/>
                  <a:pt x="255" y="102"/>
                  <a:pt x="255" y="102"/>
                </a:cubicBezTo>
                <a:cubicBezTo>
                  <a:pt x="249" y="94"/>
                  <a:pt x="249" y="94"/>
                  <a:pt x="249" y="94"/>
                </a:cubicBezTo>
                <a:cubicBezTo>
                  <a:pt x="249" y="93"/>
                  <a:pt x="249" y="93"/>
                  <a:pt x="249" y="93"/>
                </a:cubicBezTo>
                <a:cubicBezTo>
                  <a:pt x="255" y="89"/>
                  <a:pt x="262" y="86"/>
                  <a:pt x="270" y="86"/>
                </a:cubicBezTo>
                <a:cubicBezTo>
                  <a:pt x="280" y="86"/>
                  <a:pt x="285" y="91"/>
                  <a:pt x="285" y="102"/>
                </a:cubicBezTo>
                <a:cubicBezTo>
                  <a:pt x="285" y="121"/>
                  <a:pt x="285" y="121"/>
                  <a:pt x="285" y="121"/>
                </a:cubicBezTo>
                <a:cubicBezTo>
                  <a:pt x="285" y="127"/>
                  <a:pt x="285" y="130"/>
                  <a:pt x="286" y="132"/>
                </a:cubicBezTo>
                <a:cubicBezTo>
                  <a:pt x="286" y="133"/>
                  <a:pt x="286" y="133"/>
                  <a:pt x="286" y="133"/>
                </a:cubicBezTo>
                <a:cubicBezTo>
                  <a:pt x="272" y="133"/>
                  <a:pt x="272" y="133"/>
                  <a:pt x="272" y="133"/>
                </a:cubicBezTo>
                <a:lnTo>
                  <a:pt x="272" y="132"/>
                </a:lnTo>
                <a:close/>
                <a:moveTo>
                  <a:pt x="271" y="111"/>
                </a:moveTo>
                <a:cubicBezTo>
                  <a:pt x="262" y="113"/>
                  <a:pt x="261" y="116"/>
                  <a:pt x="261" y="119"/>
                </a:cubicBezTo>
                <a:cubicBezTo>
                  <a:pt x="261" y="121"/>
                  <a:pt x="262" y="123"/>
                  <a:pt x="264" y="123"/>
                </a:cubicBezTo>
                <a:cubicBezTo>
                  <a:pt x="267" y="123"/>
                  <a:pt x="269" y="122"/>
                  <a:pt x="271" y="120"/>
                </a:cubicBezTo>
                <a:lnTo>
                  <a:pt x="271" y="111"/>
                </a:lnTo>
                <a:close/>
                <a:moveTo>
                  <a:pt x="310" y="214"/>
                </a:moveTo>
                <a:cubicBezTo>
                  <a:pt x="311" y="215"/>
                  <a:pt x="311" y="215"/>
                  <a:pt x="311" y="215"/>
                </a:cubicBezTo>
                <a:cubicBezTo>
                  <a:pt x="297" y="215"/>
                  <a:pt x="297" y="215"/>
                  <a:pt x="297" y="215"/>
                </a:cubicBezTo>
                <a:cubicBezTo>
                  <a:pt x="297" y="214"/>
                  <a:pt x="297" y="214"/>
                  <a:pt x="297" y="214"/>
                </a:cubicBezTo>
                <a:cubicBezTo>
                  <a:pt x="296" y="213"/>
                  <a:pt x="296" y="212"/>
                  <a:pt x="296" y="210"/>
                </a:cubicBezTo>
                <a:cubicBezTo>
                  <a:pt x="293" y="214"/>
                  <a:pt x="289" y="215"/>
                  <a:pt x="283" y="215"/>
                </a:cubicBezTo>
                <a:cubicBezTo>
                  <a:pt x="276" y="215"/>
                  <a:pt x="272" y="211"/>
                  <a:pt x="272" y="203"/>
                </a:cubicBezTo>
                <a:cubicBezTo>
                  <a:pt x="272" y="194"/>
                  <a:pt x="280" y="188"/>
                  <a:pt x="296" y="185"/>
                </a:cubicBezTo>
                <a:cubicBezTo>
                  <a:pt x="296" y="183"/>
                  <a:pt x="296" y="183"/>
                  <a:pt x="296" y="183"/>
                </a:cubicBezTo>
                <a:cubicBezTo>
                  <a:pt x="296" y="180"/>
                  <a:pt x="295" y="179"/>
                  <a:pt x="292" y="179"/>
                </a:cubicBezTo>
                <a:cubicBezTo>
                  <a:pt x="287" y="179"/>
                  <a:pt x="283" y="182"/>
                  <a:pt x="280" y="184"/>
                </a:cubicBezTo>
                <a:cubicBezTo>
                  <a:pt x="280" y="184"/>
                  <a:pt x="280" y="184"/>
                  <a:pt x="280" y="184"/>
                </a:cubicBezTo>
                <a:cubicBezTo>
                  <a:pt x="273" y="176"/>
                  <a:pt x="273" y="176"/>
                  <a:pt x="273" y="176"/>
                </a:cubicBezTo>
                <a:cubicBezTo>
                  <a:pt x="274" y="175"/>
                  <a:pt x="274" y="175"/>
                  <a:pt x="274" y="175"/>
                </a:cubicBezTo>
                <a:cubicBezTo>
                  <a:pt x="279" y="171"/>
                  <a:pt x="286" y="168"/>
                  <a:pt x="294" y="168"/>
                </a:cubicBezTo>
                <a:cubicBezTo>
                  <a:pt x="305" y="168"/>
                  <a:pt x="309" y="173"/>
                  <a:pt x="309" y="183"/>
                </a:cubicBezTo>
                <a:cubicBezTo>
                  <a:pt x="309" y="203"/>
                  <a:pt x="309" y="203"/>
                  <a:pt x="309" y="203"/>
                </a:cubicBezTo>
                <a:cubicBezTo>
                  <a:pt x="309" y="209"/>
                  <a:pt x="310" y="212"/>
                  <a:pt x="310" y="214"/>
                </a:cubicBezTo>
                <a:close/>
                <a:moveTo>
                  <a:pt x="296" y="193"/>
                </a:moveTo>
                <a:cubicBezTo>
                  <a:pt x="286" y="195"/>
                  <a:pt x="285" y="198"/>
                  <a:pt x="285" y="201"/>
                </a:cubicBezTo>
                <a:cubicBezTo>
                  <a:pt x="285" y="203"/>
                  <a:pt x="286" y="205"/>
                  <a:pt x="289" y="205"/>
                </a:cubicBezTo>
                <a:cubicBezTo>
                  <a:pt x="291" y="205"/>
                  <a:pt x="294" y="204"/>
                  <a:pt x="296" y="201"/>
                </a:cubicBezTo>
                <a:lnTo>
                  <a:pt x="296" y="193"/>
                </a:lnTo>
                <a:close/>
                <a:moveTo>
                  <a:pt x="318" y="159"/>
                </a:moveTo>
                <a:cubicBezTo>
                  <a:pt x="332" y="157"/>
                  <a:pt x="332" y="157"/>
                  <a:pt x="332" y="157"/>
                </a:cubicBezTo>
                <a:cubicBezTo>
                  <a:pt x="332" y="215"/>
                  <a:pt x="332" y="215"/>
                  <a:pt x="332" y="215"/>
                </a:cubicBezTo>
                <a:cubicBezTo>
                  <a:pt x="318" y="215"/>
                  <a:pt x="318" y="215"/>
                  <a:pt x="318" y="215"/>
                </a:cubicBezTo>
                <a:lnTo>
                  <a:pt x="318" y="159"/>
                </a:lnTo>
                <a:close/>
                <a:moveTo>
                  <a:pt x="208" y="153"/>
                </a:moveTo>
                <a:cubicBezTo>
                  <a:pt x="222" y="153"/>
                  <a:pt x="222" y="153"/>
                  <a:pt x="222" y="153"/>
                </a:cubicBezTo>
                <a:cubicBezTo>
                  <a:pt x="222" y="215"/>
                  <a:pt x="222" y="215"/>
                  <a:pt x="222" y="215"/>
                </a:cubicBezTo>
                <a:cubicBezTo>
                  <a:pt x="208" y="215"/>
                  <a:pt x="208" y="215"/>
                  <a:pt x="208" y="215"/>
                </a:cubicBezTo>
                <a:cubicBezTo>
                  <a:pt x="208" y="188"/>
                  <a:pt x="208" y="188"/>
                  <a:pt x="208" y="188"/>
                </a:cubicBezTo>
                <a:cubicBezTo>
                  <a:pt x="188" y="188"/>
                  <a:pt x="188" y="188"/>
                  <a:pt x="188" y="188"/>
                </a:cubicBezTo>
                <a:cubicBezTo>
                  <a:pt x="188" y="215"/>
                  <a:pt x="188" y="215"/>
                  <a:pt x="188" y="215"/>
                </a:cubicBezTo>
                <a:cubicBezTo>
                  <a:pt x="174" y="215"/>
                  <a:pt x="174" y="215"/>
                  <a:pt x="174" y="215"/>
                </a:cubicBezTo>
                <a:cubicBezTo>
                  <a:pt x="174" y="153"/>
                  <a:pt x="174" y="153"/>
                  <a:pt x="174" y="153"/>
                </a:cubicBezTo>
                <a:cubicBezTo>
                  <a:pt x="188" y="153"/>
                  <a:pt x="188" y="153"/>
                  <a:pt x="188" y="153"/>
                </a:cubicBezTo>
                <a:cubicBezTo>
                  <a:pt x="188" y="176"/>
                  <a:pt x="188" y="176"/>
                  <a:pt x="188" y="176"/>
                </a:cubicBezTo>
                <a:cubicBezTo>
                  <a:pt x="208" y="176"/>
                  <a:pt x="208" y="176"/>
                  <a:pt x="208" y="176"/>
                </a:cubicBezTo>
                <a:lnTo>
                  <a:pt x="208" y="153"/>
                </a:lnTo>
                <a:close/>
                <a:moveTo>
                  <a:pt x="342" y="130"/>
                </a:moveTo>
                <a:cubicBezTo>
                  <a:pt x="340" y="129"/>
                  <a:pt x="339" y="127"/>
                  <a:pt x="339" y="124"/>
                </a:cubicBezTo>
                <a:cubicBezTo>
                  <a:pt x="339" y="122"/>
                  <a:pt x="341" y="118"/>
                  <a:pt x="345" y="116"/>
                </a:cubicBezTo>
                <a:cubicBezTo>
                  <a:pt x="341" y="113"/>
                  <a:pt x="339" y="108"/>
                  <a:pt x="339" y="103"/>
                </a:cubicBezTo>
                <a:cubicBezTo>
                  <a:pt x="339" y="93"/>
                  <a:pt x="346" y="86"/>
                  <a:pt x="357" y="86"/>
                </a:cubicBezTo>
                <a:cubicBezTo>
                  <a:pt x="362" y="86"/>
                  <a:pt x="367" y="88"/>
                  <a:pt x="370" y="90"/>
                </a:cubicBezTo>
                <a:cubicBezTo>
                  <a:pt x="372" y="88"/>
                  <a:pt x="376" y="86"/>
                  <a:pt x="379" y="86"/>
                </a:cubicBezTo>
                <a:cubicBezTo>
                  <a:pt x="380" y="86"/>
                  <a:pt x="380" y="86"/>
                  <a:pt x="380" y="86"/>
                </a:cubicBezTo>
                <a:cubicBezTo>
                  <a:pt x="380" y="98"/>
                  <a:pt x="380" y="98"/>
                  <a:pt x="380" y="98"/>
                </a:cubicBezTo>
                <a:cubicBezTo>
                  <a:pt x="379" y="98"/>
                  <a:pt x="379" y="98"/>
                  <a:pt x="379" y="98"/>
                </a:cubicBezTo>
                <a:cubicBezTo>
                  <a:pt x="378" y="98"/>
                  <a:pt x="376" y="98"/>
                  <a:pt x="374" y="98"/>
                </a:cubicBezTo>
                <a:cubicBezTo>
                  <a:pt x="375" y="100"/>
                  <a:pt x="375" y="101"/>
                  <a:pt x="375" y="103"/>
                </a:cubicBezTo>
                <a:cubicBezTo>
                  <a:pt x="375" y="113"/>
                  <a:pt x="368" y="120"/>
                  <a:pt x="357" y="120"/>
                </a:cubicBezTo>
                <a:cubicBezTo>
                  <a:pt x="355" y="120"/>
                  <a:pt x="353" y="119"/>
                  <a:pt x="351" y="119"/>
                </a:cubicBezTo>
                <a:cubicBezTo>
                  <a:pt x="351" y="120"/>
                  <a:pt x="351" y="120"/>
                  <a:pt x="351" y="120"/>
                </a:cubicBezTo>
                <a:cubicBezTo>
                  <a:pt x="351" y="121"/>
                  <a:pt x="351" y="122"/>
                  <a:pt x="354" y="122"/>
                </a:cubicBezTo>
                <a:cubicBezTo>
                  <a:pt x="360" y="123"/>
                  <a:pt x="360" y="123"/>
                  <a:pt x="360" y="123"/>
                </a:cubicBezTo>
                <a:cubicBezTo>
                  <a:pt x="374" y="124"/>
                  <a:pt x="379" y="127"/>
                  <a:pt x="379" y="135"/>
                </a:cubicBezTo>
                <a:cubicBezTo>
                  <a:pt x="379" y="144"/>
                  <a:pt x="370" y="149"/>
                  <a:pt x="356" y="149"/>
                </a:cubicBezTo>
                <a:cubicBezTo>
                  <a:pt x="342" y="149"/>
                  <a:pt x="336" y="146"/>
                  <a:pt x="336" y="139"/>
                </a:cubicBezTo>
                <a:cubicBezTo>
                  <a:pt x="336" y="135"/>
                  <a:pt x="338" y="132"/>
                  <a:pt x="342" y="130"/>
                </a:cubicBezTo>
                <a:close/>
                <a:moveTo>
                  <a:pt x="352" y="103"/>
                </a:moveTo>
                <a:cubicBezTo>
                  <a:pt x="352" y="106"/>
                  <a:pt x="352" y="111"/>
                  <a:pt x="357" y="111"/>
                </a:cubicBezTo>
                <a:cubicBezTo>
                  <a:pt x="360" y="111"/>
                  <a:pt x="362" y="108"/>
                  <a:pt x="362" y="103"/>
                </a:cubicBezTo>
                <a:cubicBezTo>
                  <a:pt x="362" y="100"/>
                  <a:pt x="361" y="96"/>
                  <a:pt x="357" y="96"/>
                </a:cubicBezTo>
                <a:cubicBezTo>
                  <a:pt x="352" y="96"/>
                  <a:pt x="352" y="101"/>
                  <a:pt x="352" y="103"/>
                </a:cubicBezTo>
                <a:close/>
                <a:moveTo>
                  <a:pt x="348" y="137"/>
                </a:moveTo>
                <a:cubicBezTo>
                  <a:pt x="348" y="140"/>
                  <a:pt x="350" y="142"/>
                  <a:pt x="357" y="142"/>
                </a:cubicBezTo>
                <a:cubicBezTo>
                  <a:pt x="363" y="142"/>
                  <a:pt x="366" y="140"/>
                  <a:pt x="366" y="137"/>
                </a:cubicBezTo>
                <a:cubicBezTo>
                  <a:pt x="366" y="135"/>
                  <a:pt x="366" y="134"/>
                  <a:pt x="358" y="134"/>
                </a:cubicBezTo>
                <a:cubicBezTo>
                  <a:pt x="351" y="133"/>
                  <a:pt x="351" y="133"/>
                  <a:pt x="351" y="133"/>
                </a:cubicBezTo>
                <a:cubicBezTo>
                  <a:pt x="351" y="133"/>
                  <a:pt x="350" y="133"/>
                  <a:pt x="350" y="133"/>
                </a:cubicBezTo>
                <a:cubicBezTo>
                  <a:pt x="349" y="134"/>
                  <a:pt x="348" y="136"/>
                  <a:pt x="348" y="137"/>
                </a:cubicBezTo>
                <a:close/>
              </a:path>
            </a:pathLst>
          </a:custGeom>
          <a:solidFill>
            <a:schemeClr val="bg1"/>
          </a:solidFill>
          <a:ln>
            <a:noFill/>
          </a:ln>
        </p:spPr>
        <p:txBody>
          <a:bodyPr vert="horz" wrap="square" lIns="121920" tIns="60960" rIns="121920" bIns="60960" numCol="1" anchor="t" anchorCtr="0" compatLnSpc="1">
            <a:prstTxWarp prst="textNoShape">
              <a:avLst/>
            </a:prstTxWarp>
          </a:bodyPr>
          <a:lstStyle/>
          <a:p>
            <a:endParaRPr lang="en-US"/>
          </a:p>
        </p:txBody>
      </p:sp>
      <p:sp>
        <p:nvSpPr>
          <p:cNvPr id="3" name="Picture Placeholder 2"/>
          <p:cNvSpPr>
            <a:spLocks noGrp="1"/>
          </p:cNvSpPr>
          <p:nvPr>
            <p:ph type="pic" sz="quarter" idx="10"/>
          </p:nvPr>
        </p:nvSpPr>
        <p:spPr>
          <a:xfrm>
            <a:off x="0" y="3"/>
            <a:ext cx="12192000" cy="5362576"/>
          </a:xfrm>
          <a:custGeom>
            <a:avLst/>
            <a:gdLst>
              <a:gd name="connsiteX0" fmla="*/ 0 w 9144000"/>
              <a:gd name="connsiteY0" fmla="*/ 0 h 3783806"/>
              <a:gd name="connsiteX1" fmla="*/ 9144000 w 9144000"/>
              <a:gd name="connsiteY1" fmla="*/ 0 h 3783806"/>
              <a:gd name="connsiteX2" fmla="*/ 9144000 w 9144000"/>
              <a:gd name="connsiteY2" fmla="*/ 3783806 h 3783806"/>
              <a:gd name="connsiteX3" fmla="*/ 0 w 9144000"/>
              <a:gd name="connsiteY3" fmla="*/ 3783806 h 3783806"/>
              <a:gd name="connsiteX4" fmla="*/ 0 w 9144000"/>
              <a:gd name="connsiteY4" fmla="*/ 0 h 3783806"/>
              <a:gd name="connsiteX0" fmla="*/ 0 w 9144000"/>
              <a:gd name="connsiteY0" fmla="*/ 0 h 3783806"/>
              <a:gd name="connsiteX1" fmla="*/ 9144000 w 9144000"/>
              <a:gd name="connsiteY1" fmla="*/ 0 h 3783806"/>
              <a:gd name="connsiteX2" fmla="*/ 9144000 w 9144000"/>
              <a:gd name="connsiteY2" fmla="*/ 3783806 h 3783806"/>
              <a:gd name="connsiteX3" fmla="*/ 723900 w 9144000"/>
              <a:gd name="connsiteY3" fmla="*/ 3781425 h 3783806"/>
              <a:gd name="connsiteX4" fmla="*/ 0 w 9144000"/>
              <a:gd name="connsiteY4" fmla="*/ 3783806 h 3783806"/>
              <a:gd name="connsiteX5" fmla="*/ 0 w 9144000"/>
              <a:gd name="connsiteY5" fmla="*/ 0 h 3783806"/>
              <a:gd name="connsiteX0" fmla="*/ 0 w 9144000"/>
              <a:gd name="connsiteY0" fmla="*/ 0 h 3783806"/>
              <a:gd name="connsiteX1" fmla="*/ 9144000 w 9144000"/>
              <a:gd name="connsiteY1" fmla="*/ 0 h 3783806"/>
              <a:gd name="connsiteX2" fmla="*/ 9144000 w 9144000"/>
              <a:gd name="connsiteY2" fmla="*/ 3783806 h 3783806"/>
              <a:gd name="connsiteX3" fmla="*/ 692944 w 9144000"/>
              <a:gd name="connsiteY3" fmla="*/ 3781425 h 3783806"/>
              <a:gd name="connsiteX4" fmla="*/ 0 w 9144000"/>
              <a:gd name="connsiteY4" fmla="*/ 3783806 h 3783806"/>
              <a:gd name="connsiteX5" fmla="*/ 0 w 9144000"/>
              <a:gd name="connsiteY5" fmla="*/ 0 h 3783806"/>
              <a:gd name="connsiteX0" fmla="*/ 0 w 9144000"/>
              <a:gd name="connsiteY0" fmla="*/ 0 h 3783806"/>
              <a:gd name="connsiteX1" fmla="*/ 9144000 w 9144000"/>
              <a:gd name="connsiteY1" fmla="*/ 0 h 3783806"/>
              <a:gd name="connsiteX2" fmla="*/ 9144000 w 9144000"/>
              <a:gd name="connsiteY2" fmla="*/ 3783806 h 3783806"/>
              <a:gd name="connsiteX3" fmla="*/ 954881 w 9144000"/>
              <a:gd name="connsiteY3" fmla="*/ 3779044 h 3783806"/>
              <a:gd name="connsiteX4" fmla="*/ 692944 w 9144000"/>
              <a:gd name="connsiteY4" fmla="*/ 3781425 h 3783806"/>
              <a:gd name="connsiteX5" fmla="*/ 0 w 9144000"/>
              <a:gd name="connsiteY5" fmla="*/ 3783806 h 3783806"/>
              <a:gd name="connsiteX6" fmla="*/ 0 w 9144000"/>
              <a:gd name="connsiteY6" fmla="*/ 0 h 3783806"/>
              <a:gd name="connsiteX0" fmla="*/ 0 w 9144000"/>
              <a:gd name="connsiteY0" fmla="*/ 0 h 3783806"/>
              <a:gd name="connsiteX1" fmla="*/ 9144000 w 9144000"/>
              <a:gd name="connsiteY1" fmla="*/ 0 h 3783806"/>
              <a:gd name="connsiteX2" fmla="*/ 9144000 w 9144000"/>
              <a:gd name="connsiteY2" fmla="*/ 3783806 h 3783806"/>
              <a:gd name="connsiteX3" fmla="*/ 954881 w 9144000"/>
              <a:gd name="connsiteY3" fmla="*/ 3779044 h 3783806"/>
              <a:gd name="connsiteX4" fmla="*/ 821531 w 9144000"/>
              <a:gd name="connsiteY4" fmla="*/ 3779044 h 3783806"/>
              <a:gd name="connsiteX5" fmla="*/ 692944 w 9144000"/>
              <a:gd name="connsiteY5" fmla="*/ 3781425 h 3783806"/>
              <a:gd name="connsiteX6" fmla="*/ 0 w 9144000"/>
              <a:gd name="connsiteY6" fmla="*/ 3783806 h 3783806"/>
              <a:gd name="connsiteX7" fmla="*/ 0 w 9144000"/>
              <a:gd name="connsiteY7" fmla="*/ 0 h 3783806"/>
              <a:gd name="connsiteX0" fmla="*/ 0 w 9144000"/>
              <a:gd name="connsiteY0" fmla="*/ 0 h 4024313"/>
              <a:gd name="connsiteX1" fmla="*/ 9144000 w 9144000"/>
              <a:gd name="connsiteY1" fmla="*/ 0 h 4024313"/>
              <a:gd name="connsiteX2" fmla="*/ 9144000 w 9144000"/>
              <a:gd name="connsiteY2" fmla="*/ 3783806 h 4024313"/>
              <a:gd name="connsiteX3" fmla="*/ 954881 w 9144000"/>
              <a:gd name="connsiteY3" fmla="*/ 3779044 h 4024313"/>
              <a:gd name="connsiteX4" fmla="*/ 826293 w 9144000"/>
              <a:gd name="connsiteY4" fmla="*/ 4024313 h 4024313"/>
              <a:gd name="connsiteX5" fmla="*/ 692944 w 9144000"/>
              <a:gd name="connsiteY5" fmla="*/ 3781425 h 4024313"/>
              <a:gd name="connsiteX6" fmla="*/ 0 w 9144000"/>
              <a:gd name="connsiteY6" fmla="*/ 3783806 h 4024313"/>
              <a:gd name="connsiteX7" fmla="*/ 0 w 9144000"/>
              <a:gd name="connsiteY7" fmla="*/ 0 h 4024313"/>
              <a:gd name="connsiteX0" fmla="*/ 0 w 9144000"/>
              <a:gd name="connsiteY0" fmla="*/ 0 h 4024313"/>
              <a:gd name="connsiteX1" fmla="*/ 9144000 w 9144000"/>
              <a:gd name="connsiteY1" fmla="*/ 0 h 4024313"/>
              <a:gd name="connsiteX2" fmla="*/ 9144000 w 9144000"/>
              <a:gd name="connsiteY2" fmla="*/ 3783806 h 4024313"/>
              <a:gd name="connsiteX3" fmla="*/ 954881 w 9144000"/>
              <a:gd name="connsiteY3" fmla="*/ 3779044 h 4024313"/>
              <a:gd name="connsiteX4" fmla="*/ 826293 w 9144000"/>
              <a:gd name="connsiteY4" fmla="*/ 4024313 h 4024313"/>
              <a:gd name="connsiteX5" fmla="*/ 692944 w 9144000"/>
              <a:gd name="connsiteY5" fmla="*/ 3781425 h 4024313"/>
              <a:gd name="connsiteX6" fmla="*/ 0 w 9144000"/>
              <a:gd name="connsiteY6" fmla="*/ 3783806 h 4024313"/>
              <a:gd name="connsiteX7" fmla="*/ 0 w 9144000"/>
              <a:gd name="connsiteY7" fmla="*/ 0 h 4024313"/>
              <a:gd name="connsiteX0" fmla="*/ 0 w 9144000"/>
              <a:gd name="connsiteY0" fmla="*/ 0 h 4024313"/>
              <a:gd name="connsiteX1" fmla="*/ 9144000 w 9144000"/>
              <a:gd name="connsiteY1" fmla="*/ 0 h 4024313"/>
              <a:gd name="connsiteX2" fmla="*/ 9144000 w 9144000"/>
              <a:gd name="connsiteY2" fmla="*/ 3783806 h 4024313"/>
              <a:gd name="connsiteX3" fmla="*/ 954881 w 9144000"/>
              <a:gd name="connsiteY3" fmla="*/ 3779044 h 4024313"/>
              <a:gd name="connsiteX4" fmla="*/ 826293 w 9144000"/>
              <a:gd name="connsiteY4" fmla="*/ 4024313 h 4024313"/>
              <a:gd name="connsiteX5" fmla="*/ 692944 w 9144000"/>
              <a:gd name="connsiteY5" fmla="*/ 3781425 h 4024313"/>
              <a:gd name="connsiteX6" fmla="*/ 0 w 9144000"/>
              <a:gd name="connsiteY6" fmla="*/ 3783806 h 4024313"/>
              <a:gd name="connsiteX7" fmla="*/ 0 w 9144000"/>
              <a:gd name="connsiteY7" fmla="*/ 0 h 4024313"/>
              <a:gd name="connsiteX0" fmla="*/ 0 w 9144000"/>
              <a:gd name="connsiteY0" fmla="*/ 0 h 4024313"/>
              <a:gd name="connsiteX1" fmla="*/ 9144000 w 9144000"/>
              <a:gd name="connsiteY1" fmla="*/ 0 h 4024313"/>
              <a:gd name="connsiteX2" fmla="*/ 9144000 w 9144000"/>
              <a:gd name="connsiteY2" fmla="*/ 3783806 h 4024313"/>
              <a:gd name="connsiteX3" fmla="*/ 954881 w 9144000"/>
              <a:gd name="connsiteY3" fmla="*/ 3779044 h 4024313"/>
              <a:gd name="connsiteX4" fmla="*/ 826293 w 9144000"/>
              <a:gd name="connsiteY4" fmla="*/ 4024313 h 4024313"/>
              <a:gd name="connsiteX5" fmla="*/ 692944 w 9144000"/>
              <a:gd name="connsiteY5" fmla="*/ 3781425 h 4024313"/>
              <a:gd name="connsiteX6" fmla="*/ 0 w 9144000"/>
              <a:gd name="connsiteY6" fmla="*/ 3783806 h 4024313"/>
              <a:gd name="connsiteX7" fmla="*/ 0 w 9144000"/>
              <a:gd name="connsiteY7" fmla="*/ 0 h 4024313"/>
              <a:gd name="connsiteX0" fmla="*/ 0 w 9144000"/>
              <a:gd name="connsiteY0" fmla="*/ 0 h 4024313"/>
              <a:gd name="connsiteX1" fmla="*/ 9144000 w 9144000"/>
              <a:gd name="connsiteY1" fmla="*/ 0 h 4024313"/>
              <a:gd name="connsiteX2" fmla="*/ 9144000 w 9144000"/>
              <a:gd name="connsiteY2" fmla="*/ 3783806 h 4024313"/>
              <a:gd name="connsiteX3" fmla="*/ 954881 w 9144000"/>
              <a:gd name="connsiteY3" fmla="*/ 3779044 h 4024313"/>
              <a:gd name="connsiteX4" fmla="*/ 826293 w 9144000"/>
              <a:gd name="connsiteY4" fmla="*/ 4024313 h 4024313"/>
              <a:gd name="connsiteX5" fmla="*/ 692944 w 9144000"/>
              <a:gd name="connsiteY5" fmla="*/ 3781425 h 4024313"/>
              <a:gd name="connsiteX6" fmla="*/ 0 w 9144000"/>
              <a:gd name="connsiteY6" fmla="*/ 3783806 h 4024313"/>
              <a:gd name="connsiteX7" fmla="*/ 0 w 9144000"/>
              <a:gd name="connsiteY7" fmla="*/ 0 h 4024313"/>
              <a:gd name="connsiteX0" fmla="*/ 0 w 9144000"/>
              <a:gd name="connsiteY0" fmla="*/ 0 h 4024344"/>
              <a:gd name="connsiteX1" fmla="*/ 9144000 w 9144000"/>
              <a:gd name="connsiteY1" fmla="*/ 0 h 4024344"/>
              <a:gd name="connsiteX2" fmla="*/ 9144000 w 9144000"/>
              <a:gd name="connsiteY2" fmla="*/ 3783806 h 4024344"/>
              <a:gd name="connsiteX3" fmla="*/ 954881 w 9144000"/>
              <a:gd name="connsiteY3" fmla="*/ 3779044 h 4024344"/>
              <a:gd name="connsiteX4" fmla="*/ 826293 w 9144000"/>
              <a:gd name="connsiteY4" fmla="*/ 4024313 h 4024344"/>
              <a:gd name="connsiteX5" fmla="*/ 692944 w 9144000"/>
              <a:gd name="connsiteY5" fmla="*/ 3781425 h 4024344"/>
              <a:gd name="connsiteX6" fmla="*/ 0 w 9144000"/>
              <a:gd name="connsiteY6" fmla="*/ 3783806 h 4024344"/>
              <a:gd name="connsiteX7" fmla="*/ 0 w 9144000"/>
              <a:gd name="connsiteY7" fmla="*/ 0 h 4024344"/>
              <a:gd name="connsiteX0" fmla="*/ 0 w 9144000"/>
              <a:gd name="connsiteY0" fmla="*/ 0 h 4024665"/>
              <a:gd name="connsiteX1" fmla="*/ 9144000 w 9144000"/>
              <a:gd name="connsiteY1" fmla="*/ 0 h 4024665"/>
              <a:gd name="connsiteX2" fmla="*/ 9144000 w 9144000"/>
              <a:gd name="connsiteY2" fmla="*/ 3783806 h 4024665"/>
              <a:gd name="connsiteX3" fmla="*/ 954881 w 9144000"/>
              <a:gd name="connsiteY3" fmla="*/ 3779044 h 4024665"/>
              <a:gd name="connsiteX4" fmla="*/ 826293 w 9144000"/>
              <a:gd name="connsiteY4" fmla="*/ 4024313 h 4024665"/>
              <a:gd name="connsiteX5" fmla="*/ 692944 w 9144000"/>
              <a:gd name="connsiteY5" fmla="*/ 3781425 h 4024665"/>
              <a:gd name="connsiteX6" fmla="*/ 0 w 9144000"/>
              <a:gd name="connsiteY6" fmla="*/ 3783806 h 4024665"/>
              <a:gd name="connsiteX7" fmla="*/ 0 w 9144000"/>
              <a:gd name="connsiteY7" fmla="*/ 0 h 4024665"/>
              <a:gd name="connsiteX0" fmla="*/ 0 w 9144000"/>
              <a:gd name="connsiteY0" fmla="*/ 0 h 4024519"/>
              <a:gd name="connsiteX1" fmla="*/ 9144000 w 9144000"/>
              <a:gd name="connsiteY1" fmla="*/ 0 h 4024519"/>
              <a:gd name="connsiteX2" fmla="*/ 9144000 w 9144000"/>
              <a:gd name="connsiteY2" fmla="*/ 3783806 h 4024519"/>
              <a:gd name="connsiteX3" fmla="*/ 954881 w 9144000"/>
              <a:gd name="connsiteY3" fmla="*/ 3779044 h 4024519"/>
              <a:gd name="connsiteX4" fmla="*/ 826293 w 9144000"/>
              <a:gd name="connsiteY4" fmla="*/ 4024313 h 4024519"/>
              <a:gd name="connsiteX5" fmla="*/ 692944 w 9144000"/>
              <a:gd name="connsiteY5" fmla="*/ 3781425 h 4024519"/>
              <a:gd name="connsiteX6" fmla="*/ 0 w 9144000"/>
              <a:gd name="connsiteY6" fmla="*/ 3783806 h 4024519"/>
              <a:gd name="connsiteX7" fmla="*/ 0 w 9144000"/>
              <a:gd name="connsiteY7" fmla="*/ 0 h 4024519"/>
              <a:gd name="connsiteX0" fmla="*/ 0 w 9144000"/>
              <a:gd name="connsiteY0" fmla="*/ 0 h 4024313"/>
              <a:gd name="connsiteX1" fmla="*/ 9144000 w 9144000"/>
              <a:gd name="connsiteY1" fmla="*/ 0 h 4024313"/>
              <a:gd name="connsiteX2" fmla="*/ 9144000 w 9144000"/>
              <a:gd name="connsiteY2" fmla="*/ 3783806 h 4024313"/>
              <a:gd name="connsiteX3" fmla="*/ 964406 w 9144000"/>
              <a:gd name="connsiteY3" fmla="*/ 3781426 h 4024313"/>
              <a:gd name="connsiteX4" fmla="*/ 826293 w 9144000"/>
              <a:gd name="connsiteY4" fmla="*/ 4024313 h 4024313"/>
              <a:gd name="connsiteX5" fmla="*/ 692944 w 9144000"/>
              <a:gd name="connsiteY5" fmla="*/ 3781425 h 4024313"/>
              <a:gd name="connsiteX6" fmla="*/ 0 w 9144000"/>
              <a:gd name="connsiteY6" fmla="*/ 3783806 h 4024313"/>
              <a:gd name="connsiteX7" fmla="*/ 0 w 9144000"/>
              <a:gd name="connsiteY7" fmla="*/ 0 h 4024313"/>
              <a:gd name="connsiteX0" fmla="*/ 0 w 9144000"/>
              <a:gd name="connsiteY0" fmla="*/ 0 h 4024313"/>
              <a:gd name="connsiteX1" fmla="*/ 9144000 w 9144000"/>
              <a:gd name="connsiteY1" fmla="*/ 0 h 4024313"/>
              <a:gd name="connsiteX2" fmla="*/ 9144000 w 9144000"/>
              <a:gd name="connsiteY2" fmla="*/ 3783806 h 4024313"/>
              <a:gd name="connsiteX3" fmla="*/ 964406 w 9144000"/>
              <a:gd name="connsiteY3" fmla="*/ 3781426 h 4024313"/>
              <a:gd name="connsiteX4" fmla="*/ 826293 w 9144000"/>
              <a:gd name="connsiteY4" fmla="*/ 4024313 h 4024313"/>
              <a:gd name="connsiteX5" fmla="*/ 692944 w 9144000"/>
              <a:gd name="connsiteY5" fmla="*/ 3781425 h 4024313"/>
              <a:gd name="connsiteX6" fmla="*/ 0 w 9144000"/>
              <a:gd name="connsiteY6" fmla="*/ 3783806 h 4024313"/>
              <a:gd name="connsiteX7" fmla="*/ 0 w 9144000"/>
              <a:gd name="connsiteY7" fmla="*/ 0 h 4024313"/>
              <a:gd name="connsiteX0" fmla="*/ 0 w 9144000"/>
              <a:gd name="connsiteY0" fmla="*/ 0 h 4028131"/>
              <a:gd name="connsiteX1" fmla="*/ 9144000 w 9144000"/>
              <a:gd name="connsiteY1" fmla="*/ 0 h 4028131"/>
              <a:gd name="connsiteX2" fmla="*/ 9144000 w 9144000"/>
              <a:gd name="connsiteY2" fmla="*/ 3783806 h 4028131"/>
              <a:gd name="connsiteX3" fmla="*/ 964406 w 9144000"/>
              <a:gd name="connsiteY3" fmla="*/ 3781426 h 4028131"/>
              <a:gd name="connsiteX4" fmla="*/ 826293 w 9144000"/>
              <a:gd name="connsiteY4" fmla="*/ 4024313 h 4028131"/>
              <a:gd name="connsiteX5" fmla="*/ 692944 w 9144000"/>
              <a:gd name="connsiteY5" fmla="*/ 3781425 h 4028131"/>
              <a:gd name="connsiteX6" fmla="*/ 0 w 9144000"/>
              <a:gd name="connsiteY6" fmla="*/ 3783806 h 4028131"/>
              <a:gd name="connsiteX7" fmla="*/ 0 w 9144000"/>
              <a:gd name="connsiteY7" fmla="*/ 0 h 4028131"/>
              <a:gd name="connsiteX0" fmla="*/ 0 w 9144000"/>
              <a:gd name="connsiteY0" fmla="*/ 0 h 4024412"/>
              <a:gd name="connsiteX1" fmla="*/ 9144000 w 9144000"/>
              <a:gd name="connsiteY1" fmla="*/ 0 h 4024412"/>
              <a:gd name="connsiteX2" fmla="*/ 9144000 w 9144000"/>
              <a:gd name="connsiteY2" fmla="*/ 3783806 h 4024412"/>
              <a:gd name="connsiteX3" fmla="*/ 964406 w 9144000"/>
              <a:gd name="connsiteY3" fmla="*/ 3781426 h 4024412"/>
              <a:gd name="connsiteX4" fmla="*/ 826293 w 9144000"/>
              <a:gd name="connsiteY4" fmla="*/ 4024313 h 4024412"/>
              <a:gd name="connsiteX5" fmla="*/ 692944 w 9144000"/>
              <a:gd name="connsiteY5" fmla="*/ 3781425 h 4024412"/>
              <a:gd name="connsiteX6" fmla="*/ 0 w 9144000"/>
              <a:gd name="connsiteY6" fmla="*/ 3783806 h 4024412"/>
              <a:gd name="connsiteX7" fmla="*/ 0 w 9144000"/>
              <a:gd name="connsiteY7" fmla="*/ 0 h 4024412"/>
              <a:gd name="connsiteX0" fmla="*/ 0 w 9144000"/>
              <a:gd name="connsiteY0" fmla="*/ 0 h 4024313"/>
              <a:gd name="connsiteX1" fmla="*/ 9144000 w 9144000"/>
              <a:gd name="connsiteY1" fmla="*/ 0 h 4024313"/>
              <a:gd name="connsiteX2" fmla="*/ 9144000 w 9144000"/>
              <a:gd name="connsiteY2" fmla="*/ 3783806 h 4024313"/>
              <a:gd name="connsiteX3" fmla="*/ 964406 w 9144000"/>
              <a:gd name="connsiteY3" fmla="*/ 3781426 h 4024313"/>
              <a:gd name="connsiteX4" fmla="*/ 826293 w 9144000"/>
              <a:gd name="connsiteY4" fmla="*/ 4024313 h 4024313"/>
              <a:gd name="connsiteX5" fmla="*/ 692944 w 9144000"/>
              <a:gd name="connsiteY5" fmla="*/ 3781425 h 4024313"/>
              <a:gd name="connsiteX6" fmla="*/ 0 w 9144000"/>
              <a:gd name="connsiteY6" fmla="*/ 3783806 h 4024313"/>
              <a:gd name="connsiteX7" fmla="*/ 0 w 9144000"/>
              <a:gd name="connsiteY7" fmla="*/ 0 h 4024313"/>
              <a:gd name="connsiteX0" fmla="*/ 0 w 9144000"/>
              <a:gd name="connsiteY0" fmla="*/ 0 h 4024313"/>
              <a:gd name="connsiteX1" fmla="*/ 9144000 w 9144000"/>
              <a:gd name="connsiteY1" fmla="*/ 0 h 4024313"/>
              <a:gd name="connsiteX2" fmla="*/ 9144000 w 9144000"/>
              <a:gd name="connsiteY2" fmla="*/ 3783806 h 4024313"/>
              <a:gd name="connsiteX3" fmla="*/ 964406 w 9144000"/>
              <a:gd name="connsiteY3" fmla="*/ 3781426 h 4024313"/>
              <a:gd name="connsiteX4" fmla="*/ 826293 w 9144000"/>
              <a:gd name="connsiteY4" fmla="*/ 4024313 h 4024313"/>
              <a:gd name="connsiteX5" fmla="*/ 692944 w 9144000"/>
              <a:gd name="connsiteY5" fmla="*/ 3781425 h 4024313"/>
              <a:gd name="connsiteX6" fmla="*/ 0 w 9144000"/>
              <a:gd name="connsiteY6" fmla="*/ 3783806 h 4024313"/>
              <a:gd name="connsiteX7" fmla="*/ 0 w 9144000"/>
              <a:gd name="connsiteY7" fmla="*/ 0 h 4024313"/>
              <a:gd name="connsiteX0" fmla="*/ 0 w 9144000"/>
              <a:gd name="connsiteY0" fmla="*/ 0 h 4024313"/>
              <a:gd name="connsiteX1" fmla="*/ 9144000 w 9144000"/>
              <a:gd name="connsiteY1" fmla="*/ 0 h 4024313"/>
              <a:gd name="connsiteX2" fmla="*/ 9144000 w 9144000"/>
              <a:gd name="connsiteY2" fmla="*/ 3783806 h 4024313"/>
              <a:gd name="connsiteX3" fmla="*/ 964406 w 9144000"/>
              <a:gd name="connsiteY3" fmla="*/ 3781426 h 4024313"/>
              <a:gd name="connsiteX4" fmla="*/ 826293 w 9144000"/>
              <a:gd name="connsiteY4" fmla="*/ 4024313 h 4024313"/>
              <a:gd name="connsiteX5" fmla="*/ 692944 w 9144000"/>
              <a:gd name="connsiteY5" fmla="*/ 3781425 h 4024313"/>
              <a:gd name="connsiteX6" fmla="*/ 0 w 9144000"/>
              <a:gd name="connsiteY6" fmla="*/ 3783806 h 4024313"/>
              <a:gd name="connsiteX7" fmla="*/ 0 w 9144000"/>
              <a:gd name="connsiteY7" fmla="*/ 0 h 4024313"/>
              <a:gd name="connsiteX0" fmla="*/ 0 w 9144000"/>
              <a:gd name="connsiteY0" fmla="*/ 0 h 4024313"/>
              <a:gd name="connsiteX1" fmla="*/ 9144000 w 9144000"/>
              <a:gd name="connsiteY1" fmla="*/ 0 h 4024313"/>
              <a:gd name="connsiteX2" fmla="*/ 9144000 w 9144000"/>
              <a:gd name="connsiteY2" fmla="*/ 3783806 h 4024313"/>
              <a:gd name="connsiteX3" fmla="*/ 964406 w 9144000"/>
              <a:gd name="connsiteY3" fmla="*/ 3781426 h 4024313"/>
              <a:gd name="connsiteX4" fmla="*/ 826293 w 9144000"/>
              <a:gd name="connsiteY4" fmla="*/ 4024313 h 4024313"/>
              <a:gd name="connsiteX5" fmla="*/ 692944 w 9144000"/>
              <a:gd name="connsiteY5" fmla="*/ 3781425 h 4024313"/>
              <a:gd name="connsiteX6" fmla="*/ 0 w 9144000"/>
              <a:gd name="connsiteY6" fmla="*/ 3783806 h 4024313"/>
              <a:gd name="connsiteX7" fmla="*/ 0 w 9144000"/>
              <a:gd name="connsiteY7" fmla="*/ 0 h 4024313"/>
              <a:gd name="connsiteX0" fmla="*/ 0 w 9144000"/>
              <a:gd name="connsiteY0" fmla="*/ 0 h 4024313"/>
              <a:gd name="connsiteX1" fmla="*/ 9144000 w 9144000"/>
              <a:gd name="connsiteY1" fmla="*/ 0 h 4024313"/>
              <a:gd name="connsiteX2" fmla="*/ 9144000 w 9144000"/>
              <a:gd name="connsiteY2" fmla="*/ 3783806 h 4024313"/>
              <a:gd name="connsiteX3" fmla="*/ 964406 w 9144000"/>
              <a:gd name="connsiteY3" fmla="*/ 3781426 h 4024313"/>
              <a:gd name="connsiteX4" fmla="*/ 826293 w 9144000"/>
              <a:gd name="connsiteY4" fmla="*/ 4024313 h 4024313"/>
              <a:gd name="connsiteX5" fmla="*/ 666750 w 9144000"/>
              <a:gd name="connsiteY5" fmla="*/ 3781425 h 4024313"/>
              <a:gd name="connsiteX6" fmla="*/ 0 w 9144000"/>
              <a:gd name="connsiteY6" fmla="*/ 3783806 h 4024313"/>
              <a:gd name="connsiteX7" fmla="*/ 0 w 9144000"/>
              <a:gd name="connsiteY7" fmla="*/ 0 h 4024313"/>
              <a:gd name="connsiteX0" fmla="*/ 0 w 9144000"/>
              <a:gd name="connsiteY0" fmla="*/ 0 h 4024316"/>
              <a:gd name="connsiteX1" fmla="*/ 9144000 w 9144000"/>
              <a:gd name="connsiteY1" fmla="*/ 0 h 4024316"/>
              <a:gd name="connsiteX2" fmla="*/ 9144000 w 9144000"/>
              <a:gd name="connsiteY2" fmla="*/ 3783806 h 4024316"/>
              <a:gd name="connsiteX3" fmla="*/ 945356 w 9144000"/>
              <a:gd name="connsiteY3" fmla="*/ 3786189 h 4024316"/>
              <a:gd name="connsiteX4" fmla="*/ 826293 w 9144000"/>
              <a:gd name="connsiteY4" fmla="*/ 4024313 h 4024316"/>
              <a:gd name="connsiteX5" fmla="*/ 666750 w 9144000"/>
              <a:gd name="connsiteY5" fmla="*/ 3781425 h 4024316"/>
              <a:gd name="connsiteX6" fmla="*/ 0 w 9144000"/>
              <a:gd name="connsiteY6" fmla="*/ 3783806 h 4024316"/>
              <a:gd name="connsiteX7" fmla="*/ 0 w 9144000"/>
              <a:gd name="connsiteY7" fmla="*/ 0 h 4024316"/>
              <a:gd name="connsiteX0" fmla="*/ 0 w 9144000"/>
              <a:gd name="connsiteY0" fmla="*/ 0 h 4029078"/>
              <a:gd name="connsiteX1" fmla="*/ 9144000 w 9144000"/>
              <a:gd name="connsiteY1" fmla="*/ 0 h 4029078"/>
              <a:gd name="connsiteX2" fmla="*/ 9144000 w 9144000"/>
              <a:gd name="connsiteY2" fmla="*/ 3783806 h 4029078"/>
              <a:gd name="connsiteX3" fmla="*/ 945356 w 9144000"/>
              <a:gd name="connsiteY3" fmla="*/ 3786189 h 4029078"/>
              <a:gd name="connsiteX4" fmla="*/ 809624 w 9144000"/>
              <a:gd name="connsiteY4" fmla="*/ 4029075 h 4029078"/>
              <a:gd name="connsiteX5" fmla="*/ 666750 w 9144000"/>
              <a:gd name="connsiteY5" fmla="*/ 3781425 h 4029078"/>
              <a:gd name="connsiteX6" fmla="*/ 0 w 9144000"/>
              <a:gd name="connsiteY6" fmla="*/ 3783806 h 4029078"/>
              <a:gd name="connsiteX7" fmla="*/ 0 w 9144000"/>
              <a:gd name="connsiteY7" fmla="*/ 0 h 4029078"/>
              <a:gd name="connsiteX0" fmla="*/ 0 w 9144000"/>
              <a:gd name="connsiteY0" fmla="*/ 0 h 4029106"/>
              <a:gd name="connsiteX1" fmla="*/ 9144000 w 9144000"/>
              <a:gd name="connsiteY1" fmla="*/ 0 h 4029106"/>
              <a:gd name="connsiteX2" fmla="*/ 9144000 w 9144000"/>
              <a:gd name="connsiteY2" fmla="*/ 3783806 h 4029106"/>
              <a:gd name="connsiteX3" fmla="*/ 945356 w 9144000"/>
              <a:gd name="connsiteY3" fmla="*/ 3786189 h 4029106"/>
              <a:gd name="connsiteX4" fmla="*/ 809624 w 9144000"/>
              <a:gd name="connsiteY4" fmla="*/ 4029075 h 4029106"/>
              <a:gd name="connsiteX5" fmla="*/ 666750 w 9144000"/>
              <a:gd name="connsiteY5" fmla="*/ 3781425 h 4029106"/>
              <a:gd name="connsiteX6" fmla="*/ 0 w 9144000"/>
              <a:gd name="connsiteY6" fmla="*/ 3783806 h 4029106"/>
              <a:gd name="connsiteX7" fmla="*/ 0 w 9144000"/>
              <a:gd name="connsiteY7" fmla="*/ 0 h 4029106"/>
              <a:gd name="connsiteX0" fmla="*/ 0 w 9144000"/>
              <a:gd name="connsiteY0" fmla="*/ 0 h 4029106"/>
              <a:gd name="connsiteX1" fmla="*/ 9144000 w 9144000"/>
              <a:gd name="connsiteY1" fmla="*/ 0 h 4029106"/>
              <a:gd name="connsiteX2" fmla="*/ 9144000 w 9144000"/>
              <a:gd name="connsiteY2" fmla="*/ 3783806 h 4029106"/>
              <a:gd name="connsiteX3" fmla="*/ 945356 w 9144000"/>
              <a:gd name="connsiteY3" fmla="*/ 3786189 h 4029106"/>
              <a:gd name="connsiteX4" fmla="*/ 809624 w 9144000"/>
              <a:gd name="connsiteY4" fmla="*/ 4029075 h 4029106"/>
              <a:gd name="connsiteX5" fmla="*/ 666750 w 9144000"/>
              <a:gd name="connsiteY5" fmla="*/ 3781425 h 4029106"/>
              <a:gd name="connsiteX6" fmla="*/ 0 w 9144000"/>
              <a:gd name="connsiteY6" fmla="*/ 3783806 h 4029106"/>
              <a:gd name="connsiteX7" fmla="*/ 0 w 9144000"/>
              <a:gd name="connsiteY7" fmla="*/ 0 h 4029106"/>
              <a:gd name="connsiteX0" fmla="*/ 0 w 9144000"/>
              <a:gd name="connsiteY0" fmla="*/ 0 h 4039816"/>
              <a:gd name="connsiteX1" fmla="*/ 9144000 w 9144000"/>
              <a:gd name="connsiteY1" fmla="*/ 0 h 4039816"/>
              <a:gd name="connsiteX2" fmla="*/ 9144000 w 9144000"/>
              <a:gd name="connsiteY2" fmla="*/ 3783806 h 4039816"/>
              <a:gd name="connsiteX3" fmla="*/ 945356 w 9144000"/>
              <a:gd name="connsiteY3" fmla="*/ 3786189 h 4039816"/>
              <a:gd name="connsiteX4" fmla="*/ 854869 w 9144000"/>
              <a:gd name="connsiteY4" fmla="*/ 3974305 h 4039816"/>
              <a:gd name="connsiteX5" fmla="*/ 809624 w 9144000"/>
              <a:gd name="connsiteY5" fmla="*/ 4029075 h 4039816"/>
              <a:gd name="connsiteX6" fmla="*/ 666750 w 9144000"/>
              <a:gd name="connsiteY6" fmla="*/ 3781425 h 4039816"/>
              <a:gd name="connsiteX7" fmla="*/ 0 w 9144000"/>
              <a:gd name="connsiteY7" fmla="*/ 3783806 h 4039816"/>
              <a:gd name="connsiteX8" fmla="*/ 0 w 9144000"/>
              <a:gd name="connsiteY8" fmla="*/ 0 h 4039816"/>
              <a:gd name="connsiteX0" fmla="*/ 0 w 9144000"/>
              <a:gd name="connsiteY0" fmla="*/ 0 h 4029309"/>
              <a:gd name="connsiteX1" fmla="*/ 9144000 w 9144000"/>
              <a:gd name="connsiteY1" fmla="*/ 0 h 4029309"/>
              <a:gd name="connsiteX2" fmla="*/ 9144000 w 9144000"/>
              <a:gd name="connsiteY2" fmla="*/ 3783806 h 4029309"/>
              <a:gd name="connsiteX3" fmla="*/ 945356 w 9144000"/>
              <a:gd name="connsiteY3" fmla="*/ 3786189 h 4029309"/>
              <a:gd name="connsiteX4" fmla="*/ 854869 w 9144000"/>
              <a:gd name="connsiteY4" fmla="*/ 3974305 h 4029309"/>
              <a:gd name="connsiteX5" fmla="*/ 809624 w 9144000"/>
              <a:gd name="connsiteY5" fmla="*/ 4029075 h 4029309"/>
              <a:gd name="connsiteX6" fmla="*/ 766763 w 9144000"/>
              <a:gd name="connsiteY6" fmla="*/ 3983830 h 4029309"/>
              <a:gd name="connsiteX7" fmla="*/ 666750 w 9144000"/>
              <a:gd name="connsiteY7" fmla="*/ 3781425 h 4029309"/>
              <a:gd name="connsiteX8" fmla="*/ 0 w 9144000"/>
              <a:gd name="connsiteY8" fmla="*/ 3783806 h 4029309"/>
              <a:gd name="connsiteX9" fmla="*/ 0 w 9144000"/>
              <a:gd name="connsiteY9" fmla="*/ 0 h 4029309"/>
              <a:gd name="connsiteX0" fmla="*/ 0 w 9144000"/>
              <a:gd name="connsiteY0" fmla="*/ 0 h 4029309"/>
              <a:gd name="connsiteX1" fmla="*/ 9144000 w 9144000"/>
              <a:gd name="connsiteY1" fmla="*/ 0 h 4029309"/>
              <a:gd name="connsiteX2" fmla="*/ 9144000 w 9144000"/>
              <a:gd name="connsiteY2" fmla="*/ 3783806 h 4029309"/>
              <a:gd name="connsiteX3" fmla="*/ 945356 w 9144000"/>
              <a:gd name="connsiteY3" fmla="*/ 3786189 h 4029309"/>
              <a:gd name="connsiteX4" fmla="*/ 854869 w 9144000"/>
              <a:gd name="connsiteY4" fmla="*/ 3974305 h 4029309"/>
              <a:gd name="connsiteX5" fmla="*/ 809624 w 9144000"/>
              <a:gd name="connsiteY5" fmla="*/ 4029075 h 4029309"/>
              <a:gd name="connsiteX6" fmla="*/ 766763 w 9144000"/>
              <a:gd name="connsiteY6" fmla="*/ 3983830 h 4029309"/>
              <a:gd name="connsiteX7" fmla="*/ 666750 w 9144000"/>
              <a:gd name="connsiteY7" fmla="*/ 3781425 h 4029309"/>
              <a:gd name="connsiteX8" fmla="*/ 0 w 9144000"/>
              <a:gd name="connsiteY8" fmla="*/ 3783806 h 4029309"/>
              <a:gd name="connsiteX9" fmla="*/ 0 w 9144000"/>
              <a:gd name="connsiteY9" fmla="*/ 0 h 4029309"/>
              <a:gd name="connsiteX0" fmla="*/ 0 w 9144000"/>
              <a:gd name="connsiteY0" fmla="*/ 0 h 4029309"/>
              <a:gd name="connsiteX1" fmla="*/ 9144000 w 9144000"/>
              <a:gd name="connsiteY1" fmla="*/ 0 h 4029309"/>
              <a:gd name="connsiteX2" fmla="*/ 9144000 w 9144000"/>
              <a:gd name="connsiteY2" fmla="*/ 3783806 h 4029309"/>
              <a:gd name="connsiteX3" fmla="*/ 945356 w 9144000"/>
              <a:gd name="connsiteY3" fmla="*/ 3786189 h 4029309"/>
              <a:gd name="connsiteX4" fmla="*/ 850106 w 9144000"/>
              <a:gd name="connsiteY4" fmla="*/ 3974305 h 4029309"/>
              <a:gd name="connsiteX5" fmla="*/ 809624 w 9144000"/>
              <a:gd name="connsiteY5" fmla="*/ 4029075 h 4029309"/>
              <a:gd name="connsiteX6" fmla="*/ 766763 w 9144000"/>
              <a:gd name="connsiteY6" fmla="*/ 3983830 h 4029309"/>
              <a:gd name="connsiteX7" fmla="*/ 666750 w 9144000"/>
              <a:gd name="connsiteY7" fmla="*/ 3781425 h 4029309"/>
              <a:gd name="connsiteX8" fmla="*/ 0 w 9144000"/>
              <a:gd name="connsiteY8" fmla="*/ 3783806 h 4029309"/>
              <a:gd name="connsiteX9" fmla="*/ 0 w 9144000"/>
              <a:gd name="connsiteY9" fmla="*/ 0 h 4029309"/>
              <a:gd name="connsiteX0" fmla="*/ 0 w 9144000"/>
              <a:gd name="connsiteY0" fmla="*/ 0 h 4029309"/>
              <a:gd name="connsiteX1" fmla="*/ 9144000 w 9144000"/>
              <a:gd name="connsiteY1" fmla="*/ 0 h 4029309"/>
              <a:gd name="connsiteX2" fmla="*/ 9144000 w 9144000"/>
              <a:gd name="connsiteY2" fmla="*/ 3783806 h 4029309"/>
              <a:gd name="connsiteX3" fmla="*/ 945356 w 9144000"/>
              <a:gd name="connsiteY3" fmla="*/ 3786189 h 4029309"/>
              <a:gd name="connsiteX4" fmla="*/ 850106 w 9144000"/>
              <a:gd name="connsiteY4" fmla="*/ 3974305 h 4029309"/>
              <a:gd name="connsiteX5" fmla="*/ 809624 w 9144000"/>
              <a:gd name="connsiteY5" fmla="*/ 4029075 h 4029309"/>
              <a:gd name="connsiteX6" fmla="*/ 766763 w 9144000"/>
              <a:gd name="connsiteY6" fmla="*/ 3983830 h 4029309"/>
              <a:gd name="connsiteX7" fmla="*/ 666750 w 9144000"/>
              <a:gd name="connsiteY7" fmla="*/ 3781425 h 4029309"/>
              <a:gd name="connsiteX8" fmla="*/ 0 w 9144000"/>
              <a:gd name="connsiteY8" fmla="*/ 3783806 h 4029309"/>
              <a:gd name="connsiteX9" fmla="*/ 0 w 9144000"/>
              <a:gd name="connsiteY9" fmla="*/ 0 h 4029309"/>
              <a:gd name="connsiteX0" fmla="*/ 0 w 9144000"/>
              <a:gd name="connsiteY0" fmla="*/ 0 h 4029309"/>
              <a:gd name="connsiteX1" fmla="*/ 9144000 w 9144000"/>
              <a:gd name="connsiteY1" fmla="*/ 0 h 4029309"/>
              <a:gd name="connsiteX2" fmla="*/ 9144000 w 9144000"/>
              <a:gd name="connsiteY2" fmla="*/ 3783806 h 4029309"/>
              <a:gd name="connsiteX3" fmla="*/ 945356 w 9144000"/>
              <a:gd name="connsiteY3" fmla="*/ 3786189 h 4029309"/>
              <a:gd name="connsiteX4" fmla="*/ 850106 w 9144000"/>
              <a:gd name="connsiteY4" fmla="*/ 3974305 h 4029309"/>
              <a:gd name="connsiteX5" fmla="*/ 809624 w 9144000"/>
              <a:gd name="connsiteY5" fmla="*/ 4029075 h 4029309"/>
              <a:gd name="connsiteX6" fmla="*/ 766763 w 9144000"/>
              <a:gd name="connsiteY6" fmla="*/ 3983830 h 4029309"/>
              <a:gd name="connsiteX7" fmla="*/ 666750 w 9144000"/>
              <a:gd name="connsiteY7" fmla="*/ 3781425 h 4029309"/>
              <a:gd name="connsiteX8" fmla="*/ 0 w 9144000"/>
              <a:gd name="connsiteY8" fmla="*/ 3783806 h 4029309"/>
              <a:gd name="connsiteX9" fmla="*/ 0 w 9144000"/>
              <a:gd name="connsiteY9" fmla="*/ 0 h 4029309"/>
              <a:gd name="connsiteX0" fmla="*/ 0 w 9144000"/>
              <a:gd name="connsiteY0" fmla="*/ 0 h 4029309"/>
              <a:gd name="connsiteX1" fmla="*/ 9144000 w 9144000"/>
              <a:gd name="connsiteY1" fmla="*/ 0 h 4029309"/>
              <a:gd name="connsiteX2" fmla="*/ 9144000 w 9144000"/>
              <a:gd name="connsiteY2" fmla="*/ 3783806 h 4029309"/>
              <a:gd name="connsiteX3" fmla="*/ 945356 w 9144000"/>
              <a:gd name="connsiteY3" fmla="*/ 3786189 h 4029309"/>
              <a:gd name="connsiteX4" fmla="*/ 850106 w 9144000"/>
              <a:gd name="connsiteY4" fmla="*/ 3974305 h 4029309"/>
              <a:gd name="connsiteX5" fmla="*/ 809624 w 9144000"/>
              <a:gd name="connsiteY5" fmla="*/ 4029075 h 4029309"/>
              <a:gd name="connsiteX6" fmla="*/ 766763 w 9144000"/>
              <a:gd name="connsiteY6" fmla="*/ 3983830 h 4029309"/>
              <a:gd name="connsiteX7" fmla="*/ 666750 w 9144000"/>
              <a:gd name="connsiteY7" fmla="*/ 3781425 h 4029309"/>
              <a:gd name="connsiteX8" fmla="*/ 0 w 9144000"/>
              <a:gd name="connsiteY8" fmla="*/ 3783806 h 4029309"/>
              <a:gd name="connsiteX9" fmla="*/ 0 w 9144000"/>
              <a:gd name="connsiteY9" fmla="*/ 0 h 4029309"/>
              <a:gd name="connsiteX0" fmla="*/ 0 w 9144000"/>
              <a:gd name="connsiteY0" fmla="*/ 0 h 4088634"/>
              <a:gd name="connsiteX1" fmla="*/ 9144000 w 9144000"/>
              <a:gd name="connsiteY1" fmla="*/ 0 h 4088634"/>
              <a:gd name="connsiteX2" fmla="*/ 9144000 w 9144000"/>
              <a:gd name="connsiteY2" fmla="*/ 3783806 h 4088634"/>
              <a:gd name="connsiteX3" fmla="*/ 945356 w 9144000"/>
              <a:gd name="connsiteY3" fmla="*/ 3786189 h 4088634"/>
              <a:gd name="connsiteX4" fmla="*/ 850106 w 9144000"/>
              <a:gd name="connsiteY4" fmla="*/ 3974305 h 4088634"/>
              <a:gd name="connsiteX5" fmla="*/ 809624 w 9144000"/>
              <a:gd name="connsiteY5" fmla="*/ 4088606 h 4088634"/>
              <a:gd name="connsiteX6" fmla="*/ 766763 w 9144000"/>
              <a:gd name="connsiteY6" fmla="*/ 3983830 h 4088634"/>
              <a:gd name="connsiteX7" fmla="*/ 666750 w 9144000"/>
              <a:gd name="connsiteY7" fmla="*/ 3781425 h 4088634"/>
              <a:gd name="connsiteX8" fmla="*/ 0 w 9144000"/>
              <a:gd name="connsiteY8" fmla="*/ 3783806 h 4088634"/>
              <a:gd name="connsiteX9" fmla="*/ 0 w 9144000"/>
              <a:gd name="connsiteY9" fmla="*/ 0 h 4088634"/>
              <a:gd name="connsiteX0" fmla="*/ 0 w 9144000"/>
              <a:gd name="connsiteY0" fmla="*/ 0 h 4098155"/>
              <a:gd name="connsiteX1" fmla="*/ 9144000 w 9144000"/>
              <a:gd name="connsiteY1" fmla="*/ 0 h 4098155"/>
              <a:gd name="connsiteX2" fmla="*/ 9144000 w 9144000"/>
              <a:gd name="connsiteY2" fmla="*/ 3783806 h 4098155"/>
              <a:gd name="connsiteX3" fmla="*/ 945356 w 9144000"/>
              <a:gd name="connsiteY3" fmla="*/ 3786189 h 4098155"/>
              <a:gd name="connsiteX4" fmla="*/ 850106 w 9144000"/>
              <a:gd name="connsiteY4" fmla="*/ 3974305 h 4098155"/>
              <a:gd name="connsiteX5" fmla="*/ 814386 w 9144000"/>
              <a:gd name="connsiteY5" fmla="*/ 4098131 h 4098155"/>
              <a:gd name="connsiteX6" fmla="*/ 766763 w 9144000"/>
              <a:gd name="connsiteY6" fmla="*/ 3983830 h 4098155"/>
              <a:gd name="connsiteX7" fmla="*/ 666750 w 9144000"/>
              <a:gd name="connsiteY7" fmla="*/ 3781425 h 4098155"/>
              <a:gd name="connsiteX8" fmla="*/ 0 w 9144000"/>
              <a:gd name="connsiteY8" fmla="*/ 3783806 h 4098155"/>
              <a:gd name="connsiteX9" fmla="*/ 0 w 9144000"/>
              <a:gd name="connsiteY9" fmla="*/ 0 h 4098155"/>
              <a:gd name="connsiteX0" fmla="*/ 0 w 9144000"/>
              <a:gd name="connsiteY0" fmla="*/ 0 h 4098155"/>
              <a:gd name="connsiteX1" fmla="*/ 9144000 w 9144000"/>
              <a:gd name="connsiteY1" fmla="*/ 0 h 4098155"/>
              <a:gd name="connsiteX2" fmla="*/ 9144000 w 9144000"/>
              <a:gd name="connsiteY2" fmla="*/ 3783806 h 4098155"/>
              <a:gd name="connsiteX3" fmla="*/ 945356 w 9144000"/>
              <a:gd name="connsiteY3" fmla="*/ 3786189 h 4098155"/>
              <a:gd name="connsiteX4" fmla="*/ 850106 w 9144000"/>
              <a:gd name="connsiteY4" fmla="*/ 3974305 h 4098155"/>
              <a:gd name="connsiteX5" fmla="*/ 802480 w 9144000"/>
              <a:gd name="connsiteY5" fmla="*/ 4098131 h 4098155"/>
              <a:gd name="connsiteX6" fmla="*/ 766763 w 9144000"/>
              <a:gd name="connsiteY6" fmla="*/ 3983830 h 4098155"/>
              <a:gd name="connsiteX7" fmla="*/ 666750 w 9144000"/>
              <a:gd name="connsiteY7" fmla="*/ 3781425 h 4098155"/>
              <a:gd name="connsiteX8" fmla="*/ 0 w 9144000"/>
              <a:gd name="connsiteY8" fmla="*/ 3783806 h 4098155"/>
              <a:gd name="connsiteX9" fmla="*/ 0 w 9144000"/>
              <a:gd name="connsiteY9" fmla="*/ 0 h 4098155"/>
              <a:gd name="connsiteX0" fmla="*/ 0 w 9144000"/>
              <a:gd name="connsiteY0" fmla="*/ 0 h 4099570"/>
              <a:gd name="connsiteX1" fmla="*/ 9144000 w 9144000"/>
              <a:gd name="connsiteY1" fmla="*/ 0 h 4099570"/>
              <a:gd name="connsiteX2" fmla="*/ 9144000 w 9144000"/>
              <a:gd name="connsiteY2" fmla="*/ 3783806 h 4099570"/>
              <a:gd name="connsiteX3" fmla="*/ 945356 w 9144000"/>
              <a:gd name="connsiteY3" fmla="*/ 3786189 h 4099570"/>
              <a:gd name="connsiteX4" fmla="*/ 850106 w 9144000"/>
              <a:gd name="connsiteY4" fmla="*/ 3974305 h 4099570"/>
              <a:gd name="connsiteX5" fmla="*/ 802480 w 9144000"/>
              <a:gd name="connsiteY5" fmla="*/ 4098131 h 4099570"/>
              <a:gd name="connsiteX6" fmla="*/ 766763 w 9144000"/>
              <a:gd name="connsiteY6" fmla="*/ 3983830 h 4099570"/>
              <a:gd name="connsiteX7" fmla="*/ 666750 w 9144000"/>
              <a:gd name="connsiteY7" fmla="*/ 3781425 h 4099570"/>
              <a:gd name="connsiteX8" fmla="*/ 0 w 9144000"/>
              <a:gd name="connsiteY8" fmla="*/ 3783806 h 4099570"/>
              <a:gd name="connsiteX9" fmla="*/ 0 w 9144000"/>
              <a:gd name="connsiteY9" fmla="*/ 0 h 4099570"/>
              <a:gd name="connsiteX0" fmla="*/ 0 w 9144000"/>
              <a:gd name="connsiteY0" fmla="*/ 0 h 4098135"/>
              <a:gd name="connsiteX1" fmla="*/ 9144000 w 9144000"/>
              <a:gd name="connsiteY1" fmla="*/ 0 h 4098135"/>
              <a:gd name="connsiteX2" fmla="*/ 9144000 w 9144000"/>
              <a:gd name="connsiteY2" fmla="*/ 3783806 h 4098135"/>
              <a:gd name="connsiteX3" fmla="*/ 945356 w 9144000"/>
              <a:gd name="connsiteY3" fmla="*/ 3786189 h 4098135"/>
              <a:gd name="connsiteX4" fmla="*/ 850106 w 9144000"/>
              <a:gd name="connsiteY4" fmla="*/ 3974305 h 4098135"/>
              <a:gd name="connsiteX5" fmla="*/ 802480 w 9144000"/>
              <a:gd name="connsiteY5" fmla="*/ 4098131 h 4098135"/>
              <a:gd name="connsiteX6" fmla="*/ 766763 w 9144000"/>
              <a:gd name="connsiteY6" fmla="*/ 3983830 h 4098135"/>
              <a:gd name="connsiteX7" fmla="*/ 666750 w 9144000"/>
              <a:gd name="connsiteY7" fmla="*/ 3781425 h 4098135"/>
              <a:gd name="connsiteX8" fmla="*/ 0 w 9144000"/>
              <a:gd name="connsiteY8" fmla="*/ 3783806 h 4098135"/>
              <a:gd name="connsiteX9" fmla="*/ 0 w 9144000"/>
              <a:gd name="connsiteY9" fmla="*/ 0 h 4098135"/>
              <a:gd name="connsiteX0" fmla="*/ 0 w 9144000"/>
              <a:gd name="connsiteY0" fmla="*/ 0 h 4100517"/>
              <a:gd name="connsiteX1" fmla="*/ 9144000 w 9144000"/>
              <a:gd name="connsiteY1" fmla="*/ 0 h 4100517"/>
              <a:gd name="connsiteX2" fmla="*/ 9144000 w 9144000"/>
              <a:gd name="connsiteY2" fmla="*/ 3783806 h 4100517"/>
              <a:gd name="connsiteX3" fmla="*/ 945356 w 9144000"/>
              <a:gd name="connsiteY3" fmla="*/ 3786189 h 4100517"/>
              <a:gd name="connsiteX4" fmla="*/ 850106 w 9144000"/>
              <a:gd name="connsiteY4" fmla="*/ 3974305 h 4100517"/>
              <a:gd name="connsiteX5" fmla="*/ 816767 w 9144000"/>
              <a:gd name="connsiteY5" fmla="*/ 4100513 h 4100517"/>
              <a:gd name="connsiteX6" fmla="*/ 766763 w 9144000"/>
              <a:gd name="connsiteY6" fmla="*/ 3983830 h 4100517"/>
              <a:gd name="connsiteX7" fmla="*/ 666750 w 9144000"/>
              <a:gd name="connsiteY7" fmla="*/ 3781425 h 4100517"/>
              <a:gd name="connsiteX8" fmla="*/ 0 w 9144000"/>
              <a:gd name="connsiteY8" fmla="*/ 3783806 h 4100517"/>
              <a:gd name="connsiteX9" fmla="*/ 0 w 9144000"/>
              <a:gd name="connsiteY9" fmla="*/ 0 h 4100517"/>
              <a:gd name="connsiteX0" fmla="*/ 0 w 9144000"/>
              <a:gd name="connsiteY0" fmla="*/ 0 h 4021977"/>
              <a:gd name="connsiteX1" fmla="*/ 9144000 w 9144000"/>
              <a:gd name="connsiteY1" fmla="*/ 0 h 4021977"/>
              <a:gd name="connsiteX2" fmla="*/ 9144000 w 9144000"/>
              <a:gd name="connsiteY2" fmla="*/ 3783806 h 4021977"/>
              <a:gd name="connsiteX3" fmla="*/ 945356 w 9144000"/>
              <a:gd name="connsiteY3" fmla="*/ 3786189 h 4021977"/>
              <a:gd name="connsiteX4" fmla="*/ 850106 w 9144000"/>
              <a:gd name="connsiteY4" fmla="*/ 3974305 h 4021977"/>
              <a:gd name="connsiteX5" fmla="*/ 807242 w 9144000"/>
              <a:gd name="connsiteY5" fmla="*/ 4021931 h 4021977"/>
              <a:gd name="connsiteX6" fmla="*/ 766763 w 9144000"/>
              <a:gd name="connsiteY6" fmla="*/ 3983830 h 4021977"/>
              <a:gd name="connsiteX7" fmla="*/ 666750 w 9144000"/>
              <a:gd name="connsiteY7" fmla="*/ 3781425 h 4021977"/>
              <a:gd name="connsiteX8" fmla="*/ 0 w 9144000"/>
              <a:gd name="connsiteY8" fmla="*/ 3783806 h 4021977"/>
              <a:gd name="connsiteX9" fmla="*/ 0 w 9144000"/>
              <a:gd name="connsiteY9" fmla="*/ 0 h 4021977"/>
              <a:gd name="connsiteX0" fmla="*/ 0 w 9144000"/>
              <a:gd name="connsiteY0" fmla="*/ 0 h 4022430"/>
              <a:gd name="connsiteX1" fmla="*/ 9144000 w 9144000"/>
              <a:gd name="connsiteY1" fmla="*/ 0 h 4022430"/>
              <a:gd name="connsiteX2" fmla="*/ 9144000 w 9144000"/>
              <a:gd name="connsiteY2" fmla="*/ 3783806 h 4022430"/>
              <a:gd name="connsiteX3" fmla="*/ 945356 w 9144000"/>
              <a:gd name="connsiteY3" fmla="*/ 3786189 h 4022430"/>
              <a:gd name="connsiteX4" fmla="*/ 850106 w 9144000"/>
              <a:gd name="connsiteY4" fmla="*/ 3974305 h 4022430"/>
              <a:gd name="connsiteX5" fmla="*/ 807242 w 9144000"/>
              <a:gd name="connsiteY5" fmla="*/ 4021931 h 4022430"/>
              <a:gd name="connsiteX6" fmla="*/ 766763 w 9144000"/>
              <a:gd name="connsiteY6" fmla="*/ 3983830 h 4022430"/>
              <a:gd name="connsiteX7" fmla="*/ 666750 w 9144000"/>
              <a:gd name="connsiteY7" fmla="*/ 3781425 h 4022430"/>
              <a:gd name="connsiteX8" fmla="*/ 0 w 9144000"/>
              <a:gd name="connsiteY8" fmla="*/ 3783806 h 4022430"/>
              <a:gd name="connsiteX9" fmla="*/ 0 w 9144000"/>
              <a:gd name="connsiteY9" fmla="*/ 0 h 4022430"/>
              <a:gd name="connsiteX0" fmla="*/ 0 w 9144000"/>
              <a:gd name="connsiteY0" fmla="*/ 0 h 4022430"/>
              <a:gd name="connsiteX1" fmla="*/ 9144000 w 9144000"/>
              <a:gd name="connsiteY1" fmla="*/ 0 h 4022430"/>
              <a:gd name="connsiteX2" fmla="*/ 9144000 w 9144000"/>
              <a:gd name="connsiteY2" fmla="*/ 3783806 h 4022430"/>
              <a:gd name="connsiteX3" fmla="*/ 945356 w 9144000"/>
              <a:gd name="connsiteY3" fmla="*/ 3786189 h 4022430"/>
              <a:gd name="connsiteX4" fmla="*/ 850106 w 9144000"/>
              <a:gd name="connsiteY4" fmla="*/ 3974305 h 4022430"/>
              <a:gd name="connsiteX5" fmla="*/ 807242 w 9144000"/>
              <a:gd name="connsiteY5" fmla="*/ 4021931 h 4022430"/>
              <a:gd name="connsiteX6" fmla="*/ 766763 w 9144000"/>
              <a:gd name="connsiteY6" fmla="*/ 3983830 h 4022430"/>
              <a:gd name="connsiteX7" fmla="*/ 666750 w 9144000"/>
              <a:gd name="connsiteY7" fmla="*/ 3781425 h 4022430"/>
              <a:gd name="connsiteX8" fmla="*/ 0 w 9144000"/>
              <a:gd name="connsiteY8" fmla="*/ 3783806 h 4022430"/>
              <a:gd name="connsiteX9" fmla="*/ 0 w 9144000"/>
              <a:gd name="connsiteY9" fmla="*/ 0 h 4022430"/>
              <a:gd name="connsiteX0" fmla="*/ 0 w 9144000"/>
              <a:gd name="connsiteY0" fmla="*/ 0 h 4024744"/>
              <a:gd name="connsiteX1" fmla="*/ 9144000 w 9144000"/>
              <a:gd name="connsiteY1" fmla="*/ 0 h 4024744"/>
              <a:gd name="connsiteX2" fmla="*/ 9144000 w 9144000"/>
              <a:gd name="connsiteY2" fmla="*/ 3783806 h 4024744"/>
              <a:gd name="connsiteX3" fmla="*/ 945356 w 9144000"/>
              <a:gd name="connsiteY3" fmla="*/ 3786189 h 4024744"/>
              <a:gd name="connsiteX4" fmla="*/ 850106 w 9144000"/>
              <a:gd name="connsiteY4" fmla="*/ 3974305 h 4024744"/>
              <a:gd name="connsiteX5" fmla="*/ 804860 w 9144000"/>
              <a:gd name="connsiteY5" fmla="*/ 4024313 h 4024744"/>
              <a:gd name="connsiteX6" fmla="*/ 766763 w 9144000"/>
              <a:gd name="connsiteY6" fmla="*/ 3983830 h 4024744"/>
              <a:gd name="connsiteX7" fmla="*/ 666750 w 9144000"/>
              <a:gd name="connsiteY7" fmla="*/ 3781425 h 4024744"/>
              <a:gd name="connsiteX8" fmla="*/ 0 w 9144000"/>
              <a:gd name="connsiteY8" fmla="*/ 3783806 h 4024744"/>
              <a:gd name="connsiteX9" fmla="*/ 0 w 9144000"/>
              <a:gd name="connsiteY9" fmla="*/ 0 h 4024744"/>
              <a:gd name="connsiteX0" fmla="*/ 0 w 9144000"/>
              <a:gd name="connsiteY0" fmla="*/ 0 h 4024342"/>
              <a:gd name="connsiteX1" fmla="*/ 9144000 w 9144000"/>
              <a:gd name="connsiteY1" fmla="*/ 0 h 4024342"/>
              <a:gd name="connsiteX2" fmla="*/ 9144000 w 9144000"/>
              <a:gd name="connsiteY2" fmla="*/ 3783806 h 4024342"/>
              <a:gd name="connsiteX3" fmla="*/ 945356 w 9144000"/>
              <a:gd name="connsiteY3" fmla="*/ 3786189 h 4024342"/>
              <a:gd name="connsiteX4" fmla="*/ 850106 w 9144000"/>
              <a:gd name="connsiteY4" fmla="*/ 3974305 h 4024342"/>
              <a:gd name="connsiteX5" fmla="*/ 804860 w 9144000"/>
              <a:gd name="connsiteY5" fmla="*/ 4024313 h 4024342"/>
              <a:gd name="connsiteX6" fmla="*/ 766763 w 9144000"/>
              <a:gd name="connsiteY6" fmla="*/ 3983830 h 4024342"/>
              <a:gd name="connsiteX7" fmla="*/ 666750 w 9144000"/>
              <a:gd name="connsiteY7" fmla="*/ 3781425 h 4024342"/>
              <a:gd name="connsiteX8" fmla="*/ 0 w 9144000"/>
              <a:gd name="connsiteY8" fmla="*/ 3783806 h 4024342"/>
              <a:gd name="connsiteX9" fmla="*/ 0 w 9144000"/>
              <a:gd name="connsiteY9" fmla="*/ 0 h 4024342"/>
              <a:gd name="connsiteX0" fmla="*/ 0 w 9144000"/>
              <a:gd name="connsiteY0" fmla="*/ 0 h 4024342"/>
              <a:gd name="connsiteX1" fmla="*/ 9144000 w 9144000"/>
              <a:gd name="connsiteY1" fmla="*/ 0 h 4024342"/>
              <a:gd name="connsiteX2" fmla="*/ 9144000 w 9144000"/>
              <a:gd name="connsiteY2" fmla="*/ 3783806 h 4024342"/>
              <a:gd name="connsiteX3" fmla="*/ 945356 w 9144000"/>
              <a:gd name="connsiteY3" fmla="*/ 3786189 h 4024342"/>
              <a:gd name="connsiteX4" fmla="*/ 850106 w 9144000"/>
              <a:gd name="connsiteY4" fmla="*/ 3974305 h 4024342"/>
              <a:gd name="connsiteX5" fmla="*/ 804860 w 9144000"/>
              <a:gd name="connsiteY5" fmla="*/ 4024313 h 4024342"/>
              <a:gd name="connsiteX6" fmla="*/ 766763 w 9144000"/>
              <a:gd name="connsiteY6" fmla="*/ 3983830 h 4024342"/>
              <a:gd name="connsiteX7" fmla="*/ 666750 w 9144000"/>
              <a:gd name="connsiteY7" fmla="*/ 3781425 h 4024342"/>
              <a:gd name="connsiteX8" fmla="*/ 0 w 9144000"/>
              <a:gd name="connsiteY8" fmla="*/ 3783806 h 4024342"/>
              <a:gd name="connsiteX9" fmla="*/ 0 w 9144000"/>
              <a:gd name="connsiteY9" fmla="*/ 0 h 4024342"/>
              <a:gd name="connsiteX0" fmla="*/ 0 w 9144000"/>
              <a:gd name="connsiteY0" fmla="*/ 0 h 4024784"/>
              <a:gd name="connsiteX1" fmla="*/ 9144000 w 9144000"/>
              <a:gd name="connsiteY1" fmla="*/ 0 h 4024784"/>
              <a:gd name="connsiteX2" fmla="*/ 9144000 w 9144000"/>
              <a:gd name="connsiteY2" fmla="*/ 3783806 h 4024784"/>
              <a:gd name="connsiteX3" fmla="*/ 945356 w 9144000"/>
              <a:gd name="connsiteY3" fmla="*/ 3786189 h 4024784"/>
              <a:gd name="connsiteX4" fmla="*/ 850106 w 9144000"/>
              <a:gd name="connsiteY4" fmla="*/ 3974305 h 4024784"/>
              <a:gd name="connsiteX5" fmla="*/ 804860 w 9144000"/>
              <a:gd name="connsiteY5" fmla="*/ 4024313 h 4024784"/>
              <a:gd name="connsiteX6" fmla="*/ 766763 w 9144000"/>
              <a:gd name="connsiteY6" fmla="*/ 3983830 h 4024784"/>
              <a:gd name="connsiteX7" fmla="*/ 666750 w 9144000"/>
              <a:gd name="connsiteY7" fmla="*/ 3781425 h 4024784"/>
              <a:gd name="connsiteX8" fmla="*/ 0 w 9144000"/>
              <a:gd name="connsiteY8" fmla="*/ 3783806 h 4024784"/>
              <a:gd name="connsiteX9" fmla="*/ 0 w 9144000"/>
              <a:gd name="connsiteY9" fmla="*/ 0 h 4024784"/>
              <a:gd name="connsiteX0" fmla="*/ 0 w 9144000"/>
              <a:gd name="connsiteY0" fmla="*/ 0 h 4024784"/>
              <a:gd name="connsiteX1" fmla="*/ 9144000 w 9144000"/>
              <a:gd name="connsiteY1" fmla="*/ 0 h 4024784"/>
              <a:gd name="connsiteX2" fmla="*/ 9144000 w 9144000"/>
              <a:gd name="connsiteY2" fmla="*/ 3783806 h 4024784"/>
              <a:gd name="connsiteX3" fmla="*/ 942975 w 9144000"/>
              <a:gd name="connsiteY3" fmla="*/ 3788570 h 4024784"/>
              <a:gd name="connsiteX4" fmla="*/ 850106 w 9144000"/>
              <a:gd name="connsiteY4" fmla="*/ 3974305 h 4024784"/>
              <a:gd name="connsiteX5" fmla="*/ 804860 w 9144000"/>
              <a:gd name="connsiteY5" fmla="*/ 4024313 h 4024784"/>
              <a:gd name="connsiteX6" fmla="*/ 766763 w 9144000"/>
              <a:gd name="connsiteY6" fmla="*/ 3983830 h 4024784"/>
              <a:gd name="connsiteX7" fmla="*/ 666750 w 9144000"/>
              <a:gd name="connsiteY7" fmla="*/ 3781425 h 4024784"/>
              <a:gd name="connsiteX8" fmla="*/ 0 w 9144000"/>
              <a:gd name="connsiteY8" fmla="*/ 3783806 h 4024784"/>
              <a:gd name="connsiteX9" fmla="*/ 0 w 9144000"/>
              <a:gd name="connsiteY9" fmla="*/ 0 h 4024784"/>
              <a:gd name="connsiteX0" fmla="*/ 0 w 9144000"/>
              <a:gd name="connsiteY0" fmla="*/ 0 h 4024870"/>
              <a:gd name="connsiteX1" fmla="*/ 9144000 w 9144000"/>
              <a:gd name="connsiteY1" fmla="*/ 0 h 4024870"/>
              <a:gd name="connsiteX2" fmla="*/ 9144000 w 9144000"/>
              <a:gd name="connsiteY2" fmla="*/ 3783806 h 4024870"/>
              <a:gd name="connsiteX3" fmla="*/ 942975 w 9144000"/>
              <a:gd name="connsiteY3" fmla="*/ 3788570 h 4024870"/>
              <a:gd name="connsiteX4" fmla="*/ 850106 w 9144000"/>
              <a:gd name="connsiteY4" fmla="*/ 3971924 h 4024870"/>
              <a:gd name="connsiteX5" fmla="*/ 804860 w 9144000"/>
              <a:gd name="connsiteY5" fmla="*/ 4024313 h 4024870"/>
              <a:gd name="connsiteX6" fmla="*/ 766763 w 9144000"/>
              <a:gd name="connsiteY6" fmla="*/ 3983830 h 4024870"/>
              <a:gd name="connsiteX7" fmla="*/ 666750 w 9144000"/>
              <a:gd name="connsiteY7" fmla="*/ 3781425 h 4024870"/>
              <a:gd name="connsiteX8" fmla="*/ 0 w 9144000"/>
              <a:gd name="connsiteY8" fmla="*/ 3783806 h 4024870"/>
              <a:gd name="connsiteX9" fmla="*/ 0 w 9144000"/>
              <a:gd name="connsiteY9" fmla="*/ 0 h 4024870"/>
              <a:gd name="connsiteX0" fmla="*/ 0 w 9144000"/>
              <a:gd name="connsiteY0" fmla="*/ 0 h 4024870"/>
              <a:gd name="connsiteX1" fmla="*/ 9144000 w 9144000"/>
              <a:gd name="connsiteY1" fmla="*/ 0 h 4024870"/>
              <a:gd name="connsiteX2" fmla="*/ 9144000 w 9144000"/>
              <a:gd name="connsiteY2" fmla="*/ 3783806 h 4024870"/>
              <a:gd name="connsiteX3" fmla="*/ 940594 w 9144000"/>
              <a:gd name="connsiteY3" fmla="*/ 3786188 h 4024870"/>
              <a:gd name="connsiteX4" fmla="*/ 850106 w 9144000"/>
              <a:gd name="connsiteY4" fmla="*/ 3971924 h 4024870"/>
              <a:gd name="connsiteX5" fmla="*/ 804860 w 9144000"/>
              <a:gd name="connsiteY5" fmla="*/ 4024313 h 4024870"/>
              <a:gd name="connsiteX6" fmla="*/ 766763 w 9144000"/>
              <a:gd name="connsiteY6" fmla="*/ 3983830 h 4024870"/>
              <a:gd name="connsiteX7" fmla="*/ 666750 w 9144000"/>
              <a:gd name="connsiteY7" fmla="*/ 3781425 h 4024870"/>
              <a:gd name="connsiteX8" fmla="*/ 0 w 9144000"/>
              <a:gd name="connsiteY8" fmla="*/ 3783806 h 4024870"/>
              <a:gd name="connsiteX9" fmla="*/ 0 w 9144000"/>
              <a:gd name="connsiteY9" fmla="*/ 0 h 4024870"/>
              <a:gd name="connsiteX0" fmla="*/ 0 w 9144000"/>
              <a:gd name="connsiteY0" fmla="*/ 0 h 4024870"/>
              <a:gd name="connsiteX1" fmla="*/ 9144000 w 9144000"/>
              <a:gd name="connsiteY1" fmla="*/ 0 h 4024870"/>
              <a:gd name="connsiteX2" fmla="*/ 9144000 w 9144000"/>
              <a:gd name="connsiteY2" fmla="*/ 3783806 h 4024870"/>
              <a:gd name="connsiteX3" fmla="*/ 940594 w 9144000"/>
              <a:gd name="connsiteY3" fmla="*/ 3786188 h 4024870"/>
              <a:gd name="connsiteX4" fmla="*/ 850106 w 9144000"/>
              <a:gd name="connsiteY4" fmla="*/ 3971924 h 4024870"/>
              <a:gd name="connsiteX5" fmla="*/ 804860 w 9144000"/>
              <a:gd name="connsiteY5" fmla="*/ 4024313 h 4024870"/>
              <a:gd name="connsiteX6" fmla="*/ 766763 w 9144000"/>
              <a:gd name="connsiteY6" fmla="*/ 3983830 h 4024870"/>
              <a:gd name="connsiteX7" fmla="*/ 669131 w 9144000"/>
              <a:gd name="connsiteY7" fmla="*/ 3786188 h 4024870"/>
              <a:gd name="connsiteX8" fmla="*/ 0 w 9144000"/>
              <a:gd name="connsiteY8" fmla="*/ 3783806 h 4024870"/>
              <a:gd name="connsiteX9" fmla="*/ 0 w 9144000"/>
              <a:gd name="connsiteY9" fmla="*/ 0 h 4024870"/>
              <a:gd name="connsiteX0" fmla="*/ 0 w 9144000"/>
              <a:gd name="connsiteY0" fmla="*/ 0 h 4024870"/>
              <a:gd name="connsiteX1" fmla="*/ 9144000 w 9144000"/>
              <a:gd name="connsiteY1" fmla="*/ 0 h 4024870"/>
              <a:gd name="connsiteX2" fmla="*/ 9144000 w 9144000"/>
              <a:gd name="connsiteY2" fmla="*/ 3790950 h 4024870"/>
              <a:gd name="connsiteX3" fmla="*/ 940594 w 9144000"/>
              <a:gd name="connsiteY3" fmla="*/ 3786188 h 4024870"/>
              <a:gd name="connsiteX4" fmla="*/ 850106 w 9144000"/>
              <a:gd name="connsiteY4" fmla="*/ 3971924 h 4024870"/>
              <a:gd name="connsiteX5" fmla="*/ 804860 w 9144000"/>
              <a:gd name="connsiteY5" fmla="*/ 4024313 h 4024870"/>
              <a:gd name="connsiteX6" fmla="*/ 766763 w 9144000"/>
              <a:gd name="connsiteY6" fmla="*/ 3983830 h 4024870"/>
              <a:gd name="connsiteX7" fmla="*/ 669131 w 9144000"/>
              <a:gd name="connsiteY7" fmla="*/ 3786188 h 4024870"/>
              <a:gd name="connsiteX8" fmla="*/ 0 w 9144000"/>
              <a:gd name="connsiteY8" fmla="*/ 3783806 h 4024870"/>
              <a:gd name="connsiteX9" fmla="*/ 0 w 9144000"/>
              <a:gd name="connsiteY9" fmla="*/ 0 h 4024870"/>
              <a:gd name="connsiteX0" fmla="*/ 0 w 9144000"/>
              <a:gd name="connsiteY0" fmla="*/ 0 h 4079133"/>
              <a:gd name="connsiteX1" fmla="*/ 9144000 w 9144000"/>
              <a:gd name="connsiteY1" fmla="*/ 0 h 4079133"/>
              <a:gd name="connsiteX2" fmla="*/ 9144000 w 9144000"/>
              <a:gd name="connsiteY2" fmla="*/ 3790950 h 4079133"/>
              <a:gd name="connsiteX3" fmla="*/ 940594 w 9144000"/>
              <a:gd name="connsiteY3" fmla="*/ 3786188 h 4079133"/>
              <a:gd name="connsiteX4" fmla="*/ 850106 w 9144000"/>
              <a:gd name="connsiteY4" fmla="*/ 3971924 h 4079133"/>
              <a:gd name="connsiteX5" fmla="*/ 804860 w 9144000"/>
              <a:gd name="connsiteY5" fmla="*/ 4079082 h 4079133"/>
              <a:gd name="connsiteX6" fmla="*/ 766763 w 9144000"/>
              <a:gd name="connsiteY6" fmla="*/ 3983830 h 4079133"/>
              <a:gd name="connsiteX7" fmla="*/ 669131 w 9144000"/>
              <a:gd name="connsiteY7" fmla="*/ 3786188 h 4079133"/>
              <a:gd name="connsiteX8" fmla="*/ 0 w 9144000"/>
              <a:gd name="connsiteY8" fmla="*/ 3783806 h 4079133"/>
              <a:gd name="connsiteX9" fmla="*/ 0 w 9144000"/>
              <a:gd name="connsiteY9" fmla="*/ 0 h 4079133"/>
              <a:gd name="connsiteX0" fmla="*/ 0 w 9144000"/>
              <a:gd name="connsiteY0" fmla="*/ 0 h 4079133"/>
              <a:gd name="connsiteX1" fmla="*/ 9144000 w 9144000"/>
              <a:gd name="connsiteY1" fmla="*/ 0 h 4079133"/>
              <a:gd name="connsiteX2" fmla="*/ 9144000 w 9144000"/>
              <a:gd name="connsiteY2" fmla="*/ 3790950 h 4079133"/>
              <a:gd name="connsiteX3" fmla="*/ 940594 w 9144000"/>
              <a:gd name="connsiteY3" fmla="*/ 3786188 h 4079133"/>
              <a:gd name="connsiteX4" fmla="*/ 850106 w 9144000"/>
              <a:gd name="connsiteY4" fmla="*/ 3971924 h 4079133"/>
              <a:gd name="connsiteX5" fmla="*/ 804860 w 9144000"/>
              <a:gd name="connsiteY5" fmla="*/ 4079082 h 4079133"/>
              <a:gd name="connsiteX6" fmla="*/ 766763 w 9144000"/>
              <a:gd name="connsiteY6" fmla="*/ 3983830 h 4079133"/>
              <a:gd name="connsiteX7" fmla="*/ 669131 w 9144000"/>
              <a:gd name="connsiteY7" fmla="*/ 3786188 h 4079133"/>
              <a:gd name="connsiteX8" fmla="*/ 0 w 9144000"/>
              <a:gd name="connsiteY8" fmla="*/ 3783806 h 4079133"/>
              <a:gd name="connsiteX9" fmla="*/ 0 w 9144000"/>
              <a:gd name="connsiteY9" fmla="*/ 0 h 4079133"/>
              <a:gd name="connsiteX0" fmla="*/ 0 w 9144000"/>
              <a:gd name="connsiteY0" fmla="*/ 0 h 4022693"/>
              <a:gd name="connsiteX1" fmla="*/ 9144000 w 9144000"/>
              <a:gd name="connsiteY1" fmla="*/ 0 h 4022693"/>
              <a:gd name="connsiteX2" fmla="*/ 9144000 w 9144000"/>
              <a:gd name="connsiteY2" fmla="*/ 3790950 h 4022693"/>
              <a:gd name="connsiteX3" fmla="*/ 940594 w 9144000"/>
              <a:gd name="connsiteY3" fmla="*/ 3786188 h 4022693"/>
              <a:gd name="connsiteX4" fmla="*/ 850106 w 9144000"/>
              <a:gd name="connsiteY4" fmla="*/ 3971924 h 4022693"/>
              <a:gd name="connsiteX5" fmla="*/ 800097 w 9144000"/>
              <a:gd name="connsiteY5" fmla="*/ 4021932 h 4022693"/>
              <a:gd name="connsiteX6" fmla="*/ 766763 w 9144000"/>
              <a:gd name="connsiteY6" fmla="*/ 3983830 h 4022693"/>
              <a:gd name="connsiteX7" fmla="*/ 669131 w 9144000"/>
              <a:gd name="connsiteY7" fmla="*/ 3786188 h 4022693"/>
              <a:gd name="connsiteX8" fmla="*/ 0 w 9144000"/>
              <a:gd name="connsiteY8" fmla="*/ 3783806 h 4022693"/>
              <a:gd name="connsiteX9" fmla="*/ 0 w 9144000"/>
              <a:gd name="connsiteY9" fmla="*/ 0 h 4022693"/>
              <a:gd name="connsiteX0" fmla="*/ 0 w 9144000"/>
              <a:gd name="connsiteY0" fmla="*/ 0 h 4022693"/>
              <a:gd name="connsiteX1" fmla="*/ 9144000 w 9144000"/>
              <a:gd name="connsiteY1" fmla="*/ 0 h 4022693"/>
              <a:gd name="connsiteX2" fmla="*/ 9144000 w 9144000"/>
              <a:gd name="connsiteY2" fmla="*/ 3790950 h 4022693"/>
              <a:gd name="connsiteX3" fmla="*/ 940594 w 9144000"/>
              <a:gd name="connsiteY3" fmla="*/ 3786188 h 4022693"/>
              <a:gd name="connsiteX4" fmla="*/ 850106 w 9144000"/>
              <a:gd name="connsiteY4" fmla="*/ 3971924 h 4022693"/>
              <a:gd name="connsiteX5" fmla="*/ 800097 w 9144000"/>
              <a:gd name="connsiteY5" fmla="*/ 4021932 h 4022693"/>
              <a:gd name="connsiteX6" fmla="*/ 766763 w 9144000"/>
              <a:gd name="connsiteY6" fmla="*/ 3983830 h 4022693"/>
              <a:gd name="connsiteX7" fmla="*/ 669131 w 9144000"/>
              <a:gd name="connsiteY7" fmla="*/ 3786188 h 4022693"/>
              <a:gd name="connsiteX8" fmla="*/ 0 w 9144000"/>
              <a:gd name="connsiteY8" fmla="*/ 3783806 h 4022693"/>
              <a:gd name="connsiteX9" fmla="*/ 0 w 9144000"/>
              <a:gd name="connsiteY9" fmla="*/ 0 h 4022693"/>
              <a:gd name="connsiteX0" fmla="*/ 0 w 9144000"/>
              <a:gd name="connsiteY0" fmla="*/ 0 h 4022693"/>
              <a:gd name="connsiteX1" fmla="*/ 9144000 w 9144000"/>
              <a:gd name="connsiteY1" fmla="*/ 0 h 4022693"/>
              <a:gd name="connsiteX2" fmla="*/ 9144000 w 9144000"/>
              <a:gd name="connsiteY2" fmla="*/ 3790950 h 4022693"/>
              <a:gd name="connsiteX3" fmla="*/ 940594 w 9144000"/>
              <a:gd name="connsiteY3" fmla="*/ 3786188 h 4022693"/>
              <a:gd name="connsiteX4" fmla="*/ 850106 w 9144000"/>
              <a:gd name="connsiteY4" fmla="*/ 3971924 h 4022693"/>
              <a:gd name="connsiteX5" fmla="*/ 800097 w 9144000"/>
              <a:gd name="connsiteY5" fmla="*/ 4021932 h 4022693"/>
              <a:gd name="connsiteX6" fmla="*/ 766763 w 9144000"/>
              <a:gd name="connsiteY6" fmla="*/ 3983830 h 4022693"/>
              <a:gd name="connsiteX7" fmla="*/ 669131 w 9144000"/>
              <a:gd name="connsiteY7" fmla="*/ 3786188 h 4022693"/>
              <a:gd name="connsiteX8" fmla="*/ 0 w 9144000"/>
              <a:gd name="connsiteY8" fmla="*/ 3783806 h 4022693"/>
              <a:gd name="connsiteX9" fmla="*/ 0 w 9144000"/>
              <a:gd name="connsiteY9" fmla="*/ 0 h 4022693"/>
              <a:gd name="connsiteX0" fmla="*/ 0 w 9144000"/>
              <a:gd name="connsiteY0" fmla="*/ 0 h 4022693"/>
              <a:gd name="connsiteX1" fmla="*/ 9144000 w 9144000"/>
              <a:gd name="connsiteY1" fmla="*/ 0 h 4022693"/>
              <a:gd name="connsiteX2" fmla="*/ 9144000 w 9144000"/>
              <a:gd name="connsiteY2" fmla="*/ 3790950 h 4022693"/>
              <a:gd name="connsiteX3" fmla="*/ 940594 w 9144000"/>
              <a:gd name="connsiteY3" fmla="*/ 3786188 h 4022693"/>
              <a:gd name="connsiteX4" fmla="*/ 850106 w 9144000"/>
              <a:gd name="connsiteY4" fmla="*/ 3971924 h 4022693"/>
              <a:gd name="connsiteX5" fmla="*/ 804860 w 9144000"/>
              <a:gd name="connsiteY5" fmla="*/ 4021932 h 4022693"/>
              <a:gd name="connsiteX6" fmla="*/ 766763 w 9144000"/>
              <a:gd name="connsiteY6" fmla="*/ 3983830 h 4022693"/>
              <a:gd name="connsiteX7" fmla="*/ 669131 w 9144000"/>
              <a:gd name="connsiteY7" fmla="*/ 3786188 h 4022693"/>
              <a:gd name="connsiteX8" fmla="*/ 0 w 9144000"/>
              <a:gd name="connsiteY8" fmla="*/ 3783806 h 4022693"/>
              <a:gd name="connsiteX9" fmla="*/ 0 w 9144000"/>
              <a:gd name="connsiteY9" fmla="*/ 0 h 4022693"/>
              <a:gd name="connsiteX0" fmla="*/ 0 w 9144000"/>
              <a:gd name="connsiteY0" fmla="*/ 0 h 4021943"/>
              <a:gd name="connsiteX1" fmla="*/ 9144000 w 9144000"/>
              <a:gd name="connsiteY1" fmla="*/ 0 h 4021943"/>
              <a:gd name="connsiteX2" fmla="*/ 9144000 w 9144000"/>
              <a:gd name="connsiteY2" fmla="*/ 3790950 h 4021943"/>
              <a:gd name="connsiteX3" fmla="*/ 940594 w 9144000"/>
              <a:gd name="connsiteY3" fmla="*/ 3786188 h 4021943"/>
              <a:gd name="connsiteX4" fmla="*/ 850106 w 9144000"/>
              <a:gd name="connsiteY4" fmla="*/ 3971924 h 4021943"/>
              <a:gd name="connsiteX5" fmla="*/ 804860 w 9144000"/>
              <a:gd name="connsiteY5" fmla="*/ 4021932 h 4021943"/>
              <a:gd name="connsiteX6" fmla="*/ 766763 w 9144000"/>
              <a:gd name="connsiteY6" fmla="*/ 3983830 h 4021943"/>
              <a:gd name="connsiteX7" fmla="*/ 669131 w 9144000"/>
              <a:gd name="connsiteY7" fmla="*/ 3786188 h 4021943"/>
              <a:gd name="connsiteX8" fmla="*/ 0 w 9144000"/>
              <a:gd name="connsiteY8" fmla="*/ 3783806 h 4021943"/>
              <a:gd name="connsiteX9" fmla="*/ 0 w 9144000"/>
              <a:gd name="connsiteY9" fmla="*/ 0 h 4021943"/>
              <a:gd name="connsiteX0" fmla="*/ 0 w 9144000"/>
              <a:gd name="connsiteY0" fmla="*/ 0 h 4021943"/>
              <a:gd name="connsiteX1" fmla="*/ 9144000 w 9144000"/>
              <a:gd name="connsiteY1" fmla="*/ 0 h 4021943"/>
              <a:gd name="connsiteX2" fmla="*/ 9144000 w 9144000"/>
              <a:gd name="connsiteY2" fmla="*/ 3790950 h 4021943"/>
              <a:gd name="connsiteX3" fmla="*/ 940594 w 9144000"/>
              <a:gd name="connsiteY3" fmla="*/ 3786188 h 4021943"/>
              <a:gd name="connsiteX4" fmla="*/ 850106 w 9144000"/>
              <a:gd name="connsiteY4" fmla="*/ 3971924 h 4021943"/>
              <a:gd name="connsiteX5" fmla="*/ 804860 w 9144000"/>
              <a:gd name="connsiteY5" fmla="*/ 4021932 h 4021943"/>
              <a:gd name="connsiteX6" fmla="*/ 766763 w 9144000"/>
              <a:gd name="connsiteY6" fmla="*/ 3983830 h 4021943"/>
              <a:gd name="connsiteX7" fmla="*/ 669131 w 9144000"/>
              <a:gd name="connsiteY7" fmla="*/ 3786188 h 4021943"/>
              <a:gd name="connsiteX8" fmla="*/ 0 w 9144000"/>
              <a:gd name="connsiteY8" fmla="*/ 3783806 h 4021943"/>
              <a:gd name="connsiteX9" fmla="*/ 0 w 9144000"/>
              <a:gd name="connsiteY9" fmla="*/ 0 h 4021943"/>
              <a:gd name="connsiteX0" fmla="*/ 0 w 9144000"/>
              <a:gd name="connsiteY0" fmla="*/ 0 h 4021932"/>
              <a:gd name="connsiteX1" fmla="*/ 9144000 w 9144000"/>
              <a:gd name="connsiteY1" fmla="*/ 0 h 4021932"/>
              <a:gd name="connsiteX2" fmla="*/ 9144000 w 9144000"/>
              <a:gd name="connsiteY2" fmla="*/ 3790950 h 4021932"/>
              <a:gd name="connsiteX3" fmla="*/ 940594 w 9144000"/>
              <a:gd name="connsiteY3" fmla="*/ 3786188 h 4021932"/>
              <a:gd name="connsiteX4" fmla="*/ 850106 w 9144000"/>
              <a:gd name="connsiteY4" fmla="*/ 3971924 h 4021932"/>
              <a:gd name="connsiteX5" fmla="*/ 804860 w 9144000"/>
              <a:gd name="connsiteY5" fmla="*/ 4021932 h 4021932"/>
              <a:gd name="connsiteX6" fmla="*/ 762000 w 9144000"/>
              <a:gd name="connsiteY6" fmla="*/ 3971923 h 4021932"/>
              <a:gd name="connsiteX7" fmla="*/ 669131 w 9144000"/>
              <a:gd name="connsiteY7" fmla="*/ 3786188 h 4021932"/>
              <a:gd name="connsiteX8" fmla="*/ 0 w 9144000"/>
              <a:gd name="connsiteY8" fmla="*/ 3783806 h 4021932"/>
              <a:gd name="connsiteX9" fmla="*/ 0 w 9144000"/>
              <a:gd name="connsiteY9" fmla="*/ 0 h 4021932"/>
              <a:gd name="connsiteX0" fmla="*/ 0 w 9144000"/>
              <a:gd name="connsiteY0" fmla="*/ 0 h 4021932"/>
              <a:gd name="connsiteX1" fmla="*/ 9144000 w 9144000"/>
              <a:gd name="connsiteY1" fmla="*/ 0 h 4021932"/>
              <a:gd name="connsiteX2" fmla="*/ 9144000 w 9144000"/>
              <a:gd name="connsiteY2" fmla="*/ 3790950 h 4021932"/>
              <a:gd name="connsiteX3" fmla="*/ 940594 w 9144000"/>
              <a:gd name="connsiteY3" fmla="*/ 3786188 h 4021932"/>
              <a:gd name="connsiteX4" fmla="*/ 850106 w 9144000"/>
              <a:gd name="connsiteY4" fmla="*/ 3971924 h 4021932"/>
              <a:gd name="connsiteX5" fmla="*/ 804860 w 9144000"/>
              <a:gd name="connsiteY5" fmla="*/ 4021932 h 4021932"/>
              <a:gd name="connsiteX6" fmla="*/ 762000 w 9144000"/>
              <a:gd name="connsiteY6" fmla="*/ 3971923 h 4021932"/>
              <a:gd name="connsiteX7" fmla="*/ 669131 w 9144000"/>
              <a:gd name="connsiteY7" fmla="*/ 3786188 h 4021932"/>
              <a:gd name="connsiteX8" fmla="*/ 0 w 9144000"/>
              <a:gd name="connsiteY8" fmla="*/ 3783806 h 4021932"/>
              <a:gd name="connsiteX9" fmla="*/ 0 w 9144000"/>
              <a:gd name="connsiteY9" fmla="*/ 0 h 402193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9144000" h="4021932">
                <a:moveTo>
                  <a:pt x="0" y="0"/>
                </a:moveTo>
                <a:lnTo>
                  <a:pt x="9144000" y="0"/>
                </a:lnTo>
                <a:lnTo>
                  <a:pt x="9144000" y="3790950"/>
                </a:lnTo>
                <a:lnTo>
                  <a:pt x="940594" y="3786188"/>
                </a:lnTo>
                <a:cubicBezTo>
                  <a:pt x="897334" y="3870326"/>
                  <a:pt x="872728" y="3931443"/>
                  <a:pt x="850106" y="3971924"/>
                </a:cubicBezTo>
                <a:cubicBezTo>
                  <a:pt x="827484" y="4012405"/>
                  <a:pt x="819544" y="4021932"/>
                  <a:pt x="804860" y="4021932"/>
                </a:cubicBezTo>
                <a:cubicBezTo>
                  <a:pt x="790176" y="4021932"/>
                  <a:pt x="778668" y="4001292"/>
                  <a:pt x="762000" y="3971923"/>
                </a:cubicBezTo>
                <a:cubicBezTo>
                  <a:pt x="738188" y="3930648"/>
                  <a:pt x="711200" y="3876675"/>
                  <a:pt x="669131" y="3786188"/>
                </a:cubicBezTo>
                <a:lnTo>
                  <a:pt x="0" y="3783806"/>
                </a:lnTo>
                <a:lnTo>
                  <a:pt x="0" y="0"/>
                </a:lnTo>
                <a:close/>
              </a:path>
            </a:pathLst>
          </a:custGeom>
        </p:spPr>
        <p:txBody>
          <a:bodyPr anchor="ctr" anchorCtr="0"/>
          <a:lstStyle>
            <a:lvl1pPr marL="0" indent="0" algn="ctr">
              <a:buNone/>
              <a:defRPr/>
            </a:lvl1pPr>
          </a:lstStyle>
          <a:p>
            <a:r>
              <a:rPr lang="en-US"/>
              <a:t>Click icon to add picture</a:t>
            </a:r>
          </a:p>
        </p:txBody>
      </p:sp>
      <p:sp>
        <p:nvSpPr>
          <p:cNvPr id="4" name="TextBox 3"/>
          <p:cNvSpPr txBox="1"/>
          <p:nvPr userDrawn="1"/>
        </p:nvSpPr>
        <p:spPr>
          <a:xfrm>
            <a:off x="796873" y="5455427"/>
            <a:ext cx="4365507" cy="707886"/>
          </a:xfrm>
          <a:prstGeom prst="rect">
            <a:avLst/>
          </a:prstGeom>
          <a:noFill/>
        </p:spPr>
        <p:txBody>
          <a:bodyPr wrap="square" rtlCol="0">
            <a:spAutoFit/>
          </a:bodyPr>
          <a:lstStyle/>
          <a:p>
            <a:r>
              <a:rPr lang="en-US" sz="4000" b="1">
                <a:solidFill>
                  <a:srgbClr val="FFFFFF"/>
                </a:solidFill>
                <a:latin typeface="+mj-lt"/>
              </a:rPr>
              <a:t>THANK</a:t>
            </a:r>
            <a:r>
              <a:rPr lang="en-US" sz="4000" b="1" baseline="0">
                <a:solidFill>
                  <a:srgbClr val="FFFFFF"/>
                </a:solidFill>
                <a:latin typeface="+mj-lt"/>
              </a:rPr>
              <a:t> YOU</a:t>
            </a:r>
            <a:endParaRPr lang="en-US" sz="4000" b="1">
              <a:solidFill>
                <a:srgbClr val="FFFFFF"/>
              </a:solidFill>
              <a:latin typeface="+mj-lt"/>
            </a:endParaRPr>
          </a:p>
        </p:txBody>
      </p:sp>
    </p:spTree>
    <p:extLst>
      <p:ext uri="{BB962C8B-B14F-4D97-AF65-F5344CB8AC3E}">
        <p14:creationId xmlns:p14="http://schemas.microsoft.com/office/powerpoint/2010/main" val="279760036"/>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preserve="1" userDrawn="1">
  <p:cSld name="1_Thank You Text">
    <p:spTree>
      <p:nvGrpSpPr>
        <p:cNvPr id="1" name=""/>
        <p:cNvGrpSpPr/>
        <p:nvPr/>
      </p:nvGrpSpPr>
      <p:grpSpPr>
        <a:xfrm>
          <a:off x="0" y="0"/>
          <a:ext cx="0" cy="0"/>
          <a:chOff x="0" y="0"/>
          <a:chExt cx="0" cy="0"/>
        </a:xfrm>
      </p:grpSpPr>
      <p:sp>
        <p:nvSpPr>
          <p:cNvPr id="3" name="Content Placeholder 2"/>
          <p:cNvSpPr>
            <a:spLocks noGrp="1"/>
          </p:cNvSpPr>
          <p:nvPr>
            <p:ph sz="half" idx="1"/>
          </p:nvPr>
        </p:nvSpPr>
        <p:spPr>
          <a:xfrm>
            <a:off x="609600" y="1781048"/>
            <a:ext cx="3308096" cy="4035553"/>
          </a:xfrm>
        </p:spPr>
        <p:txBody>
          <a:bodyPr vert="horz" lIns="0" tIns="0" rIns="0" bIns="0" rtlCol="0">
            <a:noAutofit/>
          </a:bodyPr>
          <a:lstStyle>
            <a:lvl1pPr marL="0" indent="0">
              <a:spcBef>
                <a:spcPts val="2000"/>
              </a:spcBef>
              <a:buNone/>
              <a:defRPr lang="en-US" sz="1600" b="1" dirty="0">
                <a:solidFill>
                  <a:schemeClr val="accent1"/>
                </a:solidFill>
              </a:defRPr>
            </a:lvl1pPr>
            <a:lvl2pPr marL="455073" indent="-455073">
              <a:spcBef>
                <a:spcPts val="0"/>
              </a:spcBef>
              <a:buNone/>
              <a:defRPr lang="en-US" sz="1600" dirty="0"/>
            </a:lvl2pPr>
            <a:lvl3pPr>
              <a:defRPr lang="en-US" dirty="0"/>
            </a:lvl3pPr>
            <a:lvl4pPr>
              <a:defRPr lang="en-US" dirty="0"/>
            </a:lvl4pPr>
            <a:lvl5pPr>
              <a:defRPr lang="en-US" dirty="0"/>
            </a:lvl5pPr>
          </a:lstStyle>
          <a:p>
            <a:pPr lvl="0"/>
            <a:r>
              <a:rPr lang="en-US"/>
              <a:t>Click to edit Master text styles</a:t>
            </a:r>
          </a:p>
          <a:p>
            <a:pPr lvl="1"/>
            <a:r>
              <a:rPr lang="en-US"/>
              <a:t>Second level</a:t>
            </a:r>
          </a:p>
        </p:txBody>
      </p:sp>
      <p:sp>
        <p:nvSpPr>
          <p:cNvPr id="7" name="Title 1"/>
          <p:cNvSpPr>
            <a:spLocks noGrp="1"/>
          </p:cNvSpPr>
          <p:nvPr>
            <p:ph type="title"/>
          </p:nvPr>
        </p:nvSpPr>
        <p:spPr>
          <a:xfrm>
            <a:off x="609599" y="609600"/>
            <a:ext cx="10972803" cy="418576"/>
          </a:xfrm>
        </p:spPr>
        <p:txBody>
          <a:bodyPr vert="horz" lIns="0" tIns="0" rIns="0" bIns="0" rtlCol="0" anchor="b" anchorCtr="0">
            <a:noAutofit/>
          </a:bodyPr>
          <a:lstStyle>
            <a:lvl1pPr>
              <a:defRPr lang="en-US" sz="3200" b="1" i="0" kern="1200" cap="none" dirty="0">
                <a:solidFill>
                  <a:schemeClr val="tx2"/>
                </a:solidFill>
                <a:latin typeface="+mj-lt"/>
                <a:ea typeface="+mj-ea"/>
                <a:cs typeface="+mj-cs"/>
              </a:defRPr>
            </a:lvl1pPr>
          </a:lstStyle>
          <a:p>
            <a:pPr lvl="0" algn="l" defTabSz="457189" rtl="0" eaLnBrk="1" latinLnBrk="0" hangingPunct="1">
              <a:lnSpc>
                <a:spcPct val="85000"/>
              </a:lnSpc>
              <a:spcBef>
                <a:spcPct val="0"/>
              </a:spcBef>
              <a:buNone/>
            </a:pPr>
            <a:r>
              <a:rPr lang="en-US"/>
              <a:t>Click to edit Master title style</a:t>
            </a:r>
          </a:p>
        </p:txBody>
      </p:sp>
      <p:sp>
        <p:nvSpPr>
          <p:cNvPr id="5" name="Text Placeholder 4"/>
          <p:cNvSpPr>
            <a:spLocks noGrp="1"/>
          </p:cNvSpPr>
          <p:nvPr>
            <p:ph type="body" sz="quarter" idx="20"/>
          </p:nvPr>
        </p:nvSpPr>
        <p:spPr>
          <a:xfrm>
            <a:off x="609600" y="1268985"/>
            <a:ext cx="10972800" cy="291592"/>
          </a:xfrm>
        </p:spPr>
        <p:txBody>
          <a:bodyPr/>
          <a:lstStyle>
            <a:lvl1pPr marL="0" indent="0">
              <a:buNone/>
              <a:defRPr sz="1900"/>
            </a:lvl1pPr>
            <a:lvl2pPr marL="306910" indent="0">
              <a:buNone/>
              <a:defRPr/>
            </a:lvl2pPr>
          </a:lstStyle>
          <a:p>
            <a:pPr lvl="0"/>
            <a:r>
              <a:rPr lang="en-US"/>
              <a:t>Click to edit Master text styles</a:t>
            </a:r>
          </a:p>
        </p:txBody>
      </p:sp>
      <p:sp>
        <p:nvSpPr>
          <p:cNvPr id="15" name="Content Placeholder 2"/>
          <p:cNvSpPr>
            <a:spLocks noGrp="1"/>
          </p:cNvSpPr>
          <p:nvPr>
            <p:ph sz="half" idx="21"/>
          </p:nvPr>
        </p:nvSpPr>
        <p:spPr>
          <a:xfrm>
            <a:off x="4267200" y="1781048"/>
            <a:ext cx="3308096" cy="4035553"/>
          </a:xfrm>
        </p:spPr>
        <p:txBody>
          <a:bodyPr vert="horz" lIns="0" tIns="0" rIns="0" bIns="0" rtlCol="0">
            <a:noAutofit/>
          </a:bodyPr>
          <a:lstStyle>
            <a:lvl1pPr marL="0" indent="0">
              <a:spcBef>
                <a:spcPts val="2000"/>
              </a:spcBef>
              <a:buNone/>
              <a:defRPr lang="en-US" sz="1600" b="1" dirty="0">
                <a:solidFill>
                  <a:schemeClr val="accent1"/>
                </a:solidFill>
              </a:defRPr>
            </a:lvl1pPr>
            <a:lvl2pPr marL="455073" indent="-455073">
              <a:spcBef>
                <a:spcPts val="0"/>
              </a:spcBef>
              <a:buNone/>
              <a:defRPr lang="en-US" sz="1600" dirty="0"/>
            </a:lvl2pPr>
            <a:lvl3pPr>
              <a:defRPr lang="en-US" dirty="0"/>
            </a:lvl3pPr>
            <a:lvl4pPr>
              <a:defRPr lang="en-US" dirty="0"/>
            </a:lvl4pPr>
            <a:lvl5pPr>
              <a:defRPr lang="en-US" dirty="0"/>
            </a:lvl5pPr>
          </a:lstStyle>
          <a:p>
            <a:pPr lvl="0"/>
            <a:r>
              <a:rPr lang="en-US"/>
              <a:t>Click to edit Master text styles</a:t>
            </a:r>
          </a:p>
          <a:p>
            <a:pPr lvl="1"/>
            <a:r>
              <a:rPr lang="en-US"/>
              <a:t>Second level</a:t>
            </a:r>
          </a:p>
        </p:txBody>
      </p:sp>
      <p:sp>
        <p:nvSpPr>
          <p:cNvPr id="16" name="Content Placeholder 2"/>
          <p:cNvSpPr>
            <a:spLocks noGrp="1"/>
          </p:cNvSpPr>
          <p:nvPr>
            <p:ph sz="half" idx="22"/>
          </p:nvPr>
        </p:nvSpPr>
        <p:spPr>
          <a:xfrm>
            <a:off x="7924800" y="1781048"/>
            <a:ext cx="3308096" cy="4035553"/>
          </a:xfrm>
        </p:spPr>
        <p:txBody>
          <a:bodyPr vert="horz" lIns="0" tIns="0" rIns="0" bIns="0" rtlCol="0">
            <a:noAutofit/>
          </a:bodyPr>
          <a:lstStyle>
            <a:lvl1pPr marL="0" indent="0">
              <a:spcBef>
                <a:spcPts val="2000"/>
              </a:spcBef>
              <a:buNone/>
              <a:defRPr lang="en-US" sz="1600" b="1" dirty="0">
                <a:solidFill>
                  <a:schemeClr val="accent1"/>
                </a:solidFill>
              </a:defRPr>
            </a:lvl1pPr>
            <a:lvl2pPr marL="455073" indent="-455073">
              <a:spcBef>
                <a:spcPts val="0"/>
              </a:spcBef>
              <a:buNone/>
              <a:defRPr lang="en-US" sz="1600" dirty="0"/>
            </a:lvl2pPr>
            <a:lvl3pPr>
              <a:defRPr lang="en-US" dirty="0"/>
            </a:lvl3pPr>
            <a:lvl4pPr>
              <a:defRPr lang="en-US" dirty="0"/>
            </a:lvl4pPr>
            <a:lvl5pPr>
              <a:defRPr lang="en-US" dirty="0"/>
            </a:lvl5pPr>
          </a:lstStyle>
          <a:p>
            <a:pPr lvl="0"/>
            <a:r>
              <a:rPr lang="en-US"/>
              <a:t>Click to edit Master text styles</a:t>
            </a:r>
          </a:p>
          <a:p>
            <a:pPr lvl="1"/>
            <a:r>
              <a:rPr lang="en-US"/>
              <a:t>Second level</a:t>
            </a:r>
          </a:p>
        </p:txBody>
      </p:sp>
      <p:sp>
        <p:nvSpPr>
          <p:cNvPr id="17" name="Footer Placeholder 4"/>
          <p:cNvSpPr>
            <a:spLocks noGrp="1"/>
          </p:cNvSpPr>
          <p:nvPr>
            <p:ph type="ftr" sz="quarter" idx="3"/>
          </p:nvPr>
        </p:nvSpPr>
        <p:spPr>
          <a:xfrm>
            <a:off x="1026597" y="6465181"/>
            <a:ext cx="4517089" cy="169277"/>
          </a:xfrm>
          <a:prstGeom prst="rect">
            <a:avLst/>
          </a:prstGeom>
        </p:spPr>
        <p:txBody>
          <a:bodyPr vert="horz" wrap="square" lIns="0" tIns="0" rIns="0" bIns="0" rtlCol="0" anchor="ctr">
            <a:spAutoFit/>
          </a:bodyPr>
          <a:lstStyle>
            <a:lvl1pPr algn="l">
              <a:defRPr sz="1100">
                <a:solidFill>
                  <a:schemeClr val="tx1"/>
                </a:solidFill>
              </a:defRPr>
            </a:lvl1pPr>
          </a:lstStyle>
          <a:p>
            <a:r>
              <a:rPr lang="en-US"/>
              <a:t>Division Name or Footer</a:t>
            </a:r>
          </a:p>
        </p:txBody>
      </p:sp>
      <p:sp>
        <p:nvSpPr>
          <p:cNvPr id="18" name="Slide Number Placeholder 5"/>
          <p:cNvSpPr>
            <a:spLocks noGrp="1"/>
          </p:cNvSpPr>
          <p:nvPr>
            <p:ph type="sldNum" sz="quarter" idx="4"/>
          </p:nvPr>
        </p:nvSpPr>
        <p:spPr>
          <a:xfrm>
            <a:off x="609601" y="6455138"/>
            <a:ext cx="339625" cy="169277"/>
          </a:xfrm>
          <a:prstGeom prst="rect">
            <a:avLst/>
          </a:prstGeom>
        </p:spPr>
        <p:txBody>
          <a:bodyPr vert="horz" wrap="square" lIns="0" tIns="0" rIns="0" bIns="0" rtlCol="0" anchor="ctr">
            <a:spAutoFit/>
          </a:bodyPr>
          <a:lstStyle>
            <a:lvl1pPr algn="l">
              <a:defRPr sz="1100">
                <a:solidFill>
                  <a:schemeClr val="tx1"/>
                </a:solidFill>
              </a:defRPr>
            </a:lvl1pPr>
          </a:lstStyle>
          <a:p>
            <a:fld id="{7FEEEA1A-CB49-3744-AA40-B896987410F9}" type="slidenum">
              <a:rPr lang="en-US" smtClean="0"/>
              <a:pPr/>
              <a:t>‹#›</a:t>
            </a:fld>
            <a:endParaRPr lang="en-US"/>
          </a:p>
        </p:txBody>
      </p:sp>
    </p:spTree>
    <p:extLst>
      <p:ext uri="{BB962C8B-B14F-4D97-AF65-F5344CB8AC3E}">
        <p14:creationId xmlns:p14="http://schemas.microsoft.com/office/powerpoint/2010/main" val="376119503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preserve="1" userDrawn="1">
  <p:cSld name="Section Header">
    <p:bg>
      <p:bgPr>
        <a:solidFill>
          <a:schemeClr val="tx2"/>
        </a:solidFill>
        <a:effectLst/>
      </p:bgPr>
    </p:bg>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917363" y="1949471"/>
            <a:ext cx="10685412" cy="4088141"/>
          </a:xfrm>
        </p:spPr>
        <p:txBody>
          <a:bodyPr anchor="b" anchorCtr="0">
            <a:noAutofit/>
          </a:bodyPr>
          <a:lstStyle>
            <a:lvl1pPr algn="l">
              <a:defRPr sz="7200" b="1" cap="all">
                <a:solidFill>
                  <a:srgbClr val="FFFFFF"/>
                </a:solidFill>
              </a:defRPr>
            </a:lvl1pPr>
          </a:lstStyle>
          <a:p>
            <a:r>
              <a:rPr lang="en-US"/>
              <a:t>Click to edit Master title </a:t>
            </a:r>
            <a:br>
              <a:rPr lang="en-US"/>
            </a:br>
            <a:r>
              <a:rPr lang="en-US"/>
              <a:t>style</a:t>
            </a:r>
          </a:p>
        </p:txBody>
      </p:sp>
    </p:spTree>
    <p:extLst>
      <p:ext uri="{BB962C8B-B14F-4D97-AF65-F5344CB8AC3E}">
        <p14:creationId xmlns:p14="http://schemas.microsoft.com/office/powerpoint/2010/main" val="100980493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Two Content">
    <p:spTree>
      <p:nvGrpSpPr>
        <p:cNvPr id="1" name=""/>
        <p:cNvGrpSpPr/>
        <p:nvPr/>
      </p:nvGrpSpPr>
      <p:grpSpPr>
        <a:xfrm>
          <a:off x="0" y="0"/>
          <a:ext cx="0" cy="0"/>
          <a:chOff x="0" y="0"/>
          <a:chExt cx="0" cy="0"/>
        </a:xfrm>
      </p:grpSpPr>
      <p:sp>
        <p:nvSpPr>
          <p:cNvPr id="3" name="Content Placeholder 2"/>
          <p:cNvSpPr>
            <a:spLocks noGrp="1"/>
          </p:cNvSpPr>
          <p:nvPr>
            <p:ph sz="half" idx="1"/>
          </p:nvPr>
        </p:nvSpPr>
        <p:spPr>
          <a:xfrm>
            <a:off x="609600" y="1780032"/>
            <a:ext cx="5181600" cy="4036568"/>
          </a:xfrm>
        </p:spPr>
        <p:txBody>
          <a:bodyPr vert="horz" lIns="0" tIns="0" rIns="0" bIns="0" rtlCol="0">
            <a:noAutofit/>
          </a:bodyPr>
          <a:lstStyle>
            <a:lvl1pPr>
              <a:defRPr lang="en-US" dirty="0"/>
            </a:lvl1pPr>
            <a:lvl2pPr>
              <a:defRPr lang="en-US" dirty="0"/>
            </a:lvl2pPr>
            <a:lvl3pPr>
              <a:defRPr lang="en-US" dirty="0"/>
            </a:lvl3pPr>
            <a:lvl4pPr>
              <a:defRPr lang="en-US" dirty="0"/>
            </a:lvl4pPr>
            <a:lvl5pPr>
              <a:defRPr lang="en-US" dirty="0"/>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14" name="Content Placeholder 2"/>
          <p:cNvSpPr>
            <a:spLocks noGrp="1"/>
          </p:cNvSpPr>
          <p:nvPr>
            <p:ph sz="half" idx="15"/>
          </p:nvPr>
        </p:nvSpPr>
        <p:spPr>
          <a:xfrm>
            <a:off x="6400800" y="1780032"/>
            <a:ext cx="5181600" cy="4036568"/>
          </a:xfrm>
        </p:spPr>
        <p:txBody>
          <a:bodyPr vert="horz" lIns="0" tIns="0" rIns="0" bIns="0" rtlCol="0">
            <a:noAutofit/>
          </a:bodyPr>
          <a:lstStyle>
            <a:lvl1pPr>
              <a:defRPr lang="en-US" dirty="0"/>
            </a:lvl1pPr>
            <a:lvl2pPr>
              <a:defRPr lang="en-US" dirty="0"/>
            </a:lvl2pPr>
            <a:lvl3pPr>
              <a:defRPr lang="en-US" dirty="0"/>
            </a:lvl3pPr>
            <a:lvl4pPr>
              <a:defRPr lang="en-US" dirty="0"/>
            </a:lvl4pPr>
            <a:lvl5pPr>
              <a:defRPr lang="en-US" dirty="0"/>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10" name="Footer Placeholder 4"/>
          <p:cNvSpPr>
            <a:spLocks noGrp="1"/>
          </p:cNvSpPr>
          <p:nvPr>
            <p:ph type="ftr" sz="quarter" idx="3"/>
          </p:nvPr>
        </p:nvSpPr>
        <p:spPr>
          <a:xfrm>
            <a:off x="1026597" y="6467745"/>
            <a:ext cx="4517089" cy="164148"/>
          </a:xfrm>
          <a:prstGeom prst="rect">
            <a:avLst/>
          </a:prstGeom>
        </p:spPr>
        <p:txBody>
          <a:bodyPr vert="horz" wrap="square" lIns="0" tIns="0" rIns="0" bIns="0" rtlCol="0" anchor="ctr">
            <a:spAutoFit/>
          </a:bodyPr>
          <a:lstStyle>
            <a:lvl1pPr algn="l">
              <a:defRPr sz="1067">
                <a:solidFill>
                  <a:schemeClr val="tx1"/>
                </a:solidFill>
              </a:defRPr>
            </a:lvl1pPr>
          </a:lstStyle>
          <a:p>
            <a:r>
              <a:rPr lang="en-US"/>
              <a:t>Division Name or Footer</a:t>
            </a:r>
          </a:p>
        </p:txBody>
      </p:sp>
      <p:sp>
        <p:nvSpPr>
          <p:cNvPr id="11" name="Slide Number Placeholder 5"/>
          <p:cNvSpPr>
            <a:spLocks noGrp="1"/>
          </p:cNvSpPr>
          <p:nvPr>
            <p:ph type="sldNum" sz="quarter" idx="4"/>
          </p:nvPr>
        </p:nvSpPr>
        <p:spPr>
          <a:xfrm>
            <a:off x="609601" y="6457702"/>
            <a:ext cx="339625" cy="164148"/>
          </a:xfrm>
          <a:prstGeom prst="rect">
            <a:avLst/>
          </a:prstGeom>
        </p:spPr>
        <p:txBody>
          <a:bodyPr vert="horz" wrap="square" lIns="0" tIns="0" rIns="0" bIns="0" rtlCol="0" anchor="ctr">
            <a:spAutoFit/>
          </a:bodyPr>
          <a:lstStyle>
            <a:lvl1pPr algn="l">
              <a:defRPr sz="1067">
                <a:solidFill>
                  <a:schemeClr val="tx1"/>
                </a:solidFill>
              </a:defRPr>
            </a:lvl1pPr>
          </a:lstStyle>
          <a:p>
            <a:fld id="{7FEEEA1A-CB49-3744-AA40-B896987410F9}" type="slidenum">
              <a:rPr lang="en-US" smtClean="0"/>
              <a:pPr/>
              <a:t>‹#›</a:t>
            </a:fld>
            <a:endParaRPr lang="en-US"/>
          </a:p>
        </p:txBody>
      </p:sp>
      <p:sp>
        <p:nvSpPr>
          <p:cNvPr id="7" name="Title 1"/>
          <p:cNvSpPr>
            <a:spLocks noGrp="1"/>
          </p:cNvSpPr>
          <p:nvPr>
            <p:ph type="title"/>
          </p:nvPr>
        </p:nvSpPr>
        <p:spPr>
          <a:xfrm>
            <a:off x="609599" y="1048512"/>
            <a:ext cx="10972803" cy="418576"/>
          </a:xfrm>
        </p:spPr>
        <p:txBody>
          <a:bodyPr vert="horz" lIns="0" tIns="0" rIns="0" bIns="0" rtlCol="0" anchor="b" anchorCtr="0">
            <a:noAutofit/>
          </a:bodyPr>
          <a:lstStyle>
            <a:lvl1pPr>
              <a:defRPr lang="en-US" sz="3200" b="1" i="0" kern="1200" cap="none" dirty="0">
                <a:solidFill>
                  <a:schemeClr val="tx2"/>
                </a:solidFill>
                <a:latin typeface="+mj-lt"/>
                <a:ea typeface="+mj-ea"/>
                <a:cs typeface="+mj-cs"/>
              </a:defRPr>
            </a:lvl1pPr>
          </a:lstStyle>
          <a:p>
            <a:pPr lvl="0" algn="l" defTabSz="457189" rtl="0" eaLnBrk="1" latinLnBrk="0" hangingPunct="1">
              <a:lnSpc>
                <a:spcPct val="85000"/>
              </a:lnSpc>
              <a:spcBef>
                <a:spcPct val="0"/>
              </a:spcBef>
              <a:buNone/>
            </a:pPr>
            <a:r>
              <a:rPr lang="en-US"/>
              <a:t>Click to edit Master title style</a:t>
            </a:r>
          </a:p>
        </p:txBody>
      </p:sp>
    </p:spTree>
    <p:extLst>
      <p:ext uri="{BB962C8B-B14F-4D97-AF65-F5344CB8AC3E}">
        <p14:creationId xmlns:p14="http://schemas.microsoft.com/office/powerpoint/2010/main" val="214729031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Comparison">
    <p:spTree>
      <p:nvGrpSpPr>
        <p:cNvPr id="1" name=""/>
        <p:cNvGrpSpPr/>
        <p:nvPr/>
      </p:nvGrpSpPr>
      <p:grpSpPr>
        <a:xfrm>
          <a:off x="0" y="0"/>
          <a:ext cx="0" cy="0"/>
          <a:chOff x="0" y="0"/>
          <a:chExt cx="0" cy="0"/>
        </a:xfrm>
      </p:grpSpPr>
      <p:sp>
        <p:nvSpPr>
          <p:cNvPr id="19" name="Text Placeholder 11"/>
          <p:cNvSpPr>
            <a:spLocks noGrp="1"/>
          </p:cNvSpPr>
          <p:nvPr>
            <p:ph type="body" sz="quarter" idx="13"/>
          </p:nvPr>
        </p:nvSpPr>
        <p:spPr>
          <a:xfrm>
            <a:off x="609600" y="1689917"/>
            <a:ext cx="5181600" cy="406265"/>
          </a:xfrm>
        </p:spPr>
        <p:txBody>
          <a:bodyPr anchor="b" anchorCtr="0">
            <a:noAutofit/>
          </a:bodyPr>
          <a:lstStyle>
            <a:lvl1pPr marL="0" indent="0">
              <a:lnSpc>
                <a:spcPct val="90000"/>
              </a:lnSpc>
              <a:buNone/>
              <a:defRPr sz="2400" b="1"/>
            </a:lvl1pPr>
            <a:lvl2pPr marL="306910" indent="0">
              <a:buNone/>
              <a:defRPr/>
            </a:lvl2pPr>
          </a:lstStyle>
          <a:p>
            <a:pPr lvl="0"/>
            <a:r>
              <a:rPr lang="en-US"/>
              <a:t>Click to edit Master text styles</a:t>
            </a:r>
          </a:p>
        </p:txBody>
      </p:sp>
      <p:sp>
        <p:nvSpPr>
          <p:cNvPr id="20" name="Text Placeholder 11"/>
          <p:cNvSpPr>
            <a:spLocks noGrp="1"/>
          </p:cNvSpPr>
          <p:nvPr>
            <p:ph type="body" sz="quarter" idx="14"/>
          </p:nvPr>
        </p:nvSpPr>
        <p:spPr>
          <a:xfrm>
            <a:off x="6400800" y="1689917"/>
            <a:ext cx="5181600" cy="406265"/>
          </a:xfrm>
        </p:spPr>
        <p:txBody>
          <a:bodyPr anchor="b" anchorCtr="0">
            <a:noAutofit/>
          </a:bodyPr>
          <a:lstStyle>
            <a:lvl1pPr marL="0" indent="0">
              <a:lnSpc>
                <a:spcPct val="90000"/>
              </a:lnSpc>
              <a:buNone/>
              <a:defRPr sz="2400" b="1"/>
            </a:lvl1pPr>
            <a:lvl2pPr marL="306910" indent="0">
              <a:buNone/>
              <a:defRPr/>
            </a:lvl2pPr>
          </a:lstStyle>
          <a:p>
            <a:pPr lvl="0"/>
            <a:r>
              <a:rPr lang="en-US"/>
              <a:t>Click to edit Master text styles</a:t>
            </a:r>
          </a:p>
        </p:txBody>
      </p:sp>
      <p:sp>
        <p:nvSpPr>
          <p:cNvPr id="21" name="Content Placeholder 2"/>
          <p:cNvSpPr>
            <a:spLocks noGrp="1"/>
          </p:cNvSpPr>
          <p:nvPr>
            <p:ph sz="half" idx="15"/>
          </p:nvPr>
        </p:nvSpPr>
        <p:spPr>
          <a:xfrm>
            <a:off x="6400800" y="2231137"/>
            <a:ext cx="5181600" cy="3674876"/>
          </a:xfrm>
        </p:spPr>
        <p:txBody>
          <a:bodyPr vert="horz" lIns="0" tIns="0" rIns="0" bIns="0" rtlCol="0">
            <a:noAutofit/>
          </a:bodyPr>
          <a:lstStyle>
            <a:lvl1pPr>
              <a:defRPr lang="en-US"/>
            </a:lvl1pPr>
            <a:lvl2pPr>
              <a:defRPr lang="en-US"/>
            </a:lvl2pPr>
            <a:lvl3pPr>
              <a:defRPr lang="en-US"/>
            </a:lvl3pPr>
            <a:lvl4pPr>
              <a:defRPr lang="en-US"/>
            </a:lvl4pPr>
            <a:lvl5pPr>
              <a:defRPr lang="en-US" dirty="0"/>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9" name="Footer Placeholder 4"/>
          <p:cNvSpPr>
            <a:spLocks noGrp="1"/>
          </p:cNvSpPr>
          <p:nvPr>
            <p:ph type="ftr" sz="quarter" idx="3"/>
          </p:nvPr>
        </p:nvSpPr>
        <p:spPr>
          <a:xfrm>
            <a:off x="1026597" y="6467745"/>
            <a:ext cx="4517089" cy="164148"/>
          </a:xfrm>
          <a:prstGeom prst="rect">
            <a:avLst/>
          </a:prstGeom>
        </p:spPr>
        <p:txBody>
          <a:bodyPr vert="horz" wrap="square" lIns="0" tIns="0" rIns="0" bIns="0" rtlCol="0" anchor="ctr">
            <a:spAutoFit/>
          </a:bodyPr>
          <a:lstStyle>
            <a:lvl1pPr algn="l">
              <a:defRPr sz="1067">
                <a:solidFill>
                  <a:schemeClr val="tx1"/>
                </a:solidFill>
              </a:defRPr>
            </a:lvl1pPr>
          </a:lstStyle>
          <a:p>
            <a:r>
              <a:rPr lang="en-US"/>
              <a:t>Division Name or Footer</a:t>
            </a:r>
          </a:p>
        </p:txBody>
      </p:sp>
      <p:sp>
        <p:nvSpPr>
          <p:cNvPr id="11" name="Slide Number Placeholder 5"/>
          <p:cNvSpPr>
            <a:spLocks noGrp="1"/>
          </p:cNvSpPr>
          <p:nvPr>
            <p:ph type="sldNum" sz="quarter" idx="4"/>
          </p:nvPr>
        </p:nvSpPr>
        <p:spPr>
          <a:xfrm>
            <a:off x="609601" y="6457702"/>
            <a:ext cx="339625" cy="164148"/>
          </a:xfrm>
          <a:prstGeom prst="rect">
            <a:avLst/>
          </a:prstGeom>
        </p:spPr>
        <p:txBody>
          <a:bodyPr vert="horz" wrap="square" lIns="0" tIns="0" rIns="0" bIns="0" rtlCol="0" anchor="ctr">
            <a:spAutoFit/>
          </a:bodyPr>
          <a:lstStyle>
            <a:lvl1pPr algn="l">
              <a:defRPr sz="1067">
                <a:solidFill>
                  <a:schemeClr val="tx1"/>
                </a:solidFill>
              </a:defRPr>
            </a:lvl1pPr>
          </a:lstStyle>
          <a:p>
            <a:fld id="{7FEEEA1A-CB49-3744-AA40-B896987410F9}" type="slidenum">
              <a:rPr lang="en-US" smtClean="0"/>
              <a:pPr/>
              <a:t>‹#›</a:t>
            </a:fld>
            <a:endParaRPr lang="en-US"/>
          </a:p>
        </p:txBody>
      </p:sp>
      <p:sp>
        <p:nvSpPr>
          <p:cNvPr id="12" name="Title 1"/>
          <p:cNvSpPr>
            <a:spLocks noGrp="1"/>
          </p:cNvSpPr>
          <p:nvPr>
            <p:ph type="title"/>
          </p:nvPr>
        </p:nvSpPr>
        <p:spPr>
          <a:xfrm>
            <a:off x="609599" y="1048512"/>
            <a:ext cx="10972803" cy="418576"/>
          </a:xfrm>
        </p:spPr>
        <p:txBody>
          <a:bodyPr vert="horz" lIns="0" tIns="0" rIns="0" bIns="0" rtlCol="0" anchor="b" anchorCtr="0">
            <a:noAutofit/>
          </a:bodyPr>
          <a:lstStyle>
            <a:lvl1pPr>
              <a:defRPr lang="en-US" sz="3200" b="1" i="0" kern="1200" cap="none" dirty="0">
                <a:solidFill>
                  <a:schemeClr val="tx2"/>
                </a:solidFill>
                <a:latin typeface="+mj-lt"/>
                <a:ea typeface="+mj-ea"/>
                <a:cs typeface="+mj-cs"/>
              </a:defRPr>
            </a:lvl1pPr>
          </a:lstStyle>
          <a:p>
            <a:pPr lvl="0" algn="l" defTabSz="457189" rtl="0" eaLnBrk="1" latinLnBrk="0" hangingPunct="1">
              <a:lnSpc>
                <a:spcPct val="85000"/>
              </a:lnSpc>
              <a:spcBef>
                <a:spcPct val="0"/>
              </a:spcBef>
              <a:buNone/>
            </a:pPr>
            <a:r>
              <a:rPr lang="en-US"/>
              <a:t>Click to edit Master title style</a:t>
            </a:r>
          </a:p>
        </p:txBody>
      </p:sp>
      <p:sp>
        <p:nvSpPr>
          <p:cNvPr id="10" name="Content Placeholder 2"/>
          <p:cNvSpPr>
            <a:spLocks noGrp="1"/>
          </p:cNvSpPr>
          <p:nvPr>
            <p:ph sz="half" idx="1"/>
          </p:nvPr>
        </p:nvSpPr>
        <p:spPr>
          <a:xfrm>
            <a:off x="609599" y="2236614"/>
            <a:ext cx="5181600" cy="3669399"/>
          </a:xfrm>
        </p:spPr>
        <p:txBody>
          <a:bodyPr vert="horz" lIns="0" tIns="0" rIns="0" bIns="0" rtlCol="0">
            <a:noAutofit/>
          </a:bodyPr>
          <a:lstStyle>
            <a:lvl1pPr>
              <a:defRPr lang="en-US" dirty="0"/>
            </a:lvl1pPr>
            <a:lvl2pPr>
              <a:defRPr lang="en-US" dirty="0"/>
            </a:lvl2pPr>
            <a:lvl3pPr>
              <a:defRPr lang="en-US" dirty="0"/>
            </a:lvl3pPr>
            <a:lvl4pPr>
              <a:defRPr lang="en-US" dirty="0"/>
            </a:lvl4pPr>
            <a:lvl5pPr>
              <a:defRPr lang="en-US" dirty="0"/>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44420933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Title Only">
    <p:spTree>
      <p:nvGrpSpPr>
        <p:cNvPr id="1" name=""/>
        <p:cNvGrpSpPr/>
        <p:nvPr/>
      </p:nvGrpSpPr>
      <p:grpSpPr>
        <a:xfrm>
          <a:off x="0" y="0"/>
          <a:ext cx="0" cy="0"/>
          <a:chOff x="0" y="0"/>
          <a:chExt cx="0" cy="0"/>
        </a:xfrm>
      </p:grpSpPr>
      <p:sp>
        <p:nvSpPr>
          <p:cNvPr id="5" name="Footer Placeholder 4"/>
          <p:cNvSpPr>
            <a:spLocks noGrp="1"/>
          </p:cNvSpPr>
          <p:nvPr>
            <p:ph type="ftr" sz="quarter" idx="3"/>
          </p:nvPr>
        </p:nvSpPr>
        <p:spPr>
          <a:xfrm>
            <a:off x="1026597" y="6467745"/>
            <a:ext cx="4517089" cy="164148"/>
          </a:xfrm>
          <a:prstGeom prst="rect">
            <a:avLst/>
          </a:prstGeom>
        </p:spPr>
        <p:txBody>
          <a:bodyPr vert="horz" wrap="square" lIns="0" tIns="0" rIns="0" bIns="0" rtlCol="0" anchor="ctr">
            <a:spAutoFit/>
          </a:bodyPr>
          <a:lstStyle>
            <a:lvl1pPr algn="l">
              <a:defRPr sz="1067">
                <a:solidFill>
                  <a:schemeClr val="tx1"/>
                </a:solidFill>
              </a:defRPr>
            </a:lvl1pPr>
          </a:lstStyle>
          <a:p>
            <a:r>
              <a:rPr lang="en-US"/>
              <a:t>Division Name or Footer</a:t>
            </a:r>
          </a:p>
        </p:txBody>
      </p:sp>
      <p:sp>
        <p:nvSpPr>
          <p:cNvPr id="7" name="Slide Number Placeholder 5"/>
          <p:cNvSpPr>
            <a:spLocks noGrp="1"/>
          </p:cNvSpPr>
          <p:nvPr>
            <p:ph type="sldNum" sz="quarter" idx="4"/>
          </p:nvPr>
        </p:nvSpPr>
        <p:spPr>
          <a:xfrm>
            <a:off x="609601" y="6457702"/>
            <a:ext cx="339625" cy="164148"/>
          </a:xfrm>
          <a:prstGeom prst="rect">
            <a:avLst/>
          </a:prstGeom>
        </p:spPr>
        <p:txBody>
          <a:bodyPr vert="horz" wrap="square" lIns="0" tIns="0" rIns="0" bIns="0" rtlCol="0" anchor="ctr">
            <a:spAutoFit/>
          </a:bodyPr>
          <a:lstStyle>
            <a:lvl1pPr algn="l">
              <a:defRPr sz="1067">
                <a:solidFill>
                  <a:schemeClr val="tx1"/>
                </a:solidFill>
              </a:defRPr>
            </a:lvl1pPr>
          </a:lstStyle>
          <a:p>
            <a:fld id="{7FEEEA1A-CB49-3744-AA40-B896987410F9}" type="slidenum">
              <a:rPr lang="en-US" smtClean="0"/>
              <a:pPr/>
              <a:t>‹#›</a:t>
            </a:fld>
            <a:endParaRPr lang="en-US"/>
          </a:p>
        </p:txBody>
      </p:sp>
      <p:sp>
        <p:nvSpPr>
          <p:cNvPr id="8" name="Title 1"/>
          <p:cNvSpPr>
            <a:spLocks noGrp="1"/>
          </p:cNvSpPr>
          <p:nvPr>
            <p:ph type="title"/>
          </p:nvPr>
        </p:nvSpPr>
        <p:spPr>
          <a:xfrm>
            <a:off x="609599" y="1048512"/>
            <a:ext cx="10972803" cy="418576"/>
          </a:xfrm>
        </p:spPr>
        <p:txBody>
          <a:bodyPr vert="horz" lIns="0" tIns="0" rIns="0" bIns="0" rtlCol="0" anchor="b" anchorCtr="0">
            <a:noAutofit/>
          </a:bodyPr>
          <a:lstStyle>
            <a:lvl1pPr>
              <a:defRPr lang="en-US" sz="3200" b="1" i="0" kern="1200" cap="none" dirty="0">
                <a:solidFill>
                  <a:schemeClr val="tx2"/>
                </a:solidFill>
                <a:latin typeface="+mj-lt"/>
                <a:ea typeface="+mj-ea"/>
                <a:cs typeface="+mj-cs"/>
              </a:defRPr>
            </a:lvl1pPr>
          </a:lstStyle>
          <a:p>
            <a:pPr lvl="0" algn="l" defTabSz="457189" rtl="0" eaLnBrk="1" latinLnBrk="0" hangingPunct="1">
              <a:lnSpc>
                <a:spcPct val="85000"/>
              </a:lnSpc>
              <a:spcBef>
                <a:spcPct val="0"/>
              </a:spcBef>
              <a:buNone/>
            </a:pPr>
            <a:r>
              <a:rPr lang="en-US"/>
              <a:t>Click to edit Master title style</a:t>
            </a:r>
          </a:p>
        </p:txBody>
      </p:sp>
    </p:spTree>
    <p:extLst>
      <p:ext uri="{BB962C8B-B14F-4D97-AF65-F5344CB8AC3E}">
        <p14:creationId xmlns:p14="http://schemas.microsoft.com/office/powerpoint/2010/main" val="204007843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5" name="Footer Placeholder 4"/>
          <p:cNvSpPr>
            <a:spLocks noGrp="1"/>
          </p:cNvSpPr>
          <p:nvPr>
            <p:ph type="ftr" sz="quarter" idx="3"/>
          </p:nvPr>
        </p:nvSpPr>
        <p:spPr>
          <a:xfrm>
            <a:off x="1026597" y="6467745"/>
            <a:ext cx="4517089" cy="164148"/>
          </a:xfrm>
          <a:prstGeom prst="rect">
            <a:avLst/>
          </a:prstGeom>
        </p:spPr>
        <p:txBody>
          <a:bodyPr vert="horz" wrap="square" lIns="0" tIns="0" rIns="0" bIns="0" rtlCol="0" anchor="ctr">
            <a:spAutoFit/>
          </a:bodyPr>
          <a:lstStyle>
            <a:lvl1pPr algn="l">
              <a:defRPr sz="1067">
                <a:solidFill>
                  <a:schemeClr val="tx1"/>
                </a:solidFill>
              </a:defRPr>
            </a:lvl1pPr>
          </a:lstStyle>
          <a:p>
            <a:r>
              <a:rPr lang="en-US"/>
              <a:t>Division Name or Footer</a:t>
            </a:r>
          </a:p>
        </p:txBody>
      </p:sp>
      <p:sp>
        <p:nvSpPr>
          <p:cNvPr id="6" name="Slide Number Placeholder 5"/>
          <p:cNvSpPr>
            <a:spLocks noGrp="1"/>
          </p:cNvSpPr>
          <p:nvPr>
            <p:ph type="sldNum" sz="quarter" idx="4"/>
          </p:nvPr>
        </p:nvSpPr>
        <p:spPr>
          <a:xfrm>
            <a:off x="609601" y="6457702"/>
            <a:ext cx="339625" cy="164148"/>
          </a:xfrm>
          <a:prstGeom prst="rect">
            <a:avLst/>
          </a:prstGeom>
        </p:spPr>
        <p:txBody>
          <a:bodyPr vert="horz" wrap="square" lIns="0" tIns="0" rIns="0" bIns="0" rtlCol="0" anchor="ctr">
            <a:spAutoFit/>
          </a:bodyPr>
          <a:lstStyle>
            <a:lvl1pPr algn="l">
              <a:defRPr sz="1067">
                <a:solidFill>
                  <a:schemeClr val="tx1"/>
                </a:solidFill>
              </a:defRPr>
            </a:lvl1pPr>
          </a:lstStyle>
          <a:p>
            <a:fld id="{7FEEEA1A-CB49-3744-AA40-B896987410F9}" type="slidenum">
              <a:rPr lang="en-US" smtClean="0"/>
              <a:pPr/>
              <a:t>‹#›</a:t>
            </a:fld>
            <a:endParaRPr lang="en-US"/>
          </a:p>
        </p:txBody>
      </p:sp>
    </p:spTree>
    <p:extLst>
      <p:ext uri="{BB962C8B-B14F-4D97-AF65-F5344CB8AC3E}">
        <p14:creationId xmlns:p14="http://schemas.microsoft.com/office/powerpoint/2010/main" val="99694070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preserve="1" userDrawn="1">
  <p:cSld name="Content with Caption">
    <p:bg>
      <p:bgPr>
        <a:solidFill>
          <a:schemeClr val="bg1"/>
        </a:solidFill>
        <a:effectLst/>
      </p:bgPr>
    </p:bg>
    <p:spTree>
      <p:nvGrpSpPr>
        <p:cNvPr id="1" name=""/>
        <p:cNvGrpSpPr/>
        <p:nvPr/>
      </p:nvGrpSpPr>
      <p:grpSpPr>
        <a:xfrm>
          <a:off x="0" y="0"/>
          <a:ext cx="0" cy="0"/>
          <a:chOff x="0" y="0"/>
          <a:chExt cx="0" cy="0"/>
        </a:xfrm>
      </p:grpSpPr>
      <p:sp>
        <p:nvSpPr>
          <p:cNvPr id="5" name="Rectangle 4"/>
          <p:cNvSpPr/>
          <p:nvPr userDrawn="1"/>
        </p:nvSpPr>
        <p:spPr>
          <a:xfrm>
            <a:off x="-1" y="-20491"/>
            <a:ext cx="6784975" cy="6878491"/>
          </a:xfrm>
          <a:prstGeom prst="rect">
            <a:avLst/>
          </a:prstGeom>
          <a:solidFill>
            <a:schemeClr val="tx2"/>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3200"/>
          </a:p>
        </p:txBody>
      </p:sp>
      <p:sp>
        <p:nvSpPr>
          <p:cNvPr id="7" name="Picture Placeholder 6"/>
          <p:cNvSpPr>
            <a:spLocks noGrp="1"/>
          </p:cNvSpPr>
          <p:nvPr>
            <p:ph type="pic" sz="quarter" idx="10"/>
          </p:nvPr>
        </p:nvSpPr>
        <p:spPr>
          <a:xfrm>
            <a:off x="6784973" y="0"/>
            <a:ext cx="5407027" cy="3918136"/>
          </a:xfrm>
          <a:custGeom>
            <a:avLst/>
            <a:gdLst>
              <a:gd name="connsiteX0" fmla="*/ 0 w 4035853"/>
              <a:gd name="connsiteY0" fmla="*/ 0 h 2697096"/>
              <a:gd name="connsiteX1" fmla="*/ 4035853 w 4035853"/>
              <a:gd name="connsiteY1" fmla="*/ 0 h 2697096"/>
              <a:gd name="connsiteX2" fmla="*/ 4035853 w 4035853"/>
              <a:gd name="connsiteY2" fmla="*/ 2697096 h 2697096"/>
              <a:gd name="connsiteX3" fmla="*/ 0 w 4035853"/>
              <a:gd name="connsiteY3" fmla="*/ 2697096 h 2697096"/>
              <a:gd name="connsiteX4" fmla="*/ 0 w 4035853"/>
              <a:gd name="connsiteY4" fmla="*/ 0 h 2697096"/>
              <a:gd name="connsiteX0" fmla="*/ 0 w 4035853"/>
              <a:gd name="connsiteY0" fmla="*/ 0 h 2700356"/>
              <a:gd name="connsiteX1" fmla="*/ 4035853 w 4035853"/>
              <a:gd name="connsiteY1" fmla="*/ 0 h 2700356"/>
              <a:gd name="connsiteX2" fmla="*/ 4035853 w 4035853"/>
              <a:gd name="connsiteY2" fmla="*/ 2697096 h 2700356"/>
              <a:gd name="connsiteX3" fmla="*/ 323823 w 4035853"/>
              <a:gd name="connsiteY3" fmla="*/ 2700356 h 2700356"/>
              <a:gd name="connsiteX4" fmla="*/ 0 w 4035853"/>
              <a:gd name="connsiteY4" fmla="*/ 2697096 h 2700356"/>
              <a:gd name="connsiteX5" fmla="*/ 0 w 4035853"/>
              <a:gd name="connsiteY5" fmla="*/ 0 h 2700356"/>
              <a:gd name="connsiteX0" fmla="*/ 0 w 4035853"/>
              <a:gd name="connsiteY0" fmla="*/ 0 h 2700356"/>
              <a:gd name="connsiteX1" fmla="*/ 4035853 w 4035853"/>
              <a:gd name="connsiteY1" fmla="*/ 0 h 2700356"/>
              <a:gd name="connsiteX2" fmla="*/ 4035853 w 4035853"/>
              <a:gd name="connsiteY2" fmla="*/ 2697096 h 2700356"/>
              <a:gd name="connsiteX3" fmla="*/ 323823 w 4035853"/>
              <a:gd name="connsiteY3" fmla="*/ 2700356 h 2700356"/>
              <a:gd name="connsiteX4" fmla="*/ 0 w 4035853"/>
              <a:gd name="connsiteY4" fmla="*/ 2697096 h 2700356"/>
              <a:gd name="connsiteX5" fmla="*/ 0 w 4035853"/>
              <a:gd name="connsiteY5" fmla="*/ 0 h 2700356"/>
              <a:gd name="connsiteX0" fmla="*/ 0 w 4035853"/>
              <a:gd name="connsiteY0" fmla="*/ 0 h 2700356"/>
              <a:gd name="connsiteX1" fmla="*/ 4035853 w 4035853"/>
              <a:gd name="connsiteY1" fmla="*/ 0 h 2700356"/>
              <a:gd name="connsiteX2" fmla="*/ 4035853 w 4035853"/>
              <a:gd name="connsiteY2" fmla="*/ 2697096 h 2700356"/>
              <a:gd name="connsiteX3" fmla="*/ 612823 w 4035853"/>
              <a:gd name="connsiteY3" fmla="*/ 2689412 h 2700356"/>
              <a:gd name="connsiteX4" fmla="*/ 323823 w 4035853"/>
              <a:gd name="connsiteY4" fmla="*/ 2700356 h 2700356"/>
              <a:gd name="connsiteX5" fmla="*/ 0 w 4035853"/>
              <a:gd name="connsiteY5" fmla="*/ 2697096 h 2700356"/>
              <a:gd name="connsiteX6" fmla="*/ 0 w 4035853"/>
              <a:gd name="connsiteY6" fmla="*/ 0 h 2700356"/>
              <a:gd name="connsiteX0" fmla="*/ 0 w 4035853"/>
              <a:gd name="connsiteY0" fmla="*/ 0 h 2700356"/>
              <a:gd name="connsiteX1" fmla="*/ 4035853 w 4035853"/>
              <a:gd name="connsiteY1" fmla="*/ 0 h 2700356"/>
              <a:gd name="connsiteX2" fmla="*/ 4035853 w 4035853"/>
              <a:gd name="connsiteY2" fmla="*/ 2697096 h 2700356"/>
              <a:gd name="connsiteX3" fmla="*/ 612823 w 4035853"/>
              <a:gd name="connsiteY3" fmla="*/ 2689412 h 2700356"/>
              <a:gd name="connsiteX4" fmla="*/ 323823 w 4035853"/>
              <a:gd name="connsiteY4" fmla="*/ 2700356 h 2700356"/>
              <a:gd name="connsiteX5" fmla="*/ 0 w 4035853"/>
              <a:gd name="connsiteY5" fmla="*/ 2697096 h 2700356"/>
              <a:gd name="connsiteX6" fmla="*/ 0 w 4035853"/>
              <a:gd name="connsiteY6" fmla="*/ 0 h 2700356"/>
              <a:gd name="connsiteX0" fmla="*/ 0 w 4035853"/>
              <a:gd name="connsiteY0" fmla="*/ 0 h 2700356"/>
              <a:gd name="connsiteX1" fmla="*/ 4035853 w 4035853"/>
              <a:gd name="connsiteY1" fmla="*/ 0 h 2700356"/>
              <a:gd name="connsiteX2" fmla="*/ 4035853 w 4035853"/>
              <a:gd name="connsiteY2" fmla="*/ 2697096 h 2700356"/>
              <a:gd name="connsiteX3" fmla="*/ 612823 w 4035853"/>
              <a:gd name="connsiteY3" fmla="*/ 2689412 h 2700356"/>
              <a:gd name="connsiteX4" fmla="*/ 323823 w 4035853"/>
              <a:gd name="connsiteY4" fmla="*/ 2700356 h 2700356"/>
              <a:gd name="connsiteX5" fmla="*/ 0 w 4035853"/>
              <a:gd name="connsiteY5" fmla="*/ 2697096 h 2700356"/>
              <a:gd name="connsiteX6" fmla="*/ 0 w 4035853"/>
              <a:gd name="connsiteY6" fmla="*/ 0 h 2700356"/>
              <a:gd name="connsiteX0" fmla="*/ 0 w 4035853"/>
              <a:gd name="connsiteY0" fmla="*/ 0 h 2700645"/>
              <a:gd name="connsiteX1" fmla="*/ 4035853 w 4035853"/>
              <a:gd name="connsiteY1" fmla="*/ 0 h 2700645"/>
              <a:gd name="connsiteX2" fmla="*/ 4035853 w 4035853"/>
              <a:gd name="connsiteY2" fmla="*/ 2697096 h 2700645"/>
              <a:gd name="connsiteX3" fmla="*/ 612823 w 4035853"/>
              <a:gd name="connsiteY3" fmla="*/ 2689412 h 2700645"/>
              <a:gd name="connsiteX4" fmla="*/ 323823 w 4035853"/>
              <a:gd name="connsiteY4" fmla="*/ 2700356 h 2700645"/>
              <a:gd name="connsiteX5" fmla="*/ 0 w 4035853"/>
              <a:gd name="connsiteY5" fmla="*/ 2697096 h 2700645"/>
              <a:gd name="connsiteX6" fmla="*/ 0 w 4035853"/>
              <a:gd name="connsiteY6" fmla="*/ 0 h 2700645"/>
              <a:gd name="connsiteX0" fmla="*/ 0 w 4035853"/>
              <a:gd name="connsiteY0" fmla="*/ 0 h 2700645"/>
              <a:gd name="connsiteX1" fmla="*/ 4035853 w 4035853"/>
              <a:gd name="connsiteY1" fmla="*/ 0 h 2700645"/>
              <a:gd name="connsiteX2" fmla="*/ 4035853 w 4035853"/>
              <a:gd name="connsiteY2" fmla="*/ 2697096 h 2700645"/>
              <a:gd name="connsiteX3" fmla="*/ 612823 w 4035853"/>
              <a:gd name="connsiteY3" fmla="*/ 2689412 h 2700645"/>
              <a:gd name="connsiteX4" fmla="*/ 171423 w 4035853"/>
              <a:gd name="connsiteY4" fmla="*/ 2700356 h 2700645"/>
              <a:gd name="connsiteX5" fmla="*/ 0 w 4035853"/>
              <a:gd name="connsiteY5" fmla="*/ 2697096 h 2700645"/>
              <a:gd name="connsiteX6" fmla="*/ 0 w 4035853"/>
              <a:gd name="connsiteY6" fmla="*/ 0 h 2700645"/>
              <a:gd name="connsiteX0" fmla="*/ 0 w 4035853"/>
              <a:gd name="connsiteY0" fmla="*/ 0 h 2700645"/>
              <a:gd name="connsiteX1" fmla="*/ 4035853 w 4035853"/>
              <a:gd name="connsiteY1" fmla="*/ 0 h 2700645"/>
              <a:gd name="connsiteX2" fmla="*/ 4035853 w 4035853"/>
              <a:gd name="connsiteY2" fmla="*/ 2697096 h 2700645"/>
              <a:gd name="connsiteX3" fmla="*/ 612823 w 4035853"/>
              <a:gd name="connsiteY3" fmla="*/ 2689412 h 2700645"/>
              <a:gd name="connsiteX4" fmla="*/ 171423 w 4035853"/>
              <a:gd name="connsiteY4" fmla="*/ 2700356 h 2700645"/>
              <a:gd name="connsiteX5" fmla="*/ 0 w 4035853"/>
              <a:gd name="connsiteY5" fmla="*/ 2697096 h 2700645"/>
              <a:gd name="connsiteX6" fmla="*/ 0 w 4035853"/>
              <a:gd name="connsiteY6" fmla="*/ 0 h 2700645"/>
              <a:gd name="connsiteX0" fmla="*/ 0 w 4035853"/>
              <a:gd name="connsiteY0" fmla="*/ 0 h 2700356"/>
              <a:gd name="connsiteX1" fmla="*/ 4035853 w 4035853"/>
              <a:gd name="connsiteY1" fmla="*/ 0 h 2700356"/>
              <a:gd name="connsiteX2" fmla="*/ 4035853 w 4035853"/>
              <a:gd name="connsiteY2" fmla="*/ 2697096 h 2700356"/>
              <a:gd name="connsiteX3" fmla="*/ 612823 w 4035853"/>
              <a:gd name="connsiteY3" fmla="*/ 2689412 h 2700356"/>
              <a:gd name="connsiteX4" fmla="*/ 171423 w 4035853"/>
              <a:gd name="connsiteY4" fmla="*/ 2700356 h 2700356"/>
              <a:gd name="connsiteX5" fmla="*/ 0 w 4035853"/>
              <a:gd name="connsiteY5" fmla="*/ 2697096 h 2700356"/>
              <a:gd name="connsiteX6" fmla="*/ 0 w 4035853"/>
              <a:gd name="connsiteY6" fmla="*/ 0 h 2700356"/>
              <a:gd name="connsiteX0" fmla="*/ 0 w 4035853"/>
              <a:gd name="connsiteY0" fmla="*/ 0 h 2697975"/>
              <a:gd name="connsiteX1" fmla="*/ 4035853 w 4035853"/>
              <a:gd name="connsiteY1" fmla="*/ 0 h 2697975"/>
              <a:gd name="connsiteX2" fmla="*/ 4035853 w 4035853"/>
              <a:gd name="connsiteY2" fmla="*/ 2697096 h 2697975"/>
              <a:gd name="connsiteX3" fmla="*/ 612823 w 4035853"/>
              <a:gd name="connsiteY3" fmla="*/ 2689412 h 2697975"/>
              <a:gd name="connsiteX4" fmla="*/ 171423 w 4035853"/>
              <a:gd name="connsiteY4" fmla="*/ 2697975 h 2697975"/>
              <a:gd name="connsiteX5" fmla="*/ 0 w 4035853"/>
              <a:gd name="connsiteY5" fmla="*/ 2697096 h 2697975"/>
              <a:gd name="connsiteX6" fmla="*/ 0 w 4035853"/>
              <a:gd name="connsiteY6" fmla="*/ 0 h 2697975"/>
              <a:gd name="connsiteX0" fmla="*/ 0 w 4035853"/>
              <a:gd name="connsiteY0" fmla="*/ 0 h 2698065"/>
              <a:gd name="connsiteX1" fmla="*/ 4035853 w 4035853"/>
              <a:gd name="connsiteY1" fmla="*/ 0 h 2698065"/>
              <a:gd name="connsiteX2" fmla="*/ 4035853 w 4035853"/>
              <a:gd name="connsiteY2" fmla="*/ 2697096 h 2698065"/>
              <a:gd name="connsiteX3" fmla="*/ 612823 w 4035853"/>
              <a:gd name="connsiteY3" fmla="*/ 2689412 h 2698065"/>
              <a:gd name="connsiteX4" fmla="*/ 171423 w 4035853"/>
              <a:gd name="connsiteY4" fmla="*/ 2697975 h 2698065"/>
              <a:gd name="connsiteX5" fmla="*/ 0 w 4035853"/>
              <a:gd name="connsiteY5" fmla="*/ 2697096 h 2698065"/>
              <a:gd name="connsiteX6" fmla="*/ 0 w 4035853"/>
              <a:gd name="connsiteY6" fmla="*/ 0 h 2698065"/>
              <a:gd name="connsiteX0" fmla="*/ 0 w 4035853"/>
              <a:gd name="connsiteY0" fmla="*/ 0 h 2697975"/>
              <a:gd name="connsiteX1" fmla="*/ 4035853 w 4035853"/>
              <a:gd name="connsiteY1" fmla="*/ 0 h 2697975"/>
              <a:gd name="connsiteX2" fmla="*/ 4035853 w 4035853"/>
              <a:gd name="connsiteY2" fmla="*/ 2697096 h 2697975"/>
              <a:gd name="connsiteX3" fmla="*/ 581867 w 4035853"/>
              <a:gd name="connsiteY3" fmla="*/ 2696556 h 2697975"/>
              <a:gd name="connsiteX4" fmla="*/ 171423 w 4035853"/>
              <a:gd name="connsiteY4" fmla="*/ 2697975 h 2697975"/>
              <a:gd name="connsiteX5" fmla="*/ 0 w 4035853"/>
              <a:gd name="connsiteY5" fmla="*/ 2697096 h 2697975"/>
              <a:gd name="connsiteX6" fmla="*/ 0 w 4035853"/>
              <a:gd name="connsiteY6" fmla="*/ 0 h 2697975"/>
              <a:gd name="connsiteX0" fmla="*/ 0 w 4035853"/>
              <a:gd name="connsiteY0" fmla="*/ 0 h 2697975"/>
              <a:gd name="connsiteX1" fmla="*/ 4035853 w 4035853"/>
              <a:gd name="connsiteY1" fmla="*/ 0 h 2697975"/>
              <a:gd name="connsiteX2" fmla="*/ 4035853 w 4035853"/>
              <a:gd name="connsiteY2" fmla="*/ 2697096 h 2697975"/>
              <a:gd name="connsiteX3" fmla="*/ 581867 w 4035853"/>
              <a:gd name="connsiteY3" fmla="*/ 2696556 h 2697975"/>
              <a:gd name="connsiteX4" fmla="*/ 171423 w 4035853"/>
              <a:gd name="connsiteY4" fmla="*/ 2697975 h 2697975"/>
              <a:gd name="connsiteX5" fmla="*/ 0 w 4035853"/>
              <a:gd name="connsiteY5" fmla="*/ 2697096 h 2697975"/>
              <a:gd name="connsiteX6" fmla="*/ 0 w 4035853"/>
              <a:gd name="connsiteY6" fmla="*/ 0 h 2697975"/>
              <a:gd name="connsiteX0" fmla="*/ 0 w 4035853"/>
              <a:gd name="connsiteY0" fmla="*/ 0 h 2698071"/>
              <a:gd name="connsiteX1" fmla="*/ 4035853 w 4035853"/>
              <a:gd name="connsiteY1" fmla="*/ 0 h 2698071"/>
              <a:gd name="connsiteX2" fmla="*/ 4035853 w 4035853"/>
              <a:gd name="connsiteY2" fmla="*/ 2697096 h 2698071"/>
              <a:gd name="connsiteX3" fmla="*/ 438992 w 4035853"/>
              <a:gd name="connsiteY3" fmla="*/ 2696556 h 2698071"/>
              <a:gd name="connsiteX4" fmla="*/ 171423 w 4035853"/>
              <a:gd name="connsiteY4" fmla="*/ 2697975 h 2698071"/>
              <a:gd name="connsiteX5" fmla="*/ 0 w 4035853"/>
              <a:gd name="connsiteY5" fmla="*/ 2697096 h 2698071"/>
              <a:gd name="connsiteX6" fmla="*/ 0 w 4035853"/>
              <a:gd name="connsiteY6" fmla="*/ 0 h 2698071"/>
              <a:gd name="connsiteX0" fmla="*/ 0 w 4035853"/>
              <a:gd name="connsiteY0" fmla="*/ 0 h 2698071"/>
              <a:gd name="connsiteX1" fmla="*/ 4035853 w 4035853"/>
              <a:gd name="connsiteY1" fmla="*/ 0 h 2698071"/>
              <a:gd name="connsiteX2" fmla="*/ 4035853 w 4035853"/>
              <a:gd name="connsiteY2" fmla="*/ 2697096 h 2698071"/>
              <a:gd name="connsiteX3" fmla="*/ 441373 w 4035853"/>
              <a:gd name="connsiteY3" fmla="*/ 2696556 h 2698071"/>
              <a:gd name="connsiteX4" fmla="*/ 171423 w 4035853"/>
              <a:gd name="connsiteY4" fmla="*/ 2697975 h 2698071"/>
              <a:gd name="connsiteX5" fmla="*/ 0 w 4035853"/>
              <a:gd name="connsiteY5" fmla="*/ 2697096 h 2698071"/>
              <a:gd name="connsiteX6" fmla="*/ 0 w 4035853"/>
              <a:gd name="connsiteY6" fmla="*/ 0 h 2698071"/>
              <a:gd name="connsiteX0" fmla="*/ 0 w 4035853"/>
              <a:gd name="connsiteY0" fmla="*/ 0 h 2700356"/>
              <a:gd name="connsiteX1" fmla="*/ 4035853 w 4035853"/>
              <a:gd name="connsiteY1" fmla="*/ 0 h 2700356"/>
              <a:gd name="connsiteX2" fmla="*/ 4035853 w 4035853"/>
              <a:gd name="connsiteY2" fmla="*/ 2697096 h 2700356"/>
              <a:gd name="connsiteX3" fmla="*/ 441373 w 4035853"/>
              <a:gd name="connsiteY3" fmla="*/ 2696556 h 2700356"/>
              <a:gd name="connsiteX4" fmla="*/ 173804 w 4035853"/>
              <a:gd name="connsiteY4" fmla="*/ 2700356 h 2700356"/>
              <a:gd name="connsiteX5" fmla="*/ 0 w 4035853"/>
              <a:gd name="connsiteY5" fmla="*/ 2697096 h 2700356"/>
              <a:gd name="connsiteX6" fmla="*/ 0 w 4035853"/>
              <a:gd name="connsiteY6" fmla="*/ 0 h 2700356"/>
              <a:gd name="connsiteX0" fmla="*/ 0 w 4035853"/>
              <a:gd name="connsiteY0" fmla="*/ 0 h 2700356"/>
              <a:gd name="connsiteX1" fmla="*/ 4035853 w 4035853"/>
              <a:gd name="connsiteY1" fmla="*/ 0 h 2700356"/>
              <a:gd name="connsiteX2" fmla="*/ 4035853 w 4035853"/>
              <a:gd name="connsiteY2" fmla="*/ 2697096 h 2700356"/>
              <a:gd name="connsiteX3" fmla="*/ 441373 w 4035853"/>
              <a:gd name="connsiteY3" fmla="*/ 2696556 h 2700356"/>
              <a:gd name="connsiteX4" fmla="*/ 173804 w 4035853"/>
              <a:gd name="connsiteY4" fmla="*/ 2700356 h 2700356"/>
              <a:gd name="connsiteX5" fmla="*/ 0 w 4035853"/>
              <a:gd name="connsiteY5" fmla="*/ 2697096 h 2700356"/>
              <a:gd name="connsiteX6" fmla="*/ 0 w 4035853"/>
              <a:gd name="connsiteY6" fmla="*/ 0 h 2700356"/>
              <a:gd name="connsiteX0" fmla="*/ 0 w 4035853"/>
              <a:gd name="connsiteY0" fmla="*/ 0 h 2700356"/>
              <a:gd name="connsiteX1" fmla="*/ 4035853 w 4035853"/>
              <a:gd name="connsiteY1" fmla="*/ 0 h 2700356"/>
              <a:gd name="connsiteX2" fmla="*/ 4035853 w 4035853"/>
              <a:gd name="connsiteY2" fmla="*/ 2697096 h 2700356"/>
              <a:gd name="connsiteX3" fmla="*/ 441373 w 4035853"/>
              <a:gd name="connsiteY3" fmla="*/ 2696556 h 2700356"/>
              <a:gd name="connsiteX4" fmla="*/ 173804 w 4035853"/>
              <a:gd name="connsiteY4" fmla="*/ 2700356 h 2700356"/>
              <a:gd name="connsiteX5" fmla="*/ 0 w 4035853"/>
              <a:gd name="connsiteY5" fmla="*/ 2697096 h 2700356"/>
              <a:gd name="connsiteX6" fmla="*/ 0 w 4035853"/>
              <a:gd name="connsiteY6" fmla="*/ 0 h 2700356"/>
              <a:gd name="connsiteX0" fmla="*/ 0 w 4035853"/>
              <a:gd name="connsiteY0" fmla="*/ 0 h 2700356"/>
              <a:gd name="connsiteX1" fmla="*/ 4035853 w 4035853"/>
              <a:gd name="connsiteY1" fmla="*/ 0 h 2700356"/>
              <a:gd name="connsiteX2" fmla="*/ 4035853 w 4035853"/>
              <a:gd name="connsiteY2" fmla="*/ 2697096 h 2700356"/>
              <a:gd name="connsiteX3" fmla="*/ 441373 w 4035853"/>
              <a:gd name="connsiteY3" fmla="*/ 2696556 h 2700356"/>
              <a:gd name="connsiteX4" fmla="*/ 164279 w 4035853"/>
              <a:gd name="connsiteY4" fmla="*/ 2700356 h 2700356"/>
              <a:gd name="connsiteX5" fmla="*/ 0 w 4035853"/>
              <a:gd name="connsiteY5" fmla="*/ 2697096 h 2700356"/>
              <a:gd name="connsiteX6" fmla="*/ 0 w 4035853"/>
              <a:gd name="connsiteY6" fmla="*/ 0 h 2700356"/>
              <a:gd name="connsiteX0" fmla="*/ 0 w 4035853"/>
              <a:gd name="connsiteY0" fmla="*/ 0 h 2700357"/>
              <a:gd name="connsiteX1" fmla="*/ 4035853 w 4035853"/>
              <a:gd name="connsiteY1" fmla="*/ 0 h 2700357"/>
              <a:gd name="connsiteX2" fmla="*/ 4035853 w 4035853"/>
              <a:gd name="connsiteY2" fmla="*/ 2697096 h 2700357"/>
              <a:gd name="connsiteX3" fmla="*/ 434229 w 4035853"/>
              <a:gd name="connsiteY3" fmla="*/ 2696556 h 2700357"/>
              <a:gd name="connsiteX4" fmla="*/ 164279 w 4035853"/>
              <a:gd name="connsiteY4" fmla="*/ 2700356 h 2700357"/>
              <a:gd name="connsiteX5" fmla="*/ 0 w 4035853"/>
              <a:gd name="connsiteY5" fmla="*/ 2697096 h 2700357"/>
              <a:gd name="connsiteX6" fmla="*/ 0 w 4035853"/>
              <a:gd name="connsiteY6" fmla="*/ 0 h 2700357"/>
              <a:gd name="connsiteX0" fmla="*/ 0 w 4035853"/>
              <a:gd name="connsiteY0" fmla="*/ 0 h 2701319"/>
              <a:gd name="connsiteX1" fmla="*/ 4035853 w 4035853"/>
              <a:gd name="connsiteY1" fmla="*/ 0 h 2701319"/>
              <a:gd name="connsiteX2" fmla="*/ 4035853 w 4035853"/>
              <a:gd name="connsiteY2" fmla="*/ 2697096 h 2701319"/>
              <a:gd name="connsiteX3" fmla="*/ 431848 w 4035853"/>
              <a:gd name="connsiteY3" fmla="*/ 2701319 h 2701319"/>
              <a:gd name="connsiteX4" fmla="*/ 164279 w 4035853"/>
              <a:gd name="connsiteY4" fmla="*/ 2700356 h 2701319"/>
              <a:gd name="connsiteX5" fmla="*/ 0 w 4035853"/>
              <a:gd name="connsiteY5" fmla="*/ 2697096 h 2701319"/>
              <a:gd name="connsiteX6" fmla="*/ 0 w 4035853"/>
              <a:gd name="connsiteY6" fmla="*/ 0 h 2701319"/>
              <a:gd name="connsiteX0" fmla="*/ 0 w 4035853"/>
              <a:gd name="connsiteY0" fmla="*/ 0 h 2701319"/>
              <a:gd name="connsiteX1" fmla="*/ 4035853 w 4035853"/>
              <a:gd name="connsiteY1" fmla="*/ 0 h 2701319"/>
              <a:gd name="connsiteX2" fmla="*/ 4035853 w 4035853"/>
              <a:gd name="connsiteY2" fmla="*/ 2697096 h 2701319"/>
              <a:gd name="connsiteX3" fmla="*/ 431848 w 4035853"/>
              <a:gd name="connsiteY3" fmla="*/ 2701319 h 2701319"/>
              <a:gd name="connsiteX4" fmla="*/ 311945 w 4035853"/>
              <a:gd name="connsiteY4" fmla="*/ 2697956 h 2701319"/>
              <a:gd name="connsiteX5" fmla="*/ 164279 w 4035853"/>
              <a:gd name="connsiteY5" fmla="*/ 2700356 h 2701319"/>
              <a:gd name="connsiteX6" fmla="*/ 0 w 4035853"/>
              <a:gd name="connsiteY6" fmla="*/ 2697096 h 2701319"/>
              <a:gd name="connsiteX7" fmla="*/ 0 w 4035853"/>
              <a:gd name="connsiteY7" fmla="*/ 0 h 2701319"/>
              <a:gd name="connsiteX0" fmla="*/ 0 w 4035853"/>
              <a:gd name="connsiteY0" fmla="*/ 0 h 2943225"/>
              <a:gd name="connsiteX1" fmla="*/ 4035853 w 4035853"/>
              <a:gd name="connsiteY1" fmla="*/ 0 h 2943225"/>
              <a:gd name="connsiteX2" fmla="*/ 4035853 w 4035853"/>
              <a:gd name="connsiteY2" fmla="*/ 2697096 h 2943225"/>
              <a:gd name="connsiteX3" fmla="*/ 431848 w 4035853"/>
              <a:gd name="connsiteY3" fmla="*/ 2701319 h 2943225"/>
              <a:gd name="connsiteX4" fmla="*/ 307182 w 4035853"/>
              <a:gd name="connsiteY4" fmla="*/ 2943225 h 2943225"/>
              <a:gd name="connsiteX5" fmla="*/ 164279 w 4035853"/>
              <a:gd name="connsiteY5" fmla="*/ 2700356 h 2943225"/>
              <a:gd name="connsiteX6" fmla="*/ 0 w 4035853"/>
              <a:gd name="connsiteY6" fmla="*/ 2697096 h 2943225"/>
              <a:gd name="connsiteX7" fmla="*/ 0 w 4035853"/>
              <a:gd name="connsiteY7" fmla="*/ 0 h 2943225"/>
              <a:gd name="connsiteX0" fmla="*/ 0 w 4035853"/>
              <a:gd name="connsiteY0" fmla="*/ 0 h 2943225"/>
              <a:gd name="connsiteX1" fmla="*/ 4035853 w 4035853"/>
              <a:gd name="connsiteY1" fmla="*/ 0 h 2943225"/>
              <a:gd name="connsiteX2" fmla="*/ 4035853 w 4035853"/>
              <a:gd name="connsiteY2" fmla="*/ 2697096 h 2943225"/>
              <a:gd name="connsiteX3" fmla="*/ 431848 w 4035853"/>
              <a:gd name="connsiteY3" fmla="*/ 2701319 h 2943225"/>
              <a:gd name="connsiteX4" fmla="*/ 307182 w 4035853"/>
              <a:gd name="connsiteY4" fmla="*/ 2943225 h 2943225"/>
              <a:gd name="connsiteX5" fmla="*/ 164279 w 4035853"/>
              <a:gd name="connsiteY5" fmla="*/ 2700356 h 2943225"/>
              <a:gd name="connsiteX6" fmla="*/ 0 w 4035853"/>
              <a:gd name="connsiteY6" fmla="*/ 2697096 h 2943225"/>
              <a:gd name="connsiteX7" fmla="*/ 0 w 4035853"/>
              <a:gd name="connsiteY7" fmla="*/ 0 h 2943225"/>
              <a:gd name="connsiteX0" fmla="*/ 0 w 4035853"/>
              <a:gd name="connsiteY0" fmla="*/ 0 h 2943225"/>
              <a:gd name="connsiteX1" fmla="*/ 4035853 w 4035853"/>
              <a:gd name="connsiteY1" fmla="*/ 0 h 2943225"/>
              <a:gd name="connsiteX2" fmla="*/ 4035853 w 4035853"/>
              <a:gd name="connsiteY2" fmla="*/ 2697096 h 2943225"/>
              <a:gd name="connsiteX3" fmla="*/ 431848 w 4035853"/>
              <a:gd name="connsiteY3" fmla="*/ 2701319 h 2943225"/>
              <a:gd name="connsiteX4" fmla="*/ 307182 w 4035853"/>
              <a:gd name="connsiteY4" fmla="*/ 2943225 h 2943225"/>
              <a:gd name="connsiteX5" fmla="*/ 164279 w 4035853"/>
              <a:gd name="connsiteY5" fmla="*/ 2700356 h 2943225"/>
              <a:gd name="connsiteX6" fmla="*/ 0 w 4035853"/>
              <a:gd name="connsiteY6" fmla="*/ 2697096 h 2943225"/>
              <a:gd name="connsiteX7" fmla="*/ 0 w 4035853"/>
              <a:gd name="connsiteY7" fmla="*/ 0 h 2943225"/>
              <a:gd name="connsiteX0" fmla="*/ 0 w 4035853"/>
              <a:gd name="connsiteY0" fmla="*/ 0 h 2943225"/>
              <a:gd name="connsiteX1" fmla="*/ 4035853 w 4035853"/>
              <a:gd name="connsiteY1" fmla="*/ 0 h 2943225"/>
              <a:gd name="connsiteX2" fmla="*/ 4035853 w 4035853"/>
              <a:gd name="connsiteY2" fmla="*/ 2697096 h 2943225"/>
              <a:gd name="connsiteX3" fmla="*/ 431848 w 4035853"/>
              <a:gd name="connsiteY3" fmla="*/ 2701319 h 2943225"/>
              <a:gd name="connsiteX4" fmla="*/ 307182 w 4035853"/>
              <a:gd name="connsiteY4" fmla="*/ 2943225 h 2943225"/>
              <a:gd name="connsiteX5" fmla="*/ 164279 w 4035853"/>
              <a:gd name="connsiteY5" fmla="*/ 2700356 h 2943225"/>
              <a:gd name="connsiteX6" fmla="*/ 0 w 4035853"/>
              <a:gd name="connsiteY6" fmla="*/ 2697096 h 2943225"/>
              <a:gd name="connsiteX7" fmla="*/ 0 w 4035853"/>
              <a:gd name="connsiteY7" fmla="*/ 0 h 2943225"/>
              <a:gd name="connsiteX0" fmla="*/ 0 w 4035853"/>
              <a:gd name="connsiteY0" fmla="*/ 0 h 2943225"/>
              <a:gd name="connsiteX1" fmla="*/ 4035853 w 4035853"/>
              <a:gd name="connsiteY1" fmla="*/ 0 h 2943225"/>
              <a:gd name="connsiteX2" fmla="*/ 4035853 w 4035853"/>
              <a:gd name="connsiteY2" fmla="*/ 2697096 h 2943225"/>
              <a:gd name="connsiteX3" fmla="*/ 431848 w 4035853"/>
              <a:gd name="connsiteY3" fmla="*/ 2701319 h 2943225"/>
              <a:gd name="connsiteX4" fmla="*/ 307182 w 4035853"/>
              <a:gd name="connsiteY4" fmla="*/ 2943225 h 2943225"/>
              <a:gd name="connsiteX5" fmla="*/ 164279 w 4035853"/>
              <a:gd name="connsiteY5" fmla="*/ 2700356 h 2943225"/>
              <a:gd name="connsiteX6" fmla="*/ 0 w 4035853"/>
              <a:gd name="connsiteY6" fmla="*/ 2697096 h 2943225"/>
              <a:gd name="connsiteX7" fmla="*/ 0 w 4035853"/>
              <a:gd name="connsiteY7" fmla="*/ 0 h 2943225"/>
              <a:gd name="connsiteX0" fmla="*/ 0 w 4035853"/>
              <a:gd name="connsiteY0" fmla="*/ 0 h 2936082"/>
              <a:gd name="connsiteX1" fmla="*/ 4035853 w 4035853"/>
              <a:gd name="connsiteY1" fmla="*/ 0 h 2936082"/>
              <a:gd name="connsiteX2" fmla="*/ 4035853 w 4035853"/>
              <a:gd name="connsiteY2" fmla="*/ 2697096 h 2936082"/>
              <a:gd name="connsiteX3" fmla="*/ 431848 w 4035853"/>
              <a:gd name="connsiteY3" fmla="*/ 2701319 h 2936082"/>
              <a:gd name="connsiteX4" fmla="*/ 302420 w 4035853"/>
              <a:gd name="connsiteY4" fmla="*/ 2936082 h 2936082"/>
              <a:gd name="connsiteX5" fmla="*/ 164279 w 4035853"/>
              <a:gd name="connsiteY5" fmla="*/ 2700356 h 2936082"/>
              <a:gd name="connsiteX6" fmla="*/ 0 w 4035853"/>
              <a:gd name="connsiteY6" fmla="*/ 2697096 h 2936082"/>
              <a:gd name="connsiteX7" fmla="*/ 0 w 4035853"/>
              <a:gd name="connsiteY7" fmla="*/ 0 h 2936082"/>
              <a:gd name="connsiteX0" fmla="*/ 0 w 4035853"/>
              <a:gd name="connsiteY0" fmla="*/ 0 h 2936082"/>
              <a:gd name="connsiteX1" fmla="*/ 4035853 w 4035853"/>
              <a:gd name="connsiteY1" fmla="*/ 0 h 2936082"/>
              <a:gd name="connsiteX2" fmla="*/ 4035853 w 4035853"/>
              <a:gd name="connsiteY2" fmla="*/ 2697096 h 2936082"/>
              <a:gd name="connsiteX3" fmla="*/ 431848 w 4035853"/>
              <a:gd name="connsiteY3" fmla="*/ 2701319 h 2936082"/>
              <a:gd name="connsiteX4" fmla="*/ 302420 w 4035853"/>
              <a:gd name="connsiteY4" fmla="*/ 2936082 h 2936082"/>
              <a:gd name="connsiteX5" fmla="*/ 164279 w 4035853"/>
              <a:gd name="connsiteY5" fmla="*/ 2700356 h 2936082"/>
              <a:gd name="connsiteX6" fmla="*/ 0 w 4035853"/>
              <a:gd name="connsiteY6" fmla="*/ 2697096 h 2936082"/>
              <a:gd name="connsiteX7" fmla="*/ 0 w 4035853"/>
              <a:gd name="connsiteY7" fmla="*/ 0 h 2936082"/>
              <a:gd name="connsiteX0" fmla="*/ 0 w 4035853"/>
              <a:gd name="connsiteY0" fmla="*/ 0 h 2936082"/>
              <a:gd name="connsiteX1" fmla="*/ 4035853 w 4035853"/>
              <a:gd name="connsiteY1" fmla="*/ 0 h 2936082"/>
              <a:gd name="connsiteX2" fmla="*/ 4035853 w 4035853"/>
              <a:gd name="connsiteY2" fmla="*/ 2697096 h 2936082"/>
              <a:gd name="connsiteX3" fmla="*/ 431848 w 4035853"/>
              <a:gd name="connsiteY3" fmla="*/ 2701319 h 2936082"/>
              <a:gd name="connsiteX4" fmla="*/ 302420 w 4035853"/>
              <a:gd name="connsiteY4" fmla="*/ 2936082 h 2936082"/>
              <a:gd name="connsiteX5" fmla="*/ 164279 w 4035853"/>
              <a:gd name="connsiteY5" fmla="*/ 2700356 h 2936082"/>
              <a:gd name="connsiteX6" fmla="*/ 0 w 4035853"/>
              <a:gd name="connsiteY6" fmla="*/ 2697096 h 2936082"/>
              <a:gd name="connsiteX7" fmla="*/ 0 w 4035853"/>
              <a:gd name="connsiteY7" fmla="*/ 0 h 2936082"/>
              <a:gd name="connsiteX0" fmla="*/ 0 w 4035853"/>
              <a:gd name="connsiteY0" fmla="*/ 0 h 2936085"/>
              <a:gd name="connsiteX1" fmla="*/ 4035853 w 4035853"/>
              <a:gd name="connsiteY1" fmla="*/ 0 h 2936085"/>
              <a:gd name="connsiteX2" fmla="*/ 4035853 w 4035853"/>
              <a:gd name="connsiteY2" fmla="*/ 2697096 h 2936085"/>
              <a:gd name="connsiteX3" fmla="*/ 431848 w 4035853"/>
              <a:gd name="connsiteY3" fmla="*/ 2701319 h 2936085"/>
              <a:gd name="connsiteX4" fmla="*/ 302420 w 4035853"/>
              <a:gd name="connsiteY4" fmla="*/ 2936082 h 2936085"/>
              <a:gd name="connsiteX5" fmla="*/ 166660 w 4035853"/>
              <a:gd name="connsiteY5" fmla="*/ 2695594 h 2936085"/>
              <a:gd name="connsiteX6" fmla="*/ 0 w 4035853"/>
              <a:gd name="connsiteY6" fmla="*/ 2697096 h 2936085"/>
              <a:gd name="connsiteX7" fmla="*/ 0 w 4035853"/>
              <a:gd name="connsiteY7" fmla="*/ 0 h 2936085"/>
              <a:gd name="connsiteX0" fmla="*/ 0 w 4035853"/>
              <a:gd name="connsiteY0" fmla="*/ 0 h 2936085"/>
              <a:gd name="connsiteX1" fmla="*/ 4035853 w 4035853"/>
              <a:gd name="connsiteY1" fmla="*/ 0 h 2936085"/>
              <a:gd name="connsiteX2" fmla="*/ 4035853 w 4035853"/>
              <a:gd name="connsiteY2" fmla="*/ 2697096 h 2936085"/>
              <a:gd name="connsiteX3" fmla="*/ 431848 w 4035853"/>
              <a:gd name="connsiteY3" fmla="*/ 2701319 h 2936085"/>
              <a:gd name="connsiteX4" fmla="*/ 302420 w 4035853"/>
              <a:gd name="connsiteY4" fmla="*/ 2936082 h 2936085"/>
              <a:gd name="connsiteX5" fmla="*/ 166660 w 4035853"/>
              <a:gd name="connsiteY5" fmla="*/ 2695594 h 2936085"/>
              <a:gd name="connsiteX6" fmla="*/ 0 w 4035853"/>
              <a:gd name="connsiteY6" fmla="*/ 2697096 h 2936085"/>
              <a:gd name="connsiteX7" fmla="*/ 0 w 4035853"/>
              <a:gd name="connsiteY7" fmla="*/ 0 h 2936085"/>
              <a:gd name="connsiteX0" fmla="*/ 0 w 4035853"/>
              <a:gd name="connsiteY0" fmla="*/ 0 h 2936085"/>
              <a:gd name="connsiteX1" fmla="*/ 4035853 w 4035853"/>
              <a:gd name="connsiteY1" fmla="*/ 0 h 2936085"/>
              <a:gd name="connsiteX2" fmla="*/ 4035853 w 4035853"/>
              <a:gd name="connsiteY2" fmla="*/ 2697096 h 2936085"/>
              <a:gd name="connsiteX3" fmla="*/ 431848 w 4035853"/>
              <a:gd name="connsiteY3" fmla="*/ 2701319 h 2936085"/>
              <a:gd name="connsiteX4" fmla="*/ 302420 w 4035853"/>
              <a:gd name="connsiteY4" fmla="*/ 2936082 h 2936085"/>
              <a:gd name="connsiteX5" fmla="*/ 166660 w 4035853"/>
              <a:gd name="connsiteY5" fmla="*/ 2695594 h 2936085"/>
              <a:gd name="connsiteX6" fmla="*/ 0 w 4035853"/>
              <a:gd name="connsiteY6" fmla="*/ 2697096 h 2936085"/>
              <a:gd name="connsiteX7" fmla="*/ 0 w 4035853"/>
              <a:gd name="connsiteY7" fmla="*/ 0 h 2936085"/>
              <a:gd name="connsiteX0" fmla="*/ 0 w 4035853"/>
              <a:gd name="connsiteY0" fmla="*/ 0 h 2936090"/>
              <a:gd name="connsiteX1" fmla="*/ 4035853 w 4035853"/>
              <a:gd name="connsiteY1" fmla="*/ 0 h 2936090"/>
              <a:gd name="connsiteX2" fmla="*/ 4035853 w 4035853"/>
              <a:gd name="connsiteY2" fmla="*/ 2697096 h 2936090"/>
              <a:gd name="connsiteX3" fmla="*/ 431848 w 4035853"/>
              <a:gd name="connsiteY3" fmla="*/ 2701319 h 2936090"/>
              <a:gd name="connsiteX4" fmla="*/ 302420 w 4035853"/>
              <a:gd name="connsiteY4" fmla="*/ 2936082 h 2936090"/>
              <a:gd name="connsiteX5" fmla="*/ 166660 w 4035853"/>
              <a:gd name="connsiteY5" fmla="*/ 2695594 h 2936090"/>
              <a:gd name="connsiteX6" fmla="*/ 0 w 4035853"/>
              <a:gd name="connsiteY6" fmla="*/ 2697096 h 2936090"/>
              <a:gd name="connsiteX7" fmla="*/ 0 w 4035853"/>
              <a:gd name="connsiteY7" fmla="*/ 0 h 2936090"/>
              <a:gd name="connsiteX0" fmla="*/ 0 w 4035853"/>
              <a:gd name="connsiteY0" fmla="*/ 0 h 2936082"/>
              <a:gd name="connsiteX1" fmla="*/ 4035853 w 4035853"/>
              <a:gd name="connsiteY1" fmla="*/ 0 h 2936082"/>
              <a:gd name="connsiteX2" fmla="*/ 4035853 w 4035853"/>
              <a:gd name="connsiteY2" fmla="*/ 2697096 h 2936082"/>
              <a:gd name="connsiteX3" fmla="*/ 431848 w 4035853"/>
              <a:gd name="connsiteY3" fmla="*/ 2696556 h 2936082"/>
              <a:gd name="connsiteX4" fmla="*/ 302420 w 4035853"/>
              <a:gd name="connsiteY4" fmla="*/ 2936082 h 2936082"/>
              <a:gd name="connsiteX5" fmla="*/ 166660 w 4035853"/>
              <a:gd name="connsiteY5" fmla="*/ 2695594 h 2936082"/>
              <a:gd name="connsiteX6" fmla="*/ 0 w 4035853"/>
              <a:gd name="connsiteY6" fmla="*/ 2697096 h 2936082"/>
              <a:gd name="connsiteX7" fmla="*/ 0 w 4035853"/>
              <a:gd name="connsiteY7" fmla="*/ 0 h 2936082"/>
              <a:gd name="connsiteX0" fmla="*/ 0 w 4035853"/>
              <a:gd name="connsiteY0" fmla="*/ 0 h 2967038"/>
              <a:gd name="connsiteX1" fmla="*/ 4035853 w 4035853"/>
              <a:gd name="connsiteY1" fmla="*/ 0 h 2967038"/>
              <a:gd name="connsiteX2" fmla="*/ 4035853 w 4035853"/>
              <a:gd name="connsiteY2" fmla="*/ 2697096 h 2967038"/>
              <a:gd name="connsiteX3" fmla="*/ 431848 w 4035853"/>
              <a:gd name="connsiteY3" fmla="*/ 2696556 h 2967038"/>
              <a:gd name="connsiteX4" fmla="*/ 300039 w 4035853"/>
              <a:gd name="connsiteY4" fmla="*/ 2967038 h 2967038"/>
              <a:gd name="connsiteX5" fmla="*/ 166660 w 4035853"/>
              <a:gd name="connsiteY5" fmla="*/ 2695594 h 2967038"/>
              <a:gd name="connsiteX6" fmla="*/ 0 w 4035853"/>
              <a:gd name="connsiteY6" fmla="*/ 2697096 h 2967038"/>
              <a:gd name="connsiteX7" fmla="*/ 0 w 4035853"/>
              <a:gd name="connsiteY7" fmla="*/ 0 h 2967038"/>
              <a:gd name="connsiteX0" fmla="*/ 0 w 4035853"/>
              <a:gd name="connsiteY0" fmla="*/ 0 h 2933700"/>
              <a:gd name="connsiteX1" fmla="*/ 4035853 w 4035853"/>
              <a:gd name="connsiteY1" fmla="*/ 0 h 2933700"/>
              <a:gd name="connsiteX2" fmla="*/ 4035853 w 4035853"/>
              <a:gd name="connsiteY2" fmla="*/ 2697096 h 2933700"/>
              <a:gd name="connsiteX3" fmla="*/ 431848 w 4035853"/>
              <a:gd name="connsiteY3" fmla="*/ 2696556 h 2933700"/>
              <a:gd name="connsiteX4" fmla="*/ 302420 w 4035853"/>
              <a:gd name="connsiteY4" fmla="*/ 2933700 h 2933700"/>
              <a:gd name="connsiteX5" fmla="*/ 166660 w 4035853"/>
              <a:gd name="connsiteY5" fmla="*/ 2695594 h 2933700"/>
              <a:gd name="connsiteX6" fmla="*/ 0 w 4035853"/>
              <a:gd name="connsiteY6" fmla="*/ 2697096 h 2933700"/>
              <a:gd name="connsiteX7" fmla="*/ 0 w 4035853"/>
              <a:gd name="connsiteY7" fmla="*/ 0 h 2933700"/>
              <a:gd name="connsiteX0" fmla="*/ 0 w 4035853"/>
              <a:gd name="connsiteY0" fmla="*/ 0 h 2933700"/>
              <a:gd name="connsiteX1" fmla="*/ 4035853 w 4035853"/>
              <a:gd name="connsiteY1" fmla="*/ 0 h 2933700"/>
              <a:gd name="connsiteX2" fmla="*/ 4035853 w 4035853"/>
              <a:gd name="connsiteY2" fmla="*/ 2697096 h 2933700"/>
              <a:gd name="connsiteX3" fmla="*/ 431848 w 4035853"/>
              <a:gd name="connsiteY3" fmla="*/ 2696556 h 2933700"/>
              <a:gd name="connsiteX4" fmla="*/ 302420 w 4035853"/>
              <a:gd name="connsiteY4" fmla="*/ 2933700 h 2933700"/>
              <a:gd name="connsiteX5" fmla="*/ 166660 w 4035853"/>
              <a:gd name="connsiteY5" fmla="*/ 2695594 h 2933700"/>
              <a:gd name="connsiteX6" fmla="*/ 0 w 4035853"/>
              <a:gd name="connsiteY6" fmla="*/ 2697096 h 2933700"/>
              <a:gd name="connsiteX7" fmla="*/ 0 w 4035853"/>
              <a:gd name="connsiteY7" fmla="*/ 0 h 2933700"/>
              <a:gd name="connsiteX0" fmla="*/ 0 w 4035853"/>
              <a:gd name="connsiteY0" fmla="*/ 0 h 2933700"/>
              <a:gd name="connsiteX1" fmla="*/ 4035853 w 4035853"/>
              <a:gd name="connsiteY1" fmla="*/ 0 h 2933700"/>
              <a:gd name="connsiteX2" fmla="*/ 4035853 w 4035853"/>
              <a:gd name="connsiteY2" fmla="*/ 2697096 h 2933700"/>
              <a:gd name="connsiteX3" fmla="*/ 431848 w 4035853"/>
              <a:gd name="connsiteY3" fmla="*/ 2696556 h 2933700"/>
              <a:gd name="connsiteX4" fmla="*/ 302420 w 4035853"/>
              <a:gd name="connsiteY4" fmla="*/ 2933700 h 2933700"/>
              <a:gd name="connsiteX5" fmla="*/ 154811 w 4035853"/>
              <a:gd name="connsiteY5" fmla="*/ 2695594 h 2933700"/>
              <a:gd name="connsiteX6" fmla="*/ 0 w 4035853"/>
              <a:gd name="connsiteY6" fmla="*/ 2697096 h 2933700"/>
              <a:gd name="connsiteX7" fmla="*/ 0 w 4035853"/>
              <a:gd name="connsiteY7" fmla="*/ 0 h 2933700"/>
              <a:gd name="connsiteX0" fmla="*/ 0 w 4035853"/>
              <a:gd name="connsiteY0" fmla="*/ 0 h 2947646"/>
              <a:gd name="connsiteX1" fmla="*/ 4035853 w 4035853"/>
              <a:gd name="connsiteY1" fmla="*/ 0 h 2947646"/>
              <a:gd name="connsiteX2" fmla="*/ 4035853 w 4035853"/>
              <a:gd name="connsiteY2" fmla="*/ 2697096 h 2947646"/>
              <a:gd name="connsiteX3" fmla="*/ 431848 w 4035853"/>
              <a:gd name="connsiteY3" fmla="*/ 2696556 h 2947646"/>
              <a:gd name="connsiteX4" fmla="*/ 341259 w 4035853"/>
              <a:gd name="connsiteY4" fmla="*/ 2895599 h 2947646"/>
              <a:gd name="connsiteX5" fmla="*/ 302420 w 4035853"/>
              <a:gd name="connsiteY5" fmla="*/ 2933700 h 2947646"/>
              <a:gd name="connsiteX6" fmla="*/ 154811 w 4035853"/>
              <a:gd name="connsiteY6" fmla="*/ 2695594 h 2947646"/>
              <a:gd name="connsiteX7" fmla="*/ 0 w 4035853"/>
              <a:gd name="connsiteY7" fmla="*/ 2697096 h 2947646"/>
              <a:gd name="connsiteX8" fmla="*/ 0 w 4035853"/>
              <a:gd name="connsiteY8" fmla="*/ 0 h 2947646"/>
              <a:gd name="connsiteX0" fmla="*/ 0 w 4035853"/>
              <a:gd name="connsiteY0" fmla="*/ 0 h 2947646"/>
              <a:gd name="connsiteX1" fmla="*/ 4035853 w 4035853"/>
              <a:gd name="connsiteY1" fmla="*/ 0 h 2947646"/>
              <a:gd name="connsiteX2" fmla="*/ 4035853 w 4035853"/>
              <a:gd name="connsiteY2" fmla="*/ 2697096 h 2947646"/>
              <a:gd name="connsiteX3" fmla="*/ 431848 w 4035853"/>
              <a:gd name="connsiteY3" fmla="*/ 2696556 h 2947646"/>
              <a:gd name="connsiteX4" fmla="*/ 341259 w 4035853"/>
              <a:gd name="connsiteY4" fmla="*/ 2895599 h 2947646"/>
              <a:gd name="connsiteX5" fmla="*/ 302420 w 4035853"/>
              <a:gd name="connsiteY5" fmla="*/ 2933700 h 2947646"/>
              <a:gd name="connsiteX6" fmla="*/ 154811 w 4035853"/>
              <a:gd name="connsiteY6" fmla="*/ 2695594 h 2947646"/>
              <a:gd name="connsiteX7" fmla="*/ 0 w 4035853"/>
              <a:gd name="connsiteY7" fmla="*/ 2697096 h 2947646"/>
              <a:gd name="connsiteX8" fmla="*/ 0 w 4035853"/>
              <a:gd name="connsiteY8" fmla="*/ 0 h 2947646"/>
              <a:gd name="connsiteX0" fmla="*/ 0 w 4035853"/>
              <a:gd name="connsiteY0" fmla="*/ 0 h 2933799"/>
              <a:gd name="connsiteX1" fmla="*/ 4035853 w 4035853"/>
              <a:gd name="connsiteY1" fmla="*/ 0 h 2933799"/>
              <a:gd name="connsiteX2" fmla="*/ 4035853 w 4035853"/>
              <a:gd name="connsiteY2" fmla="*/ 2697096 h 2933799"/>
              <a:gd name="connsiteX3" fmla="*/ 431848 w 4035853"/>
              <a:gd name="connsiteY3" fmla="*/ 2696556 h 2933799"/>
              <a:gd name="connsiteX4" fmla="*/ 341259 w 4035853"/>
              <a:gd name="connsiteY4" fmla="*/ 2895599 h 2933799"/>
              <a:gd name="connsiteX5" fmla="*/ 302420 w 4035853"/>
              <a:gd name="connsiteY5" fmla="*/ 2933700 h 2933799"/>
              <a:gd name="connsiteX6" fmla="*/ 272534 w 4035853"/>
              <a:gd name="connsiteY6" fmla="*/ 2893218 h 2933799"/>
              <a:gd name="connsiteX7" fmla="*/ 154811 w 4035853"/>
              <a:gd name="connsiteY7" fmla="*/ 2695594 h 2933799"/>
              <a:gd name="connsiteX8" fmla="*/ 0 w 4035853"/>
              <a:gd name="connsiteY8" fmla="*/ 2697096 h 2933799"/>
              <a:gd name="connsiteX9" fmla="*/ 0 w 4035853"/>
              <a:gd name="connsiteY9" fmla="*/ 0 h 2933799"/>
              <a:gd name="connsiteX0" fmla="*/ 0 w 4035853"/>
              <a:gd name="connsiteY0" fmla="*/ 0 h 2933799"/>
              <a:gd name="connsiteX1" fmla="*/ 4035853 w 4035853"/>
              <a:gd name="connsiteY1" fmla="*/ 0 h 2933799"/>
              <a:gd name="connsiteX2" fmla="*/ 4035853 w 4035853"/>
              <a:gd name="connsiteY2" fmla="*/ 2697096 h 2933799"/>
              <a:gd name="connsiteX3" fmla="*/ 431848 w 4035853"/>
              <a:gd name="connsiteY3" fmla="*/ 2696556 h 2933799"/>
              <a:gd name="connsiteX4" fmla="*/ 341259 w 4035853"/>
              <a:gd name="connsiteY4" fmla="*/ 2895599 h 2933799"/>
              <a:gd name="connsiteX5" fmla="*/ 302420 w 4035853"/>
              <a:gd name="connsiteY5" fmla="*/ 2933700 h 2933799"/>
              <a:gd name="connsiteX6" fmla="*/ 260684 w 4035853"/>
              <a:gd name="connsiteY6" fmla="*/ 2893218 h 2933799"/>
              <a:gd name="connsiteX7" fmla="*/ 154811 w 4035853"/>
              <a:gd name="connsiteY7" fmla="*/ 2695594 h 2933799"/>
              <a:gd name="connsiteX8" fmla="*/ 0 w 4035853"/>
              <a:gd name="connsiteY8" fmla="*/ 2697096 h 2933799"/>
              <a:gd name="connsiteX9" fmla="*/ 0 w 4035853"/>
              <a:gd name="connsiteY9" fmla="*/ 0 h 2933799"/>
              <a:gd name="connsiteX0" fmla="*/ 0 w 4035853"/>
              <a:gd name="connsiteY0" fmla="*/ 0 h 2933799"/>
              <a:gd name="connsiteX1" fmla="*/ 4035853 w 4035853"/>
              <a:gd name="connsiteY1" fmla="*/ 0 h 2933799"/>
              <a:gd name="connsiteX2" fmla="*/ 4035853 w 4035853"/>
              <a:gd name="connsiteY2" fmla="*/ 2697096 h 2933799"/>
              <a:gd name="connsiteX3" fmla="*/ 431848 w 4035853"/>
              <a:gd name="connsiteY3" fmla="*/ 2696556 h 2933799"/>
              <a:gd name="connsiteX4" fmla="*/ 341259 w 4035853"/>
              <a:gd name="connsiteY4" fmla="*/ 2895599 h 2933799"/>
              <a:gd name="connsiteX5" fmla="*/ 302420 w 4035853"/>
              <a:gd name="connsiteY5" fmla="*/ 2933700 h 2933799"/>
              <a:gd name="connsiteX6" fmla="*/ 260684 w 4035853"/>
              <a:gd name="connsiteY6" fmla="*/ 2893218 h 2933799"/>
              <a:gd name="connsiteX7" fmla="*/ 154811 w 4035853"/>
              <a:gd name="connsiteY7" fmla="*/ 2695594 h 2933799"/>
              <a:gd name="connsiteX8" fmla="*/ 0 w 4035853"/>
              <a:gd name="connsiteY8" fmla="*/ 2697096 h 2933799"/>
              <a:gd name="connsiteX9" fmla="*/ 0 w 4035853"/>
              <a:gd name="connsiteY9" fmla="*/ 0 h 2933799"/>
              <a:gd name="connsiteX0" fmla="*/ 0 w 4035853"/>
              <a:gd name="connsiteY0" fmla="*/ 0 h 2940861"/>
              <a:gd name="connsiteX1" fmla="*/ 4035853 w 4035853"/>
              <a:gd name="connsiteY1" fmla="*/ 0 h 2940861"/>
              <a:gd name="connsiteX2" fmla="*/ 4035853 w 4035853"/>
              <a:gd name="connsiteY2" fmla="*/ 2697096 h 2940861"/>
              <a:gd name="connsiteX3" fmla="*/ 431848 w 4035853"/>
              <a:gd name="connsiteY3" fmla="*/ 2696556 h 2940861"/>
              <a:gd name="connsiteX4" fmla="*/ 341259 w 4035853"/>
              <a:gd name="connsiteY4" fmla="*/ 2895599 h 2940861"/>
              <a:gd name="connsiteX5" fmla="*/ 295311 w 4035853"/>
              <a:gd name="connsiteY5" fmla="*/ 2940844 h 2940861"/>
              <a:gd name="connsiteX6" fmla="*/ 260684 w 4035853"/>
              <a:gd name="connsiteY6" fmla="*/ 2893218 h 2940861"/>
              <a:gd name="connsiteX7" fmla="*/ 154811 w 4035853"/>
              <a:gd name="connsiteY7" fmla="*/ 2695594 h 2940861"/>
              <a:gd name="connsiteX8" fmla="*/ 0 w 4035853"/>
              <a:gd name="connsiteY8" fmla="*/ 2697096 h 2940861"/>
              <a:gd name="connsiteX9" fmla="*/ 0 w 4035853"/>
              <a:gd name="connsiteY9" fmla="*/ 0 h 2940861"/>
              <a:gd name="connsiteX0" fmla="*/ 0 w 4035853"/>
              <a:gd name="connsiteY0" fmla="*/ 0 h 2940861"/>
              <a:gd name="connsiteX1" fmla="*/ 4035853 w 4035853"/>
              <a:gd name="connsiteY1" fmla="*/ 0 h 2940861"/>
              <a:gd name="connsiteX2" fmla="*/ 4035853 w 4035853"/>
              <a:gd name="connsiteY2" fmla="*/ 2697096 h 2940861"/>
              <a:gd name="connsiteX3" fmla="*/ 431848 w 4035853"/>
              <a:gd name="connsiteY3" fmla="*/ 2696556 h 2940861"/>
              <a:gd name="connsiteX4" fmla="*/ 334149 w 4035853"/>
              <a:gd name="connsiteY4" fmla="*/ 2895599 h 2940861"/>
              <a:gd name="connsiteX5" fmla="*/ 295311 w 4035853"/>
              <a:gd name="connsiteY5" fmla="*/ 2940844 h 2940861"/>
              <a:gd name="connsiteX6" fmla="*/ 260684 w 4035853"/>
              <a:gd name="connsiteY6" fmla="*/ 2893218 h 2940861"/>
              <a:gd name="connsiteX7" fmla="*/ 154811 w 4035853"/>
              <a:gd name="connsiteY7" fmla="*/ 2695594 h 2940861"/>
              <a:gd name="connsiteX8" fmla="*/ 0 w 4035853"/>
              <a:gd name="connsiteY8" fmla="*/ 2697096 h 2940861"/>
              <a:gd name="connsiteX9" fmla="*/ 0 w 4035853"/>
              <a:gd name="connsiteY9" fmla="*/ 0 h 2940861"/>
              <a:gd name="connsiteX0" fmla="*/ 0 w 4035853"/>
              <a:gd name="connsiteY0" fmla="*/ 0 h 2940861"/>
              <a:gd name="connsiteX1" fmla="*/ 4035853 w 4035853"/>
              <a:gd name="connsiteY1" fmla="*/ 0 h 2940861"/>
              <a:gd name="connsiteX2" fmla="*/ 4035853 w 4035853"/>
              <a:gd name="connsiteY2" fmla="*/ 2697096 h 2940861"/>
              <a:gd name="connsiteX3" fmla="*/ 431848 w 4035853"/>
              <a:gd name="connsiteY3" fmla="*/ 2696556 h 2940861"/>
              <a:gd name="connsiteX4" fmla="*/ 334149 w 4035853"/>
              <a:gd name="connsiteY4" fmla="*/ 2895599 h 2940861"/>
              <a:gd name="connsiteX5" fmla="*/ 295311 w 4035853"/>
              <a:gd name="connsiteY5" fmla="*/ 2940844 h 2940861"/>
              <a:gd name="connsiteX6" fmla="*/ 260684 w 4035853"/>
              <a:gd name="connsiteY6" fmla="*/ 2893218 h 2940861"/>
              <a:gd name="connsiteX7" fmla="*/ 154811 w 4035853"/>
              <a:gd name="connsiteY7" fmla="*/ 2695594 h 2940861"/>
              <a:gd name="connsiteX8" fmla="*/ 0 w 4035853"/>
              <a:gd name="connsiteY8" fmla="*/ 2697096 h 2940861"/>
              <a:gd name="connsiteX9" fmla="*/ 0 w 4035853"/>
              <a:gd name="connsiteY9" fmla="*/ 0 h 2940861"/>
              <a:gd name="connsiteX0" fmla="*/ 0 w 4035853"/>
              <a:gd name="connsiteY0" fmla="*/ 0 h 2941325"/>
              <a:gd name="connsiteX1" fmla="*/ 4035853 w 4035853"/>
              <a:gd name="connsiteY1" fmla="*/ 0 h 2941325"/>
              <a:gd name="connsiteX2" fmla="*/ 4035853 w 4035853"/>
              <a:gd name="connsiteY2" fmla="*/ 2697096 h 2941325"/>
              <a:gd name="connsiteX3" fmla="*/ 431848 w 4035853"/>
              <a:gd name="connsiteY3" fmla="*/ 2696556 h 2941325"/>
              <a:gd name="connsiteX4" fmla="*/ 334149 w 4035853"/>
              <a:gd name="connsiteY4" fmla="*/ 2895599 h 2941325"/>
              <a:gd name="connsiteX5" fmla="*/ 295311 w 4035853"/>
              <a:gd name="connsiteY5" fmla="*/ 2940844 h 2941325"/>
              <a:gd name="connsiteX6" fmla="*/ 260684 w 4035853"/>
              <a:gd name="connsiteY6" fmla="*/ 2893218 h 2941325"/>
              <a:gd name="connsiteX7" fmla="*/ 154811 w 4035853"/>
              <a:gd name="connsiteY7" fmla="*/ 2695594 h 2941325"/>
              <a:gd name="connsiteX8" fmla="*/ 0 w 4035853"/>
              <a:gd name="connsiteY8" fmla="*/ 2697096 h 2941325"/>
              <a:gd name="connsiteX9" fmla="*/ 0 w 4035853"/>
              <a:gd name="connsiteY9" fmla="*/ 0 h 2941325"/>
              <a:gd name="connsiteX0" fmla="*/ 0 w 4035853"/>
              <a:gd name="connsiteY0" fmla="*/ 0 h 2940861"/>
              <a:gd name="connsiteX1" fmla="*/ 4035853 w 4035853"/>
              <a:gd name="connsiteY1" fmla="*/ 0 h 2940861"/>
              <a:gd name="connsiteX2" fmla="*/ 4035853 w 4035853"/>
              <a:gd name="connsiteY2" fmla="*/ 2697096 h 2940861"/>
              <a:gd name="connsiteX3" fmla="*/ 431848 w 4035853"/>
              <a:gd name="connsiteY3" fmla="*/ 2696556 h 2940861"/>
              <a:gd name="connsiteX4" fmla="*/ 334149 w 4035853"/>
              <a:gd name="connsiteY4" fmla="*/ 2895599 h 2940861"/>
              <a:gd name="connsiteX5" fmla="*/ 295311 w 4035853"/>
              <a:gd name="connsiteY5" fmla="*/ 2940844 h 2940861"/>
              <a:gd name="connsiteX6" fmla="*/ 260684 w 4035853"/>
              <a:gd name="connsiteY6" fmla="*/ 2893218 h 2940861"/>
              <a:gd name="connsiteX7" fmla="*/ 154811 w 4035853"/>
              <a:gd name="connsiteY7" fmla="*/ 2695594 h 2940861"/>
              <a:gd name="connsiteX8" fmla="*/ 0 w 4035853"/>
              <a:gd name="connsiteY8" fmla="*/ 2697096 h 2940861"/>
              <a:gd name="connsiteX9" fmla="*/ 0 w 4035853"/>
              <a:gd name="connsiteY9" fmla="*/ 0 h 2940861"/>
              <a:gd name="connsiteX0" fmla="*/ 0 w 4035853"/>
              <a:gd name="connsiteY0" fmla="*/ 0 h 2940861"/>
              <a:gd name="connsiteX1" fmla="*/ 4035853 w 4035853"/>
              <a:gd name="connsiteY1" fmla="*/ 0 h 2940861"/>
              <a:gd name="connsiteX2" fmla="*/ 4035853 w 4035853"/>
              <a:gd name="connsiteY2" fmla="*/ 2697096 h 2940861"/>
              <a:gd name="connsiteX3" fmla="*/ 431848 w 4035853"/>
              <a:gd name="connsiteY3" fmla="*/ 2696556 h 2940861"/>
              <a:gd name="connsiteX4" fmla="*/ 334149 w 4035853"/>
              <a:gd name="connsiteY4" fmla="*/ 2895599 h 2940861"/>
              <a:gd name="connsiteX5" fmla="*/ 295311 w 4035853"/>
              <a:gd name="connsiteY5" fmla="*/ 2940844 h 2940861"/>
              <a:gd name="connsiteX6" fmla="*/ 260684 w 4035853"/>
              <a:gd name="connsiteY6" fmla="*/ 2893218 h 2940861"/>
              <a:gd name="connsiteX7" fmla="*/ 154811 w 4035853"/>
              <a:gd name="connsiteY7" fmla="*/ 2695594 h 2940861"/>
              <a:gd name="connsiteX8" fmla="*/ 0 w 4035853"/>
              <a:gd name="connsiteY8" fmla="*/ 2697096 h 2940861"/>
              <a:gd name="connsiteX9" fmla="*/ 0 w 4035853"/>
              <a:gd name="connsiteY9" fmla="*/ 0 h 2940861"/>
              <a:gd name="connsiteX0" fmla="*/ 0 w 4035853"/>
              <a:gd name="connsiteY0" fmla="*/ 0 h 2938488"/>
              <a:gd name="connsiteX1" fmla="*/ 4035853 w 4035853"/>
              <a:gd name="connsiteY1" fmla="*/ 0 h 2938488"/>
              <a:gd name="connsiteX2" fmla="*/ 4035853 w 4035853"/>
              <a:gd name="connsiteY2" fmla="*/ 2697096 h 2938488"/>
              <a:gd name="connsiteX3" fmla="*/ 431848 w 4035853"/>
              <a:gd name="connsiteY3" fmla="*/ 2696556 h 2938488"/>
              <a:gd name="connsiteX4" fmla="*/ 334149 w 4035853"/>
              <a:gd name="connsiteY4" fmla="*/ 2895599 h 2938488"/>
              <a:gd name="connsiteX5" fmla="*/ 295311 w 4035853"/>
              <a:gd name="connsiteY5" fmla="*/ 2938463 h 2938488"/>
              <a:gd name="connsiteX6" fmla="*/ 260684 w 4035853"/>
              <a:gd name="connsiteY6" fmla="*/ 2893218 h 2938488"/>
              <a:gd name="connsiteX7" fmla="*/ 154811 w 4035853"/>
              <a:gd name="connsiteY7" fmla="*/ 2695594 h 2938488"/>
              <a:gd name="connsiteX8" fmla="*/ 0 w 4035853"/>
              <a:gd name="connsiteY8" fmla="*/ 2697096 h 2938488"/>
              <a:gd name="connsiteX9" fmla="*/ 0 w 4035853"/>
              <a:gd name="connsiteY9" fmla="*/ 0 h 2938488"/>
              <a:gd name="connsiteX0" fmla="*/ 0 w 4035853"/>
              <a:gd name="connsiteY0" fmla="*/ 0 h 2938488"/>
              <a:gd name="connsiteX1" fmla="*/ 4035853 w 4035853"/>
              <a:gd name="connsiteY1" fmla="*/ 0 h 2938488"/>
              <a:gd name="connsiteX2" fmla="*/ 4035853 w 4035853"/>
              <a:gd name="connsiteY2" fmla="*/ 2697096 h 2938488"/>
              <a:gd name="connsiteX3" fmla="*/ 431848 w 4035853"/>
              <a:gd name="connsiteY3" fmla="*/ 2696556 h 2938488"/>
              <a:gd name="connsiteX4" fmla="*/ 334149 w 4035853"/>
              <a:gd name="connsiteY4" fmla="*/ 2895599 h 2938488"/>
              <a:gd name="connsiteX5" fmla="*/ 295311 w 4035853"/>
              <a:gd name="connsiteY5" fmla="*/ 2938463 h 2938488"/>
              <a:gd name="connsiteX6" fmla="*/ 260684 w 4035853"/>
              <a:gd name="connsiteY6" fmla="*/ 2893218 h 2938488"/>
              <a:gd name="connsiteX7" fmla="*/ 159550 w 4035853"/>
              <a:gd name="connsiteY7" fmla="*/ 2695594 h 2938488"/>
              <a:gd name="connsiteX8" fmla="*/ 0 w 4035853"/>
              <a:gd name="connsiteY8" fmla="*/ 2697096 h 2938488"/>
              <a:gd name="connsiteX9" fmla="*/ 0 w 4035853"/>
              <a:gd name="connsiteY9" fmla="*/ 0 h 2938488"/>
              <a:gd name="connsiteX0" fmla="*/ 0 w 4035853"/>
              <a:gd name="connsiteY0" fmla="*/ 0 h 2938488"/>
              <a:gd name="connsiteX1" fmla="*/ 4035853 w 4035853"/>
              <a:gd name="connsiteY1" fmla="*/ 0 h 2938488"/>
              <a:gd name="connsiteX2" fmla="*/ 4035853 w 4035853"/>
              <a:gd name="connsiteY2" fmla="*/ 2697096 h 2938488"/>
              <a:gd name="connsiteX3" fmla="*/ 431848 w 4035853"/>
              <a:gd name="connsiteY3" fmla="*/ 2696556 h 2938488"/>
              <a:gd name="connsiteX4" fmla="*/ 334149 w 4035853"/>
              <a:gd name="connsiteY4" fmla="*/ 2895599 h 2938488"/>
              <a:gd name="connsiteX5" fmla="*/ 295311 w 4035853"/>
              <a:gd name="connsiteY5" fmla="*/ 2938463 h 2938488"/>
              <a:gd name="connsiteX6" fmla="*/ 260684 w 4035853"/>
              <a:gd name="connsiteY6" fmla="*/ 2893218 h 2938488"/>
              <a:gd name="connsiteX7" fmla="*/ 159550 w 4035853"/>
              <a:gd name="connsiteY7" fmla="*/ 2695594 h 2938488"/>
              <a:gd name="connsiteX8" fmla="*/ 0 w 4035853"/>
              <a:gd name="connsiteY8" fmla="*/ 2697096 h 2938488"/>
              <a:gd name="connsiteX9" fmla="*/ 0 w 4035853"/>
              <a:gd name="connsiteY9" fmla="*/ 0 h 2938488"/>
              <a:gd name="connsiteX0" fmla="*/ 0 w 4035853"/>
              <a:gd name="connsiteY0" fmla="*/ 0 h 2938488"/>
              <a:gd name="connsiteX1" fmla="*/ 4035853 w 4035853"/>
              <a:gd name="connsiteY1" fmla="*/ 0 h 2938488"/>
              <a:gd name="connsiteX2" fmla="*/ 4035853 w 4035853"/>
              <a:gd name="connsiteY2" fmla="*/ 2697096 h 2938488"/>
              <a:gd name="connsiteX3" fmla="*/ 431848 w 4035853"/>
              <a:gd name="connsiteY3" fmla="*/ 2696556 h 2938488"/>
              <a:gd name="connsiteX4" fmla="*/ 334149 w 4035853"/>
              <a:gd name="connsiteY4" fmla="*/ 2895599 h 2938488"/>
              <a:gd name="connsiteX5" fmla="*/ 300051 w 4035853"/>
              <a:gd name="connsiteY5" fmla="*/ 2938463 h 2938488"/>
              <a:gd name="connsiteX6" fmla="*/ 260684 w 4035853"/>
              <a:gd name="connsiteY6" fmla="*/ 2893218 h 2938488"/>
              <a:gd name="connsiteX7" fmla="*/ 159550 w 4035853"/>
              <a:gd name="connsiteY7" fmla="*/ 2695594 h 2938488"/>
              <a:gd name="connsiteX8" fmla="*/ 0 w 4035853"/>
              <a:gd name="connsiteY8" fmla="*/ 2697096 h 2938488"/>
              <a:gd name="connsiteX9" fmla="*/ 0 w 4035853"/>
              <a:gd name="connsiteY9" fmla="*/ 0 h 2938488"/>
              <a:gd name="connsiteX0" fmla="*/ 0 w 4035853"/>
              <a:gd name="connsiteY0" fmla="*/ 0 h 2938470"/>
              <a:gd name="connsiteX1" fmla="*/ 4035853 w 4035853"/>
              <a:gd name="connsiteY1" fmla="*/ 0 h 2938470"/>
              <a:gd name="connsiteX2" fmla="*/ 4035853 w 4035853"/>
              <a:gd name="connsiteY2" fmla="*/ 2697096 h 2938470"/>
              <a:gd name="connsiteX3" fmla="*/ 431848 w 4035853"/>
              <a:gd name="connsiteY3" fmla="*/ 2696556 h 2938470"/>
              <a:gd name="connsiteX4" fmla="*/ 334149 w 4035853"/>
              <a:gd name="connsiteY4" fmla="*/ 2895599 h 2938470"/>
              <a:gd name="connsiteX5" fmla="*/ 300051 w 4035853"/>
              <a:gd name="connsiteY5" fmla="*/ 2938463 h 2938470"/>
              <a:gd name="connsiteX6" fmla="*/ 260684 w 4035853"/>
              <a:gd name="connsiteY6" fmla="*/ 2893218 h 2938470"/>
              <a:gd name="connsiteX7" fmla="*/ 159550 w 4035853"/>
              <a:gd name="connsiteY7" fmla="*/ 2695594 h 2938470"/>
              <a:gd name="connsiteX8" fmla="*/ 0 w 4035853"/>
              <a:gd name="connsiteY8" fmla="*/ 2697096 h 2938470"/>
              <a:gd name="connsiteX9" fmla="*/ 0 w 4035853"/>
              <a:gd name="connsiteY9" fmla="*/ 0 h 2938470"/>
              <a:gd name="connsiteX0" fmla="*/ 0 w 4035853"/>
              <a:gd name="connsiteY0" fmla="*/ 0 h 2938470"/>
              <a:gd name="connsiteX1" fmla="*/ 4035853 w 4035853"/>
              <a:gd name="connsiteY1" fmla="*/ 0 h 2938470"/>
              <a:gd name="connsiteX2" fmla="*/ 4035853 w 4035853"/>
              <a:gd name="connsiteY2" fmla="*/ 2697096 h 2938470"/>
              <a:gd name="connsiteX3" fmla="*/ 431848 w 4035853"/>
              <a:gd name="connsiteY3" fmla="*/ 2696556 h 2938470"/>
              <a:gd name="connsiteX4" fmla="*/ 334149 w 4035853"/>
              <a:gd name="connsiteY4" fmla="*/ 2895599 h 2938470"/>
              <a:gd name="connsiteX5" fmla="*/ 300051 w 4035853"/>
              <a:gd name="connsiteY5" fmla="*/ 2938463 h 2938470"/>
              <a:gd name="connsiteX6" fmla="*/ 260684 w 4035853"/>
              <a:gd name="connsiteY6" fmla="*/ 2893218 h 2938470"/>
              <a:gd name="connsiteX7" fmla="*/ 159550 w 4035853"/>
              <a:gd name="connsiteY7" fmla="*/ 2695594 h 2938470"/>
              <a:gd name="connsiteX8" fmla="*/ 0 w 4035853"/>
              <a:gd name="connsiteY8" fmla="*/ 2697096 h 2938470"/>
              <a:gd name="connsiteX9" fmla="*/ 0 w 4035853"/>
              <a:gd name="connsiteY9" fmla="*/ 0 h 2938470"/>
              <a:gd name="connsiteX0" fmla="*/ 0 w 4035853"/>
              <a:gd name="connsiteY0" fmla="*/ 0 h 2938470"/>
              <a:gd name="connsiteX1" fmla="*/ 4035853 w 4035853"/>
              <a:gd name="connsiteY1" fmla="*/ 0 h 2938470"/>
              <a:gd name="connsiteX2" fmla="*/ 4035853 w 4035853"/>
              <a:gd name="connsiteY2" fmla="*/ 2697096 h 2938470"/>
              <a:gd name="connsiteX3" fmla="*/ 431848 w 4035853"/>
              <a:gd name="connsiteY3" fmla="*/ 2696556 h 2938470"/>
              <a:gd name="connsiteX4" fmla="*/ 334149 w 4035853"/>
              <a:gd name="connsiteY4" fmla="*/ 2895599 h 2938470"/>
              <a:gd name="connsiteX5" fmla="*/ 300051 w 4035853"/>
              <a:gd name="connsiteY5" fmla="*/ 2938463 h 2938470"/>
              <a:gd name="connsiteX6" fmla="*/ 260684 w 4035853"/>
              <a:gd name="connsiteY6" fmla="*/ 2893218 h 2938470"/>
              <a:gd name="connsiteX7" fmla="*/ 159550 w 4035853"/>
              <a:gd name="connsiteY7" fmla="*/ 2695594 h 2938470"/>
              <a:gd name="connsiteX8" fmla="*/ 0 w 4035853"/>
              <a:gd name="connsiteY8" fmla="*/ 2697096 h 2938470"/>
              <a:gd name="connsiteX9" fmla="*/ 0 w 4035853"/>
              <a:gd name="connsiteY9" fmla="*/ 0 h 2938470"/>
              <a:gd name="connsiteX0" fmla="*/ 0 w 4035853"/>
              <a:gd name="connsiteY0" fmla="*/ 0 h 2938470"/>
              <a:gd name="connsiteX1" fmla="*/ 4035853 w 4035853"/>
              <a:gd name="connsiteY1" fmla="*/ 0 h 2938470"/>
              <a:gd name="connsiteX2" fmla="*/ 4035853 w 4035853"/>
              <a:gd name="connsiteY2" fmla="*/ 2697096 h 2938470"/>
              <a:gd name="connsiteX3" fmla="*/ 431848 w 4035853"/>
              <a:gd name="connsiteY3" fmla="*/ 2696556 h 2938470"/>
              <a:gd name="connsiteX4" fmla="*/ 334149 w 4035853"/>
              <a:gd name="connsiteY4" fmla="*/ 2895599 h 2938470"/>
              <a:gd name="connsiteX5" fmla="*/ 300051 w 4035853"/>
              <a:gd name="connsiteY5" fmla="*/ 2938463 h 2938470"/>
              <a:gd name="connsiteX6" fmla="*/ 260684 w 4035853"/>
              <a:gd name="connsiteY6" fmla="*/ 2893218 h 2938470"/>
              <a:gd name="connsiteX7" fmla="*/ 159550 w 4035853"/>
              <a:gd name="connsiteY7" fmla="*/ 2695594 h 2938470"/>
              <a:gd name="connsiteX8" fmla="*/ 0 w 4035853"/>
              <a:gd name="connsiteY8" fmla="*/ 2697096 h 2938470"/>
              <a:gd name="connsiteX9" fmla="*/ 0 w 4035853"/>
              <a:gd name="connsiteY9" fmla="*/ 0 h 2938470"/>
              <a:gd name="connsiteX0" fmla="*/ 0 w 4035853"/>
              <a:gd name="connsiteY0" fmla="*/ 0 h 2948969"/>
              <a:gd name="connsiteX1" fmla="*/ 4035853 w 4035853"/>
              <a:gd name="connsiteY1" fmla="*/ 0 h 2948969"/>
              <a:gd name="connsiteX2" fmla="*/ 4035853 w 4035853"/>
              <a:gd name="connsiteY2" fmla="*/ 2697096 h 2948969"/>
              <a:gd name="connsiteX3" fmla="*/ 431848 w 4035853"/>
              <a:gd name="connsiteY3" fmla="*/ 2696556 h 2948969"/>
              <a:gd name="connsiteX4" fmla="*/ 334149 w 4035853"/>
              <a:gd name="connsiteY4" fmla="*/ 2895599 h 2948969"/>
              <a:gd name="connsiteX5" fmla="*/ 300051 w 4035853"/>
              <a:gd name="connsiteY5" fmla="*/ 2938463 h 2948969"/>
              <a:gd name="connsiteX6" fmla="*/ 260684 w 4035853"/>
              <a:gd name="connsiteY6" fmla="*/ 2893218 h 2948969"/>
              <a:gd name="connsiteX7" fmla="*/ 159550 w 4035853"/>
              <a:gd name="connsiteY7" fmla="*/ 2695594 h 2948969"/>
              <a:gd name="connsiteX8" fmla="*/ 0 w 4035853"/>
              <a:gd name="connsiteY8" fmla="*/ 2697096 h 2948969"/>
              <a:gd name="connsiteX9" fmla="*/ 0 w 4035853"/>
              <a:gd name="connsiteY9" fmla="*/ 0 h 2948969"/>
              <a:gd name="connsiteX0" fmla="*/ 0 w 4035853"/>
              <a:gd name="connsiteY0" fmla="*/ 0 h 2938468"/>
              <a:gd name="connsiteX1" fmla="*/ 4035853 w 4035853"/>
              <a:gd name="connsiteY1" fmla="*/ 0 h 2938468"/>
              <a:gd name="connsiteX2" fmla="*/ 4035853 w 4035853"/>
              <a:gd name="connsiteY2" fmla="*/ 2697096 h 2938468"/>
              <a:gd name="connsiteX3" fmla="*/ 431848 w 4035853"/>
              <a:gd name="connsiteY3" fmla="*/ 2696556 h 2938468"/>
              <a:gd name="connsiteX4" fmla="*/ 334149 w 4035853"/>
              <a:gd name="connsiteY4" fmla="*/ 2895599 h 2938468"/>
              <a:gd name="connsiteX5" fmla="*/ 300051 w 4035853"/>
              <a:gd name="connsiteY5" fmla="*/ 2938463 h 2938468"/>
              <a:gd name="connsiteX6" fmla="*/ 260684 w 4035853"/>
              <a:gd name="connsiteY6" fmla="*/ 2893218 h 2938468"/>
              <a:gd name="connsiteX7" fmla="*/ 159550 w 4035853"/>
              <a:gd name="connsiteY7" fmla="*/ 2695594 h 2938468"/>
              <a:gd name="connsiteX8" fmla="*/ 0 w 4035853"/>
              <a:gd name="connsiteY8" fmla="*/ 2697096 h 2938468"/>
              <a:gd name="connsiteX9" fmla="*/ 0 w 4035853"/>
              <a:gd name="connsiteY9" fmla="*/ 0 h 2938468"/>
              <a:gd name="connsiteX0" fmla="*/ 0 w 4035853"/>
              <a:gd name="connsiteY0" fmla="*/ 0 h 2938468"/>
              <a:gd name="connsiteX1" fmla="*/ 4035853 w 4035853"/>
              <a:gd name="connsiteY1" fmla="*/ 0 h 2938468"/>
              <a:gd name="connsiteX2" fmla="*/ 4035853 w 4035853"/>
              <a:gd name="connsiteY2" fmla="*/ 2697096 h 2938468"/>
              <a:gd name="connsiteX3" fmla="*/ 431848 w 4035853"/>
              <a:gd name="connsiteY3" fmla="*/ 2696556 h 2938468"/>
              <a:gd name="connsiteX4" fmla="*/ 334149 w 4035853"/>
              <a:gd name="connsiteY4" fmla="*/ 2895599 h 2938468"/>
              <a:gd name="connsiteX5" fmla="*/ 300051 w 4035853"/>
              <a:gd name="connsiteY5" fmla="*/ 2938463 h 2938468"/>
              <a:gd name="connsiteX6" fmla="*/ 260684 w 4035853"/>
              <a:gd name="connsiteY6" fmla="*/ 2893218 h 2938468"/>
              <a:gd name="connsiteX7" fmla="*/ 159550 w 4035853"/>
              <a:gd name="connsiteY7" fmla="*/ 2695594 h 2938468"/>
              <a:gd name="connsiteX8" fmla="*/ 0 w 4035853"/>
              <a:gd name="connsiteY8" fmla="*/ 2697096 h 2938468"/>
              <a:gd name="connsiteX9" fmla="*/ 0 w 4035853"/>
              <a:gd name="connsiteY9" fmla="*/ 0 h 2938468"/>
              <a:gd name="connsiteX0" fmla="*/ 0 w 4035853"/>
              <a:gd name="connsiteY0" fmla="*/ 0 h 2938468"/>
              <a:gd name="connsiteX1" fmla="*/ 4035853 w 4035853"/>
              <a:gd name="connsiteY1" fmla="*/ 0 h 2938468"/>
              <a:gd name="connsiteX2" fmla="*/ 4035853 w 4035853"/>
              <a:gd name="connsiteY2" fmla="*/ 2697096 h 2938468"/>
              <a:gd name="connsiteX3" fmla="*/ 431848 w 4035853"/>
              <a:gd name="connsiteY3" fmla="*/ 2696556 h 2938468"/>
              <a:gd name="connsiteX4" fmla="*/ 334149 w 4035853"/>
              <a:gd name="connsiteY4" fmla="*/ 2895599 h 2938468"/>
              <a:gd name="connsiteX5" fmla="*/ 300051 w 4035853"/>
              <a:gd name="connsiteY5" fmla="*/ 2938463 h 2938468"/>
              <a:gd name="connsiteX6" fmla="*/ 260684 w 4035853"/>
              <a:gd name="connsiteY6" fmla="*/ 2893218 h 2938468"/>
              <a:gd name="connsiteX7" fmla="*/ 159550 w 4035853"/>
              <a:gd name="connsiteY7" fmla="*/ 2695594 h 2938468"/>
              <a:gd name="connsiteX8" fmla="*/ 0 w 4035853"/>
              <a:gd name="connsiteY8" fmla="*/ 2697096 h 2938468"/>
              <a:gd name="connsiteX9" fmla="*/ 0 w 4035853"/>
              <a:gd name="connsiteY9" fmla="*/ 0 h 2938468"/>
              <a:gd name="connsiteX0" fmla="*/ 0 w 4035853"/>
              <a:gd name="connsiteY0" fmla="*/ 0 h 2938602"/>
              <a:gd name="connsiteX1" fmla="*/ 4035853 w 4035853"/>
              <a:gd name="connsiteY1" fmla="*/ 0 h 2938602"/>
              <a:gd name="connsiteX2" fmla="*/ 4035853 w 4035853"/>
              <a:gd name="connsiteY2" fmla="*/ 2697096 h 2938602"/>
              <a:gd name="connsiteX3" fmla="*/ 431848 w 4035853"/>
              <a:gd name="connsiteY3" fmla="*/ 2696556 h 2938602"/>
              <a:gd name="connsiteX4" fmla="*/ 334149 w 4035853"/>
              <a:gd name="connsiteY4" fmla="*/ 2895599 h 2938602"/>
              <a:gd name="connsiteX5" fmla="*/ 300051 w 4035853"/>
              <a:gd name="connsiteY5" fmla="*/ 2938463 h 2938602"/>
              <a:gd name="connsiteX6" fmla="*/ 260684 w 4035853"/>
              <a:gd name="connsiteY6" fmla="*/ 2893218 h 2938602"/>
              <a:gd name="connsiteX7" fmla="*/ 159550 w 4035853"/>
              <a:gd name="connsiteY7" fmla="*/ 2695594 h 2938602"/>
              <a:gd name="connsiteX8" fmla="*/ 0 w 4035853"/>
              <a:gd name="connsiteY8" fmla="*/ 2697096 h 2938602"/>
              <a:gd name="connsiteX9" fmla="*/ 0 w 4035853"/>
              <a:gd name="connsiteY9" fmla="*/ 0 h 293860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4035853" h="2938602">
                <a:moveTo>
                  <a:pt x="0" y="0"/>
                </a:moveTo>
                <a:lnTo>
                  <a:pt x="4035853" y="0"/>
                </a:lnTo>
                <a:lnTo>
                  <a:pt x="4035853" y="2697096"/>
                </a:lnTo>
                <a:lnTo>
                  <a:pt x="431848" y="2696556"/>
                </a:lnTo>
                <a:cubicBezTo>
                  <a:pt x="397879" y="2770121"/>
                  <a:pt x="343870" y="2875126"/>
                  <a:pt x="334149" y="2895599"/>
                </a:cubicBezTo>
                <a:cubicBezTo>
                  <a:pt x="324428" y="2916072"/>
                  <a:pt x="321774" y="2936479"/>
                  <a:pt x="300051" y="2938463"/>
                </a:cubicBezTo>
                <a:cubicBezTo>
                  <a:pt x="278328" y="2940447"/>
                  <a:pt x="275806" y="2920996"/>
                  <a:pt x="260684" y="2893218"/>
                </a:cubicBezTo>
                <a:cubicBezTo>
                  <a:pt x="245562" y="2865440"/>
                  <a:pt x="186012" y="2752094"/>
                  <a:pt x="159550" y="2695594"/>
                </a:cubicBezTo>
                <a:lnTo>
                  <a:pt x="0" y="2697096"/>
                </a:lnTo>
                <a:lnTo>
                  <a:pt x="0" y="0"/>
                </a:lnTo>
                <a:close/>
              </a:path>
            </a:pathLst>
          </a:custGeom>
        </p:spPr>
        <p:txBody>
          <a:bodyPr anchor="ctr" anchorCtr="1"/>
          <a:lstStyle>
            <a:lvl1pPr marL="0" indent="0">
              <a:buNone/>
              <a:defRPr>
                <a:solidFill>
                  <a:schemeClr val="tx1"/>
                </a:solidFill>
              </a:defRPr>
            </a:lvl1pPr>
          </a:lstStyle>
          <a:p>
            <a:r>
              <a:rPr lang="en-US"/>
              <a:t>Click icon to add picture</a:t>
            </a:r>
          </a:p>
        </p:txBody>
      </p:sp>
      <p:sp>
        <p:nvSpPr>
          <p:cNvPr id="14" name="Content Placeholder 12"/>
          <p:cNvSpPr>
            <a:spLocks noGrp="1"/>
          </p:cNvSpPr>
          <p:nvPr>
            <p:ph sz="quarter" idx="12" hasCustomPrompt="1"/>
          </p:nvPr>
        </p:nvSpPr>
        <p:spPr>
          <a:xfrm>
            <a:off x="6976108" y="4076701"/>
            <a:ext cx="4606291" cy="1955800"/>
          </a:xfrm>
        </p:spPr>
        <p:txBody>
          <a:bodyPr/>
          <a:lstStyle>
            <a:lvl1pPr marL="0" indent="0">
              <a:buNone/>
              <a:defRPr sz="1600" b="1">
                <a:solidFill>
                  <a:schemeClr val="tx1"/>
                </a:solidFill>
              </a:defRPr>
            </a:lvl1pPr>
            <a:lvl2pPr marL="0" indent="0">
              <a:buNone/>
              <a:defRPr sz="1600">
                <a:solidFill>
                  <a:schemeClr val="tx1"/>
                </a:solidFill>
              </a:defRPr>
            </a:lvl2pPr>
            <a:lvl3pPr marL="304792" indent="-304792">
              <a:buFont typeface="Arial" panose="020B0604020202020204" pitchFamily="34" charset="0"/>
              <a:buChar char="•"/>
              <a:defRPr sz="1600">
                <a:solidFill>
                  <a:schemeClr val="tx1"/>
                </a:solidFill>
              </a:defRPr>
            </a:lvl3pPr>
            <a:lvl4pPr marL="621776" indent="-298443">
              <a:buFont typeface="Arial" panose="020B0604020202020204" pitchFamily="34" charset="0"/>
              <a:buChar char="–"/>
              <a:defRPr sz="1600">
                <a:solidFill>
                  <a:schemeClr val="tx1"/>
                </a:solidFill>
              </a:defRPr>
            </a:lvl4pPr>
            <a:lvl5pPr marL="914377">
              <a:defRPr sz="1600">
                <a:solidFill>
                  <a:schemeClr val="tx1"/>
                </a:solidFill>
              </a:defRPr>
            </a:lvl5pPr>
          </a:lstStyle>
          <a:p>
            <a:pPr lvl="0"/>
            <a:r>
              <a:rPr lang="en-US"/>
              <a:t>Caption for content above</a:t>
            </a:r>
          </a:p>
          <a:p>
            <a:pPr lvl="1"/>
            <a:r>
              <a:rPr lang="en-US"/>
              <a:t>Second level</a:t>
            </a:r>
          </a:p>
          <a:p>
            <a:pPr lvl="2"/>
            <a:r>
              <a:rPr lang="en-US"/>
              <a:t>Third level</a:t>
            </a:r>
          </a:p>
          <a:p>
            <a:pPr lvl="3"/>
            <a:r>
              <a:rPr lang="en-US"/>
              <a:t>Fourth level</a:t>
            </a:r>
          </a:p>
          <a:p>
            <a:pPr lvl="4"/>
            <a:r>
              <a:rPr lang="en-US"/>
              <a:t>Fifth level</a:t>
            </a:r>
          </a:p>
        </p:txBody>
      </p:sp>
      <p:sp>
        <p:nvSpPr>
          <p:cNvPr id="19" name="Footer Placeholder 4"/>
          <p:cNvSpPr>
            <a:spLocks noGrp="1"/>
          </p:cNvSpPr>
          <p:nvPr>
            <p:ph type="ftr" sz="quarter" idx="3"/>
          </p:nvPr>
        </p:nvSpPr>
        <p:spPr>
          <a:xfrm>
            <a:off x="1026597" y="6467745"/>
            <a:ext cx="4517089" cy="164148"/>
          </a:xfrm>
          <a:prstGeom prst="rect">
            <a:avLst/>
          </a:prstGeom>
        </p:spPr>
        <p:txBody>
          <a:bodyPr vert="horz" wrap="square" lIns="0" tIns="0" rIns="0" bIns="0" rtlCol="0" anchor="ctr">
            <a:spAutoFit/>
          </a:bodyPr>
          <a:lstStyle>
            <a:lvl1pPr algn="l">
              <a:defRPr sz="1067">
                <a:solidFill>
                  <a:schemeClr val="bg1"/>
                </a:solidFill>
              </a:defRPr>
            </a:lvl1pPr>
          </a:lstStyle>
          <a:p>
            <a:r>
              <a:rPr lang="en-US"/>
              <a:t>Division Name or Footer</a:t>
            </a:r>
          </a:p>
        </p:txBody>
      </p:sp>
      <p:sp>
        <p:nvSpPr>
          <p:cNvPr id="20" name="Slide Number Placeholder 5"/>
          <p:cNvSpPr>
            <a:spLocks noGrp="1"/>
          </p:cNvSpPr>
          <p:nvPr>
            <p:ph type="sldNum" sz="quarter" idx="4"/>
          </p:nvPr>
        </p:nvSpPr>
        <p:spPr>
          <a:xfrm>
            <a:off x="609601" y="6457702"/>
            <a:ext cx="339625" cy="164148"/>
          </a:xfrm>
          <a:prstGeom prst="rect">
            <a:avLst/>
          </a:prstGeom>
        </p:spPr>
        <p:txBody>
          <a:bodyPr vert="horz" wrap="square" lIns="0" tIns="0" rIns="0" bIns="0" rtlCol="0" anchor="ctr">
            <a:spAutoFit/>
          </a:bodyPr>
          <a:lstStyle>
            <a:lvl1pPr algn="l">
              <a:defRPr sz="1067">
                <a:solidFill>
                  <a:schemeClr val="bg1"/>
                </a:solidFill>
              </a:defRPr>
            </a:lvl1pPr>
          </a:lstStyle>
          <a:p>
            <a:fld id="{7FEEEA1A-CB49-3744-AA40-B896987410F9}" type="slidenum">
              <a:rPr lang="en-US" smtClean="0"/>
              <a:pPr/>
              <a:t>‹#›</a:t>
            </a:fld>
            <a:endParaRPr lang="en-US"/>
          </a:p>
        </p:txBody>
      </p:sp>
      <p:sp>
        <p:nvSpPr>
          <p:cNvPr id="12" name="Title 1"/>
          <p:cNvSpPr>
            <a:spLocks noGrp="1"/>
          </p:cNvSpPr>
          <p:nvPr>
            <p:ph type="title"/>
          </p:nvPr>
        </p:nvSpPr>
        <p:spPr>
          <a:xfrm>
            <a:off x="609595" y="1572768"/>
            <a:ext cx="5473460" cy="348813"/>
          </a:xfrm>
        </p:spPr>
        <p:txBody>
          <a:bodyPr vert="horz" lIns="0" tIns="0" rIns="0" bIns="0" rtlCol="0" anchor="b" anchorCtr="0">
            <a:noAutofit/>
          </a:bodyPr>
          <a:lstStyle>
            <a:lvl1pPr>
              <a:defRPr lang="en-US" sz="2667" b="1" i="0" kern="1200" cap="none" dirty="0">
                <a:solidFill>
                  <a:schemeClr val="bg1"/>
                </a:solidFill>
                <a:latin typeface="+mj-lt"/>
                <a:ea typeface="+mj-ea"/>
                <a:cs typeface="+mj-cs"/>
              </a:defRPr>
            </a:lvl1pPr>
          </a:lstStyle>
          <a:p>
            <a:pPr lvl="0" algn="l" defTabSz="457189" rtl="0" eaLnBrk="1" latinLnBrk="0" hangingPunct="1">
              <a:lnSpc>
                <a:spcPct val="85000"/>
              </a:lnSpc>
              <a:spcBef>
                <a:spcPct val="0"/>
              </a:spcBef>
              <a:buNone/>
            </a:pPr>
            <a:r>
              <a:rPr lang="en-US"/>
              <a:t>Click to edit Master title style</a:t>
            </a:r>
          </a:p>
        </p:txBody>
      </p:sp>
      <p:sp>
        <p:nvSpPr>
          <p:cNvPr id="15" name="Content Placeholder 12"/>
          <p:cNvSpPr>
            <a:spLocks noGrp="1"/>
          </p:cNvSpPr>
          <p:nvPr>
            <p:ph sz="quarter" idx="11"/>
          </p:nvPr>
        </p:nvSpPr>
        <p:spPr>
          <a:xfrm>
            <a:off x="609601" y="1987296"/>
            <a:ext cx="5473455" cy="3707384"/>
          </a:xfrm>
        </p:spPr>
        <p:txBody>
          <a:bodyPr/>
          <a:lstStyle>
            <a:lvl1pPr>
              <a:lnSpc>
                <a:spcPct val="100000"/>
              </a:lnSpc>
              <a:buClr>
                <a:schemeClr val="bg1"/>
              </a:buClr>
              <a:defRPr>
                <a:solidFill>
                  <a:schemeClr val="bg1"/>
                </a:solidFill>
              </a:defRPr>
            </a:lvl1pPr>
            <a:lvl2pPr>
              <a:lnSpc>
                <a:spcPct val="100000"/>
              </a:lnSpc>
              <a:buClr>
                <a:schemeClr val="bg1"/>
              </a:buClr>
              <a:defRPr>
                <a:solidFill>
                  <a:schemeClr val="bg1"/>
                </a:solidFill>
              </a:defRPr>
            </a:lvl2pPr>
            <a:lvl3pPr>
              <a:lnSpc>
                <a:spcPct val="100000"/>
              </a:lnSpc>
              <a:buClr>
                <a:schemeClr val="bg1"/>
              </a:buClr>
              <a:defRPr>
                <a:solidFill>
                  <a:schemeClr val="bg1"/>
                </a:solidFill>
              </a:defRPr>
            </a:lvl3pPr>
            <a:lvl4pPr>
              <a:lnSpc>
                <a:spcPct val="100000"/>
              </a:lnSpc>
              <a:buClr>
                <a:schemeClr val="bg1"/>
              </a:buClr>
              <a:defRPr>
                <a:solidFill>
                  <a:schemeClr val="bg1"/>
                </a:solidFill>
              </a:defRPr>
            </a:lvl4pPr>
            <a:lvl5pPr>
              <a:lnSpc>
                <a:spcPct val="100000"/>
              </a:lnSpc>
              <a:buClr>
                <a:schemeClr val="bg1"/>
              </a:buClr>
              <a:defRPr>
                <a:solidFill>
                  <a:schemeClr val="bg1"/>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367687928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userDrawn="1">
  <p:cSld name="Full Page Photo">
    <p:spTree>
      <p:nvGrpSpPr>
        <p:cNvPr id="1" name=""/>
        <p:cNvGrpSpPr/>
        <p:nvPr/>
      </p:nvGrpSpPr>
      <p:grpSpPr>
        <a:xfrm>
          <a:off x="0" y="0"/>
          <a:ext cx="0" cy="0"/>
          <a:chOff x="0" y="0"/>
          <a:chExt cx="0" cy="0"/>
        </a:xfrm>
      </p:grpSpPr>
      <p:sp>
        <p:nvSpPr>
          <p:cNvPr id="10" name="Title 1"/>
          <p:cNvSpPr>
            <a:spLocks noGrp="1"/>
          </p:cNvSpPr>
          <p:nvPr>
            <p:ph type="title"/>
          </p:nvPr>
        </p:nvSpPr>
        <p:spPr>
          <a:xfrm>
            <a:off x="609600" y="5663796"/>
            <a:ext cx="10972800" cy="418576"/>
          </a:xfrm>
        </p:spPr>
        <p:txBody>
          <a:bodyPr vert="horz" lIns="0" tIns="0" rIns="0" bIns="0" rtlCol="0" anchor="b" anchorCtr="0">
            <a:noAutofit/>
          </a:bodyPr>
          <a:lstStyle>
            <a:lvl1pPr>
              <a:defRPr lang="en-US" sz="3200" b="1" i="0" kern="1200" cap="none" dirty="0">
                <a:solidFill>
                  <a:schemeClr val="tx2"/>
                </a:solidFill>
                <a:latin typeface="+mj-lt"/>
                <a:ea typeface="+mj-ea"/>
                <a:cs typeface="+mj-cs"/>
              </a:defRPr>
            </a:lvl1pPr>
          </a:lstStyle>
          <a:p>
            <a:pPr lvl="0" algn="l" defTabSz="457189" rtl="0" eaLnBrk="1" latinLnBrk="0" hangingPunct="1">
              <a:lnSpc>
                <a:spcPct val="85000"/>
              </a:lnSpc>
              <a:spcBef>
                <a:spcPct val="0"/>
              </a:spcBef>
              <a:buNone/>
            </a:pPr>
            <a:r>
              <a:rPr lang="en-US"/>
              <a:t>Click to edit Master title style</a:t>
            </a:r>
          </a:p>
        </p:txBody>
      </p:sp>
      <p:sp>
        <p:nvSpPr>
          <p:cNvPr id="4" name="Picture Placeholder 3"/>
          <p:cNvSpPr>
            <a:spLocks noGrp="1"/>
          </p:cNvSpPr>
          <p:nvPr>
            <p:ph type="pic" sz="quarter" idx="10" hasCustomPrompt="1"/>
          </p:nvPr>
        </p:nvSpPr>
        <p:spPr>
          <a:xfrm>
            <a:off x="2117" y="1"/>
            <a:ext cx="12189883" cy="5072879"/>
          </a:xfrm>
          <a:solidFill>
            <a:schemeClr val="bg2">
              <a:lumMod val="50000"/>
            </a:schemeClr>
          </a:solidFill>
        </p:spPr>
        <p:txBody>
          <a:bodyPr/>
          <a:lstStyle>
            <a:lvl1pPr marL="0" indent="0" algn="ctr">
              <a:buNone/>
              <a:defRPr>
                <a:solidFill>
                  <a:schemeClr val="bg1"/>
                </a:solidFill>
              </a:defRPr>
            </a:lvl1pPr>
          </a:lstStyle>
          <a:p>
            <a:br>
              <a:rPr lang="en-US"/>
            </a:br>
            <a:br>
              <a:rPr lang="en-US"/>
            </a:br>
            <a:br>
              <a:rPr lang="en-US"/>
            </a:br>
            <a:br>
              <a:rPr lang="en-US"/>
            </a:br>
            <a:br>
              <a:rPr lang="en-US"/>
            </a:br>
            <a:r>
              <a:rPr lang="en-US"/>
              <a:t>Click on icon to insert picture</a:t>
            </a:r>
          </a:p>
        </p:txBody>
      </p:sp>
      <p:sp>
        <p:nvSpPr>
          <p:cNvPr id="8" name="Footer Placeholder 4"/>
          <p:cNvSpPr>
            <a:spLocks noGrp="1"/>
          </p:cNvSpPr>
          <p:nvPr>
            <p:ph type="ftr" sz="quarter" idx="3"/>
          </p:nvPr>
        </p:nvSpPr>
        <p:spPr>
          <a:xfrm>
            <a:off x="1026597" y="6467745"/>
            <a:ext cx="4517089" cy="164148"/>
          </a:xfrm>
          <a:prstGeom prst="rect">
            <a:avLst/>
          </a:prstGeom>
        </p:spPr>
        <p:txBody>
          <a:bodyPr vert="horz" wrap="square" lIns="0" tIns="0" rIns="0" bIns="0" rtlCol="0" anchor="ctr">
            <a:spAutoFit/>
          </a:bodyPr>
          <a:lstStyle>
            <a:lvl1pPr algn="l">
              <a:defRPr sz="1067">
                <a:solidFill>
                  <a:schemeClr val="tx1"/>
                </a:solidFill>
              </a:defRPr>
            </a:lvl1pPr>
          </a:lstStyle>
          <a:p>
            <a:r>
              <a:rPr lang="en-US"/>
              <a:t>Division Name or Footer</a:t>
            </a:r>
          </a:p>
        </p:txBody>
      </p:sp>
      <p:sp>
        <p:nvSpPr>
          <p:cNvPr id="9" name="Slide Number Placeholder 5"/>
          <p:cNvSpPr>
            <a:spLocks noGrp="1"/>
          </p:cNvSpPr>
          <p:nvPr>
            <p:ph type="sldNum" sz="quarter" idx="4"/>
          </p:nvPr>
        </p:nvSpPr>
        <p:spPr>
          <a:xfrm>
            <a:off x="609601" y="6457702"/>
            <a:ext cx="339625" cy="164148"/>
          </a:xfrm>
          <a:prstGeom prst="rect">
            <a:avLst/>
          </a:prstGeom>
        </p:spPr>
        <p:txBody>
          <a:bodyPr vert="horz" wrap="square" lIns="0" tIns="0" rIns="0" bIns="0" rtlCol="0" anchor="ctr">
            <a:spAutoFit/>
          </a:bodyPr>
          <a:lstStyle>
            <a:lvl1pPr algn="l">
              <a:defRPr sz="1067">
                <a:solidFill>
                  <a:schemeClr val="tx1"/>
                </a:solidFill>
              </a:defRPr>
            </a:lvl1pPr>
          </a:lstStyle>
          <a:p>
            <a:fld id="{7FEEEA1A-CB49-3744-AA40-B896987410F9}" type="slidenum">
              <a:rPr lang="en-US" smtClean="0"/>
              <a:pPr/>
              <a:t>‹#›</a:t>
            </a:fld>
            <a:endParaRPr lang="en-US"/>
          </a:p>
        </p:txBody>
      </p:sp>
    </p:spTree>
    <p:extLst>
      <p:ext uri="{BB962C8B-B14F-4D97-AF65-F5344CB8AC3E}">
        <p14:creationId xmlns:p14="http://schemas.microsoft.com/office/powerpoint/2010/main" val="413027338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slideLayout" Target="../slideLayouts/slideLayout18.xml"/><Relationship Id="rId3" Type="http://schemas.openxmlformats.org/officeDocument/2006/relationships/slideLayout" Target="../slideLayouts/slideLayout3.xml"/><Relationship Id="rId21" Type="http://schemas.openxmlformats.org/officeDocument/2006/relationships/slideLayout" Target="../slideLayouts/slideLayout21.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20" Type="http://schemas.openxmlformats.org/officeDocument/2006/relationships/slideLayout" Target="../slideLayouts/slideLayout20.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19" Type="http://schemas.openxmlformats.org/officeDocument/2006/relationships/slideLayout" Target="../slideLayouts/slideLayout19.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 Id="rId22" Type="http://schemas.openxmlformats.org/officeDocument/2006/relationships/theme" Target="../theme/theme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7" name="Rectangle 6"/>
          <p:cNvSpPr/>
          <p:nvPr userDrawn="1"/>
        </p:nvSpPr>
        <p:spPr>
          <a:xfrm>
            <a:off x="0" y="0"/>
            <a:ext cx="12192000" cy="341376"/>
          </a:xfrm>
          <a:prstGeom prst="rect">
            <a:avLst/>
          </a:prstGeom>
          <a:solidFill>
            <a:schemeClr val="tx2"/>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3200"/>
          </a:p>
        </p:txBody>
      </p:sp>
      <p:sp>
        <p:nvSpPr>
          <p:cNvPr id="2" name="Title Placeholder 1"/>
          <p:cNvSpPr>
            <a:spLocks noGrp="1"/>
          </p:cNvSpPr>
          <p:nvPr>
            <p:ph type="title"/>
          </p:nvPr>
        </p:nvSpPr>
        <p:spPr>
          <a:xfrm>
            <a:off x="609599" y="1048512"/>
            <a:ext cx="10972800" cy="418576"/>
          </a:xfrm>
          <a:prstGeom prst="rect">
            <a:avLst/>
          </a:prstGeom>
        </p:spPr>
        <p:txBody>
          <a:bodyPr vert="horz" lIns="0" tIns="0" rIns="0" bIns="0" rtlCol="0" anchor="b" anchorCtr="0">
            <a:noAutofit/>
          </a:bodyPr>
          <a:lstStyle/>
          <a:p>
            <a:pPr lvl="0"/>
            <a:r>
              <a:rPr lang="en-US"/>
              <a:t>Click to edit Master title style</a:t>
            </a:r>
          </a:p>
        </p:txBody>
      </p:sp>
      <p:sp>
        <p:nvSpPr>
          <p:cNvPr id="3" name="Text Placeholder 2"/>
          <p:cNvSpPr>
            <a:spLocks noGrp="1"/>
          </p:cNvSpPr>
          <p:nvPr>
            <p:ph type="body" idx="1"/>
          </p:nvPr>
        </p:nvSpPr>
        <p:spPr>
          <a:xfrm>
            <a:off x="609601" y="1784021"/>
            <a:ext cx="10972799" cy="4018936"/>
          </a:xfrm>
          <a:prstGeom prst="rect">
            <a:avLst/>
          </a:prstGeom>
        </p:spPr>
        <p:txBody>
          <a:bodyPr vert="horz" lIns="0" tIns="0" rIns="0" bIns="0" rtlCol="0">
            <a:no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9" name="Footer Placeholder 4"/>
          <p:cNvSpPr>
            <a:spLocks noGrp="1"/>
          </p:cNvSpPr>
          <p:nvPr>
            <p:ph type="ftr" sz="quarter" idx="3"/>
          </p:nvPr>
        </p:nvSpPr>
        <p:spPr>
          <a:xfrm>
            <a:off x="1026597" y="6467745"/>
            <a:ext cx="4517089" cy="164148"/>
          </a:xfrm>
          <a:prstGeom prst="rect">
            <a:avLst/>
          </a:prstGeom>
        </p:spPr>
        <p:txBody>
          <a:bodyPr vert="horz" wrap="square" lIns="0" tIns="0" rIns="0" bIns="0" rtlCol="0" anchor="ctr">
            <a:spAutoFit/>
          </a:bodyPr>
          <a:lstStyle>
            <a:lvl1pPr algn="l">
              <a:defRPr sz="1067">
                <a:solidFill>
                  <a:schemeClr val="tx1"/>
                </a:solidFill>
              </a:defRPr>
            </a:lvl1pPr>
          </a:lstStyle>
          <a:p>
            <a:r>
              <a:rPr lang="en-US"/>
              <a:t>Division Name or Footer</a:t>
            </a:r>
          </a:p>
        </p:txBody>
      </p:sp>
      <p:sp>
        <p:nvSpPr>
          <p:cNvPr id="10" name="Slide Number Placeholder 5"/>
          <p:cNvSpPr>
            <a:spLocks noGrp="1"/>
          </p:cNvSpPr>
          <p:nvPr>
            <p:ph type="sldNum" sz="quarter" idx="4"/>
          </p:nvPr>
        </p:nvSpPr>
        <p:spPr>
          <a:xfrm>
            <a:off x="609601" y="6457702"/>
            <a:ext cx="339625" cy="164148"/>
          </a:xfrm>
          <a:prstGeom prst="rect">
            <a:avLst/>
          </a:prstGeom>
        </p:spPr>
        <p:txBody>
          <a:bodyPr vert="horz" wrap="square" lIns="0" tIns="0" rIns="0" bIns="0" rtlCol="0" anchor="ctr">
            <a:spAutoFit/>
          </a:bodyPr>
          <a:lstStyle>
            <a:lvl1pPr algn="l">
              <a:defRPr sz="1067">
                <a:solidFill>
                  <a:schemeClr val="tx1"/>
                </a:solidFill>
              </a:defRPr>
            </a:lvl1pPr>
          </a:lstStyle>
          <a:p>
            <a:fld id="{7FEEEA1A-CB49-3744-AA40-B896987410F9}" type="slidenum">
              <a:rPr lang="en-US" smtClean="0"/>
              <a:pPr/>
              <a:t>‹#›</a:t>
            </a:fld>
            <a:endParaRPr lang="en-US"/>
          </a:p>
        </p:txBody>
      </p:sp>
    </p:spTree>
    <p:extLst>
      <p:ext uri="{BB962C8B-B14F-4D97-AF65-F5344CB8AC3E}">
        <p14:creationId xmlns:p14="http://schemas.microsoft.com/office/powerpoint/2010/main" val="3915546746"/>
      </p:ext>
    </p:extLst>
  </p:cSld>
  <p:clrMap bg1="lt1" tx1="dk1" bg2="lt2" tx2="dk2" accent1="accent1" accent2="accent2" accent3="accent3" accent4="accent4" accent5="accent5" accent6="accent6" hlink="hlink" folHlink="folHlink"/>
  <p:sldLayoutIdLst>
    <p:sldLayoutId id="2147483689" r:id="rId1"/>
    <p:sldLayoutId id="2147483690" r:id="rId2"/>
    <p:sldLayoutId id="2147483691" r:id="rId3"/>
    <p:sldLayoutId id="2147483692" r:id="rId4"/>
    <p:sldLayoutId id="2147483693" r:id="rId5"/>
    <p:sldLayoutId id="2147483694" r:id="rId6"/>
    <p:sldLayoutId id="2147483695" r:id="rId7"/>
    <p:sldLayoutId id="2147483696" r:id="rId8"/>
    <p:sldLayoutId id="2147483697" r:id="rId9"/>
    <p:sldLayoutId id="2147483698" r:id="rId10"/>
    <p:sldLayoutId id="2147483699" r:id="rId11"/>
    <p:sldLayoutId id="2147483649" r:id="rId12"/>
    <p:sldLayoutId id="2147483650" r:id="rId13"/>
    <p:sldLayoutId id="2147483651" r:id="rId14"/>
    <p:sldLayoutId id="2147483652" r:id="rId15"/>
    <p:sldLayoutId id="2147483653" r:id="rId16"/>
    <p:sldLayoutId id="2147483654" r:id="rId17"/>
    <p:sldLayoutId id="2147483686" r:id="rId18"/>
    <p:sldLayoutId id="2147483685" r:id="rId19"/>
    <p:sldLayoutId id="2147483684" r:id="rId20"/>
    <p:sldLayoutId id="2147483687" r:id="rId21"/>
  </p:sldLayoutIdLst>
  <p:hf hdr="0" dt="0"/>
  <p:txStyles>
    <p:titleStyle>
      <a:lvl1pPr algn="l" defTabSz="457189" rtl="0" eaLnBrk="1" latinLnBrk="0" hangingPunct="1">
        <a:lnSpc>
          <a:spcPct val="85000"/>
        </a:lnSpc>
        <a:spcBef>
          <a:spcPct val="0"/>
        </a:spcBef>
        <a:buNone/>
        <a:defRPr lang="en-US" sz="3200" b="1" i="0" kern="1200" cap="none" dirty="0">
          <a:solidFill>
            <a:schemeClr val="tx2"/>
          </a:solidFill>
          <a:latin typeface="+mj-lt"/>
          <a:ea typeface="+mj-ea"/>
          <a:cs typeface="+mj-cs"/>
        </a:defRPr>
      </a:lvl1pPr>
    </p:titleStyle>
    <p:bodyStyle>
      <a:lvl1pPr marL="306910" indent="-306910" algn="l" defTabSz="457189" rtl="0" eaLnBrk="1" latinLnBrk="0" hangingPunct="1">
        <a:lnSpc>
          <a:spcPct val="100000"/>
        </a:lnSpc>
        <a:spcBef>
          <a:spcPts val="1067"/>
        </a:spcBef>
        <a:buClr>
          <a:schemeClr val="tx2"/>
        </a:buClr>
        <a:buFont typeface="Arial"/>
        <a:buChar char="•"/>
        <a:defRPr sz="2133" kern="1200">
          <a:solidFill>
            <a:schemeClr val="tx1"/>
          </a:solidFill>
          <a:latin typeface="+mn-lt"/>
          <a:ea typeface="+mn-ea"/>
          <a:cs typeface="+mn-cs"/>
        </a:defRPr>
      </a:lvl1pPr>
      <a:lvl2pPr marL="609585" indent="-309026" algn="l" defTabSz="457189" rtl="0" eaLnBrk="1" latinLnBrk="0" hangingPunct="1">
        <a:lnSpc>
          <a:spcPct val="100000"/>
        </a:lnSpc>
        <a:spcBef>
          <a:spcPts val="1067"/>
        </a:spcBef>
        <a:buClr>
          <a:schemeClr val="tx2"/>
        </a:buClr>
        <a:buFont typeface="Arial"/>
        <a:buChar char="–"/>
        <a:defRPr sz="1867" kern="1200">
          <a:solidFill>
            <a:schemeClr val="tx1"/>
          </a:solidFill>
          <a:latin typeface="+mn-lt"/>
          <a:ea typeface="+mn-ea"/>
          <a:cs typeface="+mn-cs"/>
        </a:defRPr>
      </a:lvl2pPr>
      <a:lvl3pPr marL="912261" indent="-304792" algn="l" defTabSz="457189" rtl="0" eaLnBrk="1" latinLnBrk="0" hangingPunct="1">
        <a:lnSpc>
          <a:spcPct val="100000"/>
        </a:lnSpc>
        <a:spcBef>
          <a:spcPts val="1067"/>
        </a:spcBef>
        <a:buClr>
          <a:schemeClr val="tx2"/>
        </a:buClr>
        <a:buFont typeface="Arial"/>
        <a:buChar char="•"/>
        <a:defRPr sz="1600" kern="1200">
          <a:solidFill>
            <a:schemeClr val="tx1"/>
          </a:solidFill>
          <a:latin typeface="+mn-lt"/>
          <a:ea typeface="+mn-ea"/>
          <a:cs typeface="+mn-cs"/>
        </a:defRPr>
      </a:lvl3pPr>
      <a:lvl4pPr marL="1219170" indent="-306910" algn="l" defTabSz="457189" rtl="0" eaLnBrk="1" latinLnBrk="0" hangingPunct="1">
        <a:lnSpc>
          <a:spcPct val="100000"/>
        </a:lnSpc>
        <a:spcBef>
          <a:spcPts val="1067"/>
        </a:spcBef>
        <a:buClr>
          <a:schemeClr val="tx2"/>
        </a:buClr>
        <a:buFont typeface="Arial"/>
        <a:buChar char="–"/>
        <a:defRPr sz="1600" kern="1200">
          <a:solidFill>
            <a:schemeClr val="tx1"/>
          </a:solidFill>
          <a:latin typeface="+mn-lt"/>
          <a:ea typeface="+mn-ea"/>
          <a:cs typeface="+mn-cs"/>
        </a:defRPr>
      </a:lvl4pPr>
      <a:lvl5pPr marL="1526079" indent="-306910" algn="l" defTabSz="457189" rtl="0" eaLnBrk="1" latinLnBrk="0" hangingPunct="1">
        <a:lnSpc>
          <a:spcPct val="100000"/>
        </a:lnSpc>
        <a:spcBef>
          <a:spcPts val="1067"/>
        </a:spcBef>
        <a:buClr>
          <a:schemeClr val="tx2"/>
        </a:buClr>
        <a:buFont typeface="Arial" panose="020B0604020202020204" pitchFamily="34" charset="0"/>
        <a:buChar char="•"/>
        <a:defRPr sz="1600" kern="1200">
          <a:solidFill>
            <a:schemeClr val="tx1"/>
          </a:solidFill>
          <a:latin typeface="+mn-lt"/>
          <a:ea typeface="+mn-ea"/>
          <a:cs typeface="+mn-cs"/>
        </a:defRPr>
      </a:lvl5pPr>
      <a:lvl6pPr marL="2514537" indent="-228594" algn="l" defTabSz="457189" rtl="0" eaLnBrk="1" latinLnBrk="0" hangingPunct="1">
        <a:spcBef>
          <a:spcPct val="20000"/>
        </a:spcBef>
        <a:buFont typeface="Arial"/>
        <a:buChar char="•"/>
        <a:defRPr sz="2000" kern="1200">
          <a:solidFill>
            <a:schemeClr val="tx1"/>
          </a:solidFill>
          <a:latin typeface="+mn-lt"/>
          <a:ea typeface="+mn-ea"/>
          <a:cs typeface="+mn-cs"/>
        </a:defRPr>
      </a:lvl6pPr>
      <a:lvl7pPr marL="2971726" indent="-228594" algn="l" defTabSz="457189" rtl="0" eaLnBrk="1" latinLnBrk="0" hangingPunct="1">
        <a:spcBef>
          <a:spcPct val="20000"/>
        </a:spcBef>
        <a:buFont typeface="Arial"/>
        <a:buChar char="•"/>
        <a:defRPr sz="2000" kern="1200">
          <a:solidFill>
            <a:schemeClr val="tx1"/>
          </a:solidFill>
          <a:latin typeface="+mn-lt"/>
          <a:ea typeface="+mn-ea"/>
          <a:cs typeface="+mn-cs"/>
        </a:defRPr>
      </a:lvl7pPr>
      <a:lvl8pPr marL="3428914" indent="-228594" algn="l" defTabSz="457189" rtl="0" eaLnBrk="1" latinLnBrk="0" hangingPunct="1">
        <a:spcBef>
          <a:spcPct val="20000"/>
        </a:spcBef>
        <a:buFont typeface="Arial"/>
        <a:buChar char="•"/>
        <a:defRPr sz="2000" kern="1200">
          <a:solidFill>
            <a:schemeClr val="tx1"/>
          </a:solidFill>
          <a:latin typeface="+mn-lt"/>
          <a:ea typeface="+mn-ea"/>
          <a:cs typeface="+mn-cs"/>
        </a:defRPr>
      </a:lvl8pPr>
      <a:lvl9pPr marL="3886103" indent="-228594" algn="l" defTabSz="457189"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189" rtl="0" eaLnBrk="1" latinLnBrk="0" hangingPunct="1">
        <a:defRPr sz="1800" kern="1200">
          <a:solidFill>
            <a:schemeClr val="tx1"/>
          </a:solidFill>
          <a:latin typeface="+mn-lt"/>
          <a:ea typeface="+mn-ea"/>
          <a:cs typeface="+mn-cs"/>
        </a:defRPr>
      </a:lvl1pPr>
      <a:lvl2pPr marL="457189" algn="l" defTabSz="457189" rtl="0" eaLnBrk="1" latinLnBrk="0" hangingPunct="1">
        <a:defRPr sz="1800" kern="1200">
          <a:solidFill>
            <a:schemeClr val="tx1"/>
          </a:solidFill>
          <a:latin typeface="+mn-lt"/>
          <a:ea typeface="+mn-ea"/>
          <a:cs typeface="+mn-cs"/>
        </a:defRPr>
      </a:lvl2pPr>
      <a:lvl3pPr marL="914377" algn="l" defTabSz="457189" rtl="0" eaLnBrk="1" latinLnBrk="0" hangingPunct="1">
        <a:defRPr sz="1800" kern="1200">
          <a:solidFill>
            <a:schemeClr val="tx1"/>
          </a:solidFill>
          <a:latin typeface="+mn-lt"/>
          <a:ea typeface="+mn-ea"/>
          <a:cs typeface="+mn-cs"/>
        </a:defRPr>
      </a:lvl3pPr>
      <a:lvl4pPr marL="1371566" algn="l" defTabSz="457189" rtl="0" eaLnBrk="1" latinLnBrk="0" hangingPunct="1">
        <a:defRPr sz="1800" kern="1200">
          <a:solidFill>
            <a:schemeClr val="tx1"/>
          </a:solidFill>
          <a:latin typeface="+mn-lt"/>
          <a:ea typeface="+mn-ea"/>
          <a:cs typeface="+mn-cs"/>
        </a:defRPr>
      </a:lvl4pPr>
      <a:lvl5pPr marL="1828754" algn="l" defTabSz="457189" rtl="0" eaLnBrk="1" latinLnBrk="0" hangingPunct="1">
        <a:defRPr sz="1800" kern="1200">
          <a:solidFill>
            <a:schemeClr val="tx1"/>
          </a:solidFill>
          <a:latin typeface="+mn-lt"/>
          <a:ea typeface="+mn-ea"/>
          <a:cs typeface="+mn-cs"/>
        </a:defRPr>
      </a:lvl5pPr>
      <a:lvl6pPr marL="2285943" algn="l" defTabSz="457189" rtl="0" eaLnBrk="1" latinLnBrk="0" hangingPunct="1">
        <a:defRPr sz="1800" kern="1200">
          <a:solidFill>
            <a:schemeClr val="tx1"/>
          </a:solidFill>
          <a:latin typeface="+mn-lt"/>
          <a:ea typeface="+mn-ea"/>
          <a:cs typeface="+mn-cs"/>
        </a:defRPr>
      </a:lvl6pPr>
      <a:lvl7pPr marL="2743131" algn="l" defTabSz="457189" rtl="0" eaLnBrk="1" latinLnBrk="0" hangingPunct="1">
        <a:defRPr sz="1800" kern="1200">
          <a:solidFill>
            <a:schemeClr val="tx1"/>
          </a:solidFill>
          <a:latin typeface="+mn-lt"/>
          <a:ea typeface="+mn-ea"/>
          <a:cs typeface="+mn-cs"/>
        </a:defRPr>
      </a:lvl7pPr>
      <a:lvl8pPr marL="3200320" algn="l" defTabSz="457189" rtl="0" eaLnBrk="1" latinLnBrk="0" hangingPunct="1">
        <a:defRPr sz="1800" kern="1200">
          <a:solidFill>
            <a:schemeClr val="tx1"/>
          </a:solidFill>
          <a:latin typeface="+mn-lt"/>
          <a:ea typeface="+mn-ea"/>
          <a:cs typeface="+mn-cs"/>
        </a:defRPr>
      </a:lvl8pPr>
      <a:lvl9pPr marL="3657509" algn="l" defTabSz="457189" rtl="0" eaLnBrk="1" latinLnBrk="0" hangingPunct="1">
        <a:defRPr sz="1800" kern="1200">
          <a:solidFill>
            <a:schemeClr val="tx1"/>
          </a:solidFill>
          <a:latin typeface="+mn-lt"/>
          <a:ea typeface="+mn-ea"/>
          <a:cs typeface="+mn-cs"/>
        </a:defRPr>
      </a:lvl9pPr>
    </p:otherStyle>
  </p:txStyles>
  <p:extLst>
    <p:ext uri="{27BBF7A9-308A-43DC-89C8-2F10F3537804}">
      <p15:sldGuideLst xmlns:p15="http://schemas.microsoft.com/office/powerpoint/2012/main">
        <p15:guide id="1" orient="horz" pos="1296" userDrawn="1">
          <p15:clr>
            <a:srgbClr val="F26B43"/>
          </p15:clr>
        </p15:guide>
        <p15:guide id="2" pos="7296" userDrawn="1">
          <p15:clr>
            <a:srgbClr val="F26B43"/>
          </p15:clr>
        </p15:guide>
        <p15:guide id="3" orient="horz" pos="656" userDrawn="1">
          <p15:clr>
            <a:srgbClr val="F26B43"/>
          </p15:clr>
        </p15:guide>
        <p15:guide id="4" pos="384" userDrawn="1">
          <p15:clr>
            <a:srgbClr val="F26B43"/>
          </p15:clr>
        </p15:guide>
        <p15:guide id="5" orient="horz" pos="3664" userDrawn="1">
          <p15:clr>
            <a:srgbClr val="F26B43"/>
          </p15:clr>
        </p15:guide>
      </p15:sldGuideLst>
    </p:ext>
  </p:extLst>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1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4.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4.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4.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17.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3.xml"/><Relationship Id="rId1" Type="http://schemas.openxmlformats.org/officeDocument/2006/relationships/slideLayout" Target="../slideLayouts/slideLayout4.xml"/><Relationship Id="rId4" Type="http://schemas.microsoft.com/office/2007/relationships/hdphoto" Target="../media/hdphoto3.wdp"/></Relationships>
</file>

<file path=ppt/slides/_rels/slide18.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notesSlide" Target="../notesSlides/notesSlide14.xml"/><Relationship Id="rId1" Type="http://schemas.openxmlformats.org/officeDocument/2006/relationships/slideLayout" Target="../slideLayouts/slideLayout7.xml"/></Relationships>
</file>

<file path=ppt/slides/_rels/slide19.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15.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6.xml"/><Relationship Id="rId1" Type="http://schemas.openxmlformats.org/officeDocument/2006/relationships/slideLayout" Target="../slideLayouts/slideLayout7.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8.xml"/></Relationships>
</file>

<file path=ppt/slides/_rels/slide26.xml.rels><?xml version="1.0" encoding="UTF-8" standalone="yes"?>
<Relationships xmlns="http://schemas.openxmlformats.org/package/2006/relationships"><Relationship Id="rId8" Type="http://schemas.openxmlformats.org/officeDocument/2006/relationships/hyperlink" Target="https://doi.org/10.1634/theoncologist.5-4-302" TargetMode="External"/><Relationship Id="rId3" Type="http://schemas.openxmlformats.org/officeDocument/2006/relationships/hyperlink" Target="https://ncsacw.acf.hhs.gov/topics/trauma-informed-care.aspx" TargetMode="External"/><Relationship Id="rId7" Type="http://schemas.openxmlformats.org/officeDocument/2006/relationships/hyperlink" Target="https://doi.org/10.4103/0973-1075.68401" TargetMode="External"/><Relationship Id="rId2" Type="http://schemas.openxmlformats.org/officeDocument/2006/relationships/hyperlink" Target="https://www.traumainformedcare.chcs.org/" TargetMode="External"/><Relationship Id="rId1" Type="http://schemas.openxmlformats.org/officeDocument/2006/relationships/slideLayout" Target="../slideLayouts/slideLayout2.xml"/><Relationship Id="rId6" Type="http://schemas.openxmlformats.org/officeDocument/2006/relationships/hyperlink" Target="https://cameronkravittfoundation.org/" TargetMode="External"/><Relationship Id="rId5" Type="http://schemas.openxmlformats.org/officeDocument/2006/relationships/hyperlink" Target="https://www.ahrq.gov/sites/default/files/wysiwyg/teamstepps/webinars/2016-materials/teamstepps-monthly-webinar-december2016.pdf" TargetMode="External"/><Relationship Id="rId4" Type="http://schemas.openxmlformats.org/officeDocument/2006/relationships/hyperlink" Target="https://pembasecamp.org/pre-base-camp-modules/" TargetMode="Externa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10.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6.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4.xml"/><Relationship Id="rId1" Type="http://schemas.openxmlformats.org/officeDocument/2006/relationships/slideLayout" Target="../slideLayouts/slideLayout2.xml"/><Relationship Id="rId4" Type="http://schemas.microsoft.com/office/2007/relationships/hdphoto" Target="../media/hdphoto1.wdp"/></Relationships>
</file>

<file path=ppt/slides/_rels/slide7.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5.xml"/><Relationship Id="rId1" Type="http://schemas.openxmlformats.org/officeDocument/2006/relationships/slideLayout" Target="../slideLayouts/slideLayout2.xml"/><Relationship Id="rId4" Type="http://schemas.microsoft.com/office/2007/relationships/hdphoto" Target="../media/hdphoto2.wdp"/></Relationships>
</file>

<file path=ppt/slides/_rels/slide8.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6.xml"/><Relationship Id="rId1" Type="http://schemas.openxmlformats.org/officeDocument/2006/relationships/slideLayout" Target="../slideLayouts/slideLayout2.xml"/><Relationship Id="rId4" Type="http://schemas.microsoft.com/office/2007/relationships/hdphoto" Target="../media/hdphoto2.wdp"/></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itle 9"/>
          <p:cNvSpPr>
            <a:spLocks noGrp="1"/>
          </p:cNvSpPr>
          <p:nvPr>
            <p:ph type="ctrTitle"/>
          </p:nvPr>
        </p:nvSpPr>
        <p:spPr>
          <a:xfrm>
            <a:off x="628320" y="1696955"/>
            <a:ext cx="10935360" cy="3464090"/>
          </a:xfrm>
        </p:spPr>
        <p:txBody>
          <a:bodyPr/>
          <a:lstStyle/>
          <a:p>
            <a:pPr algn="ctr">
              <a:lnSpc>
                <a:spcPct val="120000"/>
              </a:lnSpc>
            </a:pPr>
            <a:r>
              <a:rPr lang="en-US" sz="4800" dirty="0"/>
              <a:t>Family Presence Facilitator (FPF) Curriculum: </a:t>
            </a:r>
            <a:br>
              <a:rPr lang="en-US" sz="4800" dirty="0"/>
            </a:br>
            <a:r>
              <a:rPr lang="en-US" sz="4800" dirty="0"/>
              <a:t>simulated PARTICIPANT Training</a:t>
            </a:r>
            <a:br>
              <a:rPr lang="en-US" sz="4800" dirty="0"/>
            </a:br>
            <a:r>
              <a:rPr lang="en-US" sz="4800" dirty="0"/>
              <a:t> </a:t>
            </a:r>
            <a:endParaRPr lang="en-US" sz="4800" dirty="0">
              <a:cs typeface="Arial"/>
            </a:endParaRPr>
          </a:p>
        </p:txBody>
      </p:sp>
      <p:sp>
        <p:nvSpPr>
          <p:cNvPr id="21" name="Subtitle 20"/>
          <p:cNvSpPr>
            <a:spLocks noGrp="1"/>
          </p:cNvSpPr>
          <p:nvPr>
            <p:ph type="subTitle" idx="1"/>
          </p:nvPr>
        </p:nvSpPr>
        <p:spPr>
          <a:xfrm>
            <a:off x="758662" y="6550998"/>
            <a:ext cx="10674676" cy="169277"/>
          </a:xfrm>
        </p:spPr>
        <p:txBody>
          <a:bodyPr/>
          <a:lstStyle/>
          <a:p>
            <a:pPr algn="ctr"/>
            <a:r>
              <a:rPr lang="en-US" sz="1100" dirty="0"/>
              <a:t>Ellen Duncan MD, PhD; Joanne Agnant MD, MSc; </a:t>
            </a:r>
            <a:r>
              <a:rPr lang="en-US" sz="1100" dirty="0" err="1"/>
              <a:t>Kymme</a:t>
            </a:r>
            <a:r>
              <a:rPr lang="en-US" sz="1100" dirty="0"/>
              <a:t> Napoli, MS, CCLS; Stephanie Mejia, MS, CCLS; Paula </a:t>
            </a:r>
            <a:r>
              <a:rPr lang="en-US" sz="1100" dirty="0" err="1"/>
              <a:t>Landdeck</a:t>
            </a:r>
            <a:r>
              <a:rPr lang="en-US" sz="1100" dirty="0"/>
              <a:t>, BSN; Selin T. </a:t>
            </a:r>
            <a:r>
              <a:rPr lang="en-US" sz="1100" dirty="0" err="1"/>
              <a:t>Sagalowsky</a:t>
            </a:r>
            <a:r>
              <a:rPr lang="en-US" sz="1100" dirty="0"/>
              <a:t>, MD, MPH</a:t>
            </a:r>
            <a:endParaRPr lang="en-US" sz="1100" dirty="0">
              <a:cs typeface="Arial"/>
            </a:endParaRPr>
          </a:p>
        </p:txBody>
      </p:sp>
      <p:sp>
        <p:nvSpPr>
          <p:cNvPr id="2" name="Subtitle 20">
            <a:extLst>
              <a:ext uri="{FF2B5EF4-FFF2-40B4-BE49-F238E27FC236}">
                <a16:creationId xmlns:a16="http://schemas.microsoft.com/office/drawing/2014/main" id="{DDA480C0-D911-15AE-F090-775EEF587FC7}"/>
              </a:ext>
            </a:extLst>
          </p:cNvPr>
          <p:cNvSpPr txBox="1">
            <a:spLocks/>
          </p:cNvSpPr>
          <p:nvPr/>
        </p:nvSpPr>
        <p:spPr>
          <a:xfrm>
            <a:off x="758662" y="4588592"/>
            <a:ext cx="10674676" cy="369332"/>
          </a:xfrm>
          <a:prstGeom prst="rect">
            <a:avLst/>
          </a:prstGeom>
        </p:spPr>
        <p:txBody>
          <a:bodyPr vert="horz" wrap="square" lIns="0" tIns="0" rIns="0" bIns="0" rtlCol="0" anchor="ctr" anchorCtr="0">
            <a:spAutoFit/>
          </a:bodyPr>
          <a:lstStyle>
            <a:lvl1pPr marL="0" indent="0" algn="l" defTabSz="457189" rtl="0" eaLnBrk="1" latinLnBrk="0" hangingPunct="1">
              <a:lnSpc>
                <a:spcPct val="100000"/>
              </a:lnSpc>
              <a:spcBef>
                <a:spcPts val="1067"/>
              </a:spcBef>
              <a:buClr>
                <a:schemeClr val="tx2"/>
              </a:buClr>
              <a:buFont typeface="Arial"/>
              <a:buNone/>
              <a:defRPr sz="2133" b="0" i="0" kern="1200" cap="none" baseline="0">
                <a:solidFill>
                  <a:srgbClr val="FFFFFF"/>
                </a:solidFill>
                <a:latin typeface="+mn-lt"/>
                <a:ea typeface="+mn-ea"/>
                <a:cs typeface="+mn-cs"/>
              </a:defRPr>
            </a:lvl1pPr>
            <a:lvl2pPr marL="457189" indent="0" algn="ctr" defTabSz="457189" rtl="0" eaLnBrk="1" latinLnBrk="0" hangingPunct="1">
              <a:lnSpc>
                <a:spcPct val="100000"/>
              </a:lnSpc>
              <a:spcBef>
                <a:spcPts val="1067"/>
              </a:spcBef>
              <a:buClr>
                <a:schemeClr val="tx2"/>
              </a:buClr>
              <a:buFont typeface="Arial"/>
              <a:buNone/>
              <a:defRPr sz="1867" kern="1200">
                <a:solidFill>
                  <a:schemeClr val="tx1">
                    <a:tint val="75000"/>
                  </a:schemeClr>
                </a:solidFill>
                <a:latin typeface="+mn-lt"/>
                <a:ea typeface="+mn-ea"/>
                <a:cs typeface="+mn-cs"/>
              </a:defRPr>
            </a:lvl2pPr>
            <a:lvl3pPr marL="914377" indent="0" algn="ctr" defTabSz="457189" rtl="0" eaLnBrk="1" latinLnBrk="0" hangingPunct="1">
              <a:lnSpc>
                <a:spcPct val="100000"/>
              </a:lnSpc>
              <a:spcBef>
                <a:spcPts val="1067"/>
              </a:spcBef>
              <a:buClr>
                <a:schemeClr val="tx2"/>
              </a:buClr>
              <a:buFont typeface="Arial"/>
              <a:buNone/>
              <a:defRPr sz="1600" kern="1200">
                <a:solidFill>
                  <a:schemeClr val="tx1">
                    <a:tint val="75000"/>
                  </a:schemeClr>
                </a:solidFill>
                <a:latin typeface="+mn-lt"/>
                <a:ea typeface="+mn-ea"/>
                <a:cs typeface="+mn-cs"/>
              </a:defRPr>
            </a:lvl3pPr>
            <a:lvl4pPr marL="1371566" indent="0" algn="ctr" defTabSz="457189" rtl="0" eaLnBrk="1" latinLnBrk="0" hangingPunct="1">
              <a:lnSpc>
                <a:spcPct val="100000"/>
              </a:lnSpc>
              <a:spcBef>
                <a:spcPts val="1067"/>
              </a:spcBef>
              <a:buClr>
                <a:schemeClr val="tx2"/>
              </a:buClr>
              <a:buFont typeface="Arial"/>
              <a:buNone/>
              <a:defRPr sz="1600" kern="1200">
                <a:solidFill>
                  <a:schemeClr val="tx1">
                    <a:tint val="75000"/>
                  </a:schemeClr>
                </a:solidFill>
                <a:latin typeface="+mn-lt"/>
                <a:ea typeface="+mn-ea"/>
                <a:cs typeface="+mn-cs"/>
              </a:defRPr>
            </a:lvl4pPr>
            <a:lvl5pPr marL="1828754" indent="0" algn="ctr" defTabSz="457189" rtl="0" eaLnBrk="1" latinLnBrk="0" hangingPunct="1">
              <a:lnSpc>
                <a:spcPct val="100000"/>
              </a:lnSpc>
              <a:spcBef>
                <a:spcPts val="1067"/>
              </a:spcBef>
              <a:buClr>
                <a:schemeClr val="tx2"/>
              </a:buClr>
              <a:buFont typeface="Arial" panose="020B0604020202020204" pitchFamily="34" charset="0"/>
              <a:buNone/>
              <a:defRPr sz="1600" kern="1200">
                <a:solidFill>
                  <a:schemeClr val="tx1">
                    <a:tint val="75000"/>
                  </a:schemeClr>
                </a:solidFill>
                <a:latin typeface="+mn-lt"/>
                <a:ea typeface="+mn-ea"/>
                <a:cs typeface="+mn-cs"/>
              </a:defRPr>
            </a:lvl5pPr>
            <a:lvl6pPr marL="2285943" indent="0" algn="ctr" defTabSz="457189" rtl="0" eaLnBrk="1" latinLnBrk="0" hangingPunct="1">
              <a:spcBef>
                <a:spcPct val="20000"/>
              </a:spcBef>
              <a:buFont typeface="Arial"/>
              <a:buNone/>
              <a:defRPr sz="2000" kern="1200">
                <a:solidFill>
                  <a:schemeClr val="tx1">
                    <a:tint val="75000"/>
                  </a:schemeClr>
                </a:solidFill>
                <a:latin typeface="+mn-lt"/>
                <a:ea typeface="+mn-ea"/>
                <a:cs typeface="+mn-cs"/>
              </a:defRPr>
            </a:lvl6pPr>
            <a:lvl7pPr marL="2743131" indent="0" algn="ctr" defTabSz="457189" rtl="0" eaLnBrk="1" latinLnBrk="0" hangingPunct="1">
              <a:spcBef>
                <a:spcPct val="20000"/>
              </a:spcBef>
              <a:buFont typeface="Arial"/>
              <a:buNone/>
              <a:defRPr sz="2000" kern="1200">
                <a:solidFill>
                  <a:schemeClr val="tx1">
                    <a:tint val="75000"/>
                  </a:schemeClr>
                </a:solidFill>
                <a:latin typeface="+mn-lt"/>
                <a:ea typeface="+mn-ea"/>
                <a:cs typeface="+mn-cs"/>
              </a:defRPr>
            </a:lvl7pPr>
            <a:lvl8pPr marL="3200320" indent="0" algn="ctr" defTabSz="457189" rtl="0" eaLnBrk="1" latinLnBrk="0" hangingPunct="1">
              <a:spcBef>
                <a:spcPct val="20000"/>
              </a:spcBef>
              <a:buFont typeface="Arial"/>
              <a:buNone/>
              <a:defRPr sz="2000" kern="1200">
                <a:solidFill>
                  <a:schemeClr val="tx1">
                    <a:tint val="75000"/>
                  </a:schemeClr>
                </a:solidFill>
                <a:latin typeface="+mn-lt"/>
                <a:ea typeface="+mn-ea"/>
                <a:cs typeface="+mn-cs"/>
              </a:defRPr>
            </a:lvl8pPr>
            <a:lvl9pPr marL="3657509" indent="0" algn="ctr" defTabSz="457189" rtl="0" eaLnBrk="1" latinLnBrk="0" hangingPunct="1">
              <a:spcBef>
                <a:spcPct val="20000"/>
              </a:spcBef>
              <a:buFont typeface="Arial"/>
              <a:buNone/>
              <a:defRPr sz="2000" kern="1200">
                <a:solidFill>
                  <a:schemeClr val="tx1">
                    <a:tint val="75000"/>
                  </a:schemeClr>
                </a:solidFill>
                <a:latin typeface="+mn-lt"/>
                <a:ea typeface="+mn-ea"/>
                <a:cs typeface="+mn-cs"/>
              </a:defRPr>
            </a:lvl9pPr>
          </a:lstStyle>
          <a:p>
            <a:pPr algn="ctr"/>
            <a:r>
              <a:rPr lang="en-US" sz="2400" i="1" dirty="0"/>
              <a:t>Estimated duration: 30 minutes</a:t>
            </a:r>
            <a:endParaRPr lang="en-US" sz="2400" i="1" dirty="0">
              <a:cs typeface="Arial"/>
            </a:endParaRPr>
          </a:p>
        </p:txBody>
      </p:sp>
    </p:spTree>
    <p:extLst>
      <p:ext uri="{BB962C8B-B14F-4D97-AF65-F5344CB8AC3E}">
        <p14:creationId xmlns:p14="http://schemas.microsoft.com/office/powerpoint/2010/main" val="3157483606"/>
      </p:ext>
    </p:extLst>
  </p:cSld>
  <p:clrMapOvr>
    <a:masterClrMapping/>
  </p:clrMapOvr>
  <mc:AlternateContent xmlns:mc="http://schemas.openxmlformats.org/markup-compatibility/2006" xmlns:p14="http://schemas.microsoft.com/office/powerpoint/2010/main">
    <mc:Choice Requires="p14">
      <p:transition spd="slow" p14:dur="2000" advTm="10969"/>
    </mc:Choice>
    <mc:Fallback xmlns="">
      <p:transition spd="slow" advTm="10969"/>
    </mc:Fallback>
  </mc:AlternateContent>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Title 14"/>
          <p:cNvSpPr>
            <a:spLocks noGrp="1"/>
          </p:cNvSpPr>
          <p:nvPr>
            <p:ph type="title"/>
          </p:nvPr>
        </p:nvSpPr>
        <p:spPr/>
        <p:txBody>
          <a:bodyPr vert="horz" lIns="0" tIns="0" rIns="0" bIns="0" rtlCol="0" anchor="ctr" anchorCtr="0">
            <a:noAutofit/>
          </a:bodyPr>
          <a:lstStyle/>
          <a:p>
            <a:r>
              <a:rPr lang="en-US" dirty="0"/>
              <a:t>Personality traits</a:t>
            </a:r>
          </a:p>
        </p:txBody>
      </p:sp>
    </p:spTree>
    <p:extLst>
      <p:ext uri="{BB962C8B-B14F-4D97-AF65-F5344CB8AC3E}">
        <p14:creationId xmlns:p14="http://schemas.microsoft.com/office/powerpoint/2010/main" val="483309127"/>
      </p:ext>
    </p:extLst>
  </p:cSld>
  <p:clrMapOvr>
    <a:masterClrMapping/>
  </p:clrMapOvr>
  <mc:AlternateContent xmlns:mc="http://schemas.openxmlformats.org/markup-compatibility/2006" xmlns:p14="http://schemas.microsoft.com/office/powerpoint/2010/main">
    <mc:Choice Requires="p14">
      <p:transition spd="slow" p14:dur="2000" advTm="7031"/>
    </mc:Choice>
    <mc:Fallback xmlns="">
      <p:transition spd="slow" advTm="7031"/>
    </mc:Fallback>
  </mc:AlternateContent>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6" descr="A person covering the face with the hands&#10;&#10;Description automatically generated">
            <a:extLst>
              <a:ext uri="{FF2B5EF4-FFF2-40B4-BE49-F238E27FC236}">
                <a16:creationId xmlns:a16="http://schemas.microsoft.com/office/drawing/2014/main" id="{729F3E2F-07A9-3327-A32A-C5909DF12252}"/>
              </a:ext>
            </a:extLst>
          </p:cNvPr>
          <p:cNvPicPr>
            <a:picLocks noChangeAspect="1"/>
          </p:cNvPicPr>
          <p:nvPr/>
        </p:nvPicPr>
        <p:blipFill rotWithShape="1">
          <a:blip r:embed="rId3"/>
          <a:srcRect r="-79" b="2166"/>
          <a:stretch/>
        </p:blipFill>
        <p:spPr>
          <a:xfrm>
            <a:off x="1373" y="284218"/>
            <a:ext cx="12192013" cy="6576484"/>
          </a:xfrm>
          <a:prstGeom prst="rect">
            <a:avLst/>
          </a:prstGeom>
        </p:spPr>
      </p:pic>
      <p:sp>
        <p:nvSpPr>
          <p:cNvPr id="2" name="Title 1">
            <a:extLst>
              <a:ext uri="{FF2B5EF4-FFF2-40B4-BE49-F238E27FC236}">
                <a16:creationId xmlns:a16="http://schemas.microsoft.com/office/drawing/2014/main" id="{C551AF25-74B9-44A9-973E-75F4DE5FE04E}"/>
              </a:ext>
            </a:extLst>
          </p:cNvPr>
          <p:cNvSpPr>
            <a:spLocks noGrp="1"/>
          </p:cNvSpPr>
          <p:nvPr>
            <p:ph type="title"/>
          </p:nvPr>
        </p:nvSpPr>
        <p:spPr>
          <a:xfrm>
            <a:off x="609599" y="760965"/>
            <a:ext cx="10972803" cy="418576"/>
          </a:xfrm>
        </p:spPr>
        <p:txBody>
          <a:bodyPr/>
          <a:lstStyle/>
          <a:p>
            <a:r>
              <a:rPr lang="en-US" sz="3700">
                <a:cs typeface="Arial"/>
              </a:rPr>
              <a:t>Personality Traits</a:t>
            </a:r>
            <a:endParaRPr lang="en-US"/>
          </a:p>
        </p:txBody>
      </p:sp>
      <p:sp>
        <p:nvSpPr>
          <p:cNvPr id="3" name="Content Placeholder 2">
            <a:extLst>
              <a:ext uri="{FF2B5EF4-FFF2-40B4-BE49-F238E27FC236}">
                <a16:creationId xmlns:a16="http://schemas.microsoft.com/office/drawing/2014/main" id="{3E11CACD-6C7E-40ED-AD2C-A9A6844B6D92}"/>
              </a:ext>
            </a:extLst>
          </p:cNvPr>
          <p:cNvSpPr>
            <a:spLocks noGrp="1"/>
          </p:cNvSpPr>
          <p:nvPr>
            <p:ph sz="quarter" idx="13"/>
          </p:nvPr>
        </p:nvSpPr>
        <p:spPr>
          <a:xfrm>
            <a:off x="609600" y="1590856"/>
            <a:ext cx="11429849" cy="4410379"/>
          </a:xfrm>
        </p:spPr>
        <p:txBody>
          <a:bodyPr vert="horz" lIns="0" tIns="0" rIns="0" bIns="0" rtlCol="0" anchor="t">
            <a:noAutofit/>
          </a:bodyPr>
          <a:lstStyle/>
          <a:p>
            <a:pPr marL="306070" indent="-306070">
              <a:lnSpc>
                <a:spcPct val="120000"/>
              </a:lnSpc>
            </a:pPr>
            <a:r>
              <a:rPr lang="en-US" sz="3600" b="1" dirty="0">
                <a:solidFill>
                  <a:schemeClr val="tx1">
                    <a:lumMod val="75000"/>
                  </a:schemeClr>
                </a:solidFill>
                <a:cs typeface="Arial"/>
              </a:rPr>
              <a:t>How many? </a:t>
            </a:r>
            <a:r>
              <a:rPr lang="en-US" sz="3600" dirty="0">
                <a:solidFill>
                  <a:schemeClr val="tx1">
                    <a:lumMod val="75000"/>
                  </a:schemeClr>
                </a:solidFill>
                <a:cs typeface="Arial"/>
              </a:rPr>
              <a:t>There are hundreds of different personality traits!</a:t>
            </a:r>
            <a:endParaRPr lang="en-US" dirty="0">
              <a:solidFill>
                <a:schemeClr val="tx1">
                  <a:lumMod val="75000"/>
                </a:schemeClr>
              </a:solidFill>
              <a:cs typeface="Arial"/>
            </a:endParaRPr>
          </a:p>
          <a:p>
            <a:pPr marL="608965" lvl="1" indent="-308610">
              <a:lnSpc>
                <a:spcPct val="120000"/>
              </a:lnSpc>
            </a:pPr>
            <a:endParaRPr lang="en-US" sz="1100" dirty="0">
              <a:solidFill>
                <a:schemeClr val="tx1">
                  <a:lumMod val="75000"/>
                </a:schemeClr>
              </a:solidFill>
              <a:ea typeface="+mn-lt"/>
              <a:cs typeface="+mn-lt"/>
            </a:endParaRPr>
          </a:p>
          <a:p>
            <a:pPr marL="306070" indent="-306070">
              <a:lnSpc>
                <a:spcPct val="120000"/>
              </a:lnSpc>
            </a:pPr>
            <a:r>
              <a:rPr lang="en-US" sz="3600" b="1" dirty="0">
                <a:solidFill>
                  <a:schemeClr val="tx1">
                    <a:lumMod val="75000"/>
                  </a:schemeClr>
                </a:solidFill>
                <a:ea typeface="+mn-lt"/>
                <a:cs typeface="+mn-lt"/>
              </a:rPr>
              <a:t>Our focus</a:t>
            </a:r>
            <a:r>
              <a:rPr lang="en-US" sz="3600" dirty="0">
                <a:solidFill>
                  <a:schemeClr val="tx1">
                    <a:lumMod val="75000"/>
                  </a:schemeClr>
                </a:solidFill>
                <a:ea typeface="+mn-lt"/>
                <a:cs typeface="+mn-lt"/>
              </a:rPr>
              <a:t>:  </a:t>
            </a:r>
          </a:p>
          <a:p>
            <a:pPr marL="608965" lvl="1" indent="-308610">
              <a:lnSpc>
                <a:spcPct val="120000"/>
              </a:lnSpc>
            </a:pPr>
            <a:r>
              <a:rPr lang="en-US" sz="3100" dirty="0">
                <a:solidFill>
                  <a:schemeClr val="tx1">
                    <a:lumMod val="75000"/>
                  </a:schemeClr>
                </a:solidFill>
                <a:ea typeface="+mn-lt"/>
                <a:cs typeface="+mn-lt"/>
              </a:rPr>
              <a:t>Agitated</a:t>
            </a:r>
          </a:p>
          <a:p>
            <a:pPr marL="608965" lvl="1" indent="-308610">
              <a:lnSpc>
                <a:spcPct val="120000"/>
              </a:lnSpc>
            </a:pPr>
            <a:r>
              <a:rPr lang="en-US" sz="3100" dirty="0">
                <a:solidFill>
                  <a:schemeClr val="tx1">
                    <a:lumMod val="75000"/>
                  </a:schemeClr>
                </a:solidFill>
                <a:cs typeface="Arial"/>
              </a:rPr>
              <a:t>Anxious</a:t>
            </a:r>
          </a:p>
          <a:p>
            <a:pPr marL="608965" lvl="1" indent="-308610">
              <a:lnSpc>
                <a:spcPct val="120000"/>
              </a:lnSpc>
            </a:pPr>
            <a:r>
              <a:rPr lang="en-US" sz="3100" dirty="0">
                <a:solidFill>
                  <a:schemeClr val="tx1">
                    <a:lumMod val="75000"/>
                  </a:schemeClr>
                </a:solidFill>
                <a:cs typeface="Arial"/>
              </a:rPr>
              <a:t>Quiet</a:t>
            </a:r>
          </a:p>
          <a:p>
            <a:pPr marL="300355" lvl="1" indent="0">
              <a:lnSpc>
                <a:spcPct val="120000"/>
              </a:lnSpc>
              <a:buNone/>
            </a:pPr>
            <a:endParaRPr lang="en-US" sz="2100" b="1" i="1" dirty="0">
              <a:cs typeface="Arial"/>
            </a:endParaRPr>
          </a:p>
          <a:p>
            <a:pPr marL="608965" lvl="1" indent="-308610">
              <a:lnSpc>
                <a:spcPct val="120000"/>
              </a:lnSpc>
            </a:pPr>
            <a:endParaRPr lang="en-US" sz="2100" dirty="0">
              <a:cs typeface="Arial"/>
            </a:endParaRPr>
          </a:p>
        </p:txBody>
      </p:sp>
      <p:sp>
        <p:nvSpPr>
          <p:cNvPr id="5" name="Slide Number Placeholder 4">
            <a:extLst>
              <a:ext uri="{FF2B5EF4-FFF2-40B4-BE49-F238E27FC236}">
                <a16:creationId xmlns:a16="http://schemas.microsoft.com/office/drawing/2014/main" id="{39FB0557-AA6D-4A0D-A1D3-3E8C0C180956}"/>
              </a:ext>
            </a:extLst>
          </p:cNvPr>
          <p:cNvSpPr>
            <a:spLocks noGrp="1"/>
          </p:cNvSpPr>
          <p:nvPr>
            <p:ph type="sldNum" sz="quarter" idx="4"/>
          </p:nvPr>
        </p:nvSpPr>
        <p:spPr/>
        <p:txBody>
          <a:bodyPr/>
          <a:lstStyle/>
          <a:p>
            <a:fld id="{7FEEEA1A-CB49-3744-AA40-B896987410F9}" type="slidenum">
              <a:rPr lang="en-US" smtClean="0"/>
              <a:pPr/>
              <a:t>11</a:t>
            </a:fld>
            <a:endParaRPr lang="en-US"/>
          </a:p>
        </p:txBody>
      </p:sp>
      <p:sp>
        <p:nvSpPr>
          <p:cNvPr id="9" name="Footer Placeholder 5">
            <a:extLst>
              <a:ext uri="{FF2B5EF4-FFF2-40B4-BE49-F238E27FC236}">
                <a16:creationId xmlns:a16="http://schemas.microsoft.com/office/drawing/2014/main" id="{04385C29-D972-48FB-B8A4-7BB2E37D8A0D}"/>
              </a:ext>
            </a:extLst>
          </p:cNvPr>
          <p:cNvSpPr txBox="1">
            <a:spLocks/>
          </p:cNvSpPr>
          <p:nvPr/>
        </p:nvSpPr>
        <p:spPr>
          <a:xfrm>
            <a:off x="270933" y="6668046"/>
            <a:ext cx="11159067" cy="123111"/>
          </a:xfrm>
          <a:prstGeom prst="rect">
            <a:avLst/>
          </a:prstGeom>
        </p:spPr>
        <p:txBody>
          <a:bodyPr vert="horz" wrap="square" lIns="0" tIns="0" rIns="0" bIns="0" rtlCol="0" anchor="ct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800">
                <a:ea typeface="+mn-lt"/>
                <a:cs typeface="+mn-lt"/>
              </a:rPr>
              <a:t>Image by – </a:t>
            </a:r>
            <a:r>
              <a:rPr lang="en-US" sz="800" err="1">
                <a:ea typeface="+mn-lt"/>
                <a:cs typeface="+mn-lt"/>
              </a:rPr>
              <a:t>reuben</a:t>
            </a:r>
            <a:r>
              <a:rPr lang="en-US" sz="800">
                <a:ea typeface="+mn-lt"/>
                <a:cs typeface="+mn-lt"/>
              </a:rPr>
              <a:t> - , </a:t>
            </a:r>
            <a:r>
              <a:rPr lang="en-US" sz="800"/>
              <a:t>retrieved from: https://search.openverse.engineering/image/a579a816-d390-44d2-ad89-b6314b51f565 on 4 March 2022. Creative Commons license associated: https://creativecommons.org/licenses/by-nc/4.0/.</a:t>
            </a:r>
            <a:endParaRPr lang="en-US" sz="800">
              <a:cs typeface="Arial"/>
            </a:endParaRPr>
          </a:p>
        </p:txBody>
      </p:sp>
    </p:spTree>
    <p:extLst>
      <p:ext uri="{BB962C8B-B14F-4D97-AF65-F5344CB8AC3E}">
        <p14:creationId xmlns:p14="http://schemas.microsoft.com/office/powerpoint/2010/main" val="3217855894"/>
      </p:ext>
    </p:extLst>
  </p:cSld>
  <p:clrMapOvr>
    <a:masterClrMapping/>
  </p:clrMapOvr>
  <mc:AlternateContent xmlns:mc="http://schemas.openxmlformats.org/markup-compatibility/2006" xmlns:p14="http://schemas.microsoft.com/office/powerpoint/2010/main">
    <mc:Choice Requires="p14">
      <p:transition spd="slow" p14:dur="2000" advTm="63038"/>
    </mc:Choice>
    <mc:Fallback xmlns="">
      <p:transition spd="slow" advTm="63038"/>
    </mc:Fallback>
  </mc:AlternateContent>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Content Placeholder 13"/>
          <p:cNvSpPr>
            <a:spLocks noGrp="1"/>
          </p:cNvSpPr>
          <p:nvPr>
            <p:ph sz="half" idx="1"/>
          </p:nvPr>
        </p:nvSpPr>
        <p:spPr>
          <a:xfrm>
            <a:off x="440266" y="1610698"/>
            <a:ext cx="5243098" cy="4553035"/>
          </a:xfrm>
        </p:spPr>
        <p:txBody>
          <a:bodyPr vert="horz" lIns="0" tIns="0" rIns="0" bIns="0" rtlCol="0" anchor="t">
            <a:normAutofit fontScale="92500" lnSpcReduction="20000"/>
          </a:bodyPr>
          <a:lstStyle/>
          <a:p>
            <a:pPr marL="306070" indent="-306070"/>
            <a:r>
              <a:rPr lang="en-US" b="1"/>
              <a:t>Example Behaviors (In order of escalation)</a:t>
            </a:r>
          </a:p>
          <a:p>
            <a:pPr marL="608330" lvl="1" indent="-306070"/>
            <a:r>
              <a:rPr lang="en-US">
                <a:cs typeface="Arial"/>
              </a:rPr>
              <a:t>Pacing and appearing nervous/ agitated</a:t>
            </a:r>
          </a:p>
          <a:p>
            <a:pPr marL="608330" lvl="1" indent="-306070"/>
            <a:r>
              <a:rPr lang="en-US">
                <a:cs typeface="Arial"/>
              </a:rPr>
              <a:t>Angry facial/ body expressions (e.g., furrowed brows, crossed arms, clenched jaw)</a:t>
            </a:r>
          </a:p>
          <a:p>
            <a:pPr marL="608330" lvl="1" indent="-306070"/>
            <a:r>
              <a:rPr lang="en-US">
                <a:cs typeface="Arial"/>
              </a:rPr>
              <a:t>Loud voice </a:t>
            </a:r>
            <a:r>
              <a:rPr lang="en-US">
                <a:cs typeface="Arial"/>
                <a:sym typeface="Wingdings"/>
              </a:rPr>
              <a:t></a:t>
            </a:r>
            <a:r>
              <a:rPr lang="en-US">
                <a:cs typeface="Arial"/>
              </a:rPr>
              <a:t> yelling </a:t>
            </a:r>
            <a:r>
              <a:rPr lang="en-US">
                <a:cs typeface="Arial"/>
                <a:sym typeface="Wingdings"/>
              </a:rPr>
              <a:t> </a:t>
            </a:r>
            <a:r>
              <a:rPr lang="en-US">
                <a:cs typeface="Arial"/>
              </a:rPr>
              <a:t>oppositional behaviors (e.g., “Stop touching him!") </a:t>
            </a:r>
          </a:p>
          <a:p>
            <a:pPr marL="608330" lvl="1" indent="-306070"/>
            <a:r>
              <a:rPr lang="en-US">
                <a:cs typeface="Arial"/>
              </a:rPr>
              <a:t>Balling fists </a:t>
            </a:r>
            <a:r>
              <a:rPr lang="en-US">
                <a:cs typeface="Arial"/>
                <a:sym typeface="Wingdings"/>
              </a:rPr>
              <a:t> </a:t>
            </a:r>
            <a:r>
              <a:rPr lang="en-US">
                <a:cs typeface="Arial"/>
              </a:rPr>
              <a:t>knocking things to ground</a:t>
            </a:r>
          </a:p>
          <a:p>
            <a:pPr marL="608330" lvl="1" indent="-306070"/>
            <a:endParaRPr lang="en-US">
              <a:cs typeface="Arial"/>
            </a:endParaRPr>
          </a:p>
          <a:p>
            <a:pPr marL="306070" indent="-306070"/>
            <a:r>
              <a:rPr lang="en-US" b="1">
                <a:cs typeface="Arial"/>
              </a:rPr>
              <a:t>De-escalation: DESC</a:t>
            </a:r>
          </a:p>
          <a:p>
            <a:pPr marL="628650" lvl="1" indent="-171450">
              <a:spcBef>
                <a:spcPts val="800"/>
              </a:spcBef>
              <a:buFont typeface="Arial,Sans-Serif"/>
              <a:buChar char="•"/>
            </a:pPr>
            <a:r>
              <a:rPr lang="en-US" b="1">
                <a:ea typeface="+mn-lt"/>
                <a:cs typeface="+mn-lt"/>
              </a:rPr>
              <a:t>Describe </a:t>
            </a:r>
            <a:r>
              <a:rPr lang="en-US">
                <a:ea typeface="+mn-lt"/>
                <a:cs typeface="+mn-lt"/>
              </a:rPr>
              <a:t>the specific behavior or situation</a:t>
            </a:r>
          </a:p>
          <a:p>
            <a:pPr marL="628650" lvl="1" indent="-171450">
              <a:spcBef>
                <a:spcPts val="800"/>
              </a:spcBef>
              <a:buFont typeface="Arial,Sans-Serif"/>
              <a:buChar char="•"/>
            </a:pPr>
            <a:r>
              <a:rPr lang="en-US" b="1">
                <a:ea typeface="+mn-lt"/>
                <a:cs typeface="+mn-lt"/>
              </a:rPr>
              <a:t>Express </a:t>
            </a:r>
            <a:r>
              <a:rPr lang="en-US">
                <a:ea typeface="+mn-lt"/>
                <a:cs typeface="+mn-lt"/>
              </a:rPr>
              <a:t>your feelings about the action</a:t>
            </a:r>
          </a:p>
          <a:p>
            <a:pPr marL="628650" lvl="1" indent="-171450">
              <a:spcBef>
                <a:spcPts val="800"/>
              </a:spcBef>
              <a:buFont typeface="Arial,Sans-Serif"/>
              <a:buChar char="•"/>
            </a:pPr>
            <a:r>
              <a:rPr lang="en-US" b="1">
                <a:ea typeface="+mn-lt"/>
                <a:cs typeface="+mn-lt"/>
              </a:rPr>
              <a:t>Specify </a:t>
            </a:r>
            <a:r>
              <a:rPr lang="en-US">
                <a:ea typeface="+mn-lt"/>
                <a:cs typeface="+mn-lt"/>
              </a:rPr>
              <a:t>the behavior you would like to happen</a:t>
            </a:r>
          </a:p>
          <a:p>
            <a:pPr marL="628650" lvl="1" indent="-171450">
              <a:spcBef>
                <a:spcPts val="800"/>
              </a:spcBef>
              <a:buFont typeface="Arial,Sans-Serif"/>
              <a:buChar char="•"/>
            </a:pPr>
            <a:r>
              <a:rPr lang="en-US" b="1">
                <a:ea typeface="+mn-lt"/>
                <a:cs typeface="+mn-lt"/>
              </a:rPr>
              <a:t>Consequences </a:t>
            </a:r>
            <a:r>
              <a:rPr lang="en-US">
                <a:ea typeface="+mn-lt"/>
                <a:cs typeface="+mn-lt"/>
              </a:rPr>
              <a:t>should be specified</a:t>
            </a:r>
          </a:p>
          <a:p>
            <a:pPr marL="326390" indent="-171450">
              <a:spcBef>
                <a:spcPts val="800"/>
              </a:spcBef>
              <a:buFont typeface="Arial,Sans-Serif"/>
              <a:buChar char="•"/>
            </a:pPr>
            <a:endParaRPr lang="en-US" b="1">
              <a:cs typeface="Arial"/>
            </a:endParaRPr>
          </a:p>
          <a:p>
            <a:pPr marL="608965" lvl="1" indent="-308610"/>
            <a:endParaRPr lang="en-US">
              <a:cs typeface="Arial"/>
            </a:endParaRPr>
          </a:p>
          <a:p>
            <a:pPr marL="608965" lvl="1" indent="-308610"/>
            <a:endParaRPr lang="en-US">
              <a:cs typeface="Arial"/>
            </a:endParaRPr>
          </a:p>
        </p:txBody>
      </p:sp>
      <p:sp>
        <p:nvSpPr>
          <p:cNvPr id="7" name="Slide Number Placeholder 6"/>
          <p:cNvSpPr>
            <a:spLocks noGrp="1"/>
          </p:cNvSpPr>
          <p:nvPr>
            <p:ph type="sldNum" sz="quarter" idx="4"/>
          </p:nvPr>
        </p:nvSpPr>
        <p:spPr/>
        <p:txBody>
          <a:bodyPr wrap="square" anchor="ctr">
            <a:normAutofit/>
          </a:bodyPr>
          <a:lstStyle/>
          <a:p>
            <a:pPr>
              <a:spcAft>
                <a:spcPts val="600"/>
              </a:spcAft>
            </a:pPr>
            <a:fld id="{7FEEEA1A-CB49-3744-AA40-B896987410F9}" type="slidenum">
              <a:rPr lang="en-US" smtClean="0"/>
              <a:pPr>
                <a:spcAft>
                  <a:spcPts val="600"/>
                </a:spcAft>
              </a:pPr>
              <a:t>12</a:t>
            </a:fld>
            <a:endParaRPr lang="en-US"/>
          </a:p>
        </p:txBody>
      </p:sp>
      <p:sp>
        <p:nvSpPr>
          <p:cNvPr id="9" name="Title 8"/>
          <p:cNvSpPr>
            <a:spLocks noGrp="1"/>
          </p:cNvSpPr>
          <p:nvPr>
            <p:ph type="title"/>
          </p:nvPr>
        </p:nvSpPr>
        <p:spPr>
          <a:xfrm>
            <a:off x="575732" y="862245"/>
            <a:ext cx="10972803" cy="418576"/>
          </a:xfrm>
        </p:spPr>
        <p:txBody>
          <a:bodyPr anchor="b">
            <a:normAutofit/>
          </a:bodyPr>
          <a:lstStyle/>
          <a:p>
            <a:r>
              <a:rPr lang="en-US" dirty="0"/>
              <a:t>Agitated</a:t>
            </a:r>
            <a:endParaRPr lang="en-US"/>
          </a:p>
        </p:txBody>
      </p:sp>
      <p:graphicFrame>
        <p:nvGraphicFramePr>
          <p:cNvPr id="2" name="Table 2">
            <a:extLst>
              <a:ext uri="{FF2B5EF4-FFF2-40B4-BE49-F238E27FC236}">
                <a16:creationId xmlns:a16="http://schemas.microsoft.com/office/drawing/2014/main" id="{7BFAC94E-FF59-44F7-B6A5-EA842572796B}"/>
              </a:ext>
            </a:extLst>
          </p:cNvPr>
          <p:cNvGraphicFramePr>
            <a:graphicFrameLocks noGrp="1"/>
          </p:cNvGraphicFramePr>
          <p:nvPr>
            <p:extLst>
              <p:ext uri="{D42A27DB-BD31-4B8C-83A1-F6EECF244321}">
                <p14:modId xmlns:p14="http://schemas.microsoft.com/office/powerpoint/2010/main" val="51300142"/>
              </p:ext>
            </p:extLst>
          </p:nvPr>
        </p:nvGraphicFramePr>
        <p:xfrm>
          <a:off x="5985858" y="1039468"/>
          <a:ext cx="5725818" cy="4339061"/>
        </p:xfrm>
        <a:graphic>
          <a:graphicData uri="http://schemas.openxmlformats.org/drawingml/2006/table">
            <a:tbl>
              <a:tblPr firstRow="1" bandRow="1" bandCol="1">
                <a:tableStyleId>{5C22544A-7EE6-4342-B048-85BDC9FD1C3A}</a:tableStyleId>
              </a:tblPr>
              <a:tblGrid>
                <a:gridCol w="2862909">
                  <a:extLst>
                    <a:ext uri="{9D8B030D-6E8A-4147-A177-3AD203B41FA5}">
                      <a16:colId xmlns:a16="http://schemas.microsoft.com/office/drawing/2014/main" val="1632813122"/>
                    </a:ext>
                  </a:extLst>
                </a:gridCol>
                <a:gridCol w="2862909">
                  <a:extLst>
                    <a:ext uri="{9D8B030D-6E8A-4147-A177-3AD203B41FA5}">
                      <a16:colId xmlns:a16="http://schemas.microsoft.com/office/drawing/2014/main" val="1676569126"/>
                    </a:ext>
                  </a:extLst>
                </a:gridCol>
              </a:tblGrid>
              <a:tr h="442485">
                <a:tc>
                  <a:txBody>
                    <a:bodyPr/>
                    <a:lstStyle/>
                    <a:p>
                      <a:pPr lvl="0">
                        <a:buNone/>
                      </a:pPr>
                      <a:r>
                        <a:rPr lang="en-US" sz="2400" b="1" dirty="0">
                          <a:solidFill>
                            <a:srgbClr val="383834"/>
                          </a:solidFill>
                        </a:rPr>
                        <a:t>IF</a:t>
                      </a:r>
                    </a:p>
                  </a:txBody>
                  <a:tcPr>
                    <a:lnL w="12700">
                      <a:solidFill>
                        <a:schemeClr val="tx1"/>
                      </a:solidFill>
                    </a:lnL>
                    <a:lnR w="12700">
                      <a:solidFill>
                        <a:schemeClr val="tx1"/>
                      </a:solidFill>
                    </a:lnR>
                    <a:lnT w="12700">
                      <a:solidFill>
                        <a:schemeClr val="tx1"/>
                      </a:solidFill>
                    </a:lnT>
                    <a:lnB w="12700">
                      <a:solidFill>
                        <a:schemeClr val="tx1"/>
                      </a:solidFill>
                    </a:lnB>
                    <a:noFill/>
                  </a:tcPr>
                </a:tc>
                <a:tc>
                  <a:txBody>
                    <a:bodyPr/>
                    <a:lstStyle/>
                    <a:p>
                      <a:pPr lvl="0">
                        <a:buNone/>
                      </a:pPr>
                      <a:r>
                        <a:rPr lang="en-US" sz="2400" b="1" dirty="0">
                          <a:solidFill>
                            <a:srgbClr val="383834"/>
                          </a:solidFill>
                        </a:rPr>
                        <a:t>THEN</a:t>
                      </a:r>
                    </a:p>
                  </a:txBody>
                  <a:tcPr>
                    <a:lnL w="12700">
                      <a:solidFill>
                        <a:schemeClr val="tx1"/>
                      </a:solidFill>
                    </a:lnL>
                    <a:lnR w="12700">
                      <a:solidFill>
                        <a:schemeClr val="tx1"/>
                      </a:solidFill>
                    </a:lnR>
                    <a:lnT w="12700">
                      <a:solidFill>
                        <a:schemeClr val="tx1"/>
                      </a:solidFill>
                    </a:lnT>
                    <a:lnB w="12700">
                      <a:solidFill>
                        <a:schemeClr val="tx1"/>
                      </a:solidFill>
                    </a:lnB>
                    <a:noFill/>
                  </a:tcPr>
                </a:tc>
                <a:extLst>
                  <a:ext uri="{0D108BD9-81ED-4DB2-BD59-A6C34878D82A}">
                    <a16:rowId xmlns:a16="http://schemas.microsoft.com/office/drawing/2014/main" val="32181981"/>
                  </a:ext>
                </a:extLst>
              </a:tr>
              <a:tr h="1215311">
                <a:tc>
                  <a:txBody>
                    <a:bodyPr/>
                    <a:lstStyle/>
                    <a:p>
                      <a:r>
                        <a:rPr lang="en-US" sz="2000" b="0" dirty="0">
                          <a:solidFill>
                            <a:srgbClr val="383834"/>
                          </a:solidFill>
                        </a:rPr>
                        <a:t>De-escalation techniques are not employed</a:t>
                      </a:r>
                    </a:p>
                  </a:txBody>
                  <a:tcPr>
                    <a:lnL w="12700">
                      <a:solidFill>
                        <a:schemeClr val="tx1"/>
                      </a:solidFill>
                    </a:lnL>
                    <a:lnR w="12700">
                      <a:solidFill>
                        <a:schemeClr val="tx1"/>
                      </a:solidFill>
                    </a:lnR>
                    <a:lnT w="12700">
                      <a:solidFill>
                        <a:schemeClr val="tx1"/>
                      </a:solidFill>
                    </a:lnT>
                    <a:lnB w="12700">
                      <a:solidFill>
                        <a:schemeClr val="tx1"/>
                      </a:solidFill>
                    </a:lnB>
                    <a:solidFill>
                      <a:srgbClr val="FF0000"/>
                    </a:solidFill>
                  </a:tcPr>
                </a:tc>
                <a:tc>
                  <a:txBody>
                    <a:bodyPr/>
                    <a:lstStyle/>
                    <a:p>
                      <a:r>
                        <a:rPr lang="en-US" sz="2000" b="0" dirty="0">
                          <a:solidFill>
                            <a:srgbClr val="383834"/>
                          </a:solidFill>
                        </a:rPr>
                        <a:t>Agitation level increases 7</a:t>
                      </a:r>
                      <a:r>
                        <a:rPr lang="en-US" sz="2000" b="0" dirty="0">
                          <a:solidFill>
                            <a:srgbClr val="002060"/>
                          </a:solidFill>
                        </a:rPr>
                        <a:t> </a:t>
                      </a:r>
                      <a:r>
                        <a:rPr lang="en-US" sz="2000" b="0" i="0" u="none" strike="noStrike" noProof="0" dirty="0">
                          <a:solidFill>
                            <a:srgbClr val="002060"/>
                          </a:solidFill>
                          <a:latin typeface="Arial"/>
                        </a:rPr>
                        <a:t>→ 10</a:t>
                      </a:r>
                      <a:endParaRPr lang="en-US" sz="2000" b="0" dirty="0">
                        <a:solidFill>
                          <a:srgbClr val="002060"/>
                        </a:solidFill>
                      </a:endParaRPr>
                    </a:p>
                  </a:txBody>
                  <a:tcPr>
                    <a:lnL w="12700">
                      <a:solidFill>
                        <a:schemeClr val="tx1"/>
                      </a:solidFill>
                    </a:lnL>
                    <a:lnR w="12700">
                      <a:solidFill>
                        <a:schemeClr val="tx1"/>
                      </a:solidFill>
                    </a:lnR>
                    <a:lnT w="12700">
                      <a:solidFill>
                        <a:schemeClr val="tx1"/>
                      </a:solidFill>
                    </a:lnT>
                    <a:lnB w="12700">
                      <a:solidFill>
                        <a:schemeClr val="tx1"/>
                      </a:solidFill>
                    </a:lnB>
                    <a:solidFill>
                      <a:srgbClr val="FF0000"/>
                    </a:solidFill>
                  </a:tcPr>
                </a:tc>
                <a:extLst>
                  <a:ext uri="{0D108BD9-81ED-4DB2-BD59-A6C34878D82A}">
                    <a16:rowId xmlns:a16="http://schemas.microsoft.com/office/drawing/2014/main" val="3095189828"/>
                  </a:ext>
                </a:extLst>
              </a:tr>
              <a:tr h="1234294">
                <a:tc>
                  <a:txBody>
                    <a:bodyPr/>
                    <a:lstStyle/>
                    <a:p>
                      <a:r>
                        <a:rPr lang="en-US" sz="2000" b="0" dirty="0">
                          <a:solidFill>
                            <a:srgbClr val="383834"/>
                          </a:solidFill>
                        </a:rPr>
                        <a:t>De-escalation techniques are partly employed</a:t>
                      </a:r>
                    </a:p>
                  </a:txBody>
                  <a:tcPr>
                    <a:lnL w="12700">
                      <a:solidFill>
                        <a:schemeClr val="tx1"/>
                      </a:solidFill>
                    </a:lnL>
                    <a:lnR w="12700">
                      <a:solidFill>
                        <a:schemeClr val="tx1"/>
                      </a:solidFill>
                    </a:lnR>
                    <a:lnT w="12700">
                      <a:solidFill>
                        <a:schemeClr val="tx1"/>
                      </a:solidFill>
                    </a:lnT>
                    <a:lnB w="12700">
                      <a:solidFill>
                        <a:schemeClr val="tx1"/>
                      </a:solidFill>
                    </a:lnB>
                    <a:solidFill>
                      <a:srgbClr val="FFFF00"/>
                    </a:solidFill>
                  </a:tcPr>
                </a:tc>
                <a:tc>
                  <a:txBody>
                    <a:bodyPr/>
                    <a:lstStyle/>
                    <a:p>
                      <a:r>
                        <a:rPr lang="en-US" sz="2000" b="0" dirty="0">
                          <a:solidFill>
                            <a:srgbClr val="383834"/>
                          </a:solidFill>
                        </a:rPr>
                        <a:t>Agitation level stays the same </a:t>
                      </a:r>
                      <a:r>
                        <a:rPr lang="en-US" sz="2000" b="0" i="0" u="none" strike="noStrike" noProof="0" dirty="0">
                          <a:solidFill>
                            <a:srgbClr val="383834"/>
                          </a:solidFill>
                          <a:latin typeface="Arial"/>
                        </a:rPr>
                        <a:t>7</a:t>
                      </a:r>
                      <a:r>
                        <a:rPr lang="en-US" sz="2000" b="0" i="0" u="none" strike="noStrike" noProof="0" dirty="0">
                          <a:solidFill>
                            <a:srgbClr val="002060"/>
                          </a:solidFill>
                          <a:latin typeface="Arial"/>
                        </a:rPr>
                        <a:t> → 7</a:t>
                      </a:r>
                      <a:endParaRPr lang="en-US" sz="2000" b="0" dirty="0">
                        <a:solidFill>
                          <a:srgbClr val="383834"/>
                        </a:solidFill>
                      </a:endParaRPr>
                    </a:p>
                  </a:txBody>
                  <a:tcPr>
                    <a:lnL w="12700">
                      <a:solidFill>
                        <a:schemeClr val="tx1"/>
                      </a:solidFill>
                    </a:lnL>
                    <a:lnR w="12700">
                      <a:solidFill>
                        <a:schemeClr val="tx1"/>
                      </a:solidFill>
                    </a:lnR>
                    <a:lnT w="12700">
                      <a:solidFill>
                        <a:schemeClr val="tx1"/>
                      </a:solidFill>
                    </a:lnT>
                    <a:lnB w="12700">
                      <a:solidFill>
                        <a:schemeClr val="tx1"/>
                      </a:solidFill>
                    </a:lnB>
                    <a:solidFill>
                      <a:srgbClr val="FFFF00"/>
                    </a:solidFill>
                  </a:tcPr>
                </a:tc>
                <a:extLst>
                  <a:ext uri="{0D108BD9-81ED-4DB2-BD59-A6C34878D82A}">
                    <a16:rowId xmlns:a16="http://schemas.microsoft.com/office/drawing/2014/main" val="1558888817"/>
                  </a:ext>
                </a:extLst>
              </a:tr>
              <a:tr h="1432256">
                <a:tc>
                  <a:txBody>
                    <a:bodyPr/>
                    <a:lstStyle/>
                    <a:p>
                      <a:r>
                        <a:rPr lang="en-US" sz="2000" b="0" dirty="0">
                          <a:solidFill>
                            <a:srgbClr val="383834"/>
                          </a:solidFill>
                        </a:rPr>
                        <a:t>De-escalation techniques are sufficiently employed</a:t>
                      </a:r>
                    </a:p>
                  </a:txBody>
                  <a:tcPr>
                    <a:lnL w="12700">
                      <a:solidFill>
                        <a:schemeClr val="tx1"/>
                      </a:solidFill>
                    </a:lnL>
                    <a:lnR w="12700">
                      <a:solidFill>
                        <a:schemeClr val="tx1"/>
                      </a:solidFill>
                    </a:lnR>
                    <a:lnT w="12700">
                      <a:solidFill>
                        <a:schemeClr val="tx1"/>
                      </a:solidFill>
                    </a:lnT>
                    <a:lnB w="12700">
                      <a:solidFill>
                        <a:schemeClr val="tx1"/>
                      </a:solidFill>
                    </a:lnB>
                    <a:solidFill>
                      <a:srgbClr val="00B050"/>
                    </a:solidFill>
                  </a:tcPr>
                </a:tc>
                <a:tc>
                  <a:txBody>
                    <a:bodyPr/>
                    <a:lstStyle/>
                    <a:p>
                      <a:pPr lvl="0">
                        <a:buNone/>
                      </a:pPr>
                      <a:r>
                        <a:rPr lang="en-US" sz="2000" b="0" i="0" u="none" strike="noStrike" noProof="0" dirty="0">
                          <a:solidFill>
                            <a:srgbClr val="383834"/>
                          </a:solidFill>
                          <a:latin typeface="Arial"/>
                        </a:rPr>
                        <a:t>Agitation level decreases 7</a:t>
                      </a:r>
                      <a:r>
                        <a:rPr lang="en-US" sz="2000" b="0" i="0" u="none" strike="noStrike" noProof="0" dirty="0">
                          <a:solidFill>
                            <a:srgbClr val="002060"/>
                          </a:solidFill>
                          <a:latin typeface="Arial"/>
                        </a:rPr>
                        <a:t> → 4</a:t>
                      </a:r>
                      <a:endParaRPr lang="en-US" sz="2000" b="0" dirty="0">
                        <a:solidFill>
                          <a:srgbClr val="383834"/>
                        </a:solidFill>
                      </a:endParaRPr>
                    </a:p>
                  </a:txBody>
                  <a:tcPr>
                    <a:lnL w="12700">
                      <a:solidFill>
                        <a:schemeClr val="tx1"/>
                      </a:solidFill>
                    </a:lnL>
                    <a:lnR w="12700">
                      <a:solidFill>
                        <a:schemeClr val="tx1"/>
                      </a:solidFill>
                    </a:lnR>
                    <a:lnT w="12700">
                      <a:solidFill>
                        <a:schemeClr val="tx1"/>
                      </a:solidFill>
                    </a:lnT>
                    <a:lnB w="12700">
                      <a:solidFill>
                        <a:schemeClr val="tx1"/>
                      </a:solidFill>
                    </a:lnB>
                    <a:solidFill>
                      <a:srgbClr val="00B050"/>
                    </a:solidFill>
                  </a:tcPr>
                </a:tc>
                <a:extLst>
                  <a:ext uri="{0D108BD9-81ED-4DB2-BD59-A6C34878D82A}">
                    <a16:rowId xmlns:a16="http://schemas.microsoft.com/office/drawing/2014/main" val="3043834941"/>
                  </a:ext>
                </a:extLst>
              </a:tr>
            </a:tbl>
          </a:graphicData>
        </a:graphic>
      </p:graphicFrame>
    </p:spTree>
    <p:extLst>
      <p:ext uri="{BB962C8B-B14F-4D97-AF65-F5344CB8AC3E}">
        <p14:creationId xmlns:p14="http://schemas.microsoft.com/office/powerpoint/2010/main" val="2960214513"/>
      </p:ext>
    </p:extLst>
  </p:cSld>
  <p:clrMapOvr>
    <a:masterClrMapping/>
  </p:clrMapOvr>
  <mc:AlternateContent xmlns:mc="http://schemas.openxmlformats.org/markup-compatibility/2006" xmlns:p14="http://schemas.microsoft.com/office/powerpoint/2010/main">
    <mc:Choice Requires="p14">
      <p:transition spd="slow" p14:dur="2000" advTm="27047"/>
    </mc:Choice>
    <mc:Fallback xmlns="">
      <p:transition spd="slow" advTm="27047"/>
    </mc:Fallback>
  </mc:AlternateContent>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Content Placeholder 13"/>
          <p:cNvSpPr>
            <a:spLocks noGrp="1"/>
          </p:cNvSpPr>
          <p:nvPr>
            <p:ph sz="half" idx="1"/>
          </p:nvPr>
        </p:nvSpPr>
        <p:spPr>
          <a:xfrm>
            <a:off x="440267" y="1780032"/>
            <a:ext cx="3623733" cy="4036568"/>
          </a:xfrm>
        </p:spPr>
        <p:txBody>
          <a:bodyPr vert="horz" lIns="0" tIns="0" rIns="0" bIns="0" rtlCol="0" anchor="t">
            <a:normAutofit/>
          </a:bodyPr>
          <a:lstStyle/>
          <a:p>
            <a:pPr marL="306070" indent="-306070"/>
            <a:r>
              <a:rPr lang="en-US" b="1"/>
              <a:t>Example Behaviors</a:t>
            </a:r>
            <a:endParaRPr lang="en-US" b="1">
              <a:cs typeface="Arial"/>
            </a:endParaRPr>
          </a:p>
          <a:p>
            <a:pPr marL="608965" lvl="1" indent="-308610"/>
            <a:r>
              <a:rPr lang="en-US">
                <a:cs typeface="Arial"/>
              </a:rPr>
              <a:t>Verbalizing anxiety (e.g., "Oh, gosh, I'm so worried!”)</a:t>
            </a:r>
            <a:endParaRPr lang="en-US">
              <a:ea typeface="+mn-lt"/>
              <a:cs typeface="+mn-lt"/>
            </a:endParaRPr>
          </a:p>
          <a:p>
            <a:pPr marL="608965" lvl="1" indent="-308610"/>
            <a:r>
              <a:rPr lang="en-US">
                <a:cs typeface="Arial"/>
              </a:rPr>
              <a:t>Speaking quickly</a:t>
            </a:r>
            <a:endParaRPr lang="en-US"/>
          </a:p>
          <a:p>
            <a:pPr marL="608965" lvl="1" indent="-308610"/>
            <a:r>
              <a:rPr lang="en-US">
                <a:ea typeface="+mn-lt"/>
                <a:cs typeface="+mn-lt"/>
              </a:rPr>
              <a:t>Hand-wringing</a:t>
            </a:r>
          </a:p>
          <a:p>
            <a:pPr marL="608965" lvl="1" indent="-308610"/>
            <a:r>
              <a:rPr lang="en-US">
                <a:ea typeface="+mn-lt"/>
                <a:cs typeface="+mn-lt"/>
              </a:rPr>
              <a:t>Asking many questions, including prognosis (e.g., "Is he going to die?")</a:t>
            </a:r>
          </a:p>
          <a:p>
            <a:pPr marL="608965" lvl="1" indent="-308610"/>
            <a:r>
              <a:rPr lang="en-US">
                <a:ea typeface="+mn-lt"/>
                <a:cs typeface="+mn-lt"/>
              </a:rPr>
              <a:t>Pacing/ rocking</a:t>
            </a:r>
          </a:p>
          <a:p>
            <a:pPr marL="608965" lvl="1" indent="-308610"/>
            <a:r>
              <a:rPr lang="en-US">
                <a:cs typeface="Arial"/>
              </a:rPr>
              <a:t>Hyperventilating</a:t>
            </a:r>
          </a:p>
          <a:p>
            <a:pPr marL="608965" lvl="1" indent="-308610"/>
            <a:endParaRPr lang="en-US">
              <a:cs typeface="Arial"/>
            </a:endParaRPr>
          </a:p>
          <a:p>
            <a:pPr marL="306070" indent="-306070"/>
            <a:endParaRPr lang="en-US" b="1">
              <a:cs typeface="Arial"/>
            </a:endParaRPr>
          </a:p>
          <a:p>
            <a:pPr marL="306070" indent="-306070"/>
            <a:endParaRPr lang="en-US">
              <a:cs typeface="Arial"/>
            </a:endParaRPr>
          </a:p>
        </p:txBody>
      </p:sp>
      <p:sp>
        <p:nvSpPr>
          <p:cNvPr id="7" name="Slide Number Placeholder 6"/>
          <p:cNvSpPr>
            <a:spLocks noGrp="1"/>
          </p:cNvSpPr>
          <p:nvPr>
            <p:ph type="sldNum" sz="quarter" idx="4"/>
          </p:nvPr>
        </p:nvSpPr>
        <p:spPr/>
        <p:txBody>
          <a:bodyPr wrap="square" anchor="ctr">
            <a:normAutofit/>
          </a:bodyPr>
          <a:lstStyle/>
          <a:p>
            <a:pPr>
              <a:spcAft>
                <a:spcPts val="600"/>
              </a:spcAft>
            </a:pPr>
            <a:fld id="{7FEEEA1A-CB49-3744-AA40-B896987410F9}" type="slidenum">
              <a:rPr lang="en-US" smtClean="0"/>
              <a:pPr>
                <a:spcAft>
                  <a:spcPts val="600"/>
                </a:spcAft>
              </a:pPr>
              <a:t>13</a:t>
            </a:fld>
            <a:endParaRPr lang="en-US"/>
          </a:p>
        </p:txBody>
      </p:sp>
      <p:sp>
        <p:nvSpPr>
          <p:cNvPr id="9" name="Title 8"/>
          <p:cNvSpPr>
            <a:spLocks noGrp="1"/>
          </p:cNvSpPr>
          <p:nvPr>
            <p:ph type="title"/>
          </p:nvPr>
        </p:nvSpPr>
        <p:spPr/>
        <p:txBody>
          <a:bodyPr anchor="b">
            <a:normAutofit/>
          </a:bodyPr>
          <a:lstStyle/>
          <a:p>
            <a:r>
              <a:rPr lang="en-US"/>
              <a:t>Anxious</a:t>
            </a:r>
          </a:p>
        </p:txBody>
      </p:sp>
      <p:graphicFrame>
        <p:nvGraphicFramePr>
          <p:cNvPr id="4" name="Table 2">
            <a:extLst>
              <a:ext uri="{FF2B5EF4-FFF2-40B4-BE49-F238E27FC236}">
                <a16:creationId xmlns:a16="http://schemas.microsoft.com/office/drawing/2014/main" id="{A71E2988-A0E3-49A6-BED7-AC0E73D645D2}"/>
              </a:ext>
            </a:extLst>
          </p:cNvPr>
          <p:cNvGraphicFramePr>
            <a:graphicFrameLocks noGrp="1"/>
          </p:cNvGraphicFramePr>
          <p:nvPr>
            <p:extLst>
              <p:ext uri="{D42A27DB-BD31-4B8C-83A1-F6EECF244321}">
                <p14:modId xmlns:p14="http://schemas.microsoft.com/office/powerpoint/2010/main" val="881347193"/>
              </p:ext>
            </p:extLst>
          </p:nvPr>
        </p:nvGraphicFramePr>
        <p:xfrm>
          <a:off x="5189620" y="2196431"/>
          <a:ext cx="6102565" cy="2516334"/>
        </p:xfrm>
        <a:graphic>
          <a:graphicData uri="http://schemas.openxmlformats.org/drawingml/2006/table">
            <a:tbl>
              <a:tblPr firstRow="1" bandRow="1" bandCol="1">
                <a:tableStyleId>{5C22544A-7EE6-4342-B048-85BDC9FD1C3A}</a:tableStyleId>
              </a:tblPr>
              <a:tblGrid>
                <a:gridCol w="3487942">
                  <a:extLst>
                    <a:ext uri="{9D8B030D-6E8A-4147-A177-3AD203B41FA5}">
                      <a16:colId xmlns:a16="http://schemas.microsoft.com/office/drawing/2014/main" val="1632813122"/>
                    </a:ext>
                  </a:extLst>
                </a:gridCol>
                <a:gridCol w="2614623">
                  <a:extLst>
                    <a:ext uri="{9D8B030D-6E8A-4147-A177-3AD203B41FA5}">
                      <a16:colId xmlns:a16="http://schemas.microsoft.com/office/drawing/2014/main" val="1676569126"/>
                    </a:ext>
                  </a:extLst>
                </a:gridCol>
              </a:tblGrid>
              <a:tr h="328257">
                <a:tc>
                  <a:txBody>
                    <a:bodyPr/>
                    <a:lstStyle/>
                    <a:p>
                      <a:pPr lvl="0">
                        <a:buNone/>
                      </a:pPr>
                      <a:r>
                        <a:rPr lang="en-US" sz="2400" b="1" dirty="0">
                          <a:solidFill>
                            <a:srgbClr val="383834"/>
                          </a:solidFill>
                        </a:rPr>
                        <a:t>IF</a:t>
                      </a:r>
                    </a:p>
                  </a:txBody>
                  <a:tcPr>
                    <a:lnL w="12700">
                      <a:solidFill>
                        <a:schemeClr val="tx1"/>
                      </a:solidFill>
                    </a:lnL>
                    <a:lnR w="12700">
                      <a:solidFill>
                        <a:schemeClr val="tx1"/>
                      </a:solidFill>
                    </a:lnR>
                    <a:lnT w="12700">
                      <a:solidFill>
                        <a:schemeClr val="tx1"/>
                      </a:solidFill>
                    </a:lnT>
                    <a:lnB w="12700">
                      <a:solidFill>
                        <a:schemeClr val="tx1"/>
                      </a:solidFill>
                    </a:lnB>
                    <a:noFill/>
                  </a:tcPr>
                </a:tc>
                <a:tc>
                  <a:txBody>
                    <a:bodyPr/>
                    <a:lstStyle/>
                    <a:p>
                      <a:pPr lvl="0">
                        <a:buNone/>
                      </a:pPr>
                      <a:r>
                        <a:rPr lang="en-US" sz="2400" b="1" dirty="0">
                          <a:solidFill>
                            <a:srgbClr val="383834"/>
                          </a:solidFill>
                        </a:rPr>
                        <a:t>THEN</a:t>
                      </a:r>
                    </a:p>
                  </a:txBody>
                  <a:tcPr>
                    <a:lnL w="12700">
                      <a:solidFill>
                        <a:schemeClr val="tx1"/>
                      </a:solidFill>
                    </a:lnL>
                    <a:lnR w="12700">
                      <a:solidFill>
                        <a:schemeClr val="tx1"/>
                      </a:solidFill>
                    </a:lnR>
                    <a:lnT w="12700">
                      <a:solidFill>
                        <a:schemeClr val="tx1"/>
                      </a:solidFill>
                    </a:lnT>
                    <a:lnB w="12700">
                      <a:solidFill>
                        <a:schemeClr val="tx1"/>
                      </a:solidFill>
                    </a:lnB>
                    <a:noFill/>
                  </a:tcPr>
                </a:tc>
                <a:extLst>
                  <a:ext uri="{0D108BD9-81ED-4DB2-BD59-A6C34878D82A}">
                    <a16:rowId xmlns:a16="http://schemas.microsoft.com/office/drawing/2014/main" val="32181981"/>
                  </a:ext>
                </a:extLst>
              </a:tr>
              <a:tr h="1008708">
                <a:tc>
                  <a:txBody>
                    <a:bodyPr/>
                    <a:lstStyle/>
                    <a:p>
                      <a:r>
                        <a:rPr lang="en-US" sz="2000" b="0" dirty="0">
                          <a:solidFill>
                            <a:srgbClr val="383834"/>
                          </a:solidFill>
                        </a:rPr>
                        <a:t>Information is speculative, not sensitive, or judgmental</a:t>
                      </a:r>
                    </a:p>
                  </a:txBody>
                  <a:tcPr>
                    <a:lnL w="12700">
                      <a:solidFill>
                        <a:schemeClr val="tx1"/>
                      </a:solidFill>
                    </a:lnL>
                    <a:lnR w="12700">
                      <a:solidFill>
                        <a:schemeClr val="tx1"/>
                      </a:solidFill>
                    </a:lnR>
                    <a:lnT w="12700">
                      <a:solidFill>
                        <a:schemeClr val="tx1"/>
                      </a:solidFill>
                    </a:lnT>
                    <a:lnB w="12700">
                      <a:solidFill>
                        <a:schemeClr val="tx1"/>
                      </a:solidFill>
                    </a:lnB>
                    <a:solidFill>
                      <a:srgbClr val="FF0000"/>
                    </a:solidFill>
                  </a:tcPr>
                </a:tc>
                <a:tc>
                  <a:txBody>
                    <a:bodyPr/>
                    <a:lstStyle/>
                    <a:p>
                      <a:r>
                        <a:rPr lang="en-US" sz="2000" b="0" dirty="0">
                          <a:solidFill>
                            <a:srgbClr val="383834"/>
                          </a:solidFill>
                        </a:rPr>
                        <a:t>Anxiety level increases </a:t>
                      </a:r>
                      <a:r>
                        <a:rPr lang="en-US" sz="2000" b="0" i="0" u="none" strike="noStrike" noProof="0" dirty="0">
                          <a:solidFill>
                            <a:srgbClr val="383834"/>
                          </a:solidFill>
                          <a:latin typeface="Arial"/>
                        </a:rPr>
                        <a:t>7 → 10</a:t>
                      </a:r>
                    </a:p>
                  </a:txBody>
                  <a:tcPr>
                    <a:lnL w="12700">
                      <a:solidFill>
                        <a:schemeClr val="tx1"/>
                      </a:solidFill>
                    </a:lnL>
                    <a:lnR w="12700">
                      <a:solidFill>
                        <a:schemeClr val="tx1"/>
                      </a:solidFill>
                    </a:lnR>
                    <a:lnT w="12700">
                      <a:solidFill>
                        <a:schemeClr val="tx1"/>
                      </a:solidFill>
                    </a:lnT>
                    <a:lnB w="12700">
                      <a:solidFill>
                        <a:schemeClr val="tx1"/>
                      </a:solidFill>
                    </a:lnB>
                    <a:solidFill>
                      <a:srgbClr val="FF0000"/>
                    </a:solidFill>
                  </a:tcPr>
                </a:tc>
                <a:extLst>
                  <a:ext uri="{0D108BD9-81ED-4DB2-BD59-A6C34878D82A}">
                    <a16:rowId xmlns:a16="http://schemas.microsoft.com/office/drawing/2014/main" val="3095189828"/>
                  </a:ext>
                </a:extLst>
              </a:tr>
              <a:tr h="1050426">
                <a:tc>
                  <a:txBody>
                    <a:bodyPr/>
                    <a:lstStyle/>
                    <a:p>
                      <a:r>
                        <a:rPr lang="en-US" sz="2000" b="0" dirty="0">
                          <a:solidFill>
                            <a:srgbClr val="383834"/>
                          </a:solidFill>
                        </a:rPr>
                        <a:t>Information is non-judgmental, fact-based, and sensitive</a:t>
                      </a:r>
                    </a:p>
                  </a:txBody>
                  <a:tcPr>
                    <a:lnL w="12700">
                      <a:solidFill>
                        <a:schemeClr val="tx1"/>
                      </a:solid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a:solidFill>
                        <a:schemeClr val="tx1"/>
                      </a:solidFill>
                    </a:lnB>
                    <a:solidFill>
                      <a:srgbClr val="00B050"/>
                    </a:solidFill>
                  </a:tcPr>
                </a:tc>
                <a:tc>
                  <a:txBody>
                    <a:bodyPr/>
                    <a:lstStyle/>
                    <a:p>
                      <a:r>
                        <a:rPr lang="en-US" sz="2000" b="0" dirty="0">
                          <a:solidFill>
                            <a:srgbClr val="383834"/>
                          </a:solidFill>
                        </a:rPr>
                        <a:t>Anxiety level decreases </a:t>
                      </a:r>
                      <a:r>
                        <a:rPr lang="en-US" sz="2000" b="0" i="0" u="none" strike="noStrike" noProof="0" dirty="0">
                          <a:solidFill>
                            <a:srgbClr val="383834"/>
                          </a:solidFill>
                          <a:latin typeface="Arial"/>
                        </a:rPr>
                        <a:t>7</a:t>
                      </a:r>
                      <a:r>
                        <a:rPr lang="en-US" sz="2000" b="0" i="0" u="none" strike="noStrike" noProof="0" dirty="0">
                          <a:solidFill>
                            <a:srgbClr val="002060"/>
                          </a:solidFill>
                          <a:latin typeface="Arial"/>
                        </a:rPr>
                        <a:t> → 4</a:t>
                      </a:r>
                      <a:endParaRPr lang="en-US" sz="2000" b="0" dirty="0">
                        <a:solidFill>
                          <a:srgbClr val="383834"/>
                        </a:solidFill>
                      </a:endParaRPr>
                    </a:p>
                  </a:txBody>
                  <a:tcPr>
                    <a:lnL w="12700" cap="flat" cmpd="sng" algn="ctr">
                      <a:solidFill>
                        <a:schemeClr val="tx1"/>
                      </a:solidFill>
                      <a:prstDash val="solid"/>
                      <a:round/>
                      <a:headEnd type="none" w="med" len="med"/>
                      <a:tailEnd type="none" w="med" len="med"/>
                    </a:lnL>
                    <a:lnR w="12700">
                      <a:solidFill>
                        <a:schemeClr val="tx1"/>
                      </a:solidFill>
                    </a:lnR>
                    <a:lnT w="12700" cap="flat" cmpd="sng" algn="ctr">
                      <a:solidFill>
                        <a:schemeClr val="tx1"/>
                      </a:solidFill>
                      <a:prstDash val="solid"/>
                      <a:round/>
                      <a:headEnd type="none" w="med" len="med"/>
                      <a:tailEnd type="none" w="med" len="med"/>
                    </a:lnT>
                    <a:lnB w="12700">
                      <a:solidFill>
                        <a:schemeClr val="tx1"/>
                      </a:solidFill>
                    </a:lnB>
                    <a:solidFill>
                      <a:srgbClr val="00B050"/>
                    </a:solidFill>
                  </a:tcPr>
                </a:tc>
                <a:extLst>
                  <a:ext uri="{0D108BD9-81ED-4DB2-BD59-A6C34878D82A}">
                    <a16:rowId xmlns:a16="http://schemas.microsoft.com/office/drawing/2014/main" val="3043834941"/>
                  </a:ext>
                </a:extLst>
              </a:tr>
            </a:tbl>
          </a:graphicData>
        </a:graphic>
      </p:graphicFrame>
    </p:spTree>
    <p:extLst>
      <p:ext uri="{BB962C8B-B14F-4D97-AF65-F5344CB8AC3E}">
        <p14:creationId xmlns:p14="http://schemas.microsoft.com/office/powerpoint/2010/main" val="1237955407"/>
      </p:ext>
    </p:extLst>
  </p:cSld>
  <p:clrMapOvr>
    <a:masterClrMapping/>
  </p:clrMapOvr>
  <mc:AlternateContent xmlns:mc="http://schemas.openxmlformats.org/markup-compatibility/2006" xmlns:p14="http://schemas.microsoft.com/office/powerpoint/2010/main">
    <mc:Choice Requires="p14">
      <p:transition spd="slow" p14:dur="2000" advTm="27047"/>
    </mc:Choice>
    <mc:Fallback xmlns="">
      <p:transition spd="slow" advTm="27047"/>
    </mc:Fallback>
  </mc:AlternateContent>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Content Placeholder 13"/>
          <p:cNvSpPr>
            <a:spLocks noGrp="1"/>
          </p:cNvSpPr>
          <p:nvPr>
            <p:ph sz="half" idx="1"/>
          </p:nvPr>
        </p:nvSpPr>
        <p:spPr>
          <a:xfrm>
            <a:off x="609600" y="1780032"/>
            <a:ext cx="3251200" cy="4036568"/>
          </a:xfrm>
        </p:spPr>
        <p:txBody>
          <a:bodyPr vert="horz" lIns="0" tIns="0" rIns="0" bIns="0" rtlCol="0" anchor="t">
            <a:normAutofit/>
          </a:bodyPr>
          <a:lstStyle/>
          <a:p>
            <a:pPr marL="306070" indent="-306070"/>
            <a:r>
              <a:rPr lang="en-US" b="1"/>
              <a:t>Example Behaviors</a:t>
            </a:r>
          </a:p>
          <a:p>
            <a:pPr marL="608965" lvl="1" indent="-308610"/>
            <a:r>
              <a:rPr lang="en-US">
                <a:cs typeface="Arial"/>
              </a:rPr>
              <a:t>Avoidance of eye contact</a:t>
            </a:r>
          </a:p>
          <a:p>
            <a:pPr marL="608965" lvl="1" indent="-308610"/>
            <a:r>
              <a:rPr lang="en-US">
                <a:cs typeface="Arial"/>
              </a:rPr>
              <a:t>Staring blankly</a:t>
            </a:r>
          </a:p>
          <a:p>
            <a:pPr marL="608965" lvl="1" indent="-308610"/>
            <a:r>
              <a:rPr lang="en-US">
                <a:cs typeface="Arial"/>
              </a:rPr>
              <a:t>Closed/ frozen posture</a:t>
            </a:r>
          </a:p>
          <a:p>
            <a:pPr marL="608965" lvl="1" indent="-308610"/>
            <a:endParaRPr lang="en-US">
              <a:cs typeface="Arial"/>
            </a:endParaRPr>
          </a:p>
          <a:p>
            <a:pPr marL="300355" lvl="1" indent="0">
              <a:buNone/>
            </a:pPr>
            <a:endParaRPr lang="en-US">
              <a:cs typeface="Arial"/>
            </a:endParaRPr>
          </a:p>
          <a:p>
            <a:pPr marL="608965" lvl="1" indent="-308610"/>
            <a:endParaRPr lang="en-US">
              <a:cs typeface="Arial"/>
            </a:endParaRPr>
          </a:p>
          <a:p>
            <a:pPr marL="306070" indent="-306070"/>
            <a:endParaRPr lang="en-US">
              <a:cs typeface="Arial"/>
            </a:endParaRPr>
          </a:p>
          <a:p>
            <a:pPr marL="306070" indent="-306070"/>
            <a:endParaRPr lang="en-US">
              <a:cs typeface="Arial"/>
            </a:endParaRPr>
          </a:p>
        </p:txBody>
      </p:sp>
      <p:sp>
        <p:nvSpPr>
          <p:cNvPr id="7" name="Slide Number Placeholder 6"/>
          <p:cNvSpPr>
            <a:spLocks noGrp="1"/>
          </p:cNvSpPr>
          <p:nvPr>
            <p:ph type="sldNum" sz="quarter" idx="4"/>
          </p:nvPr>
        </p:nvSpPr>
        <p:spPr/>
        <p:txBody>
          <a:bodyPr wrap="square" anchor="ctr">
            <a:normAutofit/>
          </a:bodyPr>
          <a:lstStyle/>
          <a:p>
            <a:pPr>
              <a:spcAft>
                <a:spcPts val="600"/>
              </a:spcAft>
            </a:pPr>
            <a:fld id="{7FEEEA1A-CB49-3744-AA40-B896987410F9}" type="slidenum">
              <a:rPr lang="en-US" smtClean="0"/>
              <a:pPr>
                <a:spcAft>
                  <a:spcPts val="600"/>
                </a:spcAft>
              </a:pPr>
              <a:t>14</a:t>
            </a:fld>
            <a:endParaRPr lang="en-US"/>
          </a:p>
        </p:txBody>
      </p:sp>
      <p:sp>
        <p:nvSpPr>
          <p:cNvPr id="9" name="Title 8"/>
          <p:cNvSpPr>
            <a:spLocks noGrp="1"/>
          </p:cNvSpPr>
          <p:nvPr>
            <p:ph type="title"/>
          </p:nvPr>
        </p:nvSpPr>
        <p:spPr/>
        <p:txBody>
          <a:bodyPr anchor="b">
            <a:normAutofit/>
          </a:bodyPr>
          <a:lstStyle/>
          <a:p>
            <a:r>
              <a:rPr lang="en-US"/>
              <a:t>Quiet</a:t>
            </a:r>
          </a:p>
        </p:txBody>
      </p:sp>
      <p:graphicFrame>
        <p:nvGraphicFramePr>
          <p:cNvPr id="2" name="Table 2">
            <a:extLst>
              <a:ext uri="{FF2B5EF4-FFF2-40B4-BE49-F238E27FC236}">
                <a16:creationId xmlns:a16="http://schemas.microsoft.com/office/drawing/2014/main" id="{AE213307-9C46-468C-91D5-4DA5D7112706}"/>
              </a:ext>
            </a:extLst>
          </p:cNvPr>
          <p:cNvGraphicFramePr>
            <a:graphicFrameLocks noGrp="1"/>
          </p:cNvGraphicFramePr>
          <p:nvPr>
            <p:extLst>
              <p:ext uri="{D42A27DB-BD31-4B8C-83A1-F6EECF244321}">
                <p14:modId xmlns:p14="http://schemas.microsoft.com/office/powerpoint/2010/main" val="3146205810"/>
              </p:ext>
            </p:extLst>
          </p:nvPr>
        </p:nvGraphicFramePr>
        <p:xfrm>
          <a:off x="4311316" y="1486567"/>
          <a:ext cx="7135673" cy="3415923"/>
        </p:xfrm>
        <a:graphic>
          <a:graphicData uri="http://schemas.openxmlformats.org/drawingml/2006/table">
            <a:tbl>
              <a:tblPr firstRow="1" bandRow="1" bandCol="1">
                <a:tableStyleId>{5C22544A-7EE6-4342-B048-85BDC9FD1C3A}</a:tableStyleId>
              </a:tblPr>
              <a:tblGrid>
                <a:gridCol w="4460191">
                  <a:extLst>
                    <a:ext uri="{9D8B030D-6E8A-4147-A177-3AD203B41FA5}">
                      <a16:colId xmlns:a16="http://schemas.microsoft.com/office/drawing/2014/main" val="1632813122"/>
                    </a:ext>
                  </a:extLst>
                </a:gridCol>
                <a:gridCol w="2675482">
                  <a:extLst>
                    <a:ext uri="{9D8B030D-6E8A-4147-A177-3AD203B41FA5}">
                      <a16:colId xmlns:a16="http://schemas.microsoft.com/office/drawing/2014/main" val="1676569126"/>
                    </a:ext>
                  </a:extLst>
                </a:gridCol>
              </a:tblGrid>
              <a:tr h="395042">
                <a:tc>
                  <a:txBody>
                    <a:bodyPr/>
                    <a:lstStyle/>
                    <a:p>
                      <a:pPr lvl="0">
                        <a:buNone/>
                      </a:pPr>
                      <a:r>
                        <a:rPr lang="en-US" sz="2400" b="1" dirty="0">
                          <a:solidFill>
                            <a:srgbClr val="383834"/>
                          </a:solidFill>
                        </a:rPr>
                        <a:t>IF</a:t>
                      </a:r>
                    </a:p>
                  </a:txBody>
                  <a:tcPr>
                    <a:lnL w="12700">
                      <a:solidFill>
                        <a:schemeClr val="tx1"/>
                      </a:solidFill>
                    </a:lnL>
                    <a:lnR w="12700">
                      <a:solidFill>
                        <a:schemeClr val="tx1"/>
                      </a:solidFill>
                    </a:lnR>
                    <a:lnT w="12700">
                      <a:solidFill>
                        <a:schemeClr val="tx1"/>
                      </a:solidFill>
                    </a:lnT>
                    <a:lnB w="12700">
                      <a:solidFill>
                        <a:schemeClr val="tx1"/>
                      </a:solidFill>
                    </a:lnB>
                    <a:noFill/>
                  </a:tcPr>
                </a:tc>
                <a:tc>
                  <a:txBody>
                    <a:bodyPr/>
                    <a:lstStyle/>
                    <a:p>
                      <a:pPr lvl="0">
                        <a:buNone/>
                      </a:pPr>
                      <a:r>
                        <a:rPr lang="en-US" sz="2400" b="1" dirty="0">
                          <a:solidFill>
                            <a:srgbClr val="383834"/>
                          </a:solidFill>
                        </a:rPr>
                        <a:t>THEN</a:t>
                      </a:r>
                    </a:p>
                  </a:txBody>
                  <a:tcPr>
                    <a:lnL w="12700">
                      <a:solidFill>
                        <a:schemeClr val="tx1"/>
                      </a:solidFill>
                    </a:lnL>
                    <a:lnR w="12700">
                      <a:solidFill>
                        <a:schemeClr val="tx1"/>
                      </a:solidFill>
                    </a:lnR>
                    <a:lnT w="12700">
                      <a:solidFill>
                        <a:schemeClr val="tx1"/>
                      </a:solidFill>
                    </a:lnT>
                    <a:lnB w="12700">
                      <a:solidFill>
                        <a:schemeClr val="tx1"/>
                      </a:solidFill>
                    </a:lnB>
                    <a:noFill/>
                  </a:tcPr>
                </a:tc>
                <a:extLst>
                  <a:ext uri="{0D108BD9-81ED-4DB2-BD59-A6C34878D82A}">
                    <a16:rowId xmlns:a16="http://schemas.microsoft.com/office/drawing/2014/main" val="32181981"/>
                  </a:ext>
                </a:extLst>
              </a:tr>
              <a:tr h="1130239">
                <a:tc>
                  <a:txBody>
                    <a:bodyPr/>
                    <a:lstStyle/>
                    <a:p>
                      <a:r>
                        <a:rPr lang="en-US" sz="2000" b="0" dirty="0">
                          <a:solidFill>
                            <a:srgbClr val="383834"/>
                          </a:solidFill>
                        </a:rPr>
                        <a:t>Information is shared in an overwhelming manner</a:t>
                      </a:r>
                    </a:p>
                  </a:txBody>
                  <a:tcPr>
                    <a:lnL w="12700">
                      <a:solidFill>
                        <a:schemeClr val="tx1"/>
                      </a:solidFill>
                    </a:lnL>
                    <a:lnR w="12700">
                      <a:solidFill>
                        <a:schemeClr val="tx1"/>
                      </a:solidFill>
                    </a:lnR>
                    <a:lnT w="12700">
                      <a:solidFill>
                        <a:schemeClr val="tx1"/>
                      </a:solidFill>
                    </a:lnT>
                    <a:lnB w="12700">
                      <a:solidFill>
                        <a:schemeClr val="tx1"/>
                      </a:solidFill>
                    </a:lnB>
                    <a:solidFill>
                      <a:srgbClr val="FF0000"/>
                    </a:solidFill>
                  </a:tcPr>
                </a:tc>
                <a:tc>
                  <a:txBody>
                    <a:bodyPr/>
                    <a:lstStyle/>
                    <a:p>
                      <a:r>
                        <a:rPr lang="en-US" sz="2000" b="0" dirty="0">
                          <a:solidFill>
                            <a:srgbClr val="383834"/>
                          </a:solidFill>
                        </a:rPr>
                        <a:t>Withdrawn behaviors increase </a:t>
                      </a:r>
                      <a:r>
                        <a:rPr lang="en-US" sz="2000" b="0" i="0" u="none" strike="noStrike" noProof="0" dirty="0">
                          <a:solidFill>
                            <a:srgbClr val="383834"/>
                          </a:solidFill>
                          <a:latin typeface="Arial"/>
                        </a:rPr>
                        <a:t>7</a:t>
                      </a:r>
                      <a:r>
                        <a:rPr lang="en-US" sz="2000" b="0" i="0" u="none" strike="noStrike" noProof="0" dirty="0">
                          <a:solidFill>
                            <a:srgbClr val="002060"/>
                          </a:solidFill>
                          <a:latin typeface="Arial"/>
                        </a:rPr>
                        <a:t> → 10</a:t>
                      </a:r>
                      <a:endParaRPr lang="en-US" dirty="0"/>
                    </a:p>
                  </a:txBody>
                  <a:tcPr>
                    <a:lnL w="12700">
                      <a:solidFill>
                        <a:schemeClr val="tx1"/>
                      </a:solidFill>
                    </a:lnL>
                    <a:lnR w="12700">
                      <a:solidFill>
                        <a:schemeClr val="tx1"/>
                      </a:solidFill>
                    </a:lnR>
                    <a:lnT w="12700">
                      <a:solidFill>
                        <a:schemeClr val="tx1"/>
                      </a:solidFill>
                    </a:lnT>
                    <a:lnB w="12700">
                      <a:solidFill>
                        <a:schemeClr val="tx1"/>
                      </a:solidFill>
                    </a:lnB>
                    <a:solidFill>
                      <a:srgbClr val="FF0000"/>
                    </a:solidFill>
                  </a:tcPr>
                </a:tc>
                <a:extLst>
                  <a:ext uri="{0D108BD9-81ED-4DB2-BD59-A6C34878D82A}">
                    <a16:rowId xmlns:a16="http://schemas.microsoft.com/office/drawing/2014/main" val="3095189828"/>
                  </a:ext>
                </a:extLst>
              </a:tr>
              <a:tr h="1828484">
                <a:tc>
                  <a:txBody>
                    <a:bodyPr/>
                    <a:lstStyle/>
                    <a:p>
                      <a:pPr lvl="0">
                        <a:buNone/>
                      </a:pPr>
                      <a:r>
                        <a:rPr lang="en-US" sz="2000" b="0" dirty="0">
                          <a:solidFill>
                            <a:srgbClr val="383834"/>
                          </a:solidFill>
                        </a:rPr>
                        <a:t>Information is tailored to the needs of the SP </a:t>
                      </a:r>
                      <a:r>
                        <a:rPr lang="en-US" sz="2000" b="0" i="0" u="none" strike="noStrike" noProof="0" dirty="0">
                          <a:solidFill>
                            <a:srgbClr val="383834"/>
                          </a:solidFill>
                          <a:latin typeface="Arial"/>
                        </a:rPr>
                        <a:t>(e.g., FPF makes eye contact, engages in conversation, asks appropriate questions, responds to touch such as hand on shoulder)</a:t>
                      </a:r>
                      <a:endParaRPr lang="en-US" sz="2000" b="0" dirty="0">
                        <a:solidFill>
                          <a:srgbClr val="383834"/>
                        </a:solidFill>
                      </a:endParaRPr>
                    </a:p>
                  </a:txBody>
                  <a:tcPr>
                    <a:lnL w="12700">
                      <a:solidFill>
                        <a:schemeClr val="tx1"/>
                      </a:solid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a:solidFill>
                        <a:schemeClr val="tx1"/>
                      </a:solidFill>
                    </a:lnB>
                    <a:solidFill>
                      <a:srgbClr val="00B050"/>
                    </a:solidFill>
                  </a:tcPr>
                </a:tc>
                <a:tc>
                  <a:txBody>
                    <a:bodyPr/>
                    <a:lstStyle/>
                    <a:p>
                      <a:pPr lvl="0">
                        <a:buNone/>
                      </a:pPr>
                      <a:r>
                        <a:rPr lang="en-US" sz="2000" b="0" i="0" u="none" strike="noStrike" noProof="0" dirty="0">
                          <a:solidFill>
                            <a:srgbClr val="383834"/>
                          </a:solidFill>
                          <a:latin typeface="Arial"/>
                        </a:rPr>
                        <a:t>Withdrawn behaviors decrease 7</a:t>
                      </a:r>
                      <a:r>
                        <a:rPr lang="en-US" sz="2000" b="0" i="0" u="none" strike="noStrike" noProof="0" dirty="0">
                          <a:solidFill>
                            <a:srgbClr val="002060"/>
                          </a:solidFill>
                          <a:latin typeface="Arial"/>
                        </a:rPr>
                        <a:t> → 4</a:t>
                      </a:r>
                      <a:endParaRPr lang="en-US" sz="2000" b="0" dirty="0">
                        <a:solidFill>
                          <a:srgbClr val="383834"/>
                        </a:solidFill>
                      </a:endParaRPr>
                    </a:p>
                  </a:txBody>
                  <a:tcPr>
                    <a:lnL w="12700" cap="flat" cmpd="sng" algn="ctr">
                      <a:solidFill>
                        <a:schemeClr val="tx1"/>
                      </a:solidFill>
                      <a:prstDash val="solid"/>
                      <a:round/>
                      <a:headEnd type="none" w="med" len="med"/>
                      <a:tailEnd type="none" w="med" len="med"/>
                    </a:lnL>
                    <a:lnR w="12700">
                      <a:solidFill>
                        <a:schemeClr val="tx1"/>
                      </a:solidFill>
                    </a:lnR>
                    <a:lnT w="12700" cap="flat" cmpd="sng" algn="ctr">
                      <a:solidFill>
                        <a:schemeClr val="tx1"/>
                      </a:solidFill>
                      <a:prstDash val="solid"/>
                      <a:round/>
                      <a:headEnd type="none" w="med" len="med"/>
                      <a:tailEnd type="none" w="med" len="med"/>
                    </a:lnT>
                    <a:lnB w="12700">
                      <a:solidFill>
                        <a:schemeClr val="tx1"/>
                      </a:solidFill>
                    </a:lnB>
                    <a:solidFill>
                      <a:srgbClr val="00B050"/>
                    </a:solidFill>
                  </a:tcPr>
                </a:tc>
                <a:extLst>
                  <a:ext uri="{0D108BD9-81ED-4DB2-BD59-A6C34878D82A}">
                    <a16:rowId xmlns:a16="http://schemas.microsoft.com/office/drawing/2014/main" val="3043834941"/>
                  </a:ext>
                </a:extLst>
              </a:tr>
            </a:tbl>
          </a:graphicData>
        </a:graphic>
      </p:graphicFrame>
    </p:spTree>
    <p:extLst>
      <p:ext uri="{BB962C8B-B14F-4D97-AF65-F5344CB8AC3E}">
        <p14:creationId xmlns:p14="http://schemas.microsoft.com/office/powerpoint/2010/main" val="270997585"/>
      </p:ext>
    </p:extLst>
  </p:cSld>
  <p:clrMapOvr>
    <a:masterClrMapping/>
  </p:clrMapOvr>
  <mc:AlternateContent xmlns:mc="http://schemas.openxmlformats.org/markup-compatibility/2006" xmlns:p14="http://schemas.microsoft.com/office/powerpoint/2010/main">
    <mc:Choice Requires="p14">
      <p:transition spd="slow" p14:dur="2000" advTm="27047"/>
    </mc:Choice>
    <mc:Fallback xmlns="">
      <p:transition spd="slow" advTm="27047"/>
    </mc:Fallback>
  </mc:AlternateContent>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itle 8"/>
          <p:cNvSpPr>
            <a:spLocks noGrp="1"/>
          </p:cNvSpPr>
          <p:nvPr>
            <p:ph type="title"/>
          </p:nvPr>
        </p:nvSpPr>
        <p:spPr>
          <a:xfrm>
            <a:off x="609599" y="807235"/>
            <a:ext cx="10972803" cy="418576"/>
          </a:xfrm>
        </p:spPr>
        <p:txBody>
          <a:bodyPr/>
          <a:lstStyle/>
          <a:p>
            <a:r>
              <a:rPr lang="en-US" sz="3700"/>
              <a:t>Outline</a:t>
            </a:r>
          </a:p>
        </p:txBody>
      </p:sp>
      <p:sp>
        <p:nvSpPr>
          <p:cNvPr id="14" name="Content Placeholder 13"/>
          <p:cNvSpPr>
            <a:spLocks noGrp="1"/>
          </p:cNvSpPr>
          <p:nvPr>
            <p:ph sz="quarter" idx="13"/>
          </p:nvPr>
        </p:nvSpPr>
        <p:spPr>
          <a:xfrm>
            <a:off x="609600" y="1476789"/>
            <a:ext cx="10972801" cy="4737116"/>
          </a:xfrm>
        </p:spPr>
        <p:txBody>
          <a:bodyPr vert="horz" lIns="0" tIns="0" rIns="0" bIns="0" rtlCol="0" anchor="t">
            <a:noAutofit/>
          </a:bodyPr>
          <a:lstStyle/>
          <a:p>
            <a:pPr marL="306070" indent="-306070">
              <a:lnSpc>
                <a:spcPct val="150000"/>
              </a:lnSpc>
              <a:spcBef>
                <a:spcPts val="800"/>
              </a:spcBef>
            </a:pPr>
            <a:r>
              <a:rPr lang="en-US" sz="2700" dirty="0">
                <a:ea typeface="+mn-lt"/>
                <a:cs typeface="+mn-lt"/>
              </a:rPr>
              <a:t>Overview</a:t>
            </a:r>
          </a:p>
          <a:p>
            <a:pPr marL="306070" indent="-306070">
              <a:lnSpc>
                <a:spcPct val="150000"/>
              </a:lnSpc>
              <a:spcBef>
                <a:spcPts val="800"/>
              </a:spcBef>
            </a:pPr>
            <a:r>
              <a:rPr lang="en-US" sz="2700">
                <a:ea typeface="+mn-lt"/>
                <a:cs typeface="+mn-lt"/>
              </a:rPr>
              <a:t>Personality Traits</a:t>
            </a:r>
          </a:p>
          <a:p>
            <a:pPr marL="306070" indent="-306070">
              <a:lnSpc>
                <a:spcPct val="150000"/>
              </a:lnSpc>
              <a:spcBef>
                <a:spcPts val="800"/>
              </a:spcBef>
            </a:pPr>
            <a:r>
              <a:rPr lang="en-US" sz="2700" dirty="0">
                <a:solidFill>
                  <a:srgbClr val="9E2FED"/>
                </a:solidFill>
                <a:cs typeface="Arial"/>
              </a:rPr>
              <a:t>Observer Tool</a:t>
            </a:r>
            <a:endParaRPr lang="en-US" sz="2700" dirty="0">
              <a:solidFill>
                <a:srgbClr val="9E2FED"/>
              </a:solidFill>
              <a:ea typeface="+mn-lt"/>
              <a:cs typeface="+mn-lt"/>
            </a:endParaRPr>
          </a:p>
          <a:p>
            <a:pPr marL="306070" indent="-306070">
              <a:lnSpc>
                <a:spcPct val="150000"/>
              </a:lnSpc>
              <a:spcBef>
                <a:spcPts val="800"/>
              </a:spcBef>
            </a:pPr>
            <a:r>
              <a:rPr lang="en-US" sz="2700" dirty="0">
                <a:cs typeface="Arial"/>
              </a:rPr>
              <a:t>Practice!</a:t>
            </a:r>
            <a:endParaRPr lang="en-US" sz="2700" dirty="0">
              <a:ea typeface="+mn-lt"/>
              <a:cs typeface="+mn-lt"/>
            </a:endParaRPr>
          </a:p>
          <a:p>
            <a:pPr marL="306070" indent="-306070">
              <a:lnSpc>
                <a:spcPct val="150000"/>
              </a:lnSpc>
              <a:spcBef>
                <a:spcPts val="800"/>
              </a:spcBef>
            </a:pPr>
            <a:r>
              <a:rPr lang="en-US" sz="2700" dirty="0">
                <a:cs typeface="Arial"/>
              </a:rPr>
              <a:t>Summary</a:t>
            </a:r>
            <a:endParaRPr lang="en-US" sz="2700" dirty="0">
              <a:ea typeface="+mn-lt"/>
              <a:cs typeface="+mn-lt"/>
            </a:endParaRPr>
          </a:p>
          <a:p>
            <a:pPr marL="306070" indent="-306070">
              <a:spcBef>
                <a:spcPts val="800"/>
              </a:spcBef>
            </a:pPr>
            <a:endParaRPr lang="en-US" sz="2700">
              <a:ea typeface="+mn-lt"/>
              <a:cs typeface="+mn-lt"/>
            </a:endParaRPr>
          </a:p>
          <a:p>
            <a:pPr marL="306070" indent="-306070">
              <a:spcBef>
                <a:spcPts val="800"/>
              </a:spcBef>
            </a:pPr>
            <a:endParaRPr lang="en-US" sz="2700">
              <a:cs typeface="Arial"/>
            </a:endParaRPr>
          </a:p>
        </p:txBody>
      </p:sp>
      <p:sp>
        <p:nvSpPr>
          <p:cNvPr id="7" name="Slide Number Placeholder 6"/>
          <p:cNvSpPr>
            <a:spLocks noGrp="1"/>
          </p:cNvSpPr>
          <p:nvPr>
            <p:ph type="sldNum" sz="quarter" idx="4"/>
          </p:nvPr>
        </p:nvSpPr>
        <p:spPr/>
        <p:txBody>
          <a:bodyPr/>
          <a:lstStyle/>
          <a:p>
            <a:fld id="{7FEEEA1A-CB49-3744-AA40-B896987410F9}" type="slidenum">
              <a:rPr lang="en-US" smtClean="0"/>
              <a:pPr/>
              <a:t>15</a:t>
            </a:fld>
            <a:endParaRPr lang="en-US"/>
          </a:p>
        </p:txBody>
      </p:sp>
    </p:spTree>
    <p:extLst>
      <p:ext uri="{BB962C8B-B14F-4D97-AF65-F5344CB8AC3E}">
        <p14:creationId xmlns:p14="http://schemas.microsoft.com/office/powerpoint/2010/main" val="614994627"/>
      </p:ext>
    </p:extLst>
  </p:cSld>
  <p:clrMapOvr>
    <a:masterClrMapping/>
  </p:clrMapOvr>
  <mc:AlternateContent xmlns:mc="http://schemas.openxmlformats.org/markup-compatibility/2006" xmlns:p14="http://schemas.microsoft.com/office/powerpoint/2010/main">
    <mc:Choice Requires="p14">
      <p:transition spd="slow" p14:dur="2000" advTm="5565"/>
    </mc:Choice>
    <mc:Fallback xmlns="">
      <p:transition spd="slow" advTm="5565"/>
    </mc:Fallback>
  </mc:AlternateContent>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Title 14"/>
          <p:cNvSpPr>
            <a:spLocks noGrp="1"/>
          </p:cNvSpPr>
          <p:nvPr>
            <p:ph type="title"/>
          </p:nvPr>
        </p:nvSpPr>
        <p:spPr/>
        <p:txBody>
          <a:bodyPr vert="horz" lIns="0" tIns="0" rIns="0" bIns="0" rtlCol="0" anchor="ctr" anchorCtr="0">
            <a:noAutofit/>
          </a:bodyPr>
          <a:lstStyle/>
          <a:p>
            <a:r>
              <a:rPr lang="en-US" dirty="0">
                <a:cs typeface="Arial"/>
              </a:rPr>
              <a:t> OBSERVER TOOL</a:t>
            </a:r>
          </a:p>
        </p:txBody>
      </p:sp>
    </p:spTree>
    <p:extLst>
      <p:ext uri="{BB962C8B-B14F-4D97-AF65-F5344CB8AC3E}">
        <p14:creationId xmlns:p14="http://schemas.microsoft.com/office/powerpoint/2010/main" val="2762859102"/>
      </p:ext>
    </p:extLst>
  </p:cSld>
  <p:clrMapOvr>
    <a:masterClrMapping/>
  </p:clrMapOvr>
  <mc:AlternateContent xmlns:mc="http://schemas.openxmlformats.org/markup-compatibility/2006" xmlns:p14="http://schemas.microsoft.com/office/powerpoint/2010/main">
    <mc:Choice Requires="p14">
      <p:transition spd="slow" p14:dur="2000" advTm="3896"/>
    </mc:Choice>
    <mc:Fallback xmlns="">
      <p:transition spd="slow" advTm="3896"/>
    </mc:Fallback>
  </mc:AlternateContent>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Picture 10" descr="Fenugreek and the Heart - Stethoscope">
            <a:extLst>
              <a:ext uri="{FF2B5EF4-FFF2-40B4-BE49-F238E27FC236}">
                <a16:creationId xmlns:a16="http://schemas.microsoft.com/office/drawing/2014/main" id="{D2859504-8D01-4823-B5EC-540338CFC38A}"/>
              </a:ext>
            </a:extLst>
          </p:cNvPr>
          <p:cNvPicPr>
            <a:picLocks noChangeAspect="1" noChangeArrowheads="1"/>
          </p:cNvPicPr>
          <p:nvPr/>
        </p:nvPicPr>
        <p:blipFill rotWithShape="1">
          <a:blip r:embed="rId3">
            <a:alphaModFix amt="28000"/>
            <a:extLst>
              <a:ext uri="{BEBA8EAE-BF5A-486C-A8C5-ECC9F3942E4B}">
                <a14:imgProps xmlns:a14="http://schemas.microsoft.com/office/drawing/2010/main">
                  <a14:imgLayer r:embed="rId4">
                    <a14:imgEffect>
                      <a14:colorTemperature colorTemp="4906"/>
                    </a14:imgEffect>
                  </a14:imgLayer>
                </a14:imgProps>
              </a:ext>
              <a:ext uri="{28A0092B-C50C-407E-A947-70E740481C1C}">
                <a14:useLocalDpi xmlns:a14="http://schemas.microsoft.com/office/drawing/2010/main" val="0"/>
              </a:ext>
            </a:extLst>
          </a:blip>
          <a:srcRect t="24835" b="4771"/>
          <a:stretch/>
        </p:blipFill>
        <p:spPr bwMode="auto">
          <a:xfrm>
            <a:off x="-8626" y="339551"/>
            <a:ext cx="12192000" cy="6515106"/>
          </a:xfrm>
          <a:prstGeom prst="rect">
            <a:avLst/>
          </a:prstGeom>
          <a:noFill/>
          <a:extLst>
            <a:ext uri="{909E8E84-426E-40DD-AFC4-6F175D3DCCD1}">
              <a14:hiddenFill xmlns:a14="http://schemas.microsoft.com/office/drawing/2010/main">
                <a:solidFill>
                  <a:srgbClr val="FFFFFF"/>
                </a:solidFill>
              </a14:hiddenFill>
            </a:ext>
          </a:extLst>
        </p:spPr>
      </p:pic>
      <p:sp>
        <p:nvSpPr>
          <p:cNvPr id="2" name="Content Placeholder 1">
            <a:extLst>
              <a:ext uri="{FF2B5EF4-FFF2-40B4-BE49-F238E27FC236}">
                <a16:creationId xmlns:a16="http://schemas.microsoft.com/office/drawing/2014/main" id="{F6AA21AD-CE8F-43B2-87F3-D16A20C7AB35}"/>
              </a:ext>
            </a:extLst>
          </p:cNvPr>
          <p:cNvSpPr>
            <a:spLocks noGrp="1"/>
          </p:cNvSpPr>
          <p:nvPr>
            <p:ph sz="half" idx="1"/>
          </p:nvPr>
        </p:nvSpPr>
        <p:spPr>
          <a:xfrm>
            <a:off x="152401" y="1463731"/>
            <a:ext cx="4385734" cy="4338492"/>
          </a:xfrm>
        </p:spPr>
        <p:txBody>
          <a:bodyPr vert="horz" lIns="0" tIns="0" rIns="0" bIns="0" rtlCol="0" anchor="t">
            <a:noAutofit/>
          </a:bodyPr>
          <a:lstStyle/>
          <a:p>
            <a:pPr marL="306486" indent="-306486"/>
            <a:r>
              <a:rPr lang="en-US" sz="2700" b="1">
                <a:solidFill>
                  <a:schemeClr val="tx2"/>
                </a:solidFill>
                <a:cs typeface="Arial"/>
              </a:rPr>
              <a:t>Respect and Value</a:t>
            </a:r>
          </a:p>
          <a:p>
            <a:pPr lvl="1"/>
            <a:r>
              <a:rPr lang="en-US" sz="2100">
                <a:solidFill>
                  <a:schemeClr val="bg2">
                    <a:lumMod val="25000"/>
                  </a:schemeClr>
                </a:solidFill>
                <a:cs typeface="Arial"/>
              </a:rPr>
              <a:t>Introduce yourself and key team members</a:t>
            </a:r>
          </a:p>
          <a:p>
            <a:pPr lvl="1"/>
            <a:r>
              <a:rPr lang="en-US" sz="2100">
                <a:solidFill>
                  <a:schemeClr val="bg2">
                    <a:lumMod val="25000"/>
                  </a:schemeClr>
                </a:solidFill>
                <a:cs typeface="Arial"/>
              </a:rPr>
              <a:t>Facilitate family positioning</a:t>
            </a:r>
          </a:p>
          <a:p>
            <a:pPr lvl="1"/>
            <a:r>
              <a:rPr lang="en-US" sz="2100">
                <a:solidFill>
                  <a:schemeClr val="tx1">
                    <a:lumMod val="75000"/>
                  </a:schemeClr>
                </a:solidFill>
                <a:cs typeface="Arial"/>
              </a:rPr>
              <a:t>Acknowledge linguistic, cultural, and religious preferences</a:t>
            </a:r>
          </a:p>
          <a:p>
            <a:pPr lvl="1"/>
            <a:r>
              <a:rPr lang="en-US" sz="2100">
                <a:solidFill>
                  <a:schemeClr val="bg2">
                    <a:lumMod val="25000"/>
                  </a:schemeClr>
                </a:solidFill>
                <a:cs typeface="Arial"/>
              </a:rPr>
              <a:t>Use empathetic, non-judgmental communication</a:t>
            </a:r>
          </a:p>
        </p:txBody>
      </p:sp>
      <p:sp>
        <p:nvSpPr>
          <p:cNvPr id="3" name="Content Placeholder 2">
            <a:extLst>
              <a:ext uri="{FF2B5EF4-FFF2-40B4-BE49-F238E27FC236}">
                <a16:creationId xmlns:a16="http://schemas.microsoft.com/office/drawing/2014/main" id="{3025F434-976C-4365-B5AA-B25172EC466B}"/>
              </a:ext>
            </a:extLst>
          </p:cNvPr>
          <p:cNvSpPr>
            <a:spLocks noGrp="1"/>
          </p:cNvSpPr>
          <p:nvPr>
            <p:ph sz="half" idx="15"/>
          </p:nvPr>
        </p:nvSpPr>
        <p:spPr>
          <a:xfrm>
            <a:off x="4795616" y="812266"/>
            <a:ext cx="7231295" cy="5225140"/>
          </a:xfrm>
        </p:spPr>
        <p:txBody>
          <a:bodyPr vert="horz" lIns="0" tIns="0" rIns="0" bIns="0" rtlCol="0" anchor="t">
            <a:noAutofit/>
          </a:bodyPr>
          <a:lstStyle/>
          <a:p>
            <a:pPr marL="306070" indent="-306070"/>
            <a:r>
              <a:rPr lang="en-US" sz="2700" b="1" dirty="0">
                <a:solidFill>
                  <a:schemeClr val="tx2"/>
                </a:solidFill>
                <a:cs typeface="Arial"/>
              </a:rPr>
              <a:t>Information Sharing </a:t>
            </a:r>
            <a:endParaRPr lang="en-US" b="1" dirty="0">
              <a:solidFill>
                <a:schemeClr val="tx2"/>
              </a:solidFill>
              <a:cs typeface="Arial"/>
            </a:endParaRPr>
          </a:p>
          <a:p>
            <a:pPr marL="608965" lvl="1" indent="-308610"/>
            <a:r>
              <a:rPr lang="en-US" sz="2100" dirty="0">
                <a:solidFill>
                  <a:schemeClr val="bg2">
                    <a:lumMod val="25000"/>
                  </a:schemeClr>
                </a:solidFill>
                <a:cs typeface="Arial"/>
              </a:rPr>
              <a:t>Ascertain preferences </a:t>
            </a:r>
          </a:p>
          <a:p>
            <a:pPr marL="608965" lvl="1" indent="-308610"/>
            <a:r>
              <a:rPr lang="en-US" sz="2100" dirty="0">
                <a:solidFill>
                  <a:schemeClr val="bg2">
                    <a:lumMod val="25000"/>
                  </a:schemeClr>
                </a:solidFill>
                <a:cs typeface="Arial"/>
              </a:rPr>
              <a:t>Provide simple, fact-based, non-speculative information</a:t>
            </a:r>
          </a:p>
          <a:p>
            <a:pPr marL="608965" lvl="1" indent="-308610"/>
            <a:r>
              <a:rPr lang="en-US" sz="2100" dirty="0">
                <a:solidFill>
                  <a:schemeClr val="bg2">
                    <a:lumMod val="25000"/>
                  </a:schemeClr>
                </a:solidFill>
                <a:cs typeface="Arial"/>
              </a:rPr>
              <a:t>Elicit questions and clarifications</a:t>
            </a:r>
          </a:p>
          <a:p>
            <a:pPr marL="608965" lvl="1" indent="-308610"/>
            <a:r>
              <a:rPr lang="en-US" sz="2100" dirty="0">
                <a:solidFill>
                  <a:schemeClr val="bg2">
                    <a:lumMod val="25000"/>
                  </a:schemeClr>
                </a:solidFill>
                <a:cs typeface="Arial"/>
              </a:rPr>
              <a:t>Employ de-escalation strategies as needed</a:t>
            </a:r>
          </a:p>
          <a:p>
            <a:pPr marL="306070" indent="-306070"/>
            <a:r>
              <a:rPr lang="en-US" sz="2400" b="1" dirty="0">
                <a:solidFill>
                  <a:schemeClr val="tx2"/>
                </a:solidFill>
                <a:cs typeface="Arial"/>
              </a:rPr>
              <a:t>Non-Verbal Communication</a:t>
            </a:r>
          </a:p>
          <a:p>
            <a:pPr marL="608965" lvl="1" indent="-308610"/>
            <a:r>
              <a:rPr lang="en-US" sz="2100" dirty="0">
                <a:solidFill>
                  <a:schemeClr val="bg2">
                    <a:lumMod val="25000"/>
                  </a:schemeClr>
                </a:solidFill>
                <a:cs typeface="Arial"/>
              </a:rPr>
              <a:t>Use receptive listening skills</a:t>
            </a:r>
          </a:p>
          <a:p>
            <a:pPr marL="608965" lvl="1" indent="-308610"/>
            <a:r>
              <a:rPr lang="en-US" sz="2100" dirty="0">
                <a:solidFill>
                  <a:schemeClr val="bg2">
                    <a:lumMod val="25000"/>
                  </a:schemeClr>
                </a:solidFill>
                <a:cs typeface="Arial"/>
              </a:rPr>
              <a:t>Use physical distance and touch to provide comfort</a:t>
            </a:r>
          </a:p>
          <a:p>
            <a:pPr marL="306070" indent="-306070"/>
            <a:r>
              <a:rPr lang="en-US" sz="2700" b="1" dirty="0">
                <a:solidFill>
                  <a:schemeClr val="tx2"/>
                </a:solidFill>
                <a:cs typeface="Arial"/>
              </a:rPr>
              <a:t>Summary and Follow-Up</a:t>
            </a:r>
          </a:p>
          <a:p>
            <a:pPr marL="608965" lvl="1" indent="-308610"/>
            <a:r>
              <a:rPr lang="en-US" sz="2100" dirty="0">
                <a:solidFill>
                  <a:schemeClr val="bg2">
                    <a:lumMod val="25000"/>
                  </a:schemeClr>
                </a:solidFill>
                <a:cs typeface="Arial"/>
              </a:rPr>
              <a:t>Advocate for summary, next steps, and closure</a:t>
            </a:r>
          </a:p>
        </p:txBody>
      </p:sp>
      <p:sp>
        <p:nvSpPr>
          <p:cNvPr id="5" name="Slide Number Placeholder 4">
            <a:extLst>
              <a:ext uri="{FF2B5EF4-FFF2-40B4-BE49-F238E27FC236}">
                <a16:creationId xmlns:a16="http://schemas.microsoft.com/office/drawing/2014/main" id="{F2FED725-C689-480E-A39F-A13E38706A51}"/>
              </a:ext>
            </a:extLst>
          </p:cNvPr>
          <p:cNvSpPr>
            <a:spLocks noGrp="1"/>
          </p:cNvSpPr>
          <p:nvPr>
            <p:ph type="sldNum" sz="quarter" idx="4"/>
          </p:nvPr>
        </p:nvSpPr>
        <p:spPr/>
        <p:txBody>
          <a:bodyPr/>
          <a:lstStyle/>
          <a:p>
            <a:fld id="{7FEEEA1A-CB49-3744-AA40-B896987410F9}" type="slidenum">
              <a:rPr lang="en-US" smtClean="0"/>
              <a:pPr/>
              <a:t>17</a:t>
            </a:fld>
            <a:endParaRPr lang="en-US"/>
          </a:p>
        </p:txBody>
      </p:sp>
      <p:sp>
        <p:nvSpPr>
          <p:cNvPr id="6" name="Title 5">
            <a:extLst>
              <a:ext uri="{FF2B5EF4-FFF2-40B4-BE49-F238E27FC236}">
                <a16:creationId xmlns:a16="http://schemas.microsoft.com/office/drawing/2014/main" id="{0156E0C9-4DA1-48B0-828F-6BF8F59E3826}"/>
              </a:ext>
            </a:extLst>
          </p:cNvPr>
          <p:cNvSpPr>
            <a:spLocks noGrp="1"/>
          </p:cNvSpPr>
          <p:nvPr>
            <p:ph type="title"/>
          </p:nvPr>
        </p:nvSpPr>
        <p:spPr>
          <a:xfrm>
            <a:off x="219812" y="563836"/>
            <a:ext cx="10972803" cy="418576"/>
          </a:xfrm>
        </p:spPr>
        <p:txBody>
          <a:bodyPr/>
          <a:lstStyle/>
          <a:p>
            <a:r>
              <a:rPr lang="en-US" sz="3700">
                <a:cs typeface="Arial"/>
              </a:rPr>
              <a:t>Key FPF Behaviors</a:t>
            </a:r>
          </a:p>
        </p:txBody>
      </p:sp>
      <p:sp>
        <p:nvSpPr>
          <p:cNvPr id="12" name="Footer Placeholder 5">
            <a:extLst>
              <a:ext uri="{FF2B5EF4-FFF2-40B4-BE49-F238E27FC236}">
                <a16:creationId xmlns:a16="http://schemas.microsoft.com/office/drawing/2014/main" id="{8B28410D-E612-4381-A3A7-21A70A6C6F2B}"/>
              </a:ext>
            </a:extLst>
          </p:cNvPr>
          <p:cNvSpPr txBox="1">
            <a:spLocks/>
          </p:cNvSpPr>
          <p:nvPr/>
        </p:nvSpPr>
        <p:spPr>
          <a:xfrm>
            <a:off x="337775" y="6664705"/>
            <a:ext cx="11834172" cy="123111"/>
          </a:xfrm>
          <a:prstGeom prst="rect">
            <a:avLst/>
          </a:prstGeom>
        </p:spPr>
        <p:txBody>
          <a:bodyPr vert="horz" wrap="square" lIns="0" tIns="0" rIns="0" bIns="0" rtlCol="0" anchor="ct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800">
                <a:ea typeface="+mn-lt"/>
                <a:cs typeface="+mn-lt"/>
              </a:rPr>
              <a:t>Image by </a:t>
            </a:r>
            <a:r>
              <a:rPr lang="en-US" sz="800" err="1">
                <a:ea typeface="+mn-lt"/>
                <a:cs typeface="+mn-lt"/>
              </a:rPr>
              <a:t>formulatehealth</a:t>
            </a:r>
            <a:r>
              <a:rPr lang="en-US" sz="800">
                <a:ea typeface="+mn-lt"/>
                <a:cs typeface="+mn-lt"/>
              </a:rPr>
              <a:t>, </a:t>
            </a:r>
            <a:r>
              <a:rPr lang="en-US" sz="800"/>
              <a:t>retrieved from: https://search.openverse.engineering/image/cb8dd8b6-11c0-42a4-9cc9-5579dc461f4c on 4 March 2022. Creative Commons license associated: https://creativecommons.org/licenses/by/4.0/.</a:t>
            </a:r>
            <a:endParaRPr lang="en-US" sz="800">
              <a:cs typeface="Arial"/>
            </a:endParaRPr>
          </a:p>
        </p:txBody>
      </p:sp>
    </p:spTree>
    <p:extLst>
      <p:ext uri="{BB962C8B-B14F-4D97-AF65-F5344CB8AC3E}">
        <p14:creationId xmlns:p14="http://schemas.microsoft.com/office/powerpoint/2010/main" val="267503431"/>
      </p:ext>
    </p:extLst>
  </p:cSld>
  <p:clrMapOvr>
    <a:masterClrMapping/>
  </p:clrMapOvr>
  <mc:AlternateContent xmlns:mc="http://schemas.openxmlformats.org/markup-compatibility/2006" xmlns:p14="http://schemas.microsoft.com/office/powerpoint/2010/main">
    <mc:Choice Requires="p14">
      <p:transition spd="slow" p14:dur="2000" advTm="16575"/>
    </mc:Choice>
    <mc:Fallback xmlns="">
      <p:transition spd="slow" advTm="16575"/>
    </mc:Fallback>
  </mc:AlternateContent>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lide Number Placeholder 2">
            <a:extLst>
              <a:ext uri="{FF2B5EF4-FFF2-40B4-BE49-F238E27FC236}">
                <a16:creationId xmlns:a16="http://schemas.microsoft.com/office/drawing/2014/main" id="{42E776EB-BAB5-3643-13F2-1D36B5CFF9F9}"/>
              </a:ext>
            </a:extLst>
          </p:cNvPr>
          <p:cNvSpPr>
            <a:spLocks noGrp="1"/>
          </p:cNvSpPr>
          <p:nvPr>
            <p:ph type="sldNum" sz="quarter" idx="4"/>
          </p:nvPr>
        </p:nvSpPr>
        <p:spPr/>
        <p:txBody>
          <a:bodyPr/>
          <a:lstStyle/>
          <a:p>
            <a:fld id="{7FEEEA1A-CB49-3744-AA40-B896987410F9}" type="slidenum">
              <a:rPr lang="en-US" smtClean="0"/>
              <a:pPr/>
              <a:t>18</a:t>
            </a:fld>
            <a:endParaRPr lang="en-US"/>
          </a:p>
        </p:txBody>
      </p:sp>
      <p:pic>
        <p:nvPicPr>
          <p:cNvPr id="2" name="Picture 1">
            <a:extLst>
              <a:ext uri="{FF2B5EF4-FFF2-40B4-BE49-F238E27FC236}">
                <a16:creationId xmlns:a16="http://schemas.microsoft.com/office/drawing/2014/main" id="{3B065A5D-262E-0FDD-FAB7-0F73F21509CD}"/>
              </a:ext>
            </a:extLst>
          </p:cNvPr>
          <p:cNvPicPr>
            <a:picLocks noChangeAspect="1"/>
          </p:cNvPicPr>
          <p:nvPr/>
        </p:nvPicPr>
        <p:blipFill rotWithShape="1">
          <a:blip r:embed="rId3">
            <a:extLst>
              <a:ext uri="{28A0092B-C50C-407E-A947-70E740481C1C}">
                <a14:useLocalDpi xmlns:a14="http://schemas.microsoft.com/office/drawing/2010/main" val="0"/>
              </a:ext>
            </a:extLst>
          </a:blip>
          <a:srcRect l="3733" t="10868" r="6381" b="10635"/>
          <a:stretch/>
        </p:blipFill>
        <p:spPr bwMode="auto">
          <a:xfrm>
            <a:off x="1249678" y="80949"/>
            <a:ext cx="9692640" cy="6540901"/>
          </a:xfrm>
          <a:prstGeom prst="rect">
            <a:avLst/>
          </a:prstGeom>
          <a:ln>
            <a:noFill/>
          </a:ln>
          <a:extLst>
            <a:ext uri="{53640926-AAD7-44D8-BBD7-CCE9431645EC}">
              <a14:shadowObscured xmlns:a14="http://schemas.microsoft.com/office/drawing/2010/main"/>
            </a:ext>
          </a:extLst>
        </p:spPr>
      </p:pic>
      <p:sp>
        <p:nvSpPr>
          <p:cNvPr id="4" name="Subtitle 20">
            <a:extLst>
              <a:ext uri="{FF2B5EF4-FFF2-40B4-BE49-F238E27FC236}">
                <a16:creationId xmlns:a16="http://schemas.microsoft.com/office/drawing/2014/main" id="{737148E5-929D-B0B4-EBA4-3611617AC3ED}"/>
              </a:ext>
            </a:extLst>
          </p:cNvPr>
          <p:cNvSpPr txBox="1">
            <a:spLocks/>
          </p:cNvSpPr>
          <p:nvPr/>
        </p:nvSpPr>
        <p:spPr>
          <a:xfrm>
            <a:off x="2092994" y="6631767"/>
            <a:ext cx="8006007" cy="199310"/>
          </a:xfrm>
          <a:prstGeom prst="rect">
            <a:avLst/>
          </a:prstGeom>
        </p:spPr>
        <p:txBody>
          <a:bodyPr/>
          <a:lstStyle>
            <a:lvl1pPr marL="230183" indent="-230183" algn="l" defTabSz="342892" rtl="0" eaLnBrk="1" latinLnBrk="0" hangingPunct="1">
              <a:lnSpc>
                <a:spcPct val="100000"/>
              </a:lnSpc>
              <a:spcBef>
                <a:spcPts val="800"/>
              </a:spcBef>
              <a:buClr>
                <a:schemeClr val="tx2"/>
              </a:buClr>
              <a:buFont typeface="Arial"/>
              <a:buChar char="•"/>
              <a:defRPr sz="1600" kern="1200">
                <a:solidFill>
                  <a:schemeClr val="tx1"/>
                </a:solidFill>
                <a:latin typeface="+mn-lt"/>
                <a:ea typeface="+mn-ea"/>
                <a:cs typeface="+mn-cs"/>
              </a:defRPr>
            </a:lvl1pPr>
            <a:lvl2pPr marL="457189" indent="-231770" algn="l" defTabSz="342892" rtl="0" eaLnBrk="1" latinLnBrk="0" hangingPunct="1">
              <a:lnSpc>
                <a:spcPct val="100000"/>
              </a:lnSpc>
              <a:spcBef>
                <a:spcPts val="800"/>
              </a:spcBef>
              <a:buClr>
                <a:schemeClr val="tx2"/>
              </a:buClr>
              <a:buFont typeface="Arial"/>
              <a:buChar char="–"/>
              <a:defRPr sz="1400" kern="1200">
                <a:solidFill>
                  <a:schemeClr val="tx1"/>
                </a:solidFill>
                <a:latin typeface="+mn-lt"/>
                <a:ea typeface="+mn-ea"/>
                <a:cs typeface="+mn-cs"/>
              </a:defRPr>
            </a:lvl2pPr>
            <a:lvl3pPr marL="684196" indent="-228594" algn="l" defTabSz="342892" rtl="0" eaLnBrk="1" latinLnBrk="0" hangingPunct="1">
              <a:lnSpc>
                <a:spcPct val="100000"/>
              </a:lnSpc>
              <a:spcBef>
                <a:spcPts val="800"/>
              </a:spcBef>
              <a:buClr>
                <a:schemeClr val="tx2"/>
              </a:buClr>
              <a:buFont typeface="Arial"/>
              <a:buChar char="•"/>
              <a:defRPr sz="1200" kern="1200">
                <a:solidFill>
                  <a:schemeClr val="tx1"/>
                </a:solidFill>
                <a:latin typeface="+mn-lt"/>
                <a:ea typeface="+mn-ea"/>
                <a:cs typeface="+mn-cs"/>
              </a:defRPr>
            </a:lvl3pPr>
            <a:lvl4pPr marL="914378" indent="-230183" algn="l" defTabSz="342892" rtl="0" eaLnBrk="1" latinLnBrk="0" hangingPunct="1">
              <a:lnSpc>
                <a:spcPct val="100000"/>
              </a:lnSpc>
              <a:spcBef>
                <a:spcPts val="800"/>
              </a:spcBef>
              <a:buClr>
                <a:schemeClr val="tx2"/>
              </a:buClr>
              <a:buFont typeface="Arial"/>
              <a:buChar char="–"/>
              <a:defRPr sz="1200" kern="1200">
                <a:solidFill>
                  <a:schemeClr val="tx1"/>
                </a:solidFill>
                <a:latin typeface="+mn-lt"/>
                <a:ea typeface="+mn-ea"/>
                <a:cs typeface="+mn-cs"/>
              </a:defRPr>
            </a:lvl4pPr>
            <a:lvl5pPr marL="1144559" indent="-230183" algn="l" defTabSz="342892" rtl="0" eaLnBrk="1" latinLnBrk="0" hangingPunct="1">
              <a:lnSpc>
                <a:spcPct val="100000"/>
              </a:lnSpc>
              <a:spcBef>
                <a:spcPts val="800"/>
              </a:spcBef>
              <a:buClr>
                <a:schemeClr val="tx2"/>
              </a:buClr>
              <a:buFont typeface="Arial" panose="020B0604020202020204" pitchFamily="34" charset="0"/>
              <a:buChar char="•"/>
              <a:defRPr sz="1200" kern="1200">
                <a:solidFill>
                  <a:schemeClr val="tx1"/>
                </a:solidFill>
                <a:latin typeface="+mn-lt"/>
                <a:ea typeface="+mn-ea"/>
                <a:cs typeface="+mn-cs"/>
              </a:defRPr>
            </a:lvl5pPr>
            <a:lvl6pPr marL="1885903" indent="-171446" algn="l" defTabSz="342892" rtl="0" eaLnBrk="1" latinLnBrk="0" hangingPunct="1">
              <a:spcBef>
                <a:spcPct val="20000"/>
              </a:spcBef>
              <a:buFont typeface="Arial"/>
              <a:buChar char="•"/>
              <a:defRPr sz="1500" kern="1200">
                <a:solidFill>
                  <a:schemeClr val="tx1"/>
                </a:solidFill>
                <a:latin typeface="+mn-lt"/>
                <a:ea typeface="+mn-ea"/>
                <a:cs typeface="+mn-cs"/>
              </a:defRPr>
            </a:lvl6pPr>
            <a:lvl7pPr marL="2228795" indent="-171446" algn="l" defTabSz="342892" rtl="0" eaLnBrk="1" latinLnBrk="0" hangingPunct="1">
              <a:spcBef>
                <a:spcPct val="20000"/>
              </a:spcBef>
              <a:buFont typeface="Arial"/>
              <a:buChar char="•"/>
              <a:defRPr sz="1500" kern="1200">
                <a:solidFill>
                  <a:schemeClr val="tx1"/>
                </a:solidFill>
                <a:latin typeface="+mn-lt"/>
                <a:ea typeface="+mn-ea"/>
                <a:cs typeface="+mn-cs"/>
              </a:defRPr>
            </a:lvl7pPr>
            <a:lvl8pPr marL="2571686" indent="-171446" algn="l" defTabSz="342892" rtl="0" eaLnBrk="1" latinLnBrk="0" hangingPunct="1">
              <a:spcBef>
                <a:spcPct val="20000"/>
              </a:spcBef>
              <a:buFont typeface="Arial"/>
              <a:buChar char="•"/>
              <a:defRPr sz="1500" kern="1200">
                <a:solidFill>
                  <a:schemeClr val="tx1"/>
                </a:solidFill>
                <a:latin typeface="+mn-lt"/>
                <a:ea typeface="+mn-ea"/>
                <a:cs typeface="+mn-cs"/>
              </a:defRPr>
            </a:lvl8pPr>
            <a:lvl9pPr marL="2914577" indent="-171446" algn="l" defTabSz="342892" rtl="0" eaLnBrk="1" latinLnBrk="0" hangingPunct="1">
              <a:spcBef>
                <a:spcPct val="20000"/>
              </a:spcBef>
              <a:buFont typeface="Arial"/>
              <a:buChar char="•"/>
              <a:defRPr sz="1500" kern="1200">
                <a:solidFill>
                  <a:schemeClr val="tx1"/>
                </a:solidFill>
                <a:latin typeface="+mn-lt"/>
                <a:ea typeface="+mn-ea"/>
                <a:cs typeface="+mn-cs"/>
              </a:defRPr>
            </a:lvl9pPr>
          </a:lstStyle>
          <a:p>
            <a:pPr marL="0" indent="0" algn="ctr">
              <a:buNone/>
            </a:pPr>
            <a:r>
              <a:rPr lang="en-US" sz="900" dirty="0"/>
              <a:t>FPF Simulation Assessment Tool Developed by Ellen Duncan MD, PhD, Joanne Agnant MD, MSc, and Selin T. Sagalowsky, MD, MPH</a:t>
            </a:r>
            <a:endParaRPr lang="en-US" sz="900" dirty="0">
              <a:cs typeface="Arial"/>
            </a:endParaRPr>
          </a:p>
        </p:txBody>
      </p:sp>
    </p:spTree>
    <p:extLst>
      <p:ext uri="{BB962C8B-B14F-4D97-AF65-F5344CB8AC3E}">
        <p14:creationId xmlns:p14="http://schemas.microsoft.com/office/powerpoint/2010/main" val="1127798271"/>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lide Number Placeholder 2">
            <a:extLst>
              <a:ext uri="{FF2B5EF4-FFF2-40B4-BE49-F238E27FC236}">
                <a16:creationId xmlns:a16="http://schemas.microsoft.com/office/drawing/2014/main" id="{B907A617-20B2-98C2-DBF9-CF046B1B340B}"/>
              </a:ext>
            </a:extLst>
          </p:cNvPr>
          <p:cNvSpPr>
            <a:spLocks noGrp="1"/>
          </p:cNvSpPr>
          <p:nvPr>
            <p:ph type="sldNum" sz="quarter" idx="4"/>
          </p:nvPr>
        </p:nvSpPr>
        <p:spPr/>
        <p:txBody>
          <a:bodyPr/>
          <a:lstStyle/>
          <a:p>
            <a:fld id="{7FEEEA1A-CB49-3744-AA40-B896987410F9}" type="slidenum">
              <a:rPr lang="en-US" smtClean="0"/>
              <a:pPr/>
              <a:t>19</a:t>
            </a:fld>
            <a:endParaRPr lang="en-US"/>
          </a:p>
        </p:txBody>
      </p:sp>
      <p:pic>
        <p:nvPicPr>
          <p:cNvPr id="6" name="Picture 6" descr="A white grid with black text&#10;&#10;Description automatically generated">
            <a:extLst>
              <a:ext uri="{FF2B5EF4-FFF2-40B4-BE49-F238E27FC236}">
                <a16:creationId xmlns:a16="http://schemas.microsoft.com/office/drawing/2014/main" id="{35093BD4-11DB-4A2E-6351-B3F6DE10CF86}"/>
              </a:ext>
            </a:extLst>
          </p:cNvPr>
          <p:cNvPicPr>
            <a:picLocks noChangeAspect="1"/>
          </p:cNvPicPr>
          <p:nvPr/>
        </p:nvPicPr>
        <p:blipFill>
          <a:blip r:embed="rId3"/>
          <a:stretch>
            <a:fillRect/>
          </a:stretch>
        </p:blipFill>
        <p:spPr>
          <a:xfrm>
            <a:off x="781455" y="236694"/>
            <a:ext cx="11228960" cy="6376505"/>
          </a:xfrm>
          <a:prstGeom prst="rect">
            <a:avLst/>
          </a:prstGeom>
        </p:spPr>
      </p:pic>
      <p:sp>
        <p:nvSpPr>
          <p:cNvPr id="2" name="Subtitle 20">
            <a:extLst>
              <a:ext uri="{FF2B5EF4-FFF2-40B4-BE49-F238E27FC236}">
                <a16:creationId xmlns:a16="http://schemas.microsoft.com/office/drawing/2014/main" id="{4FDF9F26-9811-4347-98E7-534FB82FB0D1}"/>
              </a:ext>
            </a:extLst>
          </p:cNvPr>
          <p:cNvSpPr txBox="1">
            <a:spLocks/>
          </p:cNvSpPr>
          <p:nvPr/>
        </p:nvSpPr>
        <p:spPr>
          <a:xfrm>
            <a:off x="2092994" y="6631767"/>
            <a:ext cx="8006007" cy="199310"/>
          </a:xfrm>
          <a:prstGeom prst="rect">
            <a:avLst/>
          </a:prstGeom>
        </p:spPr>
        <p:txBody>
          <a:bodyPr/>
          <a:lstStyle>
            <a:lvl1pPr marL="230183" indent="-230183" algn="l" defTabSz="342892" rtl="0" eaLnBrk="1" latinLnBrk="0" hangingPunct="1">
              <a:lnSpc>
                <a:spcPct val="100000"/>
              </a:lnSpc>
              <a:spcBef>
                <a:spcPts val="800"/>
              </a:spcBef>
              <a:buClr>
                <a:schemeClr val="tx2"/>
              </a:buClr>
              <a:buFont typeface="Arial"/>
              <a:buChar char="•"/>
              <a:defRPr sz="1600" kern="1200">
                <a:solidFill>
                  <a:schemeClr val="tx1"/>
                </a:solidFill>
                <a:latin typeface="+mn-lt"/>
                <a:ea typeface="+mn-ea"/>
                <a:cs typeface="+mn-cs"/>
              </a:defRPr>
            </a:lvl1pPr>
            <a:lvl2pPr marL="457189" indent="-231770" algn="l" defTabSz="342892" rtl="0" eaLnBrk="1" latinLnBrk="0" hangingPunct="1">
              <a:lnSpc>
                <a:spcPct val="100000"/>
              </a:lnSpc>
              <a:spcBef>
                <a:spcPts val="800"/>
              </a:spcBef>
              <a:buClr>
                <a:schemeClr val="tx2"/>
              </a:buClr>
              <a:buFont typeface="Arial"/>
              <a:buChar char="–"/>
              <a:defRPr sz="1400" kern="1200">
                <a:solidFill>
                  <a:schemeClr val="tx1"/>
                </a:solidFill>
                <a:latin typeface="+mn-lt"/>
                <a:ea typeface="+mn-ea"/>
                <a:cs typeface="+mn-cs"/>
              </a:defRPr>
            </a:lvl2pPr>
            <a:lvl3pPr marL="684196" indent="-228594" algn="l" defTabSz="342892" rtl="0" eaLnBrk="1" latinLnBrk="0" hangingPunct="1">
              <a:lnSpc>
                <a:spcPct val="100000"/>
              </a:lnSpc>
              <a:spcBef>
                <a:spcPts val="800"/>
              </a:spcBef>
              <a:buClr>
                <a:schemeClr val="tx2"/>
              </a:buClr>
              <a:buFont typeface="Arial"/>
              <a:buChar char="•"/>
              <a:defRPr sz="1200" kern="1200">
                <a:solidFill>
                  <a:schemeClr val="tx1"/>
                </a:solidFill>
                <a:latin typeface="+mn-lt"/>
                <a:ea typeface="+mn-ea"/>
                <a:cs typeface="+mn-cs"/>
              </a:defRPr>
            </a:lvl3pPr>
            <a:lvl4pPr marL="914378" indent="-230183" algn="l" defTabSz="342892" rtl="0" eaLnBrk="1" latinLnBrk="0" hangingPunct="1">
              <a:lnSpc>
                <a:spcPct val="100000"/>
              </a:lnSpc>
              <a:spcBef>
                <a:spcPts val="800"/>
              </a:spcBef>
              <a:buClr>
                <a:schemeClr val="tx2"/>
              </a:buClr>
              <a:buFont typeface="Arial"/>
              <a:buChar char="–"/>
              <a:defRPr sz="1200" kern="1200">
                <a:solidFill>
                  <a:schemeClr val="tx1"/>
                </a:solidFill>
                <a:latin typeface="+mn-lt"/>
                <a:ea typeface="+mn-ea"/>
                <a:cs typeface="+mn-cs"/>
              </a:defRPr>
            </a:lvl4pPr>
            <a:lvl5pPr marL="1144559" indent="-230183" algn="l" defTabSz="342892" rtl="0" eaLnBrk="1" latinLnBrk="0" hangingPunct="1">
              <a:lnSpc>
                <a:spcPct val="100000"/>
              </a:lnSpc>
              <a:spcBef>
                <a:spcPts val="800"/>
              </a:spcBef>
              <a:buClr>
                <a:schemeClr val="tx2"/>
              </a:buClr>
              <a:buFont typeface="Arial" panose="020B0604020202020204" pitchFamily="34" charset="0"/>
              <a:buChar char="•"/>
              <a:defRPr sz="1200" kern="1200">
                <a:solidFill>
                  <a:schemeClr val="tx1"/>
                </a:solidFill>
                <a:latin typeface="+mn-lt"/>
                <a:ea typeface="+mn-ea"/>
                <a:cs typeface="+mn-cs"/>
              </a:defRPr>
            </a:lvl5pPr>
            <a:lvl6pPr marL="1885903" indent="-171446" algn="l" defTabSz="342892" rtl="0" eaLnBrk="1" latinLnBrk="0" hangingPunct="1">
              <a:spcBef>
                <a:spcPct val="20000"/>
              </a:spcBef>
              <a:buFont typeface="Arial"/>
              <a:buChar char="•"/>
              <a:defRPr sz="1500" kern="1200">
                <a:solidFill>
                  <a:schemeClr val="tx1"/>
                </a:solidFill>
                <a:latin typeface="+mn-lt"/>
                <a:ea typeface="+mn-ea"/>
                <a:cs typeface="+mn-cs"/>
              </a:defRPr>
            </a:lvl6pPr>
            <a:lvl7pPr marL="2228795" indent="-171446" algn="l" defTabSz="342892" rtl="0" eaLnBrk="1" latinLnBrk="0" hangingPunct="1">
              <a:spcBef>
                <a:spcPct val="20000"/>
              </a:spcBef>
              <a:buFont typeface="Arial"/>
              <a:buChar char="•"/>
              <a:defRPr sz="1500" kern="1200">
                <a:solidFill>
                  <a:schemeClr val="tx1"/>
                </a:solidFill>
                <a:latin typeface="+mn-lt"/>
                <a:ea typeface="+mn-ea"/>
                <a:cs typeface="+mn-cs"/>
              </a:defRPr>
            </a:lvl7pPr>
            <a:lvl8pPr marL="2571686" indent="-171446" algn="l" defTabSz="342892" rtl="0" eaLnBrk="1" latinLnBrk="0" hangingPunct="1">
              <a:spcBef>
                <a:spcPct val="20000"/>
              </a:spcBef>
              <a:buFont typeface="Arial"/>
              <a:buChar char="•"/>
              <a:defRPr sz="1500" kern="1200">
                <a:solidFill>
                  <a:schemeClr val="tx1"/>
                </a:solidFill>
                <a:latin typeface="+mn-lt"/>
                <a:ea typeface="+mn-ea"/>
                <a:cs typeface="+mn-cs"/>
              </a:defRPr>
            </a:lvl8pPr>
            <a:lvl9pPr marL="2914577" indent="-171446" algn="l" defTabSz="342892" rtl="0" eaLnBrk="1" latinLnBrk="0" hangingPunct="1">
              <a:spcBef>
                <a:spcPct val="20000"/>
              </a:spcBef>
              <a:buFont typeface="Arial"/>
              <a:buChar char="•"/>
              <a:defRPr sz="1500" kern="1200">
                <a:solidFill>
                  <a:schemeClr val="tx1"/>
                </a:solidFill>
                <a:latin typeface="+mn-lt"/>
                <a:ea typeface="+mn-ea"/>
                <a:cs typeface="+mn-cs"/>
              </a:defRPr>
            </a:lvl9pPr>
          </a:lstStyle>
          <a:p>
            <a:pPr marL="0" indent="0" algn="ctr">
              <a:buNone/>
            </a:pPr>
            <a:r>
              <a:rPr lang="en-US" sz="900" dirty="0"/>
              <a:t>FPF Simulation Assessment Tool Developed by Ellen Duncan MD, PhD, Joanne Agnant MD, MSc, and Selin T. Sagalowsky, MD, MPH</a:t>
            </a:r>
            <a:endParaRPr lang="en-US" sz="900" dirty="0">
              <a:cs typeface="Arial"/>
            </a:endParaRPr>
          </a:p>
        </p:txBody>
      </p:sp>
    </p:spTree>
    <p:extLst>
      <p:ext uri="{BB962C8B-B14F-4D97-AF65-F5344CB8AC3E}">
        <p14:creationId xmlns:p14="http://schemas.microsoft.com/office/powerpoint/2010/main" val="243148423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E62F8B3-52F4-4267-8390-7BEAA3A7A6AB}"/>
              </a:ext>
            </a:extLst>
          </p:cNvPr>
          <p:cNvSpPr>
            <a:spLocks noGrp="1"/>
          </p:cNvSpPr>
          <p:nvPr>
            <p:ph type="title"/>
          </p:nvPr>
        </p:nvSpPr>
        <p:spPr/>
        <p:txBody>
          <a:bodyPr/>
          <a:lstStyle/>
          <a:p>
            <a:r>
              <a:rPr lang="en-US" dirty="0">
                <a:cs typeface="Arial"/>
              </a:rPr>
              <a:t>**CONTENT </a:t>
            </a:r>
            <a:r>
              <a:rPr lang="en-US">
                <a:cs typeface="Arial"/>
              </a:rPr>
              <a:t>ADVISORY &amp; TRAUMA INFORMED CARE**</a:t>
            </a:r>
            <a:endParaRPr lang="en-US"/>
          </a:p>
        </p:txBody>
      </p:sp>
      <p:sp>
        <p:nvSpPr>
          <p:cNvPr id="3" name="Content Placeholder 2">
            <a:extLst>
              <a:ext uri="{FF2B5EF4-FFF2-40B4-BE49-F238E27FC236}">
                <a16:creationId xmlns:a16="http://schemas.microsoft.com/office/drawing/2014/main" id="{A339D4AF-8E0D-40A6-88D1-785C765D71A9}"/>
              </a:ext>
            </a:extLst>
          </p:cNvPr>
          <p:cNvSpPr>
            <a:spLocks noGrp="1"/>
          </p:cNvSpPr>
          <p:nvPr>
            <p:ph sz="quarter" idx="13"/>
          </p:nvPr>
        </p:nvSpPr>
        <p:spPr/>
        <p:txBody>
          <a:bodyPr vert="horz" lIns="0" tIns="0" rIns="0" bIns="0" rtlCol="0" anchor="t">
            <a:noAutofit/>
          </a:bodyPr>
          <a:lstStyle/>
          <a:p>
            <a:pPr marL="0" indent="0" algn="ctr">
              <a:lnSpc>
                <a:spcPct val="150000"/>
              </a:lnSpc>
              <a:buNone/>
            </a:pPr>
            <a:r>
              <a:rPr lang="en-US" sz="2667" dirty="0">
                <a:ea typeface="+mn-lt"/>
                <a:cs typeface="+mn-lt"/>
              </a:rPr>
              <a:t>The following scenarios involve emotionally challenging situations. We have all been patients, and many are parents; portraying the role of family member to a child who is critically ill or dying is a sensitive topic, especially so if you have experienced trauma in your own life. Please let us know at any point if you need to take a break, leave the training, and/or stop your participation in this program. Your feedback about the cases, roles, learners, and overall curriculum is invaluable.</a:t>
            </a:r>
            <a:endParaRPr lang="en-US" dirty="0"/>
          </a:p>
          <a:p>
            <a:pPr marL="306486" indent="-306486">
              <a:lnSpc>
                <a:spcPct val="150000"/>
              </a:lnSpc>
            </a:pPr>
            <a:endParaRPr lang="en-US" sz="2667" dirty="0">
              <a:cs typeface="Arial"/>
            </a:endParaRPr>
          </a:p>
        </p:txBody>
      </p:sp>
      <p:sp>
        <p:nvSpPr>
          <p:cNvPr id="5" name="Slide Number Placeholder 4">
            <a:extLst>
              <a:ext uri="{FF2B5EF4-FFF2-40B4-BE49-F238E27FC236}">
                <a16:creationId xmlns:a16="http://schemas.microsoft.com/office/drawing/2014/main" id="{46897AAD-5FB7-468E-9C33-C242EAFC2D9F}"/>
              </a:ext>
            </a:extLst>
          </p:cNvPr>
          <p:cNvSpPr>
            <a:spLocks noGrp="1"/>
          </p:cNvSpPr>
          <p:nvPr>
            <p:ph type="sldNum" sz="quarter" idx="4"/>
          </p:nvPr>
        </p:nvSpPr>
        <p:spPr/>
        <p:txBody>
          <a:bodyPr/>
          <a:lstStyle/>
          <a:p>
            <a:fld id="{7FEEEA1A-CB49-3744-AA40-B896987410F9}" type="slidenum">
              <a:rPr lang="en-US" smtClean="0"/>
              <a:pPr/>
              <a:t>2</a:t>
            </a:fld>
            <a:endParaRPr lang="en-US"/>
          </a:p>
        </p:txBody>
      </p:sp>
    </p:spTree>
    <p:extLst>
      <p:ext uri="{BB962C8B-B14F-4D97-AF65-F5344CB8AC3E}">
        <p14:creationId xmlns:p14="http://schemas.microsoft.com/office/powerpoint/2010/main" val="2340474459"/>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lide Number Placeholder 2">
            <a:extLst>
              <a:ext uri="{FF2B5EF4-FFF2-40B4-BE49-F238E27FC236}">
                <a16:creationId xmlns:a16="http://schemas.microsoft.com/office/drawing/2014/main" id="{BD4FA4BF-8E70-D26F-9728-5FF3C6FEB0EF}"/>
              </a:ext>
            </a:extLst>
          </p:cNvPr>
          <p:cNvSpPr>
            <a:spLocks noGrp="1"/>
          </p:cNvSpPr>
          <p:nvPr>
            <p:ph type="sldNum" sz="quarter" idx="4"/>
          </p:nvPr>
        </p:nvSpPr>
        <p:spPr/>
        <p:txBody>
          <a:bodyPr/>
          <a:lstStyle/>
          <a:p>
            <a:fld id="{7FEEEA1A-CB49-3744-AA40-B896987410F9}" type="slidenum">
              <a:rPr lang="en-US" smtClean="0"/>
              <a:pPr/>
              <a:t>20</a:t>
            </a:fld>
            <a:endParaRPr lang="en-US"/>
          </a:p>
        </p:txBody>
      </p:sp>
      <p:pic>
        <p:nvPicPr>
          <p:cNvPr id="6" name="Picture 6" descr="A table of white squares with black text&#10;&#10;Description automatically generated">
            <a:extLst>
              <a:ext uri="{FF2B5EF4-FFF2-40B4-BE49-F238E27FC236}">
                <a16:creationId xmlns:a16="http://schemas.microsoft.com/office/drawing/2014/main" id="{D2925B5C-655C-8507-DC8D-85E546E84BEB}"/>
              </a:ext>
            </a:extLst>
          </p:cNvPr>
          <p:cNvPicPr>
            <a:picLocks noChangeAspect="1"/>
          </p:cNvPicPr>
          <p:nvPr/>
        </p:nvPicPr>
        <p:blipFill>
          <a:blip r:embed="rId3"/>
          <a:stretch>
            <a:fillRect/>
          </a:stretch>
        </p:blipFill>
        <p:spPr>
          <a:xfrm>
            <a:off x="400457" y="786382"/>
            <a:ext cx="11382983" cy="4888023"/>
          </a:xfrm>
          <a:prstGeom prst="rect">
            <a:avLst/>
          </a:prstGeom>
        </p:spPr>
      </p:pic>
      <p:sp>
        <p:nvSpPr>
          <p:cNvPr id="2" name="Subtitle 20">
            <a:extLst>
              <a:ext uri="{FF2B5EF4-FFF2-40B4-BE49-F238E27FC236}">
                <a16:creationId xmlns:a16="http://schemas.microsoft.com/office/drawing/2014/main" id="{D6482D98-C247-5363-394C-D07C8D760374}"/>
              </a:ext>
            </a:extLst>
          </p:cNvPr>
          <p:cNvSpPr txBox="1">
            <a:spLocks/>
          </p:cNvSpPr>
          <p:nvPr/>
        </p:nvSpPr>
        <p:spPr>
          <a:xfrm>
            <a:off x="2092994" y="6631767"/>
            <a:ext cx="8006007" cy="199310"/>
          </a:xfrm>
          <a:prstGeom prst="rect">
            <a:avLst/>
          </a:prstGeom>
        </p:spPr>
        <p:txBody>
          <a:bodyPr/>
          <a:lstStyle>
            <a:lvl1pPr marL="230183" indent="-230183" algn="l" defTabSz="342892" rtl="0" eaLnBrk="1" latinLnBrk="0" hangingPunct="1">
              <a:lnSpc>
                <a:spcPct val="100000"/>
              </a:lnSpc>
              <a:spcBef>
                <a:spcPts val="800"/>
              </a:spcBef>
              <a:buClr>
                <a:schemeClr val="tx2"/>
              </a:buClr>
              <a:buFont typeface="Arial"/>
              <a:buChar char="•"/>
              <a:defRPr sz="1600" kern="1200">
                <a:solidFill>
                  <a:schemeClr val="tx1"/>
                </a:solidFill>
                <a:latin typeface="+mn-lt"/>
                <a:ea typeface="+mn-ea"/>
                <a:cs typeface="+mn-cs"/>
              </a:defRPr>
            </a:lvl1pPr>
            <a:lvl2pPr marL="457189" indent="-231770" algn="l" defTabSz="342892" rtl="0" eaLnBrk="1" latinLnBrk="0" hangingPunct="1">
              <a:lnSpc>
                <a:spcPct val="100000"/>
              </a:lnSpc>
              <a:spcBef>
                <a:spcPts val="800"/>
              </a:spcBef>
              <a:buClr>
                <a:schemeClr val="tx2"/>
              </a:buClr>
              <a:buFont typeface="Arial"/>
              <a:buChar char="–"/>
              <a:defRPr sz="1400" kern="1200">
                <a:solidFill>
                  <a:schemeClr val="tx1"/>
                </a:solidFill>
                <a:latin typeface="+mn-lt"/>
                <a:ea typeface="+mn-ea"/>
                <a:cs typeface="+mn-cs"/>
              </a:defRPr>
            </a:lvl2pPr>
            <a:lvl3pPr marL="684196" indent="-228594" algn="l" defTabSz="342892" rtl="0" eaLnBrk="1" latinLnBrk="0" hangingPunct="1">
              <a:lnSpc>
                <a:spcPct val="100000"/>
              </a:lnSpc>
              <a:spcBef>
                <a:spcPts val="800"/>
              </a:spcBef>
              <a:buClr>
                <a:schemeClr val="tx2"/>
              </a:buClr>
              <a:buFont typeface="Arial"/>
              <a:buChar char="•"/>
              <a:defRPr sz="1200" kern="1200">
                <a:solidFill>
                  <a:schemeClr val="tx1"/>
                </a:solidFill>
                <a:latin typeface="+mn-lt"/>
                <a:ea typeface="+mn-ea"/>
                <a:cs typeface="+mn-cs"/>
              </a:defRPr>
            </a:lvl3pPr>
            <a:lvl4pPr marL="914378" indent="-230183" algn="l" defTabSz="342892" rtl="0" eaLnBrk="1" latinLnBrk="0" hangingPunct="1">
              <a:lnSpc>
                <a:spcPct val="100000"/>
              </a:lnSpc>
              <a:spcBef>
                <a:spcPts val="800"/>
              </a:spcBef>
              <a:buClr>
                <a:schemeClr val="tx2"/>
              </a:buClr>
              <a:buFont typeface="Arial"/>
              <a:buChar char="–"/>
              <a:defRPr sz="1200" kern="1200">
                <a:solidFill>
                  <a:schemeClr val="tx1"/>
                </a:solidFill>
                <a:latin typeface="+mn-lt"/>
                <a:ea typeface="+mn-ea"/>
                <a:cs typeface="+mn-cs"/>
              </a:defRPr>
            </a:lvl4pPr>
            <a:lvl5pPr marL="1144559" indent="-230183" algn="l" defTabSz="342892" rtl="0" eaLnBrk="1" latinLnBrk="0" hangingPunct="1">
              <a:lnSpc>
                <a:spcPct val="100000"/>
              </a:lnSpc>
              <a:spcBef>
                <a:spcPts val="800"/>
              </a:spcBef>
              <a:buClr>
                <a:schemeClr val="tx2"/>
              </a:buClr>
              <a:buFont typeface="Arial" panose="020B0604020202020204" pitchFamily="34" charset="0"/>
              <a:buChar char="•"/>
              <a:defRPr sz="1200" kern="1200">
                <a:solidFill>
                  <a:schemeClr val="tx1"/>
                </a:solidFill>
                <a:latin typeface="+mn-lt"/>
                <a:ea typeface="+mn-ea"/>
                <a:cs typeface="+mn-cs"/>
              </a:defRPr>
            </a:lvl5pPr>
            <a:lvl6pPr marL="1885903" indent="-171446" algn="l" defTabSz="342892" rtl="0" eaLnBrk="1" latinLnBrk="0" hangingPunct="1">
              <a:spcBef>
                <a:spcPct val="20000"/>
              </a:spcBef>
              <a:buFont typeface="Arial"/>
              <a:buChar char="•"/>
              <a:defRPr sz="1500" kern="1200">
                <a:solidFill>
                  <a:schemeClr val="tx1"/>
                </a:solidFill>
                <a:latin typeface="+mn-lt"/>
                <a:ea typeface="+mn-ea"/>
                <a:cs typeface="+mn-cs"/>
              </a:defRPr>
            </a:lvl6pPr>
            <a:lvl7pPr marL="2228795" indent="-171446" algn="l" defTabSz="342892" rtl="0" eaLnBrk="1" latinLnBrk="0" hangingPunct="1">
              <a:spcBef>
                <a:spcPct val="20000"/>
              </a:spcBef>
              <a:buFont typeface="Arial"/>
              <a:buChar char="•"/>
              <a:defRPr sz="1500" kern="1200">
                <a:solidFill>
                  <a:schemeClr val="tx1"/>
                </a:solidFill>
                <a:latin typeface="+mn-lt"/>
                <a:ea typeface="+mn-ea"/>
                <a:cs typeface="+mn-cs"/>
              </a:defRPr>
            </a:lvl7pPr>
            <a:lvl8pPr marL="2571686" indent="-171446" algn="l" defTabSz="342892" rtl="0" eaLnBrk="1" latinLnBrk="0" hangingPunct="1">
              <a:spcBef>
                <a:spcPct val="20000"/>
              </a:spcBef>
              <a:buFont typeface="Arial"/>
              <a:buChar char="•"/>
              <a:defRPr sz="1500" kern="1200">
                <a:solidFill>
                  <a:schemeClr val="tx1"/>
                </a:solidFill>
                <a:latin typeface="+mn-lt"/>
                <a:ea typeface="+mn-ea"/>
                <a:cs typeface="+mn-cs"/>
              </a:defRPr>
            </a:lvl8pPr>
            <a:lvl9pPr marL="2914577" indent="-171446" algn="l" defTabSz="342892" rtl="0" eaLnBrk="1" latinLnBrk="0" hangingPunct="1">
              <a:spcBef>
                <a:spcPct val="20000"/>
              </a:spcBef>
              <a:buFont typeface="Arial"/>
              <a:buChar char="•"/>
              <a:defRPr sz="1500" kern="1200">
                <a:solidFill>
                  <a:schemeClr val="tx1"/>
                </a:solidFill>
                <a:latin typeface="+mn-lt"/>
                <a:ea typeface="+mn-ea"/>
                <a:cs typeface="+mn-cs"/>
              </a:defRPr>
            </a:lvl9pPr>
          </a:lstStyle>
          <a:p>
            <a:pPr marL="0" indent="0" algn="ctr">
              <a:buNone/>
            </a:pPr>
            <a:r>
              <a:rPr lang="en-US" sz="900" dirty="0"/>
              <a:t>FPF Simulation Assessment Tool Developed by Ellen Duncan MD, PhD, Joanne Agnant MD, MSc, and Selin T. Sagalowsky, MD, MPH</a:t>
            </a:r>
            <a:endParaRPr lang="en-US" sz="900" dirty="0">
              <a:cs typeface="Arial"/>
            </a:endParaRPr>
          </a:p>
        </p:txBody>
      </p:sp>
    </p:spTree>
    <p:extLst>
      <p:ext uri="{BB962C8B-B14F-4D97-AF65-F5344CB8AC3E}">
        <p14:creationId xmlns:p14="http://schemas.microsoft.com/office/powerpoint/2010/main" val="28464993"/>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itle 8"/>
          <p:cNvSpPr>
            <a:spLocks noGrp="1"/>
          </p:cNvSpPr>
          <p:nvPr>
            <p:ph type="title"/>
          </p:nvPr>
        </p:nvSpPr>
        <p:spPr>
          <a:xfrm>
            <a:off x="609599" y="965385"/>
            <a:ext cx="10972803" cy="418576"/>
          </a:xfrm>
        </p:spPr>
        <p:txBody>
          <a:bodyPr/>
          <a:lstStyle/>
          <a:p>
            <a:r>
              <a:rPr lang="en-US" sz="3700"/>
              <a:t>Outline</a:t>
            </a:r>
          </a:p>
        </p:txBody>
      </p:sp>
      <p:sp>
        <p:nvSpPr>
          <p:cNvPr id="14" name="Content Placeholder 13"/>
          <p:cNvSpPr>
            <a:spLocks noGrp="1"/>
          </p:cNvSpPr>
          <p:nvPr>
            <p:ph sz="quarter" idx="13"/>
          </p:nvPr>
        </p:nvSpPr>
        <p:spPr>
          <a:xfrm>
            <a:off x="609600" y="1563053"/>
            <a:ext cx="10972801" cy="4737116"/>
          </a:xfrm>
        </p:spPr>
        <p:txBody>
          <a:bodyPr vert="horz" lIns="0" tIns="0" rIns="0" bIns="0" rtlCol="0" anchor="t">
            <a:noAutofit/>
          </a:bodyPr>
          <a:lstStyle/>
          <a:p>
            <a:pPr marL="306070" indent="-306070">
              <a:lnSpc>
                <a:spcPct val="150000"/>
              </a:lnSpc>
              <a:spcBef>
                <a:spcPts val="800"/>
              </a:spcBef>
            </a:pPr>
            <a:r>
              <a:rPr lang="en-US" sz="2700" dirty="0">
                <a:ea typeface="+mn-lt"/>
                <a:cs typeface="+mn-lt"/>
              </a:rPr>
              <a:t>Overview</a:t>
            </a:r>
          </a:p>
          <a:p>
            <a:pPr marL="306070" indent="-306070">
              <a:lnSpc>
                <a:spcPct val="150000"/>
              </a:lnSpc>
              <a:spcBef>
                <a:spcPts val="800"/>
              </a:spcBef>
            </a:pPr>
            <a:r>
              <a:rPr lang="en-US" sz="2700" dirty="0"/>
              <a:t>Personality Traits</a:t>
            </a:r>
            <a:endParaRPr lang="en-US" sz="2700" dirty="0">
              <a:ea typeface="+mn-lt"/>
              <a:cs typeface="+mn-lt"/>
            </a:endParaRPr>
          </a:p>
          <a:p>
            <a:pPr marL="306070" indent="-306070">
              <a:lnSpc>
                <a:spcPct val="150000"/>
              </a:lnSpc>
              <a:spcBef>
                <a:spcPts val="800"/>
              </a:spcBef>
            </a:pPr>
            <a:r>
              <a:rPr lang="en-US" sz="2700" dirty="0">
                <a:ea typeface="+mn-lt"/>
                <a:cs typeface="+mn-lt"/>
              </a:rPr>
              <a:t>Observer Tool</a:t>
            </a:r>
          </a:p>
          <a:p>
            <a:pPr marL="306070" indent="-306070">
              <a:lnSpc>
                <a:spcPct val="150000"/>
              </a:lnSpc>
              <a:spcBef>
                <a:spcPts val="800"/>
              </a:spcBef>
            </a:pPr>
            <a:r>
              <a:rPr lang="en-US" sz="2700" dirty="0">
                <a:solidFill>
                  <a:srgbClr val="9E2FED"/>
                </a:solidFill>
                <a:ea typeface="+mn-lt"/>
                <a:cs typeface="+mn-lt"/>
              </a:rPr>
              <a:t>Practice!</a:t>
            </a:r>
          </a:p>
          <a:p>
            <a:pPr marL="306070" indent="-306070">
              <a:lnSpc>
                <a:spcPct val="150000"/>
              </a:lnSpc>
              <a:spcBef>
                <a:spcPts val="800"/>
              </a:spcBef>
            </a:pPr>
            <a:r>
              <a:rPr lang="en-US" sz="2700" dirty="0">
                <a:ea typeface="+mn-lt"/>
                <a:cs typeface="+mn-lt"/>
              </a:rPr>
              <a:t>Summary</a:t>
            </a:r>
          </a:p>
          <a:p>
            <a:pPr marL="306070" indent="-306070">
              <a:spcBef>
                <a:spcPts val="800"/>
              </a:spcBef>
            </a:pPr>
            <a:endParaRPr lang="en-US" sz="2700" dirty="0">
              <a:ea typeface="+mn-lt"/>
              <a:cs typeface="+mn-lt"/>
            </a:endParaRPr>
          </a:p>
          <a:p>
            <a:pPr marL="306070" indent="-306070">
              <a:spcBef>
                <a:spcPts val="800"/>
              </a:spcBef>
            </a:pPr>
            <a:endParaRPr lang="en-US" sz="2700" dirty="0">
              <a:ea typeface="+mn-lt"/>
              <a:cs typeface="+mn-lt"/>
            </a:endParaRPr>
          </a:p>
          <a:p>
            <a:pPr marL="306070" indent="-306070">
              <a:spcBef>
                <a:spcPts val="800"/>
              </a:spcBef>
            </a:pPr>
            <a:endParaRPr lang="en-US" sz="2700" dirty="0">
              <a:cs typeface="Arial"/>
            </a:endParaRPr>
          </a:p>
        </p:txBody>
      </p:sp>
      <p:sp>
        <p:nvSpPr>
          <p:cNvPr id="7" name="Slide Number Placeholder 6"/>
          <p:cNvSpPr>
            <a:spLocks noGrp="1"/>
          </p:cNvSpPr>
          <p:nvPr>
            <p:ph type="sldNum" sz="quarter" idx="4"/>
          </p:nvPr>
        </p:nvSpPr>
        <p:spPr/>
        <p:txBody>
          <a:bodyPr/>
          <a:lstStyle/>
          <a:p>
            <a:fld id="{7FEEEA1A-CB49-3744-AA40-B896987410F9}" type="slidenum">
              <a:rPr lang="en-US" smtClean="0"/>
              <a:pPr/>
              <a:t>21</a:t>
            </a:fld>
            <a:endParaRPr lang="en-US"/>
          </a:p>
        </p:txBody>
      </p:sp>
    </p:spTree>
    <p:extLst>
      <p:ext uri="{BB962C8B-B14F-4D97-AF65-F5344CB8AC3E}">
        <p14:creationId xmlns:p14="http://schemas.microsoft.com/office/powerpoint/2010/main" val="4278517905"/>
      </p:ext>
    </p:extLst>
  </p:cSld>
  <p:clrMapOvr>
    <a:masterClrMapping/>
  </p:clrMapOvr>
  <mc:AlternateContent xmlns:mc="http://schemas.openxmlformats.org/markup-compatibility/2006" xmlns:p14="http://schemas.microsoft.com/office/powerpoint/2010/main">
    <mc:Choice Requires="p14">
      <p:transition spd="slow" p14:dur="2000" advTm="14008"/>
    </mc:Choice>
    <mc:Fallback xmlns="">
      <p:transition spd="slow" advTm="14008"/>
    </mc:Fallback>
  </mc:AlternateContent>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Title 14"/>
          <p:cNvSpPr>
            <a:spLocks noGrp="1"/>
          </p:cNvSpPr>
          <p:nvPr>
            <p:ph type="title"/>
          </p:nvPr>
        </p:nvSpPr>
        <p:spPr/>
        <p:txBody>
          <a:bodyPr vert="horz" lIns="0" tIns="0" rIns="0" bIns="0" rtlCol="0" anchor="ctr" anchorCtr="0">
            <a:noAutofit/>
          </a:bodyPr>
          <a:lstStyle/>
          <a:p>
            <a:r>
              <a:rPr lang="en-US" dirty="0"/>
              <a:t>Practice</a:t>
            </a:r>
          </a:p>
        </p:txBody>
      </p:sp>
    </p:spTree>
    <p:extLst>
      <p:ext uri="{BB962C8B-B14F-4D97-AF65-F5344CB8AC3E}">
        <p14:creationId xmlns:p14="http://schemas.microsoft.com/office/powerpoint/2010/main" val="4201050054"/>
      </p:ext>
    </p:extLst>
  </p:cSld>
  <p:clrMapOvr>
    <a:masterClrMapping/>
  </p:clrMapOvr>
  <mc:AlternateContent xmlns:mc="http://schemas.openxmlformats.org/markup-compatibility/2006" xmlns:p14="http://schemas.microsoft.com/office/powerpoint/2010/main">
    <mc:Choice Requires="p14">
      <p:transition spd="slow" p14:dur="2000" advTm="4009"/>
    </mc:Choice>
    <mc:Fallback xmlns="">
      <p:transition spd="slow" advTm="4009"/>
    </mc:Fallback>
  </mc:AlternateContent>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18C2E42-3D95-4A0E-B893-5689EF5D1002}"/>
              </a:ext>
            </a:extLst>
          </p:cNvPr>
          <p:cNvSpPr>
            <a:spLocks noGrp="1"/>
          </p:cNvSpPr>
          <p:nvPr>
            <p:ph type="title"/>
          </p:nvPr>
        </p:nvSpPr>
        <p:spPr/>
        <p:txBody>
          <a:bodyPr/>
          <a:lstStyle/>
          <a:p>
            <a:r>
              <a:rPr lang="en-US" sz="3700">
                <a:cs typeface="Arial"/>
              </a:rPr>
              <a:t>Hands-On Practice</a:t>
            </a:r>
          </a:p>
        </p:txBody>
      </p:sp>
      <p:sp>
        <p:nvSpPr>
          <p:cNvPr id="3" name="Content Placeholder 2">
            <a:extLst>
              <a:ext uri="{FF2B5EF4-FFF2-40B4-BE49-F238E27FC236}">
                <a16:creationId xmlns:a16="http://schemas.microsoft.com/office/drawing/2014/main" id="{F6E22F5D-1CB0-4E49-8321-D052EE985432}"/>
              </a:ext>
            </a:extLst>
          </p:cNvPr>
          <p:cNvSpPr>
            <a:spLocks noGrp="1"/>
          </p:cNvSpPr>
          <p:nvPr>
            <p:ph sz="quarter" idx="13"/>
          </p:nvPr>
        </p:nvSpPr>
        <p:spPr/>
        <p:txBody>
          <a:bodyPr vert="horz" lIns="0" tIns="0" rIns="0" bIns="0" rtlCol="0" anchor="t">
            <a:noAutofit/>
          </a:bodyPr>
          <a:lstStyle/>
          <a:p>
            <a:pPr marL="306070" indent="-306070">
              <a:lnSpc>
                <a:spcPct val="150000"/>
              </a:lnSpc>
            </a:pPr>
            <a:r>
              <a:rPr lang="en-US" sz="3200" dirty="0">
                <a:cs typeface="Arial"/>
              </a:rPr>
              <a:t>Please read the scripted resuscitations provided with this training</a:t>
            </a:r>
            <a:endParaRPr lang="en-US" dirty="0"/>
          </a:p>
          <a:p>
            <a:pPr marL="306070" indent="-306070">
              <a:lnSpc>
                <a:spcPct val="150000"/>
              </a:lnSpc>
            </a:pPr>
            <a:r>
              <a:rPr lang="en-US" sz="3200" dirty="0">
                <a:cs typeface="Arial"/>
              </a:rPr>
              <a:t>You will take turns role-playing each family member personality types (anxious, agitated, quiet) with an FPF </a:t>
            </a:r>
          </a:p>
          <a:p>
            <a:pPr marL="306070" indent="-306070">
              <a:lnSpc>
                <a:spcPct val="150000"/>
              </a:lnSpc>
            </a:pPr>
            <a:endParaRPr lang="en-US" sz="3200" dirty="0">
              <a:cs typeface="Arial"/>
            </a:endParaRPr>
          </a:p>
        </p:txBody>
      </p:sp>
      <p:sp>
        <p:nvSpPr>
          <p:cNvPr id="5" name="Slide Number Placeholder 4">
            <a:extLst>
              <a:ext uri="{FF2B5EF4-FFF2-40B4-BE49-F238E27FC236}">
                <a16:creationId xmlns:a16="http://schemas.microsoft.com/office/drawing/2014/main" id="{ADB6DC06-A7BB-47BF-98A7-F863210C07A3}"/>
              </a:ext>
            </a:extLst>
          </p:cNvPr>
          <p:cNvSpPr>
            <a:spLocks noGrp="1"/>
          </p:cNvSpPr>
          <p:nvPr>
            <p:ph type="sldNum" sz="quarter" idx="4"/>
          </p:nvPr>
        </p:nvSpPr>
        <p:spPr/>
        <p:txBody>
          <a:bodyPr/>
          <a:lstStyle/>
          <a:p>
            <a:fld id="{7FEEEA1A-CB49-3744-AA40-B896987410F9}" type="slidenum">
              <a:rPr lang="en-US" smtClean="0"/>
              <a:pPr/>
              <a:t>23</a:t>
            </a:fld>
            <a:endParaRPr lang="en-US"/>
          </a:p>
        </p:txBody>
      </p:sp>
    </p:spTree>
    <p:extLst>
      <p:ext uri="{BB962C8B-B14F-4D97-AF65-F5344CB8AC3E}">
        <p14:creationId xmlns:p14="http://schemas.microsoft.com/office/powerpoint/2010/main" val="2570269277"/>
      </p:ext>
    </p:extLst>
  </p:cSld>
  <p:clrMapOvr>
    <a:masterClrMapping/>
  </p:clrMapOvr>
  <mc:AlternateContent xmlns:mc="http://schemas.openxmlformats.org/markup-compatibility/2006" xmlns:p14="http://schemas.microsoft.com/office/powerpoint/2010/main">
    <mc:Choice Requires="p14">
      <p:transition spd="slow" p14:dur="2000" advTm="22029"/>
    </mc:Choice>
    <mc:Fallback xmlns="">
      <p:transition spd="slow" advTm="22029"/>
    </mc:Fallback>
  </mc:AlternateContent>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Title 14"/>
          <p:cNvSpPr>
            <a:spLocks noGrp="1"/>
          </p:cNvSpPr>
          <p:nvPr>
            <p:ph type="title"/>
          </p:nvPr>
        </p:nvSpPr>
        <p:spPr/>
        <p:txBody>
          <a:bodyPr vert="horz" lIns="0" tIns="0" rIns="0" bIns="0" rtlCol="0" anchor="ctr" anchorCtr="0">
            <a:noAutofit/>
          </a:bodyPr>
          <a:lstStyle/>
          <a:p>
            <a:r>
              <a:rPr lang="en-US" dirty="0"/>
              <a:t>Summary</a:t>
            </a:r>
          </a:p>
        </p:txBody>
      </p:sp>
    </p:spTree>
    <p:extLst>
      <p:ext uri="{BB962C8B-B14F-4D97-AF65-F5344CB8AC3E}">
        <p14:creationId xmlns:p14="http://schemas.microsoft.com/office/powerpoint/2010/main" val="3584599968"/>
      </p:ext>
    </p:extLst>
  </p:cSld>
  <p:clrMapOvr>
    <a:masterClrMapping/>
  </p:clrMapOvr>
  <mc:AlternateContent xmlns:mc="http://schemas.openxmlformats.org/markup-compatibility/2006" xmlns:p14="http://schemas.microsoft.com/office/powerpoint/2010/main">
    <mc:Choice Requires="p14">
      <p:transition spd="slow" p14:dur="2000" advTm="7356"/>
    </mc:Choice>
    <mc:Fallback xmlns="">
      <p:transition spd="slow" advTm="7356"/>
    </mc:Fallback>
  </mc:AlternateContent>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3" name="Content Placeholder 52"/>
          <p:cNvSpPr>
            <a:spLocks noGrp="1"/>
          </p:cNvSpPr>
          <p:nvPr>
            <p:ph sz="quarter" idx="12"/>
          </p:nvPr>
        </p:nvSpPr>
        <p:spPr>
          <a:xfrm>
            <a:off x="6986760" y="2578998"/>
            <a:ext cx="4930545" cy="1712609"/>
          </a:xfrm>
        </p:spPr>
        <p:txBody>
          <a:bodyPr vert="horz" lIns="0" tIns="0" rIns="0" bIns="0" rtlCol="0" anchor="t">
            <a:noAutofit/>
          </a:bodyPr>
          <a:lstStyle/>
          <a:p>
            <a:r>
              <a:rPr lang="en-US" sz="2800" b="0" dirty="0">
                <a:ea typeface="+mn-lt"/>
                <a:cs typeface="+mn-lt"/>
              </a:rPr>
              <a:t>"Good words are worth much, and cost little."</a:t>
            </a:r>
          </a:p>
          <a:p>
            <a:pPr algn="r"/>
            <a:r>
              <a:rPr lang="en-US" sz="2800" b="0" dirty="0">
                <a:ea typeface="+mn-lt"/>
                <a:cs typeface="+mn-lt"/>
              </a:rPr>
              <a:t>- George Herbert</a:t>
            </a:r>
          </a:p>
        </p:txBody>
      </p:sp>
      <p:sp>
        <p:nvSpPr>
          <p:cNvPr id="3" name="Slide Number Placeholder 2"/>
          <p:cNvSpPr>
            <a:spLocks noGrp="1"/>
          </p:cNvSpPr>
          <p:nvPr>
            <p:ph type="sldNum" sz="quarter" idx="4"/>
          </p:nvPr>
        </p:nvSpPr>
        <p:spPr/>
        <p:txBody>
          <a:bodyPr/>
          <a:lstStyle/>
          <a:p>
            <a:fld id="{7FEEEA1A-CB49-3744-AA40-B896987410F9}" type="slidenum">
              <a:rPr lang="en-US" smtClean="0"/>
              <a:pPr/>
              <a:t>25</a:t>
            </a:fld>
            <a:endParaRPr lang="en-US"/>
          </a:p>
        </p:txBody>
      </p:sp>
      <p:sp>
        <p:nvSpPr>
          <p:cNvPr id="6" name="Title 5"/>
          <p:cNvSpPr>
            <a:spLocks noGrp="1"/>
          </p:cNvSpPr>
          <p:nvPr>
            <p:ph type="title"/>
          </p:nvPr>
        </p:nvSpPr>
        <p:spPr>
          <a:xfrm>
            <a:off x="609595" y="451287"/>
            <a:ext cx="5481565" cy="648749"/>
          </a:xfrm>
        </p:spPr>
        <p:txBody>
          <a:bodyPr/>
          <a:lstStyle/>
          <a:p>
            <a:r>
              <a:rPr lang="en-US" sz="3200"/>
              <a:t>Summary</a:t>
            </a:r>
            <a:endParaRPr lang="en-US" sz="3200">
              <a:cs typeface="Arial"/>
            </a:endParaRPr>
          </a:p>
        </p:txBody>
      </p:sp>
      <p:sp>
        <p:nvSpPr>
          <p:cNvPr id="20" name="Content Placeholder 19"/>
          <p:cNvSpPr>
            <a:spLocks noGrp="1"/>
          </p:cNvSpPr>
          <p:nvPr>
            <p:ph sz="quarter" idx="11"/>
          </p:nvPr>
        </p:nvSpPr>
        <p:spPr>
          <a:xfrm>
            <a:off x="609600" y="1404883"/>
            <a:ext cx="5480381" cy="4721117"/>
          </a:xfrm>
        </p:spPr>
        <p:txBody>
          <a:bodyPr vert="horz" lIns="0" tIns="0" rIns="0" bIns="0" rtlCol="0" anchor="t">
            <a:noAutofit/>
          </a:bodyPr>
          <a:lstStyle/>
          <a:p>
            <a:pPr marL="306070" indent="-306070"/>
            <a:r>
              <a:rPr lang="en-US" sz="2400">
                <a:cs typeface="Arial"/>
              </a:rPr>
              <a:t>Supported family presence during pediatric resuscitations can benefit patients and family members, and is desired by most </a:t>
            </a:r>
          </a:p>
          <a:p>
            <a:pPr marL="306070" indent="-306070"/>
            <a:r>
              <a:rPr lang="en-US" sz="2400"/>
              <a:t>Key components of the FPF role include: showing respect &amp; value, thoughtful information sharing, appropriate nonverbal communication, and summary and follow-up</a:t>
            </a:r>
            <a:endParaRPr lang="en-US" sz="2400">
              <a:cs typeface="Arial"/>
            </a:endParaRPr>
          </a:p>
          <a:p>
            <a:pPr marL="306070" indent="-306070"/>
            <a:r>
              <a:rPr lang="en-US" sz="2400">
                <a:cs typeface="Arial"/>
              </a:rPr>
              <a:t>Involvement of SPs is crucial to help the team foster these essential skills</a:t>
            </a:r>
          </a:p>
        </p:txBody>
      </p:sp>
    </p:spTree>
    <p:extLst>
      <p:ext uri="{BB962C8B-B14F-4D97-AF65-F5344CB8AC3E}">
        <p14:creationId xmlns:p14="http://schemas.microsoft.com/office/powerpoint/2010/main" val="3187644739"/>
      </p:ext>
    </p:extLst>
  </p:cSld>
  <p:clrMapOvr>
    <a:masterClrMapping/>
  </p:clrMapOvr>
  <mc:AlternateContent xmlns:mc="http://schemas.openxmlformats.org/markup-compatibility/2006" xmlns:p14="http://schemas.microsoft.com/office/powerpoint/2010/main">
    <mc:Choice Requires="p14">
      <p:transition spd="slow" p14:dur="2000" advTm="28432"/>
    </mc:Choice>
    <mc:Fallback xmlns="">
      <p:transition spd="slow" advTm="28432"/>
    </mc:Fallback>
  </mc:AlternateContent>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0499AE-93A1-4920-8F86-1445FFC82CA2}"/>
              </a:ext>
            </a:extLst>
          </p:cNvPr>
          <p:cNvSpPr>
            <a:spLocks noGrp="1"/>
          </p:cNvSpPr>
          <p:nvPr>
            <p:ph type="title"/>
          </p:nvPr>
        </p:nvSpPr>
        <p:spPr>
          <a:xfrm>
            <a:off x="609599" y="530927"/>
            <a:ext cx="10972803" cy="418576"/>
          </a:xfrm>
        </p:spPr>
        <p:txBody>
          <a:bodyPr/>
          <a:lstStyle/>
          <a:p>
            <a:r>
              <a:rPr lang="en-US">
                <a:cs typeface="Arial"/>
              </a:rPr>
              <a:t>Resources</a:t>
            </a:r>
          </a:p>
        </p:txBody>
      </p:sp>
      <p:sp>
        <p:nvSpPr>
          <p:cNvPr id="3" name="Content Placeholder 2">
            <a:extLst>
              <a:ext uri="{FF2B5EF4-FFF2-40B4-BE49-F238E27FC236}">
                <a16:creationId xmlns:a16="http://schemas.microsoft.com/office/drawing/2014/main" id="{244448D8-6854-4C85-A320-33725E75611D}"/>
              </a:ext>
            </a:extLst>
          </p:cNvPr>
          <p:cNvSpPr>
            <a:spLocks noGrp="1"/>
          </p:cNvSpPr>
          <p:nvPr>
            <p:ph sz="quarter" idx="13"/>
          </p:nvPr>
        </p:nvSpPr>
        <p:spPr>
          <a:xfrm>
            <a:off x="644106" y="1244380"/>
            <a:ext cx="11211225" cy="5449591"/>
          </a:xfrm>
        </p:spPr>
        <p:txBody>
          <a:bodyPr vert="horz" lIns="0" tIns="0" rIns="0" bIns="0" rtlCol="0" anchor="t">
            <a:noAutofit/>
          </a:bodyPr>
          <a:lstStyle/>
          <a:p>
            <a:pPr marL="0" indent="-229870">
              <a:spcBef>
                <a:spcPts val="0"/>
              </a:spcBef>
              <a:spcAft>
                <a:spcPts val="500"/>
              </a:spcAft>
            </a:pPr>
            <a:r>
              <a:rPr lang="en-US" sz="1600" b="1" dirty="0">
                <a:ea typeface="+mn-lt"/>
                <a:cs typeface="+mn-lt"/>
              </a:rPr>
              <a:t>Trauma Informed Care Resources and De-</a:t>
            </a:r>
            <a:r>
              <a:rPr lang="en-US" sz="1600" b="1" dirty="0" err="1">
                <a:ea typeface="+mn-lt"/>
                <a:cs typeface="+mn-lt"/>
              </a:rPr>
              <a:t>Roling</a:t>
            </a:r>
            <a:endParaRPr lang="en-US" sz="1600" dirty="0">
              <a:ea typeface="+mn-lt"/>
              <a:cs typeface="+mn-lt"/>
            </a:endParaRPr>
          </a:p>
          <a:p>
            <a:pPr marL="683895" lvl="2" indent="-304165">
              <a:spcBef>
                <a:spcPts val="0"/>
              </a:spcBef>
              <a:spcAft>
                <a:spcPts val="500"/>
              </a:spcAft>
            </a:pPr>
            <a:r>
              <a:rPr lang="en-US" dirty="0">
                <a:ea typeface="+mn-lt"/>
                <a:cs typeface="+mn-lt"/>
                <a:hlinkClick r:id="rId2"/>
              </a:rPr>
              <a:t>https://www.traumainformedcare.chcs.org/</a:t>
            </a:r>
            <a:endParaRPr lang="en-US" dirty="0">
              <a:ea typeface="+mn-lt"/>
              <a:cs typeface="+mn-lt"/>
            </a:endParaRPr>
          </a:p>
          <a:p>
            <a:pPr marL="683895" lvl="2" indent="-304165">
              <a:spcBef>
                <a:spcPts val="0"/>
              </a:spcBef>
              <a:spcAft>
                <a:spcPts val="500"/>
              </a:spcAft>
            </a:pPr>
            <a:r>
              <a:rPr lang="en-US" dirty="0">
                <a:ea typeface="+mn-lt"/>
                <a:cs typeface="+mn-lt"/>
                <a:hlinkClick r:id="rId3"/>
              </a:rPr>
              <a:t>https://ncsacw.acf.hhs.gov/topics/trauma-informed-care.aspx</a:t>
            </a:r>
            <a:r>
              <a:rPr lang="en-US" dirty="0">
                <a:ea typeface="+mn-lt"/>
                <a:cs typeface="+mn-lt"/>
              </a:rPr>
              <a:t> </a:t>
            </a:r>
          </a:p>
          <a:p>
            <a:pPr marL="683895" lvl="2" indent="-304165">
              <a:spcBef>
                <a:spcPts val="0"/>
              </a:spcBef>
              <a:spcAft>
                <a:spcPts val="500"/>
              </a:spcAft>
            </a:pPr>
            <a:r>
              <a:rPr lang="en-US" dirty="0">
                <a:ea typeface="+mn-lt"/>
                <a:cs typeface="+mn-lt"/>
              </a:rPr>
              <a:t>Bailey, Sally &amp; Dickinson, Paige. (2022). The Importance of Safely De-</a:t>
            </a:r>
            <a:r>
              <a:rPr lang="en-US" dirty="0" err="1">
                <a:ea typeface="+mn-lt"/>
                <a:cs typeface="+mn-lt"/>
              </a:rPr>
              <a:t>roling</a:t>
            </a:r>
            <a:r>
              <a:rPr lang="en-US" dirty="0">
                <a:ea typeface="+mn-lt"/>
                <a:cs typeface="+mn-lt"/>
              </a:rPr>
              <a:t>. </a:t>
            </a:r>
          </a:p>
          <a:p>
            <a:pPr marL="0" indent="-229870">
              <a:spcBef>
                <a:spcPts val="0"/>
              </a:spcBef>
              <a:spcAft>
                <a:spcPts val="500"/>
              </a:spcAft>
            </a:pPr>
            <a:r>
              <a:rPr lang="en-US" sz="1600" b="1" dirty="0">
                <a:ea typeface="+mn-lt"/>
                <a:cs typeface="+mn-lt"/>
              </a:rPr>
              <a:t>Communication Resources</a:t>
            </a:r>
            <a:endParaRPr lang="en-US" sz="1600" b="1" dirty="0">
              <a:cs typeface="Arial"/>
            </a:endParaRPr>
          </a:p>
          <a:p>
            <a:pPr marL="683895" lvl="2" indent="-304165">
              <a:spcBef>
                <a:spcPts val="0"/>
              </a:spcBef>
              <a:spcAft>
                <a:spcPts val="500"/>
              </a:spcAft>
            </a:pPr>
            <a:r>
              <a:rPr lang="en-US" dirty="0">
                <a:ea typeface="+mn-lt"/>
                <a:cs typeface="+mn-lt"/>
              </a:rPr>
              <a:t>Woodward, H and Ching, K. "PEM BASE Camp Team Modules: Patient and Family Communication." Available at: </a:t>
            </a:r>
            <a:r>
              <a:rPr lang="en-US" dirty="0">
                <a:ea typeface="+mn-lt"/>
                <a:cs typeface="+mn-lt"/>
                <a:hlinkClick r:id="rId4"/>
              </a:rPr>
              <a:t>https://pembasecamp.org/pre-base-camp-modules/</a:t>
            </a:r>
            <a:r>
              <a:rPr lang="en-US" dirty="0">
                <a:ea typeface="+mn-lt"/>
                <a:cs typeface="+mn-lt"/>
              </a:rPr>
              <a:t>. </a:t>
            </a:r>
          </a:p>
          <a:p>
            <a:pPr marL="683895" lvl="2" indent="-304165">
              <a:spcBef>
                <a:spcPts val="0"/>
              </a:spcBef>
              <a:spcAft>
                <a:spcPts val="500"/>
              </a:spcAft>
            </a:pPr>
            <a:r>
              <a:rPr lang="en-US" dirty="0" err="1">
                <a:ea typeface="+mn-lt"/>
                <a:cs typeface="+mn-lt"/>
              </a:rPr>
              <a:t>TeamSTEPPS</a:t>
            </a:r>
            <a:r>
              <a:rPr lang="en-US" dirty="0">
                <a:ea typeface="+mn-lt"/>
                <a:cs typeface="+mn-lt"/>
              </a:rPr>
              <a:t> Team Strategies &amp; Tools to Enhance Performance &amp; Patient Safety, </a:t>
            </a:r>
            <a:r>
              <a:rPr lang="en-US" dirty="0">
                <a:ea typeface="+mn-lt"/>
                <a:cs typeface="+mn-lt"/>
                <a:hlinkClick r:id="rId5"/>
              </a:rPr>
              <a:t>https://www.ahrq.gov/sites/default/files/wysiwyg/teamstepps/webinars/2016-materials/teamstepps-monthly-webinar-december2016.pdf</a:t>
            </a:r>
            <a:r>
              <a:rPr lang="en-US" dirty="0">
                <a:ea typeface="+mn-lt"/>
                <a:cs typeface="+mn-lt"/>
              </a:rPr>
              <a:t>, Accessed 17 November 2021.</a:t>
            </a:r>
          </a:p>
          <a:p>
            <a:pPr marL="0" indent="-229870">
              <a:spcBef>
                <a:spcPts val="0"/>
              </a:spcBef>
              <a:spcAft>
                <a:spcPts val="500"/>
              </a:spcAft>
            </a:pPr>
            <a:r>
              <a:rPr lang="en-US" sz="1600" b="1" dirty="0">
                <a:cs typeface="Arial"/>
              </a:rPr>
              <a:t>Resources on Breaking Bad News</a:t>
            </a:r>
          </a:p>
          <a:p>
            <a:pPr marL="683895" lvl="2" indent="-304165">
              <a:spcBef>
                <a:spcPts val="0"/>
              </a:spcBef>
              <a:spcAft>
                <a:spcPts val="500"/>
              </a:spcAft>
            </a:pPr>
            <a:r>
              <a:rPr lang="en-US" dirty="0">
                <a:ea typeface="+mn-lt"/>
                <a:cs typeface="+mn-lt"/>
              </a:rPr>
              <a:t>Cameron </a:t>
            </a:r>
            <a:r>
              <a:rPr lang="en-US" dirty="0" err="1">
                <a:ea typeface="+mn-lt"/>
                <a:cs typeface="+mn-lt"/>
              </a:rPr>
              <a:t>Kravitt</a:t>
            </a:r>
            <a:r>
              <a:rPr lang="en-US" dirty="0">
                <a:ea typeface="+mn-lt"/>
                <a:cs typeface="+mn-lt"/>
              </a:rPr>
              <a:t> Foundation: </a:t>
            </a:r>
            <a:r>
              <a:rPr lang="en-US" dirty="0">
                <a:ea typeface="+mn-lt"/>
                <a:cs typeface="+mn-lt"/>
                <a:hlinkClick r:id="rId6"/>
              </a:rPr>
              <a:t>https://cameronkravittfoundation.org/</a:t>
            </a:r>
            <a:endParaRPr lang="en-US" dirty="0">
              <a:ea typeface="+mn-lt"/>
              <a:cs typeface="+mn-lt"/>
            </a:endParaRPr>
          </a:p>
          <a:p>
            <a:pPr marL="683895" lvl="2" indent="-304165">
              <a:spcBef>
                <a:spcPts val="0"/>
              </a:spcBef>
              <a:spcAft>
                <a:spcPts val="500"/>
              </a:spcAft>
            </a:pPr>
            <a:r>
              <a:rPr lang="en-US" dirty="0">
                <a:ea typeface="+mn-lt"/>
                <a:cs typeface="+mn-lt"/>
              </a:rPr>
              <a:t>Narayanan, V., </a:t>
            </a:r>
            <a:r>
              <a:rPr lang="en-US" dirty="0" err="1">
                <a:ea typeface="+mn-lt"/>
                <a:cs typeface="+mn-lt"/>
              </a:rPr>
              <a:t>Bista</a:t>
            </a:r>
            <a:r>
              <a:rPr lang="en-US" dirty="0">
                <a:ea typeface="+mn-lt"/>
                <a:cs typeface="+mn-lt"/>
              </a:rPr>
              <a:t>, B., &amp; Koshy, C. (2010). 'BREAKS' Protocol for Breaking Bad News. </a:t>
            </a:r>
            <a:r>
              <a:rPr lang="en-US" i="1" dirty="0">
                <a:ea typeface="+mn-lt"/>
                <a:cs typeface="+mn-lt"/>
              </a:rPr>
              <a:t>Indian journal of palliative care</a:t>
            </a:r>
            <a:r>
              <a:rPr lang="en-US" dirty="0">
                <a:ea typeface="+mn-lt"/>
                <a:cs typeface="+mn-lt"/>
              </a:rPr>
              <a:t>, </a:t>
            </a:r>
            <a:r>
              <a:rPr lang="en-US" i="1" dirty="0">
                <a:ea typeface="+mn-lt"/>
                <a:cs typeface="+mn-lt"/>
              </a:rPr>
              <a:t>16</a:t>
            </a:r>
            <a:r>
              <a:rPr lang="en-US" dirty="0">
                <a:ea typeface="+mn-lt"/>
                <a:cs typeface="+mn-lt"/>
              </a:rPr>
              <a:t>(2), 61–65. </a:t>
            </a:r>
            <a:r>
              <a:rPr lang="en-US" dirty="0">
                <a:ea typeface="+mn-lt"/>
                <a:cs typeface="+mn-lt"/>
                <a:hlinkClick r:id="rId7"/>
              </a:rPr>
              <a:t>https://doi.org/10.4103/0973-1075.68401</a:t>
            </a:r>
            <a:endParaRPr lang="en-US" dirty="0">
              <a:cs typeface="Arial"/>
            </a:endParaRPr>
          </a:p>
          <a:p>
            <a:pPr marL="683895" lvl="2" indent="-304165">
              <a:spcBef>
                <a:spcPts val="0"/>
              </a:spcBef>
              <a:spcAft>
                <a:spcPts val="500"/>
              </a:spcAft>
            </a:pPr>
            <a:r>
              <a:rPr lang="en-US" dirty="0" err="1">
                <a:cs typeface="Arial"/>
              </a:rPr>
              <a:t>Rabow</a:t>
            </a:r>
            <a:r>
              <a:rPr lang="en-US" dirty="0">
                <a:cs typeface="Arial"/>
              </a:rPr>
              <a:t>, M. W., &amp; McPhee, S. J. (1999). Beyond breaking bad news: how to help patients who suffer. </a:t>
            </a:r>
            <a:r>
              <a:rPr lang="en-US" i="1" dirty="0">
                <a:cs typeface="Arial"/>
              </a:rPr>
              <a:t>The Western journal of medicine</a:t>
            </a:r>
            <a:r>
              <a:rPr lang="en-US" dirty="0">
                <a:cs typeface="Arial"/>
              </a:rPr>
              <a:t>, </a:t>
            </a:r>
            <a:r>
              <a:rPr lang="en-US" i="1" dirty="0">
                <a:cs typeface="Arial"/>
              </a:rPr>
              <a:t>171</a:t>
            </a:r>
            <a:r>
              <a:rPr lang="en-US" dirty="0">
                <a:cs typeface="Arial"/>
              </a:rPr>
              <a:t>(4), 260–263. </a:t>
            </a:r>
            <a:endParaRPr lang="en-US" dirty="0">
              <a:ea typeface="+mn-lt"/>
              <a:cs typeface="+mn-lt"/>
            </a:endParaRPr>
          </a:p>
          <a:p>
            <a:pPr marL="683895" lvl="2" indent="-304165">
              <a:spcBef>
                <a:spcPts val="0"/>
              </a:spcBef>
              <a:spcAft>
                <a:spcPts val="500"/>
              </a:spcAft>
            </a:pPr>
            <a:r>
              <a:rPr lang="en-US" dirty="0" err="1">
                <a:ea typeface="+mn-lt"/>
                <a:cs typeface="+mn-lt"/>
              </a:rPr>
              <a:t>Baile</a:t>
            </a:r>
            <a:r>
              <a:rPr lang="en-US" dirty="0">
                <a:ea typeface="+mn-lt"/>
                <a:cs typeface="+mn-lt"/>
              </a:rPr>
              <a:t>, W. F., Buckman, R., </a:t>
            </a:r>
            <a:r>
              <a:rPr lang="en-US" dirty="0" err="1">
                <a:ea typeface="+mn-lt"/>
                <a:cs typeface="+mn-lt"/>
              </a:rPr>
              <a:t>Lenzi</a:t>
            </a:r>
            <a:r>
              <a:rPr lang="en-US" dirty="0">
                <a:ea typeface="+mn-lt"/>
                <a:cs typeface="+mn-lt"/>
              </a:rPr>
              <a:t>, R., </a:t>
            </a:r>
            <a:r>
              <a:rPr lang="en-US" dirty="0" err="1">
                <a:ea typeface="+mn-lt"/>
                <a:cs typeface="+mn-lt"/>
              </a:rPr>
              <a:t>Glober</a:t>
            </a:r>
            <a:r>
              <a:rPr lang="en-US" dirty="0">
                <a:ea typeface="+mn-lt"/>
                <a:cs typeface="+mn-lt"/>
              </a:rPr>
              <a:t>, G., Beale, E. A., &amp; Kudelka, A. P. (2000). SPIKES-A six-step protocol for delivering bad news: application to the patient with cancer. </a:t>
            </a:r>
            <a:r>
              <a:rPr lang="en-US" i="1" dirty="0">
                <a:ea typeface="+mn-lt"/>
                <a:cs typeface="+mn-lt"/>
              </a:rPr>
              <a:t>The oncologist</a:t>
            </a:r>
            <a:r>
              <a:rPr lang="en-US" dirty="0">
                <a:ea typeface="+mn-lt"/>
                <a:cs typeface="+mn-lt"/>
              </a:rPr>
              <a:t>, </a:t>
            </a:r>
            <a:r>
              <a:rPr lang="en-US" i="1" dirty="0">
                <a:ea typeface="+mn-lt"/>
                <a:cs typeface="+mn-lt"/>
              </a:rPr>
              <a:t>5</a:t>
            </a:r>
            <a:r>
              <a:rPr lang="en-US" dirty="0">
                <a:ea typeface="+mn-lt"/>
                <a:cs typeface="+mn-lt"/>
              </a:rPr>
              <a:t>(4), 302–311. </a:t>
            </a:r>
            <a:r>
              <a:rPr lang="en-US" dirty="0">
                <a:ea typeface="+mn-lt"/>
                <a:cs typeface="+mn-lt"/>
                <a:hlinkClick r:id="rId8"/>
              </a:rPr>
              <a:t>https://doi.org/10.1634/theoncologist.5-4-302</a:t>
            </a:r>
            <a:endParaRPr lang="en-US" dirty="0">
              <a:ea typeface="+mn-lt"/>
              <a:cs typeface="+mn-lt"/>
            </a:endParaRPr>
          </a:p>
        </p:txBody>
      </p:sp>
      <p:sp>
        <p:nvSpPr>
          <p:cNvPr id="5" name="Slide Number Placeholder 4">
            <a:extLst>
              <a:ext uri="{FF2B5EF4-FFF2-40B4-BE49-F238E27FC236}">
                <a16:creationId xmlns:a16="http://schemas.microsoft.com/office/drawing/2014/main" id="{F144A619-73EE-4C2B-A585-FBDE64404EA9}"/>
              </a:ext>
            </a:extLst>
          </p:cNvPr>
          <p:cNvSpPr>
            <a:spLocks noGrp="1"/>
          </p:cNvSpPr>
          <p:nvPr>
            <p:ph type="sldNum" sz="quarter" idx="4"/>
          </p:nvPr>
        </p:nvSpPr>
        <p:spPr/>
        <p:txBody>
          <a:bodyPr/>
          <a:lstStyle/>
          <a:p>
            <a:fld id="{7FEEEA1A-CB49-3744-AA40-B896987410F9}" type="slidenum">
              <a:rPr lang="en-US" smtClean="0"/>
              <a:pPr/>
              <a:t>26</a:t>
            </a:fld>
            <a:endParaRPr lang="en-US"/>
          </a:p>
        </p:txBody>
      </p:sp>
    </p:spTree>
    <p:extLst>
      <p:ext uri="{BB962C8B-B14F-4D97-AF65-F5344CB8AC3E}">
        <p14:creationId xmlns:p14="http://schemas.microsoft.com/office/powerpoint/2010/main" val="3017569055"/>
      </p:ext>
    </p:extLst>
  </p:cSld>
  <p:clrMapOvr>
    <a:masterClrMapping/>
  </p:clrMapOvr>
  <mc:AlternateContent xmlns:mc="http://schemas.openxmlformats.org/markup-compatibility/2006" xmlns:p14="http://schemas.microsoft.com/office/powerpoint/2010/main">
    <mc:Choice Requires="p14">
      <p:transition spd="slow" p14:dur="2000" advTm="11545"/>
    </mc:Choice>
    <mc:Fallback xmlns="">
      <p:transition spd="slow" advTm="11545"/>
    </mc:Fallback>
  </mc:AlternateContent>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Tree>
    <p:extLst>
      <p:ext uri="{BB962C8B-B14F-4D97-AF65-F5344CB8AC3E}">
        <p14:creationId xmlns:p14="http://schemas.microsoft.com/office/powerpoint/2010/main" val="1264078744"/>
      </p:ext>
    </p:extLst>
  </p:cSld>
  <p:clrMapOvr>
    <a:masterClrMapping/>
  </p:clrMapOvr>
  <mc:AlternateContent xmlns:mc="http://schemas.openxmlformats.org/markup-compatibility/2006" xmlns:p14="http://schemas.microsoft.com/office/powerpoint/2010/main">
    <mc:Choice Requires="p14">
      <p:transition spd="slow" p14:dur="2000" advTm="11579"/>
    </mc:Choice>
    <mc:Fallback xmlns="">
      <p:transition spd="slow" advTm="11579"/>
    </mc:Fallback>
  </mc:AlternateContent>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2AA3C0D-CC4C-AA35-6367-FE90B033DCC5}"/>
              </a:ext>
            </a:extLst>
          </p:cNvPr>
          <p:cNvSpPr>
            <a:spLocks noGrp="1"/>
          </p:cNvSpPr>
          <p:nvPr>
            <p:ph type="title"/>
          </p:nvPr>
        </p:nvSpPr>
        <p:spPr/>
        <p:txBody>
          <a:bodyPr/>
          <a:lstStyle/>
          <a:p>
            <a:r>
              <a:rPr lang="en-US" dirty="0">
                <a:cs typeface="Arial"/>
              </a:rPr>
              <a:t>De-Roling</a:t>
            </a:r>
            <a:endParaRPr lang="en-US" dirty="0"/>
          </a:p>
        </p:txBody>
      </p:sp>
      <p:sp>
        <p:nvSpPr>
          <p:cNvPr id="3" name="Content Placeholder 2">
            <a:extLst>
              <a:ext uri="{FF2B5EF4-FFF2-40B4-BE49-F238E27FC236}">
                <a16:creationId xmlns:a16="http://schemas.microsoft.com/office/drawing/2014/main" id="{82E4A652-B00D-7DFA-55D1-7BA188DB9466}"/>
              </a:ext>
            </a:extLst>
          </p:cNvPr>
          <p:cNvSpPr>
            <a:spLocks noGrp="1"/>
          </p:cNvSpPr>
          <p:nvPr>
            <p:ph sz="quarter" idx="13"/>
          </p:nvPr>
        </p:nvSpPr>
        <p:spPr/>
        <p:txBody>
          <a:bodyPr vert="horz" lIns="0" tIns="0" rIns="0" bIns="0" rtlCol="0" anchor="t">
            <a:noAutofit/>
          </a:bodyPr>
          <a:lstStyle/>
          <a:p>
            <a:pPr marL="306070" indent="-306070">
              <a:lnSpc>
                <a:spcPct val="120000"/>
              </a:lnSpc>
            </a:pPr>
            <a:r>
              <a:rPr lang="en-US" sz="2800" dirty="0">
                <a:ea typeface="+mn-lt"/>
                <a:cs typeface="+mn-lt"/>
              </a:rPr>
              <a:t>Please remember that although you are participating in a simulation, these experiences are difficult for everyone involved</a:t>
            </a:r>
            <a:endParaRPr lang="en-US" sz="2800">
              <a:cs typeface="Arial"/>
            </a:endParaRPr>
          </a:p>
          <a:p>
            <a:pPr marL="306070" indent="-306070">
              <a:lnSpc>
                <a:spcPct val="120000"/>
              </a:lnSpc>
            </a:pPr>
            <a:r>
              <a:rPr lang="en-US" sz="2800" dirty="0">
                <a:cs typeface="Arial"/>
              </a:rPr>
              <a:t>De-</a:t>
            </a:r>
            <a:r>
              <a:rPr lang="en-US" sz="2800" err="1">
                <a:cs typeface="Arial"/>
              </a:rPr>
              <a:t>roling</a:t>
            </a:r>
            <a:r>
              <a:rPr lang="en-US" sz="2800" dirty="0">
                <a:cs typeface="Arial"/>
              </a:rPr>
              <a:t> involves separating yourself from your character, and is helpful especially in circumstances in which there are unpleasant or intense feelings evoked by playing a certain character</a:t>
            </a:r>
          </a:p>
          <a:p>
            <a:pPr marL="306070" indent="-306070">
              <a:lnSpc>
                <a:spcPct val="120000"/>
              </a:lnSpc>
            </a:pPr>
            <a:r>
              <a:rPr lang="en-US" sz="2800" dirty="0">
                <a:cs typeface="Arial"/>
              </a:rPr>
              <a:t>De-</a:t>
            </a:r>
            <a:r>
              <a:rPr lang="en-US" sz="2800" err="1">
                <a:cs typeface="Arial"/>
              </a:rPr>
              <a:t>roling</a:t>
            </a:r>
            <a:r>
              <a:rPr lang="en-US" sz="2800" dirty="0">
                <a:cs typeface="Arial"/>
              </a:rPr>
              <a:t> is crucial for your emotional well-being</a:t>
            </a:r>
          </a:p>
          <a:p>
            <a:pPr marL="306070" indent="-306070">
              <a:lnSpc>
                <a:spcPct val="120000"/>
              </a:lnSpc>
            </a:pPr>
            <a:endParaRPr lang="en-US" sz="2800" dirty="0">
              <a:cs typeface="Arial"/>
            </a:endParaRPr>
          </a:p>
        </p:txBody>
      </p:sp>
      <p:sp>
        <p:nvSpPr>
          <p:cNvPr id="5" name="Slide Number Placeholder 4">
            <a:extLst>
              <a:ext uri="{FF2B5EF4-FFF2-40B4-BE49-F238E27FC236}">
                <a16:creationId xmlns:a16="http://schemas.microsoft.com/office/drawing/2014/main" id="{738FCBBB-F571-3CC2-3C81-E208542661EC}"/>
              </a:ext>
            </a:extLst>
          </p:cNvPr>
          <p:cNvSpPr>
            <a:spLocks noGrp="1"/>
          </p:cNvSpPr>
          <p:nvPr>
            <p:ph type="sldNum" sz="quarter" idx="4"/>
          </p:nvPr>
        </p:nvSpPr>
        <p:spPr/>
        <p:txBody>
          <a:bodyPr/>
          <a:lstStyle/>
          <a:p>
            <a:fld id="{7FEEEA1A-CB49-3744-AA40-B896987410F9}" type="slidenum">
              <a:rPr lang="en-US" smtClean="0"/>
              <a:pPr/>
              <a:t>3</a:t>
            </a:fld>
            <a:endParaRPr lang="en-US"/>
          </a:p>
        </p:txBody>
      </p:sp>
    </p:spTree>
    <p:extLst>
      <p:ext uri="{BB962C8B-B14F-4D97-AF65-F5344CB8AC3E}">
        <p14:creationId xmlns:p14="http://schemas.microsoft.com/office/powerpoint/2010/main" val="71559988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itle 8"/>
          <p:cNvSpPr>
            <a:spLocks noGrp="1"/>
          </p:cNvSpPr>
          <p:nvPr>
            <p:ph type="title"/>
          </p:nvPr>
        </p:nvSpPr>
        <p:spPr>
          <a:xfrm>
            <a:off x="609599" y="965385"/>
            <a:ext cx="10972803" cy="418576"/>
          </a:xfrm>
        </p:spPr>
        <p:txBody>
          <a:bodyPr/>
          <a:lstStyle/>
          <a:p>
            <a:r>
              <a:rPr lang="en-US" sz="3700"/>
              <a:t>Outline</a:t>
            </a:r>
          </a:p>
        </p:txBody>
      </p:sp>
      <p:sp>
        <p:nvSpPr>
          <p:cNvPr id="14" name="Content Placeholder 13"/>
          <p:cNvSpPr>
            <a:spLocks noGrp="1"/>
          </p:cNvSpPr>
          <p:nvPr>
            <p:ph sz="quarter" idx="13"/>
          </p:nvPr>
        </p:nvSpPr>
        <p:spPr>
          <a:xfrm>
            <a:off x="609600" y="1563053"/>
            <a:ext cx="10972801" cy="4737116"/>
          </a:xfrm>
        </p:spPr>
        <p:txBody>
          <a:bodyPr vert="horz" lIns="0" tIns="0" rIns="0" bIns="0" rtlCol="0" anchor="t">
            <a:noAutofit/>
          </a:bodyPr>
          <a:lstStyle/>
          <a:p>
            <a:pPr marL="306070" indent="-306070">
              <a:lnSpc>
                <a:spcPct val="150000"/>
              </a:lnSpc>
              <a:spcBef>
                <a:spcPts val="800"/>
              </a:spcBef>
            </a:pPr>
            <a:r>
              <a:rPr lang="en-US" sz="2700" dirty="0">
                <a:solidFill>
                  <a:schemeClr val="tx2">
                    <a:lumMod val="60000"/>
                    <a:lumOff val="40000"/>
                  </a:schemeClr>
                </a:solidFill>
                <a:ea typeface="+mn-lt"/>
                <a:cs typeface="+mn-lt"/>
              </a:rPr>
              <a:t>Overview</a:t>
            </a:r>
            <a:endParaRPr lang="en-US" sz="2700" dirty="0">
              <a:solidFill>
                <a:schemeClr val="tx2">
                  <a:lumMod val="60000"/>
                  <a:lumOff val="40000"/>
                </a:schemeClr>
              </a:solidFill>
              <a:cs typeface="Arial"/>
            </a:endParaRPr>
          </a:p>
          <a:p>
            <a:pPr marL="306070" indent="-306070">
              <a:lnSpc>
                <a:spcPct val="150000"/>
              </a:lnSpc>
              <a:spcBef>
                <a:spcPts val="800"/>
              </a:spcBef>
            </a:pPr>
            <a:r>
              <a:rPr lang="en-US" sz="2700" dirty="0">
                <a:ea typeface="+mn-lt"/>
                <a:cs typeface="+mn-lt"/>
              </a:rPr>
              <a:t>Personality </a:t>
            </a:r>
            <a:r>
              <a:rPr lang="en-US" sz="2700">
                <a:ea typeface="+mn-lt"/>
                <a:cs typeface="+mn-lt"/>
              </a:rPr>
              <a:t>Traits</a:t>
            </a:r>
            <a:endParaRPr lang="en-US" sz="2700">
              <a:cs typeface="Arial"/>
            </a:endParaRPr>
          </a:p>
          <a:p>
            <a:pPr marL="306070" indent="-306070">
              <a:lnSpc>
                <a:spcPct val="150000"/>
              </a:lnSpc>
              <a:spcBef>
                <a:spcPts val="800"/>
              </a:spcBef>
            </a:pPr>
            <a:r>
              <a:rPr lang="en-US" sz="2700" dirty="0">
                <a:cs typeface="Arial"/>
              </a:rPr>
              <a:t>Observer Tool</a:t>
            </a:r>
          </a:p>
          <a:p>
            <a:pPr marL="306070" indent="-306070">
              <a:lnSpc>
                <a:spcPct val="150000"/>
              </a:lnSpc>
              <a:spcBef>
                <a:spcPts val="800"/>
              </a:spcBef>
            </a:pPr>
            <a:r>
              <a:rPr lang="en-US" sz="2700" dirty="0">
                <a:cs typeface="Arial"/>
              </a:rPr>
              <a:t>Practice!</a:t>
            </a:r>
          </a:p>
          <a:p>
            <a:pPr marL="306070" indent="-306070">
              <a:lnSpc>
                <a:spcPct val="150000"/>
              </a:lnSpc>
              <a:spcBef>
                <a:spcPts val="800"/>
              </a:spcBef>
            </a:pPr>
            <a:r>
              <a:rPr lang="en-US" sz="2700" dirty="0">
                <a:cs typeface="Arial"/>
              </a:rPr>
              <a:t>Summary</a:t>
            </a:r>
          </a:p>
        </p:txBody>
      </p:sp>
      <p:sp>
        <p:nvSpPr>
          <p:cNvPr id="7" name="Slide Number Placeholder 6"/>
          <p:cNvSpPr>
            <a:spLocks noGrp="1"/>
          </p:cNvSpPr>
          <p:nvPr>
            <p:ph type="sldNum" sz="quarter" idx="4"/>
          </p:nvPr>
        </p:nvSpPr>
        <p:spPr/>
        <p:txBody>
          <a:bodyPr/>
          <a:lstStyle/>
          <a:p>
            <a:fld id="{7FEEEA1A-CB49-3744-AA40-B896987410F9}" type="slidenum">
              <a:rPr lang="en-US" smtClean="0"/>
              <a:pPr/>
              <a:t>4</a:t>
            </a:fld>
            <a:endParaRPr lang="en-US"/>
          </a:p>
        </p:txBody>
      </p:sp>
    </p:spTree>
    <p:extLst>
      <p:ext uri="{BB962C8B-B14F-4D97-AF65-F5344CB8AC3E}">
        <p14:creationId xmlns:p14="http://schemas.microsoft.com/office/powerpoint/2010/main" val="2790284329"/>
      </p:ext>
    </p:extLst>
  </p:cSld>
  <p:clrMapOvr>
    <a:masterClrMapping/>
  </p:clrMapOvr>
  <mc:AlternateContent xmlns:mc="http://schemas.openxmlformats.org/markup-compatibility/2006" xmlns:p14="http://schemas.microsoft.com/office/powerpoint/2010/main">
    <mc:Choice Requires="p14">
      <p:transition spd="slow" p14:dur="2000" advTm="17103"/>
    </mc:Choice>
    <mc:Fallback xmlns="">
      <p:transition spd="slow" advTm="17103"/>
    </mc:Fallback>
  </mc:AlternateContent>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Title 14"/>
          <p:cNvSpPr>
            <a:spLocks noGrp="1"/>
          </p:cNvSpPr>
          <p:nvPr>
            <p:ph type="title"/>
          </p:nvPr>
        </p:nvSpPr>
        <p:spPr/>
        <p:txBody>
          <a:bodyPr vert="horz" lIns="0" tIns="0" rIns="0" bIns="0" rtlCol="0" anchor="ctr" anchorCtr="0">
            <a:noAutofit/>
          </a:bodyPr>
          <a:lstStyle/>
          <a:p>
            <a:r>
              <a:rPr lang="en-US" dirty="0"/>
              <a:t>overview</a:t>
            </a:r>
          </a:p>
        </p:txBody>
      </p:sp>
    </p:spTree>
    <p:extLst>
      <p:ext uri="{BB962C8B-B14F-4D97-AF65-F5344CB8AC3E}">
        <p14:creationId xmlns:p14="http://schemas.microsoft.com/office/powerpoint/2010/main" val="3107070248"/>
      </p:ext>
    </p:extLst>
  </p:cSld>
  <p:clrMapOvr>
    <a:masterClrMapping/>
  </p:clrMapOvr>
  <mc:AlternateContent xmlns:mc="http://schemas.openxmlformats.org/markup-compatibility/2006" xmlns:p14="http://schemas.microsoft.com/office/powerpoint/2010/main">
    <mc:Choice Requires="p14">
      <p:transition spd="slow" p14:dur="2000" advTm="3980"/>
    </mc:Choice>
    <mc:Fallback xmlns="">
      <p:transition spd="slow" advTm="3980"/>
    </mc:Fallback>
  </mc:AlternateContent>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 name="Picture 11" descr="Norwich Junior Doctors showing CPR outside on The Haymarket Norwich A3">
            <a:extLst>
              <a:ext uri="{FF2B5EF4-FFF2-40B4-BE49-F238E27FC236}">
                <a16:creationId xmlns:a16="http://schemas.microsoft.com/office/drawing/2014/main" id="{993737EF-5C20-4DC7-9694-00A5F8C49A06}"/>
              </a:ext>
            </a:extLst>
          </p:cNvPr>
          <p:cNvPicPr>
            <a:picLocks noChangeAspect="1" noChangeArrowheads="1"/>
          </p:cNvPicPr>
          <p:nvPr/>
        </p:nvPicPr>
        <p:blipFill rotWithShape="1">
          <a:blip r:embed="rId3">
            <a:alphaModFix amt="21000"/>
            <a:extLst>
              <a:ext uri="{BEBA8EAE-BF5A-486C-A8C5-ECC9F3942E4B}">
                <a14:imgProps xmlns:a14="http://schemas.microsoft.com/office/drawing/2010/main">
                  <a14:imgLayer r:embed="rId4">
                    <a14:imgEffect>
                      <a14:colorTemperature colorTemp="4765"/>
                    </a14:imgEffect>
                    <a14:imgEffect>
                      <a14:saturation sat="102000"/>
                    </a14:imgEffect>
                    <a14:imgEffect>
                      <a14:brightnessContrast bright="-17000" contrast="-6000"/>
                    </a14:imgEffect>
                  </a14:imgLayer>
                </a14:imgProps>
              </a:ext>
              <a:ext uri="{28A0092B-C50C-407E-A947-70E740481C1C}">
                <a14:useLocalDpi xmlns:a14="http://schemas.microsoft.com/office/drawing/2010/main" val="0"/>
              </a:ext>
            </a:extLst>
          </a:blip>
          <a:srcRect t="13388" b="11159"/>
          <a:stretch/>
        </p:blipFill>
        <p:spPr bwMode="auto">
          <a:xfrm>
            <a:off x="9191" y="356001"/>
            <a:ext cx="12171947" cy="6495107"/>
          </a:xfrm>
          <a:prstGeom prst="rect">
            <a:avLst/>
          </a:prstGeom>
          <a:noFill/>
          <a:extLst>
            <a:ext uri="{909E8E84-426E-40DD-AFC4-6F175D3DCCD1}">
              <a14:hiddenFill xmlns:a14="http://schemas.microsoft.com/office/drawing/2010/main">
                <a:solidFill>
                  <a:srgbClr val="FFFFFF"/>
                </a:solidFill>
              </a14:hiddenFill>
            </a:ext>
          </a:extLst>
        </p:spPr>
      </p:pic>
      <p:sp>
        <p:nvSpPr>
          <p:cNvPr id="9" name="Title 8"/>
          <p:cNvSpPr>
            <a:spLocks noGrp="1"/>
          </p:cNvSpPr>
          <p:nvPr>
            <p:ph type="title"/>
          </p:nvPr>
        </p:nvSpPr>
        <p:spPr>
          <a:xfrm>
            <a:off x="609599" y="715808"/>
            <a:ext cx="10972803" cy="418576"/>
          </a:xfrm>
        </p:spPr>
        <p:txBody>
          <a:bodyPr/>
          <a:lstStyle/>
          <a:p>
            <a:r>
              <a:rPr lang="en-US" sz="3700" dirty="0"/>
              <a:t>Overview</a:t>
            </a:r>
            <a:endParaRPr lang="en-US" dirty="0"/>
          </a:p>
        </p:txBody>
      </p:sp>
      <p:sp>
        <p:nvSpPr>
          <p:cNvPr id="14" name="Content Placeholder 13"/>
          <p:cNvSpPr>
            <a:spLocks noGrp="1"/>
          </p:cNvSpPr>
          <p:nvPr>
            <p:ph sz="quarter" idx="13"/>
          </p:nvPr>
        </p:nvSpPr>
        <p:spPr>
          <a:xfrm>
            <a:off x="609599" y="1531664"/>
            <a:ext cx="11219645" cy="5175941"/>
          </a:xfrm>
        </p:spPr>
        <p:txBody>
          <a:bodyPr vert="horz" lIns="0" tIns="0" rIns="0" bIns="0" rtlCol="0" anchor="t">
            <a:noAutofit/>
          </a:bodyPr>
          <a:lstStyle/>
          <a:p>
            <a:pPr marL="306070" indent="-306070">
              <a:lnSpc>
                <a:spcPct val="120000"/>
              </a:lnSpc>
            </a:pPr>
            <a:r>
              <a:rPr lang="en-US" sz="3700" b="1" dirty="0">
                <a:solidFill>
                  <a:schemeClr val="tx1">
                    <a:lumMod val="75000"/>
                  </a:schemeClr>
                </a:solidFill>
                <a:ea typeface="+mn-lt"/>
                <a:cs typeface="+mn-lt"/>
              </a:rPr>
              <a:t>FPF Curriculum: </a:t>
            </a:r>
            <a:r>
              <a:rPr lang="en-US" sz="3700" dirty="0">
                <a:solidFill>
                  <a:schemeClr val="tx1">
                    <a:lumMod val="75000"/>
                  </a:schemeClr>
                </a:solidFill>
                <a:ea typeface="+mn-lt"/>
                <a:cs typeface="+mn-lt"/>
              </a:rPr>
              <a:t>Our goal is to teach team members to provide compassionate, comprehensive care for patients and family members during pediatric medical resuscitations</a:t>
            </a:r>
            <a:endParaRPr lang="en-US" dirty="0">
              <a:solidFill>
                <a:schemeClr val="tx1">
                  <a:lumMod val="75000"/>
                </a:schemeClr>
              </a:solidFill>
            </a:endParaRPr>
          </a:p>
          <a:p>
            <a:pPr marL="306070" indent="-306070">
              <a:lnSpc>
                <a:spcPct val="120000"/>
              </a:lnSpc>
            </a:pPr>
            <a:r>
              <a:rPr lang="en-US" sz="3700" b="1" dirty="0">
                <a:solidFill>
                  <a:schemeClr val="tx1">
                    <a:lumMod val="75000"/>
                  </a:schemeClr>
                </a:solidFill>
                <a:cs typeface="Arial"/>
              </a:rPr>
              <a:t>Simulated Participants </a:t>
            </a:r>
            <a:r>
              <a:rPr lang="en-US" sz="3700" dirty="0">
                <a:solidFill>
                  <a:schemeClr val="tx1">
                    <a:lumMod val="75000"/>
                  </a:schemeClr>
                </a:solidFill>
                <a:cs typeface="Arial"/>
              </a:rPr>
              <a:t>are essential in helping us fulfill this goal</a:t>
            </a:r>
          </a:p>
        </p:txBody>
      </p:sp>
      <p:sp>
        <p:nvSpPr>
          <p:cNvPr id="7" name="Slide Number Placeholder 6"/>
          <p:cNvSpPr>
            <a:spLocks noGrp="1"/>
          </p:cNvSpPr>
          <p:nvPr>
            <p:ph type="sldNum" sz="quarter" idx="4"/>
          </p:nvPr>
        </p:nvSpPr>
        <p:spPr/>
        <p:txBody>
          <a:bodyPr/>
          <a:lstStyle/>
          <a:p>
            <a:fld id="{7FEEEA1A-CB49-3744-AA40-B896987410F9}" type="slidenum">
              <a:rPr lang="en-US" smtClean="0"/>
              <a:pPr/>
              <a:t>6</a:t>
            </a:fld>
            <a:endParaRPr lang="en-US"/>
          </a:p>
        </p:txBody>
      </p:sp>
      <p:sp>
        <p:nvSpPr>
          <p:cNvPr id="13" name="Footer Placeholder 5">
            <a:extLst>
              <a:ext uri="{FF2B5EF4-FFF2-40B4-BE49-F238E27FC236}">
                <a16:creationId xmlns:a16="http://schemas.microsoft.com/office/drawing/2014/main" id="{71FE123A-E770-4747-AA6B-9E79DD12776A}"/>
              </a:ext>
            </a:extLst>
          </p:cNvPr>
          <p:cNvSpPr txBox="1">
            <a:spLocks/>
          </p:cNvSpPr>
          <p:nvPr/>
        </p:nvSpPr>
        <p:spPr>
          <a:xfrm>
            <a:off x="387071" y="6690608"/>
            <a:ext cx="11807435" cy="123111"/>
          </a:xfrm>
          <a:prstGeom prst="rect">
            <a:avLst/>
          </a:prstGeom>
        </p:spPr>
        <p:txBody>
          <a:bodyPr vert="horz" wrap="square" lIns="0" tIns="0" rIns="0" bIns="0" rtlCol="0" anchor="ct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800" dirty="0">
                <a:ea typeface="+mn-lt"/>
                <a:cs typeface="+mn-lt"/>
              </a:rPr>
              <a:t>Image by Roger Blackwell, </a:t>
            </a:r>
            <a:r>
              <a:rPr lang="en-US" sz="800" dirty="0"/>
              <a:t>retrieved from: https://</a:t>
            </a:r>
            <a:r>
              <a:rPr lang="en-US" sz="800" dirty="0" err="1"/>
              <a:t>wordpress.org</a:t>
            </a:r>
            <a:r>
              <a:rPr lang="en-US" sz="800" dirty="0"/>
              <a:t>/</a:t>
            </a:r>
            <a:r>
              <a:rPr lang="en-US" sz="800" dirty="0" err="1"/>
              <a:t>openverse</a:t>
            </a:r>
            <a:r>
              <a:rPr lang="en-US" sz="800" dirty="0"/>
              <a:t>/image/4a64baa3-4da2-4a1e-8527-cff8fc6f23bb on 3 March 2022. Creative Commons license associated: https://</a:t>
            </a:r>
            <a:r>
              <a:rPr lang="en-US" sz="800" dirty="0" err="1"/>
              <a:t>creativecommons.org</a:t>
            </a:r>
            <a:r>
              <a:rPr lang="en-US" sz="800" dirty="0"/>
              <a:t>/licenses/by/4.0/.</a:t>
            </a:r>
            <a:endParaRPr lang="en-US" sz="800" dirty="0">
              <a:cs typeface="Arial"/>
            </a:endParaRPr>
          </a:p>
        </p:txBody>
      </p:sp>
    </p:spTree>
    <p:extLst>
      <p:ext uri="{BB962C8B-B14F-4D97-AF65-F5344CB8AC3E}">
        <p14:creationId xmlns:p14="http://schemas.microsoft.com/office/powerpoint/2010/main" val="2501830990"/>
      </p:ext>
    </p:extLst>
  </p:cSld>
  <p:clrMapOvr>
    <a:masterClrMapping/>
  </p:clrMapOvr>
  <mc:AlternateContent xmlns:mc="http://schemas.openxmlformats.org/markup-compatibility/2006" xmlns:p14="http://schemas.microsoft.com/office/powerpoint/2010/main">
    <mc:Choice Requires="p14">
      <p:transition spd="slow" p14:dur="2000" advTm="29847"/>
    </mc:Choice>
    <mc:Fallback xmlns="">
      <p:transition spd="slow" advTm="29847"/>
    </mc:Fallback>
  </mc:AlternateContent>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descr="Inauguración del Hospital Municipal de Chiconcuac">
            <a:extLst>
              <a:ext uri="{FF2B5EF4-FFF2-40B4-BE49-F238E27FC236}">
                <a16:creationId xmlns:a16="http://schemas.microsoft.com/office/drawing/2014/main" id="{0E129356-031F-022B-52A4-B58802E1D5C9}"/>
              </a:ext>
            </a:extLst>
          </p:cNvPr>
          <p:cNvPicPr>
            <a:picLocks noChangeAspect="1" noChangeArrowheads="1"/>
          </p:cNvPicPr>
          <p:nvPr/>
        </p:nvPicPr>
        <p:blipFill rotWithShape="1">
          <a:blip r:embed="rId3">
            <a:alphaModFix amt="33000"/>
            <a:extLst>
              <a:ext uri="{BEBA8EAE-BF5A-486C-A8C5-ECC9F3942E4B}">
                <a14:imgProps xmlns:a14="http://schemas.microsoft.com/office/drawing/2010/main">
                  <a14:imgLayer r:embed="rId4">
                    <a14:imgEffect>
                      <a14:colorTemperature colorTemp="3977"/>
                    </a14:imgEffect>
                    <a14:imgEffect>
                      <a14:brightnessContrast bright="-19000" contrast="-6000"/>
                    </a14:imgEffect>
                  </a14:imgLayer>
                </a14:imgProps>
              </a:ext>
              <a:ext uri="{28A0092B-C50C-407E-A947-70E740481C1C}">
                <a14:useLocalDpi xmlns:a14="http://schemas.microsoft.com/office/drawing/2010/main" val="0"/>
              </a:ext>
            </a:extLst>
          </a:blip>
          <a:srcRect t="20045" b="-249"/>
          <a:stretch/>
        </p:blipFill>
        <p:spPr bwMode="auto">
          <a:xfrm>
            <a:off x="0" y="343763"/>
            <a:ext cx="12192000" cy="6599297"/>
          </a:xfrm>
          <a:prstGeom prst="rect">
            <a:avLst/>
          </a:prstGeom>
          <a:noFill/>
          <a:extLst>
            <a:ext uri="{909E8E84-426E-40DD-AFC4-6F175D3DCCD1}">
              <a14:hiddenFill xmlns:a14="http://schemas.microsoft.com/office/drawing/2010/main">
                <a:solidFill>
                  <a:srgbClr val="FFFFFF"/>
                </a:solidFill>
              </a14:hiddenFill>
            </a:ext>
          </a:extLst>
        </p:spPr>
      </p:pic>
      <p:sp>
        <p:nvSpPr>
          <p:cNvPr id="9" name="Title 8"/>
          <p:cNvSpPr>
            <a:spLocks noGrp="1"/>
          </p:cNvSpPr>
          <p:nvPr>
            <p:ph type="title"/>
          </p:nvPr>
        </p:nvSpPr>
        <p:spPr>
          <a:xfrm>
            <a:off x="609599" y="715808"/>
            <a:ext cx="10972803" cy="418576"/>
          </a:xfrm>
        </p:spPr>
        <p:txBody>
          <a:bodyPr/>
          <a:lstStyle/>
          <a:p>
            <a:r>
              <a:rPr lang="en-US" sz="3733" dirty="0"/>
              <a:t>Objectives</a:t>
            </a:r>
          </a:p>
        </p:txBody>
      </p:sp>
      <p:sp>
        <p:nvSpPr>
          <p:cNvPr id="14" name="Content Placeholder 13"/>
          <p:cNvSpPr>
            <a:spLocks noGrp="1"/>
          </p:cNvSpPr>
          <p:nvPr>
            <p:ph sz="quarter" idx="13"/>
          </p:nvPr>
        </p:nvSpPr>
        <p:spPr>
          <a:xfrm>
            <a:off x="609599" y="1323280"/>
            <a:ext cx="11431883" cy="5384325"/>
          </a:xfrm>
        </p:spPr>
        <p:txBody>
          <a:bodyPr vert="horz" lIns="0" tIns="0" rIns="0" bIns="0" rtlCol="0" anchor="t">
            <a:noAutofit/>
          </a:bodyPr>
          <a:lstStyle/>
          <a:p>
            <a:pPr marL="306070" indent="-306070">
              <a:lnSpc>
                <a:spcPct val="120000"/>
              </a:lnSpc>
            </a:pPr>
            <a:r>
              <a:rPr lang="en-US" sz="3600" b="1" dirty="0">
                <a:solidFill>
                  <a:schemeClr val="tx1">
                    <a:lumMod val="75000"/>
                  </a:schemeClr>
                </a:solidFill>
                <a:latin typeface="Arial"/>
                <a:ea typeface="Calibri"/>
                <a:cs typeface="Arial"/>
              </a:rPr>
              <a:t> </a:t>
            </a:r>
            <a:r>
              <a:rPr lang="en-US" sz="3733" dirty="0">
                <a:solidFill>
                  <a:srgbClr val="000000"/>
                </a:solidFill>
                <a:latin typeface="Calibri"/>
                <a:ea typeface="Calibri"/>
                <a:cs typeface="Calibri"/>
              </a:rPr>
              <a:t>Articulate the purpose and benefits of the Family Presence Facilitator (FPF) role </a:t>
            </a:r>
            <a:endParaRPr lang="en-US" sz="3733" dirty="0">
              <a:solidFill>
                <a:srgbClr val="000000"/>
              </a:solidFill>
              <a:latin typeface="Segoe UI"/>
              <a:cs typeface="Segoe UI"/>
            </a:endParaRPr>
          </a:p>
          <a:p>
            <a:pPr marL="305874" indent="-306070">
              <a:lnSpc>
                <a:spcPct val="120000"/>
              </a:lnSpc>
            </a:pPr>
            <a:r>
              <a:rPr lang="en-US" sz="3733" dirty="0">
                <a:solidFill>
                  <a:srgbClr val="000000"/>
                </a:solidFill>
                <a:latin typeface="Calibri" panose="020F0502020204030204" pitchFamily="34" charset="0"/>
              </a:rPr>
              <a:t>List the four components of the FPF role and key behaviors for each </a:t>
            </a:r>
            <a:endParaRPr lang="en-US" sz="3733" dirty="0">
              <a:solidFill>
                <a:srgbClr val="000000"/>
              </a:solidFill>
              <a:latin typeface="Segoe UI" panose="020B0502040204020203" pitchFamily="34" charset="0"/>
              <a:cs typeface="Segoe UI" panose="020B0502040204020203" pitchFamily="34" charset="0"/>
            </a:endParaRPr>
          </a:p>
          <a:p>
            <a:pPr marL="305874" indent="-306070">
              <a:lnSpc>
                <a:spcPct val="120000"/>
              </a:lnSpc>
            </a:pPr>
            <a:r>
              <a:rPr lang="en-US" sz="3733" dirty="0">
                <a:solidFill>
                  <a:srgbClr val="000000"/>
                </a:solidFill>
                <a:latin typeface="Calibri" panose="020F0502020204030204" pitchFamily="34" charset="0"/>
              </a:rPr>
              <a:t>Demonstrate the key personality types in a role-play scenario</a:t>
            </a:r>
            <a:endParaRPr lang="en-US" sz="3733" dirty="0">
              <a:solidFill>
                <a:srgbClr val="000000"/>
              </a:solidFill>
              <a:latin typeface="Segoe UI" panose="020B0502040204020203" pitchFamily="34" charset="0"/>
              <a:cs typeface="Segoe UI" panose="020B0502040204020203" pitchFamily="34" charset="0"/>
            </a:endParaRPr>
          </a:p>
        </p:txBody>
      </p:sp>
      <p:sp>
        <p:nvSpPr>
          <p:cNvPr id="7" name="Slide Number Placeholder 6"/>
          <p:cNvSpPr>
            <a:spLocks noGrp="1"/>
          </p:cNvSpPr>
          <p:nvPr>
            <p:ph type="sldNum" sz="quarter" idx="4"/>
          </p:nvPr>
        </p:nvSpPr>
        <p:spPr/>
        <p:txBody>
          <a:bodyPr/>
          <a:lstStyle/>
          <a:p>
            <a:fld id="{7FEEEA1A-CB49-3744-AA40-B896987410F9}" type="slidenum">
              <a:rPr lang="en-US" dirty="0" smtClean="0"/>
              <a:pPr/>
              <a:t>7</a:t>
            </a:fld>
            <a:endParaRPr lang="en-US"/>
          </a:p>
        </p:txBody>
      </p:sp>
      <p:sp>
        <p:nvSpPr>
          <p:cNvPr id="3" name="Footer Placeholder 5">
            <a:extLst>
              <a:ext uri="{FF2B5EF4-FFF2-40B4-BE49-F238E27FC236}">
                <a16:creationId xmlns:a16="http://schemas.microsoft.com/office/drawing/2014/main" id="{1A32A307-ABE1-2ADC-DA40-ADE928ED30E1}"/>
              </a:ext>
            </a:extLst>
          </p:cNvPr>
          <p:cNvSpPr txBox="1">
            <a:spLocks/>
          </p:cNvSpPr>
          <p:nvPr/>
        </p:nvSpPr>
        <p:spPr>
          <a:xfrm>
            <a:off x="352755" y="6683424"/>
            <a:ext cx="11319631" cy="123111"/>
          </a:xfrm>
          <a:prstGeom prst="rect">
            <a:avLst/>
          </a:prstGeom>
        </p:spPr>
        <p:txBody>
          <a:bodyPr vert="horz" wrap="square" lIns="0" tIns="0" rIns="0" bIns="0" rtlCol="0" anchor="ctr">
            <a:spAutoFit/>
          </a:bodyPr>
          <a:lstStyle>
            <a:defPPr>
              <a:defRPr lang="en-US"/>
            </a:defPPr>
            <a:lvl1pPr marL="0" algn="l" defTabSz="457200" rtl="0" eaLnBrk="1" latinLnBrk="0" hangingPunct="1">
              <a:defRPr sz="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dirty="0">
                <a:ea typeface="+mn-lt"/>
                <a:cs typeface="+mn-lt"/>
              </a:rPr>
              <a:t>Image by Presidencia de la República Medicana, </a:t>
            </a:r>
            <a:r>
              <a:rPr lang="en-US" dirty="0"/>
              <a:t>retrieved from: https://wordpress.org/openverse/image/5fca08ef-6c8d-44ed-b5a2-da05a4d8022c on 4 March 2022. Creative Commons license associated: https://creativecommons.org/licenses/by/2.0/.</a:t>
            </a:r>
            <a:endParaRPr lang="en-US" dirty="0">
              <a:cs typeface="Arial"/>
            </a:endParaRPr>
          </a:p>
        </p:txBody>
      </p:sp>
    </p:spTree>
    <p:extLst>
      <p:ext uri="{BB962C8B-B14F-4D97-AF65-F5344CB8AC3E}">
        <p14:creationId xmlns:p14="http://schemas.microsoft.com/office/powerpoint/2010/main" val="3168291106"/>
      </p:ext>
    </p:extLst>
  </p:cSld>
  <p:clrMapOvr>
    <a:masterClrMapping/>
  </p:clrMapOvr>
  <mc:AlternateContent xmlns:mc="http://schemas.openxmlformats.org/markup-compatibility/2006" xmlns:p14="http://schemas.microsoft.com/office/powerpoint/2010/main">
    <mc:Choice Requires="p14">
      <p:transition spd="slow" p14:dur="2000" advTm="59157"/>
    </mc:Choice>
    <mc:Fallback xmlns="">
      <p:transition spd="slow" advTm="59157"/>
    </mc:Fallback>
  </mc:AlternateContent>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Inauguración del Hospital Municipal de Chiconcuac">
            <a:extLst>
              <a:ext uri="{FF2B5EF4-FFF2-40B4-BE49-F238E27FC236}">
                <a16:creationId xmlns:a16="http://schemas.microsoft.com/office/drawing/2014/main" id="{43918FFD-E5E0-40F2-870E-BC995D5C87B2}"/>
              </a:ext>
            </a:extLst>
          </p:cNvPr>
          <p:cNvPicPr>
            <a:picLocks noChangeAspect="1" noChangeArrowheads="1"/>
          </p:cNvPicPr>
          <p:nvPr/>
        </p:nvPicPr>
        <p:blipFill rotWithShape="1">
          <a:blip r:embed="rId3">
            <a:alphaModFix amt="33000"/>
            <a:extLst>
              <a:ext uri="{BEBA8EAE-BF5A-486C-A8C5-ECC9F3942E4B}">
                <a14:imgProps xmlns:a14="http://schemas.microsoft.com/office/drawing/2010/main">
                  <a14:imgLayer r:embed="rId4">
                    <a14:imgEffect>
                      <a14:colorTemperature colorTemp="3977"/>
                    </a14:imgEffect>
                    <a14:imgEffect>
                      <a14:brightnessContrast bright="-19000" contrast="-6000"/>
                    </a14:imgEffect>
                  </a14:imgLayer>
                </a14:imgProps>
              </a:ext>
              <a:ext uri="{28A0092B-C50C-407E-A947-70E740481C1C}">
                <a14:useLocalDpi xmlns:a14="http://schemas.microsoft.com/office/drawing/2010/main" val="0"/>
              </a:ext>
            </a:extLst>
          </a:blip>
          <a:srcRect t="20045" b="-249"/>
          <a:stretch/>
        </p:blipFill>
        <p:spPr bwMode="auto">
          <a:xfrm>
            <a:off x="0" y="347839"/>
            <a:ext cx="12195283" cy="6523493"/>
          </a:xfrm>
          <a:prstGeom prst="rect">
            <a:avLst/>
          </a:prstGeom>
          <a:noFill/>
          <a:extLst>
            <a:ext uri="{909E8E84-426E-40DD-AFC4-6F175D3DCCD1}">
              <a14:hiddenFill xmlns:a14="http://schemas.microsoft.com/office/drawing/2010/main">
                <a:solidFill>
                  <a:srgbClr val="FFFFFF"/>
                </a:solidFill>
              </a14:hiddenFill>
            </a:ext>
          </a:extLst>
        </p:spPr>
      </p:pic>
      <p:sp>
        <p:nvSpPr>
          <p:cNvPr id="9" name="Title 8"/>
          <p:cNvSpPr>
            <a:spLocks noGrp="1"/>
          </p:cNvSpPr>
          <p:nvPr>
            <p:ph type="title"/>
          </p:nvPr>
        </p:nvSpPr>
        <p:spPr>
          <a:xfrm>
            <a:off x="609599" y="982639"/>
            <a:ext cx="10972803" cy="418576"/>
          </a:xfrm>
        </p:spPr>
        <p:txBody>
          <a:bodyPr/>
          <a:lstStyle/>
          <a:p>
            <a:r>
              <a:rPr lang="en-US" sz="3700"/>
              <a:t>Simulation Basics, Continued</a:t>
            </a:r>
            <a:endParaRPr lang="en-US" sz="3700">
              <a:cs typeface="Arial"/>
            </a:endParaRPr>
          </a:p>
        </p:txBody>
      </p:sp>
      <p:sp>
        <p:nvSpPr>
          <p:cNvPr id="14" name="Content Placeholder 13"/>
          <p:cNvSpPr>
            <a:spLocks noGrp="1"/>
          </p:cNvSpPr>
          <p:nvPr>
            <p:ph sz="quarter" idx="13"/>
          </p:nvPr>
        </p:nvSpPr>
        <p:spPr>
          <a:xfrm>
            <a:off x="609599" y="1625713"/>
            <a:ext cx="11389744" cy="4530102"/>
          </a:xfrm>
        </p:spPr>
        <p:txBody>
          <a:bodyPr vert="horz" lIns="0" tIns="0" rIns="0" bIns="0" rtlCol="0" anchor="t">
            <a:noAutofit/>
          </a:bodyPr>
          <a:lstStyle/>
          <a:p>
            <a:pPr marL="306070" indent="-306070">
              <a:lnSpc>
                <a:spcPct val="140000"/>
              </a:lnSpc>
            </a:pPr>
            <a:r>
              <a:rPr lang="en-US" sz="3200" b="1" dirty="0">
                <a:solidFill>
                  <a:schemeClr val="tx1">
                    <a:lumMod val="75000"/>
                  </a:schemeClr>
                </a:solidFill>
                <a:cs typeface="Arial"/>
              </a:rPr>
              <a:t>Structure</a:t>
            </a:r>
            <a:r>
              <a:rPr lang="en-US" sz="3200" dirty="0">
                <a:solidFill>
                  <a:schemeClr val="tx1">
                    <a:lumMod val="75000"/>
                  </a:schemeClr>
                </a:solidFill>
                <a:cs typeface="Arial"/>
              </a:rPr>
              <a:t>: </a:t>
            </a:r>
            <a:endParaRPr lang="en-US" dirty="0">
              <a:solidFill>
                <a:schemeClr val="tx1">
                  <a:lumMod val="75000"/>
                </a:schemeClr>
              </a:solidFill>
            </a:endParaRPr>
          </a:p>
          <a:p>
            <a:pPr marL="608965" lvl="1" indent="-308610">
              <a:lnSpc>
                <a:spcPct val="140000"/>
              </a:lnSpc>
            </a:pPr>
            <a:r>
              <a:rPr lang="en-US" sz="3000" dirty="0" err="1">
                <a:solidFill>
                  <a:schemeClr val="tx1">
                    <a:lumMod val="75000"/>
                  </a:schemeClr>
                </a:solidFill>
                <a:cs typeface="Arial"/>
              </a:rPr>
              <a:t>Prebrief</a:t>
            </a:r>
            <a:r>
              <a:rPr lang="en-US" sz="3000" dirty="0">
                <a:solidFill>
                  <a:schemeClr val="tx1">
                    <a:lumMod val="75000"/>
                  </a:schemeClr>
                </a:solidFill>
                <a:cs typeface="Arial"/>
              </a:rPr>
              <a:t>: 5-10 minutes</a:t>
            </a:r>
          </a:p>
          <a:p>
            <a:pPr marL="608965" lvl="1" indent="-308610">
              <a:lnSpc>
                <a:spcPct val="140000"/>
              </a:lnSpc>
            </a:pPr>
            <a:r>
              <a:rPr lang="en-US" sz="3000" dirty="0">
                <a:solidFill>
                  <a:schemeClr val="tx1">
                    <a:lumMod val="75000"/>
                  </a:schemeClr>
                </a:solidFill>
                <a:cs typeface="Arial"/>
              </a:rPr>
              <a:t>Simulation: 15-20 minutes </a:t>
            </a:r>
            <a:r>
              <a:rPr lang="en-US" sz="3000" i="1" dirty="0">
                <a:solidFill>
                  <a:schemeClr val="tx1">
                    <a:lumMod val="75000"/>
                  </a:schemeClr>
                </a:solidFill>
                <a:cs typeface="Arial"/>
              </a:rPr>
              <a:t>(SP generally plays family member)</a:t>
            </a:r>
          </a:p>
          <a:p>
            <a:pPr marL="608965" lvl="1" indent="-308610">
              <a:lnSpc>
                <a:spcPct val="140000"/>
              </a:lnSpc>
            </a:pPr>
            <a:r>
              <a:rPr lang="en-US" sz="3000" dirty="0">
                <a:solidFill>
                  <a:schemeClr val="tx1">
                    <a:lumMod val="75000"/>
                  </a:schemeClr>
                </a:solidFill>
                <a:cs typeface="Arial"/>
              </a:rPr>
              <a:t>Debrief: 30-40 minutes</a:t>
            </a:r>
          </a:p>
          <a:p>
            <a:pPr marL="306705" indent="-306070">
              <a:lnSpc>
                <a:spcPct val="140000"/>
              </a:lnSpc>
            </a:pPr>
            <a:r>
              <a:rPr lang="en-US" sz="3200" b="1" dirty="0">
                <a:solidFill>
                  <a:schemeClr val="tx1">
                    <a:lumMod val="75000"/>
                  </a:schemeClr>
                </a:solidFill>
                <a:cs typeface="Arial"/>
              </a:rPr>
              <a:t>Types of cases</a:t>
            </a:r>
            <a:r>
              <a:rPr lang="en-US" sz="3200" dirty="0">
                <a:solidFill>
                  <a:schemeClr val="tx1">
                    <a:lumMod val="75000"/>
                  </a:schemeClr>
                </a:solidFill>
                <a:cs typeface="Arial"/>
              </a:rPr>
              <a:t>: septic shock, cardiac arrest, respiratory failure, stroke, seizure, anaphylaxis</a:t>
            </a:r>
          </a:p>
          <a:p>
            <a:pPr marL="635" indent="0">
              <a:lnSpc>
                <a:spcPct val="140000"/>
              </a:lnSpc>
              <a:buNone/>
            </a:pPr>
            <a:endParaRPr lang="en-US" sz="3200" dirty="0">
              <a:solidFill>
                <a:schemeClr val="tx1">
                  <a:lumMod val="75000"/>
                </a:schemeClr>
              </a:solidFill>
              <a:cs typeface="Arial"/>
            </a:endParaRPr>
          </a:p>
          <a:p>
            <a:pPr marL="306070" indent="-306070">
              <a:lnSpc>
                <a:spcPct val="140000"/>
              </a:lnSpc>
            </a:pPr>
            <a:endParaRPr lang="en-US" sz="2900" dirty="0">
              <a:solidFill>
                <a:schemeClr val="tx1">
                  <a:lumMod val="75000"/>
                </a:schemeClr>
              </a:solidFill>
              <a:cs typeface="Arial"/>
            </a:endParaRPr>
          </a:p>
          <a:p>
            <a:pPr marL="608965" lvl="1" indent="-308610">
              <a:lnSpc>
                <a:spcPct val="140000"/>
              </a:lnSpc>
            </a:pPr>
            <a:endParaRPr lang="en-US" sz="2100" dirty="0">
              <a:solidFill>
                <a:schemeClr val="tx1">
                  <a:lumMod val="75000"/>
                </a:schemeClr>
              </a:solidFill>
              <a:cs typeface="Arial"/>
            </a:endParaRPr>
          </a:p>
        </p:txBody>
      </p:sp>
      <p:sp>
        <p:nvSpPr>
          <p:cNvPr id="7" name="Slide Number Placeholder 6"/>
          <p:cNvSpPr>
            <a:spLocks noGrp="1"/>
          </p:cNvSpPr>
          <p:nvPr>
            <p:ph type="sldNum" sz="quarter" idx="4"/>
          </p:nvPr>
        </p:nvSpPr>
        <p:spPr/>
        <p:txBody>
          <a:bodyPr/>
          <a:lstStyle/>
          <a:p>
            <a:fld id="{7FEEEA1A-CB49-3744-AA40-B896987410F9}" type="slidenum">
              <a:rPr lang="en-US" smtClean="0"/>
              <a:pPr/>
              <a:t>8</a:t>
            </a:fld>
            <a:endParaRPr lang="en-US"/>
          </a:p>
        </p:txBody>
      </p:sp>
      <p:sp>
        <p:nvSpPr>
          <p:cNvPr id="4" name="Footer Placeholder 5">
            <a:extLst>
              <a:ext uri="{FF2B5EF4-FFF2-40B4-BE49-F238E27FC236}">
                <a16:creationId xmlns:a16="http://schemas.microsoft.com/office/drawing/2014/main" id="{C257A08E-004E-4A8F-A55A-F84014C35AC3}"/>
              </a:ext>
            </a:extLst>
          </p:cNvPr>
          <p:cNvSpPr txBox="1">
            <a:spLocks/>
          </p:cNvSpPr>
          <p:nvPr/>
        </p:nvSpPr>
        <p:spPr>
          <a:xfrm>
            <a:off x="304354" y="6671392"/>
            <a:ext cx="11847540" cy="123111"/>
          </a:xfrm>
          <a:prstGeom prst="rect">
            <a:avLst/>
          </a:prstGeom>
        </p:spPr>
        <p:txBody>
          <a:bodyPr vert="horz" wrap="square" lIns="0" tIns="0" rIns="0" bIns="0" rtlCol="0" anchor="ct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800" dirty="0">
                <a:ea typeface="+mn-lt"/>
                <a:cs typeface="+mn-lt"/>
              </a:rPr>
              <a:t>Image by Presidencia de la República </a:t>
            </a:r>
            <a:r>
              <a:rPr lang="en-US" sz="800" dirty="0" err="1">
                <a:ea typeface="+mn-lt"/>
                <a:cs typeface="+mn-lt"/>
              </a:rPr>
              <a:t>Medicana</a:t>
            </a:r>
            <a:r>
              <a:rPr lang="en-US" sz="800" dirty="0">
                <a:ea typeface="+mn-lt"/>
                <a:cs typeface="+mn-lt"/>
              </a:rPr>
              <a:t>, </a:t>
            </a:r>
            <a:r>
              <a:rPr lang="en-US" sz="800" dirty="0"/>
              <a:t>retrieved from: https://</a:t>
            </a:r>
            <a:r>
              <a:rPr lang="en-US" sz="800" dirty="0" err="1"/>
              <a:t>wordpress.org</a:t>
            </a:r>
            <a:r>
              <a:rPr lang="en-US" sz="800" dirty="0"/>
              <a:t>/</a:t>
            </a:r>
            <a:r>
              <a:rPr lang="en-US" sz="800" dirty="0" err="1"/>
              <a:t>openverse</a:t>
            </a:r>
            <a:r>
              <a:rPr lang="en-US" sz="800" dirty="0"/>
              <a:t>/image/5fca08ef-6c8d-44ed-b5a2-da05a4d8022c on 4 March 2022. Creative Commons license associated: https://</a:t>
            </a:r>
            <a:r>
              <a:rPr lang="en-US" sz="800" dirty="0" err="1"/>
              <a:t>creativecommons.org</a:t>
            </a:r>
            <a:r>
              <a:rPr lang="en-US" sz="800" dirty="0"/>
              <a:t>/licenses/by/4.0/.</a:t>
            </a:r>
            <a:endParaRPr lang="en-US" sz="800" dirty="0">
              <a:cs typeface="Arial"/>
            </a:endParaRPr>
          </a:p>
        </p:txBody>
      </p:sp>
    </p:spTree>
    <p:extLst>
      <p:ext uri="{BB962C8B-B14F-4D97-AF65-F5344CB8AC3E}">
        <p14:creationId xmlns:p14="http://schemas.microsoft.com/office/powerpoint/2010/main" val="3853581152"/>
      </p:ext>
    </p:extLst>
  </p:cSld>
  <p:clrMapOvr>
    <a:masterClrMapping/>
  </p:clrMapOvr>
  <mc:AlternateContent xmlns:mc="http://schemas.openxmlformats.org/markup-compatibility/2006" xmlns:p14="http://schemas.microsoft.com/office/powerpoint/2010/main">
    <mc:Choice Requires="p14">
      <p:transition spd="slow" p14:dur="2000" advTm="32788"/>
    </mc:Choice>
    <mc:Fallback xmlns="">
      <p:transition spd="slow" advTm="32788"/>
    </mc:Fallback>
  </mc:AlternateContent>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itle 8"/>
          <p:cNvSpPr>
            <a:spLocks noGrp="1"/>
          </p:cNvSpPr>
          <p:nvPr>
            <p:ph type="title"/>
          </p:nvPr>
        </p:nvSpPr>
        <p:spPr>
          <a:xfrm>
            <a:off x="609599" y="807235"/>
            <a:ext cx="10972803" cy="418576"/>
          </a:xfrm>
        </p:spPr>
        <p:txBody>
          <a:bodyPr/>
          <a:lstStyle/>
          <a:p>
            <a:r>
              <a:rPr lang="en-US" sz="3700"/>
              <a:t>Outline</a:t>
            </a:r>
          </a:p>
        </p:txBody>
      </p:sp>
      <p:sp>
        <p:nvSpPr>
          <p:cNvPr id="14" name="Content Placeholder 13"/>
          <p:cNvSpPr>
            <a:spLocks noGrp="1"/>
          </p:cNvSpPr>
          <p:nvPr>
            <p:ph sz="quarter" idx="13"/>
          </p:nvPr>
        </p:nvSpPr>
        <p:spPr>
          <a:xfrm>
            <a:off x="609600" y="1476789"/>
            <a:ext cx="10972801" cy="4737116"/>
          </a:xfrm>
        </p:spPr>
        <p:txBody>
          <a:bodyPr vert="horz" lIns="0" tIns="0" rIns="0" bIns="0" rtlCol="0" anchor="t">
            <a:noAutofit/>
          </a:bodyPr>
          <a:lstStyle/>
          <a:p>
            <a:pPr marL="306070" indent="-306070">
              <a:lnSpc>
                <a:spcPct val="150000"/>
              </a:lnSpc>
              <a:spcBef>
                <a:spcPts val="800"/>
              </a:spcBef>
            </a:pPr>
            <a:r>
              <a:rPr lang="en-US" sz="2700" dirty="0">
                <a:ea typeface="+mn-lt"/>
                <a:cs typeface="+mn-lt"/>
              </a:rPr>
              <a:t>Overview</a:t>
            </a:r>
          </a:p>
          <a:p>
            <a:pPr marL="306070" indent="-306070">
              <a:lnSpc>
                <a:spcPct val="150000"/>
              </a:lnSpc>
              <a:spcBef>
                <a:spcPts val="800"/>
              </a:spcBef>
            </a:pPr>
            <a:r>
              <a:rPr lang="en-US" sz="2700" dirty="0">
                <a:solidFill>
                  <a:srgbClr val="9E2FED"/>
                </a:solidFill>
              </a:rPr>
              <a:t>Personality </a:t>
            </a:r>
            <a:r>
              <a:rPr lang="en-US" sz="2700">
                <a:solidFill>
                  <a:srgbClr val="9E2FED"/>
                </a:solidFill>
              </a:rPr>
              <a:t>Traits</a:t>
            </a:r>
            <a:endParaRPr lang="en-US" sz="2700">
              <a:solidFill>
                <a:srgbClr val="9E2FED"/>
              </a:solidFill>
              <a:ea typeface="+mn-lt"/>
              <a:cs typeface="+mn-lt"/>
            </a:endParaRPr>
          </a:p>
          <a:p>
            <a:pPr marL="306070" indent="-306070">
              <a:lnSpc>
                <a:spcPct val="150000"/>
              </a:lnSpc>
              <a:spcBef>
                <a:spcPts val="800"/>
              </a:spcBef>
            </a:pPr>
            <a:r>
              <a:rPr lang="en-US" sz="2700" dirty="0">
                <a:ea typeface="+mn-lt"/>
                <a:cs typeface="+mn-lt"/>
              </a:rPr>
              <a:t>Observer Tool</a:t>
            </a:r>
          </a:p>
          <a:p>
            <a:pPr marL="306070" indent="-306070">
              <a:lnSpc>
                <a:spcPct val="150000"/>
              </a:lnSpc>
              <a:spcBef>
                <a:spcPts val="800"/>
              </a:spcBef>
            </a:pPr>
            <a:r>
              <a:rPr lang="en-US" sz="2700" dirty="0">
                <a:ea typeface="+mn-lt"/>
                <a:cs typeface="+mn-lt"/>
              </a:rPr>
              <a:t>Practice!</a:t>
            </a:r>
          </a:p>
          <a:p>
            <a:pPr marL="306070" indent="-306070">
              <a:lnSpc>
                <a:spcPct val="150000"/>
              </a:lnSpc>
              <a:spcBef>
                <a:spcPts val="800"/>
              </a:spcBef>
            </a:pPr>
            <a:r>
              <a:rPr lang="en-US" sz="2700" dirty="0">
                <a:ea typeface="+mn-lt"/>
                <a:cs typeface="+mn-lt"/>
              </a:rPr>
              <a:t>Summary</a:t>
            </a:r>
          </a:p>
          <a:p>
            <a:pPr marL="306070" indent="-306070">
              <a:spcBef>
                <a:spcPts val="800"/>
              </a:spcBef>
            </a:pPr>
            <a:endParaRPr lang="en-US" sz="2700">
              <a:cs typeface="Arial"/>
            </a:endParaRPr>
          </a:p>
        </p:txBody>
      </p:sp>
      <p:sp>
        <p:nvSpPr>
          <p:cNvPr id="7" name="Slide Number Placeholder 6"/>
          <p:cNvSpPr>
            <a:spLocks noGrp="1"/>
          </p:cNvSpPr>
          <p:nvPr>
            <p:ph type="sldNum" sz="quarter" idx="4"/>
          </p:nvPr>
        </p:nvSpPr>
        <p:spPr/>
        <p:txBody>
          <a:bodyPr/>
          <a:lstStyle/>
          <a:p>
            <a:fld id="{7FEEEA1A-CB49-3744-AA40-B896987410F9}" type="slidenum">
              <a:rPr lang="en-US" dirty="0" smtClean="0"/>
              <a:pPr/>
              <a:t>9</a:t>
            </a:fld>
            <a:endParaRPr lang="en-US"/>
          </a:p>
        </p:txBody>
      </p:sp>
    </p:spTree>
    <p:extLst>
      <p:ext uri="{BB962C8B-B14F-4D97-AF65-F5344CB8AC3E}">
        <p14:creationId xmlns:p14="http://schemas.microsoft.com/office/powerpoint/2010/main" val="2743119629"/>
      </p:ext>
    </p:extLst>
  </p:cSld>
  <p:clrMapOvr>
    <a:masterClrMapping/>
  </p:clrMapOvr>
  <mc:AlternateContent xmlns:mc="http://schemas.openxmlformats.org/markup-compatibility/2006" xmlns:p14="http://schemas.microsoft.com/office/powerpoint/2010/main">
    <mc:Choice Requires="p14">
      <p:transition spd="slow" p14:dur="2000" advTm="6994"/>
    </mc:Choice>
    <mc:Fallback xmlns="">
      <p:transition spd="slow" advTm="6994"/>
    </mc:Fallback>
  </mc:AlternateContent>
</p:sld>
</file>

<file path=ppt/theme/theme1.xml><?xml version="1.0" encoding="utf-8"?>
<a:theme xmlns:a="http://schemas.openxmlformats.org/drawingml/2006/main" name="NYU Langone Health Theme 1 Purple Cover White Interior">
  <a:themeElements>
    <a:clrScheme name="NYU Langone Vibrant Office Colors">
      <a:dk1>
        <a:srgbClr val="53565A"/>
      </a:dk1>
      <a:lt1>
        <a:srgbClr val="FFFFFF"/>
      </a:lt1>
      <a:dk2>
        <a:srgbClr val="580F8B"/>
      </a:dk2>
      <a:lt2>
        <a:srgbClr val="D9D9D6"/>
      </a:lt2>
      <a:accent1>
        <a:srgbClr val="580F8B"/>
      </a:accent1>
      <a:accent2>
        <a:srgbClr val="E0A526"/>
      </a:accent2>
      <a:accent3>
        <a:srgbClr val="489FDF"/>
      </a:accent3>
      <a:accent4>
        <a:srgbClr val="E5554F"/>
      </a:accent4>
      <a:accent5>
        <a:srgbClr val="40C1AC"/>
      </a:accent5>
      <a:accent6>
        <a:srgbClr val="9BB8D3"/>
      </a:accent6>
      <a:hlink>
        <a:srgbClr val="0000FF"/>
      </a:hlink>
      <a:folHlink>
        <a:srgbClr val="00EBFF"/>
      </a:folHlink>
    </a:clrScheme>
    <a:fontScheme name="NYU Langone Office Fonts">
      <a:majorFont>
        <a:latin typeface="Arial"/>
        <a:ea typeface=""/>
        <a:cs typeface=""/>
      </a:majorFont>
      <a:minorFont>
        <a:latin typeface="Arial"/>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chemeClr val="tx2"/>
        </a:solidFill>
        <a:ln>
          <a:noFill/>
        </a:ln>
        <a:effectLst/>
      </a:spPr>
      <a:bodyPr rtlCol="0" anchor="ctr"/>
      <a:lstStyle>
        <a:defPPr algn="ctr">
          <a:defRPr>
            <a:ln>
              <a:noFill/>
            </a:ln>
            <a:solidFill>
              <a:schemeClr val="accent1"/>
            </a:solidFill>
          </a:defRPr>
        </a:defPPr>
      </a:lstStyle>
      <a:style>
        <a:lnRef idx="1">
          <a:schemeClr val="accent1"/>
        </a:lnRef>
        <a:fillRef idx="3">
          <a:schemeClr val="accent1"/>
        </a:fillRef>
        <a:effectRef idx="2">
          <a:schemeClr val="accent1"/>
        </a:effectRef>
        <a:fontRef idx="minor">
          <a:schemeClr val="lt1"/>
        </a:fontRef>
      </a:style>
    </a:spDef>
    <a:lnDef>
      <a:spPr>
        <a:ln w="9525">
          <a:solidFill>
            <a:schemeClr val="tx1"/>
          </a:solidFill>
        </a:ln>
        <a:effectLst/>
      </a:spPr>
      <a:bodyPr/>
      <a:lstStyle/>
      <a:style>
        <a:lnRef idx="2">
          <a:schemeClr val="accent1"/>
        </a:lnRef>
        <a:fillRef idx="0">
          <a:schemeClr val="accent1"/>
        </a:fillRef>
        <a:effectRef idx="1">
          <a:schemeClr val="accent1"/>
        </a:effectRef>
        <a:fontRef idx="minor">
          <a:schemeClr val="tx1"/>
        </a:fontRef>
      </a:style>
    </a:lnDef>
    <a:txDef>
      <a:spPr>
        <a:noFill/>
      </a:spPr>
      <a:bodyPr wrap="square" rtlCol="0">
        <a:spAutoFit/>
      </a:bodyPr>
      <a:lstStyle>
        <a:defPPr>
          <a:defRPr sz="1400" dirty="0" err="1" smtClean="0"/>
        </a:defPPr>
      </a:lstStyle>
    </a:txDef>
  </a:objectDefaults>
  <a:extraClrSchemeLst/>
  <a:extLst>
    <a:ext uri="{05A4C25C-085E-4340-85A3-A5531E510DB2}">
      <thm15:themeFamily xmlns:thm15="http://schemas.microsoft.com/office/thememl/2012/main" name="Presentation69" id="{603220F1-3477-264D-A5C4-944B6C8361D1}" vid="{D3FEF756-BC4C-EF42-A084-459B398DACEE}"/>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568</TotalTime>
  <Words>2033</Words>
  <Application>Microsoft Macintosh PowerPoint</Application>
  <PresentationFormat>Widescreen</PresentationFormat>
  <Paragraphs>214</Paragraphs>
  <Slides>27</Slides>
  <Notes>19</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7</vt:i4>
      </vt:variant>
    </vt:vector>
  </HeadingPairs>
  <TitlesOfParts>
    <vt:vector size="32" baseType="lpstr">
      <vt:lpstr>Arial</vt:lpstr>
      <vt:lpstr>Arial,Sans-Serif</vt:lpstr>
      <vt:lpstr>Calibri</vt:lpstr>
      <vt:lpstr>Segoe UI</vt:lpstr>
      <vt:lpstr>NYU Langone Health Theme 1 Purple Cover White Interior</vt:lpstr>
      <vt:lpstr>Family Presence Facilitator (FPF) Curriculum:  simulated PARTICIPANT Training  </vt:lpstr>
      <vt:lpstr>**CONTENT ADVISORY &amp; TRAUMA INFORMED CARE**</vt:lpstr>
      <vt:lpstr>De-Roling</vt:lpstr>
      <vt:lpstr>Outline</vt:lpstr>
      <vt:lpstr>overview</vt:lpstr>
      <vt:lpstr>Overview</vt:lpstr>
      <vt:lpstr>Objectives</vt:lpstr>
      <vt:lpstr>Simulation Basics, Continued</vt:lpstr>
      <vt:lpstr>Outline</vt:lpstr>
      <vt:lpstr>Personality traits</vt:lpstr>
      <vt:lpstr>Personality Traits</vt:lpstr>
      <vt:lpstr>Agitated</vt:lpstr>
      <vt:lpstr>Anxious</vt:lpstr>
      <vt:lpstr>Quiet</vt:lpstr>
      <vt:lpstr>Outline</vt:lpstr>
      <vt:lpstr> OBSERVER TOOL</vt:lpstr>
      <vt:lpstr>Key FPF Behaviors</vt:lpstr>
      <vt:lpstr>PowerPoint Presentation</vt:lpstr>
      <vt:lpstr>PowerPoint Presentation</vt:lpstr>
      <vt:lpstr>PowerPoint Presentation</vt:lpstr>
      <vt:lpstr>Outline</vt:lpstr>
      <vt:lpstr>Practice</vt:lpstr>
      <vt:lpstr>Hands-On Practice</vt:lpstr>
      <vt:lpstr>Summary</vt:lpstr>
      <vt:lpstr>Summary</vt:lpstr>
      <vt:lpstr>Resources</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
  <cp:lastModifiedBy>Duncan, Ellen</cp:lastModifiedBy>
  <cp:revision>399</cp:revision>
  <dcterms:created xsi:type="dcterms:W3CDTF">2022-01-07T16:28:31Z</dcterms:created>
  <dcterms:modified xsi:type="dcterms:W3CDTF">2024-04-01T18:45:38Z</dcterms:modified>
</cp:coreProperties>
</file>